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26"/>
  </p:notesMasterIdLst>
  <p:handoutMasterIdLst>
    <p:handoutMasterId r:id="rId27"/>
  </p:handoutMasterIdLst>
  <p:sldIdLst>
    <p:sldId id="504" r:id="rId5"/>
    <p:sldId id="273" r:id="rId6"/>
    <p:sldId id="514" r:id="rId7"/>
    <p:sldId id="261" r:id="rId8"/>
    <p:sldId id="444" r:id="rId9"/>
    <p:sldId id="272" r:id="rId10"/>
    <p:sldId id="269" r:id="rId11"/>
    <p:sldId id="271" r:id="rId12"/>
    <p:sldId id="280" r:id="rId13"/>
    <p:sldId id="526" r:id="rId14"/>
    <p:sldId id="527" r:id="rId15"/>
    <p:sldId id="515" r:id="rId16"/>
    <p:sldId id="516" r:id="rId17"/>
    <p:sldId id="517" r:id="rId18"/>
    <p:sldId id="518" r:id="rId19"/>
    <p:sldId id="519" r:id="rId20"/>
    <p:sldId id="520" r:id="rId21"/>
    <p:sldId id="521" r:id="rId22"/>
    <p:sldId id="524" r:id="rId23"/>
    <p:sldId id="528" r:id="rId24"/>
    <p:sldId id="529" r:id="rId25"/>
  </p:sldIdLst>
  <p:sldSz cx="12192000" cy="6858000"/>
  <p:notesSz cx="6858000" cy="9144000"/>
  <p:defaultTextStyle>
    <a:defPPr>
      <a:defRPr lang="en-US"/>
    </a:defPPr>
    <a:lvl1pPr marL="0" algn="l" defTabSz="2286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1pPr>
    <a:lvl2pPr marL="228600" algn="l" defTabSz="2286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2pPr>
    <a:lvl3pPr marL="457200" algn="l" defTabSz="2286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3pPr>
    <a:lvl4pPr marL="685800" algn="l" defTabSz="2286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4pPr>
    <a:lvl5pPr marL="914400" algn="l" defTabSz="2286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5pPr>
    <a:lvl6pPr marL="1143000" algn="l" defTabSz="2286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6pPr>
    <a:lvl7pPr marL="1371600" algn="l" defTabSz="2286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7pPr>
    <a:lvl8pPr marL="1600200" algn="l" defTabSz="2286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8pPr>
    <a:lvl9pPr marL="1828800" algn="l" defTabSz="2286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INSTRUCTIONS IN ENGLISH" id="{5D1FC9DF-0947-4479-8873-150F6ED9FB85}">
          <p14:sldIdLst>
            <p14:sldId id="504"/>
            <p14:sldId id="273"/>
            <p14:sldId id="514"/>
            <p14:sldId id="261"/>
            <p14:sldId id="444"/>
            <p14:sldId id="272"/>
            <p14:sldId id="269"/>
            <p14:sldId id="271"/>
            <p14:sldId id="280"/>
            <p14:sldId id="526"/>
            <p14:sldId id="527"/>
          </p14:sldIdLst>
        </p14:section>
        <p14:section name="INSTRUCTIONS IN NORWEGIAN" id="{17679E2B-7A6D-423B-B88B-A3C6FD1B452A}">
          <p14:sldIdLst>
            <p14:sldId id="515"/>
            <p14:sldId id="516"/>
            <p14:sldId id="517"/>
            <p14:sldId id="518"/>
            <p14:sldId id="519"/>
            <p14:sldId id="520"/>
            <p14:sldId id="521"/>
            <p14:sldId id="524"/>
            <p14:sldId id="528"/>
            <p14:sldId id="529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4ABF7"/>
    <a:srgbClr val="DAE2FF"/>
    <a:srgbClr val="FAF5F3"/>
    <a:srgbClr val="E3DCD8"/>
    <a:srgbClr val="DAE1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3236E5A-013A-4D87-832D-FDA45A17DE50}" v="4" dt="2024-01-25T07:55:53.62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ddels stil 2 – utheving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iddels stil 2 – utheving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00A15C55-8517-42AA-B614-E9B94910E393}" styleName="Middels stil 2 – utheving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78499" autoAdjust="0"/>
  </p:normalViewPr>
  <p:slideViewPr>
    <p:cSldViewPr snapToGrid="0" showGuides="1">
      <p:cViewPr varScale="1">
        <p:scale>
          <a:sx n="121" d="100"/>
          <a:sy n="121" d="100"/>
        </p:scale>
        <p:origin x="1668" y="102"/>
      </p:cViewPr>
      <p:guideLst>
        <p:guide orient="horz" pos="2160"/>
        <p:guide pos="3840"/>
      </p:guideLst>
    </p:cSldViewPr>
  </p:slideViewPr>
  <p:notesTextViewPr>
    <p:cViewPr>
      <p:scale>
        <a:sx n="125" d="100"/>
        <a:sy n="125" d="100"/>
      </p:scale>
      <p:origin x="0" y="0"/>
    </p:cViewPr>
  </p:notesTextViewPr>
  <p:sorterViewPr>
    <p:cViewPr>
      <p:scale>
        <a:sx n="139" d="100"/>
        <a:sy n="139" d="100"/>
      </p:scale>
      <p:origin x="0" y="0"/>
    </p:cViewPr>
  </p:sorterViewPr>
  <p:notesViewPr>
    <p:cSldViewPr snapToGrid="0">
      <p:cViewPr varScale="1">
        <p:scale>
          <a:sx n="148" d="100"/>
          <a:sy n="148" d="100"/>
        </p:scale>
        <p:origin x="2104" y="200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openxmlformats.org/officeDocument/2006/relationships/notesMaster" Target="notesMasters/notesMaster1.xml"/><Relationship Id="rId3" Type="http://schemas.openxmlformats.org/officeDocument/2006/relationships/customXml" Target="../customXml/item3.xml"/><Relationship Id="rId21" Type="http://schemas.openxmlformats.org/officeDocument/2006/relationships/slide" Target="slides/slide17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slide" Target="slides/slide21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slide" Target="slides/slide16.xml"/><Relationship Id="rId29" Type="http://schemas.openxmlformats.org/officeDocument/2006/relationships/viewProps" Target="viewProp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slide" Target="slides/slide20.xml"/><Relationship Id="rId32" Type="http://schemas.microsoft.com/office/2015/10/relationships/revisionInfo" Target="revisionInfo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slide" Target="slides/slide19.xml"/><Relationship Id="rId28" Type="http://schemas.openxmlformats.org/officeDocument/2006/relationships/presProps" Target="presProps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31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slide" Target="slides/slide18.xml"/><Relationship Id="rId27" Type="http://schemas.openxmlformats.org/officeDocument/2006/relationships/handoutMaster" Target="handoutMasters/handoutMaster1.xml"/><Relationship Id="rId30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CBB432FE-D8FD-4513-B0C3-FF243BAD8D22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180000" rIns="91440" bIns="45720" rtlCol="0"/>
          <a:lstStyle>
            <a:lvl1pPr algn="l">
              <a:defRPr sz="1200"/>
            </a:lvl1pPr>
          </a:lstStyle>
          <a:p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E2AB5F7-9DE6-41E0-83C4-D64C5F181AF8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180000" rIns="91440" bIns="45720" rtlCol="0"/>
          <a:lstStyle>
            <a:lvl1pPr algn="r">
              <a:defRPr sz="1200"/>
            </a:lvl1pPr>
          </a:lstStyle>
          <a:p>
            <a:fld id="{F38982BD-1F9B-46A5-BDA1-E69360B60D29}" type="datetimeFigureOut">
              <a:rPr lang="en-US" sz="800" smtClean="0">
                <a:latin typeface="Arial" panose="020B0604020202020204" pitchFamily="34" charset="0"/>
                <a:cs typeface="Arial" panose="020B0604020202020204" pitchFamily="34" charset="0"/>
              </a:rPr>
              <a:t>1/25/2024</a:t>
            </a:fld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E5F102C-78F0-490A-8EAB-6C4C129D38C2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180000" rtlCol="0" anchor="b"/>
          <a:lstStyle>
            <a:lvl1pPr algn="l">
              <a:defRPr sz="1200"/>
            </a:lvl1pPr>
          </a:lstStyle>
          <a:p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D82BBD7-99F6-4D11-A75A-72849674DFF5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180000" rtlCol="0" anchor="b"/>
          <a:lstStyle>
            <a:lvl1pPr algn="r">
              <a:defRPr sz="1200"/>
            </a:lvl1pPr>
          </a:lstStyle>
          <a:p>
            <a:fld id="{0C803EB6-4D56-41AC-98B5-716B25DBA0A9}" type="slidenum">
              <a:rPr lang="en-US" sz="800" smtClean="0">
                <a:latin typeface="Arial" panose="020B0604020202020204" pitchFamily="34" charset="0"/>
                <a:cs typeface="Arial" panose="020B0604020202020204" pitchFamily="34" charset="0"/>
              </a:rPr>
              <a:t>‹#›</a:t>
            </a:fld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79849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180000" rIns="91440" bIns="45720" rtlCol="0"/>
          <a:lstStyle>
            <a:lvl1pPr algn="l"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180000" rIns="91440" bIns="45720" rtlCol="0"/>
          <a:lstStyle>
            <a:lvl1pPr algn="r"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1C8D1BF0-B0B7-460C-A38B-BE12DB807F71}" type="datetimeFigureOut">
              <a:rPr lang="en-US" smtClean="0"/>
              <a:pPr/>
              <a:t>1/25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180000" rtlCol="0" anchor="b"/>
          <a:lstStyle>
            <a:lvl1pPr algn="l"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180000" rtlCol="0" anchor="b"/>
          <a:lstStyle>
            <a:lvl1pPr algn="r"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641C4EF3-3E66-471F-A78B-367EBE00DB1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78669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000"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1pPr>
    <a:lvl2pPr marL="228600" algn="l" defTabSz="457200" rtl="0" eaLnBrk="1" latinLnBrk="0" hangingPunct="1">
      <a:defRPr sz="1000"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2pPr>
    <a:lvl3pPr marL="457200" algn="l" defTabSz="457200" rtl="0" eaLnBrk="1" latinLnBrk="0" hangingPunct="1">
      <a:defRPr sz="1000"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3pPr>
    <a:lvl4pPr marL="685800" algn="l" defTabSz="457200" rtl="0" eaLnBrk="1" latinLnBrk="0" hangingPunct="1">
      <a:defRPr sz="1000"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4pPr>
    <a:lvl5pPr marL="914400" algn="l" defTabSz="457200" rtl="0" eaLnBrk="1" latinLnBrk="0" hangingPunct="1">
      <a:defRPr sz="1000"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5pPr>
    <a:lvl6pPr marL="1143000" algn="l" defTabSz="45720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6pPr>
    <a:lvl7pPr marL="1371600" algn="l" defTabSz="45720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7pPr>
    <a:lvl8pPr marL="1600200" algn="l" defTabSz="45720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8pPr>
    <a:lvl9pPr marL="1828800" algn="l" defTabSz="45720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lysbil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ssholder for nota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41C4EF3-3E66-471F-A78B-367EBE00DB18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5668103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lysbil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ssholder for nota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41C4EF3-3E66-471F-A78B-367EBE00DB18}" type="slidenum">
              <a:rPr lang="en-US" smtClean="0"/>
              <a:pPr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533926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lysbil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ssholder for nota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41C4EF3-3E66-471F-A78B-367EBE00DB18}" type="slidenum">
              <a:rPr lang="en-US" smtClean="0"/>
              <a:pPr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1103082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lysbil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ssholder for nota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2286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641C4EF3-3E66-471F-A78B-367EBE00DB18}" type="slidenum">
              <a:rPr kumimoji="0" lang="en-US" sz="8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pPr marL="0" marR="0" lvl="0" indent="0" algn="r" defTabSz="2286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3</a:t>
            </a:fld>
            <a:endParaRPr kumimoji="0" lang="en-US" sz="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91449410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lysbil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ssholder for nota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nb-NO" dirty="0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41C4EF3-3E66-471F-A78B-367EBE00DB18}" type="slidenum">
              <a:rPr lang="en-US" smtClean="0"/>
              <a:pPr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9714965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lysbil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ssholder for nota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41C4EF3-3E66-471F-A78B-367EBE00DB18}" type="slidenum">
              <a:rPr lang="en-US" smtClean="0"/>
              <a:pPr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1623439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lysbil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ssholder for nota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b-NO" sz="1000" kern="1200" dirty="0">
              <a:solidFill>
                <a:schemeClr val="tx1"/>
              </a:solidFill>
              <a:effectLst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41C4EF3-3E66-471F-A78B-367EBE00DB18}" type="slidenum">
              <a:rPr lang="en-US" smtClean="0"/>
              <a:pPr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7185482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lysbil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ssholder for nota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41C4EF3-3E66-471F-A78B-367EBE00DB18}" type="slidenum">
              <a:rPr lang="en-US" smtClean="0"/>
              <a:pPr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195269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lysbil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ssholder for nota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None/>
            </a:pPr>
            <a:endParaRPr lang="nb-NO" b="0" dirty="0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41C4EF3-3E66-471F-A78B-367EBE00DB18}" type="slidenum">
              <a:rPr lang="en-US" smtClean="0"/>
              <a:pPr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612502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lysbil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ssholder for nota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nb-NO" dirty="0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2286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641C4EF3-3E66-471F-A78B-367EBE00DB18}" type="slidenum">
              <a:rPr kumimoji="0" lang="en-US" sz="8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pPr marL="0" marR="0" lvl="0" indent="0" algn="r" defTabSz="2286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9</a:t>
            </a:fld>
            <a:endParaRPr kumimoji="0" lang="en-US" sz="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92164366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lysbil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ssholder for nota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None/>
            </a:pPr>
            <a:endParaRPr lang="nb-NO" b="0" dirty="0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41C4EF3-3E66-471F-A78B-367EBE00DB18}" type="slidenum">
              <a:rPr lang="en-US" smtClean="0"/>
              <a:pPr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824509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lysbil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ssholder for nota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2286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641C4EF3-3E66-471F-A78B-367EBE00DB18}" type="slidenum">
              <a:rPr kumimoji="0" lang="en-US" sz="8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pPr marL="0" marR="0" lvl="0" indent="0" algn="r" defTabSz="2286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</a:t>
            </a:fld>
            <a:endParaRPr kumimoji="0" lang="en-US" sz="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57022769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lysbil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ssholder for nota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41C4EF3-3E66-471F-A78B-367EBE00DB18}" type="slidenum">
              <a:rPr lang="en-US" smtClean="0"/>
              <a:pPr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560280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lysbil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ssholder for nota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nb-NO" dirty="0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41C4EF3-3E66-471F-A78B-367EBE00DB18}" type="slidenum">
              <a:rPr lang="en-US" smtClean="0"/>
              <a:pPr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186893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lysbil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ssholder for nota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41C4EF3-3E66-471F-A78B-367EBE00DB18}" type="slidenum">
              <a:rPr lang="en-US" smtClean="0"/>
              <a:pPr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660656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lysbil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ssholder for nota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b-NO" sz="1000" kern="1200" dirty="0">
              <a:solidFill>
                <a:schemeClr val="tx1"/>
              </a:solidFill>
              <a:effectLst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41C4EF3-3E66-471F-A78B-367EBE00DB18}" type="slidenum">
              <a:rPr lang="en-US" smtClean="0"/>
              <a:pPr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634999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lysbil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ssholder for nota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41C4EF3-3E66-471F-A78B-367EBE00DB18}" type="slidenum">
              <a:rPr lang="en-US" smtClean="0"/>
              <a:pPr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4709819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lysbil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ssholder for nota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None/>
            </a:pPr>
            <a:endParaRPr lang="nb-NO" b="0" dirty="0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41C4EF3-3E66-471F-A78B-367EBE00DB18}" type="slidenum">
              <a:rPr lang="en-US" smtClean="0"/>
              <a:pPr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3637140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lysbil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ssholder for nota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nb-NO" dirty="0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41C4EF3-3E66-471F-A78B-367EBE00DB18}" type="slidenum">
              <a:rPr lang="en-US" smtClean="0"/>
              <a:pPr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5832977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lysbil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ssholder for nota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None/>
            </a:pPr>
            <a:endParaRPr lang="nb-NO" b="0" dirty="0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41C4EF3-3E66-471F-A78B-367EBE00DB18}" type="slidenum">
              <a:rPr lang="en-US" smtClean="0"/>
              <a:pPr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01142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svg"/><Relationship Id="rId3" Type="http://schemas.openxmlformats.org/officeDocument/2006/relationships/image" Target="../media/image8.png"/><Relationship Id="rId7" Type="http://schemas.openxmlformats.org/officeDocument/2006/relationships/image" Target="../media/image5.png"/><Relationship Id="rId2" Type="http://schemas.openxmlformats.org/officeDocument/2006/relationships/image" Target="../media/image7.png"/><Relationship Id="rId1" Type="http://schemas.openxmlformats.org/officeDocument/2006/relationships/slideMaster" Target="../slideMasters/slideMaster1.xml"/><Relationship Id="rId6" Type="http://schemas.openxmlformats.org/officeDocument/2006/relationships/image" Target="../media/image11.svg"/><Relationship Id="rId5" Type="http://schemas.openxmlformats.org/officeDocument/2006/relationships/image" Target="../media/image10.png"/><Relationship Id="rId4" Type="http://schemas.openxmlformats.org/officeDocument/2006/relationships/image" Target="../media/image9.svg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Master" Target="../slideMasters/slideMaster1.xml"/><Relationship Id="rId6" Type="http://schemas.openxmlformats.org/officeDocument/2006/relationships/image" Target="../media/image28.svg"/><Relationship Id="rId5" Type="http://schemas.openxmlformats.org/officeDocument/2006/relationships/image" Target="../media/image27.png"/><Relationship Id="rId4" Type="http://schemas.openxmlformats.org/officeDocument/2006/relationships/image" Target="../media/image26.svg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9.png"/><Relationship Id="rId1" Type="http://schemas.openxmlformats.org/officeDocument/2006/relationships/slideMaster" Target="../slideMasters/slideMaster1.xml"/><Relationship Id="rId6" Type="http://schemas.openxmlformats.org/officeDocument/2006/relationships/image" Target="../media/image28.svg"/><Relationship Id="rId5" Type="http://schemas.openxmlformats.org/officeDocument/2006/relationships/image" Target="../media/image27.png"/><Relationship Id="rId4" Type="http://schemas.openxmlformats.org/officeDocument/2006/relationships/image" Target="../media/image26.svg"/></Relationships>
</file>

<file path=ppt/slideLayouts/_rels/slideLayout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3" Type="http://schemas.openxmlformats.org/officeDocument/2006/relationships/image" Target="../media/image31.svg"/><Relationship Id="rId7" Type="http://schemas.openxmlformats.org/officeDocument/2006/relationships/image" Target="../media/image33.svg"/><Relationship Id="rId2" Type="http://schemas.openxmlformats.org/officeDocument/2006/relationships/image" Target="../media/image30.png"/><Relationship Id="rId1" Type="http://schemas.openxmlformats.org/officeDocument/2006/relationships/slideMaster" Target="../slideMasters/slideMaster1.xml"/><Relationship Id="rId6" Type="http://schemas.openxmlformats.org/officeDocument/2006/relationships/image" Target="../media/image32.png"/><Relationship Id="rId5" Type="http://schemas.openxmlformats.org/officeDocument/2006/relationships/image" Target="../media/image26.svg"/><Relationship Id="rId4" Type="http://schemas.openxmlformats.org/officeDocument/2006/relationships/image" Target="../media/image25.png"/><Relationship Id="rId9" Type="http://schemas.openxmlformats.org/officeDocument/2006/relationships/image" Target="../media/image28.svg"/></Relationships>
</file>

<file path=ppt/slideLayouts/_rels/slideLayout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34.png"/><Relationship Id="rId1" Type="http://schemas.openxmlformats.org/officeDocument/2006/relationships/slideMaster" Target="../slideMasters/slideMaster1.xml"/><Relationship Id="rId6" Type="http://schemas.openxmlformats.org/officeDocument/2006/relationships/image" Target="../media/image28.svg"/><Relationship Id="rId5" Type="http://schemas.openxmlformats.org/officeDocument/2006/relationships/image" Target="../media/image27.png"/><Relationship Id="rId4" Type="http://schemas.openxmlformats.org/officeDocument/2006/relationships/image" Target="../media/image26.svg"/></Relationships>
</file>

<file path=ppt/slideLayouts/_rels/slideLayout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svg"/><Relationship Id="rId2" Type="http://schemas.openxmlformats.org/officeDocument/2006/relationships/image" Target="../media/image25.png"/><Relationship Id="rId1" Type="http://schemas.openxmlformats.org/officeDocument/2006/relationships/slideMaster" Target="../slideMasters/slideMaster1.xml"/><Relationship Id="rId5" Type="http://schemas.openxmlformats.org/officeDocument/2006/relationships/image" Target="../media/image28.svg"/><Relationship Id="rId4" Type="http://schemas.openxmlformats.org/officeDocument/2006/relationships/image" Target="../media/image27.png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svg"/><Relationship Id="rId2" Type="http://schemas.openxmlformats.org/officeDocument/2006/relationships/image" Target="../media/image35.png"/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svg"/><Relationship Id="rId2" Type="http://schemas.openxmlformats.org/officeDocument/2006/relationships/image" Target="../media/image37.png"/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svg"/><Relationship Id="rId2" Type="http://schemas.openxmlformats.org/officeDocument/2006/relationships/image" Target="../media/image39.png"/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svg"/><Relationship Id="rId7" Type="http://schemas.openxmlformats.org/officeDocument/2006/relationships/image" Target="../media/image17.svg"/><Relationship Id="rId2" Type="http://schemas.openxmlformats.org/officeDocument/2006/relationships/image" Target="../media/image12.png"/><Relationship Id="rId1" Type="http://schemas.openxmlformats.org/officeDocument/2006/relationships/slideMaster" Target="../slideMasters/slideMaster1.xml"/><Relationship Id="rId6" Type="http://schemas.openxmlformats.org/officeDocument/2006/relationships/image" Target="../media/image16.png"/><Relationship Id="rId5" Type="http://schemas.openxmlformats.org/officeDocument/2006/relationships/image" Target="../media/image15.svg"/><Relationship Id="rId4" Type="http://schemas.openxmlformats.org/officeDocument/2006/relationships/image" Target="../media/image14.png"/></Relationships>
</file>

<file path=ppt/slideLayouts/_rels/slideLayout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png"/><Relationship Id="rId1" Type="http://schemas.openxmlformats.org/officeDocument/2006/relationships/slideMaster" Target="../slideMasters/slideMaster1.xml"/></Relationships>
</file>

<file path=ppt/slideLayouts/_rels/slideLayout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png"/><Relationship Id="rId1" Type="http://schemas.openxmlformats.org/officeDocument/2006/relationships/slideMaster" Target="../slideMasters/slideMaster1.xml"/></Relationships>
</file>

<file path=ppt/slideLayouts/_rels/slideLayout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png"/><Relationship Id="rId1" Type="http://schemas.openxmlformats.org/officeDocument/2006/relationships/slideMaster" Target="../slideMasters/slideMaster1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eg"/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svg"/><Relationship Id="rId2" Type="http://schemas.openxmlformats.org/officeDocument/2006/relationships/image" Target="../media/image45.png"/><Relationship Id="rId1" Type="http://schemas.openxmlformats.org/officeDocument/2006/relationships/slideMaster" Target="../slideMasters/slideMaster1.xml"/></Relationships>
</file>

<file path=ppt/slideLayouts/_rels/slideLayout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7.png"/><Relationship Id="rId1" Type="http://schemas.openxmlformats.org/officeDocument/2006/relationships/slideMaster" Target="../slideMasters/slideMaster1.xml"/></Relationships>
</file>

<file path=ppt/slideLayouts/_rels/slideLayout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7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svg"/><Relationship Id="rId2" Type="http://schemas.openxmlformats.org/officeDocument/2006/relationships/image" Target="../media/image19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hyperlink" Target="http://www.rbup.no/" TargetMode="External"/><Relationship Id="rId2" Type="http://schemas.openxmlformats.org/officeDocument/2006/relationships/image" Target="../media/image21.png"/><Relationship Id="rId1" Type="http://schemas.openxmlformats.org/officeDocument/2006/relationships/slideMaster" Target="../slideMasters/slideMaster1.xml"/><Relationship Id="rId5" Type="http://schemas.openxmlformats.org/officeDocument/2006/relationships/image" Target="../media/image4.svg"/><Relationship Id="rId4" Type="http://schemas.openxmlformats.org/officeDocument/2006/relationships/image" Target="../media/image3.png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Master" Target="../slideMasters/slideMaster1.xml"/><Relationship Id="rId6" Type="http://schemas.openxmlformats.org/officeDocument/2006/relationships/image" Target="../media/image11.svg"/><Relationship Id="rId5" Type="http://schemas.openxmlformats.org/officeDocument/2006/relationships/image" Target="../media/image10.png"/><Relationship Id="rId4" Type="http://schemas.openxmlformats.org/officeDocument/2006/relationships/image" Target="../media/image9.svg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jpeg"/><Relationship Id="rId7" Type="http://schemas.openxmlformats.org/officeDocument/2006/relationships/image" Target="../media/image11.svg"/><Relationship Id="rId2" Type="http://schemas.openxmlformats.org/officeDocument/2006/relationships/image" Target="../media/image22.png"/><Relationship Id="rId1" Type="http://schemas.openxmlformats.org/officeDocument/2006/relationships/slideMaster" Target="../slideMasters/slideMaster1.xml"/><Relationship Id="rId6" Type="http://schemas.openxmlformats.org/officeDocument/2006/relationships/image" Target="../media/image10.png"/><Relationship Id="rId5" Type="http://schemas.openxmlformats.org/officeDocument/2006/relationships/image" Target="../media/image9.svg"/><Relationship Id="rId4" Type="http://schemas.openxmlformats.org/officeDocument/2006/relationships/image" Target="../media/image8.png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Forside RBUP">
    <p:bg>
      <p:bgPr>
        <a:solidFill>
          <a:schemeClr val="accent5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55CAB40B-704E-4695-9742-891A1684D576}"/>
              </a:ext>
            </a:extLst>
          </p:cNvPr>
          <p:cNvSpPr/>
          <p:nvPr userDrawn="1"/>
        </p:nvSpPr>
        <p:spPr>
          <a:xfrm>
            <a:off x="6299200" y="6718905"/>
            <a:ext cx="5892800" cy="139096"/>
          </a:xfrm>
          <a:prstGeom prst="rect">
            <a:avLst/>
          </a:prstGeom>
          <a:solidFill>
            <a:srgbClr val="E3DCD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2" name="Picture 21" descr="A picture containing venn diagram  Description automatically generated">
            <a:extLst>
              <a:ext uri="{FF2B5EF4-FFF2-40B4-BE49-F238E27FC236}">
                <a16:creationId xmlns:a16="http://schemas.microsoft.com/office/drawing/2014/main" id="{2967F070-C292-44DA-9559-0DAD792F17AE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9892" y="994102"/>
            <a:ext cx="8732108" cy="5863898"/>
          </a:xfrm>
          <a:prstGeom prst="rect">
            <a:avLst/>
          </a:prstGeom>
        </p:spPr>
      </p:pic>
      <p:pic>
        <p:nvPicPr>
          <p:cNvPr id="10" name="Graphic 9">
            <a:extLst>
              <a:ext uri="{FF2B5EF4-FFF2-40B4-BE49-F238E27FC236}">
                <a16:creationId xmlns:a16="http://schemas.microsoft.com/office/drawing/2014/main" id="{D6B5AA2E-9626-49A2-9CF4-6B0AF6ECA62D}"/>
              </a:ext>
            </a:extLst>
          </p:cNvPr>
          <p:cNvPicPr>
            <a:picLocks noChangeAspect="1"/>
          </p:cNvPicPr>
          <p:nvPr userDrawn="1"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2535291" y="534913"/>
            <a:ext cx="1452509" cy="391834"/>
          </a:xfrm>
          <a:prstGeom prst="rect">
            <a:avLst/>
          </a:prstGeom>
        </p:spPr>
      </p:pic>
      <p:pic>
        <p:nvPicPr>
          <p:cNvPr id="5" name="Graphic 4">
            <a:extLst>
              <a:ext uri="{FF2B5EF4-FFF2-40B4-BE49-F238E27FC236}">
                <a16:creationId xmlns:a16="http://schemas.microsoft.com/office/drawing/2014/main" id="{9DD12F87-B997-488E-81CD-3D5A71EB679C}"/>
              </a:ext>
            </a:extLst>
          </p:cNvPr>
          <p:cNvPicPr>
            <a:picLocks noChangeAspect="1"/>
          </p:cNvPicPr>
          <p:nvPr userDrawn="1"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44617" y="534914"/>
            <a:ext cx="1737263" cy="372746"/>
          </a:xfrm>
          <a:prstGeom prst="rect">
            <a:avLst/>
          </a:prstGeom>
        </p:spPr>
      </p:pic>
      <p:sp>
        <p:nvSpPr>
          <p:cNvPr id="12" name="Tittel 1">
            <a:extLst>
              <a:ext uri="{FF2B5EF4-FFF2-40B4-BE49-F238E27FC236}">
                <a16:creationId xmlns:a16="http://schemas.microsoft.com/office/drawing/2014/main" id="{2CD5DF7F-7A8A-3649-AE4E-FC96E1AECB0C}"/>
              </a:ext>
            </a:extLst>
          </p:cNvPr>
          <p:cNvSpPr txBox="1">
            <a:spLocks/>
          </p:cNvSpPr>
          <p:nvPr userDrawn="1"/>
        </p:nvSpPr>
        <p:spPr>
          <a:xfrm>
            <a:off x="1020016" y="1153266"/>
            <a:ext cx="4443283" cy="2387600"/>
          </a:xfrm>
          <a:prstGeom prst="rect">
            <a:avLst/>
          </a:prstGeom>
        </p:spPr>
        <p:txBody>
          <a:bodyPr vert="horz" lIns="0" tIns="0" rIns="0" bIns="0" rtlCol="0" anchor="b" anchorCtr="0">
            <a:normAutofit/>
          </a:bodyPr>
          <a:lstStyle>
            <a:lvl1pPr algn="l" defTabSz="914446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 sz="3501" b="1" kern="1200" dirty="0">
                <a:solidFill>
                  <a:schemeClr val="bg1"/>
                </a:solidFill>
                <a:latin typeface="+mj-lt"/>
                <a:ea typeface="+mj-ea"/>
                <a:cs typeface="+mj-cs"/>
              </a:rPr>
              <a:t>Kompetansesenter for barn og unges psykiske helse</a:t>
            </a:r>
          </a:p>
        </p:txBody>
      </p:sp>
      <p:sp>
        <p:nvSpPr>
          <p:cNvPr id="13" name="Undertittel 2">
            <a:extLst>
              <a:ext uri="{FF2B5EF4-FFF2-40B4-BE49-F238E27FC236}">
                <a16:creationId xmlns:a16="http://schemas.microsoft.com/office/drawing/2014/main" id="{D6F29D64-3AA7-AE46-B163-08409B5F8029}"/>
              </a:ext>
            </a:extLst>
          </p:cNvPr>
          <p:cNvSpPr txBox="1">
            <a:spLocks/>
          </p:cNvSpPr>
          <p:nvPr userDrawn="1"/>
        </p:nvSpPr>
        <p:spPr>
          <a:xfrm>
            <a:off x="1020016" y="3735403"/>
            <a:ext cx="4443283" cy="1764696"/>
          </a:xfrm>
          <a:prstGeom prst="rect">
            <a:avLst/>
          </a:prstGeom>
        </p:spPr>
        <p:txBody>
          <a:bodyPr vert="horz" lIns="0" tIns="0" rIns="0" bIns="0" rtlCol="0" anchor="t">
            <a:normAutofit/>
          </a:bodyPr>
          <a:lstStyle>
            <a:lvl1pPr marL="406481" indent="-406481" algn="l" defTabSz="914446" rtl="0" eaLnBrk="1" latinLnBrk="0" hangingPunct="1">
              <a:lnSpc>
                <a:spcPct val="110000"/>
              </a:lnSpc>
              <a:spcBef>
                <a:spcPts val="1200"/>
              </a:spcBef>
              <a:buSzPct val="100000"/>
              <a:buFontTx/>
              <a:buBlip>
                <a:blip r:embed="rId7">
                  <a:extLst>
                    <a:ext uri="{96DAC541-7B7A-43D3-8B79-37D633B846F1}">
                      <asvg:svgBlip xmlns:asvg="http://schemas.microsoft.com/office/drawing/2016/SVG/main" r:embed="rId8"/>
                    </a:ext>
                  </a:extLst>
                </a:blip>
              </a:buBlip>
              <a:defRPr sz="2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809787" indent="-407275" algn="l" defTabSz="914446" rtl="0" eaLnBrk="1" latinLnBrk="0" hangingPunct="1">
              <a:lnSpc>
                <a:spcPct val="110000"/>
              </a:lnSpc>
              <a:spcBef>
                <a:spcPts val="600"/>
              </a:spcBef>
              <a:buClr>
                <a:srgbClr val="94ABF7"/>
              </a:buClr>
              <a:buFont typeface="Arial" panose="020B0604020202020204" pitchFamily="34" charset="0"/>
              <a:buChar char="●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257300" indent="-447675" algn="l" defTabSz="914446" rtl="0" eaLnBrk="1" latinLnBrk="0" hangingPunct="1">
              <a:lnSpc>
                <a:spcPct val="110000"/>
              </a:lnSpc>
              <a:spcBef>
                <a:spcPts val="600"/>
              </a:spcBef>
              <a:buClr>
                <a:srgbClr val="94ABF7"/>
              </a:buClr>
              <a:buFont typeface="Arial" panose="020B0604020202020204" pitchFamily="34" charset="0"/>
              <a:buChar char="■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793875" indent="-422275" algn="l" defTabSz="914446" rtl="0" eaLnBrk="1" latinLnBrk="0" hangingPunct="1">
              <a:lnSpc>
                <a:spcPct val="110000"/>
              </a:lnSpc>
              <a:spcBef>
                <a:spcPts val="600"/>
              </a:spcBef>
              <a:buClr>
                <a:srgbClr val="94ABF7"/>
              </a:buClr>
              <a:buFont typeface="Arial" panose="020B0604020202020204" pitchFamily="34" charset="0"/>
              <a:buChar char="■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241550" indent="-412750" algn="l" defTabSz="914446" rtl="0" eaLnBrk="1" latinLnBrk="0" hangingPunct="1">
              <a:lnSpc>
                <a:spcPct val="110000"/>
              </a:lnSpc>
              <a:spcBef>
                <a:spcPts val="600"/>
              </a:spcBef>
              <a:buClr>
                <a:srgbClr val="94ABF7"/>
              </a:buClr>
              <a:buFont typeface="Arial" panose="020B0604020202020204" pitchFamily="34" charset="0"/>
              <a:buChar char="■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726" indent="-228611" algn="l" defTabSz="914446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948" indent="-228611" algn="l" defTabSz="914446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171" indent="-228611" algn="l" defTabSz="914446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394" indent="-228611" algn="l" defTabSz="914446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nb-NO" sz="1500" b="1" kern="1200" dirty="0">
                <a:solidFill>
                  <a:schemeClr val="bg1"/>
                </a:solidFill>
                <a:latin typeface="+mn-lt"/>
                <a:ea typeface="+mn-ea"/>
                <a:cs typeface="+mn-cs"/>
              </a:rPr>
              <a:t>En kort introduksjon til RBUP</a:t>
            </a:r>
          </a:p>
        </p:txBody>
      </p:sp>
    </p:spTree>
    <p:extLst>
      <p:ext uri="{BB962C8B-B14F-4D97-AF65-F5344CB8AC3E}">
        <p14:creationId xmlns:p14="http://schemas.microsoft.com/office/powerpoint/2010/main" val="42211983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Forside blå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 descr="Venn diagram  Description automatically generated">
            <a:extLst>
              <a:ext uri="{FF2B5EF4-FFF2-40B4-BE49-F238E27FC236}">
                <a16:creationId xmlns:a16="http://schemas.microsoft.com/office/drawing/2014/main" id="{69F6A221-31F5-470F-886D-658B0C5C2510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9892" y="994101"/>
            <a:ext cx="8732108" cy="5876255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20016" y="1153266"/>
            <a:ext cx="4443283" cy="2387600"/>
          </a:xfrm>
        </p:spPr>
        <p:txBody>
          <a:bodyPr lIns="0" tIns="0" rIns="0" bIns="0" anchor="b">
            <a:normAutofit/>
          </a:bodyPr>
          <a:lstStyle>
            <a:lvl1pPr algn="l">
              <a:lnSpc>
                <a:spcPct val="110000"/>
              </a:lnSpc>
              <a:defRPr sz="3501" b="1"/>
            </a:lvl1pPr>
          </a:lstStyle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0016" y="3735403"/>
            <a:ext cx="4443283" cy="1764696"/>
          </a:xfrm>
        </p:spPr>
        <p:txBody>
          <a:bodyPr lIns="0" tIns="0" rIns="0" bIns="0">
            <a:normAutofit/>
          </a:bodyPr>
          <a:lstStyle>
            <a:lvl1pPr marL="0" indent="0" algn="l">
              <a:buNone/>
              <a:defRPr sz="1500" b="1"/>
            </a:lvl1pPr>
            <a:lvl2pPr marL="457223" indent="0" algn="ctr">
              <a:buNone/>
              <a:defRPr sz="2000"/>
            </a:lvl2pPr>
            <a:lvl3pPr marL="914446" indent="0" algn="ctr">
              <a:buNone/>
              <a:defRPr sz="1800"/>
            </a:lvl3pPr>
            <a:lvl4pPr marL="1371669" indent="0" algn="ctr">
              <a:buNone/>
              <a:defRPr sz="1600"/>
            </a:lvl4pPr>
            <a:lvl5pPr marL="1828891" indent="0" algn="ctr">
              <a:buNone/>
              <a:defRPr sz="1600"/>
            </a:lvl5pPr>
            <a:lvl6pPr marL="2286114" indent="0" algn="ctr">
              <a:buNone/>
              <a:defRPr sz="1600"/>
            </a:lvl6pPr>
            <a:lvl7pPr marL="2743337" indent="0" algn="ctr">
              <a:buNone/>
              <a:defRPr sz="1600"/>
            </a:lvl7pPr>
            <a:lvl8pPr marL="3200560" indent="0" algn="ctr">
              <a:buNone/>
              <a:defRPr sz="1600"/>
            </a:lvl8pPr>
            <a:lvl9pPr marL="3657783" indent="0" algn="ctr">
              <a:buNone/>
              <a:defRPr sz="1600"/>
            </a:lvl9pPr>
          </a:lstStyle>
          <a:p>
            <a:r>
              <a:rPr lang="nb-NO"/>
              <a:t>Klikk for å redigere undertittelstil i malen</a:t>
            </a:r>
            <a:endParaRPr lang="en-US" dirty="0"/>
          </a:p>
        </p:txBody>
      </p:sp>
      <p:pic>
        <p:nvPicPr>
          <p:cNvPr id="7" name="Graphic 6">
            <a:extLst>
              <a:ext uri="{FF2B5EF4-FFF2-40B4-BE49-F238E27FC236}">
                <a16:creationId xmlns:a16="http://schemas.microsoft.com/office/drawing/2014/main" id="{5E52912F-49FF-47E3-8CB0-3A24E707119D}"/>
              </a:ext>
            </a:extLst>
          </p:cNvPr>
          <p:cNvPicPr>
            <a:picLocks noChangeAspect="1"/>
          </p:cNvPicPr>
          <p:nvPr userDrawn="1"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2535291" y="534913"/>
            <a:ext cx="1452509" cy="391834"/>
          </a:xfrm>
          <a:prstGeom prst="rect">
            <a:avLst/>
          </a:prstGeom>
        </p:spPr>
      </p:pic>
      <p:pic>
        <p:nvPicPr>
          <p:cNvPr id="10" name="Graphic 9">
            <a:extLst>
              <a:ext uri="{FF2B5EF4-FFF2-40B4-BE49-F238E27FC236}">
                <a16:creationId xmlns:a16="http://schemas.microsoft.com/office/drawing/2014/main" id="{7D246C38-BA2F-4B45-9693-11953DF7C0A0}"/>
              </a:ext>
            </a:extLst>
          </p:cNvPr>
          <p:cNvPicPr>
            <a:picLocks noChangeAspect="1"/>
          </p:cNvPicPr>
          <p:nvPr userDrawn="1"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44617" y="534914"/>
            <a:ext cx="1737263" cy="3727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631628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Forside g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 descr="Shape, circle  Description automatically generated">
            <a:extLst>
              <a:ext uri="{FF2B5EF4-FFF2-40B4-BE49-F238E27FC236}">
                <a16:creationId xmlns:a16="http://schemas.microsoft.com/office/drawing/2014/main" id="{489255EC-1B9E-42D9-B9DB-A64B6F648D2A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1788"/>
          <a:stretch/>
        </p:blipFill>
        <p:spPr>
          <a:xfrm>
            <a:off x="5765800" y="0"/>
            <a:ext cx="58293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20016" y="1153266"/>
            <a:ext cx="4443283" cy="2387600"/>
          </a:xfrm>
        </p:spPr>
        <p:txBody>
          <a:bodyPr lIns="0" tIns="0" rIns="0" bIns="0" anchor="b">
            <a:normAutofit/>
          </a:bodyPr>
          <a:lstStyle>
            <a:lvl1pPr algn="l">
              <a:lnSpc>
                <a:spcPct val="110000"/>
              </a:lnSpc>
              <a:defRPr sz="3501" b="1"/>
            </a:lvl1pPr>
          </a:lstStyle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0016" y="3735403"/>
            <a:ext cx="4443283" cy="1764696"/>
          </a:xfrm>
        </p:spPr>
        <p:txBody>
          <a:bodyPr lIns="0" tIns="0" rIns="0" bIns="0">
            <a:normAutofit/>
          </a:bodyPr>
          <a:lstStyle>
            <a:lvl1pPr marL="0" indent="0" algn="l">
              <a:buNone/>
              <a:defRPr sz="1500" b="1"/>
            </a:lvl1pPr>
            <a:lvl2pPr marL="457223" indent="0" algn="ctr">
              <a:buNone/>
              <a:defRPr sz="2000"/>
            </a:lvl2pPr>
            <a:lvl3pPr marL="914446" indent="0" algn="ctr">
              <a:buNone/>
              <a:defRPr sz="1800"/>
            </a:lvl3pPr>
            <a:lvl4pPr marL="1371669" indent="0" algn="ctr">
              <a:buNone/>
              <a:defRPr sz="1600"/>
            </a:lvl4pPr>
            <a:lvl5pPr marL="1828891" indent="0" algn="ctr">
              <a:buNone/>
              <a:defRPr sz="1600"/>
            </a:lvl5pPr>
            <a:lvl6pPr marL="2286114" indent="0" algn="ctr">
              <a:buNone/>
              <a:defRPr sz="1600"/>
            </a:lvl6pPr>
            <a:lvl7pPr marL="2743337" indent="0" algn="ctr">
              <a:buNone/>
              <a:defRPr sz="1600"/>
            </a:lvl7pPr>
            <a:lvl8pPr marL="3200560" indent="0" algn="ctr">
              <a:buNone/>
              <a:defRPr sz="1600"/>
            </a:lvl8pPr>
            <a:lvl9pPr marL="3657783" indent="0" algn="ctr">
              <a:buNone/>
              <a:defRPr sz="1600"/>
            </a:lvl9pPr>
          </a:lstStyle>
          <a:p>
            <a:r>
              <a:rPr lang="nb-NO"/>
              <a:t>Klikk for å redigere undertittelstil i malen</a:t>
            </a:r>
            <a:endParaRPr lang="en-US" dirty="0"/>
          </a:p>
        </p:txBody>
      </p:sp>
      <p:pic>
        <p:nvPicPr>
          <p:cNvPr id="8" name="Graphic 7">
            <a:extLst>
              <a:ext uri="{FF2B5EF4-FFF2-40B4-BE49-F238E27FC236}">
                <a16:creationId xmlns:a16="http://schemas.microsoft.com/office/drawing/2014/main" id="{B4D1CAD8-84C6-4218-81FB-4656613AB7A5}"/>
              </a:ext>
            </a:extLst>
          </p:cNvPr>
          <p:cNvPicPr>
            <a:picLocks noChangeAspect="1"/>
          </p:cNvPicPr>
          <p:nvPr userDrawn="1"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2535291" y="534913"/>
            <a:ext cx="1452509" cy="391834"/>
          </a:xfrm>
          <a:prstGeom prst="rect">
            <a:avLst/>
          </a:prstGeom>
        </p:spPr>
      </p:pic>
      <p:pic>
        <p:nvPicPr>
          <p:cNvPr id="7" name="Graphic 6">
            <a:extLst>
              <a:ext uri="{FF2B5EF4-FFF2-40B4-BE49-F238E27FC236}">
                <a16:creationId xmlns:a16="http://schemas.microsoft.com/office/drawing/2014/main" id="{8235705C-9822-4DCC-8A03-F2775BC2501D}"/>
              </a:ext>
            </a:extLst>
          </p:cNvPr>
          <p:cNvPicPr>
            <a:picLocks noChangeAspect="1"/>
          </p:cNvPicPr>
          <p:nvPr userDrawn="1"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44617" y="534914"/>
            <a:ext cx="1737263" cy="3727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1318366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Forside gul 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Graphic 5">
            <a:extLst>
              <a:ext uri="{FF2B5EF4-FFF2-40B4-BE49-F238E27FC236}">
                <a16:creationId xmlns:a16="http://schemas.microsoft.com/office/drawing/2014/main" id="{62841CB0-AF14-46ED-89D8-9B3FC1825D93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b="32314"/>
          <a:stretch/>
        </p:blipFill>
        <p:spPr>
          <a:xfrm>
            <a:off x="5765635" y="2921000"/>
            <a:ext cx="5827348" cy="3937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20016" y="1153266"/>
            <a:ext cx="4443283" cy="2387600"/>
          </a:xfrm>
        </p:spPr>
        <p:txBody>
          <a:bodyPr lIns="0" tIns="0" rIns="0" bIns="0" anchor="b">
            <a:normAutofit/>
          </a:bodyPr>
          <a:lstStyle>
            <a:lvl1pPr algn="l">
              <a:lnSpc>
                <a:spcPct val="110000"/>
              </a:lnSpc>
              <a:defRPr sz="3501" b="1"/>
            </a:lvl1pPr>
          </a:lstStyle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0016" y="3735403"/>
            <a:ext cx="4443283" cy="1764696"/>
          </a:xfrm>
        </p:spPr>
        <p:txBody>
          <a:bodyPr lIns="0" tIns="0" rIns="0" bIns="0">
            <a:normAutofit/>
          </a:bodyPr>
          <a:lstStyle>
            <a:lvl1pPr marL="0" indent="0" algn="l">
              <a:buNone/>
              <a:defRPr sz="1500" b="1"/>
            </a:lvl1pPr>
            <a:lvl2pPr marL="457223" indent="0" algn="ctr">
              <a:buNone/>
              <a:defRPr sz="2000"/>
            </a:lvl2pPr>
            <a:lvl3pPr marL="914446" indent="0" algn="ctr">
              <a:buNone/>
              <a:defRPr sz="1800"/>
            </a:lvl3pPr>
            <a:lvl4pPr marL="1371669" indent="0" algn="ctr">
              <a:buNone/>
              <a:defRPr sz="1600"/>
            </a:lvl4pPr>
            <a:lvl5pPr marL="1828891" indent="0" algn="ctr">
              <a:buNone/>
              <a:defRPr sz="1600"/>
            </a:lvl5pPr>
            <a:lvl6pPr marL="2286114" indent="0" algn="ctr">
              <a:buNone/>
              <a:defRPr sz="1600"/>
            </a:lvl6pPr>
            <a:lvl7pPr marL="2743337" indent="0" algn="ctr">
              <a:buNone/>
              <a:defRPr sz="1600"/>
            </a:lvl7pPr>
            <a:lvl8pPr marL="3200560" indent="0" algn="ctr">
              <a:buNone/>
              <a:defRPr sz="1600"/>
            </a:lvl8pPr>
            <a:lvl9pPr marL="3657783" indent="0" algn="ctr">
              <a:buNone/>
              <a:defRPr sz="1600"/>
            </a:lvl9pPr>
          </a:lstStyle>
          <a:p>
            <a:r>
              <a:rPr lang="nb-NO"/>
              <a:t>Klikk for å redigere undertittelstil i malen</a:t>
            </a:r>
            <a:endParaRPr lang="en-US" dirty="0"/>
          </a:p>
        </p:txBody>
      </p:sp>
      <p:sp>
        <p:nvSpPr>
          <p:cNvPr id="42" name="Picture Placeholder 41">
            <a:extLst>
              <a:ext uri="{FF2B5EF4-FFF2-40B4-BE49-F238E27FC236}">
                <a16:creationId xmlns:a16="http://schemas.microsoft.com/office/drawing/2014/main" id="{C2515012-5C0B-4EA5-A0BC-35D8E2C2464B}"/>
              </a:ext>
            </a:extLst>
          </p:cNvPr>
          <p:cNvSpPr>
            <a:spLocks noGrp="1"/>
          </p:cNvSpPr>
          <p:nvPr>
            <p:ph type="pic" sz="quarter" idx="10"/>
          </p:nvPr>
        </p:nvSpPr>
        <p:spPr>
          <a:xfrm>
            <a:off x="5765800" y="0"/>
            <a:ext cx="5852583" cy="5820505"/>
          </a:xfrm>
          <a:custGeom>
            <a:avLst/>
            <a:gdLst>
              <a:gd name="connsiteX0" fmla="*/ 0 w 11762465"/>
              <a:gd name="connsiteY0" fmla="*/ 0 h 11639664"/>
              <a:gd name="connsiteX1" fmla="*/ 11762463 w 11762465"/>
              <a:gd name="connsiteY1" fmla="*/ 0 h 11639664"/>
              <a:gd name="connsiteX2" fmla="*/ 11762463 w 11762465"/>
              <a:gd name="connsiteY2" fmla="*/ 5594657 h 11639664"/>
              <a:gd name="connsiteX3" fmla="*/ 11758707 w 11762465"/>
              <a:gd name="connsiteY3" fmla="*/ 5594657 h 11639664"/>
              <a:gd name="connsiteX4" fmla="*/ 11762465 w 11762465"/>
              <a:gd name="connsiteY4" fmla="*/ 5743633 h 11639664"/>
              <a:gd name="connsiteX5" fmla="*/ 5880849 w 11762465"/>
              <a:gd name="connsiteY5" fmla="*/ 11639664 h 11639664"/>
              <a:gd name="connsiteX6" fmla="*/ 6885 w 11762465"/>
              <a:gd name="connsiteY6" fmla="*/ 6047042 h 11639664"/>
              <a:gd name="connsiteX7" fmla="*/ 0 w 11762465"/>
              <a:gd name="connsiteY7" fmla="*/ 5774080 h 11639664"/>
              <a:gd name="connsiteX8" fmla="*/ 0 w 11762465"/>
              <a:gd name="connsiteY8" fmla="*/ 5713189 h 11639664"/>
              <a:gd name="connsiteX9" fmla="*/ 2990 w 11762465"/>
              <a:gd name="connsiteY9" fmla="*/ 5594657 h 11639664"/>
              <a:gd name="connsiteX10" fmla="*/ 0 w 11762465"/>
              <a:gd name="connsiteY10" fmla="*/ 5594657 h 1163966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</a:cxnLst>
            <a:rect l="l" t="t" r="r" b="b"/>
            <a:pathLst>
              <a:path w="11762465" h="11639664">
                <a:moveTo>
                  <a:pt x="0" y="0"/>
                </a:moveTo>
                <a:lnTo>
                  <a:pt x="11762463" y="0"/>
                </a:lnTo>
                <a:lnTo>
                  <a:pt x="11762463" y="5594657"/>
                </a:lnTo>
                <a:lnTo>
                  <a:pt x="11758707" y="5594657"/>
                </a:lnTo>
                <a:lnTo>
                  <a:pt x="11762465" y="5743633"/>
                </a:lnTo>
                <a:cubicBezTo>
                  <a:pt x="11762465" y="8999921"/>
                  <a:pt x="9129175" y="11639664"/>
                  <a:pt x="5880849" y="11639664"/>
                </a:cubicBezTo>
                <a:cubicBezTo>
                  <a:pt x="2734031" y="11639664"/>
                  <a:pt x="164413" y="9162327"/>
                  <a:pt x="6885" y="6047042"/>
                </a:cubicBezTo>
                <a:lnTo>
                  <a:pt x="0" y="5774080"/>
                </a:lnTo>
                <a:lnTo>
                  <a:pt x="0" y="5713189"/>
                </a:lnTo>
                <a:lnTo>
                  <a:pt x="2990" y="5594657"/>
                </a:lnTo>
                <a:lnTo>
                  <a:pt x="0" y="5594657"/>
                </a:lnTo>
                <a:close/>
              </a:path>
            </a:pathLst>
          </a:custGeom>
          <a:solidFill>
            <a:schemeClr val="bg1">
              <a:lumMod val="75000"/>
            </a:schemeClr>
          </a:solidFill>
        </p:spPr>
        <p:txBody>
          <a:bodyPr wrap="square">
            <a:noAutofit/>
          </a:bodyPr>
          <a:lstStyle>
            <a:lvl1pPr marL="0" indent="0">
              <a:buNone/>
              <a:defRPr/>
            </a:lvl1pPr>
          </a:lstStyle>
          <a:p>
            <a:r>
              <a:rPr lang="nb-NO"/>
              <a:t>Klikk på ikonet for å legge til et bilde</a:t>
            </a:r>
            <a:endParaRPr lang="en-US" dirty="0"/>
          </a:p>
        </p:txBody>
      </p:sp>
      <p:pic>
        <p:nvPicPr>
          <p:cNvPr id="9" name="Graphic 8">
            <a:extLst>
              <a:ext uri="{FF2B5EF4-FFF2-40B4-BE49-F238E27FC236}">
                <a16:creationId xmlns:a16="http://schemas.microsoft.com/office/drawing/2014/main" id="{10281902-E29F-488C-B901-59A091184B6C}"/>
              </a:ext>
            </a:extLst>
          </p:cNvPr>
          <p:cNvPicPr>
            <a:picLocks noChangeAspect="1"/>
          </p:cNvPicPr>
          <p:nvPr userDrawn="1"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2535291" y="534913"/>
            <a:ext cx="1452509" cy="391834"/>
          </a:xfrm>
          <a:prstGeom prst="rect">
            <a:avLst/>
          </a:prstGeom>
        </p:spPr>
      </p:pic>
      <p:sp>
        <p:nvSpPr>
          <p:cNvPr id="15" name="Text Placeholder 4">
            <a:extLst>
              <a:ext uri="{FF2B5EF4-FFF2-40B4-BE49-F238E27FC236}">
                <a16:creationId xmlns:a16="http://schemas.microsoft.com/office/drawing/2014/main" id="{654C42E4-CED3-4A94-8367-BF2CFF54185A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5783579" y="2942253"/>
            <a:ext cx="5791201" cy="3858597"/>
          </a:xfrm>
          <a:blipFill dpi="0" rotWithShape="1">
            <a:blip r:embed="rId6">
              <a:alphaModFix amt="68000"/>
              <a:extLst>
                <a:ext uri="{96DAC541-7B7A-43D3-8B79-37D633B846F1}">
                  <asvg:svgBlip xmlns:asvg="http://schemas.microsoft.com/office/drawing/2016/SVG/main" r:embed="rId7"/>
                </a:ext>
              </a:extLst>
            </a:blip>
            <a:srcRect/>
            <a:stretch>
              <a:fillRect/>
            </a:stretch>
          </a:blipFill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r>
              <a:rPr lang="nb-NO" dirty="0"/>
              <a:t> </a:t>
            </a:r>
            <a:endParaRPr lang="en-US" dirty="0"/>
          </a:p>
        </p:txBody>
      </p:sp>
      <p:pic>
        <p:nvPicPr>
          <p:cNvPr id="10" name="Graphic 9">
            <a:extLst>
              <a:ext uri="{FF2B5EF4-FFF2-40B4-BE49-F238E27FC236}">
                <a16:creationId xmlns:a16="http://schemas.microsoft.com/office/drawing/2014/main" id="{5552D236-73F9-4D56-8683-7FE46B68CA13}"/>
              </a:ext>
            </a:extLst>
          </p:cNvPr>
          <p:cNvPicPr>
            <a:picLocks noChangeAspect="1"/>
          </p:cNvPicPr>
          <p:nvPr userDrawn="1"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544617" y="534914"/>
            <a:ext cx="1737263" cy="3727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02964107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 userDrawn="1">
          <p15:clr>
            <a:srgbClr val="FBAE40"/>
          </p15:clr>
        </p15:guide>
        <p15:guide id="2" pos="3840" userDrawn="1">
          <p15:clr>
            <a:srgbClr val="FBAE40"/>
          </p15:clr>
        </p15:guide>
      </p15:sldGuideLst>
    </p:ext>
  </p:extLst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Forside gul firka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Chart, pie chart  Description automatically generated">
            <a:extLst>
              <a:ext uri="{FF2B5EF4-FFF2-40B4-BE49-F238E27FC236}">
                <a16:creationId xmlns:a16="http://schemas.microsoft.com/office/drawing/2014/main" id="{1B2EC5BA-9D26-44D0-B707-3D52ABD2B1B9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4488" y="538961"/>
            <a:ext cx="8617512" cy="5745008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20016" y="1153266"/>
            <a:ext cx="4443283" cy="2387600"/>
          </a:xfrm>
        </p:spPr>
        <p:txBody>
          <a:bodyPr lIns="0" tIns="0" rIns="0" bIns="0" anchor="b">
            <a:normAutofit/>
          </a:bodyPr>
          <a:lstStyle>
            <a:lvl1pPr algn="l">
              <a:lnSpc>
                <a:spcPct val="110000"/>
              </a:lnSpc>
              <a:defRPr sz="3501" b="1"/>
            </a:lvl1pPr>
          </a:lstStyle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0016" y="3735403"/>
            <a:ext cx="4443283" cy="1764696"/>
          </a:xfrm>
        </p:spPr>
        <p:txBody>
          <a:bodyPr lIns="0" tIns="0" rIns="0" bIns="0">
            <a:normAutofit/>
          </a:bodyPr>
          <a:lstStyle>
            <a:lvl1pPr marL="0" indent="0" algn="l">
              <a:buNone/>
              <a:defRPr sz="1500" b="1"/>
            </a:lvl1pPr>
            <a:lvl2pPr marL="457223" indent="0" algn="ctr">
              <a:buNone/>
              <a:defRPr sz="2000"/>
            </a:lvl2pPr>
            <a:lvl3pPr marL="914446" indent="0" algn="ctr">
              <a:buNone/>
              <a:defRPr sz="1800"/>
            </a:lvl3pPr>
            <a:lvl4pPr marL="1371669" indent="0" algn="ctr">
              <a:buNone/>
              <a:defRPr sz="1600"/>
            </a:lvl4pPr>
            <a:lvl5pPr marL="1828891" indent="0" algn="ctr">
              <a:buNone/>
              <a:defRPr sz="1600"/>
            </a:lvl5pPr>
            <a:lvl6pPr marL="2286114" indent="0" algn="ctr">
              <a:buNone/>
              <a:defRPr sz="1600"/>
            </a:lvl6pPr>
            <a:lvl7pPr marL="2743337" indent="0" algn="ctr">
              <a:buNone/>
              <a:defRPr sz="1600"/>
            </a:lvl7pPr>
            <a:lvl8pPr marL="3200560" indent="0" algn="ctr">
              <a:buNone/>
              <a:defRPr sz="1600"/>
            </a:lvl8pPr>
            <a:lvl9pPr marL="3657783" indent="0" algn="ctr">
              <a:buNone/>
              <a:defRPr sz="1600"/>
            </a:lvl9pPr>
          </a:lstStyle>
          <a:p>
            <a:r>
              <a:rPr lang="nb-NO"/>
              <a:t>Klikk for å redigere undertittelstil i malen</a:t>
            </a:r>
            <a:endParaRPr lang="en-US" dirty="0"/>
          </a:p>
        </p:txBody>
      </p:sp>
      <p:pic>
        <p:nvPicPr>
          <p:cNvPr id="7" name="Graphic 6">
            <a:extLst>
              <a:ext uri="{FF2B5EF4-FFF2-40B4-BE49-F238E27FC236}">
                <a16:creationId xmlns:a16="http://schemas.microsoft.com/office/drawing/2014/main" id="{E0766909-2793-4DF1-A810-2BA0F2E16A5E}"/>
              </a:ext>
            </a:extLst>
          </p:cNvPr>
          <p:cNvPicPr>
            <a:picLocks noChangeAspect="1"/>
          </p:cNvPicPr>
          <p:nvPr userDrawn="1"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2535291" y="534913"/>
            <a:ext cx="1452509" cy="391834"/>
          </a:xfrm>
          <a:prstGeom prst="rect">
            <a:avLst/>
          </a:prstGeom>
        </p:spPr>
      </p:pic>
      <p:pic>
        <p:nvPicPr>
          <p:cNvPr id="9" name="Graphic 8">
            <a:extLst>
              <a:ext uri="{FF2B5EF4-FFF2-40B4-BE49-F238E27FC236}">
                <a16:creationId xmlns:a16="http://schemas.microsoft.com/office/drawing/2014/main" id="{6EB9111A-390F-4C12-8EFB-0ADFD0761565}"/>
              </a:ext>
            </a:extLst>
          </p:cNvPr>
          <p:cNvPicPr>
            <a:picLocks noChangeAspect="1"/>
          </p:cNvPicPr>
          <p:nvPr userDrawn="1"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44617" y="534914"/>
            <a:ext cx="1737263" cy="3727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4252691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Forside bue 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20016" y="1153266"/>
            <a:ext cx="4443283" cy="2387600"/>
          </a:xfrm>
        </p:spPr>
        <p:txBody>
          <a:bodyPr lIns="0" tIns="0" rIns="0" bIns="0" anchor="b">
            <a:normAutofit/>
          </a:bodyPr>
          <a:lstStyle>
            <a:lvl1pPr algn="l">
              <a:lnSpc>
                <a:spcPct val="110000"/>
              </a:lnSpc>
              <a:defRPr sz="3501" b="1"/>
            </a:lvl1pPr>
          </a:lstStyle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0016" y="3735403"/>
            <a:ext cx="4443283" cy="1764696"/>
          </a:xfrm>
        </p:spPr>
        <p:txBody>
          <a:bodyPr lIns="0" tIns="0" rIns="0" bIns="0">
            <a:normAutofit/>
          </a:bodyPr>
          <a:lstStyle>
            <a:lvl1pPr marL="0" indent="0" algn="l">
              <a:buNone/>
              <a:defRPr sz="1500" b="1"/>
            </a:lvl1pPr>
            <a:lvl2pPr marL="457223" indent="0" algn="ctr">
              <a:buNone/>
              <a:defRPr sz="2000"/>
            </a:lvl2pPr>
            <a:lvl3pPr marL="914446" indent="0" algn="ctr">
              <a:buNone/>
              <a:defRPr sz="1800"/>
            </a:lvl3pPr>
            <a:lvl4pPr marL="1371669" indent="0" algn="ctr">
              <a:buNone/>
              <a:defRPr sz="1600"/>
            </a:lvl4pPr>
            <a:lvl5pPr marL="1828891" indent="0" algn="ctr">
              <a:buNone/>
              <a:defRPr sz="1600"/>
            </a:lvl5pPr>
            <a:lvl6pPr marL="2286114" indent="0" algn="ctr">
              <a:buNone/>
              <a:defRPr sz="1600"/>
            </a:lvl6pPr>
            <a:lvl7pPr marL="2743337" indent="0" algn="ctr">
              <a:buNone/>
              <a:defRPr sz="1600"/>
            </a:lvl7pPr>
            <a:lvl8pPr marL="3200560" indent="0" algn="ctr">
              <a:buNone/>
              <a:defRPr sz="1600"/>
            </a:lvl8pPr>
            <a:lvl9pPr marL="3657783" indent="0" algn="ctr">
              <a:buNone/>
              <a:defRPr sz="1600"/>
            </a:lvl9pPr>
          </a:lstStyle>
          <a:p>
            <a:r>
              <a:rPr lang="nb-NO"/>
              <a:t>Klikk for å redigere undertittelstil i malen</a:t>
            </a:r>
            <a:endParaRPr lang="en-US" dirty="0"/>
          </a:p>
        </p:txBody>
      </p:sp>
      <p:sp>
        <p:nvSpPr>
          <p:cNvPr id="16" name="Picture Placeholder 15">
            <a:extLst>
              <a:ext uri="{FF2B5EF4-FFF2-40B4-BE49-F238E27FC236}">
                <a16:creationId xmlns:a16="http://schemas.microsoft.com/office/drawing/2014/main" id="{ADE06614-DF40-4650-9528-A85FF7FD7253}"/>
              </a:ext>
            </a:extLst>
          </p:cNvPr>
          <p:cNvSpPr>
            <a:spLocks noGrp="1"/>
          </p:cNvSpPr>
          <p:nvPr>
            <p:ph type="pic" sz="quarter" idx="10"/>
          </p:nvPr>
        </p:nvSpPr>
        <p:spPr>
          <a:xfrm>
            <a:off x="6365344" y="1016118"/>
            <a:ext cx="5826656" cy="5841882"/>
          </a:xfrm>
          <a:custGeom>
            <a:avLst/>
            <a:gdLst>
              <a:gd name="connsiteX0" fmla="*/ 5825898 w 11651794"/>
              <a:gd name="connsiteY0" fmla="*/ 0 h 11682413"/>
              <a:gd name="connsiteX1" fmla="*/ 11651794 w 11651794"/>
              <a:gd name="connsiteY1" fmla="*/ 5825898 h 11682413"/>
              <a:gd name="connsiteX2" fmla="*/ 11651794 w 11651794"/>
              <a:gd name="connsiteY2" fmla="*/ 8273536 h 11682413"/>
              <a:gd name="connsiteX3" fmla="*/ 11651794 w 11651794"/>
              <a:gd name="connsiteY3" fmla="*/ 8308545 h 11682413"/>
              <a:gd name="connsiteX4" fmla="*/ 11651794 w 11651794"/>
              <a:gd name="connsiteY4" fmla="*/ 11682314 h 11682413"/>
              <a:gd name="connsiteX5" fmla="*/ 10574010 w 11651794"/>
              <a:gd name="connsiteY5" fmla="*/ 11682314 h 11682413"/>
              <a:gd name="connsiteX6" fmla="*/ 10573940 w 11651794"/>
              <a:gd name="connsiteY6" fmla="*/ 11682413 h 11682413"/>
              <a:gd name="connsiteX7" fmla="*/ 1077855 w 11651794"/>
              <a:gd name="connsiteY7" fmla="*/ 11682413 h 11682413"/>
              <a:gd name="connsiteX8" fmla="*/ 1077784 w 11651794"/>
              <a:gd name="connsiteY8" fmla="*/ 11682314 h 11682413"/>
              <a:gd name="connsiteX9" fmla="*/ 0 w 11651794"/>
              <a:gd name="connsiteY9" fmla="*/ 11682314 h 11682413"/>
              <a:gd name="connsiteX10" fmla="*/ 0 w 11651794"/>
              <a:gd name="connsiteY10" fmla="*/ 8308545 h 11682413"/>
              <a:gd name="connsiteX11" fmla="*/ 0 w 11651794"/>
              <a:gd name="connsiteY11" fmla="*/ 8273536 h 11682413"/>
              <a:gd name="connsiteX12" fmla="*/ 0 w 11651794"/>
              <a:gd name="connsiteY12" fmla="*/ 5825898 h 11682413"/>
              <a:gd name="connsiteX13" fmla="*/ 5825898 w 11651794"/>
              <a:gd name="connsiteY13" fmla="*/ 0 h 1168241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</a:cxnLst>
            <a:rect l="l" t="t" r="r" b="b"/>
            <a:pathLst>
              <a:path w="11651794" h="11682413">
                <a:moveTo>
                  <a:pt x="5825898" y="0"/>
                </a:moveTo>
                <a:cubicBezTo>
                  <a:pt x="9043454" y="0"/>
                  <a:pt x="11651794" y="2608345"/>
                  <a:pt x="11651794" y="5825898"/>
                </a:cubicBezTo>
                <a:lnTo>
                  <a:pt x="11651794" y="8273536"/>
                </a:lnTo>
                <a:lnTo>
                  <a:pt x="11651794" y="8308545"/>
                </a:lnTo>
                <a:lnTo>
                  <a:pt x="11651794" y="11682314"/>
                </a:lnTo>
                <a:lnTo>
                  <a:pt x="10574010" y="11682314"/>
                </a:lnTo>
                <a:lnTo>
                  <a:pt x="10573940" y="11682413"/>
                </a:lnTo>
                <a:lnTo>
                  <a:pt x="1077855" y="11682413"/>
                </a:lnTo>
                <a:lnTo>
                  <a:pt x="1077784" y="11682314"/>
                </a:lnTo>
                <a:lnTo>
                  <a:pt x="0" y="11682314"/>
                </a:lnTo>
                <a:lnTo>
                  <a:pt x="0" y="8308545"/>
                </a:lnTo>
                <a:lnTo>
                  <a:pt x="0" y="8273536"/>
                </a:lnTo>
                <a:lnTo>
                  <a:pt x="0" y="5825898"/>
                </a:lnTo>
                <a:cubicBezTo>
                  <a:pt x="0" y="2608345"/>
                  <a:pt x="2608343" y="0"/>
                  <a:pt x="5825898" y="0"/>
                </a:cubicBezTo>
                <a:close/>
              </a:path>
            </a:pathLst>
          </a:custGeom>
          <a:solidFill>
            <a:schemeClr val="bg1">
              <a:lumMod val="75000"/>
            </a:schemeClr>
          </a:solidFill>
        </p:spPr>
        <p:txBody>
          <a:bodyPr wrap="square">
            <a:noAutofit/>
          </a:bodyPr>
          <a:lstStyle>
            <a:lvl1pPr marL="0" indent="0">
              <a:buNone/>
              <a:defRPr/>
            </a:lvl1pPr>
          </a:lstStyle>
          <a:p>
            <a:r>
              <a:rPr lang="nb-NO"/>
              <a:t>Klikk på ikonet for å legge til et bilde</a:t>
            </a:r>
            <a:endParaRPr lang="en-US" dirty="0"/>
          </a:p>
        </p:txBody>
      </p:sp>
      <p:pic>
        <p:nvPicPr>
          <p:cNvPr id="7" name="Graphic 6">
            <a:extLst>
              <a:ext uri="{FF2B5EF4-FFF2-40B4-BE49-F238E27FC236}">
                <a16:creationId xmlns:a16="http://schemas.microsoft.com/office/drawing/2014/main" id="{302086FF-04D4-4CB7-914E-1C63C4A7A10E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2535291" y="534913"/>
            <a:ext cx="1452509" cy="391834"/>
          </a:xfrm>
          <a:prstGeom prst="rect">
            <a:avLst/>
          </a:prstGeom>
        </p:spPr>
      </p:pic>
      <p:pic>
        <p:nvPicPr>
          <p:cNvPr id="9" name="Graphic 8">
            <a:extLst>
              <a:ext uri="{FF2B5EF4-FFF2-40B4-BE49-F238E27FC236}">
                <a16:creationId xmlns:a16="http://schemas.microsoft.com/office/drawing/2014/main" id="{1A8D4395-D3D2-4E8A-830A-B54FA8F9653C}"/>
              </a:ext>
            </a:extLst>
          </p:cNvPr>
          <p:cNvPicPr>
            <a:picLocks noChangeAspect="1"/>
          </p:cNvPicPr>
          <p:nvPr userDrawn="1"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544617" y="534914"/>
            <a:ext cx="1737263" cy="3727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1374682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Kapittel g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Freeform: Shape 17">
            <a:extLst>
              <a:ext uri="{FF2B5EF4-FFF2-40B4-BE49-F238E27FC236}">
                <a16:creationId xmlns:a16="http://schemas.microsoft.com/office/drawing/2014/main" id="{086ECD79-8CB7-45A8-8F3B-F441CCF3707E}"/>
              </a:ext>
            </a:extLst>
          </p:cNvPr>
          <p:cNvSpPr/>
          <p:nvPr userDrawn="1"/>
        </p:nvSpPr>
        <p:spPr>
          <a:xfrm>
            <a:off x="1020016" y="0"/>
            <a:ext cx="10151968" cy="6857999"/>
          </a:xfrm>
          <a:custGeom>
            <a:avLst/>
            <a:gdLst>
              <a:gd name="connsiteX0" fmla="*/ 2760136 w 20301293"/>
              <a:gd name="connsiteY0" fmla="*/ 0 h 13714412"/>
              <a:gd name="connsiteX1" fmla="*/ 17541157 w 20301293"/>
              <a:gd name="connsiteY1" fmla="*/ 0 h 13714412"/>
              <a:gd name="connsiteX2" fmla="*/ 17664339 w 20301293"/>
              <a:gd name="connsiteY2" fmla="*/ 127398 h 13714412"/>
              <a:gd name="connsiteX3" fmla="*/ 20301293 w 20301293"/>
              <a:gd name="connsiteY3" fmla="*/ 6857206 h 13714412"/>
              <a:gd name="connsiteX4" fmla="*/ 17664339 w 20301293"/>
              <a:gd name="connsiteY4" fmla="*/ 13587013 h 13714412"/>
              <a:gd name="connsiteX5" fmla="*/ 17541155 w 20301293"/>
              <a:gd name="connsiteY5" fmla="*/ 13714412 h 13714412"/>
              <a:gd name="connsiteX6" fmla="*/ 2760137 w 20301293"/>
              <a:gd name="connsiteY6" fmla="*/ 13714412 h 13714412"/>
              <a:gd name="connsiteX7" fmla="*/ 2636954 w 20301293"/>
              <a:gd name="connsiteY7" fmla="*/ 13587013 h 13714412"/>
              <a:gd name="connsiteX8" fmla="*/ 0 w 20301293"/>
              <a:gd name="connsiteY8" fmla="*/ 6857206 h 13714412"/>
              <a:gd name="connsiteX9" fmla="*/ 2636954 w 20301293"/>
              <a:gd name="connsiteY9" fmla="*/ 127398 h 1371441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20301293" h="13714412">
                <a:moveTo>
                  <a:pt x="2760136" y="0"/>
                </a:moveTo>
                <a:lnTo>
                  <a:pt x="17541157" y="0"/>
                </a:lnTo>
                <a:lnTo>
                  <a:pt x="17664339" y="127398"/>
                </a:lnTo>
                <a:cubicBezTo>
                  <a:pt x="19302723" y="1904863"/>
                  <a:pt x="20301293" y="4266048"/>
                  <a:pt x="20301293" y="6857206"/>
                </a:cubicBezTo>
                <a:cubicBezTo>
                  <a:pt x="20301293" y="9448363"/>
                  <a:pt x="19302723" y="11809548"/>
                  <a:pt x="17664339" y="13587013"/>
                </a:cubicBezTo>
                <a:lnTo>
                  <a:pt x="17541155" y="13714412"/>
                </a:lnTo>
                <a:lnTo>
                  <a:pt x="2760137" y="13714412"/>
                </a:lnTo>
                <a:lnTo>
                  <a:pt x="2636954" y="13587013"/>
                </a:lnTo>
                <a:cubicBezTo>
                  <a:pt x="998569" y="11809548"/>
                  <a:pt x="0" y="9448363"/>
                  <a:pt x="0" y="6857206"/>
                </a:cubicBezTo>
                <a:cubicBezTo>
                  <a:pt x="0" y="4266048"/>
                  <a:pt x="998569" y="1904863"/>
                  <a:pt x="2636954" y="127398"/>
                </a:cubicBezTo>
                <a:close/>
              </a:path>
            </a:pathLst>
          </a:cu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 sz="45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2311015" y="1763811"/>
            <a:ext cx="7575678" cy="1764696"/>
          </a:xfrm>
        </p:spPr>
        <p:txBody>
          <a:bodyPr lIns="0" tIns="0" rIns="0" bIns="0" anchor="b">
            <a:normAutofit/>
          </a:bodyPr>
          <a:lstStyle>
            <a:lvl1pPr algn="ctr">
              <a:lnSpc>
                <a:spcPct val="110000"/>
              </a:lnSpc>
              <a:defRPr sz="3501" b="1"/>
            </a:lvl1pPr>
          </a:lstStyle>
          <a:p>
            <a:r>
              <a:rPr lang="nb-NO" dirty="0"/>
              <a:t>Kapitteltitte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2311015" y="3746262"/>
            <a:ext cx="7575678" cy="1246446"/>
          </a:xfrm>
        </p:spPr>
        <p:txBody>
          <a:bodyPr lIns="0" tIns="0" rIns="0" bIns="0">
            <a:normAutofit/>
          </a:bodyPr>
          <a:lstStyle>
            <a:lvl1pPr marL="0" indent="0" algn="ctr">
              <a:buNone/>
              <a:defRPr sz="1500" b="1"/>
            </a:lvl1pPr>
            <a:lvl2pPr marL="457223" indent="0" algn="ctr">
              <a:buNone/>
              <a:defRPr sz="2000"/>
            </a:lvl2pPr>
            <a:lvl3pPr marL="914446" indent="0" algn="ctr">
              <a:buNone/>
              <a:defRPr sz="1800"/>
            </a:lvl3pPr>
            <a:lvl4pPr marL="1371669" indent="0" algn="ctr">
              <a:buNone/>
              <a:defRPr sz="1600"/>
            </a:lvl4pPr>
            <a:lvl5pPr marL="1828891" indent="0" algn="ctr">
              <a:buNone/>
              <a:defRPr sz="1600"/>
            </a:lvl5pPr>
            <a:lvl6pPr marL="2286114" indent="0" algn="ctr">
              <a:buNone/>
              <a:defRPr sz="1600"/>
            </a:lvl6pPr>
            <a:lvl7pPr marL="2743337" indent="0" algn="ctr">
              <a:buNone/>
              <a:defRPr sz="1600"/>
            </a:lvl7pPr>
            <a:lvl8pPr marL="3200560" indent="0" algn="ctr">
              <a:buNone/>
              <a:defRPr sz="1600"/>
            </a:lvl8pPr>
            <a:lvl9pPr marL="3657783" indent="0" algn="ctr">
              <a:buNone/>
              <a:defRPr sz="1600"/>
            </a:lvl9pPr>
          </a:lstStyle>
          <a:p>
            <a:r>
              <a:rPr lang="nb-NO" dirty="0"/>
              <a:t>Undertittel</a:t>
            </a:r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BCDEB1-410B-4E44-9E27-C4D1076D47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BC5DA-09B7-4CD9-B21E-157BBBE69313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6870726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Kapittel rø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phic 4">
            <a:extLst>
              <a:ext uri="{FF2B5EF4-FFF2-40B4-BE49-F238E27FC236}">
                <a16:creationId xmlns:a16="http://schemas.microsoft.com/office/drawing/2014/main" id="{64560E81-DB08-49BC-A463-028BD94BB805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t="15689" b="15689"/>
          <a:stretch/>
        </p:blipFill>
        <p:spPr>
          <a:xfrm>
            <a:off x="1099138" y="0"/>
            <a:ext cx="9993724" cy="68579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2311015" y="1763811"/>
            <a:ext cx="7575678" cy="1764696"/>
          </a:xfrm>
        </p:spPr>
        <p:txBody>
          <a:bodyPr lIns="0" tIns="0" rIns="0" bIns="0" anchor="b">
            <a:normAutofit/>
          </a:bodyPr>
          <a:lstStyle>
            <a:lvl1pPr algn="ctr">
              <a:lnSpc>
                <a:spcPct val="110000"/>
              </a:lnSpc>
              <a:defRPr sz="3501" b="1"/>
            </a:lvl1pPr>
          </a:lstStyle>
          <a:p>
            <a:r>
              <a:rPr lang="nb-NO" dirty="0"/>
              <a:t>Kapitteltitte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2311015" y="3746262"/>
            <a:ext cx="7575678" cy="1246446"/>
          </a:xfrm>
        </p:spPr>
        <p:txBody>
          <a:bodyPr lIns="0" tIns="0" rIns="0" bIns="0">
            <a:normAutofit/>
          </a:bodyPr>
          <a:lstStyle>
            <a:lvl1pPr marL="0" indent="0" algn="ctr">
              <a:buNone/>
              <a:defRPr sz="1500" b="1"/>
            </a:lvl1pPr>
            <a:lvl2pPr marL="457223" indent="0" algn="ctr">
              <a:buNone/>
              <a:defRPr sz="2000"/>
            </a:lvl2pPr>
            <a:lvl3pPr marL="914446" indent="0" algn="ctr">
              <a:buNone/>
              <a:defRPr sz="1800"/>
            </a:lvl3pPr>
            <a:lvl4pPr marL="1371669" indent="0" algn="ctr">
              <a:buNone/>
              <a:defRPr sz="1600"/>
            </a:lvl4pPr>
            <a:lvl5pPr marL="1828891" indent="0" algn="ctr">
              <a:buNone/>
              <a:defRPr sz="1600"/>
            </a:lvl5pPr>
            <a:lvl6pPr marL="2286114" indent="0" algn="ctr">
              <a:buNone/>
              <a:defRPr sz="1600"/>
            </a:lvl6pPr>
            <a:lvl7pPr marL="2743337" indent="0" algn="ctr">
              <a:buNone/>
              <a:defRPr sz="1600"/>
            </a:lvl7pPr>
            <a:lvl8pPr marL="3200560" indent="0" algn="ctr">
              <a:buNone/>
              <a:defRPr sz="1600"/>
            </a:lvl8pPr>
            <a:lvl9pPr marL="3657783" indent="0" algn="ctr">
              <a:buNone/>
              <a:defRPr sz="1600"/>
            </a:lvl9pPr>
          </a:lstStyle>
          <a:p>
            <a:r>
              <a:rPr lang="nb-NO" dirty="0"/>
              <a:t>Undertittel</a:t>
            </a:r>
            <a:endParaRPr lang="en-US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231A23E-7560-480D-B75E-CAF63F1D5A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BC5DA-09B7-4CD9-B21E-157BBBE69313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1580116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Kapittel turk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phic 4">
            <a:extLst>
              <a:ext uri="{FF2B5EF4-FFF2-40B4-BE49-F238E27FC236}">
                <a16:creationId xmlns:a16="http://schemas.microsoft.com/office/drawing/2014/main" id="{40EABFEB-D9F9-4115-9293-231E63E787CF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483004" y="0"/>
            <a:ext cx="9256416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2311015" y="1763811"/>
            <a:ext cx="7575678" cy="1764696"/>
          </a:xfrm>
        </p:spPr>
        <p:txBody>
          <a:bodyPr lIns="0" tIns="0" rIns="0" bIns="0" anchor="b">
            <a:normAutofit/>
          </a:bodyPr>
          <a:lstStyle>
            <a:lvl1pPr algn="ctr">
              <a:lnSpc>
                <a:spcPct val="110000"/>
              </a:lnSpc>
              <a:defRPr sz="3501" b="1"/>
            </a:lvl1pPr>
          </a:lstStyle>
          <a:p>
            <a:r>
              <a:rPr lang="nb-NO" dirty="0"/>
              <a:t>Kapitteltitte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2311015" y="3746262"/>
            <a:ext cx="7575678" cy="1246446"/>
          </a:xfrm>
        </p:spPr>
        <p:txBody>
          <a:bodyPr lIns="0" tIns="0" rIns="0" bIns="0">
            <a:normAutofit/>
          </a:bodyPr>
          <a:lstStyle>
            <a:lvl1pPr marL="0" indent="0" algn="ctr">
              <a:buNone/>
              <a:defRPr sz="1500" b="1"/>
            </a:lvl1pPr>
            <a:lvl2pPr marL="457223" indent="0" algn="ctr">
              <a:buNone/>
              <a:defRPr sz="2000"/>
            </a:lvl2pPr>
            <a:lvl3pPr marL="914446" indent="0" algn="ctr">
              <a:buNone/>
              <a:defRPr sz="1800"/>
            </a:lvl3pPr>
            <a:lvl4pPr marL="1371669" indent="0" algn="ctr">
              <a:buNone/>
              <a:defRPr sz="1600"/>
            </a:lvl4pPr>
            <a:lvl5pPr marL="1828891" indent="0" algn="ctr">
              <a:buNone/>
              <a:defRPr sz="1600"/>
            </a:lvl5pPr>
            <a:lvl6pPr marL="2286114" indent="0" algn="ctr">
              <a:buNone/>
              <a:defRPr sz="1600"/>
            </a:lvl6pPr>
            <a:lvl7pPr marL="2743337" indent="0" algn="ctr">
              <a:buNone/>
              <a:defRPr sz="1600"/>
            </a:lvl7pPr>
            <a:lvl8pPr marL="3200560" indent="0" algn="ctr">
              <a:buNone/>
              <a:defRPr sz="1600"/>
            </a:lvl8pPr>
            <a:lvl9pPr marL="3657783" indent="0" algn="ctr">
              <a:buNone/>
              <a:defRPr sz="1600"/>
            </a:lvl9pPr>
          </a:lstStyle>
          <a:p>
            <a:r>
              <a:rPr lang="nb-NO" dirty="0"/>
              <a:t>Undertittel</a:t>
            </a:r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FC57F0-30DE-4495-AF1C-70898F85E1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BC5DA-09B7-4CD9-B21E-157BBBE69313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95316391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Kapittel blå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phic 4">
            <a:extLst>
              <a:ext uri="{FF2B5EF4-FFF2-40B4-BE49-F238E27FC236}">
                <a16:creationId xmlns:a16="http://schemas.microsoft.com/office/drawing/2014/main" id="{40EABFEB-D9F9-4115-9293-231E63E787CF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483004" y="0"/>
            <a:ext cx="9256416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2311015" y="1763811"/>
            <a:ext cx="7575678" cy="1764696"/>
          </a:xfrm>
        </p:spPr>
        <p:txBody>
          <a:bodyPr lIns="0" tIns="0" rIns="0" bIns="0" anchor="b">
            <a:normAutofit/>
          </a:bodyPr>
          <a:lstStyle>
            <a:lvl1pPr algn="ctr">
              <a:lnSpc>
                <a:spcPct val="110000"/>
              </a:lnSpc>
              <a:defRPr sz="3501" b="1"/>
            </a:lvl1pPr>
          </a:lstStyle>
          <a:p>
            <a:r>
              <a:rPr lang="nb-NO" dirty="0"/>
              <a:t>Kapitteltitte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2311015" y="3746262"/>
            <a:ext cx="7575678" cy="1246446"/>
          </a:xfrm>
        </p:spPr>
        <p:txBody>
          <a:bodyPr lIns="0" tIns="0" rIns="0" bIns="0">
            <a:normAutofit/>
          </a:bodyPr>
          <a:lstStyle>
            <a:lvl1pPr marL="0" indent="0" algn="ctr">
              <a:buNone/>
              <a:defRPr sz="1500" b="1"/>
            </a:lvl1pPr>
            <a:lvl2pPr marL="457223" indent="0" algn="ctr">
              <a:buNone/>
              <a:defRPr sz="2000"/>
            </a:lvl2pPr>
            <a:lvl3pPr marL="914446" indent="0" algn="ctr">
              <a:buNone/>
              <a:defRPr sz="1800"/>
            </a:lvl3pPr>
            <a:lvl4pPr marL="1371669" indent="0" algn="ctr">
              <a:buNone/>
              <a:defRPr sz="1600"/>
            </a:lvl4pPr>
            <a:lvl5pPr marL="1828891" indent="0" algn="ctr">
              <a:buNone/>
              <a:defRPr sz="1600"/>
            </a:lvl5pPr>
            <a:lvl6pPr marL="2286114" indent="0" algn="ctr">
              <a:buNone/>
              <a:defRPr sz="1600"/>
            </a:lvl6pPr>
            <a:lvl7pPr marL="2743337" indent="0" algn="ctr">
              <a:buNone/>
              <a:defRPr sz="1600"/>
            </a:lvl7pPr>
            <a:lvl8pPr marL="3200560" indent="0" algn="ctr">
              <a:buNone/>
              <a:defRPr sz="1600"/>
            </a:lvl8pPr>
            <a:lvl9pPr marL="3657783" indent="0" algn="ctr">
              <a:buNone/>
              <a:defRPr sz="1600"/>
            </a:lvl9pPr>
          </a:lstStyle>
          <a:p>
            <a:r>
              <a:rPr lang="nb-NO" dirty="0"/>
              <a:t>Undertittel</a:t>
            </a:r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FC57F0-30DE-4495-AF1C-70898F85E1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BC5DA-09B7-4CD9-B21E-157BBBE69313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7801174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Kapittel tre gu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7F9C728F-A6AD-4E98-8BE2-2A032D23A7AE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8547" y="885273"/>
            <a:ext cx="10174318" cy="5087453"/>
          </a:xfrm>
          <a:prstGeom prst="rect">
            <a:avLst/>
          </a:prstGeom>
        </p:spPr>
      </p:pic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2311015" y="3746262"/>
            <a:ext cx="7575678" cy="1246446"/>
          </a:xfrm>
        </p:spPr>
        <p:txBody>
          <a:bodyPr lIns="0" tIns="0" rIns="0" bIns="0">
            <a:normAutofit/>
          </a:bodyPr>
          <a:lstStyle>
            <a:lvl1pPr marL="0" indent="0" algn="ctr">
              <a:buNone/>
              <a:defRPr sz="1500" b="1"/>
            </a:lvl1pPr>
            <a:lvl2pPr marL="457223" indent="0" algn="ctr">
              <a:buNone/>
              <a:defRPr sz="2000"/>
            </a:lvl2pPr>
            <a:lvl3pPr marL="914446" indent="0" algn="ctr">
              <a:buNone/>
              <a:defRPr sz="1800"/>
            </a:lvl3pPr>
            <a:lvl4pPr marL="1371669" indent="0" algn="ctr">
              <a:buNone/>
              <a:defRPr sz="1600"/>
            </a:lvl4pPr>
            <a:lvl5pPr marL="1828891" indent="0" algn="ctr">
              <a:buNone/>
              <a:defRPr sz="1600"/>
            </a:lvl5pPr>
            <a:lvl6pPr marL="2286114" indent="0" algn="ctr">
              <a:buNone/>
              <a:defRPr sz="1600"/>
            </a:lvl6pPr>
            <a:lvl7pPr marL="2743337" indent="0" algn="ctr">
              <a:buNone/>
              <a:defRPr sz="1600"/>
            </a:lvl7pPr>
            <a:lvl8pPr marL="3200560" indent="0" algn="ctr">
              <a:buNone/>
              <a:defRPr sz="1600"/>
            </a:lvl8pPr>
            <a:lvl9pPr marL="3657783" indent="0" algn="ctr">
              <a:buNone/>
              <a:defRPr sz="1600"/>
            </a:lvl9pPr>
          </a:lstStyle>
          <a:p>
            <a:r>
              <a:rPr lang="nb-NO" dirty="0"/>
              <a:t>Undertittel</a:t>
            </a:r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2311015" y="1763811"/>
            <a:ext cx="7575678" cy="1764696"/>
          </a:xfrm>
        </p:spPr>
        <p:txBody>
          <a:bodyPr lIns="0" tIns="0" rIns="0" bIns="0" anchor="b">
            <a:normAutofit/>
          </a:bodyPr>
          <a:lstStyle>
            <a:lvl1pPr algn="ctr">
              <a:lnSpc>
                <a:spcPct val="110000"/>
              </a:lnSpc>
              <a:defRPr sz="3501" b="1"/>
            </a:lvl1pPr>
          </a:lstStyle>
          <a:p>
            <a:r>
              <a:rPr lang="nb-NO" dirty="0"/>
              <a:t>Kapitteltittel</a:t>
            </a:r>
            <a:endParaRPr lang="en-US" dirty="0"/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81405BA7-0133-45D3-8EDB-BC046FA175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BC5DA-09B7-4CD9-B21E-157BBBE69313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54041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RBUP oppdragsgivere">
    <p:bg>
      <p:bgPr>
        <a:solidFill>
          <a:schemeClr val="accent5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>
            <a:extLst>
              <a:ext uri="{FF2B5EF4-FFF2-40B4-BE49-F238E27FC236}">
                <a16:creationId xmlns:a16="http://schemas.microsoft.com/office/drawing/2014/main" id="{9B575F1D-41C4-B247-B308-D404AEE38C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solidFill>
                  <a:srgbClr val="DAE1FF"/>
                </a:solidFill>
              </a:defRPr>
            </a:lvl1pPr>
          </a:lstStyle>
          <a:p>
            <a:fld id="{E9379DD6-9036-5E4E-A769-804A89AA79F3}" type="datetimeFigureOut">
              <a:rPr lang="nb-NO" smtClean="0"/>
              <a:pPr/>
              <a:t>25.01.2024</a:t>
            </a:fld>
            <a:endParaRPr lang="nb-NO"/>
          </a:p>
        </p:txBody>
      </p:sp>
      <p:sp>
        <p:nvSpPr>
          <p:cNvPr id="3" name="Plassholder for bunntekst 2">
            <a:extLst>
              <a:ext uri="{FF2B5EF4-FFF2-40B4-BE49-F238E27FC236}">
                <a16:creationId xmlns:a16="http://schemas.microsoft.com/office/drawing/2014/main" id="{A7124F85-C205-8540-BFDF-933469DA8A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rgbClr val="DAE1FF"/>
                </a:solidFill>
              </a:defRPr>
            </a:lvl1pPr>
          </a:lstStyle>
          <a:p>
            <a:endParaRPr lang="nb-NO" dirty="0"/>
          </a:p>
        </p:txBody>
      </p:sp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F1CBB488-7E8F-9D4D-8031-2DF0600214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7274F-C966-8C46-AFC4-F3A14ECF3B01}" type="slidenum">
              <a:rPr lang="nb-NO" smtClean="0"/>
              <a:t>‹#›</a:t>
            </a:fld>
            <a:endParaRPr lang="nb-NO"/>
          </a:p>
        </p:txBody>
      </p:sp>
      <p:grpSp>
        <p:nvGrpSpPr>
          <p:cNvPr id="16" name="Gruppe 15">
            <a:extLst>
              <a:ext uri="{FF2B5EF4-FFF2-40B4-BE49-F238E27FC236}">
                <a16:creationId xmlns:a16="http://schemas.microsoft.com/office/drawing/2014/main" id="{69D2337A-D247-A444-B238-E608FA3C5C26}"/>
              </a:ext>
            </a:extLst>
          </p:cNvPr>
          <p:cNvGrpSpPr/>
          <p:nvPr userDrawn="1"/>
        </p:nvGrpSpPr>
        <p:grpSpPr>
          <a:xfrm>
            <a:off x="396023" y="393704"/>
            <a:ext cx="833492" cy="177295"/>
            <a:chOff x="396023" y="393704"/>
            <a:chExt cx="833492" cy="177295"/>
          </a:xfrm>
        </p:grpSpPr>
        <p:sp>
          <p:nvSpPr>
            <p:cNvPr id="7" name="Friform 6">
              <a:extLst>
                <a:ext uri="{FF2B5EF4-FFF2-40B4-BE49-F238E27FC236}">
                  <a16:creationId xmlns:a16="http://schemas.microsoft.com/office/drawing/2014/main" id="{E4417223-476C-4C4D-8450-353BD99C4EEB}"/>
                </a:ext>
              </a:extLst>
            </p:cNvPr>
            <p:cNvSpPr/>
            <p:nvPr/>
          </p:nvSpPr>
          <p:spPr>
            <a:xfrm>
              <a:off x="936121" y="394334"/>
              <a:ext cx="135024" cy="176665"/>
            </a:xfrm>
            <a:custGeom>
              <a:avLst/>
              <a:gdLst>
                <a:gd name="connsiteX0" fmla="*/ 108524 w 135024"/>
                <a:gd name="connsiteY0" fmla="*/ 0 h 176665"/>
                <a:gd name="connsiteX1" fmla="*/ 108524 w 135024"/>
                <a:gd name="connsiteY1" fmla="*/ 109154 h 176665"/>
                <a:gd name="connsiteX2" fmla="*/ 96536 w 135024"/>
                <a:gd name="connsiteY2" fmla="*/ 138808 h 176665"/>
                <a:gd name="connsiteX3" fmla="*/ 66881 w 135024"/>
                <a:gd name="connsiteY3" fmla="*/ 150796 h 176665"/>
                <a:gd name="connsiteX4" fmla="*/ 37226 w 135024"/>
                <a:gd name="connsiteY4" fmla="*/ 138808 h 176665"/>
                <a:gd name="connsiteX5" fmla="*/ 25238 w 135024"/>
                <a:gd name="connsiteY5" fmla="*/ 109154 h 176665"/>
                <a:gd name="connsiteX6" fmla="*/ 25238 w 135024"/>
                <a:gd name="connsiteY6" fmla="*/ 0 h 176665"/>
                <a:gd name="connsiteX7" fmla="*/ 0 w 135024"/>
                <a:gd name="connsiteY7" fmla="*/ 0 h 176665"/>
                <a:gd name="connsiteX8" fmla="*/ 0 w 135024"/>
                <a:gd name="connsiteY8" fmla="*/ 109154 h 176665"/>
                <a:gd name="connsiteX9" fmla="*/ 5048 w 135024"/>
                <a:gd name="connsiteY9" fmla="*/ 135023 h 176665"/>
                <a:gd name="connsiteX10" fmla="*/ 19560 w 135024"/>
                <a:gd name="connsiteY10" fmla="*/ 157106 h 176665"/>
                <a:gd name="connsiteX11" fmla="*/ 41643 w 135024"/>
                <a:gd name="connsiteY11" fmla="*/ 171617 h 176665"/>
                <a:gd name="connsiteX12" fmla="*/ 67512 w 135024"/>
                <a:gd name="connsiteY12" fmla="*/ 176665 h 176665"/>
                <a:gd name="connsiteX13" fmla="*/ 93382 w 135024"/>
                <a:gd name="connsiteY13" fmla="*/ 171617 h 176665"/>
                <a:gd name="connsiteX14" fmla="*/ 115465 w 135024"/>
                <a:gd name="connsiteY14" fmla="*/ 157106 h 176665"/>
                <a:gd name="connsiteX15" fmla="*/ 129977 w 135024"/>
                <a:gd name="connsiteY15" fmla="*/ 135023 h 176665"/>
                <a:gd name="connsiteX16" fmla="*/ 135025 w 135024"/>
                <a:gd name="connsiteY16" fmla="*/ 109154 h 176665"/>
                <a:gd name="connsiteX17" fmla="*/ 135025 w 135024"/>
                <a:gd name="connsiteY17" fmla="*/ 0 h 176665"/>
                <a:gd name="connsiteX18" fmla="*/ 108524 w 135024"/>
                <a:gd name="connsiteY18" fmla="*/ 0 h 1766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</a:cxnLst>
              <a:rect l="l" t="t" r="r" b="b"/>
              <a:pathLst>
                <a:path w="135024" h="176665">
                  <a:moveTo>
                    <a:pt x="108524" y="0"/>
                  </a:moveTo>
                  <a:lnTo>
                    <a:pt x="108524" y="109154"/>
                  </a:lnTo>
                  <a:cubicBezTo>
                    <a:pt x="108524" y="120511"/>
                    <a:pt x="104108" y="131237"/>
                    <a:pt x="96536" y="138808"/>
                  </a:cubicBezTo>
                  <a:cubicBezTo>
                    <a:pt x="88965" y="146380"/>
                    <a:pt x="78239" y="150796"/>
                    <a:pt x="66881" y="150796"/>
                  </a:cubicBezTo>
                  <a:cubicBezTo>
                    <a:pt x="55524" y="150796"/>
                    <a:pt x="44798" y="146380"/>
                    <a:pt x="37226" y="138808"/>
                  </a:cubicBezTo>
                  <a:cubicBezTo>
                    <a:pt x="29655" y="131237"/>
                    <a:pt x="25238" y="120511"/>
                    <a:pt x="25238" y="109154"/>
                  </a:cubicBezTo>
                  <a:lnTo>
                    <a:pt x="25238" y="0"/>
                  </a:lnTo>
                  <a:lnTo>
                    <a:pt x="0" y="0"/>
                  </a:lnTo>
                  <a:lnTo>
                    <a:pt x="0" y="109154"/>
                  </a:lnTo>
                  <a:cubicBezTo>
                    <a:pt x="0" y="117987"/>
                    <a:pt x="1893" y="126820"/>
                    <a:pt x="5048" y="135023"/>
                  </a:cubicBezTo>
                  <a:cubicBezTo>
                    <a:pt x="8202" y="143225"/>
                    <a:pt x="13250" y="150796"/>
                    <a:pt x="19560" y="157106"/>
                  </a:cubicBezTo>
                  <a:cubicBezTo>
                    <a:pt x="25869" y="163415"/>
                    <a:pt x="33441" y="168463"/>
                    <a:pt x="41643" y="171617"/>
                  </a:cubicBezTo>
                  <a:cubicBezTo>
                    <a:pt x="49846" y="174772"/>
                    <a:pt x="58679" y="176665"/>
                    <a:pt x="67512" y="176665"/>
                  </a:cubicBezTo>
                  <a:cubicBezTo>
                    <a:pt x="76346" y="176665"/>
                    <a:pt x="85179" y="174772"/>
                    <a:pt x="93382" y="171617"/>
                  </a:cubicBezTo>
                  <a:cubicBezTo>
                    <a:pt x="101584" y="168463"/>
                    <a:pt x="109155" y="163415"/>
                    <a:pt x="115465" y="157106"/>
                  </a:cubicBezTo>
                  <a:cubicBezTo>
                    <a:pt x="121775" y="150796"/>
                    <a:pt x="126822" y="143225"/>
                    <a:pt x="129977" y="135023"/>
                  </a:cubicBezTo>
                  <a:cubicBezTo>
                    <a:pt x="133132" y="126820"/>
                    <a:pt x="135025" y="117987"/>
                    <a:pt x="135025" y="109154"/>
                  </a:cubicBezTo>
                  <a:lnTo>
                    <a:pt x="135025" y="0"/>
                  </a:lnTo>
                  <a:lnTo>
                    <a:pt x="108524" y="0"/>
                  </a:lnTo>
                  <a:close/>
                </a:path>
              </a:pathLst>
            </a:custGeom>
            <a:solidFill>
              <a:schemeClr val="bg1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8" name="Friform 7">
              <a:extLst>
                <a:ext uri="{FF2B5EF4-FFF2-40B4-BE49-F238E27FC236}">
                  <a16:creationId xmlns:a16="http://schemas.microsoft.com/office/drawing/2014/main" id="{A4700748-0F56-1646-82B6-10AD483E361B}"/>
                </a:ext>
              </a:extLst>
            </p:cNvPr>
            <p:cNvSpPr/>
            <p:nvPr/>
          </p:nvSpPr>
          <p:spPr>
            <a:xfrm>
              <a:off x="630107" y="393704"/>
              <a:ext cx="119881" cy="175403"/>
            </a:xfrm>
            <a:custGeom>
              <a:avLst/>
              <a:gdLst>
                <a:gd name="connsiteX0" fmla="*/ 66881 w 119881"/>
                <a:gd name="connsiteY0" fmla="*/ 76345 h 175403"/>
                <a:gd name="connsiteX1" fmla="*/ 24607 w 119881"/>
                <a:gd name="connsiteY1" fmla="*/ 76345 h 175403"/>
                <a:gd name="connsiteX2" fmla="*/ 24607 w 119881"/>
                <a:gd name="connsiteY2" fmla="*/ 22714 h 175403"/>
                <a:gd name="connsiteX3" fmla="*/ 66881 w 119881"/>
                <a:gd name="connsiteY3" fmla="*/ 22714 h 175403"/>
                <a:gd name="connsiteX4" fmla="*/ 85179 w 119881"/>
                <a:gd name="connsiteY4" fmla="*/ 30285 h 175403"/>
                <a:gd name="connsiteX5" fmla="*/ 92751 w 119881"/>
                <a:gd name="connsiteY5" fmla="*/ 48583 h 175403"/>
                <a:gd name="connsiteX6" fmla="*/ 92751 w 119881"/>
                <a:gd name="connsiteY6" fmla="*/ 50476 h 175403"/>
                <a:gd name="connsiteX7" fmla="*/ 85179 w 119881"/>
                <a:gd name="connsiteY7" fmla="*/ 68773 h 175403"/>
                <a:gd name="connsiteX8" fmla="*/ 66881 w 119881"/>
                <a:gd name="connsiteY8" fmla="*/ 76345 h 175403"/>
                <a:gd name="connsiteX9" fmla="*/ 119882 w 119881"/>
                <a:gd name="connsiteY9" fmla="*/ 49845 h 175403"/>
                <a:gd name="connsiteX10" fmla="*/ 119882 w 119881"/>
                <a:gd name="connsiteY10" fmla="*/ 49845 h 175403"/>
                <a:gd name="connsiteX11" fmla="*/ 105370 w 119881"/>
                <a:gd name="connsiteY11" fmla="*/ 14512 h 175403"/>
                <a:gd name="connsiteX12" fmla="*/ 70667 w 119881"/>
                <a:gd name="connsiteY12" fmla="*/ 0 h 175403"/>
                <a:gd name="connsiteX13" fmla="*/ 0 w 119881"/>
                <a:gd name="connsiteY13" fmla="*/ 0 h 175403"/>
                <a:gd name="connsiteX14" fmla="*/ 0 w 119881"/>
                <a:gd name="connsiteY14" fmla="*/ 174772 h 175403"/>
                <a:gd name="connsiteX15" fmla="*/ 25238 w 119881"/>
                <a:gd name="connsiteY15" fmla="*/ 174772 h 175403"/>
                <a:gd name="connsiteX16" fmla="*/ 25238 w 119881"/>
                <a:gd name="connsiteY16" fmla="*/ 98428 h 175403"/>
                <a:gd name="connsiteX17" fmla="*/ 37226 w 119881"/>
                <a:gd name="connsiteY17" fmla="*/ 98428 h 175403"/>
                <a:gd name="connsiteX18" fmla="*/ 86441 w 119881"/>
                <a:gd name="connsiteY18" fmla="*/ 175403 h 175403"/>
                <a:gd name="connsiteX19" fmla="*/ 117989 w 119881"/>
                <a:gd name="connsiteY19" fmla="*/ 175403 h 175403"/>
                <a:gd name="connsiteX20" fmla="*/ 67512 w 119881"/>
                <a:gd name="connsiteY20" fmla="*/ 98428 h 175403"/>
                <a:gd name="connsiteX21" fmla="*/ 71298 w 119881"/>
                <a:gd name="connsiteY21" fmla="*/ 98428 h 175403"/>
                <a:gd name="connsiteX22" fmla="*/ 90227 w 119881"/>
                <a:gd name="connsiteY22" fmla="*/ 94642 h 175403"/>
                <a:gd name="connsiteX23" fmla="*/ 106001 w 119881"/>
                <a:gd name="connsiteY23" fmla="*/ 83916 h 175403"/>
                <a:gd name="connsiteX24" fmla="*/ 116727 w 119881"/>
                <a:gd name="connsiteY24" fmla="*/ 68142 h 175403"/>
                <a:gd name="connsiteX25" fmla="*/ 119882 w 119881"/>
                <a:gd name="connsiteY25" fmla="*/ 49845 h 1754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</a:cxnLst>
              <a:rect l="l" t="t" r="r" b="b"/>
              <a:pathLst>
                <a:path w="119881" h="175403">
                  <a:moveTo>
                    <a:pt x="66881" y="76345"/>
                  </a:moveTo>
                  <a:lnTo>
                    <a:pt x="24607" y="76345"/>
                  </a:lnTo>
                  <a:lnTo>
                    <a:pt x="24607" y="22714"/>
                  </a:lnTo>
                  <a:lnTo>
                    <a:pt x="66881" y="22714"/>
                  </a:lnTo>
                  <a:cubicBezTo>
                    <a:pt x="73822" y="22714"/>
                    <a:pt x="80762" y="25238"/>
                    <a:pt x="85179" y="30285"/>
                  </a:cubicBezTo>
                  <a:cubicBezTo>
                    <a:pt x="90227" y="35333"/>
                    <a:pt x="92751" y="41642"/>
                    <a:pt x="92751" y="48583"/>
                  </a:cubicBezTo>
                  <a:lnTo>
                    <a:pt x="92751" y="50476"/>
                  </a:lnTo>
                  <a:cubicBezTo>
                    <a:pt x="92751" y="57416"/>
                    <a:pt x="90227" y="64357"/>
                    <a:pt x="85179" y="68773"/>
                  </a:cubicBezTo>
                  <a:cubicBezTo>
                    <a:pt x="80131" y="73190"/>
                    <a:pt x="73822" y="76345"/>
                    <a:pt x="66881" y="76345"/>
                  </a:cubicBezTo>
                  <a:close/>
                  <a:moveTo>
                    <a:pt x="119882" y="49845"/>
                  </a:moveTo>
                  <a:lnTo>
                    <a:pt x="119882" y="49845"/>
                  </a:lnTo>
                  <a:cubicBezTo>
                    <a:pt x="119882" y="36595"/>
                    <a:pt x="114834" y="23976"/>
                    <a:pt x="105370" y="14512"/>
                  </a:cubicBezTo>
                  <a:cubicBezTo>
                    <a:pt x="95905" y="5048"/>
                    <a:pt x="83917" y="0"/>
                    <a:pt x="70667" y="0"/>
                  </a:cubicBezTo>
                  <a:lnTo>
                    <a:pt x="0" y="0"/>
                  </a:lnTo>
                  <a:lnTo>
                    <a:pt x="0" y="174772"/>
                  </a:lnTo>
                  <a:lnTo>
                    <a:pt x="25238" y="174772"/>
                  </a:lnTo>
                  <a:lnTo>
                    <a:pt x="25238" y="98428"/>
                  </a:lnTo>
                  <a:lnTo>
                    <a:pt x="37226" y="98428"/>
                  </a:lnTo>
                  <a:lnTo>
                    <a:pt x="86441" y="175403"/>
                  </a:lnTo>
                  <a:lnTo>
                    <a:pt x="117989" y="175403"/>
                  </a:lnTo>
                  <a:lnTo>
                    <a:pt x="67512" y="98428"/>
                  </a:lnTo>
                  <a:lnTo>
                    <a:pt x="71298" y="98428"/>
                  </a:lnTo>
                  <a:cubicBezTo>
                    <a:pt x="77608" y="98428"/>
                    <a:pt x="83917" y="97166"/>
                    <a:pt x="90227" y="94642"/>
                  </a:cubicBezTo>
                  <a:cubicBezTo>
                    <a:pt x="95905" y="92118"/>
                    <a:pt x="101584" y="88333"/>
                    <a:pt x="106001" y="83916"/>
                  </a:cubicBezTo>
                  <a:cubicBezTo>
                    <a:pt x="110417" y="79499"/>
                    <a:pt x="114203" y="73821"/>
                    <a:pt x="116727" y="68142"/>
                  </a:cubicBezTo>
                  <a:cubicBezTo>
                    <a:pt x="118620" y="62464"/>
                    <a:pt x="119882" y="56154"/>
                    <a:pt x="119882" y="49845"/>
                  </a:cubicBezTo>
                  <a:close/>
                </a:path>
              </a:pathLst>
            </a:custGeom>
            <a:solidFill>
              <a:schemeClr val="bg1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9" name="Friform 8">
              <a:extLst>
                <a:ext uri="{FF2B5EF4-FFF2-40B4-BE49-F238E27FC236}">
                  <a16:creationId xmlns:a16="http://schemas.microsoft.com/office/drawing/2014/main" id="{2155C271-B3EC-E440-9284-9A0B58693943}"/>
                </a:ext>
              </a:extLst>
            </p:cNvPr>
            <p:cNvSpPr/>
            <p:nvPr/>
          </p:nvSpPr>
          <p:spPr>
            <a:xfrm>
              <a:off x="1109003" y="394334"/>
              <a:ext cx="120512" cy="174772"/>
            </a:xfrm>
            <a:custGeom>
              <a:avLst/>
              <a:gdLst>
                <a:gd name="connsiteX0" fmla="*/ 92751 w 120512"/>
                <a:gd name="connsiteY0" fmla="*/ 49845 h 174772"/>
                <a:gd name="connsiteX1" fmla="*/ 85179 w 120512"/>
                <a:gd name="connsiteY1" fmla="*/ 68142 h 174772"/>
                <a:gd name="connsiteX2" fmla="*/ 66881 w 120512"/>
                <a:gd name="connsiteY2" fmla="*/ 75714 h 174772"/>
                <a:gd name="connsiteX3" fmla="*/ 24607 w 120512"/>
                <a:gd name="connsiteY3" fmla="*/ 75714 h 174772"/>
                <a:gd name="connsiteX4" fmla="*/ 24607 w 120512"/>
                <a:gd name="connsiteY4" fmla="*/ 22083 h 174772"/>
                <a:gd name="connsiteX5" fmla="*/ 66881 w 120512"/>
                <a:gd name="connsiteY5" fmla="*/ 22083 h 174772"/>
                <a:gd name="connsiteX6" fmla="*/ 85179 w 120512"/>
                <a:gd name="connsiteY6" fmla="*/ 29654 h 174772"/>
                <a:gd name="connsiteX7" fmla="*/ 92751 w 120512"/>
                <a:gd name="connsiteY7" fmla="*/ 47952 h 174772"/>
                <a:gd name="connsiteX8" fmla="*/ 92751 w 120512"/>
                <a:gd name="connsiteY8" fmla="*/ 49845 h 174772"/>
                <a:gd name="connsiteX9" fmla="*/ 71298 w 120512"/>
                <a:gd name="connsiteY9" fmla="*/ 0 h 174772"/>
                <a:gd name="connsiteX10" fmla="*/ 0 w 120512"/>
                <a:gd name="connsiteY10" fmla="*/ 0 h 174772"/>
                <a:gd name="connsiteX11" fmla="*/ 0 w 120512"/>
                <a:gd name="connsiteY11" fmla="*/ 174772 h 174772"/>
                <a:gd name="connsiteX12" fmla="*/ 25238 w 120512"/>
                <a:gd name="connsiteY12" fmla="*/ 174772 h 174772"/>
                <a:gd name="connsiteX13" fmla="*/ 25238 w 120512"/>
                <a:gd name="connsiteY13" fmla="*/ 97797 h 174772"/>
                <a:gd name="connsiteX14" fmla="*/ 71298 w 120512"/>
                <a:gd name="connsiteY14" fmla="*/ 97797 h 174772"/>
                <a:gd name="connsiteX15" fmla="*/ 90227 w 120512"/>
                <a:gd name="connsiteY15" fmla="*/ 94011 h 174772"/>
                <a:gd name="connsiteX16" fmla="*/ 106001 w 120512"/>
                <a:gd name="connsiteY16" fmla="*/ 83285 h 174772"/>
                <a:gd name="connsiteX17" fmla="*/ 116727 w 120512"/>
                <a:gd name="connsiteY17" fmla="*/ 67511 h 174772"/>
                <a:gd name="connsiteX18" fmla="*/ 120513 w 120512"/>
                <a:gd name="connsiteY18" fmla="*/ 48583 h 174772"/>
                <a:gd name="connsiteX19" fmla="*/ 120513 w 120512"/>
                <a:gd name="connsiteY19" fmla="*/ 48583 h 174772"/>
                <a:gd name="connsiteX20" fmla="*/ 106001 w 120512"/>
                <a:gd name="connsiteY20" fmla="*/ 13881 h 174772"/>
                <a:gd name="connsiteX21" fmla="*/ 71298 w 120512"/>
                <a:gd name="connsiteY21" fmla="*/ 0 h 1747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</a:cxnLst>
              <a:rect l="l" t="t" r="r" b="b"/>
              <a:pathLst>
                <a:path w="120512" h="174772">
                  <a:moveTo>
                    <a:pt x="92751" y="49845"/>
                  </a:moveTo>
                  <a:cubicBezTo>
                    <a:pt x="92751" y="56785"/>
                    <a:pt x="90227" y="63726"/>
                    <a:pt x="85179" y="68142"/>
                  </a:cubicBezTo>
                  <a:cubicBezTo>
                    <a:pt x="80131" y="72559"/>
                    <a:pt x="73822" y="75714"/>
                    <a:pt x="66881" y="75714"/>
                  </a:cubicBezTo>
                  <a:lnTo>
                    <a:pt x="24607" y="75714"/>
                  </a:lnTo>
                  <a:lnTo>
                    <a:pt x="24607" y="22083"/>
                  </a:lnTo>
                  <a:lnTo>
                    <a:pt x="66881" y="22083"/>
                  </a:lnTo>
                  <a:cubicBezTo>
                    <a:pt x="73822" y="22083"/>
                    <a:pt x="80762" y="24607"/>
                    <a:pt x="85179" y="29654"/>
                  </a:cubicBezTo>
                  <a:cubicBezTo>
                    <a:pt x="89596" y="34702"/>
                    <a:pt x="92751" y="41012"/>
                    <a:pt x="92751" y="47952"/>
                  </a:cubicBezTo>
                  <a:lnTo>
                    <a:pt x="92751" y="49845"/>
                  </a:lnTo>
                  <a:close/>
                  <a:moveTo>
                    <a:pt x="71298" y="0"/>
                  </a:moveTo>
                  <a:lnTo>
                    <a:pt x="0" y="0"/>
                  </a:lnTo>
                  <a:lnTo>
                    <a:pt x="0" y="174772"/>
                  </a:lnTo>
                  <a:lnTo>
                    <a:pt x="25238" y="174772"/>
                  </a:lnTo>
                  <a:lnTo>
                    <a:pt x="25238" y="97797"/>
                  </a:lnTo>
                  <a:lnTo>
                    <a:pt x="71298" y="97797"/>
                  </a:lnTo>
                  <a:cubicBezTo>
                    <a:pt x="77608" y="97797"/>
                    <a:pt x="83917" y="96535"/>
                    <a:pt x="90227" y="94011"/>
                  </a:cubicBezTo>
                  <a:cubicBezTo>
                    <a:pt x="96536" y="91487"/>
                    <a:pt x="101584" y="87702"/>
                    <a:pt x="106001" y="83285"/>
                  </a:cubicBezTo>
                  <a:cubicBezTo>
                    <a:pt x="110417" y="78868"/>
                    <a:pt x="114203" y="73190"/>
                    <a:pt x="116727" y="67511"/>
                  </a:cubicBezTo>
                  <a:cubicBezTo>
                    <a:pt x="119251" y="61833"/>
                    <a:pt x="120513" y="55523"/>
                    <a:pt x="120513" y="48583"/>
                  </a:cubicBezTo>
                  <a:lnTo>
                    <a:pt x="120513" y="48583"/>
                  </a:lnTo>
                  <a:cubicBezTo>
                    <a:pt x="120513" y="35333"/>
                    <a:pt x="115465" y="23345"/>
                    <a:pt x="106001" y="13881"/>
                  </a:cubicBezTo>
                  <a:cubicBezTo>
                    <a:pt x="96536" y="5048"/>
                    <a:pt x="83917" y="0"/>
                    <a:pt x="71298" y="0"/>
                  </a:cubicBezTo>
                  <a:close/>
                </a:path>
              </a:pathLst>
            </a:custGeom>
            <a:solidFill>
              <a:schemeClr val="bg1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0" name="Friform 9">
              <a:extLst>
                <a:ext uri="{FF2B5EF4-FFF2-40B4-BE49-F238E27FC236}">
                  <a16:creationId xmlns:a16="http://schemas.microsoft.com/office/drawing/2014/main" id="{CABCEB2B-D1C6-FF41-8954-5339E12DAF9B}"/>
                </a:ext>
              </a:extLst>
            </p:cNvPr>
            <p:cNvSpPr/>
            <p:nvPr/>
          </p:nvSpPr>
          <p:spPr>
            <a:xfrm>
              <a:off x="782168" y="394334"/>
              <a:ext cx="120354" cy="174772"/>
            </a:xfrm>
            <a:custGeom>
              <a:avLst/>
              <a:gdLst>
                <a:gd name="connsiteX0" fmla="*/ 93381 w 120354"/>
                <a:gd name="connsiteY0" fmla="*/ 49845 h 174772"/>
                <a:gd name="connsiteX1" fmla="*/ 91489 w 120354"/>
                <a:gd name="connsiteY1" fmla="*/ 59940 h 174772"/>
                <a:gd name="connsiteX2" fmla="*/ 85810 w 120354"/>
                <a:gd name="connsiteY2" fmla="*/ 68142 h 174772"/>
                <a:gd name="connsiteX3" fmla="*/ 77608 w 120354"/>
                <a:gd name="connsiteY3" fmla="*/ 73821 h 174772"/>
                <a:gd name="connsiteX4" fmla="*/ 67512 w 120354"/>
                <a:gd name="connsiteY4" fmla="*/ 75714 h 174772"/>
                <a:gd name="connsiteX5" fmla="*/ 25238 w 120354"/>
                <a:gd name="connsiteY5" fmla="*/ 75714 h 174772"/>
                <a:gd name="connsiteX6" fmla="*/ 25238 w 120354"/>
                <a:gd name="connsiteY6" fmla="*/ 22083 h 174772"/>
                <a:gd name="connsiteX7" fmla="*/ 67512 w 120354"/>
                <a:gd name="connsiteY7" fmla="*/ 22083 h 174772"/>
                <a:gd name="connsiteX8" fmla="*/ 85810 w 120354"/>
                <a:gd name="connsiteY8" fmla="*/ 29654 h 174772"/>
                <a:gd name="connsiteX9" fmla="*/ 93381 w 120354"/>
                <a:gd name="connsiteY9" fmla="*/ 47952 h 174772"/>
                <a:gd name="connsiteX10" fmla="*/ 93381 w 120354"/>
                <a:gd name="connsiteY10" fmla="*/ 49845 h 174772"/>
                <a:gd name="connsiteX11" fmla="*/ 93381 w 120354"/>
                <a:gd name="connsiteY11" fmla="*/ 126189 h 174772"/>
                <a:gd name="connsiteX12" fmla="*/ 85810 w 120354"/>
                <a:gd name="connsiteY12" fmla="*/ 144487 h 174772"/>
                <a:gd name="connsiteX13" fmla="*/ 67512 w 120354"/>
                <a:gd name="connsiteY13" fmla="*/ 152058 h 174772"/>
                <a:gd name="connsiteX14" fmla="*/ 25238 w 120354"/>
                <a:gd name="connsiteY14" fmla="*/ 152058 h 174772"/>
                <a:gd name="connsiteX15" fmla="*/ 25238 w 120354"/>
                <a:gd name="connsiteY15" fmla="*/ 98428 h 174772"/>
                <a:gd name="connsiteX16" fmla="*/ 67512 w 120354"/>
                <a:gd name="connsiteY16" fmla="*/ 98428 h 174772"/>
                <a:gd name="connsiteX17" fmla="*/ 85810 w 120354"/>
                <a:gd name="connsiteY17" fmla="*/ 105999 h 174772"/>
                <a:gd name="connsiteX18" fmla="*/ 93381 w 120354"/>
                <a:gd name="connsiteY18" fmla="*/ 124296 h 174772"/>
                <a:gd name="connsiteX19" fmla="*/ 93381 w 120354"/>
                <a:gd name="connsiteY19" fmla="*/ 126189 h 174772"/>
                <a:gd name="connsiteX20" fmla="*/ 119882 w 120354"/>
                <a:gd name="connsiteY20" fmla="*/ 48583 h 174772"/>
                <a:gd name="connsiteX21" fmla="*/ 105370 w 120354"/>
                <a:gd name="connsiteY21" fmla="*/ 14512 h 174772"/>
                <a:gd name="connsiteX22" fmla="*/ 71298 w 120354"/>
                <a:gd name="connsiteY22" fmla="*/ 0 h 174772"/>
                <a:gd name="connsiteX23" fmla="*/ 0 w 120354"/>
                <a:gd name="connsiteY23" fmla="*/ 0 h 174772"/>
                <a:gd name="connsiteX24" fmla="*/ 0 w 120354"/>
                <a:gd name="connsiteY24" fmla="*/ 174772 h 174772"/>
                <a:gd name="connsiteX25" fmla="*/ 71929 w 120354"/>
                <a:gd name="connsiteY25" fmla="*/ 174772 h 174772"/>
                <a:gd name="connsiteX26" fmla="*/ 100322 w 120354"/>
                <a:gd name="connsiteY26" fmla="*/ 165308 h 174772"/>
                <a:gd name="connsiteX27" fmla="*/ 117989 w 120354"/>
                <a:gd name="connsiteY27" fmla="*/ 141332 h 174772"/>
                <a:gd name="connsiteX28" fmla="*/ 117989 w 120354"/>
                <a:gd name="connsiteY28" fmla="*/ 111678 h 174772"/>
                <a:gd name="connsiteX29" fmla="*/ 100322 w 120354"/>
                <a:gd name="connsiteY29" fmla="*/ 87702 h 174772"/>
                <a:gd name="connsiteX30" fmla="*/ 114834 w 120354"/>
                <a:gd name="connsiteY30" fmla="*/ 70666 h 174772"/>
                <a:gd name="connsiteX31" fmla="*/ 119882 w 120354"/>
                <a:gd name="connsiteY31" fmla="*/ 48583 h 1747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</a:cxnLst>
              <a:rect l="l" t="t" r="r" b="b"/>
              <a:pathLst>
                <a:path w="120354" h="174772">
                  <a:moveTo>
                    <a:pt x="93381" y="49845"/>
                  </a:moveTo>
                  <a:cubicBezTo>
                    <a:pt x="93381" y="53000"/>
                    <a:pt x="92751" y="56785"/>
                    <a:pt x="91489" y="59940"/>
                  </a:cubicBezTo>
                  <a:cubicBezTo>
                    <a:pt x="90227" y="63095"/>
                    <a:pt x="88334" y="66249"/>
                    <a:pt x="85810" y="68142"/>
                  </a:cubicBezTo>
                  <a:cubicBezTo>
                    <a:pt x="83286" y="70666"/>
                    <a:pt x="80762" y="72559"/>
                    <a:pt x="77608" y="73821"/>
                  </a:cubicBezTo>
                  <a:cubicBezTo>
                    <a:pt x="74453" y="75083"/>
                    <a:pt x="71298" y="75714"/>
                    <a:pt x="67512" y="75714"/>
                  </a:cubicBezTo>
                  <a:lnTo>
                    <a:pt x="25238" y="75714"/>
                  </a:lnTo>
                  <a:lnTo>
                    <a:pt x="25238" y="22083"/>
                  </a:lnTo>
                  <a:lnTo>
                    <a:pt x="67512" y="22083"/>
                  </a:lnTo>
                  <a:cubicBezTo>
                    <a:pt x="74453" y="22083"/>
                    <a:pt x="81393" y="24607"/>
                    <a:pt x="85810" y="29654"/>
                  </a:cubicBezTo>
                  <a:cubicBezTo>
                    <a:pt x="90227" y="34702"/>
                    <a:pt x="93381" y="41012"/>
                    <a:pt x="93381" y="47952"/>
                  </a:cubicBezTo>
                  <a:lnTo>
                    <a:pt x="93381" y="49845"/>
                  </a:lnTo>
                  <a:close/>
                  <a:moveTo>
                    <a:pt x="93381" y="126189"/>
                  </a:moveTo>
                  <a:cubicBezTo>
                    <a:pt x="93381" y="133130"/>
                    <a:pt x="90858" y="140070"/>
                    <a:pt x="85810" y="144487"/>
                  </a:cubicBezTo>
                  <a:cubicBezTo>
                    <a:pt x="80762" y="149534"/>
                    <a:pt x="74453" y="152058"/>
                    <a:pt x="67512" y="152058"/>
                  </a:cubicBezTo>
                  <a:lnTo>
                    <a:pt x="25238" y="152058"/>
                  </a:lnTo>
                  <a:lnTo>
                    <a:pt x="25238" y="98428"/>
                  </a:lnTo>
                  <a:lnTo>
                    <a:pt x="67512" y="98428"/>
                  </a:lnTo>
                  <a:cubicBezTo>
                    <a:pt x="74453" y="98428"/>
                    <a:pt x="81393" y="100951"/>
                    <a:pt x="85810" y="105999"/>
                  </a:cubicBezTo>
                  <a:cubicBezTo>
                    <a:pt x="90858" y="111047"/>
                    <a:pt x="93381" y="117356"/>
                    <a:pt x="93381" y="124296"/>
                  </a:cubicBezTo>
                  <a:lnTo>
                    <a:pt x="93381" y="126189"/>
                  </a:lnTo>
                  <a:close/>
                  <a:moveTo>
                    <a:pt x="119882" y="48583"/>
                  </a:moveTo>
                  <a:cubicBezTo>
                    <a:pt x="119882" y="35964"/>
                    <a:pt x="114834" y="23345"/>
                    <a:pt x="105370" y="14512"/>
                  </a:cubicBezTo>
                  <a:cubicBezTo>
                    <a:pt x="96536" y="5679"/>
                    <a:pt x="83917" y="0"/>
                    <a:pt x="71298" y="0"/>
                  </a:cubicBezTo>
                  <a:lnTo>
                    <a:pt x="0" y="0"/>
                  </a:lnTo>
                  <a:lnTo>
                    <a:pt x="0" y="174772"/>
                  </a:lnTo>
                  <a:lnTo>
                    <a:pt x="71929" y="174772"/>
                  </a:lnTo>
                  <a:cubicBezTo>
                    <a:pt x="82024" y="174772"/>
                    <a:pt x="92120" y="171617"/>
                    <a:pt x="100322" y="165308"/>
                  </a:cubicBezTo>
                  <a:cubicBezTo>
                    <a:pt x="108524" y="159629"/>
                    <a:pt x="114834" y="150796"/>
                    <a:pt x="117989" y="141332"/>
                  </a:cubicBezTo>
                  <a:cubicBezTo>
                    <a:pt x="121144" y="131868"/>
                    <a:pt x="121144" y="121142"/>
                    <a:pt x="117989" y="111678"/>
                  </a:cubicBezTo>
                  <a:cubicBezTo>
                    <a:pt x="114834" y="102213"/>
                    <a:pt x="108524" y="93380"/>
                    <a:pt x="100322" y="87702"/>
                  </a:cubicBezTo>
                  <a:cubicBezTo>
                    <a:pt x="106632" y="83285"/>
                    <a:pt x="111679" y="77606"/>
                    <a:pt x="114834" y="70666"/>
                  </a:cubicBezTo>
                  <a:cubicBezTo>
                    <a:pt x="117989" y="63726"/>
                    <a:pt x="119882" y="56154"/>
                    <a:pt x="119882" y="48583"/>
                  </a:cubicBezTo>
                  <a:close/>
                </a:path>
              </a:pathLst>
            </a:custGeom>
            <a:solidFill>
              <a:schemeClr val="bg1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1" name="Friform 10">
              <a:extLst>
                <a:ext uri="{FF2B5EF4-FFF2-40B4-BE49-F238E27FC236}">
                  <a16:creationId xmlns:a16="http://schemas.microsoft.com/office/drawing/2014/main" id="{FDE142EE-EA11-0D44-8133-C976551BE02B}"/>
                </a:ext>
              </a:extLst>
            </p:cNvPr>
            <p:cNvSpPr/>
            <p:nvPr/>
          </p:nvSpPr>
          <p:spPr>
            <a:xfrm>
              <a:off x="454701" y="393704"/>
              <a:ext cx="116095" cy="116725"/>
            </a:xfrm>
            <a:custGeom>
              <a:avLst/>
              <a:gdLst>
                <a:gd name="connsiteX0" fmla="*/ 58048 w 116095"/>
                <a:gd name="connsiteY0" fmla="*/ 0 h 116725"/>
                <a:gd name="connsiteX1" fmla="*/ 99060 w 116095"/>
                <a:gd name="connsiteY1" fmla="*/ 17036 h 116725"/>
                <a:gd name="connsiteX2" fmla="*/ 116096 w 116095"/>
                <a:gd name="connsiteY2" fmla="*/ 58047 h 116725"/>
                <a:gd name="connsiteX3" fmla="*/ 116096 w 116095"/>
                <a:gd name="connsiteY3" fmla="*/ 116725 h 116725"/>
                <a:gd name="connsiteX4" fmla="*/ 0 w 116095"/>
                <a:gd name="connsiteY4" fmla="*/ 116725 h 116725"/>
                <a:gd name="connsiteX5" fmla="*/ 0 w 116095"/>
                <a:gd name="connsiteY5" fmla="*/ 58678 h 116725"/>
                <a:gd name="connsiteX6" fmla="*/ 17036 w 116095"/>
                <a:gd name="connsiteY6" fmla="*/ 17667 h 116725"/>
                <a:gd name="connsiteX7" fmla="*/ 58048 w 116095"/>
                <a:gd name="connsiteY7" fmla="*/ 0 h 1167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116095" h="116725">
                  <a:moveTo>
                    <a:pt x="58048" y="0"/>
                  </a:moveTo>
                  <a:cubicBezTo>
                    <a:pt x="73822" y="0"/>
                    <a:pt x="88334" y="6309"/>
                    <a:pt x="99060" y="17036"/>
                  </a:cubicBezTo>
                  <a:cubicBezTo>
                    <a:pt x="109786" y="27762"/>
                    <a:pt x="116096" y="42904"/>
                    <a:pt x="116096" y="58047"/>
                  </a:cubicBezTo>
                  <a:lnTo>
                    <a:pt x="116096" y="116725"/>
                  </a:lnTo>
                  <a:lnTo>
                    <a:pt x="0" y="116725"/>
                  </a:lnTo>
                  <a:lnTo>
                    <a:pt x="0" y="58678"/>
                  </a:lnTo>
                  <a:cubicBezTo>
                    <a:pt x="0" y="42904"/>
                    <a:pt x="6310" y="28393"/>
                    <a:pt x="17036" y="17667"/>
                  </a:cubicBezTo>
                  <a:cubicBezTo>
                    <a:pt x="27762" y="6940"/>
                    <a:pt x="42905" y="0"/>
                    <a:pt x="58048" y="0"/>
                  </a:cubicBezTo>
                  <a:close/>
                </a:path>
              </a:pathLst>
            </a:custGeom>
            <a:solidFill>
              <a:srgbClr val="E31836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2" name="Friform 11">
              <a:extLst>
                <a:ext uri="{FF2B5EF4-FFF2-40B4-BE49-F238E27FC236}">
                  <a16:creationId xmlns:a16="http://schemas.microsoft.com/office/drawing/2014/main" id="{BE68B60E-5400-E548-B180-D50FFA1F5567}"/>
                </a:ext>
              </a:extLst>
            </p:cNvPr>
            <p:cNvSpPr/>
            <p:nvPr/>
          </p:nvSpPr>
          <p:spPr>
            <a:xfrm>
              <a:off x="396023" y="452382"/>
              <a:ext cx="58678" cy="116094"/>
            </a:xfrm>
            <a:custGeom>
              <a:avLst/>
              <a:gdLst>
                <a:gd name="connsiteX0" fmla="*/ 58679 w 58678"/>
                <a:gd name="connsiteY0" fmla="*/ 0 h 116094"/>
                <a:gd name="connsiteX1" fmla="*/ 17667 w 58678"/>
                <a:gd name="connsiteY1" fmla="*/ 17036 h 116094"/>
                <a:gd name="connsiteX2" fmla="*/ 0 w 58678"/>
                <a:gd name="connsiteY2" fmla="*/ 58047 h 116094"/>
                <a:gd name="connsiteX3" fmla="*/ 17036 w 58678"/>
                <a:gd name="connsiteY3" fmla="*/ 99059 h 116094"/>
                <a:gd name="connsiteX4" fmla="*/ 58048 w 58678"/>
                <a:gd name="connsiteY4" fmla="*/ 116094 h 116094"/>
                <a:gd name="connsiteX5" fmla="*/ 58048 w 58678"/>
                <a:gd name="connsiteY5" fmla="*/ 116094 h 116094"/>
                <a:gd name="connsiteX6" fmla="*/ 58048 w 58678"/>
                <a:gd name="connsiteY6" fmla="*/ 116094 h 116094"/>
                <a:gd name="connsiteX7" fmla="*/ 58048 w 58678"/>
                <a:gd name="connsiteY7" fmla="*/ 0 h 1160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58678" h="116094">
                  <a:moveTo>
                    <a:pt x="58679" y="0"/>
                  </a:moveTo>
                  <a:cubicBezTo>
                    <a:pt x="42905" y="0"/>
                    <a:pt x="28393" y="6309"/>
                    <a:pt x="17667" y="17036"/>
                  </a:cubicBezTo>
                  <a:cubicBezTo>
                    <a:pt x="6310" y="27762"/>
                    <a:pt x="0" y="42904"/>
                    <a:pt x="0" y="58047"/>
                  </a:cubicBezTo>
                  <a:cubicBezTo>
                    <a:pt x="0" y="73821"/>
                    <a:pt x="6310" y="88332"/>
                    <a:pt x="17036" y="99059"/>
                  </a:cubicBezTo>
                  <a:cubicBezTo>
                    <a:pt x="27762" y="109785"/>
                    <a:pt x="42905" y="116094"/>
                    <a:pt x="58048" y="116094"/>
                  </a:cubicBezTo>
                  <a:cubicBezTo>
                    <a:pt x="58048" y="116094"/>
                    <a:pt x="58048" y="116094"/>
                    <a:pt x="58048" y="116094"/>
                  </a:cubicBezTo>
                  <a:lnTo>
                    <a:pt x="58048" y="116094"/>
                  </a:lnTo>
                  <a:lnTo>
                    <a:pt x="58048" y="0"/>
                  </a:lnTo>
                  <a:close/>
                </a:path>
              </a:pathLst>
            </a:custGeom>
            <a:solidFill>
              <a:srgbClr val="728EE6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3" name="Friform 12">
              <a:extLst>
                <a:ext uri="{FF2B5EF4-FFF2-40B4-BE49-F238E27FC236}">
                  <a16:creationId xmlns:a16="http://schemas.microsoft.com/office/drawing/2014/main" id="{375D5841-1A60-CD4C-956D-CDB13050F634}"/>
                </a:ext>
              </a:extLst>
            </p:cNvPr>
            <p:cNvSpPr/>
            <p:nvPr/>
          </p:nvSpPr>
          <p:spPr>
            <a:xfrm>
              <a:off x="454701" y="510429"/>
              <a:ext cx="116726" cy="58047"/>
            </a:xfrm>
            <a:custGeom>
              <a:avLst/>
              <a:gdLst>
                <a:gd name="connsiteX0" fmla="*/ 116727 w 116726"/>
                <a:gd name="connsiteY0" fmla="*/ 0 h 58047"/>
                <a:gd name="connsiteX1" fmla="*/ 58048 w 116726"/>
                <a:gd name="connsiteY1" fmla="*/ 0 h 58047"/>
                <a:gd name="connsiteX2" fmla="*/ 41012 w 116726"/>
                <a:gd name="connsiteY2" fmla="*/ 41012 h 58047"/>
                <a:gd name="connsiteX3" fmla="*/ 0 w 116726"/>
                <a:gd name="connsiteY3" fmla="*/ 58047 h 58047"/>
                <a:gd name="connsiteX4" fmla="*/ 116727 w 116726"/>
                <a:gd name="connsiteY4" fmla="*/ 58047 h 58047"/>
                <a:gd name="connsiteX5" fmla="*/ 116727 w 116726"/>
                <a:gd name="connsiteY5" fmla="*/ 0 h 580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116726" h="58047">
                  <a:moveTo>
                    <a:pt x="116727" y="0"/>
                  </a:moveTo>
                  <a:lnTo>
                    <a:pt x="58048" y="0"/>
                  </a:lnTo>
                  <a:cubicBezTo>
                    <a:pt x="58048" y="15774"/>
                    <a:pt x="51738" y="30285"/>
                    <a:pt x="41012" y="41012"/>
                  </a:cubicBezTo>
                  <a:cubicBezTo>
                    <a:pt x="30286" y="51738"/>
                    <a:pt x="15143" y="58047"/>
                    <a:pt x="0" y="58047"/>
                  </a:cubicBezTo>
                  <a:lnTo>
                    <a:pt x="116727" y="58047"/>
                  </a:lnTo>
                  <a:lnTo>
                    <a:pt x="116727" y="0"/>
                  </a:lnTo>
                  <a:close/>
                </a:path>
              </a:pathLst>
            </a:custGeom>
            <a:solidFill>
              <a:srgbClr val="C2CFF4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4" name="Friform 13">
              <a:extLst>
                <a:ext uri="{FF2B5EF4-FFF2-40B4-BE49-F238E27FC236}">
                  <a16:creationId xmlns:a16="http://schemas.microsoft.com/office/drawing/2014/main" id="{37E584FD-1A9B-EA4B-B752-AC5EC51F4134}"/>
                </a:ext>
              </a:extLst>
            </p:cNvPr>
            <p:cNvSpPr/>
            <p:nvPr/>
          </p:nvSpPr>
          <p:spPr>
            <a:xfrm>
              <a:off x="454701" y="510429"/>
              <a:ext cx="58047" cy="58678"/>
            </a:xfrm>
            <a:custGeom>
              <a:avLst/>
              <a:gdLst>
                <a:gd name="connsiteX0" fmla="*/ 58048 w 58047"/>
                <a:gd name="connsiteY0" fmla="*/ 0 h 58678"/>
                <a:gd name="connsiteX1" fmla="*/ 0 w 58047"/>
                <a:gd name="connsiteY1" fmla="*/ 0 h 58678"/>
                <a:gd name="connsiteX2" fmla="*/ 0 w 58047"/>
                <a:gd name="connsiteY2" fmla="*/ 58678 h 58678"/>
                <a:gd name="connsiteX3" fmla="*/ 0 w 58047"/>
                <a:gd name="connsiteY3" fmla="*/ 58678 h 58678"/>
                <a:gd name="connsiteX4" fmla="*/ 41012 w 58047"/>
                <a:gd name="connsiteY4" fmla="*/ 41642 h 58678"/>
                <a:gd name="connsiteX5" fmla="*/ 58048 w 58047"/>
                <a:gd name="connsiteY5" fmla="*/ 0 h 5867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8047" h="58678">
                  <a:moveTo>
                    <a:pt x="58048" y="0"/>
                  </a:moveTo>
                  <a:lnTo>
                    <a:pt x="0" y="0"/>
                  </a:lnTo>
                  <a:lnTo>
                    <a:pt x="0" y="58678"/>
                  </a:lnTo>
                  <a:lnTo>
                    <a:pt x="0" y="58678"/>
                  </a:lnTo>
                  <a:cubicBezTo>
                    <a:pt x="15774" y="58678"/>
                    <a:pt x="30286" y="52369"/>
                    <a:pt x="41012" y="41642"/>
                  </a:cubicBezTo>
                  <a:cubicBezTo>
                    <a:pt x="52369" y="30285"/>
                    <a:pt x="58048" y="15774"/>
                    <a:pt x="58048" y="0"/>
                  </a:cubicBezTo>
                  <a:close/>
                </a:path>
              </a:pathLst>
            </a:custGeom>
            <a:solidFill>
              <a:srgbClr val="355EDB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5" name="Friform 14">
              <a:extLst>
                <a:ext uri="{FF2B5EF4-FFF2-40B4-BE49-F238E27FC236}">
                  <a16:creationId xmlns:a16="http://schemas.microsoft.com/office/drawing/2014/main" id="{0CB0DC64-E5F2-7B48-8881-992026495689}"/>
                </a:ext>
              </a:extLst>
            </p:cNvPr>
            <p:cNvSpPr/>
            <p:nvPr/>
          </p:nvSpPr>
          <p:spPr>
            <a:xfrm>
              <a:off x="454701" y="452382"/>
              <a:ext cx="116726" cy="58678"/>
            </a:xfrm>
            <a:custGeom>
              <a:avLst/>
              <a:gdLst>
                <a:gd name="connsiteX0" fmla="*/ 0 w 116726"/>
                <a:gd name="connsiteY0" fmla="*/ 0 h 58678"/>
                <a:gd name="connsiteX1" fmla="*/ 116727 w 116726"/>
                <a:gd name="connsiteY1" fmla="*/ 0 h 58678"/>
                <a:gd name="connsiteX2" fmla="*/ 116727 w 116726"/>
                <a:gd name="connsiteY2" fmla="*/ 58678 h 58678"/>
                <a:gd name="connsiteX3" fmla="*/ 0 w 116726"/>
                <a:gd name="connsiteY3" fmla="*/ 58678 h 5867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16726" h="58678">
                  <a:moveTo>
                    <a:pt x="0" y="0"/>
                  </a:moveTo>
                  <a:lnTo>
                    <a:pt x="116727" y="0"/>
                  </a:lnTo>
                  <a:lnTo>
                    <a:pt x="116727" y="58678"/>
                  </a:lnTo>
                  <a:lnTo>
                    <a:pt x="0" y="58678"/>
                  </a:lnTo>
                  <a:close/>
                </a:path>
              </a:pathLst>
            </a:custGeom>
            <a:solidFill>
              <a:srgbClr val="C21536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</p:grpSp>
      <p:sp>
        <p:nvSpPr>
          <p:cNvPr id="17" name="TekstSylinder 16">
            <a:extLst>
              <a:ext uri="{FF2B5EF4-FFF2-40B4-BE49-F238E27FC236}">
                <a16:creationId xmlns:a16="http://schemas.microsoft.com/office/drawing/2014/main" id="{FABB6000-10C3-E34D-AF83-204F770E3F07}"/>
              </a:ext>
            </a:extLst>
          </p:cNvPr>
          <p:cNvSpPr txBox="1"/>
          <p:nvPr userDrawn="1"/>
        </p:nvSpPr>
        <p:spPr>
          <a:xfrm>
            <a:off x="1124574" y="1084562"/>
            <a:ext cx="5320987" cy="1292662"/>
          </a:xfrm>
          <a:prstGeom prst="rect">
            <a:avLst/>
          </a:prstGeom>
          <a:noFill/>
          <a:ln>
            <a:noFill/>
          </a:ln>
        </p:spPr>
        <p:txBody>
          <a:bodyPr wrap="square" lIns="0" tIns="0" rIns="0" bIns="0" rtlCol="0" anchor="t" anchorCtr="0">
            <a:spAutoFit/>
          </a:bodyPr>
          <a:lstStyle/>
          <a:p>
            <a:r>
              <a:rPr lang="nb-NO" sz="2800" noProof="1">
                <a:solidFill>
                  <a:schemeClr val="bg1"/>
                </a:solidFill>
              </a:rPr>
              <a:t>Hdir og Bufdir er våre oppdragsgivere og vi finansieres gjennom årlige tilskuddsbrev</a:t>
            </a:r>
          </a:p>
        </p:txBody>
      </p:sp>
      <p:grpSp>
        <p:nvGrpSpPr>
          <p:cNvPr id="18" name="Gruppe 17">
            <a:extLst>
              <a:ext uri="{FF2B5EF4-FFF2-40B4-BE49-F238E27FC236}">
                <a16:creationId xmlns:a16="http://schemas.microsoft.com/office/drawing/2014/main" id="{3F281C44-891B-E34A-AB73-C7ADD7C1FF6D}"/>
              </a:ext>
            </a:extLst>
          </p:cNvPr>
          <p:cNvGrpSpPr/>
          <p:nvPr userDrawn="1"/>
        </p:nvGrpSpPr>
        <p:grpSpPr>
          <a:xfrm>
            <a:off x="7568697" y="2565529"/>
            <a:ext cx="3572378" cy="3572378"/>
            <a:chOff x="7568697" y="2093158"/>
            <a:chExt cx="3572378" cy="3572378"/>
          </a:xfrm>
        </p:grpSpPr>
        <p:sp>
          <p:nvSpPr>
            <p:cNvPr id="19" name="Ellipse 18">
              <a:extLst>
                <a:ext uri="{FF2B5EF4-FFF2-40B4-BE49-F238E27FC236}">
                  <a16:creationId xmlns:a16="http://schemas.microsoft.com/office/drawing/2014/main" id="{A588BF3E-2A53-B44A-B70C-397FEF7A3462}"/>
                </a:ext>
              </a:extLst>
            </p:cNvPr>
            <p:cNvSpPr/>
            <p:nvPr/>
          </p:nvSpPr>
          <p:spPr>
            <a:xfrm>
              <a:off x="7568697" y="2093158"/>
              <a:ext cx="3572378" cy="3572378"/>
            </a:xfrm>
            <a:prstGeom prst="ellipse">
              <a:avLst/>
            </a:prstGeom>
            <a:solidFill>
              <a:schemeClr val="bg1"/>
            </a:solidFill>
            <a:ln w="889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b-NO"/>
            </a:p>
          </p:txBody>
        </p:sp>
        <p:pic>
          <p:nvPicPr>
            <p:cNvPr id="20" name="Grafikk 19">
              <a:extLst>
                <a:ext uri="{FF2B5EF4-FFF2-40B4-BE49-F238E27FC236}">
                  <a16:creationId xmlns:a16="http://schemas.microsoft.com/office/drawing/2014/main" id="{C4B196C3-1095-8A41-9A7A-96B59E0B635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rcRect l="35371" t="31623" r="37921" b="29998"/>
            <a:stretch/>
          </p:blipFill>
          <p:spPr>
            <a:xfrm>
              <a:off x="8358377" y="2931598"/>
              <a:ext cx="1866276" cy="1895498"/>
            </a:xfrm>
            <a:prstGeom prst="rect">
              <a:avLst/>
            </a:prstGeom>
          </p:spPr>
        </p:pic>
      </p:grpSp>
      <p:pic>
        <p:nvPicPr>
          <p:cNvPr id="21" name="Grafikk 20">
            <a:extLst>
              <a:ext uri="{FF2B5EF4-FFF2-40B4-BE49-F238E27FC236}">
                <a16:creationId xmlns:a16="http://schemas.microsoft.com/office/drawing/2014/main" id="{8FFAF332-4E61-0549-83D0-D3F372599285}"/>
              </a:ext>
            </a:extLst>
          </p:cNvPr>
          <p:cNvPicPr>
            <a:picLocks noChangeAspect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050926" y="3583094"/>
            <a:ext cx="4192024" cy="539089"/>
          </a:xfrm>
          <a:prstGeom prst="rect">
            <a:avLst/>
          </a:prstGeom>
        </p:spPr>
      </p:pic>
      <p:pic>
        <p:nvPicPr>
          <p:cNvPr id="22" name="Grafikk 21">
            <a:extLst>
              <a:ext uri="{FF2B5EF4-FFF2-40B4-BE49-F238E27FC236}">
                <a16:creationId xmlns:a16="http://schemas.microsoft.com/office/drawing/2014/main" id="{525ABE20-75F9-4848-98F6-AD127F41EDA9}"/>
              </a:ext>
            </a:extLst>
          </p:cNvPr>
          <p:cNvPicPr>
            <a:picLocks noChangeAspect="1"/>
          </p:cNvPicPr>
          <p:nvPr userDrawn="1"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1124577" y="4426984"/>
            <a:ext cx="2074024" cy="572557"/>
          </a:xfrm>
          <a:prstGeom prst="rect">
            <a:avLst/>
          </a:prstGeom>
        </p:spPr>
      </p:pic>
      <p:grpSp>
        <p:nvGrpSpPr>
          <p:cNvPr id="23" name="Gruppe 22">
            <a:extLst>
              <a:ext uri="{FF2B5EF4-FFF2-40B4-BE49-F238E27FC236}">
                <a16:creationId xmlns:a16="http://schemas.microsoft.com/office/drawing/2014/main" id="{6EF12114-8794-624E-AA00-3409DA9915A3}"/>
              </a:ext>
            </a:extLst>
          </p:cNvPr>
          <p:cNvGrpSpPr/>
          <p:nvPr userDrawn="1"/>
        </p:nvGrpSpPr>
        <p:grpSpPr>
          <a:xfrm>
            <a:off x="5638800" y="3917727"/>
            <a:ext cx="914400" cy="914400"/>
            <a:chOff x="8446259" y="4787630"/>
            <a:chExt cx="914400" cy="914400"/>
          </a:xfrm>
        </p:grpSpPr>
        <p:sp>
          <p:nvSpPr>
            <p:cNvPr id="24" name="Ellipse 23">
              <a:extLst>
                <a:ext uri="{FF2B5EF4-FFF2-40B4-BE49-F238E27FC236}">
                  <a16:creationId xmlns:a16="http://schemas.microsoft.com/office/drawing/2014/main" id="{022CFBA9-8BDB-514E-9B34-107A8D3E795E}"/>
                </a:ext>
              </a:extLst>
            </p:cNvPr>
            <p:cNvSpPr/>
            <p:nvPr/>
          </p:nvSpPr>
          <p:spPr>
            <a:xfrm>
              <a:off x="8446259" y="4787630"/>
              <a:ext cx="914400" cy="914400"/>
            </a:xfrm>
            <a:prstGeom prst="ellipse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b-NO"/>
            </a:p>
          </p:txBody>
        </p:sp>
        <p:sp>
          <p:nvSpPr>
            <p:cNvPr id="25" name="Friform 24" descr="Pil høyre kontur">
              <a:extLst>
                <a:ext uri="{FF2B5EF4-FFF2-40B4-BE49-F238E27FC236}">
                  <a16:creationId xmlns:a16="http://schemas.microsoft.com/office/drawing/2014/main" id="{2A17BDDB-7046-934A-BD39-F0764BEFCD75}"/>
                </a:ext>
              </a:extLst>
            </p:cNvPr>
            <p:cNvSpPr/>
            <p:nvPr/>
          </p:nvSpPr>
          <p:spPr>
            <a:xfrm>
              <a:off x="8636123" y="5092430"/>
              <a:ext cx="481664" cy="304800"/>
            </a:xfrm>
            <a:custGeom>
              <a:avLst/>
              <a:gdLst>
                <a:gd name="connsiteX0" fmla="*/ 336000 w 481664"/>
                <a:gd name="connsiteY0" fmla="*/ 2674 h 304800"/>
                <a:gd name="connsiteX1" fmla="*/ 478875 w 481664"/>
                <a:gd name="connsiteY1" fmla="*/ 145549 h 304800"/>
                <a:gd name="connsiteX2" fmla="*/ 478875 w 481664"/>
                <a:gd name="connsiteY2" fmla="*/ 159017 h 304800"/>
                <a:gd name="connsiteX3" fmla="*/ 336000 w 481664"/>
                <a:gd name="connsiteY3" fmla="*/ 301892 h 304800"/>
                <a:gd name="connsiteX4" fmla="*/ 335766 w 481664"/>
                <a:gd name="connsiteY4" fmla="*/ 302127 h 304800"/>
                <a:gd name="connsiteX5" fmla="*/ 322298 w 481664"/>
                <a:gd name="connsiteY5" fmla="*/ 301892 h 304800"/>
                <a:gd name="connsiteX6" fmla="*/ 322532 w 481664"/>
                <a:gd name="connsiteY6" fmla="*/ 288424 h 304800"/>
                <a:gd name="connsiteX7" fmla="*/ 448986 w 481664"/>
                <a:gd name="connsiteY7" fmla="*/ 161970 h 304800"/>
                <a:gd name="connsiteX8" fmla="*/ 449013 w 481664"/>
                <a:gd name="connsiteY8" fmla="*/ 161904 h 304800"/>
                <a:gd name="connsiteX9" fmla="*/ 448919 w 481664"/>
                <a:gd name="connsiteY9" fmla="*/ 161808 h 304800"/>
                <a:gd name="connsiteX10" fmla="*/ 0 w 481664"/>
                <a:gd name="connsiteY10" fmla="*/ 161808 h 304800"/>
                <a:gd name="connsiteX11" fmla="*/ 0 w 481664"/>
                <a:gd name="connsiteY11" fmla="*/ 142758 h 304800"/>
                <a:gd name="connsiteX12" fmla="*/ 448919 w 481664"/>
                <a:gd name="connsiteY12" fmla="*/ 142758 h 304800"/>
                <a:gd name="connsiteX13" fmla="*/ 448985 w 481664"/>
                <a:gd name="connsiteY13" fmla="*/ 142730 h 304800"/>
                <a:gd name="connsiteX14" fmla="*/ 448986 w 481664"/>
                <a:gd name="connsiteY14" fmla="*/ 142596 h 304800"/>
                <a:gd name="connsiteX15" fmla="*/ 322532 w 481664"/>
                <a:gd name="connsiteY15" fmla="*/ 16142 h 304800"/>
                <a:gd name="connsiteX16" fmla="*/ 322532 w 481664"/>
                <a:gd name="connsiteY16" fmla="*/ 2908 h 304800"/>
                <a:gd name="connsiteX17" fmla="*/ 336000 w 481664"/>
                <a:gd name="connsiteY17" fmla="*/ 2674 h 3048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</a:cxnLst>
              <a:rect l="l" t="t" r="r" b="b"/>
              <a:pathLst>
                <a:path w="481664" h="304800">
                  <a:moveTo>
                    <a:pt x="336000" y="2674"/>
                  </a:moveTo>
                  <a:lnTo>
                    <a:pt x="478875" y="145549"/>
                  </a:lnTo>
                  <a:cubicBezTo>
                    <a:pt x="482594" y="149268"/>
                    <a:pt x="482594" y="155298"/>
                    <a:pt x="478875" y="159017"/>
                  </a:cubicBezTo>
                  <a:lnTo>
                    <a:pt x="336000" y="301892"/>
                  </a:lnTo>
                  <a:cubicBezTo>
                    <a:pt x="335924" y="301971"/>
                    <a:pt x="335846" y="302049"/>
                    <a:pt x="335766" y="302127"/>
                  </a:cubicBezTo>
                  <a:cubicBezTo>
                    <a:pt x="331983" y="305781"/>
                    <a:pt x="325952" y="305677"/>
                    <a:pt x="322298" y="301892"/>
                  </a:cubicBezTo>
                  <a:cubicBezTo>
                    <a:pt x="318643" y="298108"/>
                    <a:pt x="318748" y="292079"/>
                    <a:pt x="322532" y="288424"/>
                  </a:cubicBezTo>
                  <a:lnTo>
                    <a:pt x="448986" y="161970"/>
                  </a:lnTo>
                  <a:cubicBezTo>
                    <a:pt x="449003" y="161953"/>
                    <a:pt x="449012" y="161929"/>
                    <a:pt x="449013" y="161904"/>
                  </a:cubicBezTo>
                  <a:cubicBezTo>
                    <a:pt x="449013" y="161852"/>
                    <a:pt x="448971" y="161809"/>
                    <a:pt x="448919" y="161808"/>
                  </a:cubicBezTo>
                  <a:lnTo>
                    <a:pt x="0" y="161808"/>
                  </a:lnTo>
                  <a:lnTo>
                    <a:pt x="0" y="142758"/>
                  </a:lnTo>
                  <a:lnTo>
                    <a:pt x="448919" y="142758"/>
                  </a:lnTo>
                  <a:cubicBezTo>
                    <a:pt x="448944" y="142758"/>
                    <a:pt x="448967" y="142748"/>
                    <a:pt x="448985" y="142730"/>
                  </a:cubicBezTo>
                  <a:cubicBezTo>
                    <a:pt x="449022" y="142694"/>
                    <a:pt x="449023" y="142633"/>
                    <a:pt x="448986" y="142596"/>
                  </a:cubicBezTo>
                  <a:lnTo>
                    <a:pt x="322532" y="16142"/>
                  </a:lnTo>
                  <a:cubicBezTo>
                    <a:pt x="318967" y="12451"/>
                    <a:pt x="318967" y="6599"/>
                    <a:pt x="322532" y="2908"/>
                  </a:cubicBezTo>
                  <a:cubicBezTo>
                    <a:pt x="326187" y="-876"/>
                    <a:pt x="332216" y="-981"/>
                    <a:pt x="336000" y="2674"/>
                  </a:cubicBezTo>
                  <a:close/>
                </a:path>
              </a:pathLst>
            </a:custGeom>
            <a:solidFill>
              <a:schemeClr val="bg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</p:grpSp>
    </p:spTree>
    <p:extLst>
      <p:ext uri="{BB962C8B-B14F-4D97-AF65-F5344CB8AC3E}">
        <p14:creationId xmlns:p14="http://schemas.microsoft.com/office/powerpoint/2010/main" val="1336991719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Kapittel tre rø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Logo, company name  Description automatically generated">
            <a:extLst>
              <a:ext uri="{FF2B5EF4-FFF2-40B4-BE49-F238E27FC236}">
                <a16:creationId xmlns:a16="http://schemas.microsoft.com/office/drawing/2014/main" id="{C3580309-7AB6-46CE-9557-7DF4BFFD13D0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0324" y="884611"/>
            <a:ext cx="10157254" cy="5078628"/>
          </a:xfrm>
          <a:prstGeom prst="rect">
            <a:avLst/>
          </a:prstGeom>
        </p:spPr>
      </p:pic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2311015" y="3746262"/>
            <a:ext cx="7575678" cy="1246446"/>
          </a:xfrm>
        </p:spPr>
        <p:txBody>
          <a:bodyPr lIns="0" tIns="0" rIns="0" bIns="0">
            <a:normAutofit/>
          </a:bodyPr>
          <a:lstStyle>
            <a:lvl1pPr marL="0" indent="0" algn="ctr">
              <a:buNone/>
              <a:defRPr sz="1500" b="1">
                <a:solidFill>
                  <a:schemeClr val="bg1"/>
                </a:solidFill>
              </a:defRPr>
            </a:lvl1pPr>
            <a:lvl2pPr marL="457223" indent="0" algn="ctr">
              <a:buNone/>
              <a:defRPr sz="2000"/>
            </a:lvl2pPr>
            <a:lvl3pPr marL="914446" indent="0" algn="ctr">
              <a:buNone/>
              <a:defRPr sz="1800"/>
            </a:lvl3pPr>
            <a:lvl4pPr marL="1371669" indent="0" algn="ctr">
              <a:buNone/>
              <a:defRPr sz="1600"/>
            </a:lvl4pPr>
            <a:lvl5pPr marL="1828891" indent="0" algn="ctr">
              <a:buNone/>
              <a:defRPr sz="1600"/>
            </a:lvl5pPr>
            <a:lvl6pPr marL="2286114" indent="0" algn="ctr">
              <a:buNone/>
              <a:defRPr sz="1600"/>
            </a:lvl6pPr>
            <a:lvl7pPr marL="2743337" indent="0" algn="ctr">
              <a:buNone/>
              <a:defRPr sz="1600"/>
            </a:lvl7pPr>
            <a:lvl8pPr marL="3200560" indent="0" algn="ctr">
              <a:buNone/>
              <a:defRPr sz="1600"/>
            </a:lvl8pPr>
            <a:lvl9pPr marL="3657783" indent="0" algn="ctr">
              <a:buNone/>
              <a:defRPr sz="1600"/>
            </a:lvl9pPr>
          </a:lstStyle>
          <a:p>
            <a:r>
              <a:rPr lang="nb-NO" dirty="0"/>
              <a:t>Undertittel</a:t>
            </a:r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2311015" y="1763811"/>
            <a:ext cx="7575678" cy="1764696"/>
          </a:xfrm>
        </p:spPr>
        <p:txBody>
          <a:bodyPr lIns="0" tIns="0" rIns="0" bIns="0" anchor="b">
            <a:normAutofit/>
          </a:bodyPr>
          <a:lstStyle>
            <a:lvl1pPr algn="ctr">
              <a:lnSpc>
                <a:spcPct val="110000"/>
              </a:lnSpc>
              <a:defRPr sz="3501" b="1">
                <a:solidFill>
                  <a:schemeClr val="bg1"/>
                </a:solidFill>
              </a:defRPr>
            </a:lvl1pPr>
          </a:lstStyle>
          <a:p>
            <a:r>
              <a:rPr lang="nb-NO" dirty="0"/>
              <a:t>Kapitteltittel</a:t>
            </a:r>
            <a:endParaRPr lang="en-US" dirty="0"/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3AD6C053-846D-4908-B264-CFEE9D88E4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BC5DA-09B7-4CD9-B21E-157BBBE69313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12980141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Kapittel tre grøn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Icon  Description automatically generated with medium confidence">
            <a:extLst>
              <a:ext uri="{FF2B5EF4-FFF2-40B4-BE49-F238E27FC236}">
                <a16:creationId xmlns:a16="http://schemas.microsoft.com/office/drawing/2014/main" id="{CA27D4A3-A815-4C1F-B632-A29007598346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1150" y="881575"/>
            <a:ext cx="10189699" cy="5094850"/>
          </a:xfrm>
          <a:prstGeom prst="rect">
            <a:avLst/>
          </a:prstGeom>
        </p:spPr>
      </p:pic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2311015" y="3746262"/>
            <a:ext cx="7575678" cy="1246446"/>
          </a:xfrm>
        </p:spPr>
        <p:txBody>
          <a:bodyPr lIns="0" tIns="0" rIns="0" bIns="0">
            <a:normAutofit/>
          </a:bodyPr>
          <a:lstStyle>
            <a:lvl1pPr marL="0" indent="0" algn="ctr">
              <a:buNone/>
              <a:defRPr sz="1500" b="1">
                <a:solidFill>
                  <a:schemeClr val="bg1"/>
                </a:solidFill>
              </a:defRPr>
            </a:lvl1pPr>
            <a:lvl2pPr marL="457223" indent="0" algn="ctr">
              <a:buNone/>
              <a:defRPr sz="2000"/>
            </a:lvl2pPr>
            <a:lvl3pPr marL="914446" indent="0" algn="ctr">
              <a:buNone/>
              <a:defRPr sz="1800"/>
            </a:lvl3pPr>
            <a:lvl4pPr marL="1371669" indent="0" algn="ctr">
              <a:buNone/>
              <a:defRPr sz="1600"/>
            </a:lvl4pPr>
            <a:lvl5pPr marL="1828891" indent="0" algn="ctr">
              <a:buNone/>
              <a:defRPr sz="1600"/>
            </a:lvl5pPr>
            <a:lvl6pPr marL="2286114" indent="0" algn="ctr">
              <a:buNone/>
              <a:defRPr sz="1600"/>
            </a:lvl6pPr>
            <a:lvl7pPr marL="2743337" indent="0" algn="ctr">
              <a:buNone/>
              <a:defRPr sz="1600"/>
            </a:lvl7pPr>
            <a:lvl8pPr marL="3200560" indent="0" algn="ctr">
              <a:buNone/>
              <a:defRPr sz="1600"/>
            </a:lvl8pPr>
            <a:lvl9pPr marL="3657783" indent="0" algn="ctr">
              <a:buNone/>
              <a:defRPr sz="1600"/>
            </a:lvl9pPr>
          </a:lstStyle>
          <a:p>
            <a:r>
              <a:rPr lang="nb-NO" dirty="0"/>
              <a:t>Undertittel</a:t>
            </a:r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2311015" y="1763811"/>
            <a:ext cx="7575678" cy="1764696"/>
          </a:xfrm>
        </p:spPr>
        <p:txBody>
          <a:bodyPr lIns="0" tIns="0" rIns="0" bIns="0" anchor="b">
            <a:normAutofit/>
          </a:bodyPr>
          <a:lstStyle>
            <a:lvl1pPr algn="ctr">
              <a:lnSpc>
                <a:spcPct val="110000"/>
              </a:lnSpc>
              <a:defRPr sz="3501" b="1">
                <a:solidFill>
                  <a:schemeClr val="bg1"/>
                </a:solidFill>
              </a:defRPr>
            </a:lvl1pPr>
          </a:lstStyle>
          <a:p>
            <a:r>
              <a:rPr lang="nb-NO" dirty="0"/>
              <a:t>Kapitteltittel</a:t>
            </a:r>
            <a:endParaRPr lang="en-US" dirty="0"/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E809C9E1-78B1-4552-A61E-39E8AA7303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BC5DA-09B7-4CD9-B21E-157BBBE69313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48569494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Kapittel tre blå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Chart, pie chart  Description automatically generated">
            <a:extLst>
              <a:ext uri="{FF2B5EF4-FFF2-40B4-BE49-F238E27FC236}">
                <a16:creationId xmlns:a16="http://schemas.microsoft.com/office/drawing/2014/main" id="{DC5B4502-35F7-4EF6-83EC-4631211B2B88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2405" y="902203"/>
            <a:ext cx="10115745" cy="5053594"/>
          </a:xfrm>
          <a:prstGeom prst="rect">
            <a:avLst/>
          </a:prstGeom>
        </p:spPr>
      </p:pic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2311015" y="3746262"/>
            <a:ext cx="7575678" cy="1246446"/>
          </a:xfrm>
        </p:spPr>
        <p:txBody>
          <a:bodyPr lIns="0" tIns="0" rIns="0" bIns="0">
            <a:normAutofit/>
          </a:bodyPr>
          <a:lstStyle>
            <a:lvl1pPr marL="0" indent="0" algn="ctr">
              <a:buNone/>
              <a:defRPr sz="1500" b="1">
                <a:solidFill>
                  <a:schemeClr val="bg1"/>
                </a:solidFill>
              </a:defRPr>
            </a:lvl1pPr>
            <a:lvl2pPr marL="457223" indent="0" algn="ctr">
              <a:buNone/>
              <a:defRPr sz="2000"/>
            </a:lvl2pPr>
            <a:lvl3pPr marL="914446" indent="0" algn="ctr">
              <a:buNone/>
              <a:defRPr sz="1800"/>
            </a:lvl3pPr>
            <a:lvl4pPr marL="1371669" indent="0" algn="ctr">
              <a:buNone/>
              <a:defRPr sz="1600"/>
            </a:lvl4pPr>
            <a:lvl5pPr marL="1828891" indent="0" algn="ctr">
              <a:buNone/>
              <a:defRPr sz="1600"/>
            </a:lvl5pPr>
            <a:lvl6pPr marL="2286114" indent="0" algn="ctr">
              <a:buNone/>
              <a:defRPr sz="1600"/>
            </a:lvl6pPr>
            <a:lvl7pPr marL="2743337" indent="0" algn="ctr">
              <a:buNone/>
              <a:defRPr sz="1600"/>
            </a:lvl7pPr>
            <a:lvl8pPr marL="3200560" indent="0" algn="ctr">
              <a:buNone/>
              <a:defRPr sz="1600"/>
            </a:lvl8pPr>
            <a:lvl9pPr marL="3657783" indent="0" algn="ctr">
              <a:buNone/>
              <a:defRPr sz="1600"/>
            </a:lvl9pPr>
          </a:lstStyle>
          <a:p>
            <a:r>
              <a:rPr lang="nb-NO" dirty="0"/>
              <a:t>Undertittel</a:t>
            </a:r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2311015" y="1763811"/>
            <a:ext cx="7575678" cy="1764696"/>
          </a:xfrm>
        </p:spPr>
        <p:txBody>
          <a:bodyPr lIns="0" tIns="0" rIns="0" bIns="0" anchor="b">
            <a:normAutofit/>
          </a:bodyPr>
          <a:lstStyle>
            <a:lvl1pPr algn="ctr">
              <a:lnSpc>
                <a:spcPct val="110000"/>
              </a:lnSpc>
              <a:defRPr sz="3501" b="1">
                <a:solidFill>
                  <a:schemeClr val="bg1"/>
                </a:solidFill>
              </a:defRPr>
            </a:lvl1pPr>
          </a:lstStyle>
          <a:p>
            <a:r>
              <a:rPr lang="nb-NO" dirty="0"/>
              <a:t>Kapitteltittel</a:t>
            </a:r>
            <a:endParaRPr lang="en-US" dirty="0"/>
          </a:p>
        </p:txBody>
      </p:sp>
      <p:sp>
        <p:nvSpPr>
          <p:cNvPr id="12" name="Slide Number Placeholder 11">
            <a:extLst>
              <a:ext uri="{FF2B5EF4-FFF2-40B4-BE49-F238E27FC236}">
                <a16:creationId xmlns:a16="http://schemas.microsoft.com/office/drawing/2014/main" id="{F9B36E74-61F2-43F3-88C0-B6EBF8E03C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BC5DA-09B7-4CD9-B21E-157BBBE69313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86479364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Mengde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25161ADC-CD6D-464E-B7E8-3DAB5FBDC7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86D482F9-C37B-3244-A56E-759DA3A25C2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nb-NO" dirty="0"/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72116A91-32DA-DD4F-A9A7-09AA204B37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FD0C1-8D6A-984B-BAA4-6C0BD30CA447}" type="datetime1">
              <a:rPr lang="nb-NO" smtClean="0"/>
              <a:t>25.01.2024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C97633DA-A4BE-9049-9E5A-FF76056EA1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F0608AA6-369E-1F4A-8BCB-36522B4E0C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7274F-C966-8C46-AFC4-F3A14ECF3B01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799777565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AE39FC8D-CD5E-A94C-9157-7E0AFD1899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1051200" y="1648800"/>
            <a:ext cx="4968600" cy="435133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nb-NO" dirty="0"/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1C900E3D-66D8-664E-8BCB-F1E9492959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648800"/>
            <a:ext cx="5181600" cy="435133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2580687D-0329-BF46-B372-CE44C18A2D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409BB-C003-8E44-A439-6715929C159D}" type="datetime1">
              <a:rPr lang="nb-NO" smtClean="0"/>
              <a:t>25.01.2024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1F5DB2BB-9931-0848-B4C6-C4CACC8E5E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9C9066C4-7D64-5947-8A60-9187DEB95E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7274F-C966-8C46-AFC4-F3A14ECF3B01}" type="slidenum">
              <a:rPr lang="nb-NO" smtClean="0"/>
              <a:t>‹#›</a:t>
            </a:fld>
            <a:endParaRPr lang="nb-NO"/>
          </a:p>
        </p:txBody>
      </p:sp>
      <p:sp>
        <p:nvSpPr>
          <p:cNvPr id="8" name="Tittel 7">
            <a:extLst>
              <a:ext uri="{FF2B5EF4-FFF2-40B4-BE49-F238E27FC236}">
                <a16:creationId xmlns:a16="http://schemas.microsoft.com/office/drawing/2014/main" id="{769638F1-D593-2846-A131-27B6006E91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</p:spTree>
    <p:extLst>
      <p:ext uri="{BB962C8B-B14F-4D97-AF65-F5344CB8AC3E}">
        <p14:creationId xmlns:p14="http://schemas.microsoft.com/office/powerpoint/2010/main" val="2272471589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n innholdsd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AE39FC8D-CD5E-A94C-9157-7E0AFD1899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1051200" y="1648800"/>
            <a:ext cx="4968600" cy="435133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nb-NO" dirty="0"/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2580687D-0329-BF46-B372-CE44C18A2D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409BB-C003-8E44-A439-6715929C159D}" type="datetime1">
              <a:rPr lang="nb-NO" smtClean="0"/>
              <a:t>25.01.2024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1F5DB2BB-9931-0848-B4C6-C4CACC8E5E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9C9066C4-7D64-5947-8A60-9187DEB95E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7274F-C966-8C46-AFC4-F3A14ECF3B01}" type="slidenum">
              <a:rPr lang="nb-NO" smtClean="0"/>
              <a:t>‹#›</a:t>
            </a:fld>
            <a:endParaRPr lang="nb-NO"/>
          </a:p>
        </p:txBody>
      </p:sp>
      <p:sp>
        <p:nvSpPr>
          <p:cNvPr id="8" name="Tittel 7">
            <a:extLst>
              <a:ext uri="{FF2B5EF4-FFF2-40B4-BE49-F238E27FC236}">
                <a16:creationId xmlns:a16="http://schemas.microsoft.com/office/drawing/2014/main" id="{769638F1-D593-2846-A131-27B6006E91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</p:spTree>
    <p:extLst>
      <p:ext uri="{BB962C8B-B14F-4D97-AF65-F5344CB8AC3E}">
        <p14:creationId xmlns:p14="http://schemas.microsoft.com/office/powerpoint/2010/main" val="2535484540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re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AE39FC8D-CD5E-A94C-9157-7E0AFD1899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1051199" y="1648800"/>
            <a:ext cx="3240000" cy="4352400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nb-NO" dirty="0"/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1C900E3D-66D8-664E-8BCB-F1E9492959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98000" y="1648800"/>
            <a:ext cx="3240000" cy="435133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nb-NO" dirty="0"/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2580687D-0329-BF46-B372-CE44C18A2D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409BB-C003-8E44-A439-6715929C159D}" type="datetime1">
              <a:rPr lang="nb-NO" smtClean="0"/>
              <a:t>25.01.2024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1F5DB2BB-9931-0848-B4C6-C4CACC8E5E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9C9066C4-7D64-5947-8A60-9187DEB95E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7274F-C966-8C46-AFC4-F3A14ECF3B01}" type="slidenum">
              <a:rPr lang="nb-NO" smtClean="0"/>
              <a:t>‹#›</a:t>
            </a:fld>
            <a:endParaRPr lang="nb-NO"/>
          </a:p>
        </p:txBody>
      </p:sp>
      <p:sp>
        <p:nvSpPr>
          <p:cNvPr id="8" name="Tittel 7">
            <a:extLst>
              <a:ext uri="{FF2B5EF4-FFF2-40B4-BE49-F238E27FC236}">
                <a16:creationId xmlns:a16="http://schemas.microsoft.com/office/drawing/2014/main" id="{769638F1-D593-2846-A131-27B6006E91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51200" y="856800"/>
            <a:ext cx="10533600" cy="705600"/>
          </a:xfrm>
        </p:spPr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10" name="Plassholder for innhold 3">
            <a:extLst>
              <a:ext uri="{FF2B5EF4-FFF2-40B4-BE49-F238E27FC236}">
                <a16:creationId xmlns:a16="http://schemas.microsoft.com/office/drawing/2014/main" id="{7D648917-D892-F54F-B53D-08FCA6253830}"/>
              </a:ext>
            </a:extLst>
          </p:cNvPr>
          <p:cNvSpPr>
            <a:spLocks noGrp="1"/>
          </p:cNvSpPr>
          <p:nvPr>
            <p:ph sz="half" idx="13"/>
          </p:nvPr>
        </p:nvSpPr>
        <p:spPr>
          <a:xfrm>
            <a:off x="8344800" y="1648800"/>
            <a:ext cx="3240000" cy="435133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21980070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kst og bilde høy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Graphic 8">
            <a:extLst>
              <a:ext uri="{FF2B5EF4-FFF2-40B4-BE49-F238E27FC236}">
                <a16:creationId xmlns:a16="http://schemas.microsoft.com/office/drawing/2014/main" id="{99EE3E8F-69F1-4126-83AB-3A64AEC51CB9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1583908" y="6137907"/>
            <a:ext cx="608092" cy="608083"/>
          </a:xfrm>
          <a:prstGeom prst="rect">
            <a:avLst/>
          </a:prstGeom>
        </p:spPr>
      </p:pic>
      <p:sp>
        <p:nvSpPr>
          <p:cNvPr id="6" name="Picture Placeholder 5">
            <a:extLst>
              <a:ext uri="{FF2B5EF4-FFF2-40B4-BE49-F238E27FC236}">
                <a16:creationId xmlns:a16="http://schemas.microsoft.com/office/drawing/2014/main" id="{EF1BAB11-A5D7-4E87-B446-A09650D76D8B}"/>
              </a:ext>
            </a:extLst>
          </p:cNvPr>
          <p:cNvSpPr>
            <a:spLocks noGrp="1"/>
          </p:cNvSpPr>
          <p:nvPr>
            <p:ph type="pic" sz="quarter" idx="14"/>
          </p:nvPr>
        </p:nvSpPr>
        <p:spPr>
          <a:xfrm>
            <a:off x="6096000" y="855762"/>
            <a:ext cx="5099714" cy="5103276"/>
          </a:xfrm>
          <a:solidFill>
            <a:schemeClr val="bg1">
              <a:lumMod val="85000"/>
            </a:schemeClr>
          </a:solidFill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b-NO"/>
              <a:t>Klikk på ikonet for å legge til et bilde</a:t>
            </a:r>
            <a:endParaRPr lang="en-US" dirty="0"/>
          </a:p>
        </p:txBody>
      </p:sp>
      <p:sp>
        <p:nvSpPr>
          <p:cNvPr id="2" name="Content Placeholder 1">
            <a:extLst>
              <a:ext uri="{FF2B5EF4-FFF2-40B4-BE49-F238E27FC236}">
                <a16:creationId xmlns:a16="http://schemas.microsoft.com/office/drawing/2014/main" id="{1A39A88D-7467-41D8-962F-1669AF17C798}"/>
              </a:ext>
            </a:extLst>
          </p:cNvPr>
          <p:cNvSpPr>
            <a:spLocks noGrp="1"/>
          </p:cNvSpPr>
          <p:nvPr>
            <p:ph sz="quarter" idx="15"/>
          </p:nvPr>
        </p:nvSpPr>
        <p:spPr>
          <a:xfrm>
            <a:off x="1049814" y="1648978"/>
            <a:ext cx="4584805" cy="4310061"/>
          </a:xfrm>
          <a:prstGeom prst="rect">
            <a:avLst/>
          </a:prstGeom>
        </p:spPr>
        <p:txBody>
          <a:bodyPr lIns="0" tIns="0" rIns="0" bIns="0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US"/>
          </a:p>
        </p:txBody>
      </p:sp>
      <p:sp>
        <p:nvSpPr>
          <p:cNvPr id="11" name="Slide Number Placeholder 10">
            <a:extLst>
              <a:ext uri="{FF2B5EF4-FFF2-40B4-BE49-F238E27FC236}">
                <a16:creationId xmlns:a16="http://schemas.microsoft.com/office/drawing/2014/main" id="{77028577-F95A-41FD-B362-3E9891A1C538}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/>
        <p:txBody>
          <a:bodyPr/>
          <a:lstStyle/>
          <a:p>
            <a:fld id="{1E4BC5DA-09B7-4CD9-B21E-157BBBE69313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4" name="Tittel 3">
            <a:extLst>
              <a:ext uri="{FF2B5EF4-FFF2-40B4-BE49-F238E27FC236}">
                <a16:creationId xmlns:a16="http://schemas.microsoft.com/office/drawing/2014/main" id="{814E7EBD-81B4-8540-BEA7-E66E278C76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51200" y="856800"/>
            <a:ext cx="4583419" cy="705600"/>
          </a:xfrm>
        </p:spPr>
        <p:txBody>
          <a:bodyPr/>
          <a:lstStyle/>
          <a:p>
            <a:r>
              <a:rPr lang="nb-NO"/>
              <a:t>Klikk for å redigere tittelstil</a:t>
            </a:r>
            <a:endParaRPr lang="nb-NO" dirty="0"/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9CD81BCE-7B47-C444-AE38-350BA3E3FB65}"/>
              </a:ext>
            </a:extLst>
          </p:cNvPr>
          <p:cNvSpPr>
            <a:spLocks noGrp="1"/>
          </p:cNvSpPr>
          <p:nvPr>
            <p:ph type="dt" sz="half" idx="19"/>
          </p:nvPr>
        </p:nvSpPr>
        <p:spPr/>
        <p:txBody>
          <a:bodyPr/>
          <a:lstStyle/>
          <a:p>
            <a:fld id="{9D03F6E6-5CDA-F241-BB38-1AEA2D1479E3}" type="datetime1">
              <a:rPr lang="nb-NO" smtClean="0"/>
              <a:t>25.01.2024</a:t>
            </a:fld>
            <a:endParaRPr lang="nb-NO"/>
          </a:p>
        </p:txBody>
      </p:sp>
      <p:sp>
        <p:nvSpPr>
          <p:cNvPr id="7" name="Plassholder for bunntekst 6">
            <a:extLst>
              <a:ext uri="{FF2B5EF4-FFF2-40B4-BE49-F238E27FC236}">
                <a16:creationId xmlns:a16="http://schemas.microsoft.com/office/drawing/2014/main" id="{579E207B-F514-BC47-A43F-D46DE78043C9}"/>
              </a:ext>
            </a:extLst>
          </p:cNvPr>
          <p:cNvSpPr>
            <a:spLocks noGrp="1"/>
          </p:cNvSpPr>
          <p:nvPr>
            <p:ph type="ftr" sz="quarter" idx="20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091771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kst og rundt bilde høy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Graphic 8">
            <a:extLst>
              <a:ext uri="{FF2B5EF4-FFF2-40B4-BE49-F238E27FC236}">
                <a16:creationId xmlns:a16="http://schemas.microsoft.com/office/drawing/2014/main" id="{99EE3E8F-69F1-4126-83AB-3A64AEC51CB9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1583908" y="6137907"/>
            <a:ext cx="608092" cy="608083"/>
          </a:xfrm>
          <a:prstGeom prst="rect">
            <a:avLst/>
          </a:prstGeom>
        </p:spPr>
      </p:pic>
      <p:sp>
        <p:nvSpPr>
          <p:cNvPr id="6" name="Picture Placeholder 5">
            <a:extLst>
              <a:ext uri="{FF2B5EF4-FFF2-40B4-BE49-F238E27FC236}">
                <a16:creationId xmlns:a16="http://schemas.microsoft.com/office/drawing/2014/main" id="{EF1BAB11-A5D7-4E87-B446-A09650D76D8B}"/>
              </a:ext>
            </a:extLst>
          </p:cNvPr>
          <p:cNvSpPr>
            <a:spLocks noGrp="1"/>
          </p:cNvSpPr>
          <p:nvPr>
            <p:ph type="pic" sz="quarter" idx="14"/>
          </p:nvPr>
        </p:nvSpPr>
        <p:spPr>
          <a:xfrm>
            <a:off x="7166412" y="1648976"/>
            <a:ext cx="4307053" cy="4310061"/>
          </a:xfrm>
          <a:prstGeom prst="ellipse">
            <a:avLst/>
          </a:prstGeom>
          <a:solidFill>
            <a:schemeClr val="bg1">
              <a:lumMod val="85000"/>
            </a:schemeClr>
          </a:solidFill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b-NO"/>
              <a:t>Klikk på ikonet for å legge til et bilde</a:t>
            </a:r>
            <a:endParaRPr lang="en-US" dirty="0"/>
          </a:p>
        </p:txBody>
      </p:sp>
      <p:sp>
        <p:nvSpPr>
          <p:cNvPr id="2" name="Content Placeholder 1">
            <a:extLst>
              <a:ext uri="{FF2B5EF4-FFF2-40B4-BE49-F238E27FC236}">
                <a16:creationId xmlns:a16="http://schemas.microsoft.com/office/drawing/2014/main" id="{1A39A88D-7467-41D8-962F-1669AF17C798}"/>
              </a:ext>
            </a:extLst>
          </p:cNvPr>
          <p:cNvSpPr>
            <a:spLocks noGrp="1"/>
          </p:cNvSpPr>
          <p:nvPr>
            <p:ph sz="quarter" idx="15"/>
          </p:nvPr>
        </p:nvSpPr>
        <p:spPr>
          <a:xfrm>
            <a:off x="1049813" y="1648978"/>
            <a:ext cx="5580000" cy="4310061"/>
          </a:xfrm>
          <a:prstGeom prst="rect">
            <a:avLst/>
          </a:prstGeom>
        </p:spPr>
        <p:txBody>
          <a:bodyPr lIns="0" tIns="0" rIns="0" bIns="0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US" dirty="0"/>
          </a:p>
        </p:txBody>
      </p:sp>
      <p:sp>
        <p:nvSpPr>
          <p:cNvPr id="11" name="Slide Number Placeholder 10">
            <a:extLst>
              <a:ext uri="{FF2B5EF4-FFF2-40B4-BE49-F238E27FC236}">
                <a16:creationId xmlns:a16="http://schemas.microsoft.com/office/drawing/2014/main" id="{77028577-F95A-41FD-B362-3E9891A1C538}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/>
        <p:txBody>
          <a:bodyPr/>
          <a:lstStyle/>
          <a:p>
            <a:fld id="{1E4BC5DA-09B7-4CD9-B21E-157BBBE69313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9CD81BCE-7B47-C444-AE38-350BA3E3FB65}"/>
              </a:ext>
            </a:extLst>
          </p:cNvPr>
          <p:cNvSpPr>
            <a:spLocks noGrp="1"/>
          </p:cNvSpPr>
          <p:nvPr>
            <p:ph type="dt" sz="half" idx="19"/>
          </p:nvPr>
        </p:nvSpPr>
        <p:spPr/>
        <p:txBody>
          <a:bodyPr/>
          <a:lstStyle/>
          <a:p>
            <a:fld id="{9D03F6E6-5CDA-F241-BB38-1AEA2D1479E3}" type="datetime1">
              <a:rPr lang="nb-NO" smtClean="0"/>
              <a:t>25.01.2024</a:t>
            </a:fld>
            <a:endParaRPr lang="nb-NO"/>
          </a:p>
        </p:txBody>
      </p:sp>
      <p:sp>
        <p:nvSpPr>
          <p:cNvPr id="7" name="Plassholder for bunntekst 6">
            <a:extLst>
              <a:ext uri="{FF2B5EF4-FFF2-40B4-BE49-F238E27FC236}">
                <a16:creationId xmlns:a16="http://schemas.microsoft.com/office/drawing/2014/main" id="{579E207B-F514-BC47-A43F-D46DE78043C9}"/>
              </a:ext>
            </a:extLst>
          </p:cNvPr>
          <p:cNvSpPr>
            <a:spLocks noGrp="1"/>
          </p:cNvSpPr>
          <p:nvPr>
            <p:ph type="ftr" sz="quarter" idx="20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3" name="Tittel 2">
            <a:extLst>
              <a:ext uri="{FF2B5EF4-FFF2-40B4-BE49-F238E27FC236}">
                <a16:creationId xmlns:a16="http://schemas.microsoft.com/office/drawing/2014/main" id="{A849F1B7-ABFC-4B46-B012-1AF9091EC0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</p:spTree>
    <p:extLst>
      <p:ext uri="{BB962C8B-B14F-4D97-AF65-F5344CB8AC3E}">
        <p14:creationId xmlns:p14="http://schemas.microsoft.com/office/powerpoint/2010/main" val="1294572953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kst og bilde vens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icture Placeholder 5">
            <a:extLst>
              <a:ext uri="{FF2B5EF4-FFF2-40B4-BE49-F238E27FC236}">
                <a16:creationId xmlns:a16="http://schemas.microsoft.com/office/drawing/2014/main" id="{EF1BAB11-A5D7-4E87-B446-A09650D76D8B}"/>
              </a:ext>
            </a:extLst>
          </p:cNvPr>
          <p:cNvSpPr>
            <a:spLocks noGrp="1"/>
          </p:cNvSpPr>
          <p:nvPr>
            <p:ph type="pic" sz="quarter" idx="14"/>
          </p:nvPr>
        </p:nvSpPr>
        <p:spPr>
          <a:xfrm>
            <a:off x="996286" y="877362"/>
            <a:ext cx="5099714" cy="5103276"/>
          </a:xfrm>
          <a:solidFill>
            <a:schemeClr val="bg1">
              <a:lumMod val="85000"/>
            </a:schemeClr>
          </a:solidFill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b-NO"/>
              <a:t>Klikk på ikonet for å legge til et bilde</a:t>
            </a:r>
            <a:endParaRPr lang="en-US" dirty="0"/>
          </a:p>
        </p:txBody>
      </p:sp>
      <p:sp>
        <p:nvSpPr>
          <p:cNvPr id="2" name="Content Placeholder 1">
            <a:extLst>
              <a:ext uri="{FF2B5EF4-FFF2-40B4-BE49-F238E27FC236}">
                <a16:creationId xmlns:a16="http://schemas.microsoft.com/office/drawing/2014/main" id="{1CB87FF5-7260-4863-8D50-47EFEFD05D7D}"/>
              </a:ext>
            </a:extLst>
          </p:cNvPr>
          <p:cNvSpPr>
            <a:spLocks noGrp="1"/>
          </p:cNvSpPr>
          <p:nvPr>
            <p:ph sz="quarter" idx="15"/>
          </p:nvPr>
        </p:nvSpPr>
        <p:spPr>
          <a:xfrm>
            <a:off x="6802437" y="1648978"/>
            <a:ext cx="4393279" cy="4310061"/>
          </a:xfrm>
          <a:prstGeom prst="rect">
            <a:avLst/>
          </a:prstGeom>
        </p:spPr>
        <p:txBody>
          <a:bodyPr lIns="0" tIns="0" rIns="0" bIns="0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US" dirty="0"/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E7FA11CB-7D08-468C-B2F7-6FF89B9F03DE}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/>
        <p:txBody>
          <a:bodyPr/>
          <a:lstStyle/>
          <a:p>
            <a:fld id="{1E4BC5DA-09B7-4CD9-B21E-157BBBE69313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3" name="Tittel 2">
            <a:extLst>
              <a:ext uri="{FF2B5EF4-FFF2-40B4-BE49-F238E27FC236}">
                <a16:creationId xmlns:a16="http://schemas.microsoft.com/office/drawing/2014/main" id="{B0A132E7-DB30-4440-8BF9-7F5D40DEA0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02436" y="856800"/>
            <a:ext cx="4782363" cy="705600"/>
          </a:xfrm>
        </p:spPr>
        <p:txBody>
          <a:bodyPr/>
          <a:lstStyle/>
          <a:p>
            <a:r>
              <a:rPr lang="nb-NO"/>
              <a:t>Klikk for å redigere tittelstil</a:t>
            </a:r>
            <a:endParaRPr lang="nb-NO" dirty="0"/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FE7D96E1-02BA-FC44-A6F6-1946E2507B20}"/>
              </a:ext>
            </a:extLst>
          </p:cNvPr>
          <p:cNvSpPr>
            <a:spLocks noGrp="1"/>
          </p:cNvSpPr>
          <p:nvPr>
            <p:ph type="dt" sz="half" idx="19"/>
          </p:nvPr>
        </p:nvSpPr>
        <p:spPr/>
        <p:txBody>
          <a:bodyPr/>
          <a:lstStyle/>
          <a:p>
            <a:fld id="{9D03F6E6-5CDA-F241-BB38-1AEA2D1479E3}" type="datetime1">
              <a:rPr lang="nb-NO" smtClean="0"/>
              <a:t>25.01.2024</a:t>
            </a:fld>
            <a:endParaRPr lang="nb-NO"/>
          </a:p>
        </p:txBody>
      </p:sp>
      <p:sp>
        <p:nvSpPr>
          <p:cNvPr id="7" name="Plassholder for bunntekst 6">
            <a:extLst>
              <a:ext uri="{FF2B5EF4-FFF2-40B4-BE49-F238E27FC236}">
                <a16:creationId xmlns:a16="http://schemas.microsoft.com/office/drawing/2014/main" id="{BFB0678E-62D6-A248-82AC-4D24773911B6}"/>
              </a:ext>
            </a:extLst>
          </p:cNvPr>
          <p:cNvSpPr>
            <a:spLocks noGrp="1"/>
          </p:cNvSpPr>
          <p:nvPr>
            <p:ph type="ftr" sz="quarter" idx="20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588677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RBU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>
            <a:extLst>
              <a:ext uri="{FF2B5EF4-FFF2-40B4-BE49-F238E27FC236}">
                <a16:creationId xmlns:a16="http://schemas.microsoft.com/office/drawing/2014/main" id="{9B575F1D-41C4-B247-B308-D404AEE38C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79DD6-9036-5E4E-A769-804A89AA79F3}" type="datetimeFigureOut">
              <a:rPr lang="nb-NO" smtClean="0"/>
              <a:t>25.01.2024</a:t>
            </a:fld>
            <a:endParaRPr lang="nb-NO"/>
          </a:p>
        </p:txBody>
      </p:sp>
      <p:sp>
        <p:nvSpPr>
          <p:cNvPr id="3" name="Plassholder for bunntekst 2">
            <a:extLst>
              <a:ext uri="{FF2B5EF4-FFF2-40B4-BE49-F238E27FC236}">
                <a16:creationId xmlns:a16="http://schemas.microsoft.com/office/drawing/2014/main" id="{A7124F85-C205-8540-BFDF-933469DA8A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F1CBB488-7E8F-9D4D-8031-2DF0600214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7274F-C966-8C46-AFC4-F3A14ECF3B01}" type="slidenum">
              <a:rPr lang="nb-NO" smtClean="0"/>
              <a:t>‹#›</a:t>
            </a:fld>
            <a:endParaRPr lang="nb-NO"/>
          </a:p>
        </p:txBody>
      </p:sp>
      <p:pic>
        <p:nvPicPr>
          <p:cNvPr id="6" name="Plassholder for bilde 5" descr="Et bilde som inneholder person, utendørs, bakke  Automatisk generert beskrivelse">
            <a:extLst>
              <a:ext uri="{FF2B5EF4-FFF2-40B4-BE49-F238E27FC236}">
                <a16:creationId xmlns:a16="http://schemas.microsoft.com/office/drawing/2014/main" id="{B1875EE4-4BF0-024A-B73E-ECA74A138F45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865" b="15280"/>
          <a:stretch/>
        </p:blipFill>
        <p:spPr>
          <a:xfrm>
            <a:off x="2244098" y="855763"/>
            <a:ext cx="9947902" cy="5103276"/>
          </a:xfrm>
          <a:prstGeom prst="rect">
            <a:avLst/>
          </a:prstGeom>
          <a:noFill/>
        </p:spPr>
      </p:pic>
      <p:sp>
        <p:nvSpPr>
          <p:cNvPr id="7" name="Utsettelse 6">
            <a:extLst>
              <a:ext uri="{FF2B5EF4-FFF2-40B4-BE49-F238E27FC236}">
                <a16:creationId xmlns:a16="http://schemas.microsoft.com/office/drawing/2014/main" id="{1DD4609C-A19A-CB43-8256-D2E4271FB972}"/>
              </a:ext>
            </a:extLst>
          </p:cNvPr>
          <p:cNvSpPr>
            <a:spLocks noChangeAspect="1"/>
          </p:cNvSpPr>
          <p:nvPr userDrawn="1"/>
        </p:nvSpPr>
        <p:spPr>
          <a:xfrm>
            <a:off x="0" y="855763"/>
            <a:ext cx="5255348" cy="5101200"/>
          </a:xfrm>
          <a:prstGeom prst="flowChartDelay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 sz="2400" dirty="0"/>
          </a:p>
        </p:txBody>
      </p:sp>
      <p:sp>
        <p:nvSpPr>
          <p:cNvPr id="8" name="TekstSylinder 7">
            <a:extLst>
              <a:ext uri="{FF2B5EF4-FFF2-40B4-BE49-F238E27FC236}">
                <a16:creationId xmlns:a16="http://schemas.microsoft.com/office/drawing/2014/main" id="{BA484E68-4E82-C742-BBA7-519FF824100D}"/>
              </a:ext>
            </a:extLst>
          </p:cNvPr>
          <p:cNvSpPr txBox="1"/>
          <p:nvPr userDrawn="1"/>
        </p:nvSpPr>
        <p:spPr>
          <a:xfrm>
            <a:off x="1051200" y="1898259"/>
            <a:ext cx="3420440" cy="3016210"/>
          </a:xfrm>
          <a:prstGeom prst="rect">
            <a:avLst/>
          </a:prstGeom>
          <a:noFill/>
          <a:ln>
            <a:noFill/>
          </a:ln>
        </p:spPr>
        <p:txBody>
          <a:bodyPr wrap="square" lIns="0" tIns="0" rIns="0" bIns="0" rtlCol="0" anchor="ctr" anchorCtr="0">
            <a:spAutoFit/>
          </a:bodyPr>
          <a:lstStyle/>
          <a:p>
            <a:r>
              <a:rPr lang="nb-NO" sz="2800" dirty="0">
                <a:solidFill>
                  <a:schemeClr val="bg1"/>
                </a:solidFill>
              </a:rPr>
              <a:t>Vi skal bidra til å styrke kompetansen og kvaliteten i de tjenestene som arbeider med barn, unge og deres familier</a:t>
            </a:r>
          </a:p>
        </p:txBody>
      </p:sp>
    </p:spTree>
    <p:extLst>
      <p:ext uri="{BB962C8B-B14F-4D97-AF65-F5344CB8AC3E}">
        <p14:creationId xmlns:p14="http://schemas.microsoft.com/office/powerpoint/2010/main" val="190717154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8" grpId="0"/>
    </p:bldLst>
  </p:timing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tort bilde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icture Placeholder 5">
            <a:extLst>
              <a:ext uri="{FF2B5EF4-FFF2-40B4-BE49-F238E27FC236}">
                <a16:creationId xmlns:a16="http://schemas.microsoft.com/office/drawing/2014/main" id="{EF1BAB11-A5D7-4E87-B446-A09650D76D8B}"/>
              </a:ext>
            </a:extLst>
          </p:cNvPr>
          <p:cNvSpPr>
            <a:spLocks noGrp="1"/>
          </p:cNvSpPr>
          <p:nvPr>
            <p:ph type="pic" sz="quarter" idx="14"/>
          </p:nvPr>
        </p:nvSpPr>
        <p:spPr>
          <a:xfrm>
            <a:off x="996286" y="877362"/>
            <a:ext cx="10199429" cy="5103276"/>
          </a:xfrm>
          <a:solidFill>
            <a:schemeClr val="bg1">
              <a:lumMod val="85000"/>
            </a:schemeClr>
          </a:solidFill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b-NO"/>
              <a:t>Klikk på ikonet for å legge til et bilde</a:t>
            </a:r>
            <a:endParaRPr lang="en-US" dirty="0"/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4C6141BB-3AF3-47A1-A6E6-4B631BD0D5FD}"/>
              </a:ext>
            </a:extLst>
          </p:cNvPr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1E4BC5DA-09B7-4CD9-B21E-157BBBE69313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2" name="Plassholder for dato 1">
            <a:extLst>
              <a:ext uri="{FF2B5EF4-FFF2-40B4-BE49-F238E27FC236}">
                <a16:creationId xmlns:a16="http://schemas.microsoft.com/office/drawing/2014/main" id="{B7339E21-B963-184D-9DC9-751E620F0B0A}"/>
              </a:ext>
            </a:extLst>
          </p:cNvPr>
          <p:cNvSpPr>
            <a:spLocks noGrp="1"/>
          </p:cNvSpPr>
          <p:nvPr>
            <p:ph type="dt" sz="half" idx="18"/>
          </p:nvPr>
        </p:nvSpPr>
        <p:spPr/>
        <p:txBody>
          <a:bodyPr/>
          <a:lstStyle/>
          <a:p>
            <a:fld id="{9D03F6E6-5CDA-F241-BB38-1AEA2D1479E3}" type="datetime1">
              <a:rPr lang="nb-NO" smtClean="0"/>
              <a:t>25.01.2024</a:t>
            </a:fld>
            <a:endParaRPr lang="nb-NO"/>
          </a:p>
        </p:txBody>
      </p:sp>
      <p:sp>
        <p:nvSpPr>
          <p:cNvPr id="3" name="Plassholder for bunntekst 2">
            <a:extLst>
              <a:ext uri="{FF2B5EF4-FFF2-40B4-BE49-F238E27FC236}">
                <a16:creationId xmlns:a16="http://schemas.microsoft.com/office/drawing/2014/main" id="{9EC7AC3A-8A6F-8F43-9445-4991AC11EB45}"/>
              </a:ext>
            </a:extLst>
          </p:cNvPr>
          <p:cNvSpPr>
            <a:spLocks noGrp="1"/>
          </p:cNvSpPr>
          <p:nvPr>
            <p:ph type="ftr" sz="quarter" idx="19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94162969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F040C22A-9F7B-8549-B1F5-0E999E1C71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dato 2">
            <a:extLst>
              <a:ext uri="{FF2B5EF4-FFF2-40B4-BE49-F238E27FC236}">
                <a16:creationId xmlns:a16="http://schemas.microsoft.com/office/drawing/2014/main" id="{DE608CB4-7FB8-4F4A-8B58-A10D4C7093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79DD6-9036-5E4E-A769-804A89AA79F3}" type="datetimeFigureOut">
              <a:rPr lang="nb-NO" smtClean="0"/>
              <a:t>25.01.2024</a:t>
            </a:fld>
            <a:endParaRPr lang="nb-NO"/>
          </a:p>
        </p:txBody>
      </p:sp>
      <p:sp>
        <p:nvSpPr>
          <p:cNvPr id="4" name="Plassholder for bunntekst 3">
            <a:extLst>
              <a:ext uri="{FF2B5EF4-FFF2-40B4-BE49-F238E27FC236}">
                <a16:creationId xmlns:a16="http://schemas.microsoft.com/office/drawing/2014/main" id="{6A1CF599-976F-D34F-B0CC-3B079ECD9B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Plassholder for lysbildenummer 4">
            <a:extLst>
              <a:ext uri="{FF2B5EF4-FFF2-40B4-BE49-F238E27FC236}">
                <a16:creationId xmlns:a16="http://schemas.microsoft.com/office/drawing/2014/main" id="{CAD27731-15F3-A146-B14B-44BF964ED7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7274F-C966-8C46-AFC4-F3A14ECF3B01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20340555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>
            <a:extLst>
              <a:ext uri="{FF2B5EF4-FFF2-40B4-BE49-F238E27FC236}">
                <a16:creationId xmlns:a16="http://schemas.microsoft.com/office/drawing/2014/main" id="{9B575F1D-41C4-B247-B308-D404AEE38C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79DD6-9036-5E4E-A769-804A89AA79F3}" type="datetimeFigureOut">
              <a:rPr lang="nb-NO" smtClean="0"/>
              <a:t>25.01.2024</a:t>
            </a:fld>
            <a:endParaRPr lang="nb-NO"/>
          </a:p>
        </p:txBody>
      </p:sp>
      <p:sp>
        <p:nvSpPr>
          <p:cNvPr id="3" name="Plassholder for bunntekst 2">
            <a:extLst>
              <a:ext uri="{FF2B5EF4-FFF2-40B4-BE49-F238E27FC236}">
                <a16:creationId xmlns:a16="http://schemas.microsoft.com/office/drawing/2014/main" id="{A7124F85-C205-8540-BFDF-933469DA8A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F1CBB488-7E8F-9D4D-8031-2DF0600214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7274F-C966-8C46-AFC4-F3A14ECF3B01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17370770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Tomt neg">
    <p:bg>
      <p:bgPr>
        <a:solidFill>
          <a:schemeClr val="accent5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>
            <a:extLst>
              <a:ext uri="{FF2B5EF4-FFF2-40B4-BE49-F238E27FC236}">
                <a16:creationId xmlns:a16="http://schemas.microsoft.com/office/drawing/2014/main" id="{9B575F1D-41C4-B247-B308-D404AEE38C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79DD6-9036-5E4E-A769-804A89AA79F3}" type="datetimeFigureOut">
              <a:rPr lang="nb-NO" smtClean="0"/>
              <a:t>25.01.2024</a:t>
            </a:fld>
            <a:endParaRPr lang="nb-NO"/>
          </a:p>
        </p:txBody>
      </p:sp>
      <p:sp>
        <p:nvSpPr>
          <p:cNvPr id="3" name="Plassholder for bunntekst 2">
            <a:extLst>
              <a:ext uri="{FF2B5EF4-FFF2-40B4-BE49-F238E27FC236}">
                <a16:creationId xmlns:a16="http://schemas.microsoft.com/office/drawing/2014/main" id="{A7124F85-C205-8540-BFDF-933469DA8A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F1CBB488-7E8F-9D4D-8031-2DF0600214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7274F-C966-8C46-AFC4-F3A14ECF3B01}" type="slidenum">
              <a:rPr lang="nb-NO" smtClean="0"/>
              <a:t>‹#›</a:t>
            </a:fld>
            <a:endParaRPr lang="nb-NO"/>
          </a:p>
        </p:txBody>
      </p:sp>
      <p:grpSp>
        <p:nvGrpSpPr>
          <p:cNvPr id="16" name="Gruppe 15">
            <a:extLst>
              <a:ext uri="{FF2B5EF4-FFF2-40B4-BE49-F238E27FC236}">
                <a16:creationId xmlns:a16="http://schemas.microsoft.com/office/drawing/2014/main" id="{69D2337A-D247-A444-B238-E608FA3C5C26}"/>
              </a:ext>
            </a:extLst>
          </p:cNvPr>
          <p:cNvGrpSpPr/>
          <p:nvPr userDrawn="1"/>
        </p:nvGrpSpPr>
        <p:grpSpPr>
          <a:xfrm>
            <a:off x="396023" y="393704"/>
            <a:ext cx="833492" cy="177295"/>
            <a:chOff x="396023" y="393704"/>
            <a:chExt cx="833492" cy="177295"/>
          </a:xfrm>
        </p:grpSpPr>
        <p:sp>
          <p:nvSpPr>
            <p:cNvPr id="7" name="Friform 6">
              <a:extLst>
                <a:ext uri="{FF2B5EF4-FFF2-40B4-BE49-F238E27FC236}">
                  <a16:creationId xmlns:a16="http://schemas.microsoft.com/office/drawing/2014/main" id="{E4417223-476C-4C4D-8450-353BD99C4EEB}"/>
                </a:ext>
              </a:extLst>
            </p:cNvPr>
            <p:cNvSpPr/>
            <p:nvPr/>
          </p:nvSpPr>
          <p:spPr>
            <a:xfrm>
              <a:off x="936121" y="394334"/>
              <a:ext cx="135024" cy="176665"/>
            </a:xfrm>
            <a:custGeom>
              <a:avLst/>
              <a:gdLst>
                <a:gd name="connsiteX0" fmla="*/ 108524 w 135024"/>
                <a:gd name="connsiteY0" fmla="*/ 0 h 176665"/>
                <a:gd name="connsiteX1" fmla="*/ 108524 w 135024"/>
                <a:gd name="connsiteY1" fmla="*/ 109154 h 176665"/>
                <a:gd name="connsiteX2" fmla="*/ 96536 w 135024"/>
                <a:gd name="connsiteY2" fmla="*/ 138808 h 176665"/>
                <a:gd name="connsiteX3" fmla="*/ 66881 w 135024"/>
                <a:gd name="connsiteY3" fmla="*/ 150796 h 176665"/>
                <a:gd name="connsiteX4" fmla="*/ 37226 w 135024"/>
                <a:gd name="connsiteY4" fmla="*/ 138808 h 176665"/>
                <a:gd name="connsiteX5" fmla="*/ 25238 w 135024"/>
                <a:gd name="connsiteY5" fmla="*/ 109154 h 176665"/>
                <a:gd name="connsiteX6" fmla="*/ 25238 w 135024"/>
                <a:gd name="connsiteY6" fmla="*/ 0 h 176665"/>
                <a:gd name="connsiteX7" fmla="*/ 0 w 135024"/>
                <a:gd name="connsiteY7" fmla="*/ 0 h 176665"/>
                <a:gd name="connsiteX8" fmla="*/ 0 w 135024"/>
                <a:gd name="connsiteY8" fmla="*/ 109154 h 176665"/>
                <a:gd name="connsiteX9" fmla="*/ 5048 w 135024"/>
                <a:gd name="connsiteY9" fmla="*/ 135023 h 176665"/>
                <a:gd name="connsiteX10" fmla="*/ 19560 w 135024"/>
                <a:gd name="connsiteY10" fmla="*/ 157106 h 176665"/>
                <a:gd name="connsiteX11" fmla="*/ 41643 w 135024"/>
                <a:gd name="connsiteY11" fmla="*/ 171617 h 176665"/>
                <a:gd name="connsiteX12" fmla="*/ 67512 w 135024"/>
                <a:gd name="connsiteY12" fmla="*/ 176665 h 176665"/>
                <a:gd name="connsiteX13" fmla="*/ 93382 w 135024"/>
                <a:gd name="connsiteY13" fmla="*/ 171617 h 176665"/>
                <a:gd name="connsiteX14" fmla="*/ 115465 w 135024"/>
                <a:gd name="connsiteY14" fmla="*/ 157106 h 176665"/>
                <a:gd name="connsiteX15" fmla="*/ 129977 w 135024"/>
                <a:gd name="connsiteY15" fmla="*/ 135023 h 176665"/>
                <a:gd name="connsiteX16" fmla="*/ 135025 w 135024"/>
                <a:gd name="connsiteY16" fmla="*/ 109154 h 176665"/>
                <a:gd name="connsiteX17" fmla="*/ 135025 w 135024"/>
                <a:gd name="connsiteY17" fmla="*/ 0 h 176665"/>
                <a:gd name="connsiteX18" fmla="*/ 108524 w 135024"/>
                <a:gd name="connsiteY18" fmla="*/ 0 h 1766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</a:cxnLst>
              <a:rect l="l" t="t" r="r" b="b"/>
              <a:pathLst>
                <a:path w="135024" h="176665">
                  <a:moveTo>
                    <a:pt x="108524" y="0"/>
                  </a:moveTo>
                  <a:lnTo>
                    <a:pt x="108524" y="109154"/>
                  </a:lnTo>
                  <a:cubicBezTo>
                    <a:pt x="108524" y="120511"/>
                    <a:pt x="104108" y="131237"/>
                    <a:pt x="96536" y="138808"/>
                  </a:cubicBezTo>
                  <a:cubicBezTo>
                    <a:pt x="88965" y="146380"/>
                    <a:pt x="78239" y="150796"/>
                    <a:pt x="66881" y="150796"/>
                  </a:cubicBezTo>
                  <a:cubicBezTo>
                    <a:pt x="55524" y="150796"/>
                    <a:pt x="44798" y="146380"/>
                    <a:pt x="37226" y="138808"/>
                  </a:cubicBezTo>
                  <a:cubicBezTo>
                    <a:pt x="29655" y="131237"/>
                    <a:pt x="25238" y="120511"/>
                    <a:pt x="25238" y="109154"/>
                  </a:cubicBezTo>
                  <a:lnTo>
                    <a:pt x="25238" y="0"/>
                  </a:lnTo>
                  <a:lnTo>
                    <a:pt x="0" y="0"/>
                  </a:lnTo>
                  <a:lnTo>
                    <a:pt x="0" y="109154"/>
                  </a:lnTo>
                  <a:cubicBezTo>
                    <a:pt x="0" y="117987"/>
                    <a:pt x="1893" y="126820"/>
                    <a:pt x="5048" y="135023"/>
                  </a:cubicBezTo>
                  <a:cubicBezTo>
                    <a:pt x="8202" y="143225"/>
                    <a:pt x="13250" y="150796"/>
                    <a:pt x="19560" y="157106"/>
                  </a:cubicBezTo>
                  <a:cubicBezTo>
                    <a:pt x="25869" y="163415"/>
                    <a:pt x="33441" y="168463"/>
                    <a:pt x="41643" y="171617"/>
                  </a:cubicBezTo>
                  <a:cubicBezTo>
                    <a:pt x="49846" y="174772"/>
                    <a:pt x="58679" y="176665"/>
                    <a:pt x="67512" y="176665"/>
                  </a:cubicBezTo>
                  <a:cubicBezTo>
                    <a:pt x="76346" y="176665"/>
                    <a:pt x="85179" y="174772"/>
                    <a:pt x="93382" y="171617"/>
                  </a:cubicBezTo>
                  <a:cubicBezTo>
                    <a:pt x="101584" y="168463"/>
                    <a:pt x="109155" y="163415"/>
                    <a:pt x="115465" y="157106"/>
                  </a:cubicBezTo>
                  <a:cubicBezTo>
                    <a:pt x="121775" y="150796"/>
                    <a:pt x="126822" y="143225"/>
                    <a:pt x="129977" y="135023"/>
                  </a:cubicBezTo>
                  <a:cubicBezTo>
                    <a:pt x="133132" y="126820"/>
                    <a:pt x="135025" y="117987"/>
                    <a:pt x="135025" y="109154"/>
                  </a:cubicBezTo>
                  <a:lnTo>
                    <a:pt x="135025" y="0"/>
                  </a:lnTo>
                  <a:lnTo>
                    <a:pt x="108524" y="0"/>
                  </a:lnTo>
                  <a:close/>
                </a:path>
              </a:pathLst>
            </a:custGeom>
            <a:solidFill>
              <a:schemeClr val="bg1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8" name="Friform 7">
              <a:extLst>
                <a:ext uri="{FF2B5EF4-FFF2-40B4-BE49-F238E27FC236}">
                  <a16:creationId xmlns:a16="http://schemas.microsoft.com/office/drawing/2014/main" id="{A4700748-0F56-1646-82B6-10AD483E361B}"/>
                </a:ext>
              </a:extLst>
            </p:cNvPr>
            <p:cNvSpPr/>
            <p:nvPr/>
          </p:nvSpPr>
          <p:spPr>
            <a:xfrm>
              <a:off x="630107" y="393704"/>
              <a:ext cx="119881" cy="175403"/>
            </a:xfrm>
            <a:custGeom>
              <a:avLst/>
              <a:gdLst>
                <a:gd name="connsiteX0" fmla="*/ 66881 w 119881"/>
                <a:gd name="connsiteY0" fmla="*/ 76345 h 175403"/>
                <a:gd name="connsiteX1" fmla="*/ 24607 w 119881"/>
                <a:gd name="connsiteY1" fmla="*/ 76345 h 175403"/>
                <a:gd name="connsiteX2" fmla="*/ 24607 w 119881"/>
                <a:gd name="connsiteY2" fmla="*/ 22714 h 175403"/>
                <a:gd name="connsiteX3" fmla="*/ 66881 w 119881"/>
                <a:gd name="connsiteY3" fmla="*/ 22714 h 175403"/>
                <a:gd name="connsiteX4" fmla="*/ 85179 w 119881"/>
                <a:gd name="connsiteY4" fmla="*/ 30285 h 175403"/>
                <a:gd name="connsiteX5" fmla="*/ 92751 w 119881"/>
                <a:gd name="connsiteY5" fmla="*/ 48583 h 175403"/>
                <a:gd name="connsiteX6" fmla="*/ 92751 w 119881"/>
                <a:gd name="connsiteY6" fmla="*/ 50476 h 175403"/>
                <a:gd name="connsiteX7" fmla="*/ 85179 w 119881"/>
                <a:gd name="connsiteY7" fmla="*/ 68773 h 175403"/>
                <a:gd name="connsiteX8" fmla="*/ 66881 w 119881"/>
                <a:gd name="connsiteY8" fmla="*/ 76345 h 175403"/>
                <a:gd name="connsiteX9" fmla="*/ 119882 w 119881"/>
                <a:gd name="connsiteY9" fmla="*/ 49845 h 175403"/>
                <a:gd name="connsiteX10" fmla="*/ 119882 w 119881"/>
                <a:gd name="connsiteY10" fmla="*/ 49845 h 175403"/>
                <a:gd name="connsiteX11" fmla="*/ 105370 w 119881"/>
                <a:gd name="connsiteY11" fmla="*/ 14512 h 175403"/>
                <a:gd name="connsiteX12" fmla="*/ 70667 w 119881"/>
                <a:gd name="connsiteY12" fmla="*/ 0 h 175403"/>
                <a:gd name="connsiteX13" fmla="*/ 0 w 119881"/>
                <a:gd name="connsiteY13" fmla="*/ 0 h 175403"/>
                <a:gd name="connsiteX14" fmla="*/ 0 w 119881"/>
                <a:gd name="connsiteY14" fmla="*/ 174772 h 175403"/>
                <a:gd name="connsiteX15" fmla="*/ 25238 w 119881"/>
                <a:gd name="connsiteY15" fmla="*/ 174772 h 175403"/>
                <a:gd name="connsiteX16" fmla="*/ 25238 w 119881"/>
                <a:gd name="connsiteY16" fmla="*/ 98428 h 175403"/>
                <a:gd name="connsiteX17" fmla="*/ 37226 w 119881"/>
                <a:gd name="connsiteY17" fmla="*/ 98428 h 175403"/>
                <a:gd name="connsiteX18" fmla="*/ 86441 w 119881"/>
                <a:gd name="connsiteY18" fmla="*/ 175403 h 175403"/>
                <a:gd name="connsiteX19" fmla="*/ 117989 w 119881"/>
                <a:gd name="connsiteY19" fmla="*/ 175403 h 175403"/>
                <a:gd name="connsiteX20" fmla="*/ 67512 w 119881"/>
                <a:gd name="connsiteY20" fmla="*/ 98428 h 175403"/>
                <a:gd name="connsiteX21" fmla="*/ 71298 w 119881"/>
                <a:gd name="connsiteY21" fmla="*/ 98428 h 175403"/>
                <a:gd name="connsiteX22" fmla="*/ 90227 w 119881"/>
                <a:gd name="connsiteY22" fmla="*/ 94642 h 175403"/>
                <a:gd name="connsiteX23" fmla="*/ 106001 w 119881"/>
                <a:gd name="connsiteY23" fmla="*/ 83916 h 175403"/>
                <a:gd name="connsiteX24" fmla="*/ 116727 w 119881"/>
                <a:gd name="connsiteY24" fmla="*/ 68142 h 175403"/>
                <a:gd name="connsiteX25" fmla="*/ 119882 w 119881"/>
                <a:gd name="connsiteY25" fmla="*/ 49845 h 1754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</a:cxnLst>
              <a:rect l="l" t="t" r="r" b="b"/>
              <a:pathLst>
                <a:path w="119881" h="175403">
                  <a:moveTo>
                    <a:pt x="66881" y="76345"/>
                  </a:moveTo>
                  <a:lnTo>
                    <a:pt x="24607" y="76345"/>
                  </a:lnTo>
                  <a:lnTo>
                    <a:pt x="24607" y="22714"/>
                  </a:lnTo>
                  <a:lnTo>
                    <a:pt x="66881" y="22714"/>
                  </a:lnTo>
                  <a:cubicBezTo>
                    <a:pt x="73822" y="22714"/>
                    <a:pt x="80762" y="25238"/>
                    <a:pt x="85179" y="30285"/>
                  </a:cubicBezTo>
                  <a:cubicBezTo>
                    <a:pt x="90227" y="35333"/>
                    <a:pt x="92751" y="41642"/>
                    <a:pt x="92751" y="48583"/>
                  </a:cubicBezTo>
                  <a:lnTo>
                    <a:pt x="92751" y="50476"/>
                  </a:lnTo>
                  <a:cubicBezTo>
                    <a:pt x="92751" y="57416"/>
                    <a:pt x="90227" y="64357"/>
                    <a:pt x="85179" y="68773"/>
                  </a:cubicBezTo>
                  <a:cubicBezTo>
                    <a:pt x="80131" y="73190"/>
                    <a:pt x="73822" y="76345"/>
                    <a:pt x="66881" y="76345"/>
                  </a:cubicBezTo>
                  <a:close/>
                  <a:moveTo>
                    <a:pt x="119882" y="49845"/>
                  </a:moveTo>
                  <a:lnTo>
                    <a:pt x="119882" y="49845"/>
                  </a:lnTo>
                  <a:cubicBezTo>
                    <a:pt x="119882" y="36595"/>
                    <a:pt x="114834" y="23976"/>
                    <a:pt x="105370" y="14512"/>
                  </a:cubicBezTo>
                  <a:cubicBezTo>
                    <a:pt x="95905" y="5048"/>
                    <a:pt x="83917" y="0"/>
                    <a:pt x="70667" y="0"/>
                  </a:cubicBezTo>
                  <a:lnTo>
                    <a:pt x="0" y="0"/>
                  </a:lnTo>
                  <a:lnTo>
                    <a:pt x="0" y="174772"/>
                  </a:lnTo>
                  <a:lnTo>
                    <a:pt x="25238" y="174772"/>
                  </a:lnTo>
                  <a:lnTo>
                    <a:pt x="25238" y="98428"/>
                  </a:lnTo>
                  <a:lnTo>
                    <a:pt x="37226" y="98428"/>
                  </a:lnTo>
                  <a:lnTo>
                    <a:pt x="86441" y="175403"/>
                  </a:lnTo>
                  <a:lnTo>
                    <a:pt x="117989" y="175403"/>
                  </a:lnTo>
                  <a:lnTo>
                    <a:pt x="67512" y="98428"/>
                  </a:lnTo>
                  <a:lnTo>
                    <a:pt x="71298" y="98428"/>
                  </a:lnTo>
                  <a:cubicBezTo>
                    <a:pt x="77608" y="98428"/>
                    <a:pt x="83917" y="97166"/>
                    <a:pt x="90227" y="94642"/>
                  </a:cubicBezTo>
                  <a:cubicBezTo>
                    <a:pt x="95905" y="92118"/>
                    <a:pt x="101584" y="88333"/>
                    <a:pt x="106001" y="83916"/>
                  </a:cubicBezTo>
                  <a:cubicBezTo>
                    <a:pt x="110417" y="79499"/>
                    <a:pt x="114203" y="73821"/>
                    <a:pt x="116727" y="68142"/>
                  </a:cubicBezTo>
                  <a:cubicBezTo>
                    <a:pt x="118620" y="62464"/>
                    <a:pt x="119882" y="56154"/>
                    <a:pt x="119882" y="49845"/>
                  </a:cubicBezTo>
                  <a:close/>
                </a:path>
              </a:pathLst>
            </a:custGeom>
            <a:solidFill>
              <a:schemeClr val="bg1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9" name="Friform 8">
              <a:extLst>
                <a:ext uri="{FF2B5EF4-FFF2-40B4-BE49-F238E27FC236}">
                  <a16:creationId xmlns:a16="http://schemas.microsoft.com/office/drawing/2014/main" id="{2155C271-B3EC-E440-9284-9A0B58693943}"/>
                </a:ext>
              </a:extLst>
            </p:cNvPr>
            <p:cNvSpPr/>
            <p:nvPr/>
          </p:nvSpPr>
          <p:spPr>
            <a:xfrm>
              <a:off x="1109003" y="394334"/>
              <a:ext cx="120512" cy="174772"/>
            </a:xfrm>
            <a:custGeom>
              <a:avLst/>
              <a:gdLst>
                <a:gd name="connsiteX0" fmla="*/ 92751 w 120512"/>
                <a:gd name="connsiteY0" fmla="*/ 49845 h 174772"/>
                <a:gd name="connsiteX1" fmla="*/ 85179 w 120512"/>
                <a:gd name="connsiteY1" fmla="*/ 68142 h 174772"/>
                <a:gd name="connsiteX2" fmla="*/ 66881 w 120512"/>
                <a:gd name="connsiteY2" fmla="*/ 75714 h 174772"/>
                <a:gd name="connsiteX3" fmla="*/ 24607 w 120512"/>
                <a:gd name="connsiteY3" fmla="*/ 75714 h 174772"/>
                <a:gd name="connsiteX4" fmla="*/ 24607 w 120512"/>
                <a:gd name="connsiteY4" fmla="*/ 22083 h 174772"/>
                <a:gd name="connsiteX5" fmla="*/ 66881 w 120512"/>
                <a:gd name="connsiteY5" fmla="*/ 22083 h 174772"/>
                <a:gd name="connsiteX6" fmla="*/ 85179 w 120512"/>
                <a:gd name="connsiteY6" fmla="*/ 29654 h 174772"/>
                <a:gd name="connsiteX7" fmla="*/ 92751 w 120512"/>
                <a:gd name="connsiteY7" fmla="*/ 47952 h 174772"/>
                <a:gd name="connsiteX8" fmla="*/ 92751 w 120512"/>
                <a:gd name="connsiteY8" fmla="*/ 49845 h 174772"/>
                <a:gd name="connsiteX9" fmla="*/ 71298 w 120512"/>
                <a:gd name="connsiteY9" fmla="*/ 0 h 174772"/>
                <a:gd name="connsiteX10" fmla="*/ 0 w 120512"/>
                <a:gd name="connsiteY10" fmla="*/ 0 h 174772"/>
                <a:gd name="connsiteX11" fmla="*/ 0 w 120512"/>
                <a:gd name="connsiteY11" fmla="*/ 174772 h 174772"/>
                <a:gd name="connsiteX12" fmla="*/ 25238 w 120512"/>
                <a:gd name="connsiteY12" fmla="*/ 174772 h 174772"/>
                <a:gd name="connsiteX13" fmla="*/ 25238 w 120512"/>
                <a:gd name="connsiteY13" fmla="*/ 97797 h 174772"/>
                <a:gd name="connsiteX14" fmla="*/ 71298 w 120512"/>
                <a:gd name="connsiteY14" fmla="*/ 97797 h 174772"/>
                <a:gd name="connsiteX15" fmla="*/ 90227 w 120512"/>
                <a:gd name="connsiteY15" fmla="*/ 94011 h 174772"/>
                <a:gd name="connsiteX16" fmla="*/ 106001 w 120512"/>
                <a:gd name="connsiteY16" fmla="*/ 83285 h 174772"/>
                <a:gd name="connsiteX17" fmla="*/ 116727 w 120512"/>
                <a:gd name="connsiteY17" fmla="*/ 67511 h 174772"/>
                <a:gd name="connsiteX18" fmla="*/ 120513 w 120512"/>
                <a:gd name="connsiteY18" fmla="*/ 48583 h 174772"/>
                <a:gd name="connsiteX19" fmla="*/ 120513 w 120512"/>
                <a:gd name="connsiteY19" fmla="*/ 48583 h 174772"/>
                <a:gd name="connsiteX20" fmla="*/ 106001 w 120512"/>
                <a:gd name="connsiteY20" fmla="*/ 13881 h 174772"/>
                <a:gd name="connsiteX21" fmla="*/ 71298 w 120512"/>
                <a:gd name="connsiteY21" fmla="*/ 0 h 1747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</a:cxnLst>
              <a:rect l="l" t="t" r="r" b="b"/>
              <a:pathLst>
                <a:path w="120512" h="174772">
                  <a:moveTo>
                    <a:pt x="92751" y="49845"/>
                  </a:moveTo>
                  <a:cubicBezTo>
                    <a:pt x="92751" y="56785"/>
                    <a:pt x="90227" y="63726"/>
                    <a:pt x="85179" y="68142"/>
                  </a:cubicBezTo>
                  <a:cubicBezTo>
                    <a:pt x="80131" y="72559"/>
                    <a:pt x="73822" y="75714"/>
                    <a:pt x="66881" y="75714"/>
                  </a:cubicBezTo>
                  <a:lnTo>
                    <a:pt x="24607" y="75714"/>
                  </a:lnTo>
                  <a:lnTo>
                    <a:pt x="24607" y="22083"/>
                  </a:lnTo>
                  <a:lnTo>
                    <a:pt x="66881" y="22083"/>
                  </a:lnTo>
                  <a:cubicBezTo>
                    <a:pt x="73822" y="22083"/>
                    <a:pt x="80762" y="24607"/>
                    <a:pt x="85179" y="29654"/>
                  </a:cubicBezTo>
                  <a:cubicBezTo>
                    <a:pt x="89596" y="34702"/>
                    <a:pt x="92751" y="41012"/>
                    <a:pt x="92751" y="47952"/>
                  </a:cubicBezTo>
                  <a:lnTo>
                    <a:pt x="92751" y="49845"/>
                  </a:lnTo>
                  <a:close/>
                  <a:moveTo>
                    <a:pt x="71298" y="0"/>
                  </a:moveTo>
                  <a:lnTo>
                    <a:pt x="0" y="0"/>
                  </a:lnTo>
                  <a:lnTo>
                    <a:pt x="0" y="174772"/>
                  </a:lnTo>
                  <a:lnTo>
                    <a:pt x="25238" y="174772"/>
                  </a:lnTo>
                  <a:lnTo>
                    <a:pt x="25238" y="97797"/>
                  </a:lnTo>
                  <a:lnTo>
                    <a:pt x="71298" y="97797"/>
                  </a:lnTo>
                  <a:cubicBezTo>
                    <a:pt x="77608" y="97797"/>
                    <a:pt x="83917" y="96535"/>
                    <a:pt x="90227" y="94011"/>
                  </a:cubicBezTo>
                  <a:cubicBezTo>
                    <a:pt x="96536" y="91487"/>
                    <a:pt x="101584" y="87702"/>
                    <a:pt x="106001" y="83285"/>
                  </a:cubicBezTo>
                  <a:cubicBezTo>
                    <a:pt x="110417" y="78868"/>
                    <a:pt x="114203" y="73190"/>
                    <a:pt x="116727" y="67511"/>
                  </a:cubicBezTo>
                  <a:cubicBezTo>
                    <a:pt x="119251" y="61833"/>
                    <a:pt x="120513" y="55523"/>
                    <a:pt x="120513" y="48583"/>
                  </a:cubicBezTo>
                  <a:lnTo>
                    <a:pt x="120513" y="48583"/>
                  </a:lnTo>
                  <a:cubicBezTo>
                    <a:pt x="120513" y="35333"/>
                    <a:pt x="115465" y="23345"/>
                    <a:pt x="106001" y="13881"/>
                  </a:cubicBezTo>
                  <a:cubicBezTo>
                    <a:pt x="96536" y="5048"/>
                    <a:pt x="83917" y="0"/>
                    <a:pt x="71298" y="0"/>
                  </a:cubicBezTo>
                  <a:close/>
                </a:path>
              </a:pathLst>
            </a:custGeom>
            <a:solidFill>
              <a:schemeClr val="bg1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0" name="Friform 9">
              <a:extLst>
                <a:ext uri="{FF2B5EF4-FFF2-40B4-BE49-F238E27FC236}">
                  <a16:creationId xmlns:a16="http://schemas.microsoft.com/office/drawing/2014/main" id="{CABCEB2B-D1C6-FF41-8954-5339E12DAF9B}"/>
                </a:ext>
              </a:extLst>
            </p:cNvPr>
            <p:cNvSpPr/>
            <p:nvPr/>
          </p:nvSpPr>
          <p:spPr>
            <a:xfrm>
              <a:off x="782168" y="394334"/>
              <a:ext cx="120354" cy="174772"/>
            </a:xfrm>
            <a:custGeom>
              <a:avLst/>
              <a:gdLst>
                <a:gd name="connsiteX0" fmla="*/ 93381 w 120354"/>
                <a:gd name="connsiteY0" fmla="*/ 49845 h 174772"/>
                <a:gd name="connsiteX1" fmla="*/ 91489 w 120354"/>
                <a:gd name="connsiteY1" fmla="*/ 59940 h 174772"/>
                <a:gd name="connsiteX2" fmla="*/ 85810 w 120354"/>
                <a:gd name="connsiteY2" fmla="*/ 68142 h 174772"/>
                <a:gd name="connsiteX3" fmla="*/ 77608 w 120354"/>
                <a:gd name="connsiteY3" fmla="*/ 73821 h 174772"/>
                <a:gd name="connsiteX4" fmla="*/ 67512 w 120354"/>
                <a:gd name="connsiteY4" fmla="*/ 75714 h 174772"/>
                <a:gd name="connsiteX5" fmla="*/ 25238 w 120354"/>
                <a:gd name="connsiteY5" fmla="*/ 75714 h 174772"/>
                <a:gd name="connsiteX6" fmla="*/ 25238 w 120354"/>
                <a:gd name="connsiteY6" fmla="*/ 22083 h 174772"/>
                <a:gd name="connsiteX7" fmla="*/ 67512 w 120354"/>
                <a:gd name="connsiteY7" fmla="*/ 22083 h 174772"/>
                <a:gd name="connsiteX8" fmla="*/ 85810 w 120354"/>
                <a:gd name="connsiteY8" fmla="*/ 29654 h 174772"/>
                <a:gd name="connsiteX9" fmla="*/ 93381 w 120354"/>
                <a:gd name="connsiteY9" fmla="*/ 47952 h 174772"/>
                <a:gd name="connsiteX10" fmla="*/ 93381 w 120354"/>
                <a:gd name="connsiteY10" fmla="*/ 49845 h 174772"/>
                <a:gd name="connsiteX11" fmla="*/ 93381 w 120354"/>
                <a:gd name="connsiteY11" fmla="*/ 126189 h 174772"/>
                <a:gd name="connsiteX12" fmla="*/ 85810 w 120354"/>
                <a:gd name="connsiteY12" fmla="*/ 144487 h 174772"/>
                <a:gd name="connsiteX13" fmla="*/ 67512 w 120354"/>
                <a:gd name="connsiteY13" fmla="*/ 152058 h 174772"/>
                <a:gd name="connsiteX14" fmla="*/ 25238 w 120354"/>
                <a:gd name="connsiteY14" fmla="*/ 152058 h 174772"/>
                <a:gd name="connsiteX15" fmla="*/ 25238 w 120354"/>
                <a:gd name="connsiteY15" fmla="*/ 98428 h 174772"/>
                <a:gd name="connsiteX16" fmla="*/ 67512 w 120354"/>
                <a:gd name="connsiteY16" fmla="*/ 98428 h 174772"/>
                <a:gd name="connsiteX17" fmla="*/ 85810 w 120354"/>
                <a:gd name="connsiteY17" fmla="*/ 105999 h 174772"/>
                <a:gd name="connsiteX18" fmla="*/ 93381 w 120354"/>
                <a:gd name="connsiteY18" fmla="*/ 124296 h 174772"/>
                <a:gd name="connsiteX19" fmla="*/ 93381 w 120354"/>
                <a:gd name="connsiteY19" fmla="*/ 126189 h 174772"/>
                <a:gd name="connsiteX20" fmla="*/ 119882 w 120354"/>
                <a:gd name="connsiteY20" fmla="*/ 48583 h 174772"/>
                <a:gd name="connsiteX21" fmla="*/ 105370 w 120354"/>
                <a:gd name="connsiteY21" fmla="*/ 14512 h 174772"/>
                <a:gd name="connsiteX22" fmla="*/ 71298 w 120354"/>
                <a:gd name="connsiteY22" fmla="*/ 0 h 174772"/>
                <a:gd name="connsiteX23" fmla="*/ 0 w 120354"/>
                <a:gd name="connsiteY23" fmla="*/ 0 h 174772"/>
                <a:gd name="connsiteX24" fmla="*/ 0 w 120354"/>
                <a:gd name="connsiteY24" fmla="*/ 174772 h 174772"/>
                <a:gd name="connsiteX25" fmla="*/ 71929 w 120354"/>
                <a:gd name="connsiteY25" fmla="*/ 174772 h 174772"/>
                <a:gd name="connsiteX26" fmla="*/ 100322 w 120354"/>
                <a:gd name="connsiteY26" fmla="*/ 165308 h 174772"/>
                <a:gd name="connsiteX27" fmla="*/ 117989 w 120354"/>
                <a:gd name="connsiteY27" fmla="*/ 141332 h 174772"/>
                <a:gd name="connsiteX28" fmla="*/ 117989 w 120354"/>
                <a:gd name="connsiteY28" fmla="*/ 111678 h 174772"/>
                <a:gd name="connsiteX29" fmla="*/ 100322 w 120354"/>
                <a:gd name="connsiteY29" fmla="*/ 87702 h 174772"/>
                <a:gd name="connsiteX30" fmla="*/ 114834 w 120354"/>
                <a:gd name="connsiteY30" fmla="*/ 70666 h 174772"/>
                <a:gd name="connsiteX31" fmla="*/ 119882 w 120354"/>
                <a:gd name="connsiteY31" fmla="*/ 48583 h 1747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</a:cxnLst>
              <a:rect l="l" t="t" r="r" b="b"/>
              <a:pathLst>
                <a:path w="120354" h="174772">
                  <a:moveTo>
                    <a:pt x="93381" y="49845"/>
                  </a:moveTo>
                  <a:cubicBezTo>
                    <a:pt x="93381" y="53000"/>
                    <a:pt x="92751" y="56785"/>
                    <a:pt x="91489" y="59940"/>
                  </a:cubicBezTo>
                  <a:cubicBezTo>
                    <a:pt x="90227" y="63095"/>
                    <a:pt x="88334" y="66249"/>
                    <a:pt x="85810" y="68142"/>
                  </a:cubicBezTo>
                  <a:cubicBezTo>
                    <a:pt x="83286" y="70666"/>
                    <a:pt x="80762" y="72559"/>
                    <a:pt x="77608" y="73821"/>
                  </a:cubicBezTo>
                  <a:cubicBezTo>
                    <a:pt x="74453" y="75083"/>
                    <a:pt x="71298" y="75714"/>
                    <a:pt x="67512" y="75714"/>
                  </a:cubicBezTo>
                  <a:lnTo>
                    <a:pt x="25238" y="75714"/>
                  </a:lnTo>
                  <a:lnTo>
                    <a:pt x="25238" y="22083"/>
                  </a:lnTo>
                  <a:lnTo>
                    <a:pt x="67512" y="22083"/>
                  </a:lnTo>
                  <a:cubicBezTo>
                    <a:pt x="74453" y="22083"/>
                    <a:pt x="81393" y="24607"/>
                    <a:pt x="85810" y="29654"/>
                  </a:cubicBezTo>
                  <a:cubicBezTo>
                    <a:pt x="90227" y="34702"/>
                    <a:pt x="93381" y="41012"/>
                    <a:pt x="93381" y="47952"/>
                  </a:cubicBezTo>
                  <a:lnTo>
                    <a:pt x="93381" y="49845"/>
                  </a:lnTo>
                  <a:close/>
                  <a:moveTo>
                    <a:pt x="93381" y="126189"/>
                  </a:moveTo>
                  <a:cubicBezTo>
                    <a:pt x="93381" y="133130"/>
                    <a:pt x="90858" y="140070"/>
                    <a:pt x="85810" y="144487"/>
                  </a:cubicBezTo>
                  <a:cubicBezTo>
                    <a:pt x="80762" y="149534"/>
                    <a:pt x="74453" y="152058"/>
                    <a:pt x="67512" y="152058"/>
                  </a:cubicBezTo>
                  <a:lnTo>
                    <a:pt x="25238" y="152058"/>
                  </a:lnTo>
                  <a:lnTo>
                    <a:pt x="25238" y="98428"/>
                  </a:lnTo>
                  <a:lnTo>
                    <a:pt x="67512" y="98428"/>
                  </a:lnTo>
                  <a:cubicBezTo>
                    <a:pt x="74453" y="98428"/>
                    <a:pt x="81393" y="100951"/>
                    <a:pt x="85810" y="105999"/>
                  </a:cubicBezTo>
                  <a:cubicBezTo>
                    <a:pt x="90858" y="111047"/>
                    <a:pt x="93381" y="117356"/>
                    <a:pt x="93381" y="124296"/>
                  </a:cubicBezTo>
                  <a:lnTo>
                    <a:pt x="93381" y="126189"/>
                  </a:lnTo>
                  <a:close/>
                  <a:moveTo>
                    <a:pt x="119882" y="48583"/>
                  </a:moveTo>
                  <a:cubicBezTo>
                    <a:pt x="119882" y="35964"/>
                    <a:pt x="114834" y="23345"/>
                    <a:pt x="105370" y="14512"/>
                  </a:cubicBezTo>
                  <a:cubicBezTo>
                    <a:pt x="96536" y="5679"/>
                    <a:pt x="83917" y="0"/>
                    <a:pt x="71298" y="0"/>
                  </a:cubicBezTo>
                  <a:lnTo>
                    <a:pt x="0" y="0"/>
                  </a:lnTo>
                  <a:lnTo>
                    <a:pt x="0" y="174772"/>
                  </a:lnTo>
                  <a:lnTo>
                    <a:pt x="71929" y="174772"/>
                  </a:lnTo>
                  <a:cubicBezTo>
                    <a:pt x="82024" y="174772"/>
                    <a:pt x="92120" y="171617"/>
                    <a:pt x="100322" y="165308"/>
                  </a:cubicBezTo>
                  <a:cubicBezTo>
                    <a:pt x="108524" y="159629"/>
                    <a:pt x="114834" y="150796"/>
                    <a:pt x="117989" y="141332"/>
                  </a:cubicBezTo>
                  <a:cubicBezTo>
                    <a:pt x="121144" y="131868"/>
                    <a:pt x="121144" y="121142"/>
                    <a:pt x="117989" y="111678"/>
                  </a:cubicBezTo>
                  <a:cubicBezTo>
                    <a:pt x="114834" y="102213"/>
                    <a:pt x="108524" y="93380"/>
                    <a:pt x="100322" y="87702"/>
                  </a:cubicBezTo>
                  <a:cubicBezTo>
                    <a:pt x="106632" y="83285"/>
                    <a:pt x="111679" y="77606"/>
                    <a:pt x="114834" y="70666"/>
                  </a:cubicBezTo>
                  <a:cubicBezTo>
                    <a:pt x="117989" y="63726"/>
                    <a:pt x="119882" y="56154"/>
                    <a:pt x="119882" y="48583"/>
                  </a:cubicBezTo>
                  <a:close/>
                </a:path>
              </a:pathLst>
            </a:custGeom>
            <a:solidFill>
              <a:schemeClr val="bg1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1" name="Friform 10">
              <a:extLst>
                <a:ext uri="{FF2B5EF4-FFF2-40B4-BE49-F238E27FC236}">
                  <a16:creationId xmlns:a16="http://schemas.microsoft.com/office/drawing/2014/main" id="{FDE142EE-EA11-0D44-8133-C976551BE02B}"/>
                </a:ext>
              </a:extLst>
            </p:cNvPr>
            <p:cNvSpPr/>
            <p:nvPr/>
          </p:nvSpPr>
          <p:spPr>
            <a:xfrm>
              <a:off x="454701" y="393704"/>
              <a:ext cx="116095" cy="116725"/>
            </a:xfrm>
            <a:custGeom>
              <a:avLst/>
              <a:gdLst>
                <a:gd name="connsiteX0" fmla="*/ 58048 w 116095"/>
                <a:gd name="connsiteY0" fmla="*/ 0 h 116725"/>
                <a:gd name="connsiteX1" fmla="*/ 99060 w 116095"/>
                <a:gd name="connsiteY1" fmla="*/ 17036 h 116725"/>
                <a:gd name="connsiteX2" fmla="*/ 116096 w 116095"/>
                <a:gd name="connsiteY2" fmla="*/ 58047 h 116725"/>
                <a:gd name="connsiteX3" fmla="*/ 116096 w 116095"/>
                <a:gd name="connsiteY3" fmla="*/ 116725 h 116725"/>
                <a:gd name="connsiteX4" fmla="*/ 0 w 116095"/>
                <a:gd name="connsiteY4" fmla="*/ 116725 h 116725"/>
                <a:gd name="connsiteX5" fmla="*/ 0 w 116095"/>
                <a:gd name="connsiteY5" fmla="*/ 58678 h 116725"/>
                <a:gd name="connsiteX6" fmla="*/ 17036 w 116095"/>
                <a:gd name="connsiteY6" fmla="*/ 17667 h 116725"/>
                <a:gd name="connsiteX7" fmla="*/ 58048 w 116095"/>
                <a:gd name="connsiteY7" fmla="*/ 0 h 1167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116095" h="116725">
                  <a:moveTo>
                    <a:pt x="58048" y="0"/>
                  </a:moveTo>
                  <a:cubicBezTo>
                    <a:pt x="73822" y="0"/>
                    <a:pt x="88334" y="6309"/>
                    <a:pt x="99060" y="17036"/>
                  </a:cubicBezTo>
                  <a:cubicBezTo>
                    <a:pt x="109786" y="27762"/>
                    <a:pt x="116096" y="42904"/>
                    <a:pt x="116096" y="58047"/>
                  </a:cubicBezTo>
                  <a:lnTo>
                    <a:pt x="116096" y="116725"/>
                  </a:lnTo>
                  <a:lnTo>
                    <a:pt x="0" y="116725"/>
                  </a:lnTo>
                  <a:lnTo>
                    <a:pt x="0" y="58678"/>
                  </a:lnTo>
                  <a:cubicBezTo>
                    <a:pt x="0" y="42904"/>
                    <a:pt x="6310" y="28393"/>
                    <a:pt x="17036" y="17667"/>
                  </a:cubicBezTo>
                  <a:cubicBezTo>
                    <a:pt x="27762" y="6940"/>
                    <a:pt x="42905" y="0"/>
                    <a:pt x="58048" y="0"/>
                  </a:cubicBezTo>
                  <a:close/>
                </a:path>
              </a:pathLst>
            </a:custGeom>
            <a:solidFill>
              <a:srgbClr val="E31836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2" name="Friform 11">
              <a:extLst>
                <a:ext uri="{FF2B5EF4-FFF2-40B4-BE49-F238E27FC236}">
                  <a16:creationId xmlns:a16="http://schemas.microsoft.com/office/drawing/2014/main" id="{BE68B60E-5400-E548-B180-D50FFA1F5567}"/>
                </a:ext>
              </a:extLst>
            </p:cNvPr>
            <p:cNvSpPr/>
            <p:nvPr/>
          </p:nvSpPr>
          <p:spPr>
            <a:xfrm>
              <a:off x="396023" y="452382"/>
              <a:ext cx="58678" cy="116094"/>
            </a:xfrm>
            <a:custGeom>
              <a:avLst/>
              <a:gdLst>
                <a:gd name="connsiteX0" fmla="*/ 58679 w 58678"/>
                <a:gd name="connsiteY0" fmla="*/ 0 h 116094"/>
                <a:gd name="connsiteX1" fmla="*/ 17667 w 58678"/>
                <a:gd name="connsiteY1" fmla="*/ 17036 h 116094"/>
                <a:gd name="connsiteX2" fmla="*/ 0 w 58678"/>
                <a:gd name="connsiteY2" fmla="*/ 58047 h 116094"/>
                <a:gd name="connsiteX3" fmla="*/ 17036 w 58678"/>
                <a:gd name="connsiteY3" fmla="*/ 99059 h 116094"/>
                <a:gd name="connsiteX4" fmla="*/ 58048 w 58678"/>
                <a:gd name="connsiteY4" fmla="*/ 116094 h 116094"/>
                <a:gd name="connsiteX5" fmla="*/ 58048 w 58678"/>
                <a:gd name="connsiteY5" fmla="*/ 116094 h 116094"/>
                <a:gd name="connsiteX6" fmla="*/ 58048 w 58678"/>
                <a:gd name="connsiteY6" fmla="*/ 116094 h 116094"/>
                <a:gd name="connsiteX7" fmla="*/ 58048 w 58678"/>
                <a:gd name="connsiteY7" fmla="*/ 0 h 1160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58678" h="116094">
                  <a:moveTo>
                    <a:pt x="58679" y="0"/>
                  </a:moveTo>
                  <a:cubicBezTo>
                    <a:pt x="42905" y="0"/>
                    <a:pt x="28393" y="6309"/>
                    <a:pt x="17667" y="17036"/>
                  </a:cubicBezTo>
                  <a:cubicBezTo>
                    <a:pt x="6310" y="27762"/>
                    <a:pt x="0" y="42904"/>
                    <a:pt x="0" y="58047"/>
                  </a:cubicBezTo>
                  <a:cubicBezTo>
                    <a:pt x="0" y="73821"/>
                    <a:pt x="6310" y="88332"/>
                    <a:pt x="17036" y="99059"/>
                  </a:cubicBezTo>
                  <a:cubicBezTo>
                    <a:pt x="27762" y="109785"/>
                    <a:pt x="42905" y="116094"/>
                    <a:pt x="58048" y="116094"/>
                  </a:cubicBezTo>
                  <a:cubicBezTo>
                    <a:pt x="58048" y="116094"/>
                    <a:pt x="58048" y="116094"/>
                    <a:pt x="58048" y="116094"/>
                  </a:cubicBezTo>
                  <a:lnTo>
                    <a:pt x="58048" y="116094"/>
                  </a:lnTo>
                  <a:lnTo>
                    <a:pt x="58048" y="0"/>
                  </a:lnTo>
                  <a:close/>
                </a:path>
              </a:pathLst>
            </a:custGeom>
            <a:solidFill>
              <a:srgbClr val="728EE6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3" name="Friform 12">
              <a:extLst>
                <a:ext uri="{FF2B5EF4-FFF2-40B4-BE49-F238E27FC236}">
                  <a16:creationId xmlns:a16="http://schemas.microsoft.com/office/drawing/2014/main" id="{375D5841-1A60-CD4C-956D-CDB13050F634}"/>
                </a:ext>
              </a:extLst>
            </p:cNvPr>
            <p:cNvSpPr/>
            <p:nvPr/>
          </p:nvSpPr>
          <p:spPr>
            <a:xfrm>
              <a:off x="454701" y="510429"/>
              <a:ext cx="116726" cy="58047"/>
            </a:xfrm>
            <a:custGeom>
              <a:avLst/>
              <a:gdLst>
                <a:gd name="connsiteX0" fmla="*/ 116727 w 116726"/>
                <a:gd name="connsiteY0" fmla="*/ 0 h 58047"/>
                <a:gd name="connsiteX1" fmla="*/ 58048 w 116726"/>
                <a:gd name="connsiteY1" fmla="*/ 0 h 58047"/>
                <a:gd name="connsiteX2" fmla="*/ 41012 w 116726"/>
                <a:gd name="connsiteY2" fmla="*/ 41012 h 58047"/>
                <a:gd name="connsiteX3" fmla="*/ 0 w 116726"/>
                <a:gd name="connsiteY3" fmla="*/ 58047 h 58047"/>
                <a:gd name="connsiteX4" fmla="*/ 116727 w 116726"/>
                <a:gd name="connsiteY4" fmla="*/ 58047 h 58047"/>
                <a:gd name="connsiteX5" fmla="*/ 116727 w 116726"/>
                <a:gd name="connsiteY5" fmla="*/ 0 h 580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116726" h="58047">
                  <a:moveTo>
                    <a:pt x="116727" y="0"/>
                  </a:moveTo>
                  <a:lnTo>
                    <a:pt x="58048" y="0"/>
                  </a:lnTo>
                  <a:cubicBezTo>
                    <a:pt x="58048" y="15774"/>
                    <a:pt x="51738" y="30285"/>
                    <a:pt x="41012" y="41012"/>
                  </a:cubicBezTo>
                  <a:cubicBezTo>
                    <a:pt x="30286" y="51738"/>
                    <a:pt x="15143" y="58047"/>
                    <a:pt x="0" y="58047"/>
                  </a:cubicBezTo>
                  <a:lnTo>
                    <a:pt x="116727" y="58047"/>
                  </a:lnTo>
                  <a:lnTo>
                    <a:pt x="116727" y="0"/>
                  </a:lnTo>
                  <a:close/>
                </a:path>
              </a:pathLst>
            </a:custGeom>
            <a:solidFill>
              <a:srgbClr val="C2CFF4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4" name="Friform 13">
              <a:extLst>
                <a:ext uri="{FF2B5EF4-FFF2-40B4-BE49-F238E27FC236}">
                  <a16:creationId xmlns:a16="http://schemas.microsoft.com/office/drawing/2014/main" id="{37E584FD-1A9B-EA4B-B752-AC5EC51F4134}"/>
                </a:ext>
              </a:extLst>
            </p:cNvPr>
            <p:cNvSpPr/>
            <p:nvPr/>
          </p:nvSpPr>
          <p:spPr>
            <a:xfrm>
              <a:off x="454701" y="510429"/>
              <a:ext cx="58047" cy="58678"/>
            </a:xfrm>
            <a:custGeom>
              <a:avLst/>
              <a:gdLst>
                <a:gd name="connsiteX0" fmla="*/ 58048 w 58047"/>
                <a:gd name="connsiteY0" fmla="*/ 0 h 58678"/>
                <a:gd name="connsiteX1" fmla="*/ 0 w 58047"/>
                <a:gd name="connsiteY1" fmla="*/ 0 h 58678"/>
                <a:gd name="connsiteX2" fmla="*/ 0 w 58047"/>
                <a:gd name="connsiteY2" fmla="*/ 58678 h 58678"/>
                <a:gd name="connsiteX3" fmla="*/ 0 w 58047"/>
                <a:gd name="connsiteY3" fmla="*/ 58678 h 58678"/>
                <a:gd name="connsiteX4" fmla="*/ 41012 w 58047"/>
                <a:gd name="connsiteY4" fmla="*/ 41642 h 58678"/>
                <a:gd name="connsiteX5" fmla="*/ 58048 w 58047"/>
                <a:gd name="connsiteY5" fmla="*/ 0 h 5867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8047" h="58678">
                  <a:moveTo>
                    <a:pt x="58048" y="0"/>
                  </a:moveTo>
                  <a:lnTo>
                    <a:pt x="0" y="0"/>
                  </a:lnTo>
                  <a:lnTo>
                    <a:pt x="0" y="58678"/>
                  </a:lnTo>
                  <a:lnTo>
                    <a:pt x="0" y="58678"/>
                  </a:lnTo>
                  <a:cubicBezTo>
                    <a:pt x="15774" y="58678"/>
                    <a:pt x="30286" y="52369"/>
                    <a:pt x="41012" y="41642"/>
                  </a:cubicBezTo>
                  <a:cubicBezTo>
                    <a:pt x="52369" y="30285"/>
                    <a:pt x="58048" y="15774"/>
                    <a:pt x="58048" y="0"/>
                  </a:cubicBezTo>
                  <a:close/>
                </a:path>
              </a:pathLst>
            </a:custGeom>
            <a:solidFill>
              <a:srgbClr val="355EDB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5" name="Friform 14">
              <a:extLst>
                <a:ext uri="{FF2B5EF4-FFF2-40B4-BE49-F238E27FC236}">
                  <a16:creationId xmlns:a16="http://schemas.microsoft.com/office/drawing/2014/main" id="{0CB0DC64-E5F2-7B48-8881-992026495689}"/>
                </a:ext>
              </a:extLst>
            </p:cNvPr>
            <p:cNvSpPr/>
            <p:nvPr/>
          </p:nvSpPr>
          <p:spPr>
            <a:xfrm>
              <a:off x="454701" y="452382"/>
              <a:ext cx="116726" cy="58678"/>
            </a:xfrm>
            <a:custGeom>
              <a:avLst/>
              <a:gdLst>
                <a:gd name="connsiteX0" fmla="*/ 0 w 116726"/>
                <a:gd name="connsiteY0" fmla="*/ 0 h 58678"/>
                <a:gd name="connsiteX1" fmla="*/ 116727 w 116726"/>
                <a:gd name="connsiteY1" fmla="*/ 0 h 58678"/>
                <a:gd name="connsiteX2" fmla="*/ 116727 w 116726"/>
                <a:gd name="connsiteY2" fmla="*/ 58678 h 58678"/>
                <a:gd name="connsiteX3" fmla="*/ 0 w 116726"/>
                <a:gd name="connsiteY3" fmla="*/ 58678 h 5867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16726" h="58678">
                  <a:moveTo>
                    <a:pt x="0" y="0"/>
                  </a:moveTo>
                  <a:lnTo>
                    <a:pt x="116727" y="0"/>
                  </a:lnTo>
                  <a:lnTo>
                    <a:pt x="116727" y="58678"/>
                  </a:lnTo>
                  <a:lnTo>
                    <a:pt x="0" y="58678"/>
                  </a:lnTo>
                  <a:close/>
                </a:path>
              </a:pathLst>
            </a:custGeom>
            <a:solidFill>
              <a:srgbClr val="C21536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</p:grpSp>
    </p:spTree>
    <p:extLst>
      <p:ext uri="{BB962C8B-B14F-4D97-AF65-F5344CB8AC3E}">
        <p14:creationId xmlns:p14="http://schemas.microsoft.com/office/powerpoint/2010/main" val="3822202144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tat beige">
    <p:bg>
      <p:bgPr>
        <a:solidFill>
          <a:srgbClr val="E3DCD8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08161" y="1275023"/>
            <a:ext cx="7575678" cy="2852737"/>
          </a:xfrm>
        </p:spPr>
        <p:txBody>
          <a:bodyPr anchor="b"/>
          <a:lstStyle>
            <a:lvl1pPr algn="ctr">
              <a:lnSpc>
                <a:spcPct val="110000"/>
              </a:lnSpc>
              <a:defRPr sz="3501"/>
            </a:lvl1pPr>
          </a:lstStyle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9" name="Subtitle 2">
            <a:extLst>
              <a:ext uri="{FF2B5EF4-FFF2-40B4-BE49-F238E27FC236}">
                <a16:creationId xmlns:a16="http://schemas.microsoft.com/office/drawing/2014/main" id="{8983E566-8761-44C1-BA67-0C83D45B9E3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2308161" y="4435469"/>
            <a:ext cx="7575678" cy="1246446"/>
          </a:xfrm>
        </p:spPr>
        <p:txBody>
          <a:bodyPr lIns="0" tIns="0" rIns="0" bIns="0">
            <a:normAutofit/>
          </a:bodyPr>
          <a:lstStyle>
            <a:lvl1pPr marL="0" indent="0" algn="ctr">
              <a:buNone/>
              <a:defRPr sz="1500" b="1">
                <a:solidFill>
                  <a:schemeClr val="accent2"/>
                </a:solidFill>
              </a:defRPr>
            </a:lvl1pPr>
            <a:lvl2pPr marL="457223" indent="0" algn="ctr">
              <a:buNone/>
              <a:defRPr sz="2000"/>
            </a:lvl2pPr>
            <a:lvl3pPr marL="914446" indent="0" algn="ctr">
              <a:buNone/>
              <a:defRPr sz="1800"/>
            </a:lvl3pPr>
            <a:lvl4pPr marL="1371669" indent="0" algn="ctr">
              <a:buNone/>
              <a:defRPr sz="1600"/>
            </a:lvl4pPr>
            <a:lvl5pPr marL="1828891" indent="0" algn="ctr">
              <a:buNone/>
              <a:defRPr sz="1600"/>
            </a:lvl5pPr>
            <a:lvl6pPr marL="2286114" indent="0" algn="ctr">
              <a:buNone/>
              <a:defRPr sz="1600"/>
            </a:lvl6pPr>
            <a:lvl7pPr marL="2743337" indent="0" algn="ctr">
              <a:buNone/>
              <a:defRPr sz="1600"/>
            </a:lvl7pPr>
            <a:lvl8pPr marL="3200560" indent="0" algn="ctr">
              <a:buNone/>
              <a:defRPr sz="1600"/>
            </a:lvl8pPr>
            <a:lvl9pPr marL="3657783" indent="0" algn="ctr">
              <a:buNone/>
              <a:defRPr sz="1600"/>
            </a:lvl9pPr>
          </a:lstStyle>
          <a:p>
            <a:r>
              <a:rPr lang="nb-NO"/>
              <a:t>Klikk for å redigere undertittelstil i malen</a:t>
            </a:r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E91DECC-FB56-4662-9BC9-1F2C5BF822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BC5DA-09B7-4CD9-B21E-157BBBE69313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3" name="Plassholder for dato 2">
            <a:extLst>
              <a:ext uri="{FF2B5EF4-FFF2-40B4-BE49-F238E27FC236}">
                <a16:creationId xmlns:a16="http://schemas.microsoft.com/office/drawing/2014/main" id="{4110CB65-F599-7141-9407-3AA67880D62A}"/>
              </a:ext>
            </a:extLst>
          </p:cNvPr>
          <p:cNvSpPr>
            <a:spLocks noGrp="1"/>
          </p:cNvSpPr>
          <p:nvPr>
            <p:ph type="dt" sz="half" idx="13"/>
          </p:nvPr>
        </p:nvSpPr>
        <p:spPr>
          <a:xfrm>
            <a:off x="4724400" y="11740324"/>
            <a:ext cx="2743200" cy="365125"/>
          </a:xfrm>
        </p:spPr>
        <p:txBody>
          <a:bodyPr/>
          <a:lstStyle/>
          <a:p>
            <a:fld id="{9D03F6E6-5CDA-F241-BB38-1AEA2D1479E3}" type="datetime1">
              <a:rPr lang="nb-NO" smtClean="0"/>
              <a:t>25.01.2024</a:t>
            </a:fld>
            <a:endParaRPr lang="nb-NO"/>
          </a:p>
        </p:txBody>
      </p:sp>
      <p:sp>
        <p:nvSpPr>
          <p:cNvPr id="4" name="Plassholder for bunntekst 3">
            <a:extLst>
              <a:ext uri="{FF2B5EF4-FFF2-40B4-BE49-F238E27FC236}">
                <a16:creationId xmlns:a16="http://schemas.microsoft.com/office/drawing/2014/main" id="{21171FB3-3F01-114A-86EF-5766C2D6C3A2}"/>
              </a:ext>
            </a:extLst>
          </p:cNvPr>
          <p:cNvSpPr>
            <a:spLocks noGrp="1"/>
          </p:cNvSpPr>
          <p:nvPr>
            <p:ph type="ftr" sz="quarter" idx="14"/>
          </p:nvPr>
        </p:nvSpPr>
        <p:spPr>
          <a:xfrm>
            <a:off x="426655" y="11740324"/>
            <a:ext cx="4114800" cy="365125"/>
          </a:xfrm>
        </p:spPr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42326906"/>
      </p:ext>
    </p:extLst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tat hvit">
    <p:bg>
      <p:bgPr>
        <a:solidFill>
          <a:schemeClr val="l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08161" y="1275023"/>
            <a:ext cx="7575678" cy="2852737"/>
          </a:xfrm>
        </p:spPr>
        <p:txBody>
          <a:bodyPr anchor="b"/>
          <a:lstStyle>
            <a:lvl1pPr algn="ctr">
              <a:lnSpc>
                <a:spcPct val="110000"/>
              </a:lnSpc>
              <a:defRPr sz="3501"/>
            </a:lvl1pPr>
          </a:lstStyle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9" name="Subtitle 2">
            <a:extLst>
              <a:ext uri="{FF2B5EF4-FFF2-40B4-BE49-F238E27FC236}">
                <a16:creationId xmlns:a16="http://schemas.microsoft.com/office/drawing/2014/main" id="{8983E566-8761-44C1-BA67-0C83D45B9E3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2308161" y="4435469"/>
            <a:ext cx="7575678" cy="1246446"/>
          </a:xfrm>
        </p:spPr>
        <p:txBody>
          <a:bodyPr lIns="0" tIns="0" rIns="0" bIns="0">
            <a:normAutofit/>
          </a:bodyPr>
          <a:lstStyle>
            <a:lvl1pPr marL="0" indent="0" algn="ctr">
              <a:buNone/>
              <a:defRPr sz="1500" b="1">
                <a:solidFill>
                  <a:schemeClr val="accent2"/>
                </a:solidFill>
              </a:defRPr>
            </a:lvl1pPr>
            <a:lvl2pPr marL="457223" indent="0" algn="ctr">
              <a:buNone/>
              <a:defRPr sz="2000"/>
            </a:lvl2pPr>
            <a:lvl3pPr marL="914446" indent="0" algn="ctr">
              <a:buNone/>
              <a:defRPr sz="1800"/>
            </a:lvl3pPr>
            <a:lvl4pPr marL="1371669" indent="0" algn="ctr">
              <a:buNone/>
              <a:defRPr sz="1600"/>
            </a:lvl4pPr>
            <a:lvl5pPr marL="1828891" indent="0" algn="ctr">
              <a:buNone/>
              <a:defRPr sz="1600"/>
            </a:lvl5pPr>
            <a:lvl6pPr marL="2286114" indent="0" algn="ctr">
              <a:buNone/>
              <a:defRPr sz="1600"/>
            </a:lvl6pPr>
            <a:lvl7pPr marL="2743337" indent="0" algn="ctr">
              <a:buNone/>
              <a:defRPr sz="1600"/>
            </a:lvl7pPr>
            <a:lvl8pPr marL="3200560" indent="0" algn="ctr">
              <a:buNone/>
              <a:defRPr sz="1600"/>
            </a:lvl8pPr>
            <a:lvl9pPr marL="3657783" indent="0" algn="ctr">
              <a:buNone/>
              <a:defRPr sz="1600"/>
            </a:lvl9pPr>
          </a:lstStyle>
          <a:p>
            <a:r>
              <a:rPr lang="nb-NO"/>
              <a:t>Klikk for å redigere undertittelstil i malen</a:t>
            </a:r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DC91B6B-991B-4FC8-933F-A45EFAAF92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BC5DA-09B7-4CD9-B21E-157BBBE69313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3" name="Plassholder for dato 2">
            <a:extLst>
              <a:ext uri="{FF2B5EF4-FFF2-40B4-BE49-F238E27FC236}">
                <a16:creationId xmlns:a16="http://schemas.microsoft.com/office/drawing/2014/main" id="{0FB3D153-DEAB-C540-94A5-FFF9D28548A8}"/>
              </a:ext>
            </a:extLst>
          </p:cNvPr>
          <p:cNvSpPr>
            <a:spLocks noGrp="1"/>
          </p:cNvSpPr>
          <p:nvPr>
            <p:ph type="dt" sz="half" idx="13"/>
          </p:nvPr>
        </p:nvSpPr>
        <p:spPr>
          <a:xfrm>
            <a:off x="4724400" y="12422249"/>
            <a:ext cx="2743200" cy="365125"/>
          </a:xfrm>
        </p:spPr>
        <p:txBody>
          <a:bodyPr/>
          <a:lstStyle/>
          <a:p>
            <a:fld id="{9D03F6E6-5CDA-F241-BB38-1AEA2D1479E3}" type="datetime1">
              <a:rPr lang="nb-NO" smtClean="0"/>
              <a:t>25.01.2024</a:t>
            </a:fld>
            <a:endParaRPr lang="nb-NO"/>
          </a:p>
        </p:txBody>
      </p:sp>
      <p:sp>
        <p:nvSpPr>
          <p:cNvPr id="4" name="Plassholder for bunntekst 3">
            <a:extLst>
              <a:ext uri="{FF2B5EF4-FFF2-40B4-BE49-F238E27FC236}">
                <a16:creationId xmlns:a16="http://schemas.microsoft.com/office/drawing/2014/main" id="{BA7D6FA9-7CAE-1543-85E3-EE200192FADB}"/>
              </a:ext>
            </a:extLst>
          </p:cNvPr>
          <p:cNvSpPr>
            <a:spLocks noGrp="1"/>
          </p:cNvSpPr>
          <p:nvPr>
            <p:ph type="ftr" sz="quarter" idx="14"/>
          </p:nvPr>
        </p:nvSpPr>
        <p:spPr>
          <a:xfrm>
            <a:off x="426655" y="12422249"/>
            <a:ext cx="4114800" cy="365125"/>
          </a:xfrm>
        </p:spPr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81454654"/>
      </p:ext>
    </p:extLst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itat mørk grønn">
    <p:bg>
      <p:bgPr>
        <a:solidFill>
          <a:schemeClr val="accent3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08161" y="1275023"/>
            <a:ext cx="7575678" cy="2852737"/>
          </a:xfrm>
        </p:spPr>
        <p:txBody>
          <a:bodyPr anchor="b"/>
          <a:lstStyle>
            <a:lvl1pPr algn="ctr">
              <a:lnSpc>
                <a:spcPct val="110000"/>
              </a:lnSpc>
              <a:defRPr sz="3501">
                <a:solidFill>
                  <a:schemeClr val="bg1"/>
                </a:solidFill>
              </a:defRPr>
            </a:lvl1pPr>
          </a:lstStyle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9" name="Subtitle 2">
            <a:extLst>
              <a:ext uri="{FF2B5EF4-FFF2-40B4-BE49-F238E27FC236}">
                <a16:creationId xmlns:a16="http://schemas.microsoft.com/office/drawing/2014/main" id="{8983E566-8761-44C1-BA67-0C83D45B9E3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2308161" y="4435469"/>
            <a:ext cx="7575678" cy="1246446"/>
          </a:xfrm>
        </p:spPr>
        <p:txBody>
          <a:bodyPr lIns="0" tIns="0" rIns="0" bIns="0">
            <a:normAutofit/>
          </a:bodyPr>
          <a:lstStyle>
            <a:lvl1pPr marL="0" indent="0" algn="ctr">
              <a:buNone/>
              <a:defRPr sz="1500" b="1">
                <a:solidFill>
                  <a:schemeClr val="bg1"/>
                </a:solidFill>
              </a:defRPr>
            </a:lvl1pPr>
            <a:lvl2pPr marL="457223" indent="0" algn="ctr">
              <a:buNone/>
              <a:defRPr sz="2000"/>
            </a:lvl2pPr>
            <a:lvl3pPr marL="914446" indent="0" algn="ctr">
              <a:buNone/>
              <a:defRPr sz="1800"/>
            </a:lvl3pPr>
            <a:lvl4pPr marL="1371669" indent="0" algn="ctr">
              <a:buNone/>
              <a:defRPr sz="1600"/>
            </a:lvl4pPr>
            <a:lvl5pPr marL="1828891" indent="0" algn="ctr">
              <a:buNone/>
              <a:defRPr sz="1600"/>
            </a:lvl5pPr>
            <a:lvl6pPr marL="2286114" indent="0" algn="ctr">
              <a:buNone/>
              <a:defRPr sz="1600"/>
            </a:lvl6pPr>
            <a:lvl7pPr marL="2743337" indent="0" algn="ctr">
              <a:buNone/>
              <a:defRPr sz="1600"/>
            </a:lvl7pPr>
            <a:lvl8pPr marL="3200560" indent="0" algn="ctr">
              <a:buNone/>
              <a:defRPr sz="1600"/>
            </a:lvl8pPr>
            <a:lvl9pPr marL="3657783" indent="0" algn="ctr">
              <a:buNone/>
              <a:defRPr sz="1600"/>
            </a:lvl9pPr>
          </a:lstStyle>
          <a:p>
            <a:r>
              <a:rPr lang="nb-NO"/>
              <a:t>Klikk for å redigere undertittelstil i malen</a:t>
            </a:r>
            <a:endParaRPr lang="en-US" dirty="0"/>
          </a:p>
        </p:txBody>
      </p:sp>
      <p:pic>
        <p:nvPicPr>
          <p:cNvPr id="6" name="Graphic 5">
            <a:extLst>
              <a:ext uri="{FF2B5EF4-FFF2-40B4-BE49-F238E27FC236}">
                <a16:creationId xmlns:a16="http://schemas.microsoft.com/office/drawing/2014/main" id="{D02EB656-7F20-4100-B27B-43918EE9C0B0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396023" y="393704"/>
            <a:ext cx="832860" cy="176665"/>
          </a:xfrm>
          <a:prstGeom prst="rect">
            <a:avLst/>
          </a:prstGeom>
        </p:spPr>
      </p:pic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6CC0A22-8D5E-43F7-AE86-F6B4C9834A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BC5DA-09B7-4CD9-B21E-157BBBE69313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3" name="Plassholder for dato 2">
            <a:extLst>
              <a:ext uri="{FF2B5EF4-FFF2-40B4-BE49-F238E27FC236}">
                <a16:creationId xmlns:a16="http://schemas.microsoft.com/office/drawing/2014/main" id="{86069985-0C21-F648-9C6F-23BF585812FE}"/>
              </a:ext>
            </a:extLst>
          </p:cNvPr>
          <p:cNvSpPr>
            <a:spLocks noGrp="1"/>
          </p:cNvSpPr>
          <p:nvPr>
            <p:ph type="dt" sz="half" idx="13"/>
          </p:nvPr>
        </p:nvSpPr>
        <p:spPr>
          <a:xfrm>
            <a:off x="4724400" y="11879809"/>
            <a:ext cx="2743200" cy="365125"/>
          </a:xfrm>
        </p:spPr>
        <p:txBody>
          <a:bodyPr/>
          <a:lstStyle/>
          <a:p>
            <a:fld id="{9D03F6E6-5CDA-F241-BB38-1AEA2D1479E3}" type="datetime1">
              <a:rPr lang="nb-NO" smtClean="0"/>
              <a:t>25.01.2024</a:t>
            </a:fld>
            <a:endParaRPr lang="nb-NO"/>
          </a:p>
        </p:txBody>
      </p:sp>
      <p:sp>
        <p:nvSpPr>
          <p:cNvPr id="4" name="Plassholder for bunntekst 3">
            <a:extLst>
              <a:ext uri="{FF2B5EF4-FFF2-40B4-BE49-F238E27FC236}">
                <a16:creationId xmlns:a16="http://schemas.microsoft.com/office/drawing/2014/main" id="{E81F3888-20B8-374F-968C-6264DAC33F81}"/>
              </a:ext>
            </a:extLst>
          </p:cNvPr>
          <p:cNvSpPr>
            <a:spLocks noGrp="1"/>
          </p:cNvSpPr>
          <p:nvPr>
            <p:ph type="ftr" sz="quarter" idx="14"/>
          </p:nvPr>
        </p:nvSpPr>
        <p:spPr>
          <a:xfrm>
            <a:off x="426655" y="11879809"/>
            <a:ext cx="4114800" cy="365125"/>
          </a:xfrm>
        </p:spPr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60174053"/>
      </p:ext>
    </p:extLst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Avslutningsside hvit">
    <p:bg>
      <p:bgPr>
        <a:solidFill>
          <a:schemeClr val="l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Chart, pie chart  Description automatically generated">
            <a:extLst>
              <a:ext uri="{FF2B5EF4-FFF2-40B4-BE49-F238E27FC236}">
                <a16:creationId xmlns:a16="http://schemas.microsoft.com/office/drawing/2014/main" id="{3E0AFCBD-C4FA-4817-B401-50B836E169FC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05367" y="4995193"/>
            <a:ext cx="1342016" cy="1327893"/>
          </a:xfrm>
          <a:prstGeom prst="rect">
            <a:avLst/>
          </a:prstGeom>
        </p:spPr>
      </p:pic>
      <p:sp>
        <p:nvSpPr>
          <p:cNvPr id="12" name="Title 1">
            <a:extLst>
              <a:ext uri="{FF2B5EF4-FFF2-40B4-BE49-F238E27FC236}">
                <a16:creationId xmlns:a16="http://schemas.microsoft.com/office/drawing/2014/main" id="{D9DC0413-5373-4348-9595-DC2E4AEEFA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29008" y="663754"/>
            <a:ext cx="5184996" cy="2744602"/>
          </a:xfrm>
        </p:spPr>
        <p:txBody>
          <a:bodyPr anchor="b"/>
          <a:lstStyle>
            <a:lvl1pPr algn="l">
              <a:lnSpc>
                <a:spcPct val="110000"/>
              </a:lnSpc>
              <a:defRPr sz="3501" b="1">
                <a:solidFill>
                  <a:schemeClr val="tx1"/>
                </a:solidFill>
              </a:defRPr>
            </a:lvl1pPr>
          </a:lstStyle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13" name="Text Placeholder 3">
            <a:extLst>
              <a:ext uri="{FF2B5EF4-FFF2-40B4-BE49-F238E27FC236}">
                <a16:creationId xmlns:a16="http://schemas.microsoft.com/office/drawing/2014/main" id="{F765D79C-17E5-4D80-9094-086FCDF76608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1029008" y="3968394"/>
            <a:ext cx="5184995" cy="2354692"/>
          </a:xfrm>
        </p:spPr>
        <p:txBody>
          <a:bodyPr/>
          <a:lstStyle>
            <a:lvl1pPr marL="0" indent="0">
              <a:buNone/>
              <a:defRPr>
                <a:solidFill>
                  <a:schemeClr val="accent2"/>
                </a:solidFill>
              </a:defRPr>
            </a:lvl1pPr>
          </a:lstStyle>
          <a:p>
            <a:pPr lvl="0"/>
            <a:r>
              <a:rPr lang="nb-NO" dirty="0"/>
              <a:t>Kontaktinfo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00313163"/>
      </p:ext>
    </p:extLst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Avslutningsside lilla">
    <p:bg>
      <p:bgPr>
        <a:solidFill>
          <a:schemeClr val="accent5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 descr="Chart, pie chart  Description automatically generated">
            <a:extLst>
              <a:ext uri="{FF2B5EF4-FFF2-40B4-BE49-F238E27FC236}">
                <a16:creationId xmlns:a16="http://schemas.microsoft.com/office/drawing/2014/main" id="{0A8FCB37-6E51-4B9C-8977-658D04A0DD7C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05367" y="4995193"/>
            <a:ext cx="1342016" cy="1327893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29008" y="663754"/>
            <a:ext cx="5184996" cy="2744602"/>
          </a:xfrm>
        </p:spPr>
        <p:txBody>
          <a:bodyPr anchor="b"/>
          <a:lstStyle>
            <a:lvl1pPr algn="l">
              <a:lnSpc>
                <a:spcPct val="110000"/>
              </a:lnSpc>
              <a:defRPr sz="3501" b="1">
                <a:solidFill>
                  <a:schemeClr val="bg1"/>
                </a:solidFill>
              </a:defRPr>
            </a:lvl1pPr>
          </a:lstStyle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13" name="Text Placeholder 3">
            <a:extLst>
              <a:ext uri="{FF2B5EF4-FFF2-40B4-BE49-F238E27FC236}">
                <a16:creationId xmlns:a16="http://schemas.microsoft.com/office/drawing/2014/main" id="{15446056-E43C-4D85-8DD8-057CF7216077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1029008" y="3968394"/>
            <a:ext cx="5184995" cy="2354692"/>
          </a:xfrm>
        </p:spPr>
        <p:txBody>
          <a:bodyPr/>
          <a:lstStyle>
            <a:lvl1pPr marL="0" indent="0">
              <a:buNone/>
              <a:defRPr>
                <a:solidFill>
                  <a:srgbClr val="94ABF7"/>
                </a:solidFill>
              </a:defRPr>
            </a:lvl1pPr>
          </a:lstStyle>
          <a:p>
            <a:pPr lvl="0"/>
            <a:r>
              <a:rPr lang="nb-NO" dirty="0"/>
              <a:t>Kontaktinfo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230823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BUP målgrupp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ssholder for dato 2">
            <a:extLst>
              <a:ext uri="{FF2B5EF4-FFF2-40B4-BE49-F238E27FC236}">
                <a16:creationId xmlns:a16="http://schemas.microsoft.com/office/drawing/2014/main" id="{DE608CB4-7FB8-4F4A-8B58-A10D4C7093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79DD6-9036-5E4E-A769-804A89AA79F3}" type="datetimeFigureOut">
              <a:rPr lang="nb-NO" smtClean="0"/>
              <a:t>25.01.2024</a:t>
            </a:fld>
            <a:endParaRPr lang="nb-NO"/>
          </a:p>
        </p:txBody>
      </p:sp>
      <p:sp>
        <p:nvSpPr>
          <p:cNvPr id="4" name="Plassholder for bunntekst 3">
            <a:extLst>
              <a:ext uri="{FF2B5EF4-FFF2-40B4-BE49-F238E27FC236}">
                <a16:creationId xmlns:a16="http://schemas.microsoft.com/office/drawing/2014/main" id="{6A1CF599-976F-D34F-B0CC-3B079ECD9B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Plassholder for lysbildenummer 4">
            <a:extLst>
              <a:ext uri="{FF2B5EF4-FFF2-40B4-BE49-F238E27FC236}">
                <a16:creationId xmlns:a16="http://schemas.microsoft.com/office/drawing/2014/main" id="{CAD27731-15F3-A146-B14B-44BF964ED7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7274F-C966-8C46-AFC4-F3A14ECF3B01}" type="slidenum">
              <a:rPr lang="nb-NO" smtClean="0"/>
              <a:t>‹#›</a:t>
            </a:fld>
            <a:endParaRPr lang="nb-NO"/>
          </a:p>
        </p:txBody>
      </p:sp>
      <p:sp>
        <p:nvSpPr>
          <p:cNvPr id="6" name="Tittel 1">
            <a:extLst>
              <a:ext uri="{FF2B5EF4-FFF2-40B4-BE49-F238E27FC236}">
                <a16:creationId xmlns:a16="http://schemas.microsoft.com/office/drawing/2014/main" id="{67B1E8A2-5A26-8949-9E73-0F71693E8C13}"/>
              </a:ext>
            </a:extLst>
          </p:cNvPr>
          <p:cNvSpPr txBox="1">
            <a:spLocks/>
          </p:cNvSpPr>
          <p:nvPr userDrawn="1"/>
        </p:nvSpPr>
        <p:spPr>
          <a:xfrm>
            <a:off x="1050925" y="857250"/>
            <a:ext cx="10534650" cy="704850"/>
          </a:xfrm>
          <a:prstGeom prst="rect">
            <a:avLst/>
          </a:prstGeom>
        </p:spPr>
        <p:txBody>
          <a:bodyPr vert="horz" lIns="0" tIns="0" rIns="0" bIns="0" rtlCol="0" anchor="t" anchorCtr="0">
            <a:noAutofit/>
          </a:bodyPr>
          <a:lstStyle>
            <a:lvl1pPr algn="l" defTabSz="914446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/>
              <a:t>Våre målgrupper</a:t>
            </a:r>
            <a:endParaRPr lang="nb-NO" dirty="0"/>
          </a:p>
        </p:txBody>
      </p:sp>
      <p:grpSp>
        <p:nvGrpSpPr>
          <p:cNvPr id="7" name="Gruppe 6">
            <a:extLst>
              <a:ext uri="{FF2B5EF4-FFF2-40B4-BE49-F238E27FC236}">
                <a16:creationId xmlns:a16="http://schemas.microsoft.com/office/drawing/2014/main" id="{AF375444-429E-7946-A703-A20B1E23E380}"/>
              </a:ext>
            </a:extLst>
          </p:cNvPr>
          <p:cNvGrpSpPr/>
          <p:nvPr userDrawn="1"/>
        </p:nvGrpSpPr>
        <p:grpSpPr>
          <a:xfrm>
            <a:off x="1050925" y="1538722"/>
            <a:ext cx="2969080" cy="2977244"/>
            <a:chOff x="1050925" y="1538722"/>
            <a:chExt cx="2969080" cy="2977244"/>
          </a:xfrm>
        </p:grpSpPr>
        <p:sp>
          <p:nvSpPr>
            <p:cNvPr id="8" name="Ellipse 7">
              <a:extLst>
                <a:ext uri="{FF2B5EF4-FFF2-40B4-BE49-F238E27FC236}">
                  <a16:creationId xmlns:a16="http://schemas.microsoft.com/office/drawing/2014/main" id="{2B0CBD27-A470-7D4F-B760-732A61B3096B}"/>
                </a:ext>
              </a:extLst>
            </p:cNvPr>
            <p:cNvSpPr/>
            <p:nvPr/>
          </p:nvSpPr>
          <p:spPr>
            <a:xfrm>
              <a:off x="1050925" y="1538722"/>
              <a:ext cx="2969080" cy="2977244"/>
            </a:xfrm>
            <a:prstGeom prst="ellipse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1152000" rIns="0" bIns="0" rtlCol="0" anchor="t" anchorCtr="0"/>
            <a:lstStyle/>
            <a:p>
              <a:pPr algn="ctr"/>
              <a:r>
                <a:rPr lang="nb-NO" sz="1400" dirty="0">
                  <a:solidFill>
                    <a:schemeClr val="tx1"/>
                  </a:solidFill>
                </a:rPr>
                <a:t>Kommunale helse- og omsorgstjenester</a:t>
              </a:r>
            </a:p>
            <a:p>
              <a:pPr algn="ctr"/>
              <a:endParaRPr lang="nb-NO" sz="1400" dirty="0">
                <a:solidFill>
                  <a:schemeClr val="tx1"/>
                </a:solidFill>
              </a:endParaRPr>
            </a:p>
            <a:p>
              <a:pPr algn="ctr"/>
              <a:r>
                <a:rPr lang="nb-NO" sz="1400" dirty="0">
                  <a:solidFill>
                    <a:schemeClr val="tx1"/>
                  </a:solidFill>
                </a:rPr>
                <a:t>Skole og barnehage</a:t>
              </a:r>
            </a:p>
          </p:txBody>
        </p:sp>
        <p:sp>
          <p:nvSpPr>
            <p:cNvPr id="9" name="Friform 8">
              <a:extLst>
                <a:ext uri="{FF2B5EF4-FFF2-40B4-BE49-F238E27FC236}">
                  <a16:creationId xmlns:a16="http://schemas.microsoft.com/office/drawing/2014/main" id="{31E0C443-08D4-D844-AB2B-F6D40F309EE1}"/>
                </a:ext>
              </a:extLst>
            </p:cNvPr>
            <p:cNvSpPr/>
            <p:nvPr/>
          </p:nvSpPr>
          <p:spPr>
            <a:xfrm>
              <a:off x="2285967" y="2109757"/>
              <a:ext cx="552450" cy="755882"/>
            </a:xfrm>
            <a:custGeom>
              <a:avLst/>
              <a:gdLst>
                <a:gd name="connsiteX0" fmla="*/ 426663 w 552450"/>
                <a:gd name="connsiteY0" fmla="*/ -124 h 755882"/>
                <a:gd name="connsiteX1" fmla="*/ 363802 w 552450"/>
                <a:gd name="connsiteY1" fmla="*/ 36462 h 755882"/>
                <a:gd name="connsiteX2" fmla="*/ 184155 w 552450"/>
                <a:gd name="connsiteY2" fmla="*/ 36462 h 755882"/>
                <a:gd name="connsiteX3" fmla="*/ 121889 w 552450"/>
                <a:gd name="connsiteY3" fmla="*/ 2238 h 755882"/>
                <a:gd name="connsiteX4" fmla="*/ 37279 w 552450"/>
                <a:gd name="connsiteY4" fmla="*/ 24660 h 755882"/>
                <a:gd name="connsiteX5" fmla="*/ 1231 w 552450"/>
                <a:gd name="connsiteY5" fmla="*/ 127340 h 755882"/>
                <a:gd name="connsiteX6" fmla="*/ 51877 w 552450"/>
                <a:gd name="connsiteY6" fmla="*/ 203167 h 755882"/>
                <a:gd name="connsiteX7" fmla="*/ 111760 w 552450"/>
                <a:gd name="connsiteY7" fmla="*/ 354867 h 755882"/>
                <a:gd name="connsiteX8" fmla="*/ 28640 w 552450"/>
                <a:gd name="connsiteY8" fmla="*/ 443969 h 755882"/>
                <a:gd name="connsiteX9" fmla="*/ 29534 w 552450"/>
                <a:gd name="connsiteY9" fmla="*/ 609796 h 755882"/>
                <a:gd name="connsiteX10" fmla="*/ 142447 w 552450"/>
                <a:gd name="connsiteY10" fmla="*/ 754929 h 755882"/>
                <a:gd name="connsiteX11" fmla="*/ 219609 w 552450"/>
                <a:gd name="connsiteY11" fmla="*/ 719496 h 755882"/>
                <a:gd name="connsiteX12" fmla="*/ 332223 w 552450"/>
                <a:gd name="connsiteY12" fmla="*/ 719212 h 755882"/>
                <a:gd name="connsiteX13" fmla="*/ 409385 w 552450"/>
                <a:gd name="connsiteY13" fmla="*/ 754929 h 755882"/>
                <a:gd name="connsiteX14" fmla="*/ 522595 w 552450"/>
                <a:gd name="connsiteY14" fmla="*/ 608567 h 755882"/>
                <a:gd name="connsiteX15" fmla="*/ 523787 w 552450"/>
                <a:gd name="connsiteY15" fmla="*/ 443969 h 755882"/>
                <a:gd name="connsiteX16" fmla="*/ 440667 w 552450"/>
                <a:gd name="connsiteY16" fmla="*/ 354867 h 755882"/>
                <a:gd name="connsiteX17" fmla="*/ 500549 w 552450"/>
                <a:gd name="connsiteY17" fmla="*/ 203176 h 755882"/>
                <a:gd name="connsiteX18" fmla="*/ 550898 w 552450"/>
                <a:gd name="connsiteY18" fmla="*/ 127340 h 755882"/>
                <a:gd name="connsiteX19" fmla="*/ 515445 w 552450"/>
                <a:gd name="connsiteY19" fmla="*/ 24953 h 755882"/>
                <a:gd name="connsiteX20" fmla="*/ 426664 w 552450"/>
                <a:gd name="connsiteY20" fmla="*/ -124 h 755882"/>
                <a:gd name="connsiteX21" fmla="*/ 503229 w 552450"/>
                <a:gd name="connsiteY21" fmla="*/ 39409 h 755882"/>
                <a:gd name="connsiteX22" fmla="*/ 532128 w 552450"/>
                <a:gd name="connsiteY22" fmla="*/ 124383 h 755882"/>
                <a:gd name="connsiteX23" fmla="*/ 487439 w 552450"/>
                <a:gd name="connsiteY23" fmla="*/ 189296 h 755882"/>
                <a:gd name="connsiteX24" fmla="*/ 482077 w 552450"/>
                <a:gd name="connsiteY24" fmla="*/ 197857 h 755882"/>
                <a:gd name="connsiteX25" fmla="*/ 416534 w 552450"/>
                <a:gd name="connsiteY25" fmla="*/ 350407 h 755882"/>
                <a:gd name="connsiteX26" fmla="*/ 276213 w 552450"/>
                <a:gd name="connsiteY26" fmla="*/ 395592 h 755882"/>
                <a:gd name="connsiteX27" fmla="*/ 135593 w 552450"/>
                <a:gd name="connsiteY27" fmla="*/ 350407 h 755882"/>
                <a:gd name="connsiteX28" fmla="*/ 70349 w 552450"/>
                <a:gd name="connsiteY28" fmla="*/ 197857 h 755882"/>
                <a:gd name="connsiteX29" fmla="*/ 64688 w 552450"/>
                <a:gd name="connsiteY29" fmla="*/ 189296 h 755882"/>
                <a:gd name="connsiteX30" fmla="*/ 20000 w 552450"/>
                <a:gd name="connsiteY30" fmla="*/ 124383 h 755882"/>
                <a:gd name="connsiteX31" fmla="*/ 49494 w 552450"/>
                <a:gd name="connsiteY31" fmla="*/ 39107 h 755882"/>
                <a:gd name="connsiteX32" fmla="*/ 118314 w 552450"/>
                <a:gd name="connsiteY32" fmla="*/ 20814 h 755882"/>
                <a:gd name="connsiteX33" fmla="*/ 175516 w 552450"/>
                <a:gd name="connsiteY33" fmla="*/ 53573 h 755882"/>
                <a:gd name="connsiteX34" fmla="*/ 186538 w 552450"/>
                <a:gd name="connsiteY34" fmla="*/ 55926 h 755882"/>
                <a:gd name="connsiteX35" fmla="*/ 362014 w 552450"/>
                <a:gd name="connsiteY35" fmla="*/ 55926 h 755882"/>
                <a:gd name="connsiteX36" fmla="*/ 374229 w 552450"/>
                <a:gd name="connsiteY36" fmla="*/ 52392 h 755882"/>
                <a:gd name="connsiteX37" fmla="*/ 429344 w 552450"/>
                <a:gd name="connsiteY37" fmla="*/ 18754 h 755882"/>
                <a:gd name="connsiteX38" fmla="*/ 503229 w 552450"/>
                <a:gd name="connsiteY38" fmla="*/ 39409 h 755882"/>
                <a:gd name="connsiteX39" fmla="*/ 62900 w 552450"/>
                <a:gd name="connsiteY39" fmla="*/ 74228 h 755882"/>
                <a:gd name="connsiteX40" fmla="*/ 65880 w 552450"/>
                <a:gd name="connsiteY40" fmla="*/ 155072 h 755882"/>
                <a:gd name="connsiteX41" fmla="*/ 81669 w 552450"/>
                <a:gd name="connsiteY41" fmla="*/ 155072 h 755882"/>
                <a:gd name="connsiteX42" fmla="*/ 137678 w 552450"/>
                <a:gd name="connsiteY42" fmla="*/ 81012 h 755882"/>
                <a:gd name="connsiteX43" fmla="*/ 135892 w 552450"/>
                <a:gd name="connsiteY43" fmla="*/ 66253 h 755882"/>
                <a:gd name="connsiteX44" fmla="*/ 62900 w 552450"/>
                <a:gd name="connsiteY44" fmla="*/ 74228 h 755882"/>
                <a:gd name="connsiteX45" fmla="*/ 412065 w 552450"/>
                <a:gd name="connsiteY45" fmla="*/ 66263 h 755882"/>
                <a:gd name="connsiteX46" fmla="*/ 410277 w 552450"/>
                <a:gd name="connsiteY46" fmla="*/ 81012 h 755882"/>
                <a:gd name="connsiteX47" fmla="*/ 466286 w 552450"/>
                <a:gd name="connsiteY47" fmla="*/ 155072 h 755882"/>
                <a:gd name="connsiteX48" fmla="*/ 482077 w 552450"/>
                <a:gd name="connsiteY48" fmla="*/ 155072 h 755882"/>
                <a:gd name="connsiteX49" fmla="*/ 485055 w 552450"/>
                <a:gd name="connsiteY49" fmla="*/ 74228 h 755882"/>
                <a:gd name="connsiteX50" fmla="*/ 412065 w 552450"/>
                <a:gd name="connsiteY50" fmla="*/ 66263 h 755882"/>
                <a:gd name="connsiteX51" fmla="*/ 115633 w 552450"/>
                <a:gd name="connsiteY51" fmla="*/ 78064 h 755882"/>
                <a:gd name="connsiteX52" fmla="*/ 74817 w 552450"/>
                <a:gd name="connsiteY52" fmla="*/ 131762 h 755882"/>
                <a:gd name="connsiteX53" fmla="*/ 77498 w 552450"/>
                <a:gd name="connsiteY53" fmla="*/ 86323 h 755882"/>
                <a:gd name="connsiteX54" fmla="*/ 115633 w 552450"/>
                <a:gd name="connsiteY54" fmla="*/ 78064 h 755882"/>
                <a:gd name="connsiteX55" fmla="*/ 470457 w 552450"/>
                <a:gd name="connsiteY55" fmla="*/ 86323 h 755882"/>
                <a:gd name="connsiteX56" fmla="*/ 472841 w 552450"/>
                <a:gd name="connsiteY56" fmla="*/ 131469 h 755882"/>
                <a:gd name="connsiteX57" fmla="*/ 432324 w 552450"/>
                <a:gd name="connsiteY57" fmla="*/ 78055 h 755882"/>
                <a:gd name="connsiteX58" fmla="*/ 470457 w 552450"/>
                <a:gd name="connsiteY58" fmla="*/ 86323 h 755882"/>
                <a:gd name="connsiteX59" fmla="*/ 209478 w 552450"/>
                <a:gd name="connsiteY59" fmla="*/ 121737 h 755882"/>
                <a:gd name="connsiteX60" fmla="*/ 190411 w 552450"/>
                <a:gd name="connsiteY60" fmla="*/ 150055 h 755882"/>
                <a:gd name="connsiteX61" fmla="*/ 209478 w 552450"/>
                <a:gd name="connsiteY61" fmla="*/ 178382 h 755882"/>
                <a:gd name="connsiteX62" fmla="*/ 228545 w 552450"/>
                <a:gd name="connsiteY62" fmla="*/ 150055 h 755882"/>
                <a:gd name="connsiteX63" fmla="*/ 209478 w 552450"/>
                <a:gd name="connsiteY63" fmla="*/ 121737 h 755882"/>
                <a:gd name="connsiteX64" fmla="*/ 342947 w 552450"/>
                <a:gd name="connsiteY64" fmla="*/ 121737 h 755882"/>
                <a:gd name="connsiteX65" fmla="*/ 323880 w 552450"/>
                <a:gd name="connsiteY65" fmla="*/ 150055 h 755882"/>
                <a:gd name="connsiteX66" fmla="*/ 342947 w 552450"/>
                <a:gd name="connsiteY66" fmla="*/ 178382 h 755882"/>
                <a:gd name="connsiteX67" fmla="*/ 362014 w 552450"/>
                <a:gd name="connsiteY67" fmla="*/ 150055 h 755882"/>
                <a:gd name="connsiteX68" fmla="*/ 342947 w 552450"/>
                <a:gd name="connsiteY68" fmla="*/ 121737 h 755882"/>
                <a:gd name="connsiteX69" fmla="*/ 276212 w 552450"/>
                <a:gd name="connsiteY69" fmla="*/ 188124 h 755882"/>
                <a:gd name="connsiteX70" fmla="*/ 170748 w 552450"/>
                <a:gd name="connsiteY70" fmla="*/ 282253 h 755882"/>
                <a:gd name="connsiteX71" fmla="*/ 276212 w 552450"/>
                <a:gd name="connsiteY71" fmla="*/ 376127 h 755882"/>
                <a:gd name="connsiteX72" fmla="*/ 381378 w 552450"/>
                <a:gd name="connsiteY72" fmla="*/ 282253 h 755882"/>
                <a:gd name="connsiteX73" fmla="*/ 276212 w 552450"/>
                <a:gd name="connsiteY73" fmla="*/ 188124 h 755882"/>
                <a:gd name="connsiteX74" fmla="*/ 276212 w 552450"/>
                <a:gd name="connsiteY74" fmla="*/ 206124 h 755882"/>
                <a:gd name="connsiteX75" fmla="*/ 361418 w 552450"/>
                <a:gd name="connsiteY75" fmla="*/ 282253 h 755882"/>
                <a:gd name="connsiteX76" fmla="*/ 276212 w 552450"/>
                <a:gd name="connsiteY76" fmla="*/ 358080 h 755882"/>
                <a:gd name="connsiteX77" fmla="*/ 190709 w 552450"/>
                <a:gd name="connsiteY77" fmla="*/ 282253 h 755882"/>
                <a:gd name="connsiteX78" fmla="*/ 276212 w 552450"/>
                <a:gd name="connsiteY78" fmla="*/ 206124 h 755882"/>
                <a:gd name="connsiteX79" fmla="*/ 276212 w 552450"/>
                <a:gd name="connsiteY79" fmla="*/ 217330 h 755882"/>
                <a:gd name="connsiteX80" fmla="*/ 227353 w 552450"/>
                <a:gd name="connsiteY80" fmla="*/ 253623 h 755882"/>
                <a:gd name="connsiteX81" fmla="*/ 266679 w 552450"/>
                <a:gd name="connsiteY81" fmla="*/ 289623 h 755882"/>
                <a:gd name="connsiteX82" fmla="*/ 266679 w 552450"/>
                <a:gd name="connsiteY82" fmla="*/ 321494 h 755882"/>
                <a:gd name="connsiteX83" fmla="*/ 224672 w 552450"/>
                <a:gd name="connsiteY83" fmla="*/ 302899 h 755882"/>
                <a:gd name="connsiteX84" fmla="*/ 212339 w 552450"/>
                <a:gd name="connsiteY84" fmla="*/ 304250 h 755882"/>
                <a:gd name="connsiteX85" fmla="*/ 213351 w 552450"/>
                <a:gd name="connsiteY85" fmla="*/ 317950 h 755882"/>
                <a:gd name="connsiteX86" fmla="*/ 276212 w 552450"/>
                <a:gd name="connsiteY86" fmla="*/ 341261 h 755882"/>
                <a:gd name="connsiteX87" fmla="*/ 339074 w 552450"/>
                <a:gd name="connsiteY87" fmla="*/ 317950 h 755882"/>
                <a:gd name="connsiteX88" fmla="*/ 341921 w 552450"/>
                <a:gd name="connsiteY88" fmla="*/ 304146 h 755882"/>
                <a:gd name="connsiteX89" fmla="*/ 327753 w 552450"/>
                <a:gd name="connsiteY89" fmla="*/ 302899 h 755882"/>
                <a:gd name="connsiteX90" fmla="*/ 285745 w 552450"/>
                <a:gd name="connsiteY90" fmla="*/ 321494 h 755882"/>
                <a:gd name="connsiteX91" fmla="*/ 285745 w 552450"/>
                <a:gd name="connsiteY91" fmla="*/ 289623 h 755882"/>
                <a:gd name="connsiteX92" fmla="*/ 325071 w 552450"/>
                <a:gd name="connsiteY92" fmla="*/ 253623 h 755882"/>
                <a:gd name="connsiteX93" fmla="*/ 276212 w 552450"/>
                <a:gd name="connsiteY93" fmla="*/ 217330 h 755882"/>
                <a:gd name="connsiteX94" fmla="*/ 276212 w 552450"/>
                <a:gd name="connsiteY94" fmla="*/ 233856 h 755882"/>
                <a:gd name="connsiteX95" fmla="*/ 303621 w 552450"/>
                <a:gd name="connsiteY95" fmla="*/ 253623 h 755882"/>
                <a:gd name="connsiteX96" fmla="*/ 276212 w 552450"/>
                <a:gd name="connsiteY96" fmla="*/ 273986 h 755882"/>
                <a:gd name="connsiteX97" fmla="*/ 248804 w 552450"/>
                <a:gd name="connsiteY97" fmla="*/ 253623 h 755882"/>
                <a:gd name="connsiteX98" fmla="*/ 276212 w 552450"/>
                <a:gd name="connsiteY98" fmla="*/ 233856 h 755882"/>
                <a:gd name="connsiteX99" fmla="*/ 128145 w 552450"/>
                <a:gd name="connsiteY99" fmla="*/ 368662 h 755882"/>
                <a:gd name="connsiteX100" fmla="*/ 144233 w 552450"/>
                <a:gd name="connsiteY100" fmla="*/ 379623 h 755882"/>
                <a:gd name="connsiteX101" fmla="*/ 92990 w 552450"/>
                <a:gd name="connsiteY101" fmla="*/ 502646 h 755882"/>
                <a:gd name="connsiteX102" fmla="*/ 34002 w 552450"/>
                <a:gd name="connsiteY102" fmla="*/ 582583 h 755882"/>
                <a:gd name="connsiteX103" fmla="*/ 45025 w 552450"/>
                <a:gd name="connsiteY103" fmla="*/ 453134 h 755882"/>
                <a:gd name="connsiteX104" fmla="*/ 128145 w 552450"/>
                <a:gd name="connsiteY104" fmla="*/ 368662 h 755882"/>
                <a:gd name="connsiteX105" fmla="*/ 424280 w 552450"/>
                <a:gd name="connsiteY105" fmla="*/ 368662 h 755882"/>
                <a:gd name="connsiteX106" fmla="*/ 507102 w 552450"/>
                <a:gd name="connsiteY106" fmla="*/ 453134 h 755882"/>
                <a:gd name="connsiteX107" fmla="*/ 517827 w 552450"/>
                <a:gd name="connsiteY107" fmla="*/ 582299 h 755882"/>
                <a:gd name="connsiteX108" fmla="*/ 459137 w 552450"/>
                <a:gd name="connsiteY108" fmla="*/ 502646 h 755882"/>
                <a:gd name="connsiteX109" fmla="*/ 408191 w 552450"/>
                <a:gd name="connsiteY109" fmla="*/ 379623 h 755882"/>
                <a:gd name="connsiteX110" fmla="*/ 424280 w 552450"/>
                <a:gd name="connsiteY110" fmla="*/ 368662 h 755882"/>
                <a:gd name="connsiteX111" fmla="*/ 161215 w 552450"/>
                <a:gd name="connsiteY111" fmla="*/ 389072 h 755882"/>
                <a:gd name="connsiteX112" fmla="*/ 276212 w 552450"/>
                <a:gd name="connsiteY112" fmla="*/ 414395 h 755882"/>
                <a:gd name="connsiteX113" fmla="*/ 391210 w 552450"/>
                <a:gd name="connsiteY113" fmla="*/ 389072 h 755882"/>
                <a:gd name="connsiteX114" fmla="*/ 439473 w 552450"/>
                <a:gd name="connsiteY114" fmla="*/ 493764 h 755882"/>
                <a:gd name="connsiteX115" fmla="*/ 409384 w 552450"/>
                <a:gd name="connsiteY115" fmla="*/ 489134 h 755882"/>
                <a:gd name="connsiteX116" fmla="*/ 295875 w 552450"/>
                <a:gd name="connsiteY116" fmla="*/ 622174 h 755882"/>
                <a:gd name="connsiteX117" fmla="*/ 320007 w 552450"/>
                <a:gd name="connsiteY117" fmla="*/ 703623 h 755882"/>
                <a:gd name="connsiteX118" fmla="*/ 231524 w 552450"/>
                <a:gd name="connsiteY118" fmla="*/ 704189 h 755882"/>
                <a:gd name="connsiteX119" fmla="*/ 256251 w 552450"/>
                <a:gd name="connsiteY119" fmla="*/ 622174 h 755882"/>
                <a:gd name="connsiteX120" fmla="*/ 142446 w 552450"/>
                <a:gd name="connsiteY120" fmla="*/ 489040 h 755882"/>
                <a:gd name="connsiteX121" fmla="*/ 112653 w 552450"/>
                <a:gd name="connsiteY121" fmla="*/ 493764 h 755882"/>
                <a:gd name="connsiteX122" fmla="*/ 161215 w 552450"/>
                <a:gd name="connsiteY122" fmla="*/ 389072 h 755882"/>
                <a:gd name="connsiteX123" fmla="*/ 142446 w 552450"/>
                <a:gd name="connsiteY123" fmla="*/ 509450 h 755882"/>
                <a:gd name="connsiteX124" fmla="*/ 238674 w 552450"/>
                <a:gd name="connsiteY124" fmla="*/ 622174 h 755882"/>
                <a:gd name="connsiteX125" fmla="*/ 142446 w 552450"/>
                <a:gd name="connsiteY125" fmla="*/ 734614 h 755882"/>
                <a:gd name="connsiteX126" fmla="*/ 46515 w 552450"/>
                <a:gd name="connsiteY126" fmla="*/ 622174 h 755882"/>
                <a:gd name="connsiteX127" fmla="*/ 142446 w 552450"/>
                <a:gd name="connsiteY127" fmla="*/ 509450 h 755882"/>
                <a:gd name="connsiteX128" fmla="*/ 409384 w 552450"/>
                <a:gd name="connsiteY128" fmla="*/ 509450 h 755882"/>
                <a:gd name="connsiteX129" fmla="*/ 505612 w 552450"/>
                <a:gd name="connsiteY129" fmla="*/ 622174 h 755882"/>
                <a:gd name="connsiteX130" fmla="*/ 409384 w 552450"/>
                <a:gd name="connsiteY130" fmla="*/ 734614 h 755882"/>
                <a:gd name="connsiteX131" fmla="*/ 313453 w 552450"/>
                <a:gd name="connsiteY131" fmla="*/ 622174 h 755882"/>
                <a:gd name="connsiteX132" fmla="*/ 409384 w 552450"/>
                <a:gd name="connsiteY132" fmla="*/ 509450 h 755882"/>
                <a:gd name="connsiteX133" fmla="*/ 142446 w 552450"/>
                <a:gd name="connsiteY133" fmla="*/ 536568 h 755882"/>
                <a:gd name="connsiteX134" fmla="*/ 67071 w 552450"/>
                <a:gd name="connsiteY134" fmla="*/ 622174 h 755882"/>
                <a:gd name="connsiteX135" fmla="*/ 142446 w 552450"/>
                <a:gd name="connsiteY135" fmla="*/ 707401 h 755882"/>
                <a:gd name="connsiteX136" fmla="*/ 218415 w 552450"/>
                <a:gd name="connsiteY136" fmla="*/ 622174 h 755882"/>
                <a:gd name="connsiteX137" fmla="*/ 142446 w 552450"/>
                <a:gd name="connsiteY137" fmla="*/ 536568 h 755882"/>
                <a:gd name="connsiteX138" fmla="*/ 409384 w 552450"/>
                <a:gd name="connsiteY138" fmla="*/ 536568 h 755882"/>
                <a:gd name="connsiteX139" fmla="*/ 334010 w 552450"/>
                <a:gd name="connsiteY139" fmla="*/ 622174 h 755882"/>
                <a:gd name="connsiteX140" fmla="*/ 409384 w 552450"/>
                <a:gd name="connsiteY140" fmla="*/ 707401 h 755882"/>
                <a:gd name="connsiteX141" fmla="*/ 485353 w 552450"/>
                <a:gd name="connsiteY141" fmla="*/ 622174 h 755882"/>
                <a:gd name="connsiteX142" fmla="*/ 409384 w 552450"/>
                <a:gd name="connsiteY142" fmla="*/ 536568 h 755882"/>
                <a:gd name="connsiteX143" fmla="*/ 142446 w 552450"/>
                <a:gd name="connsiteY143" fmla="*/ 556410 h 755882"/>
                <a:gd name="connsiteX144" fmla="*/ 200541 w 552450"/>
                <a:gd name="connsiteY144" fmla="*/ 622174 h 755882"/>
                <a:gd name="connsiteX145" fmla="*/ 142446 w 552450"/>
                <a:gd name="connsiteY145" fmla="*/ 687654 h 755882"/>
                <a:gd name="connsiteX146" fmla="*/ 84946 w 552450"/>
                <a:gd name="connsiteY146" fmla="*/ 622174 h 755882"/>
                <a:gd name="connsiteX147" fmla="*/ 142446 w 552450"/>
                <a:gd name="connsiteY147" fmla="*/ 556410 h 755882"/>
                <a:gd name="connsiteX148" fmla="*/ 409384 w 552450"/>
                <a:gd name="connsiteY148" fmla="*/ 556410 h 755882"/>
                <a:gd name="connsiteX149" fmla="*/ 467478 w 552450"/>
                <a:gd name="connsiteY149" fmla="*/ 622174 h 755882"/>
                <a:gd name="connsiteX150" fmla="*/ 409384 w 552450"/>
                <a:gd name="connsiteY150" fmla="*/ 687654 h 755882"/>
                <a:gd name="connsiteX151" fmla="*/ 351884 w 552450"/>
                <a:gd name="connsiteY151" fmla="*/ 622174 h 755882"/>
                <a:gd name="connsiteX152" fmla="*/ 409384 w 552450"/>
                <a:gd name="connsiteY152" fmla="*/ 556410 h 75588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</a:cxnLst>
              <a:rect l="l" t="t" r="r" b="b"/>
              <a:pathLst>
                <a:path w="552450" h="755882">
                  <a:moveTo>
                    <a:pt x="426663" y="-124"/>
                  </a:moveTo>
                  <a:cubicBezTo>
                    <a:pt x="400900" y="3561"/>
                    <a:pt x="378816" y="17366"/>
                    <a:pt x="363802" y="36462"/>
                  </a:cubicBezTo>
                  <a:cubicBezTo>
                    <a:pt x="301242" y="10250"/>
                    <a:pt x="246764" y="10099"/>
                    <a:pt x="184155" y="36462"/>
                  </a:cubicBezTo>
                  <a:cubicBezTo>
                    <a:pt x="167353" y="20153"/>
                    <a:pt x="146302" y="6745"/>
                    <a:pt x="121889" y="2238"/>
                  </a:cubicBezTo>
                  <a:cubicBezTo>
                    <a:pt x="95087" y="-2723"/>
                    <a:pt x="65097" y="2956"/>
                    <a:pt x="37279" y="24660"/>
                  </a:cubicBezTo>
                  <a:cubicBezTo>
                    <a:pt x="4886" y="50304"/>
                    <a:pt x="-3525" y="94742"/>
                    <a:pt x="1231" y="127340"/>
                  </a:cubicBezTo>
                  <a:cubicBezTo>
                    <a:pt x="6556" y="159919"/>
                    <a:pt x="25168" y="188738"/>
                    <a:pt x="51877" y="203167"/>
                  </a:cubicBezTo>
                  <a:cubicBezTo>
                    <a:pt x="53140" y="270555"/>
                    <a:pt x="76341" y="320833"/>
                    <a:pt x="111760" y="354867"/>
                  </a:cubicBezTo>
                  <a:cubicBezTo>
                    <a:pt x="76456" y="376505"/>
                    <a:pt x="47268" y="411560"/>
                    <a:pt x="28640" y="443969"/>
                  </a:cubicBezTo>
                  <a:cubicBezTo>
                    <a:pt x="-5075" y="498772"/>
                    <a:pt x="-6142" y="563591"/>
                    <a:pt x="29534" y="609796"/>
                  </a:cubicBezTo>
                  <a:cubicBezTo>
                    <a:pt x="23937" y="689071"/>
                    <a:pt x="72239" y="753795"/>
                    <a:pt x="142447" y="754929"/>
                  </a:cubicBezTo>
                  <a:cubicBezTo>
                    <a:pt x="172167" y="754929"/>
                    <a:pt x="199344" y="741511"/>
                    <a:pt x="219609" y="719496"/>
                  </a:cubicBezTo>
                  <a:cubicBezTo>
                    <a:pt x="254381" y="733859"/>
                    <a:pt x="290921" y="733764"/>
                    <a:pt x="332223" y="719212"/>
                  </a:cubicBezTo>
                  <a:cubicBezTo>
                    <a:pt x="352518" y="741323"/>
                    <a:pt x="379526" y="754929"/>
                    <a:pt x="409385" y="754929"/>
                  </a:cubicBezTo>
                  <a:cubicBezTo>
                    <a:pt x="472447" y="755213"/>
                    <a:pt x="529292" y="698236"/>
                    <a:pt x="522595" y="608567"/>
                  </a:cubicBezTo>
                  <a:cubicBezTo>
                    <a:pt x="561800" y="555371"/>
                    <a:pt x="553402" y="497261"/>
                    <a:pt x="523787" y="443969"/>
                  </a:cubicBezTo>
                  <a:cubicBezTo>
                    <a:pt x="503369" y="408347"/>
                    <a:pt x="476346" y="374237"/>
                    <a:pt x="440667" y="354867"/>
                  </a:cubicBezTo>
                  <a:cubicBezTo>
                    <a:pt x="476085" y="320833"/>
                    <a:pt x="499286" y="270555"/>
                    <a:pt x="500549" y="203176"/>
                  </a:cubicBezTo>
                  <a:cubicBezTo>
                    <a:pt x="527229" y="188729"/>
                    <a:pt x="545576" y="159900"/>
                    <a:pt x="550898" y="127340"/>
                  </a:cubicBezTo>
                  <a:cubicBezTo>
                    <a:pt x="556574" y="92616"/>
                    <a:pt x="547114" y="53195"/>
                    <a:pt x="515445" y="24953"/>
                  </a:cubicBezTo>
                  <a:cubicBezTo>
                    <a:pt x="487869" y="2672"/>
                    <a:pt x="451428" y="-3403"/>
                    <a:pt x="426664" y="-124"/>
                  </a:cubicBezTo>
                  <a:close/>
                  <a:moveTo>
                    <a:pt x="503229" y="39409"/>
                  </a:moveTo>
                  <a:cubicBezTo>
                    <a:pt x="529561" y="63098"/>
                    <a:pt x="536906" y="95148"/>
                    <a:pt x="532128" y="124383"/>
                  </a:cubicBezTo>
                  <a:cubicBezTo>
                    <a:pt x="527329" y="153740"/>
                    <a:pt x="509586" y="179422"/>
                    <a:pt x="487439" y="189296"/>
                  </a:cubicBezTo>
                  <a:cubicBezTo>
                    <a:pt x="484225" y="190845"/>
                    <a:pt x="482052" y="194313"/>
                    <a:pt x="482077" y="197857"/>
                  </a:cubicBezTo>
                  <a:cubicBezTo>
                    <a:pt x="482077" y="270839"/>
                    <a:pt x="455282" y="319189"/>
                    <a:pt x="416534" y="350407"/>
                  </a:cubicBezTo>
                  <a:cubicBezTo>
                    <a:pt x="377787" y="381607"/>
                    <a:pt x="326256" y="395592"/>
                    <a:pt x="276213" y="395592"/>
                  </a:cubicBezTo>
                  <a:cubicBezTo>
                    <a:pt x="226169" y="395592"/>
                    <a:pt x="174341" y="381607"/>
                    <a:pt x="135593" y="350407"/>
                  </a:cubicBezTo>
                  <a:cubicBezTo>
                    <a:pt x="96846" y="319189"/>
                    <a:pt x="70349" y="270839"/>
                    <a:pt x="70349" y="197857"/>
                  </a:cubicBezTo>
                  <a:cubicBezTo>
                    <a:pt x="70320" y="194256"/>
                    <a:pt x="68013" y="190760"/>
                    <a:pt x="64688" y="189296"/>
                  </a:cubicBezTo>
                  <a:cubicBezTo>
                    <a:pt x="42542" y="179422"/>
                    <a:pt x="24799" y="153740"/>
                    <a:pt x="20000" y="124383"/>
                  </a:cubicBezTo>
                  <a:cubicBezTo>
                    <a:pt x="15201" y="95035"/>
                    <a:pt x="22896" y="62833"/>
                    <a:pt x="49494" y="39107"/>
                  </a:cubicBezTo>
                  <a:cubicBezTo>
                    <a:pt x="73260" y="20805"/>
                    <a:pt x="96622" y="16808"/>
                    <a:pt x="118314" y="20814"/>
                  </a:cubicBezTo>
                  <a:cubicBezTo>
                    <a:pt x="140190" y="24858"/>
                    <a:pt x="160518" y="37520"/>
                    <a:pt x="175516" y="53573"/>
                  </a:cubicBezTo>
                  <a:cubicBezTo>
                    <a:pt x="178182" y="56550"/>
                    <a:pt x="182865" y="57551"/>
                    <a:pt x="186538" y="55926"/>
                  </a:cubicBezTo>
                  <a:cubicBezTo>
                    <a:pt x="250352" y="27655"/>
                    <a:pt x="298200" y="27655"/>
                    <a:pt x="362014" y="55926"/>
                  </a:cubicBezTo>
                  <a:cubicBezTo>
                    <a:pt x="366205" y="57910"/>
                    <a:pt x="371780" y="56295"/>
                    <a:pt x="374229" y="52392"/>
                  </a:cubicBezTo>
                  <a:cubicBezTo>
                    <a:pt x="385517" y="34770"/>
                    <a:pt x="405836" y="22194"/>
                    <a:pt x="429344" y="18754"/>
                  </a:cubicBezTo>
                  <a:cubicBezTo>
                    <a:pt x="455178" y="14965"/>
                    <a:pt x="486226" y="23724"/>
                    <a:pt x="503229" y="39409"/>
                  </a:cubicBezTo>
                  <a:close/>
                  <a:moveTo>
                    <a:pt x="62900" y="74228"/>
                  </a:moveTo>
                  <a:cubicBezTo>
                    <a:pt x="46734" y="93145"/>
                    <a:pt x="45117" y="124232"/>
                    <a:pt x="65880" y="155072"/>
                  </a:cubicBezTo>
                  <a:cubicBezTo>
                    <a:pt x="69357" y="160156"/>
                    <a:pt x="78193" y="160156"/>
                    <a:pt x="81669" y="155072"/>
                  </a:cubicBezTo>
                  <a:cubicBezTo>
                    <a:pt x="100652" y="126093"/>
                    <a:pt x="119643" y="98871"/>
                    <a:pt x="137678" y="81012"/>
                  </a:cubicBezTo>
                  <a:cubicBezTo>
                    <a:pt x="141752" y="76988"/>
                    <a:pt x="140811" y="69220"/>
                    <a:pt x="135892" y="66253"/>
                  </a:cubicBezTo>
                  <a:cubicBezTo>
                    <a:pt x="111386" y="53422"/>
                    <a:pt x="81923" y="52609"/>
                    <a:pt x="62900" y="74228"/>
                  </a:cubicBezTo>
                  <a:close/>
                  <a:moveTo>
                    <a:pt x="412065" y="66263"/>
                  </a:moveTo>
                  <a:cubicBezTo>
                    <a:pt x="407144" y="69220"/>
                    <a:pt x="406203" y="76988"/>
                    <a:pt x="410277" y="81012"/>
                  </a:cubicBezTo>
                  <a:cubicBezTo>
                    <a:pt x="428314" y="98880"/>
                    <a:pt x="447304" y="126102"/>
                    <a:pt x="466286" y="155072"/>
                  </a:cubicBezTo>
                  <a:cubicBezTo>
                    <a:pt x="469764" y="160156"/>
                    <a:pt x="478600" y="160156"/>
                    <a:pt x="482077" y="155072"/>
                  </a:cubicBezTo>
                  <a:cubicBezTo>
                    <a:pt x="502838" y="124232"/>
                    <a:pt x="501222" y="93145"/>
                    <a:pt x="485055" y="74228"/>
                  </a:cubicBezTo>
                  <a:cubicBezTo>
                    <a:pt x="463008" y="53998"/>
                    <a:pt x="436737" y="51901"/>
                    <a:pt x="412065" y="66263"/>
                  </a:cubicBezTo>
                  <a:close/>
                  <a:moveTo>
                    <a:pt x="115633" y="78064"/>
                  </a:moveTo>
                  <a:cubicBezTo>
                    <a:pt x="101764" y="93504"/>
                    <a:pt x="88220" y="111740"/>
                    <a:pt x="74817" y="131762"/>
                  </a:cubicBezTo>
                  <a:cubicBezTo>
                    <a:pt x="66169" y="112137"/>
                    <a:pt x="69236" y="95998"/>
                    <a:pt x="77498" y="86323"/>
                  </a:cubicBezTo>
                  <a:cubicBezTo>
                    <a:pt x="91014" y="73992"/>
                    <a:pt x="100145" y="73926"/>
                    <a:pt x="115633" y="78064"/>
                  </a:cubicBezTo>
                  <a:close/>
                  <a:moveTo>
                    <a:pt x="470457" y="86323"/>
                  </a:moveTo>
                  <a:cubicBezTo>
                    <a:pt x="478692" y="95961"/>
                    <a:pt x="481378" y="111929"/>
                    <a:pt x="472841" y="131469"/>
                  </a:cubicBezTo>
                  <a:cubicBezTo>
                    <a:pt x="459517" y="111570"/>
                    <a:pt x="446108" y="93419"/>
                    <a:pt x="432324" y="78055"/>
                  </a:cubicBezTo>
                  <a:cubicBezTo>
                    <a:pt x="447486" y="72518"/>
                    <a:pt x="458594" y="76515"/>
                    <a:pt x="470457" y="86323"/>
                  </a:cubicBezTo>
                  <a:close/>
                  <a:moveTo>
                    <a:pt x="209478" y="121737"/>
                  </a:moveTo>
                  <a:cubicBezTo>
                    <a:pt x="198947" y="121737"/>
                    <a:pt x="190411" y="134417"/>
                    <a:pt x="190411" y="150055"/>
                  </a:cubicBezTo>
                  <a:cubicBezTo>
                    <a:pt x="190411" y="165702"/>
                    <a:pt x="198947" y="178382"/>
                    <a:pt x="209478" y="178382"/>
                  </a:cubicBezTo>
                  <a:cubicBezTo>
                    <a:pt x="220009" y="178382"/>
                    <a:pt x="228545" y="165702"/>
                    <a:pt x="228545" y="150055"/>
                  </a:cubicBezTo>
                  <a:cubicBezTo>
                    <a:pt x="228545" y="134417"/>
                    <a:pt x="220009" y="121737"/>
                    <a:pt x="209478" y="121737"/>
                  </a:cubicBezTo>
                  <a:close/>
                  <a:moveTo>
                    <a:pt x="342947" y="121737"/>
                  </a:moveTo>
                  <a:cubicBezTo>
                    <a:pt x="332416" y="121737"/>
                    <a:pt x="323880" y="134417"/>
                    <a:pt x="323880" y="150055"/>
                  </a:cubicBezTo>
                  <a:cubicBezTo>
                    <a:pt x="323880" y="165702"/>
                    <a:pt x="332416" y="178382"/>
                    <a:pt x="342947" y="178382"/>
                  </a:cubicBezTo>
                  <a:cubicBezTo>
                    <a:pt x="353477" y="178382"/>
                    <a:pt x="362014" y="165702"/>
                    <a:pt x="362014" y="150055"/>
                  </a:cubicBezTo>
                  <a:cubicBezTo>
                    <a:pt x="362014" y="134417"/>
                    <a:pt x="353477" y="121737"/>
                    <a:pt x="342947" y="121737"/>
                  </a:cubicBezTo>
                  <a:close/>
                  <a:moveTo>
                    <a:pt x="276212" y="188124"/>
                  </a:moveTo>
                  <a:cubicBezTo>
                    <a:pt x="218129" y="188124"/>
                    <a:pt x="170748" y="230473"/>
                    <a:pt x="170748" y="282253"/>
                  </a:cubicBezTo>
                  <a:cubicBezTo>
                    <a:pt x="170748" y="334023"/>
                    <a:pt x="218129" y="376127"/>
                    <a:pt x="276212" y="376127"/>
                  </a:cubicBezTo>
                  <a:cubicBezTo>
                    <a:pt x="334295" y="376127"/>
                    <a:pt x="381378" y="334023"/>
                    <a:pt x="381378" y="282253"/>
                  </a:cubicBezTo>
                  <a:cubicBezTo>
                    <a:pt x="381378" y="230473"/>
                    <a:pt x="334295" y="188124"/>
                    <a:pt x="276212" y="188124"/>
                  </a:cubicBezTo>
                  <a:close/>
                  <a:moveTo>
                    <a:pt x="276212" y="206124"/>
                  </a:moveTo>
                  <a:cubicBezTo>
                    <a:pt x="323433" y="206124"/>
                    <a:pt x="361418" y="240159"/>
                    <a:pt x="361418" y="282253"/>
                  </a:cubicBezTo>
                  <a:cubicBezTo>
                    <a:pt x="361418" y="324338"/>
                    <a:pt x="323433" y="358080"/>
                    <a:pt x="276212" y="358080"/>
                  </a:cubicBezTo>
                  <a:cubicBezTo>
                    <a:pt x="228991" y="358080"/>
                    <a:pt x="190709" y="324338"/>
                    <a:pt x="190709" y="282253"/>
                  </a:cubicBezTo>
                  <a:cubicBezTo>
                    <a:pt x="190709" y="240159"/>
                    <a:pt x="228991" y="206124"/>
                    <a:pt x="276212" y="206124"/>
                  </a:cubicBezTo>
                  <a:close/>
                  <a:moveTo>
                    <a:pt x="276212" y="217330"/>
                  </a:moveTo>
                  <a:cubicBezTo>
                    <a:pt x="249202" y="217330"/>
                    <a:pt x="227353" y="233563"/>
                    <a:pt x="227353" y="253623"/>
                  </a:cubicBezTo>
                  <a:cubicBezTo>
                    <a:pt x="227353" y="271255"/>
                    <a:pt x="244258" y="286241"/>
                    <a:pt x="266679" y="289623"/>
                  </a:cubicBezTo>
                  <a:lnTo>
                    <a:pt x="266679" y="321494"/>
                  </a:lnTo>
                  <a:cubicBezTo>
                    <a:pt x="253063" y="319547"/>
                    <a:pt x="239113" y="313633"/>
                    <a:pt x="224672" y="302899"/>
                  </a:cubicBezTo>
                  <a:cubicBezTo>
                    <a:pt x="219205" y="299507"/>
                    <a:pt x="215017" y="301803"/>
                    <a:pt x="212339" y="304250"/>
                  </a:cubicBezTo>
                  <a:cubicBezTo>
                    <a:pt x="209285" y="308303"/>
                    <a:pt x="209025" y="314889"/>
                    <a:pt x="213351" y="317950"/>
                  </a:cubicBezTo>
                  <a:cubicBezTo>
                    <a:pt x="233638" y="333022"/>
                    <a:pt x="254762" y="341261"/>
                    <a:pt x="276212" y="341261"/>
                  </a:cubicBezTo>
                  <a:cubicBezTo>
                    <a:pt x="297663" y="341261"/>
                    <a:pt x="318787" y="333022"/>
                    <a:pt x="339074" y="317950"/>
                  </a:cubicBezTo>
                  <a:cubicBezTo>
                    <a:pt x="343698" y="315286"/>
                    <a:pt x="345119" y="308398"/>
                    <a:pt x="341921" y="304146"/>
                  </a:cubicBezTo>
                  <a:cubicBezTo>
                    <a:pt x="338724" y="299894"/>
                    <a:pt x="331656" y="299280"/>
                    <a:pt x="327753" y="302899"/>
                  </a:cubicBezTo>
                  <a:cubicBezTo>
                    <a:pt x="313312" y="313633"/>
                    <a:pt x="299361" y="319547"/>
                    <a:pt x="285745" y="321494"/>
                  </a:cubicBezTo>
                  <a:lnTo>
                    <a:pt x="285745" y="289623"/>
                  </a:lnTo>
                  <a:cubicBezTo>
                    <a:pt x="308165" y="286241"/>
                    <a:pt x="325071" y="271255"/>
                    <a:pt x="325071" y="253623"/>
                  </a:cubicBezTo>
                  <a:cubicBezTo>
                    <a:pt x="325071" y="233563"/>
                    <a:pt x="303223" y="217330"/>
                    <a:pt x="276212" y="217330"/>
                  </a:cubicBezTo>
                  <a:close/>
                  <a:moveTo>
                    <a:pt x="276212" y="233856"/>
                  </a:moveTo>
                  <a:cubicBezTo>
                    <a:pt x="291324" y="233856"/>
                    <a:pt x="303621" y="242398"/>
                    <a:pt x="303621" y="253623"/>
                  </a:cubicBezTo>
                  <a:cubicBezTo>
                    <a:pt x="303621" y="264858"/>
                    <a:pt x="291324" y="273986"/>
                    <a:pt x="276212" y="273986"/>
                  </a:cubicBezTo>
                  <a:cubicBezTo>
                    <a:pt x="261101" y="273986"/>
                    <a:pt x="248804" y="264858"/>
                    <a:pt x="248804" y="253623"/>
                  </a:cubicBezTo>
                  <a:cubicBezTo>
                    <a:pt x="248804" y="242398"/>
                    <a:pt x="261101" y="233856"/>
                    <a:pt x="276212" y="233856"/>
                  </a:cubicBezTo>
                  <a:close/>
                  <a:moveTo>
                    <a:pt x="128145" y="368662"/>
                  </a:moveTo>
                  <a:cubicBezTo>
                    <a:pt x="133355" y="372631"/>
                    <a:pt x="138699" y="376222"/>
                    <a:pt x="144233" y="379623"/>
                  </a:cubicBezTo>
                  <a:cubicBezTo>
                    <a:pt x="112636" y="416190"/>
                    <a:pt x="94537" y="458710"/>
                    <a:pt x="92990" y="502646"/>
                  </a:cubicBezTo>
                  <a:cubicBezTo>
                    <a:pt x="65110" y="518615"/>
                    <a:pt x="43360" y="547434"/>
                    <a:pt x="34002" y="582583"/>
                  </a:cubicBezTo>
                  <a:cubicBezTo>
                    <a:pt x="12144" y="538835"/>
                    <a:pt x="23912" y="490930"/>
                    <a:pt x="45025" y="453134"/>
                  </a:cubicBezTo>
                  <a:cubicBezTo>
                    <a:pt x="67490" y="420158"/>
                    <a:pt x="90038" y="383969"/>
                    <a:pt x="128145" y="368662"/>
                  </a:cubicBezTo>
                  <a:close/>
                  <a:moveTo>
                    <a:pt x="424280" y="368662"/>
                  </a:moveTo>
                  <a:cubicBezTo>
                    <a:pt x="460629" y="386804"/>
                    <a:pt x="488546" y="420820"/>
                    <a:pt x="507102" y="453134"/>
                  </a:cubicBezTo>
                  <a:cubicBezTo>
                    <a:pt x="529887" y="495182"/>
                    <a:pt x="539979" y="542615"/>
                    <a:pt x="517827" y="582299"/>
                  </a:cubicBezTo>
                  <a:cubicBezTo>
                    <a:pt x="508430" y="547339"/>
                    <a:pt x="486944" y="518615"/>
                    <a:pt x="459137" y="502646"/>
                  </a:cubicBezTo>
                  <a:cubicBezTo>
                    <a:pt x="457592" y="458804"/>
                    <a:pt x="439709" y="416095"/>
                    <a:pt x="408191" y="379623"/>
                  </a:cubicBezTo>
                  <a:cubicBezTo>
                    <a:pt x="413725" y="376222"/>
                    <a:pt x="419070" y="372631"/>
                    <a:pt x="424280" y="368662"/>
                  </a:cubicBezTo>
                  <a:close/>
                  <a:moveTo>
                    <a:pt x="161215" y="389072"/>
                  </a:moveTo>
                  <a:cubicBezTo>
                    <a:pt x="196897" y="406741"/>
                    <a:pt x="237141" y="414395"/>
                    <a:pt x="276212" y="414395"/>
                  </a:cubicBezTo>
                  <a:cubicBezTo>
                    <a:pt x="315282" y="414395"/>
                    <a:pt x="355527" y="406741"/>
                    <a:pt x="391210" y="389072"/>
                  </a:cubicBezTo>
                  <a:cubicBezTo>
                    <a:pt x="419399" y="420631"/>
                    <a:pt x="435905" y="456820"/>
                    <a:pt x="439473" y="493764"/>
                  </a:cubicBezTo>
                  <a:cubicBezTo>
                    <a:pt x="429924" y="490741"/>
                    <a:pt x="419752" y="489134"/>
                    <a:pt x="409384" y="489134"/>
                  </a:cubicBezTo>
                  <a:cubicBezTo>
                    <a:pt x="346726" y="489134"/>
                    <a:pt x="295875" y="548851"/>
                    <a:pt x="295875" y="622174"/>
                  </a:cubicBezTo>
                  <a:cubicBezTo>
                    <a:pt x="295875" y="652976"/>
                    <a:pt x="304947" y="681040"/>
                    <a:pt x="320007" y="703623"/>
                  </a:cubicBezTo>
                  <a:cubicBezTo>
                    <a:pt x="286478" y="714488"/>
                    <a:pt x="258945" y="714583"/>
                    <a:pt x="231524" y="704189"/>
                  </a:cubicBezTo>
                  <a:cubicBezTo>
                    <a:pt x="246803" y="681512"/>
                    <a:pt x="256251" y="653165"/>
                    <a:pt x="256251" y="622174"/>
                  </a:cubicBezTo>
                  <a:cubicBezTo>
                    <a:pt x="256251" y="548851"/>
                    <a:pt x="205102" y="489040"/>
                    <a:pt x="142446" y="489040"/>
                  </a:cubicBezTo>
                  <a:cubicBezTo>
                    <a:pt x="132077" y="489040"/>
                    <a:pt x="122202" y="490741"/>
                    <a:pt x="112653" y="493764"/>
                  </a:cubicBezTo>
                  <a:cubicBezTo>
                    <a:pt x="121027" y="452757"/>
                    <a:pt x="138690" y="414772"/>
                    <a:pt x="161215" y="389072"/>
                  </a:cubicBezTo>
                  <a:close/>
                  <a:moveTo>
                    <a:pt x="142446" y="509450"/>
                  </a:moveTo>
                  <a:cubicBezTo>
                    <a:pt x="195623" y="509450"/>
                    <a:pt x="238674" y="559906"/>
                    <a:pt x="238674" y="622174"/>
                  </a:cubicBezTo>
                  <a:cubicBezTo>
                    <a:pt x="238674" y="684442"/>
                    <a:pt x="195623" y="734614"/>
                    <a:pt x="142446" y="734614"/>
                  </a:cubicBezTo>
                  <a:cubicBezTo>
                    <a:pt x="89268" y="734614"/>
                    <a:pt x="46515" y="684442"/>
                    <a:pt x="46515" y="622174"/>
                  </a:cubicBezTo>
                  <a:cubicBezTo>
                    <a:pt x="46515" y="559906"/>
                    <a:pt x="89268" y="509450"/>
                    <a:pt x="142446" y="509450"/>
                  </a:cubicBezTo>
                  <a:close/>
                  <a:moveTo>
                    <a:pt x="409384" y="509450"/>
                  </a:moveTo>
                  <a:cubicBezTo>
                    <a:pt x="462561" y="509450"/>
                    <a:pt x="505612" y="559906"/>
                    <a:pt x="505612" y="622174"/>
                  </a:cubicBezTo>
                  <a:cubicBezTo>
                    <a:pt x="505612" y="684442"/>
                    <a:pt x="462561" y="734614"/>
                    <a:pt x="409384" y="734614"/>
                  </a:cubicBezTo>
                  <a:cubicBezTo>
                    <a:pt x="356206" y="734614"/>
                    <a:pt x="313453" y="684442"/>
                    <a:pt x="313453" y="622174"/>
                  </a:cubicBezTo>
                  <a:cubicBezTo>
                    <a:pt x="313453" y="559906"/>
                    <a:pt x="356206" y="509450"/>
                    <a:pt x="409384" y="509450"/>
                  </a:cubicBezTo>
                  <a:close/>
                  <a:moveTo>
                    <a:pt x="142446" y="536568"/>
                  </a:moveTo>
                  <a:cubicBezTo>
                    <a:pt x="100770" y="536568"/>
                    <a:pt x="67071" y="575024"/>
                    <a:pt x="67071" y="622174"/>
                  </a:cubicBezTo>
                  <a:cubicBezTo>
                    <a:pt x="67071" y="669324"/>
                    <a:pt x="100770" y="707401"/>
                    <a:pt x="142446" y="707401"/>
                  </a:cubicBezTo>
                  <a:cubicBezTo>
                    <a:pt x="184121" y="707401"/>
                    <a:pt x="218415" y="669324"/>
                    <a:pt x="218415" y="622174"/>
                  </a:cubicBezTo>
                  <a:cubicBezTo>
                    <a:pt x="218415" y="575024"/>
                    <a:pt x="184121" y="536568"/>
                    <a:pt x="142446" y="536568"/>
                  </a:cubicBezTo>
                  <a:close/>
                  <a:moveTo>
                    <a:pt x="409384" y="536568"/>
                  </a:moveTo>
                  <a:cubicBezTo>
                    <a:pt x="367708" y="536568"/>
                    <a:pt x="334010" y="575024"/>
                    <a:pt x="334010" y="622174"/>
                  </a:cubicBezTo>
                  <a:cubicBezTo>
                    <a:pt x="334010" y="669324"/>
                    <a:pt x="367708" y="707401"/>
                    <a:pt x="409384" y="707401"/>
                  </a:cubicBezTo>
                  <a:cubicBezTo>
                    <a:pt x="451059" y="707401"/>
                    <a:pt x="485353" y="669324"/>
                    <a:pt x="485353" y="622174"/>
                  </a:cubicBezTo>
                  <a:cubicBezTo>
                    <a:pt x="485353" y="575024"/>
                    <a:pt x="451059" y="536568"/>
                    <a:pt x="409384" y="536568"/>
                  </a:cubicBezTo>
                  <a:close/>
                  <a:moveTo>
                    <a:pt x="142446" y="556410"/>
                  </a:moveTo>
                  <a:cubicBezTo>
                    <a:pt x="174482" y="556410"/>
                    <a:pt x="200541" y="585890"/>
                    <a:pt x="200541" y="622174"/>
                  </a:cubicBezTo>
                  <a:cubicBezTo>
                    <a:pt x="200541" y="658457"/>
                    <a:pt x="174482" y="687654"/>
                    <a:pt x="142446" y="687654"/>
                  </a:cubicBezTo>
                  <a:cubicBezTo>
                    <a:pt x="110408" y="687654"/>
                    <a:pt x="84946" y="658457"/>
                    <a:pt x="84946" y="622174"/>
                  </a:cubicBezTo>
                  <a:cubicBezTo>
                    <a:pt x="84946" y="585890"/>
                    <a:pt x="110408" y="556410"/>
                    <a:pt x="142446" y="556410"/>
                  </a:cubicBezTo>
                  <a:close/>
                  <a:moveTo>
                    <a:pt x="409384" y="556410"/>
                  </a:moveTo>
                  <a:cubicBezTo>
                    <a:pt x="441420" y="556410"/>
                    <a:pt x="467478" y="585890"/>
                    <a:pt x="467478" y="622174"/>
                  </a:cubicBezTo>
                  <a:cubicBezTo>
                    <a:pt x="467478" y="658457"/>
                    <a:pt x="441420" y="687654"/>
                    <a:pt x="409384" y="687654"/>
                  </a:cubicBezTo>
                  <a:cubicBezTo>
                    <a:pt x="377346" y="687654"/>
                    <a:pt x="351884" y="658457"/>
                    <a:pt x="351884" y="622174"/>
                  </a:cubicBezTo>
                  <a:cubicBezTo>
                    <a:pt x="351884" y="585890"/>
                    <a:pt x="377346" y="556410"/>
                    <a:pt x="409384" y="556410"/>
                  </a:cubicBezTo>
                  <a:close/>
                </a:path>
              </a:pathLst>
            </a:custGeom>
            <a:solidFill>
              <a:srgbClr val="000000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</p:grpSp>
      <p:grpSp>
        <p:nvGrpSpPr>
          <p:cNvPr id="10" name="Gruppe 9">
            <a:extLst>
              <a:ext uri="{FF2B5EF4-FFF2-40B4-BE49-F238E27FC236}">
                <a16:creationId xmlns:a16="http://schemas.microsoft.com/office/drawing/2014/main" id="{BB238B42-2756-8E4A-8347-3BB218DCFE75}"/>
              </a:ext>
            </a:extLst>
          </p:cNvPr>
          <p:cNvGrpSpPr/>
          <p:nvPr userDrawn="1"/>
        </p:nvGrpSpPr>
        <p:grpSpPr>
          <a:xfrm>
            <a:off x="8216223" y="3554585"/>
            <a:ext cx="2920090" cy="2977244"/>
            <a:chOff x="7944353" y="3554585"/>
            <a:chExt cx="2920090" cy="2977244"/>
          </a:xfrm>
        </p:grpSpPr>
        <p:sp>
          <p:nvSpPr>
            <p:cNvPr id="11" name="Ellipse 10">
              <a:extLst>
                <a:ext uri="{FF2B5EF4-FFF2-40B4-BE49-F238E27FC236}">
                  <a16:creationId xmlns:a16="http://schemas.microsoft.com/office/drawing/2014/main" id="{1888971C-58FC-7A4A-AAC7-9FB3775AAA09}"/>
                </a:ext>
              </a:extLst>
            </p:cNvPr>
            <p:cNvSpPr/>
            <p:nvPr/>
          </p:nvSpPr>
          <p:spPr>
            <a:xfrm>
              <a:off x="7944353" y="3554585"/>
              <a:ext cx="2920090" cy="2977244"/>
            </a:xfrm>
            <a:prstGeom prst="ellipse">
              <a:avLst/>
            </a:prstGeom>
            <a:solidFill>
              <a:srgbClr val="E3DCD8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1152000" rIns="0" bIns="0" rtlCol="0" anchor="t" anchorCtr="0"/>
            <a:lstStyle/>
            <a:p>
              <a:pPr algn="ctr"/>
              <a:r>
                <a:rPr lang="nb-NO" sz="1400" dirty="0">
                  <a:solidFill>
                    <a:schemeClr val="tx1"/>
                  </a:solidFill>
                </a:rPr>
                <a:t>Befolkning for øvrig</a:t>
              </a:r>
              <a:endParaRPr lang="nb-NO" sz="1400" dirty="0">
                <a:solidFill>
                  <a:schemeClr val="tx1"/>
                </a:solidFill>
                <a:cs typeface="Arial"/>
              </a:endParaRPr>
            </a:p>
          </p:txBody>
        </p:sp>
        <p:pic>
          <p:nvPicPr>
            <p:cNvPr id="12" name="Grafikk 11">
              <a:extLst>
                <a:ext uri="{FF2B5EF4-FFF2-40B4-BE49-F238E27FC236}">
                  <a16:creationId xmlns:a16="http://schemas.microsoft.com/office/drawing/2014/main" id="{76C39D26-A347-4243-9556-6F89047E982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tretch>
              <a:fillRect/>
            </a:stretch>
          </p:blipFill>
          <p:spPr>
            <a:xfrm>
              <a:off x="8714695" y="3832247"/>
              <a:ext cx="1379406" cy="1724224"/>
            </a:xfrm>
            <a:prstGeom prst="rect">
              <a:avLst/>
            </a:prstGeom>
          </p:spPr>
        </p:pic>
      </p:grpSp>
      <p:grpSp>
        <p:nvGrpSpPr>
          <p:cNvPr id="13" name="Gruppe 12">
            <a:extLst>
              <a:ext uri="{FF2B5EF4-FFF2-40B4-BE49-F238E27FC236}">
                <a16:creationId xmlns:a16="http://schemas.microsoft.com/office/drawing/2014/main" id="{AD09E664-48A2-424C-849D-35260A936DB2}"/>
              </a:ext>
            </a:extLst>
          </p:cNvPr>
          <p:cNvGrpSpPr/>
          <p:nvPr userDrawn="1"/>
        </p:nvGrpSpPr>
        <p:grpSpPr>
          <a:xfrm>
            <a:off x="5844121" y="1538722"/>
            <a:ext cx="2920090" cy="2977244"/>
            <a:chOff x="5844121" y="1538722"/>
            <a:chExt cx="2920090" cy="2977244"/>
          </a:xfrm>
        </p:grpSpPr>
        <p:sp>
          <p:nvSpPr>
            <p:cNvPr id="14" name="Ellipse 13">
              <a:extLst>
                <a:ext uri="{FF2B5EF4-FFF2-40B4-BE49-F238E27FC236}">
                  <a16:creationId xmlns:a16="http://schemas.microsoft.com/office/drawing/2014/main" id="{3683CE3F-4EEE-1F4C-8EAA-EB1F393D5214}"/>
                </a:ext>
              </a:extLst>
            </p:cNvPr>
            <p:cNvSpPr/>
            <p:nvPr/>
          </p:nvSpPr>
          <p:spPr>
            <a:xfrm>
              <a:off x="5844121" y="1538722"/>
              <a:ext cx="2920090" cy="2977244"/>
            </a:xfrm>
            <a:prstGeom prst="ellipse">
              <a:avLst/>
            </a:prstGeom>
            <a:solidFill>
              <a:srgbClr val="FC816B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1152000" rIns="0" bIns="45720" rtlCol="0" anchor="t" anchorCtr="0"/>
            <a:lstStyle/>
            <a:p>
              <a:pPr algn="ctr"/>
              <a:r>
                <a:rPr lang="nb-NO" sz="1400" dirty="0">
                  <a:solidFill>
                    <a:schemeClr val="tx1"/>
                  </a:solidFill>
                  <a:cs typeface="Arial"/>
                </a:rPr>
                <a:t>Myndigheter</a:t>
              </a:r>
            </a:p>
          </p:txBody>
        </p:sp>
        <p:grpSp>
          <p:nvGrpSpPr>
            <p:cNvPr id="15" name="Gruppe 14">
              <a:extLst>
                <a:ext uri="{FF2B5EF4-FFF2-40B4-BE49-F238E27FC236}">
                  <a16:creationId xmlns:a16="http://schemas.microsoft.com/office/drawing/2014/main" id="{B1A95605-D064-0640-8788-01A6F605424F}"/>
                </a:ext>
              </a:extLst>
            </p:cNvPr>
            <p:cNvGrpSpPr/>
            <p:nvPr/>
          </p:nvGrpSpPr>
          <p:grpSpPr>
            <a:xfrm>
              <a:off x="6922990" y="2163652"/>
              <a:ext cx="762353" cy="755894"/>
              <a:chOff x="5714823" y="2932947"/>
              <a:chExt cx="762353" cy="755894"/>
            </a:xfrm>
          </p:grpSpPr>
          <p:sp>
            <p:nvSpPr>
              <p:cNvPr id="16" name="Friform 15">
                <a:extLst>
                  <a:ext uri="{FF2B5EF4-FFF2-40B4-BE49-F238E27FC236}">
                    <a16:creationId xmlns:a16="http://schemas.microsoft.com/office/drawing/2014/main" id="{F5342B5C-7436-D54A-9A5C-B04A81E058DF}"/>
                  </a:ext>
                </a:extLst>
              </p:cNvPr>
              <p:cNvSpPr/>
              <p:nvPr/>
            </p:nvSpPr>
            <p:spPr>
              <a:xfrm>
                <a:off x="5714823" y="2932947"/>
                <a:ext cx="762353" cy="755894"/>
              </a:xfrm>
              <a:custGeom>
                <a:avLst/>
                <a:gdLst>
                  <a:gd name="connsiteX0" fmla="*/ 756614 w 762353"/>
                  <a:gd name="connsiteY0" fmla="*/ 179167 h 755894"/>
                  <a:gd name="connsiteX1" fmla="*/ 610772 w 762353"/>
                  <a:gd name="connsiteY1" fmla="*/ 116513 h 755894"/>
                  <a:gd name="connsiteX2" fmla="*/ 606986 w 762353"/>
                  <a:gd name="connsiteY2" fmla="*/ 115738 h 755894"/>
                  <a:gd name="connsiteX3" fmla="*/ 390702 w 762353"/>
                  <a:gd name="connsiteY3" fmla="*/ 115738 h 755894"/>
                  <a:gd name="connsiteX4" fmla="*/ 390702 w 762353"/>
                  <a:gd name="connsiteY4" fmla="*/ 76706 h 755894"/>
                  <a:gd name="connsiteX5" fmla="*/ 473139 w 762353"/>
                  <a:gd name="connsiteY5" fmla="*/ 76706 h 755894"/>
                  <a:gd name="connsiteX6" fmla="*/ 482664 w 762353"/>
                  <a:gd name="connsiteY6" fmla="*/ 67258 h 755894"/>
                  <a:gd name="connsiteX7" fmla="*/ 482664 w 762353"/>
                  <a:gd name="connsiteY7" fmla="*/ 16193 h 755894"/>
                  <a:gd name="connsiteX8" fmla="*/ 473139 w 762353"/>
                  <a:gd name="connsiteY8" fmla="*/ 6745 h 755894"/>
                  <a:gd name="connsiteX9" fmla="*/ 390152 w 762353"/>
                  <a:gd name="connsiteY9" fmla="*/ 6745 h 755894"/>
                  <a:gd name="connsiteX10" fmla="*/ 381177 w 762353"/>
                  <a:gd name="connsiteY10" fmla="*/ 0 h 755894"/>
                  <a:gd name="connsiteX11" fmla="*/ 371652 w 762353"/>
                  <a:gd name="connsiteY11" fmla="*/ 9449 h 755894"/>
                  <a:gd name="connsiteX12" fmla="*/ 371652 w 762353"/>
                  <a:gd name="connsiteY12" fmla="*/ 115738 h 755894"/>
                  <a:gd name="connsiteX13" fmla="*/ 155368 w 762353"/>
                  <a:gd name="connsiteY13" fmla="*/ 115738 h 755894"/>
                  <a:gd name="connsiteX14" fmla="*/ 151581 w 762353"/>
                  <a:gd name="connsiteY14" fmla="*/ 116513 h 755894"/>
                  <a:gd name="connsiteX15" fmla="*/ 5744 w 762353"/>
                  <a:gd name="connsiteY15" fmla="*/ 179167 h 755894"/>
                  <a:gd name="connsiteX16" fmla="*/ 5 w 762353"/>
                  <a:gd name="connsiteY16" fmla="*/ 187841 h 755894"/>
                  <a:gd name="connsiteX17" fmla="*/ 5 w 762353"/>
                  <a:gd name="connsiteY17" fmla="*/ 245743 h 755894"/>
                  <a:gd name="connsiteX18" fmla="*/ 9529 w 762353"/>
                  <a:gd name="connsiteY18" fmla="*/ 255191 h 755894"/>
                  <a:gd name="connsiteX19" fmla="*/ 25398 w 762353"/>
                  <a:gd name="connsiteY19" fmla="*/ 255191 h 755894"/>
                  <a:gd name="connsiteX20" fmla="*/ 25398 w 762353"/>
                  <a:gd name="connsiteY20" fmla="*/ 683710 h 755894"/>
                  <a:gd name="connsiteX21" fmla="*/ 9525 w 762353"/>
                  <a:gd name="connsiteY21" fmla="*/ 683710 h 755894"/>
                  <a:gd name="connsiteX22" fmla="*/ 0 w 762353"/>
                  <a:gd name="connsiteY22" fmla="*/ 693158 h 755894"/>
                  <a:gd name="connsiteX23" fmla="*/ 0 w 762353"/>
                  <a:gd name="connsiteY23" fmla="*/ 746446 h 755894"/>
                  <a:gd name="connsiteX24" fmla="*/ 9525 w 762353"/>
                  <a:gd name="connsiteY24" fmla="*/ 755895 h 755894"/>
                  <a:gd name="connsiteX25" fmla="*/ 752829 w 762353"/>
                  <a:gd name="connsiteY25" fmla="*/ 755895 h 755894"/>
                  <a:gd name="connsiteX26" fmla="*/ 762354 w 762353"/>
                  <a:gd name="connsiteY26" fmla="*/ 746446 h 755894"/>
                  <a:gd name="connsiteX27" fmla="*/ 762354 w 762353"/>
                  <a:gd name="connsiteY27" fmla="*/ 693158 h 755894"/>
                  <a:gd name="connsiteX28" fmla="*/ 752829 w 762353"/>
                  <a:gd name="connsiteY28" fmla="*/ 683710 h 755894"/>
                  <a:gd name="connsiteX29" fmla="*/ 740034 w 762353"/>
                  <a:gd name="connsiteY29" fmla="*/ 683710 h 755894"/>
                  <a:gd name="connsiteX30" fmla="*/ 740034 w 762353"/>
                  <a:gd name="connsiteY30" fmla="*/ 255191 h 755894"/>
                  <a:gd name="connsiteX31" fmla="*/ 752829 w 762353"/>
                  <a:gd name="connsiteY31" fmla="*/ 255191 h 755894"/>
                  <a:gd name="connsiteX32" fmla="*/ 762354 w 762353"/>
                  <a:gd name="connsiteY32" fmla="*/ 245743 h 755894"/>
                  <a:gd name="connsiteX33" fmla="*/ 762354 w 762353"/>
                  <a:gd name="connsiteY33" fmla="*/ 187841 h 755894"/>
                  <a:gd name="connsiteX34" fmla="*/ 756614 w 762353"/>
                  <a:gd name="connsiteY34" fmla="*/ 179167 h 755894"/>
                  <a:gd name="connsiteX35" fmla="*/ 463614 w 762353"/>
                  <a:gd name="connsiteY35" fmla="*/ 57809 h 755894"/>
                  <a:gd name="connsiteX36" fmla="*/ 390702 w 762353"/>
                  <a:gd name="connsiteY36" fmla="*/ 57809 h 755894"/>
                  <a:gd name="connsiteX37" fmla="*/ 390702 w 762353"/>
                  <a:gd name="connsiteY37" fmla="*/ 25642 h 755894"/>
                  <a:gd name="connsiteX38" fmla="*/ 463614 w 762353"/>
                  <a:gd name="connsiteY38" fmla="*/ 25642 h 755894"/>
                  <a:gd name="connsiteX39" fmla="*/ 463614 w 762353"/>
                  <a:gd name="connsiteY39" fmla="*/ 57809 h 755894"/>
                  <a:gd name="connsiteX40" fmla="*/ 743304 w 762353"/>
                  <a:gd name="connsiteY40" fmla="*/ 736997 h 755894"/>
                  <a:gd name="connsiteX41" fmla="*/ 19050 w 762353"/>
                  <a:gd name="connsiteY41" fmla="*/ 736997 h 755894"/>
                  <a:gd name="connsiteX42" fmla="*/ 19050 w 762353"/>
                  <a:gd name="connsiteY42" fmla="*/ 702607 h 755894"/>
                  <a:gd name="connsiteX43" fmla="*/ 743304 w 762353"/>
                  <a:gd name="connsiteY43" fmla="*/ 702607 h 755894"/>
                  <a:gd name="connsiteX44" fmla="*/ 743304 w 762353"/>
                  <a:gd name="connsiteY44" fmla="*/ 736997 h 755894"/>
                  <a:gd name="connsiteX45" fmla="*/ 446238 w 762353"/>
                  <a:gd name="connsiteY45" fmla="*/ 683710 h 755894"/>
                  <a:gd name="connsiteX46" fmla="*/ 446238 w 762353"/>
                  <a:gd name="connsiteY46" fmla="*/ 458515 h 755894"/>
                  <a:gd name="connsiteX47" fmla="*/ 538260 w 762353"/>
                  <a:gd name="connsiteY47" fmla="*/ 458515 h 755894"/>
                  <a:gd name="connsiteX48" fmla="*/ 538260 w 762353"/>
                  <a:gd name="connsiteY48" fmla="*/ 683710 h 755894"/>
                  <a:gd name="connsiteX49" fmla="*/ 446238 w 762353"/>
                  <a:gd name="connsiteY49" fmla="*/ 683710 h 755894"/>
                  <a:gd name="connsiteX50" fmla="*/ 427188 w 762353"/>
                  <a:gd name="connsiteY50" fmla="*/ 458515 h 755894"/>
                  <a:gd name="connsiteX51" fmla="*/ 427188 w 762353"/>
                  <a:gd name="connsiteY51" fmla="*/ 683710 h 755894"/>
                  <a:gd name="connsiteX52" fmla="*/ 335165 w 762353"/>
                  <a:gd name="connsiteY52" fmla="*/ 683710 h 755894"/>
                  <a:gd name="connsiteX53" fmla="*/ 335165 w 762353"/>
                  <a:gd name="connsiteY53" fmla="*/ 458515 h 755894"/>
                  <a:gd name="connsiteX54" fmla="*/ 427188 w 762353"/>
                  <a:gd name="connsiteY54" fmla="*/ 458515 h 755894"/>
                  <a:gd name="connsiteX55" fmla="*/ 556199 w 762353"/>
                  <a:gd name="connsiteY55" fmla="*/ 439618 h 755894"/>
                  <a:gd name="connsiteX56" fmla="*/ 206155 w 762353"/>
                  <a:gd name="connsiteY56" fmla="*/ 439618 h 755894"/>
                  <a:gd name="connsiteX57" fmla="*/ 206155 w 762353"/>
                  <a:gd name="connsiteY57" fmla="*/ 398511 h 755894"/>
                  <a:gd name="connsiteX58" fmla="*/ 381177 w 762353"/>
                  <a:gd name="connsiteY58" fmla="*/ 362191 h 755894"/>
                  <a:gd name="connsiteX59" fmla="*/ 556199 w 762353"/>
                  <a:gd name="connsiteY59" fmla="*/ 398511 h 755894"/>
                  <a:gd name="connsiteX60" fmla="*/ 556199 w 762353"/>
                  <a:gd name="connsiteY60" fmla="*/ 439618 h 755894"/>
                  <a:gd name="connsiteX61" fmla="*/ 316115 w 762353"/>
                  <a:gd name="connsiteY61" fmla="*/ 458515 h 755894"/>
                  <a:gd name="connsiteX62" fmla="*/ 316115 w 762353"/>
                  <a:gd name="connsiteY62" fmla="*/ 683710 h 755894"/>
                  <a:gd name="connsiteX63" fmla="*/ 224093 w 762353"/>
                  <a:gd name="connsiteY63" fmla="*/ 683710 h 755894"/>
                  <a:gd name="connsiteX64" fmla="*/ 224093 w 762353"/>
                  <a:gd name="connsiteY64" fmla="*/ 458515 h 755894"/>
                  <a:gd name="connsiteX65" fmla="*/ 316115 w 762353"/>
                  <a:gd name="connsiteY65" fmla="*/ 458515 h 755894"/>
                  <a:gd name="connsiteX66" fmla="*/ 720984 w 762353"/>
                  <a:gd name="connsiteY66" fmla="*/ 683710 h 755894"/>
                  <a:gd name="connsiteX67" fmla="*/ 557310 w 762353"/>
                  <a:gd name="connsiteY67" fmla="*/ 683710 h 755894"/>
                  <a:gd name="connsiteX68" fmla="*/ 557310 w 762353"/>
                  <a:gd name="connsiteY68" fmla="*/ 458515 h 755894"/>
                  <a:gd name="connsiteX69" fmla="*/ 565724 w 762353"/>
                  <a:gd name="connsiteY69" fmla="*/ 458515 h 755894"/>
                  <a:gd name="connsiteX70" fmla="*/ 575249 w 762353"/>
                  <a:gd name="connsiteY70" fmla="*/ 449067 h 755894"/>
                  <a:gd name="connsiteX71" fmla="*/ 575249 w 762353"/>
                  <a:gd name="connsiteY71" fmla="*/ 390834 h 755894"/>
                  <a:gd name="connsiteX72" fmla="*/ 567672 w 762353"/>
                  <a:gd name="connsiteY72" fmla="*/ 381587 h 755894"/>
                  <a:gd name="connsiteX73" fmla="*/ 383126 w 762353"/>
                  <a:gd name="connsiteY73" fmla="*/ 343294 h 755894"/>
                  <a:gd name="connsiteX74" fmla="*/ 379228 w 762353"/>
                  <a:gd name="connsiteY74" fmla="*/ 343294 h 755894"/>
                  <a:gd name="connsiteX75" fmla="*/ 194681 w 762353"/>
                  <a:gd name="connsiteY75" fmla="*/ 381587 h 755894"/>
                  <a:gd name="connsiteX76" fmla="*/ 187105 w 762353"/>
                  <a:gd name="connsiteY76" fmla="*/ 390834 h 755894"/>
                  <a:gd name="connsiteX77" fmla="*/ 187105 w 762353"/>
                  <a:gd name="connsiteY77" fmla="*/ 449067 h 755894"/>
                  <a:gd name="connsiteX78" fmla="*/ 196630 w 762353"/>
                  <a:gd name="connsiteY78" fmla="*/ 458515 h 755894"/>
                  <a:gd name="connsiteX79" fmla="*/ 205043 w 762353"/>
                  <a:gd name="connsiteY79" fmla="*/ 458515 h 755894"/>
                  <a:gd name="connsiteX80" fmla="*/ 205043 w 762353"/>
                  <a:gd name="connsiteY80" fmla="*/ 683710 h 755894"/>
                  <a:gd name="connsiteX81" fmla="*/ 44448 w 762353"/>
                  <a:gd name="connsiteY81" fmla="*/ 683710 h 755894"/>
                  <a:gd name="connsiteX82" fmla="*/ 44448 w 762353"/>
                  <a:gd name="connsiteY82" fmla="*/ 255191 h 755894"/>
                  <a:gd name="connsiteX83" fmla="*/ 720984 w 762353"/>
                  <a:gd name="connsiteY83" fmla="*/ 255191 h 755894"/>
                  <a:gd name="connsiteX84" fmla="*/ 720984 w 762353"/>
                  <a:gd name="connsiteY84" fmla="*/ 683710 h 755894"/>
                  <a:gd name="connsiteX85" fmla="*/ 743304 w 762353"/>
                  <a:gd name="connsiteY85" fmla="*/ 236294 h 755894"/>
                  <a:gd name="connsiteX86" fmla="*/ 19054 w 762353"/>
                  <a:gd name="connsiteY86" fmla="*/ 236294 h 755894"/>
                  <a:gd name="connsiteX87" fmla="*/ 19054 w 762353"/>
                  <a:gd name="connsiteY87" fmla="*/ 194042 h 755894"/>
                  <a:gd name="connsiteX88" fmla="*/ 157339 w 762353"/>
                  <a:gd name="connsiteY88" fmla="*/ 134636 h 755894"/>
                  <a:gd name="connsiteX89" fmla="*/ 605014 w 762353"/>
                  <a:gd name="connsiteY89" fmla="*/ 134636 h 755894"/>
                  <a:gd name="connsiteX90" fmla="*/ 743304 w 762353"/>
                  <a:gd name="connsiteY90" fmla="*/ 194042 h 755894"/>
                  <a:gd name="connsiteX91" fmla="*/ 743304 w 762353"/>
                  <a:gd name="connsiteY91" fmla="*/ 236294 h 75589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</a:cxnLst>
                <a:rect l="l" t="t" r="r" b="b"/>
                <a:pathLst>
                  <a:path w="762353" h="755894">
                    <a:moveTo>
                      <a:pt x="756614" y="179167"/>
                    </a:moveTo>
                    <a:lnTo>
                      <a:pt x="610772" y="116513"/>
                    </a:lnTo>
                    <a:cubicBezTo>
                      <a:pt x="609577" y="116006"/>
                      <a:pt x="608289" y="115738"/>
                      <a:pt x="606986" y="115738"/>
                    </a:cubicBezTo>
                    <a:lnTo>
                      <a:pt x="390702" y="115738"/>
                    </a:lnTo>
                    <a:lnTo>
                      <a:pt x="390702" y="76706"/>
                    </a:lnTo>
                    <a:lnTo>
                      <a:pt x="473139" y="76706"/>
                    </a:lnTo>
                    <a:cubicBezTo>
                      <a:pt x="478398" y="76706"/>
                      <a:pt x="482664" y="72481"/>
                      <a:pt x="482664" y="67258"/>
                    </a:cubicBezTo>
                    <a:lnTo>
                      <a:pt x="482664" y="16193"/>
                    </a:lnTo>
                    <a:cubicBezTo>
                      <a:pt x="482664" y="10971"/>
                      <a:pt x="478398" y="6745"/>
                      <a:pt x="473139" y="6745"/>
                    </a:cubicBezTo>
                    <a:lnTo>
                      <a:pt x="390152" y="6745"/>
                    </a:lnTo>
                    <a:cubicBezTo>
                      <a:pt x="388962" y="2869"/>
                      <a:pt x="385471" y="0"/>
                      <a:pt x="381177" y="0"/>
                    </a:cubicBezTo>
                    <a:cubicBezTo>
                      <a:pt x="375917" y="0"/>
                      <a:pt x="371652" y="4226"/>
                      <a:pt x="371652" y="9449"/>
                    </a:cubicBezTo>
                    <a:lnTo>
                      <a:pt x="371652" y="115738"/>
                    </a:lnTo>
                    <a:lnTo>
                      <a:pt x="155368" y="115738"/>
                    </a:lnTo>
                    <a:cubicBezTo>
                      <a:pt x="154065" y="115738"/>
                      <a:pt x="152777" y="116006"/>
                      <a:pt x="151581" y="116513"/>
                    </a:cubicBezTo>
                    <a:lnTo>
                      <a:pt x="5744" y="179167"/>
                    </a:lnTo>
                    <a:cubicBezTo>
                      <a:pt x="2261" y="180671"/>
                      <a:pt x="5" y="184076"/>
                      <a:pt x="5" y="187841"/>
                    </a:cubicBezTo>
                    <a:lnTo>
                      <a:pt x="5" y="245743"/>
                    </a:lnTo>
                    <a:cubicBezTo>
                      <a:pt x="5" y="250965"/>
                      <a:pt x="4270" y="255191"/>
                      <a:pt x="9529" y="255191"/>
                    </a:cubicBezTo>
                    <a:lnTo>
                      <a:pt x="25398" y="255191"/>
                    </a:lnTo>
                    <a:lnTo>
                      <a:pt x="25398" y="683710"/>
                    </a:lnTo>
                    <a:lnTo>
                      <a:pt x="9525" y="683710"/>
                    </a:lnTo>
                    <a:cubicBezTo>
                      <a:pt x="4265" y="683710"/>
                      <a:pt x="0" y="687935"/>
                      <a:pt x="0" y="693158"/>
                    </a:cubicBezTo>
                    <a:lnTo>
                      <a:pt x="0" y="746446"/>
                    </a:lnTo>
                    <a:cubicBezTo>
                      <a:pt x="0" y="751668"/>
                      <a:pt x="4265" y="755895"/>
                      <a:pt x="9525" y="755895"/>
                    </a:cubicBezTo>
                    <a:lnTo>
                      <a:pt x="752829" y="755895"/>
                    </a:lnTo>
                    <a:cubicBezTo>
                      <a:pt x="758089" y="755895"/>
                      <a:pt x="762354" y="751668"/>
                      <a:pt x="762354" y="746446"/>
                    </a:cubicBezTo>
                    <a:lnTo>
                      <a:pt x="762354" y="693158"/>
                    </a:lnTo>
                    <a:cubicBezTo>
                      <a:pt x="762354" y="687935"/>
                      <a:pt x="758089" y="683710"/>
                      <a:pt x="752829" y="683710"/>
                    </a:cubicBezTo>
                    <a:lnTo>
                      <a:pt x="740034" y="683710"/>
                    </a:lnTo>
                    <a:lnTo>
                      <a:pt x="740034" y="255191"/>
                    </a:lnTo>
                    <a:lnTo>
                      <a:pt x="752829" y="255191"/>
                    </a:lnTo>
                    <a:cubicBezTo>
                      <a:pt x="758089" y="255191"/>
                      <a:pt x="762354" y="250965"/>
                      <a:pt x="762354" y="245743"/>
                    </a:cubicBezTo>
                    <a:lnTo>
                      <a:pt x="762354" y="187841"/>
                    </a:lnTo>
                    <a:cubicBezTo>
                      <a:pt x="762354" y="184076"/>
                      <a:pt x="760097" y="180671"/>
                      <a:pt x="756614" y="179167"/>
                    </a:cubicBezTo>
                    <a:close/>
                    <a:moveTo>
                      <a:pt x="463614" y="57809"/>
                    </a:moveTo>
                    <a:lnTo>
                      <a:pt x="390702" y="57809"/>
                    </a:lnTo>
                    <a:lnTo>
                      <a:pt x="390702" y="25642"/>
                    </a:lnTo>
                    <a:lnTo>
                      <a:pt x="463614" y="25642"/>
                    </a:lnTo>
                    <a:lnTo>
                      <a:pt x="463614" y="57809"/>
                    </a:lnTo>
                    <a:close/>
                    <a:moveTo>
                      <a:pt x="743304" y="736997"/>
                    </a:moveTo>
                    <a:lnTo>
                      <a:pt x="19050" y="736997"/>
                    </a:lnTo>
                    <a:lnTo>
                      <a:pt x="19050" y="702607"/>
                    </a:lnTo>
                    <a:lnTo>
                      <a:pt x="743304" y="702607"/>
                    </a:lnTo>
                    <a:lnTo>
                      <a:pt x="743304" y="736997"/>
                    </a:lnTo>
                    <a:close/>
                    <a:moveTo>
                      <a:pt x="446238" y="683710"/>
                    </a:moveTo>
                    <a:lnTo>
                      <a:pt x="446238" y="458515"/>
                    </a:lnTo>
                    <a:lnTo>
                      <a:pt x="538260" y="458515"/>
                    </a:lnTo>
                    <a:lnTo>
                      <a:pt x="538260" y="683710"/>
                    </a:lnTo>
                    <a:lnTo>
                      <a:pt x="446238" y="683710"/>
                    </a:lnTo>
                    <a:close/>
                    <a:moveTo>
                      <a:pt x="427188" y="458515"/>
                    </a:moveTo>
                    <a:lnTo>
                      <a:pt x="427188" y="683710"/>
                    </a:lnTo>
                    <a:lnTo>
                      <a:pt x="335165" y="683710"/>
                    </a:lnTo>
                    <a:lnTo>
                      <a:pt x="335165" y="458515"/>
                    </a:lnTo>
                    <a:lnTo>
                      <a:pt x="427188" y="458515"/>
                    </a:lnTo>
                    <a:close/>
                    <a:moveTo>
                      <a:pt x="556199" y="439618"/>
                    </a:moveTo>
                    <a:lnTo>
                      <a:pt x="206155" y="439618"/>
                    </a:lnTo>
                    <a:lnTo>
                      <a:pt x="206155" y="398511"/>
                    </a:lnTo>
                    <a:lnTo>
                      <a:pt x="381177" y="362191"/>
                    </a:lnTo>
                    <a:lnTo>
                      <a:pt x="556199" y="398511"/>
                    </a:lnTo>
                    <a:lnTo>
                      <a:pt x="556199" y="439618"/>
                    </a:lnTo>
                    <a:close/>
                    <a:moveTo>
                      <a:pt x="316115" y="458515"/>
                    </a:moveTo>
                    <a:lnTo>
                      <a:pt x="316115" y="683710"/>
                    </a:lnTo>
                    <a:lnTo>
                      <a:pt x="224093" y="683710"/>
                    </a:lnTo>
                    <a:lnTo>
                      <a:pt x="224093" y="458515"/>
                    </a:lnTo>
                    <a:lnTo>
                      <a:pt x="316115" y="458515"/>
                    </a:lnTo>
                    <a:close/>
                    <a:moveTo>
                      <a:pt x="720984" y="683710"/>
                    </a:moveTo>
                    <a:lnTo>
                      <a:pt x="557310" y="683710"/>
                    </a:lnTo>
                    <a:lnTo>
                      <a:pt x="557310" y="458515"/>
                    </a:lnTo>
                    <a:lnTo>
                      <a:pt x="565724" y="458515"/>
                    </a:lnTo>
                    <a:cubicBezTo>
                      <a:pt x="570983" y="458515"/>
                      <a:pt x="575249" y="454290"/>
                      <a:pt x="575249" y="449067"/>
                    </a:cubicBezTo>
                    <a:lnTo>
                      <a:pt x="575249" y="390834"/>
                    </a:lnTo>
                    <a:cubicBezTo>
                      <a:pt x="575249" y="386358"/>
                      <a:pt x="572086" y="382501"/>
                      <a:pt x="567672" y="381587"/>
                    </a:cubicBezTo>
                    <a:lnTo>
                      <a:pt x="383126" y="343294"/>
                    </a:lnTo>
                    <a:cubicBezTo>
                      <a:pt x="381842" y="343017"/>
                      <a:pt x="380512" y="343017"/>
                      <a:pt x="379228" y="343294"/>
                    </a:cubicBezTo>
                    <a:lnTo>
                      <a:pt x="194681" y="381587"/>
                    </a:lnTo>
                    <a:cubicBezTo>
                      <a:pt x="190267" y="382501"/>
                      <a:pt x="187105" y="386358"/>
                      <a:pt x="187105" y="390834"/>
                    </a:cubicBezTo>
                    <a:lnTo>
                      <a:pt x="187105" y="449067"/>
                    </a:lnTo>
                    <a:cubicBezTo>
                      <a:pt x="187105" y="454290"/>
                      <a:pt x="191370" y="458515"/>
                      <a:pt x="196630" y="458515"/>
                    </a:cubicBezTo>
                    <a:lnTo>
                      <a:pt x="205043" y="458515"/>
                    </a:lnTo>
                    <a:lnTo>
                      <a:pt x="205043" y="683710"/>
                    </a:lnTo>
                    <a:lnTo>
                      <a:pt x="44448" y="683710"/>
                    </a:lnTo>
                    <a:lnTo>
                      <a:pt x="44448" y="255191"/>
                    </a:lnTo>
                    <a:lnTo>
                      <a:pt x="720984" y="255191"/>
                    </a:lnTo>
                    <a:lnTo>
                      <a:pt x="720984" y="683710"/>
                    </a:lnTo>
                    <a:close/>
                    <a:moveTo>
                      <a:pt x="743304" y="236294"/>
                    </a:moveTo>
                    <a:lnTo>
                      <a:pt x="19054" y="236294"/>
                    </a:lnTo>
                    <a:lnTo>
                      <a:pt x="19054" y="194042"/>
                    </a:lnTo>
                    <a:lnTo>
                      <a:pt x="157339" y="134636"/>
                    </a:lnTo>
                    <a:lnTo>
                      <a:pt x="605014" y="134636"/>
                    </a:lnTo>
                    <a:lnTo>
                      <a:pt x="743304" y="194042"/>
                    </a:lnTo>
                    <a:lnTo>
                      <a:pt x="743304" y="236294"/>
                    </a:lnTo>
                    <a:close/>
                  </a:path>
                </a:pathLst>
              </a:custGeom>
              <a:solidFill>
                <a:srgbClr val="000000"/>
              </a:solidFill>
              <a:ln w="952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nb-NO"/>
              </a:p>
            </p:txBody>
          </p:sp>
          <p:sp>
            <p:nvSpPr>
              <p:cNvPr id="17" name="Friform 16">
                <a:extLst>
                  <a:ext uri="{FF2B5EF4-FFF2-40B4-BE49-F238E27FC236}">
                    <a16:creationId xmlns:a16="http://schemas.microsoft.com/office/drawing/2014/main" id="{AFFA6D6A-BC24-0645-8765-5B65A31B0B6E}"/>
                  </a:ext>
                </a:extLst>
              </p:cNvPr>
              <p:cNvSpPr/>
              <p:nvPr/>
            </p:nvSpPr>
            <p:spPr>
              <a:xfrm>
                <a:off x="5801041" y="3480534"/>
                <a:ext cx="70111" cy="69555"/>
              </a:xfrm>
              <a:custGeom>
                <a:avLst/>
                <a:gdLst>
                  <a:gd name="connsiteX0" fmla="*/ 9525 w 70111"/>
                  <a:gd name="connsiteY0" fmla="*/ 69555 h 69555"/>
                  <a:gd name="connsiteX1" fmla="*/ 60587 w 70111"/>
                  <a:gd name="connsiteY1" fmla="*/ 69555 h 69555"/>
                  <a:gd name="connsiteX2" fmla="*/ 70112 w 70111"/>
                  <a:gd name="connsiteY2" fmla="*/ 60107 h 69555"/>
                  <a:gd name="connsiteX3" fmla="*/ 70112 w 70111"/>
                  <a:gd name="connsiteY3" fmla="*/ 9449 h 69555"/>
                  <a:gd name="connsiteX4" fmla="*/ 60587 w 70111"/>
                  <a:gd name="connsiteY4" fmla="*/ 0 h 69555"/>
                  <a:gd name="connsiteX5" fmla="*/ 9525 w 70111"/>
                  <a:gd name="connsiteY5" fmla="*/ 0 h 69555"/>
                  <a:gd name="connsiteX6" fmla="*/ 0 w 70111"/>
                  <a:gd name="connsiteY6" fmla="*/ 9449 h 69555"/>
                  <a:gd name="connsiteX7" fmla="*/ 0 w 70111"/>
                  <a:gd name="connsiteY7" fmla="*/ 60107 h 69555"/>
                  <a:gd name="connsiteX8" fmla="*/ 9525 w 70111"/>
                  <a:gd name="connsiteY8" fmla="*/ 69555 h 69555"/>
                  <a:gd name="connsiteX9" fmla="*/ 19050 w 70111"/>
                  <a:gd name="connsiteY9" fmla="*/ 18898 h 69555"/>
                  <a:gd name="connsiteX10" fmla="*/ 51062 w 70111"/>
                  <a:gd name="connsiteY10" fmla="*/ 18898 h 69555"/>
                  <a:gd name="connsiteX11" fmla="*/ 51062 w 70111"/>
                  <a:gd name="connsiteY11" fmla="*/ 50658 h 69555"/>
                  <a:gd name="connsiteX12" fmla="*/ 19050 w 70111"/>
                  <a:gd name="connsiteY12" fmla="*/ 50658 h 69555"/>
                  <a:gd name="connsiteX13" fmla="*/ 19050 w 70111"/>
                  <a:gd name="connsiteY13" fmla="*/ 18898 h 695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</a:cxnLst>
                <a:rect l="l" t="t" r="r" b="b"/>
                <a:pathLst>
                  <a:path w="70111" h="69555">
                    <a:moveTo>
                      <a:pt x="9525" y="69555"/>
                    </a:moveTo>
                    <a:lnTo>
                      <a:pt x="60587" y="69555"/>
                    </a:lnTo>
                    <a:cubicBezTo>
                      <a:pt x="65847" y="69555"/>
                      <a:pt x="70112" y="65330"/>
                      <a:pt x="70112" y="60107"/>
                    </a:cubicBezTo>
                    <a:lnTo>
                      <a:pt x="70112" y="9449"/>
                    </a:lnTo>
                    <a:cubicBezTo>
                      <a:pt x="70112" y="4226"/>
                      <a:pt x="65847" y="0"/>
                      <a:pt x="60587" y="0"/>
                    </a:cubicBezTo>
                    <a:lnTo>
                      <a:pt x="9525" y="0"/>
                    </a:lnTo>
                    <a:cubicBezTo>
                      <a:pt x="4265" y="0"/>
                      <a:pt x="0" y="4226"/>
                      <a:pt x="0" y="9449"/>
                    </a:cubicBezTo>
                    <a:lnTo>
                      <a:pt x="0" y="60107"/>
                    </a:lnTo>
                    <a:cubicBezTo>
                      <a:pt x="0" y="65330"/>
                      <a:pt x="4265" y="69555"/>
                      <a:pt x="9525" y="69555"/>
                    </a:cubicBezTo>
                    <a:close/>
                    <a:moveTo>
                      <a:pt x="19050" y="18898"/>
                    </a:moveTo>
                    <a:lnTo>
                      <a:pt x="51062" y="18898"/>
                    </a:lnTo>
                    <a:lnTo>
                      <a:pt x="51062" y="50658"/>
                    </a:lnTo>
                    <a:lnTo>
                      <a:pt x="19050" y="50658"/>
                    </a:lnTo>
                    <a:lnTo>
                      <a:pt x="19050" y="18898"/>
                    </a:lnTo>
                    <a:close/>
                  </a:path>
                </a:pathLst>
              </a:custGeom>
              <a:solidFill>
                <a:srgbClr val="000000"/>
              </a:solidFill>
              <a:ln w="952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nb-NO"/>
              </a:p>
            </p:txBody>
          </p:sp>
          <p:sp>
            <p:nvSpPr>
              <p:cNvPr id="18" name="Friform 17">
                <a:extLst>
                  <a:ext uri="{FF2B5EF4-FFF2-40B4-BE49-F238E27FC236}">
                    <a16:creationId xmlns:a16="http://schemas.microsoft.com/office/drawing/2014/main" id="{161C6F65-DEDB-B94D-A2B6-9AD3919DB0AB}"/>
                  </a:ext>
                </a:extLst>
              </p:cNvPr>
              <p:cNvSpPr/>
              <p:nvPr/>
            </p:nvSpPr>
            <p:spPr>
              <a:xfrm>
                <a:off x="6319684" y="3480534"/>
                <a:ext cx="70111" cy="69555"/>
              </a:xfrm>
              <a:custGeom>
                <a:avLst/>
                <a:gdLst>
                  <a:gd name="connsiteX0" fmla="*/ 9525 w 70111"/>
                  <a:gd name="connsiteY0" fmla="*/ 69555 h 69555"/>
                  <a:gd name="connsiteX1" fmla="*/ 60587 w 70111"/>
                  <a:gd name="connsiteY1" fmla="*/ 69555 h 69555"/>
                  <a:gd name="connsiteX2" fmla="*/ 70112 w 70111"/>
                  <a:gd name="connsiteY2" fmla="*/ 60107 h 69555"/>
                  <a:gd name="connsiteX3" fmla="*/ 70112 w 70111"/>
                  <a:gd name="connsiteY3" fmla="*/ 9449 h 69555"/>
                  <a:gd name="connsiteX4" fmla="*/ 60587 w 70111"/>
                  <a:gd name="connsiteY4" fmla="*/ 0 h 69555"/>
                  <a:gd name="connsiteX5" fmla="*/ 9525 w 70111"/>
                  <a:gd name="connsiteY5" fmla="*/ 0 h 69555"/>
                  <a:gd name="connsiteX6" fmla="*/ 0 w 70111"/>
                  <a:gd name="connsiteY6" fmla="*/ 9449 h 69555"/>
                  <a:gd name="connsiteX7" fmla="*/ 0 w 70111"/>
                  <a:gd name="connsiteY7" fmla="*/ 60107 h 69555"/>
                  <a:gd name="connsiteX8" fmla="*/ 9525 w 70111"/>
                  <a:gd name="connsiteY8" fmla="*/ 69555 h 69555"/>
                  <a:gd name="connsiteX9" fmla="*/ 19050 w 70111"/>
                  <a:gd name="connsiteY9" fmla="*/ 18898 h 69555"/>
                  <a:gd name="connsiteX10" fmla="*/ 51062 w 70111"/>
                  <a:gd name="connsiteY10" fmla="*/ 18898 h 69555"/>
                  <a:gd name="connsiteX11" fmla="*/ 51062 w 70111"/>
                  <a:gd name="connsiteY11" fmla="*/ 50658 h 69555"/>
                  <a:gd name="connsiteX12" fmla="*/ 19050 w 70111"/>
                  <a:gd name="connsiteY12" fmla="*/ 50658 h 69555"/>
                  <a:gd name="connsiteX13" fmla="*/ 19050 w 70111"/>
                  <a:gd name="connsiteY13" fmla="*/ 18898 h 695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</a:cxnLst>
                <a:rect l="l" t="t" r="r" b="b"/>
                <a:pathLst>
                  <a:path w="70111" h="69555">
                    <a:moveTo>
                      <a:pt x="9525" y="69555"/>
                    </a:moveTo>
                    <a:lnTo>
                      <a:pt x="60587" y="69555"/>
                    </a:lnTo>
                    <a:cubicBezTo>
                      <a:pt x="65847" y="69555"/>
                      <a:pt x="70112" y="65330"/>
                      <a:pt x="70112" y="60107"/>
                    </a:cubicBezTo>
                    <a:lnTo>
                      <a:pt x="70112" y="9449"/>
                    </a:lnTo>
                    <a:cubicBezTo>
                      <a:pt x="70112" y="4226"/>
                      <a:pt x="65847" y="0"/>
                      <a:pt x="60587" y="0"/>
                    </a:cubicBezTo>
                    <a:lnTo>
                      <a:pt x="9525" y="0"/>
                    </a:lnTo>
                    <a:cubicBezTo>
                      <a:pt x="4264" y="0"/>
                      <a:pt x="0" y="4226"/>
                      <a:pt x="0" y="9449"/>
                    </a:cubicBezTo>
                    <a:lnTo>
                      <a:pt x="0" y="60107"/>
                    </a:lnTo>
                    <a:cubicBezTo>
                      <a:pt x="0" y="65330"/>
                      <a:pt x="4264" y="69555"/>
                      <a:pt x="9525" y="69555"/>
                    </a:cubicBezTo>
                    <a:close/>
                    <a:moveTo>
                      <a:pt x="19050" y="18898"/>
                    </a:moveTo>
                    <a:lnTo>
                      <a:pt x="51062" y="18898"/>
                    </a:lnTo>
                    <a:lnTo>
                      <a:pt x="51062" y="50658"/>
                    </a:lnTo>
                    <a:lnTo>
                      <a:pt x="19050" y="50658"/>
                    </a:lnTo>
                    <a:lnTo>
                      <a:pt x="19050" y="18898"/>
                    </a:lnTo>
                    <a:close/>
                  </a:path>
                </a:pathLst>
              </a:custGeom>
              <a:solidFill>
                <a:srgbClr val="000000"/>
              </a:solidFill>
              <a:ln w="952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nb-NO"/>
              </a:p>
            </p:txBody>
          </p:sp>
          <p:sp>
            <p:nvSpPr>
              <p:cNvPr id="19" name="Friform 18">
                <a:extLst>
                  <a:ext uri="{FF2B5EF4-FFF2-40B4-BE49-F238E27FC236}">
                    <a16:creationId xmlns:a16="http://schemas.microsoft.com/office/drawing/2014/main" id="{34795259-4ED0-F844-9820-87E93BFA77D4}"/>
                  </a:ext>
                </a:extLst>
              </p:cNvPr>
              <p:cNvSpPr/>
              <p:nvPr/>
            </p:nvSpPr>
            <p:spPr>
              <a:xfrm>
                <a:off x="5801041" y="3368763"/>
                <a:ext cx="70111" cy="69546"/>
              </a:xfrm>
              <a:custGeom>
                <a:avLst/>
                <a:gdLst>
                  <a:gd name="connsiteX0" fmla="*/ 9525 w 70111"/>
                  <a:gd name="connsiteY0" fmla="*/ 69547 h 69546"/>
                  <a:gd name="connsiteX1" fmla="*/ 60587 w 70111"/>
                  <a:gd name="connsiteY1" fmla="*/ 69547 h 69546"/>
                  <a:gd name="connsiteX2" fmla="*/ 70112 w 70111"/>
                  <a:gd name="connsiteY2" fmla="*/ 60098 h 69546"/>
                  <a:gd name="connsiteX3" fmla="*/ 70112 w 70111"/>
                  <a:gd name="connsiteY3" fmla="*/ 9449 h 69546"/>
                  <a:gd name="connsiteX4" fmla="*/ 60587 w 70111"/>
                  <a:gd name="connsiteY4" fmla="*/ 0 h 69546"/>
                  <a:gd name="connsiteX5" fmla="*/ 9525 w 70111"/>
                  <a:gd name="connsiteY5" fmla="*/ 0 h 69546"/>
                  <a:gd name="connsiteX6" fmla="*/ 0 w 70111"/>
                  <a:gd name="connsiteY6" fmla="*/ 9449 h 69546"/>
                  <a:gd name="connsiteX7" fmla="*/ 0 w 70111"/>
                  <a:gd name="connsiteY7" fmla="*/ 60098 h 69546"/>
                  <a:gd name="connsiteX8" fmla="*/ 9525 w 70111"/>
                  <a:gd name="connsiteY8" fmla="*/ 69547 h 69546"/>
                  <a:gd name="connsiteX9" fmla="*/ 19050 w 70111"/>
                  <a:gd name="connsiteY9" fmla="*/ 18898 h 69546"/>
                  <a:gd name="connsiteX10" fmla="*/ 51062 w 70111"/>
                  <a:gd name="connsiteY10" fmla="*/ 18898 h 69546"/>
                  <a:gd name="connsiteX11" fmla="*/ 51062 w 70111"/>
                  <a:gd name="connsiteY11" fmla="*/ 50649 h 69546"/>
                  <a:gd name="connsiteX12" fmla="*/ 19050 w 70111"/>
                  <a:gd name="connsiteY12" fmla="*/ 50649 h 69546"/>
                  <a:gd name="connsiteX13" fmla="*/ 19050 w 70111"/>
                  <a:gd name="connsiteY13" fmla="*/ 18898 h 695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</a:cxnLst>
                <a:rect l="l" t="t" r="r" b="b"/>
                <a:pathLst>
                  <a:path w="70111" h="69546">
                    <a:moveTo>
                      <a:pt x="9525" y="69547"/>
                    </a:moveTo>
                    <a:lnTo>
                      <a:pt x="60587" y="69547"/>
                    </a:lnTo>
                    <a:cubicBezTo>
                      <a:pt x="65847" y="69547"/>
                      <a:pt x="70112" y="65321"/>
                      <a:pt x="70112" y="60098"/>
                    </a:cubicBezTo>
                    <a:lnTo>
                      <a:pt x="70112" y="9449"/>
                    </a:lnTo>
                    <a:cubicBezTo>
                      <a:pt x="70112" y="4226"/>
                      <a:pt x="65847" y="0"/>
                      <a:pt x="60587" y="0"/>
                    </a:cubicBezTo>
                    <a:lnTo>
                      <a:pt x="9525" y="0"/>
                    </a:lnTo>
                    <a:cubicBezTo>
                      <a:pt x="4265" y="0"/>
                      <a:pt x="0" y="4226"/>
                      <a:pt x="0" y="9449"/>
                    </a:cubicBezTo>
                    <a:lnTo>
                      <a:pt x="0" y="60098"/>
                    </a:lnTo>
                    <a:cubicBezTo>
                      <a:pt x="0" y="65321"/>
                      <a:pt x="4265" y="69547"/>
                      <a:pt x="9525" y="69547"/>
                    </a:cubicBezTo>
                    <a:close/>
                    <a:moveTo>
                      <a:pt x="19050" y="18898"/>
                    </a:moveTo>
                    <a:lnTo>
                      <a:pt x="51062" y="18898"/>
                    </a:lnTo>
                    <a:lnTo>
                      <a:pt x="51062" y="50649"/>
                    </a:lnTo>
                    <a:lnTo>
                      <a:pt x="19050" y="50649"/>
                    </a:lnTo>
                    <a:lnTo>
                      <a:pt x="19050" y="18898"/>
                    </a:lnTo>
                    <a:close/>
                  </a:path>
                </a:pathLst>
              </a:custGeom>
              <a:solidFill>
                <a:srgbClr val="000000"/>
              </a:solidFill>
              <a:ln w="952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nb-NO"/>
              </a:p>
            </p:txBody>
          </p:sp>
          <p:sp>
            <p:nvSpPr>
              <p:cNvPr id="20" name="Friform 19">
                <a:extLst>
                  <a:ext uri="{FF2B5EF4-FFF2-40B4-BE49-F238E27FC236}">
                    <a16:creationId xmlns:a16="http://schemas.microsoft.com/office/drawing/2014/main" id="{6AA91960-D329-A041-AA37-6F72FC0E190C}"/>
                  </a:ext>
                </a:extLst>
              </p:cNvPr>
              <p:cNvSpPr/>
              <p:nvPr/>
            </p:nvSpPr>
            <p:spPr>
              <a:xfrm>
                <a:off x="6319684" y="3368763"/>
                <a:ext cx="70111" cy="69546"/>
              </a:xfrm>
              <a:custGeom>
                <a:avLst/>
                <a:gdLst>
                  <a:gd name="connsiteX0" fmla="*/ 9525 w 70111"/>
                  <a:gd name="connsiteY0" fmla="*/ 69547 h 69546"/>
                  <a:gd name="connsiteX1" fmla="*/ 60587 w 70111"/>
                  <a:gd name="connsiteY1" fmla="*/ 69547 h 69546"/>
                  <a:gd name="connsiteX2" fmla="*/ 70112 w 70111"/>
                  <a:gd name="connsiteY2" fmla="*/ 60098 h 69546"/>
                  <a:gd name="connsiteX3" fmla="*/ 70112 w 70111"/>
                  <a:gd name="connsiteY3" fmla="*/ 9449 h 69546"/>
                  <a:gd name="connsiteX4" fmla="*/ 60587 w 70111"/>
                  <a:gd name="connsiteY4" fmla="*/ 0 h 69546"/>
                  <a:gd name="connsiteX5" fmla="*/ 9525 w 70111"/>
                  <a:gd name="connsiteY5" fmla="*/ 0 h 69546"/>
                  <a:gd name="connsiteX6" fmla="*/ 0 w 70111"/>
                  <a:gd name="connsiteY6" fmla="*/ 9449 h 69546"/>
                  <a:gd name="connsiteX7" fmla="*/ 0 w 70111"/>
                  <a:gd name="connsiteY7" fmla="*/ 60098 h 69546"/>
                  <a:gd name="connsiteX8" fmla="*/ 9525 w 70111"/>
                  <a:gd name="connsiteY8" fmla="*/ 69547 h 69546"/>
                  <a:gd name="connsiteX9" fmla="*/ 19050 w 70111"/>
                  <a:gd name="connsiteY9" fmla="*/ 18898 h 69546"/>
                  <a:gd name="connsiteX10" fmla="*/ 51062 w 70111"/>
                  <a:gd name="connsiteY10" fmla="*/ 18898 h 69546"/>
                  <a:gd name="connsiteX11" fmla="*/ 51062 w 70111"/>
                  <a:gd name="connsiteY11" fmla="*/ 50649 h 69546"/>
                  <a:gd name="connsiteX12" fmla="*/ 19050 w 70111"/>
                  <a:gd name="connsiteY12" fmla="*/ 50649 h 69546"/>
                  <a:gd name="connsiteX13" fmla="*/ 19050 w 70111"/>
                  <a:gd name="connsiteY13" fmla="*/ 18898 h 695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</a:cxnLst>
                <a:rect l="l" t="t" r="r" b="b"/>
                <a:pathLst>
                  <a:path w="70111" h="69546">
                    <a:moveTo>
                      <a:pt x="9525" y="69547"/>
                    </a:moveTo>
                    <a:lnTo>
                      <a:pt x="60587" y="69547"/>
                    </a:lnTo>
                    <a:cubicBezTo>
                      <a:pt x="65847" y="69547"/>
                      <a:pt x="70112" y="65321"/>
                      <a:pt x="70112" y="60098"/>
                    </a:cubicBezTo>
                    <a:lnTo>
                      <a:pt x="70112" y="9449"/>
                    </a:lnTo>
                    <a:cubicBezTo>
                      <a:pt x="70112" y="4226"/>
                      <a:pt x="65847" y="0"/>
                      <a:pt x="60587" y="0"/>
                    </a:cubicBezTo>
                    <a:lnTo>
                      <a:pt x="9525" y="0"/>
                    </a:lnTo>
                    <a:cubicBezTo>
                      <a:pt x="4264" y="0"/>
                      <a:pt x="0" y="4226"/>
                      <a:pt x="0" y="9449"/>
                    </a:cubicBezTo>
                    <a:lnTo>
                      <a:pt x="0" y="60098"/>
                    </a:lnTo>
                    <a:cubicBezTo>
                      <a:pt x="0" y="65321"/>
                      <a:pt x="4264" y="69547"/>
                      <a:pt x="9525" y="69547"/>
                    </a:cubicBezTo>
                    <a:close/>
                    <a:moveTo>
                      <a:pt x="19050" y="18898"/>
                    </a:moveTo>
                    <a:lnTo>
                      <a:pt x="51062" y="18898"/>
                    </a:lnTo>
                    <a:lnTo>
                      <a:pt x="51062" y="50649"/>
                    </a:lnTo>
                    <a:lnTo>
                      <a:pt x="19050" y="50649"/>
                    </a:lnTo>
                    <a:lnTo>
                      <a:pt x="19050" y="18898"/>
                    </a:lnTo>
                    <a:close/>
                  </a:path>
                </a:pathLst>
              </a:custGeom>
              <a:solidFill>
                <a:srgbClr val="000000"/>
              </a:solidFill>
              <a:ln w="952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nb-NO"/>
              </a:p>
            </p:txBody>
          </p:sp>
          <p:sp>
            <p:nvSpPr>
              <p:cNvPr id="21" name="Friform 20">
                <a:extLst>
                  <a:ext uri="{FF2B5EF4-FFF2-40B4-BE49-F238E27FC236}">
                    <a16:creationId xmlns:a16="http://schemas.microsoft.com/office/drawing/2014/main" id="{6ACE10AC-2B85-A24F-A4B3-392EA12C0B69}"/>
                  </a:ext>
                </a:extLst>
              </p:cNvPr>
              <p:cNvSpPr/>
              <p:nvPr/>
            </p:nvSpPr>
            <p:spPr>
              <a:xfrm>
                <a:off x="5801041" y="3256993"/>
                <a:ext cx="70111" cy="69546"/>
              </a:xfrm>
              <a:custGeom>
                <a:avLst/>
                <a:gdLst>
                  <a:gd name="connsiteX0" fmla="*/ 9525 w 70111"/>
                  <a:gd name="connsiteY0" fmla="*/ 69546 h 69546"/>
                  <a:gd name="connsiteX1" fmla="*/ 60587 w 70111"/>
                  <a:gd name="connsiteY1" fmla="*/ 69546 h 69546"/>
                  <a:gd name="connsiteX2" fmla="*/ 70112 w 70111"/>
                  <a:gd name="connsiteY2" fmla="*/ 60097 h 69546"/>
                  <a:gd name="connsiteX3" fmla="*/ 70112 w 70111"/>
                  <a:gd name="connsiteY3" fmla="*/ 9449 h 69546"/>
                  <a:gd name="connsiteX4" fmla="*/ 60587 w 70111"/>
                  <a:gd name="connsiteY4" fmla="*/ 0 h 69546"/>
                  <a:gd name="connsiteX5" fmla="*/ 9525 w 70111"/>
                  <a:gd name="connsiteY5" fmla="*/ 0 h 69546"/>
                  <a:gd name="connsiteX6" fmla="*/ 0 w 70111"/>
                  <a:gd name="connsiteY6" fmla="*/ 9449 h 69546"/>
                  <a:gd name="connsiteX7" fmla="*/ 0 w 70111"/>
                  <a:gd name="connsiteY7" fmla="*/ 60097 h 69546"/>
                  <a:gd name="connsiteX8" fmla="*/ 9525 w 70111"/>
                  <a:gd name="connsiteY8" fmla="*/ 69546 h 69546"/>
                  <a:gd name="connsiteX9" fmla="*/ 19050 w 70111"/>
                  <a:gd name="connsiteY9" fmla="*/ 18898 h 69546"/>
                  <a:gd name="connsiteX10" fmla="*/ 51062 w 70111"/>
                  <a:gd name="connsiteY10" fmla="*/ 18898 h 69546"/>
                  <a:gd name="connsiteX11" fmla="*/ 51062 w 70111"/>
                  <a:gd name="connsiteY11" fmla="*/ 50648 h 69546"/>
                  <a:gd name="connsiteX12" fmla="*/ 19050 w 70111"/>
                  <a:gd name="connsiteY12" fmla="*/ 50648 h 69546"/>
                  <a:gd name="connsiteX13" fmla="*/ 19050 w 70111"/>
                  <a:gd name="connsiteY13" fmla="*/ 18898 h 695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</a:cxnLst>
                <a:rect l="l" t="t" r="r" b="b"/>
                <a:pathLst>
                  <a:path w="70111" h="69546">
                    <a:moveTo>
                      <a:pt x="9525" y="69546"/>
                    </a:moveTo>
                    <a:lnTo>
                      <a:pt x="60587" y="69546"/>
                    </a:lnTo>
                    <a:cubicBezTo>
                      <a:pt x="65847" y="69546"/>
                      <a:pt x="70112" y="65321"/>
                      <a:pt x="70112" y="60097"/>
                    </a:cubicBezTo>
                    <a:lnTo>
                      <a:pt x="70112" y="9449"/>
                    </a:lnTo>
                    <a:cubicBezTo>
                      <a:pt x="70112" y="4226"/>
                      <a:pt x="65847" y="0"/>
                      <a:pt x="60587" y="0"/>
                    </a:cubicBezTo>
                    <a:lnTo>
                      <a:pt x="9525" y="0"/>
                    </a:lnTo>
                    <a:cubicBezTo>
                      <a:pt x="4265" y="0"/>
                      <a:pt x="0" y="4226"/>
                      <a:pt x="0" y="9449"/>
                    </a:cubicBezTo>
                    <a:lnTo>
                      <a:pt x="0" y="60097"/>
                    </a:lnTo>
                    <a:cubicBezTo>
                      <a:pt x="0" y="65321"/>
                      <a:pt x="4265" y="69546"/>
                      <a:pt x="9525" y="69546"/>
                    </a:cubicBezTo>
                    <a:close/>
                    <a:moveTo>
                      <a:pt x="19050" y="18898"/>
                    </a:moveTo>
                    <a:lnTo>
                      <a:pt x="51062" y="18898"/>
                    </a:lnTo>
                    <a:lnTo>
                      <a:pt x="51062" y="50648"/>
                    </a:lnTo>
                    <a:lnTo>
                      <a:pt x="19050" y="50648"/>
                    </a:lnTo>
                    <a:lnTo>
                      <a:pt x="19050" y="18898"/>
                    </a:lnTo>
                    <a:close/>
                  </a:path>
                </a:pathLst>
              </a:custGeom>
              <a:solidFill>
                <a:srgbClr val="000000"/>
              </a:solidFill>
              <a:ln w="952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nb-NO"/>
              </a:p>
            </p:txBody>
          </p:sp>
          <p:sp>
            <p:nvSpPr>
              <p:cNvPr id="22" name="Friform 21">
                <a:extLst>
                  <a:ext uri="{FF2B5EF4-FFF2-40B4-BE49-F238E27FC236}">
                    <a16:creationId xmlns:a16="http://schemas.microsoft.com/office/drawing/2014/main" id="{23C472E9-8F5C-9E48-8DDF-47F0AA169B8F}"/>
                  </a:ext>
                </a:extLst>
              </p:cNvPr>
              <p:cNvSpPr/>
              <p:nvPr/>
            </p:nvSpPr>
            <p:spPr>
              <a:xfrm>
                <a:off x="6319684" y="3256993"/>
                <a:ext cx="70111" cy="69546"/>
              </a:xfrm>
              <a:custGeom>
                <a:avLst/>
                <a:gdLst>
                  <a:gd name="connsiteX0" fmla="*/ 9525 w 70111"/>
                  <a:gd name="connsiteY0" fmla="*/ 69546 h 69546"/>
                  <a:gd name="connsiteX1" fmla="*/ 60587 w 70111"/>
                  <a:gd name="connsiteY1" fmla="*/ 69546 h 69546"/>
                  <a:gd name="connsiteX2" fmla="*/ 70112 w 70111"/>
                  <a:gd name="connsiteY2" fmla="*/ 60097 h 69546"/>
                  <a:gd name="connsiteX3" fmla="*/ 70112 w 70111"/>
                  <a:gd name="connsiteY3" fmla="*/ 9449 h 69546"/>
                  <a:gd name="connsiteX4" fmla="*/ 60587 w 70111"/>
                  <a:gd name="connsiteY4" fmla="*/ 0 h 69546"/>
                  <a:gd name="connsiteX5" fmla="*/ 9525 w 70111"/>
                  <a:gd name="connsiteY5" fmla="*/ 0 h 69546"/>
                  <a:gd name="connsiteX6" fmla="*/ 0 w 70111"/>
                  <a:gd name="connsiteY6" fmla="*/ 9449 h 69546"/>
                  <a:gd name="connsiteX7" fmla="*/ 0 w 70111"/>
                  <a:gd name="connsiteY7" fmla="*/ 60097 h 69546"/>
                  <a:gd name="connsiteX8" fmla="*/ 9525 w 70111"/>
                  <a:gd name="connsiteY8" fmla="*/ 69546 h 69546"/>
                  <a:gd name="connsiteX9" fmla="*/ 19050 w 70111"/>
                  <a:gd name="connsiteY9" fmla="*/ 18898 h 69546"/>
                  <a:gd name="connsiteX10" fmla="*/ 51062 w 70111"/>
                  <a:gd name="connsiteY10" fmla="*/ 18898 h 69546"/>
                  <a:gd name="connsiteX11" fmla="*/ 51062 w 70111"/>
                  <a:gd name="connsiteY11" fmla="*/ 50648 h 69546"/>
                  <a:gd name="connsiteX12" fmla="*/ 19050 w 70111"/>
                  <a:gd name="connsiteY12" fmla="*/ 50648 h 69546"/>
                  <a:gd name="connsiteX13" fmla="*/ 19050 w 70111"/>
                  <a:gd name="connsiteY13" fmla="*/ 18898 h 695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</a:cxnLst>
                <a:rect l="l" t="t" r="r" b="b"/>
                <a:pathLst>
                  <a:path w="70111" h="69546">
                    <a:moveTo>
                      <a:pt x="9525" y="69546"/>
                    </a:moveTo>
                    <a:lnTo>
                      <a:pt x="60587" y="69546"/>
                    </a:lnTo>
                    <a:cubicBezTo>
                      <a:pt x="65847" y="69546"/>
                      <a:pt x="70112" y="65321"/>
                      <a:pt x="70112" y="60097"/>
                    </a:cubicBezTo>
                    <a:lnTo>
                      <a:pt x="70112" y="9449"/>
                    </a:lnTo>
                    <a:cubicBezTo>
                      <a:pt x="70112" y="4226"/>
                      <a:pt x="65847" y="0"/>
                      <a:pt x="60587" y="0"/>
                    </a:cubicBezTo>
                    <a:lnTo>
                      <a:pt x="9525" y="0"/>
                    </a:lnTo>
                    <a:cubicBezTo>
                      <a:pt x="4264" y="0"/>
                      <a:pt x="0" y="4226"/>
                      <a:pt x="0" y="9449"/>
                    </a:cubicBezTo>
                    <a:lnTo>
                      <a:pt x="0" y="60097"/>
                    </a:lnTo>
                    <a:cubicBezTo>
                      <a:pt x="0" y="65321"/>
                      <a:pt x="4264" y="69546"/>
                      <a:pt x="9525" y="69546"/>
                    </a:cubicBezTo>
                    <a:close/>
                    <a:moveTo>
                      <a:pt x="19050" y="18898"/>
                    </a:moveTo>
                    <a:lnTo>
                      <a:pt x="51062" y="18898"/>
                    </a:lnTo>
                    <a:lnTo>
                      <a:pt x="51062" y="50648"/>
                    </a:lnTo>
                    <a:lnTo>
                      <a:pt x="19050" y="50648"/>
                    </a:lnTo>
                    <a:lnTo>
                      <a:pt x="19050" y="18898"/>
                    </a:lnTo>
                    <a:close/>
                  </a:path>
                </a:pathLst>
              </a:custGeom>
              <a:solidFill>
                <a:srgbClr val="000000"/>
              </a:solidFill>
              <a:ln w="952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nb-NO"/>
              </a:p>
            </p:txBody>
          </p:sp>
        </p:grpSp>
      </p:grpSp>
      <p:grpSp>
        <p:nvGrpSpPr>
          <p:cNvPr id="23" name="Gruppe 22">
            <a:extLst>
              <a:ext uri="{FF2B5EF4-FFF2-40B4-BE49-F238E27FC236}">
                <a16:creationId xmlns:a16="http://schemas.microsoft.com/office/drawing/2014/main" id="{E929146D-C8F9-624B-A3FC-5285E69CD133}"/>
              </a:ext>
            </a:extLst>
          </p:cNvPr>
          <p:cNvGrpSpPr/>
          <p:nvPr userDrawn="1"/>
        </p:nvGrpSpPr>
        <p:grpSpPr>
          <a:xfrm>
            <a:off x="3472018" y="3587242"/>
            <a:ext cx="2920090" cy="2944587"/>
            <a:chOff x="3472018" y="3587242"/>
            <a:chExt cx="2920090" cy="2944587"/>
          </a:xfrm>
        </p:grpSpPr>
        <p:sp>
          <p:nvSpPr>
            <p:cNvPr id="24" name="Ellipse 23">
              <a:extLst>
                <a:ext uri="{FF2B5EF4-FFF2-40B4-BE49-F238E27FC236}">
                  <a16:creationId xmlns:a16="http://schemas.microsoft.com/office/drawing/2014/main" id="{80130A13-E8A4-BA4B-9BA1-EFFFC3033629}"/>
                </a:ext>
              </a:extLst>
            </p:cNvPr>
            <p:cNvSpPr/>
            <p:nvPr/>
          </p:nvSpPr>
          <p:spPr>
            <a:xfrm>
              <a:off x="3472018" y="3587242"/>
              <a:ext cx="2920090" cy="2944587"/>
            </a:xfrm>
            <a:prstGeom prst="ellipse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1152000" rIns="0" bIns="0" rtlCol="0" anchor="t" anchorCtr="0"/>
            <a:lstStyle/>
            <a:p>
              <a:pPr algn="ctr"/>
              <a:r>
                <a:rPr lang="nb-NO" sz="1400" dirty="0">
                  <a:solidFill>
                    <a:schemeClr val="tx1"/>
                  </a:solidFill>
                </a:rPr>
                <a:t>Spesialisthelsetjenesten og statlig barnevern</a:t>
              </a:r>
            </a:p>
          </p:txBody>
        </p:sp>
        <p:grpSp>
          <p:nvGrpSpPr>
            <p:cNvPr id="25" name="Gruppe 24">
              <a:extLst>
                <a:ext uri="{FF2B5EF4-FFF2-40B4-BE49-F238E27FC236}">
                  <a16:creationId xmlns:a16="http://schemas.microsoft.com/office/drawing/2014/main" id="{18F50BB6-70D2-F942-A077-ED04450CBFB7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648636" y="4330577"/>
              <a:ext cx="574153" cy="515517"/>
              <a:chOff x="5682424" y="2934921"/>
              <a:chExt cx="827150" cy="742676"/>
            </a:xfrm>
          </p:grpSpPr>
          <p:sp>
            <p:nvSpPr>
              <p:cNvPr id="26" name="Friform 25">
                <a:extLst>
                  <a:ext uri="{FF2B5EF4-FFF2-40B4-BE49-F238E27FC236}">
                    <a16:creationId xmlns:a16="http://schemas.microsoft.com/office/drawing/2014/main" id="{AA34985A-14A2-D645-891A-4702D2A58730}"/>
                  </a:ext>
                </a:extLst>
              </p:cNvPr>
              <p:cNvSpPr/>
              <p:nvPr/>
            </p:nvSpPr>
            <p:spPr>
              <a:xfrm>
                <a:off x="5682424" y="2934921"/>
                <a:ext cx="827150" cy="742676"/>
              </a:xfrm>
              <a:custGeom>
                <a:avLst/>
                <a:gdLst>
                  <a:gd name="connsiteX0" fmla="*/ 827151 w 827150"/>
                  <a:gd name="connsiteY0" fmla="*/ 229985 h 742676"/>
                  <a:gd name="connsiteX1" fmla="*/ 595313 w 827150"/>
                  <a:gd name="connsiteY1" fmla="*/ 1 h 742676"/>
                  <a:gd name="connsiteX2" fmla="*/ 413576 w 827150"/>
                  <a:gd name="connsiteY2" fmla="*/ 87592 h 742676"/>
                  <a:gd name="connsiteX3" fmla="*/ 231839 w 827150"/>
                  <a:gd name="connsiteY3" fmla="*/ 1 h 742676"/>
                  <a:gd name="connsiteX4" fmla="*/ 0 w 827150"/>
                  <a:gd name="connsiteY4" fmla="*/ 229985 h 742676"/>
                  <a:gd name="connsiteX5" fmla="*/ 404051 w 827150"/>
                  <a:gd name="connsiteY5" fmla="*/ 736819 h 742676"/>
                  <a:gd name="connsiteX6" fmla="*/ 413576 w 827150"/>
                  <a:gd name="connsiteY6" fmla="*/ 742677 h 742676"/>
                  <a:gd name="connsiteX7" fmla="*/ 423101 w 827150"/>
                  <a:gd name="connsiteY7" fmla="*/ 737008 h 742676"/>
                  <a:gd name="connsiteX8" fmla="*/ 525399 w 827150"/>
                  <a:gd name="connsiteY8" fmla="*/ 668882 h 742676"/>
                  <a:gd name="connsiteX9" fmla="*/ 772081 w 827150"/>
                  <a:gd name="connsiteY9" fmla="*/ 642385 h 742676"/>
                  <a:gd name="connsiteX10" fmla="*/ 768096 w 827150"/>
                  <a:gd name="connsiteY10" fmla="*/ 419433 h 742676"/>
                  <a:gd name="connsiteX11" fmla="*/ 827151 w 827150"/>
                  <a:gd name="connsiteY11" fmla="*/ 229985 h 742676"/>
                  <a:gd name="connsiteX12" fmla="*/ 413576 w 827150"/>
                  <a:gd name="connsiteY12" fmla="*/ 698457 h 742676"/>
                  <a:gd name="connsiteX13" fmla="*/ 37814 w 827150"/>
                  <a:gd name="connsiteY13" fmla="*/ 229985 h 742676"/>
                  <a:gd name="connsiteX14" fmla="*/ 230515 w 827150"/>
                  <a:gd name="connsiteY14" fmla="*/ 37149 h 742676"/>
                  <a:gd name="connsiteX15" fmla="*/ 397288 w 827150"/>
                  <a:gd name="connsiteY15" fmla="*/ 130300 h 742676"/>
                  <a:gd name="connsiteX16" fmla="*/ 413576 w 827150"/>
                  <a:gd name="connsiteY16" fmla="*/ 157135 h 742676"/>
                  <a:gd name="connsiteX17" fmla="*/ 429863 w 827150"/>
                  <a:gd name="connsiteY17" fmla="*/ 130300 h 742676"/>
                  <a:gd name="connsiteX18" fmla="*/ 695624 w 827150"/>
                  <a:gd name="connsiteY18" fmla="*/ 65305 h 742676"/>
                  <a:gd name="connsiteX19" fmla="*/ 789051 w 827150"/>
                  <a:gd name="connsiteY19" fmla="*/ 229985 h 742676"/>
                  <a:gd name="connsiteX20" fmla="*/ 739331 w 827150"/>
                  <a:gd name="connsiteY20" fmla="*/ 392882 h 742676"/>
                  <a:gd name="connsiteX21" fmla="*/ 493843 w 827150"/>
                  <a:gd name="connsiteY21" fmla="*/ 428670 h 742676"/>
                  <a:gd name="connsiteX22" fmla="*/ 497872 w 827150"/>
                  <a:gd name="connsiteY22" fmla="*/ 641575 h 742676"/>
                  <a:gd name="connsiteX23" fmla="*/ 413576 w 827150"/>
                  <a:gd name="connsiteY23" fmla="*/ 698457 h 742676"/>
                  <a:gd name="connsiteX24" fmla="*/ 634651 w 827150"/>
                  <a:gd name="connsiteY24" fmla="*/ 668882 h 742676"/>
                  <a:gd name="connsiteX25" fmla="*/ 497110 w 827150"/>
                  <a:gd name="connsiteY25" fmla="*/ 532441 h 742676"/>
                  <a:gd name="connsiteX26" fmla="*/ 634651 w 827150"/>
                  <a:gd name="connsiteY26" fmla="*/ 396000 h 742676"/>
                  <a:gd name="connsiteX27" fmla="*/ 772192 w 827150"/>
                  <a:gd name="connsiteY27" fmla="*/ 532441 h 742676"/>
                  <a:gd name="connsiteX28" fmla="*/ 772192 w 827150"/>
                  <a:gd name="connsiteY28" fmla="*/ 532536 h 742676"/>
                  <a:gd name="connsiteX29" fmla="*/ 634651 w 827150"/>
                  <a:gd name="connsiteY29" fmla="*/ 668882 h 74267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</a:cxnLst>
                <a:rect l="l" t="t" r="r" b="b"/>
                <a:pathLst>
                  <a:path w="827150" h="742676">
                    <a:moveTo>
                      <a:pt x="827151" y="229985"/>
                    </a:moveTo>
                    <a:cubicBezTo>
                      <a:pt x="826994" y="103033"/>
                      <a:pt x="723289" y="157"/>
                      <a:pt x="595313" y="1"/>
                    </a:cubicBezTo>
                    <a:cubicBezTo>
                      <a:pt x="524345" y="-227"/>
                      <a:pt x="457257" y="32106"/>
                      <a:pt x="413576" y="87592"/>
                    </a:cubicBezTo>
                    <a:cubicBezTo>
                      <a:pt x="369894" y="32106"/>
                      <a:pt x="302806" y="-227"/>
                      <a:pt x="231839" y="1"/>
                    </a:cubicBezTo>
                    <a:cubicBezTo>
                      <a:pt x="103863" y="157"/>
                      <a:pt x="157" y="103033"/>
                      <a:pt x="0" y="229985"/>
                    </a:cubicBezTo>
                    <a:cubicBezTo>
                      <a:pt x="0" y="489355"/>
                      <a:pt x="387191" y="726803"/>
                      <a:pt x="404051" y="736819"/>
                    </a:cubicBezTo>
                    <a:lnTo>
                      <a:pt x="413576" y="742677"/>
                    </a:lnTo>
                    <a:lnTo>
                      <a:pt x="423101" y="737008"/>
                    </a:lnTo>
                    <a:cubicBezTo>
                      <a:pt x="458376" y="716087"/>
                      <a:pt x="492523" y="693348"/>
                      <a:pt x="525399" y="668882"/>
                    </a:cubicBezTo>
                    <a:cubicBezTo>
                      <a:pt x="600894" y="729140"/>
                      <a:pt x="711338" y="717276"/>
                      <a:pt x="772081" y="642385"/>
                    </a:cubicBezTo>
                    <a:cubicBezTo>
                      <a:pt x="825219" y="576870"/>
                      <a:pt x="823542" y="483038"/>
                      <a:pt x="768096" y="419433"/>
                    </a:cubicBezTo>
                    <a:cubicBezTo>
                      <a:pt x="807244" y="355087"/>
                      <a:pt x="827151" y="291686"/>
                      <a:pt x="827151" y="229985"/>
                    </a:cubicBezTo>
                    <a:close/>
                    <a:moveTo>
                      <a:pt x="413576" y="698457"/>
                    </a:moveTo>
                    <a:cubicBezTo>
                      <a:pt x="353759" y="660000"/>
                      <a:pt x="37814" y="446646"/>
                      <a:pt x="37814" y="229985"/>
                    </a:cubicBezTo>
                    <a:cubicBezTo>
                      <a:pt x="37348" y="123948"/>
                      <a:pt x="123623" y="37612"/>
                      <a:pt x="230515" y="37149"/>
                    </a:cubicBezTo>
                    <a:cubicBezTo>
                      <a:pt x="298775" y="36853"/>
                      <a:pt x="362145" y="72249"/>
                      <a:pt x="397288" y="130300"/>
                    </a:cubicBezTo>
                    <a:lnTo>
                      <a:pt x="413576" y="157135"/>
                    </a:lnTo>
                    <a:lnTo>
                      <a:pt x="429863" y="130300"/>
                    </a:lnTo>
                    <a:cubicBezTo>
                      <a:pt x="485159" y="39551"/>
                      <a:pt x="604144" y="10453"/>
                      <a:pt x="695624" y="65305"/>
                    </a:cubicBezTo>
                    <a:cubicBezTo>
                      <a:pt x="753727" y="100144"/>
                      <a:pt x="789180" y="162636"/>
                      <a:pt x="789051" y="229985"/>
                    </a:cubicBezTo>
                    <a:cubicBezTo>
                      <a:pt x="789051" y="286678"/>
                      <a:pt x="769430" y="341481"/>
                      <a:pt x="739331" y="392882"/>
                    </a:cubicBezTo>
                    <a:cubicBezTo>
                      <a:pt x="661579" y="335518"/>
                      <a:pt x="551670" y="351540"/>
                      <a:pt x="493843" y="428670"/>
                    </a:cubicBezTo>
                    <a:cubicBezTo>
                      <a:pt x="446160" y="492270"/>
                      <a:pt x="447816" y="579796"/>
                      <a:pt x="497872" y="641575"/>
                    </a:cubicBezTo>
                    <a:cubicBezTo>
                      <a:pt x="459867" y="669449"/>
                      <a:pt x="428816" y="689197"/>
                      <a:pt x="413576" y="698457"/>
                    </a:cubicBezTo>
                    <a:close/>
                    <a:moveTo>
                      <a:pt x="634651" y="668882"/>
                    </a:moveTo>
                    <a:cubicBezTo>
                      <a:pt x="558689" y="668882"/>
                      <a:pt x="497110" y="607795"/>
                      <a:pt x="497110" y="532441"/>
                    </a:cubicBezTo>
                    <a:cubicBezTo>
                      <a:pt x="497110" y="457087"/>
                      <a:pt x="558689" y="396000"/>
                      <a:pt x="634651" y="396000"/>
                    </a:cubicBezTo>
                    <a:cubicBezTo>
                      <a:pt x="710613" y="396000"/>
                      <a:pt x="772192" y="457087"/>
                      <a:pt x="772192" y="532441"/>
                    </a:cubicBezTo>
                    <a:cubicBezTo>
                      <a:pt x="772192" y="532472"/>
                      <a:pt x="772192" y="532504"/>
                      <a:pt x="772192" y="532536"/>
                    </a:cubicBezTo>
                    <a:cubicBezTo>
                      <a:pt x="772035" y="607809"/>
                      <a:pt x="710532" y="668778"/>
                      <a:pt x="634651" y="668882"/>
                    </a:cubicBezTo>
                    <a:close/>
                  </a:path>
                </a:pathLst>
              </a:custGeom>
              <a:solidFill>
                <a:srgbClr val="000000"/>
              </a:solidFill>
              <a:ln w="952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nb-NO"/>
              </a:p>
            </p:txBody>
          </p:sp>
          <p:sp>
            <p:nvSpPr>
              <p:cNvPr id="27" name="Friform 26">
                <a:extLst>
                  <a:ext uri="{FF2B5EF4-FFF2-40B4-BE49-F238E27FC236}">
                    <a16:creationId xmlns:a16="http://schemas.microsoft.com/office/drawing/2014/main" id="{1ACB99FE-3B05-9F4C-8856-3504420E2525}"/>
                  </a:ext>
                </a:extLst>
              </p:cNvPr>
              <p:cNvSpPr/>
              <p:nvPr/>
            </p:nvSpPr>
            <p:spPr>
              <a:xfrm>
                <a:off x="6227254" y="3378354"/>
                <a:ext cx="179641" cy="178204"/>
              </a:xfrm>
              <a:custGeom>
                <a:avLst/>
                <a:gdLst>
                  <a:gd name="connsiteX0" fmla="*/ 179642 w 179641"/>
                  <a:gd name="connsiteY0" fmla="*/ 54614 h 178204"/>
                  <a:gd name="connsiteX1" fmla="*/ 124587 w 179641"/>
                  <a:gd name="connsiteY1" fmla="*/ 54614 h 178204"/>
                  <a:gd name="connsiteX2" fmla="*/ 124587 w 179641"/>
                  <a:gd name="connsiteY2" fmla="*/ 0 h 178204"/>
                  <a:gd name="connsiteX3" fmla="*/ 55054 w 179641"/>
                  <a:gd name="connsiteY3" fmla="*/ 0 h 178204"/>
                  <a:gd name="connsiteX4" fmla="*/ 55054 w 179641"/>
                  <a:gd name="connsiteY4" fmla="*/ 54614 h 178204"/>
                  <a:gd name="connsiteX5" fmla="*/ 0 w 179641"/>
                  <a:gd name="connsiteY5" fmla="*/ 54614 h 178204"/>
                  <a:gd name="connsiteX6" fmla="*/ 0 w 179641"/>
                  <a:gd name="connsiteY6" fmla="*/ 123590 h 178204"/>
                  <a:gd name="connsiteX7" fmla="*/ 55054 w 179641"/>
                  <a:gd name="connsiteY7" fmla="*/ 123590 h 178204"/>
                  <a:gd name="connsiteX8" fmla="*/ 55054 w 179641"/>
                  <a:gd name="connsiteY8" fmla="*/ 178204 h 178204"/>
                  <a:gd name="connsiteX9" fmla="*/ 124587 w 179641"/>
                  <a:gd name="connsiteY9" fmla="*/ 178204 h 178204"/>
                  <a:gd name="connsiteX10" fmla="*/ 124587 w 179641"/>
                  <a:gd name="connsiteY10" fmla="*/ 123590 h 178204"/>
                  <a:gd name="connsiteX11" fmla="*/ 179642 w 179641"/>
                  <a:gd name="connsiteY11" fmla="*/ 123590 h 178204"/>
                  <a:gd name="connsiteX12" fmla="*/ 179642 w 179641"/>
                  <a:gd name="connsiteY12" fmla="*/ 54614 h 17820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</a:cxnLst>
                <a:rect l="l" t="t" r="r" b="b"/>
                <a:pathLst>
                  <a:path w="179641" h="178204">
                    <a:moveTo>
                      <a:pt x="179642" y="54614"/>
                    </a:moveTo>
                    <a:lnTo>
                      <a:pt x="124587" y="54614"/>
                    </a:lnTo>
                    <a:lnTo>
                      <a:pt x="124587" y="0"/>
                    </a:lnTo>
                    <a:lnTo>
                      <a:pt x="55054" y="0"/>
                    </a:lnTo>
                    <a:lnTo>
                      <a:pt x="55054" y="54614"/>
                    </a:lnTo>
                    <a:lnTo>
                      <a:pt x="0" y="54614"/>
                    </a:lnTo>
                    <a:lnTo>
                      <a:pt x="0" y="123590"/>
                    </a:lnTo>
                    <a:lnTo>
                      <a:pt x="55054" y="123590"/>
                    </a:lnTo>
                    <a:lnTo>
                      <a:pt x="55054" y="178204"/>
                    </a:lnTo>
                    <a:lnTo>
                      <a:pt x="124587" y="178204"/>
                    </a:lnTo>
                    <a:lnTo>
                      <a:pt x="124587" y="123590"/>
                    </a:lnTo>
                    <a:lnTo>
                      <a:pt x="179642" y="123590"/>
                    </a:lnTo>
                    <a:lnTo>
                      <a:pt x="179642" y="54614"/>
                    </a:lnTo>
                    <a:close/>
                  </a:path>
                </a:pathLst>
              </a:custGeom>
              <a:solidFill>
                <a:srgbClr val="000000"/>
              </a:solidFill>
              <a:ln w="952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nb-NO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21626631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10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1" dur="500"/>
                                        <p:tgtEl>
                                          <p:spTgt spid="2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2" fill="hold">
                            <p:stCondLst>
                              <p:cond delay="1000"/>
                            </p:stCondLst>
                            <p:childTnLst>
                              <p:par>
                                <p:cTn id="13" presetID="10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5" dur="500"/>
                                        <p:tgtEl>
                                          <p:spTgt spid="1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6" fill="hold">
                            <p:stCondLst>
                              <p:cond delay="1500"/>
                            </p:stCondLst>
                            <p:childTnLst>
                              <p:par>
                                <p:cTn id="17" presetID="10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9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BUP hva gjør vi?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ssholder for dato 2">
            <a:extLst>
              <a:ext uri="{FF2B5EF4-FFF2-40B4-BE49-F238E27FC236}">
                <a16:creationId xmlns:a16="http://schemas.microsoft.com/office/drawing/2014/main" id="{DE608CB4-7FB8-4F4A-8B58-A10D4C7093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79DD6-9036-5E4E-A769-804A89AA79F3}" type="datetimeFigureOut">
              <a:rPr lang="nb-NO" smtClean="0"/>
              <a:t>25.01.2024</a:t>
            </a:fld>
            <a:endParaRPr lang="nb-NO"/>
          </a:p>
        </p:txBody>
      </p:sp>
      <p:sp>
        <p:nvSpPr>
          <p:cNvPr id="4" name="Plassholder for bunntekst 3">
            <a:extLst>
              <a:ext uri="{FF2B5EF4-FFF2-40B4-BE49-F238E27FC236}">
                <a16:creationId xmlns:a16="http://schemas.microsoft.com/office/drawing/2014/main" id="{6A1CF599-976F-D34F-B0CC-3B079ECD9B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Plassholder for lysbildenummer 4">
            <a:extLst>
              <a:ext uri="{FF2B5EF4-FFF2-40B4-BE49-F238E27FC236}">
                <a16:creationId xmlns:a16="http://schemas.microsoft.com/office/drawing/2014/main" id="{CAD27731-15F3-A146-B14B-44BF964ED7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7274F-C966-8C46-AFC4-F3A14ECF3B01}" type="slidenum">
              <a:rPr lang="nb-NO" smtClean="0"/>
              <a:t>‹#›</a:t>
            </a:fld>
            <a:endParaRPr lang="nb-NO"/>
          </a:p>
        </p:txBody>
      </p:sp>
      <p:sp>
        <p:nvSpPr>
          <p:cNvPr id="6" name="Tittel 1">
            <a:extLst>
              <a:ext uri="{FF2B5EF4-FFF2-40B4-BE49-F238E27FC236}">
                <a16:creationId xmlns:a16="http://schemas.microsoft.com/office/drawing/2014/main" id="{67B1E8A2-5A26-8949-9E73-0F71693E8C13}"/>
              </a:ext>
            </a:extLst>
          </p:cNvPr>
          <p:cNvSpPr txBox="1">
            <a:spLocks/>
          </p:cNvSpPr>
          <p:nvPr userDrawn="1"/>
        </p:nvSpPr>
        <p:spPr>
          <a:xfrm>
            <a:off x="1050925" y="857250"/>
            <a:ext cx="10534650" cy="704850"/>
          </a:xfrm>
          <a:prstGeom prst="rect">
            <a:avLst/>
          </a:prstGeom>
        </p:spPr>
        <p:txBody>
          <a:bodyPr vert="horz" lIns="0" tIns="0" rIns="0" bIns="0" rtlCol="0" anchor="t" anchorCtr="0">
            <a:noAutofit/>
          </a:bodyPr>
          <a:lstStyle>
            <a:lvl1pPr algn="l" defTabSz="914446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 dirty="0"/>
              <a:t>Hva gjør vi?</a:t>
            </a:r>
          </a:p>
        </p:txBody>
      </p:sp>
      <p:sp>
        <p:nvSpPr>
          <p:cNvPr id="28" name="Rektangel 27">
            <a:extLst>
              <a:ext uri="{FF2B5EF4-FFF2-40B4-BE49-F238E27FC236}">
                <a16:creationId xmlns:a16="http://schemas.microsoft.com/office/drawing/2014/main" id="{BC2F4C51-9505-3243-84A2-40C76803F129}"/>
              </a:ext>
            </a:extLst>
          </p:cNvPr>
          <p:cNvSpPr/>
          <p:nvPr userDrawn="1"/>
        </p:nvSpPr>
        <p:spPr>
          <a:xfrm>
            <a:off x="1050925" y="1801800"/>
            <a:ext cx="3329881" cy="32544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0" tIns="360000" rIns="360000" bIns="360000" rtlCol="0" anchor="t" anchorCtr="0"/>
          <a:lstStyle/>
          <a:p>
            <a:pPr lvl="0">
              <a:lnSpc>
                <a:spcPct val="120000"/>
              </a:lnSpc>
            </a:pPr>
            <a:r>
              <a:rPr lang="nb-NO" sz="2000" dirty="0">
                <a:solidFill>
                  <a:prstClr val="black"/>
                </a:solidFill>
              </a:rPr>
              <a:t>Vi tilbyr rådgivning </a:t>
            </a:r>
            <a:br>
              <a:rPr lang="nb-NO" sz="2000" dirty="0">
                <a:solidFill>
                  <a:prstClr val="black"/>
                </a:solidFill>
              </a:rPr>
            </a:br>
            <a:r>
              <a:rPr lang="nb-NO" sz="2000" dirty="0">
                <a:solidFill>
                  <a:prstClr val="black"/>
                </a:solidFill>
              </a:rPr>
              <a:t>og samarbeid om kvalitetsutvikling i tjenestene </a:t>
            </a:r>
          </a:p>
        </p:txBody>
      </p:sp>
      <p:sp>
        <p:nvSpPr>
          <p:cNvPr id="29" name="Rektangel 28">
            <a:extLst>
              <a:ext uri="{FF2B5EF4-FFF2-40B4-BE49-F238E27FC236}">
                <a16:creationId xmlns:a16="http://schemas.microsoft.com/office/drawing/2014/main" id="{0C7046C3-60AA-3E49-B070-9217541D444B}"/>
              </a:ext>
            </a:extLst>
          </p:cNvPr>
          <p:cNvSpPr/>
          <p:nvPr userDrawn="1"/>
        </p:nvSpPr>
        <p:spPr>
          <a:xfrm>
            <a:off x="4431059" y="1801800"/>
            <a:ext cx="3329881" cy="3254400"/>
          </a:xfrm>
          <a:prstGeom prst="rect">
            <a:avLst/>
          </a:prstGeom>
          <a:solidFill>
            <a:srgbClr val="C1CFF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0" tIns="360000" rIns="360000" bIns="360000" rtlCol="0" anchor="t" anchorCtr="0"/>
          <a:lstStyle/>
          <a:p>
            <a:pPr lvl="0">
              <a:lnSpc>
                <a:spcPct val="120000"/>
              </a:lnSpc>
            </a:pPr>
            <a:r>
              <a:rPr lang="nb-NO" sz="2000" dirty="0">
                <a:solidFill>
                  <a:prstClr val="black"/>
                </a:solidFill>
              </a:rPr>
              <a:t>Vi driver forsknings-prosjekter og publiserer oppsummert forskning på våre nettsider</a:t>
            </a:r>
          </a:p>
        </p:txBody>
      </p:sp>
      <p:sp>
        <p:nvSpPr>
          <p:cNvPr id="30" name="Rektangel 29">
            <a:extLst>
              <a:ext uri="{FF2B5EF4-FFF2-40B4-BE49-F238E27FC236}">
                <a16:creationId xmlns:a16="http://schemas.microsoft.com/office/drawing/2014/main" id="{2C205A64-6E68-7D47-9A9C-78AA7006097D}"/>
              </a:ext>
            </a:extLst>
          </p:cNvPr>
          <p:cNvSpPr/>
          <p:nvPr userDrawn="1"/>
        </p:nvSpPr>
        <p:spPr>
          <a:xfrm>
            <a:off x="7811194" y="1801800"/>
            <a:ext cx="3329881" cy="3254400"/>
          </a:xfrm>
          <a:prstGeom prst="rect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0" tIns="360000" rIns="503999" bIns="360000" rtlCol="0" anchor="t" anchorCtr="0"/>
          <a:lstStyle/>
          <a:p>
            <a:pPr lvl="0">
              <a:lnSpc>
                <a:spcPct val="120000"/>
              </a:lnSpc>
            </a:pPr>
            <a:r>
              <a:rPr lang="nb-NO" sz="2000" dirty="0">
                <a:solidFill>
                  <a:prstClr val="black"/>
                </a:solidFill>
              </a:rPr>
              <a:t>Vi arrangerer </a:t>
            </a:r>
            <a:br>
              <a:rPr lang="nb-NO" sz="2000" dirty="0">
                <a:solidFill>
                  <a:prstClr val="black"/>
                </a:solidFill>
              </a:rPr>
            </a:br>
            <a:r>
              <a:rPr lang="nb-NO" sz="2000" dirty="0">
                <a:solidFill>
                  <a:prstClr val="black"/>
                </a:solidFill>
              </a:rPr>
              <a:t>kurs, og flerårige undervisnings-program</a:t>
            </a:r>
          </a:p>
        </p:txBody>
      </p:sp>
    </p:spTree>
    <p:extLst>
      <p:ext uri="{BB962C8B-B14F-4D97-AF65-F5344CB8AC3E}">
        <p14:creationId xmlns:p14="http://schemas.microsoft.com/office/powerpoint/2010/main" val="405894234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2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1" dur="500"/>
                                        <p:tgtEl>
                                          <p:spTgt spid="2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2" fill="hold">
                            <p:stCondLst>
                              <p:cond delay="1000"/>
                            </p:stCondLst>
                            <p:childTnLst>
                              <p:par>
                                <p:cTn id="13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5" dur="500"/>
                                        <p:tgtEl>
                                          <p:spTgt spid="3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8" grpId="0" animBg="1"/>
      <p:bldP spid="29" grpId="0" animBg="1"/>
      <p:bldP spid="30" grpId="0" animBg="1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BUP nettside 1">
    <p:bg>
      <p:bgPr>
        <a:solidFill>
          <a:srgbClr val="E3DCD8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ssholder for dato 2">
            <a:extLst>
              <a:ext uri="{FF2B5EF4-FFF2-40B4-BE49-F238E27FC236}">
                <a16:creationId xmlns:a16="http://schemas.microsoft.com/office/drawing/2014/main" id="{DE608CB4-7FB8-4F4A-8B58-A10D4C7093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79DD6-9036-5E4E-A769-804A89AA79F3}" type="datetimeFigureOut">
              <a:rPr lang="nb-NO" smtClean="0"/>
              <a:t>25.01.2024</a:t>
            </a:fld>
            <a:endParaRPr lang="nb-NO"/>
          </a:p>
        </p:txBody>
      </p:sp>
      <p:sp>
        <p:nvSpPr>
          <p:cNvPr id="4" name="Plassholder for bunntekst 3">
            <a:extLst>
              <a:ext uri="{FF2B5EF4-FFF2-40B4-BE49-F238E27FC236}">
                <a16:creationId xmlns:a16="http://schemas.microsoft.com/office/drawing/2014/main" id="{6A1CF599-976F-D34F-B0CC-3B079ECD9B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Plassholder for lysbildenummer 4">
            <a:extLst>
              <a:ext uri="{FF2B5EF4-FFF2-40B4-BE49-F238E27FC236}">
                <a16:creationId xmlns:a16="http://schemas.microsoft.com/office/drawing/2014/main" id="{CAD27731-15F3-A146-B14B-44BF964ED7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7274F-C966-8C46-AFC4-F3A14ECF3B01}" type="slidenum">
              <a:rPr lang="nb-NO" smtClean="0"/>
              <a:t>‹#›</a:t>
            </a:fld>
            <a:endParaRPr lang="nb-NO"/>
          </a:p>
        </p:txBody>
      </p:sp>
      <p:sp>
        <p:nvSpPr>
          <p:cNvPr id="9" name="Rektangel 8">
            <a:extLst>
              <a:ext uri="{FF2B5EF4-FFF2-40B4-BE49-F238E27FC236}">
                <a16:creationId xmlns:a16="http://schemas.microsoft.com/office/drawing/2014/main" id="{24788075-A7CC-E14E-A27C-6CD23CA91042}"/>
              </a:ext>
            </a:extLst>
          </p:cNvPr>
          <p:cNvSpPr/>
          <p:nvPr userDrawn="1"/>
        </p:nvSpPr>
        <p:spPr>
          <a:xfrm>
            <a:off x="1068342" y="1328597"/>
            <a:ext cx="4358531" cy="3817098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27000" algn="ctr" rotWithShape="0">
              <a:prstClr val="black">
                <a:alpha val="2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grpSp>
        <p:nvGrpSpPr>
          <p:cNvPr id="10" name="Gruppe 9">
            <a:extLst>
              <a:ext uri="{FF2B5EF4-FFF2-40B4-BE49-F238E27FC236}">
                <a16:creationId xmlns:a16="http://schemas.microsoft.com/office/drawing/2014/main" id="{7D5BD470-2A5F-A642-B093-F27D1ECAFF59}"/>
              </a:ext>
            </a:extLst>
          </p:cNvPr>
          <p:cNvGrpSpPr/>
          <p:nvPr userDrawn="1"/>
        </p:nvGrpSpPr>
        <p:grpSpPr>
          <a:xfrm>
            <a:off x="1068343" y="1188233"/>
            <a:ext cx="4358532" cy="146974"/>
            <a:chOff x="1068343" y="1188233"/>
            <a:chExt cx="4358532" cy="146974"/>
          </a:xfrm>
          <a:effectLst>
            <a:outerShdw blurRad="127000" algn="ctr" rotWithShape="0">
              <a:prstClr val="black">
                <a:alpha val="20000"/>
              </a:prstClr>
            </a:outerShdw>
          </a:effectLst>
        </p:grpSpPr>
        <p:sp>
          <p:nvSpPr>
            <p:cNvPr id="11" name="Rektangel med avrundede hjørner på samme side 10">
              <a:extLst>
                <a:ext uri="{FF2B5EF4-FFF2-40B4-BE49-F238E27FC236}">
                  <a16:creationId xmlns:a16="http://schemas.microsoft.com/office/drawing/2014/main" id="{BAC3A6E9-E154-304A-BCE3-27B4F30475F4}"/>
                </a:ext>
              </a:extLst>
            </p:cNvPr>
            <p:cNvSpPr/>
            <p:nvPr/>
          </p:nvSpPr>
          <p:spPr>
            <a:xfrm>
              <a:off x="1068343" y="1188233"/>
              <a:ext cx="4358532" cy="146974"/>
            </a:xfrm>
            <a:prstGeom prst="round2SameRect">
              <a:avLst>
                <a:gd name="adj1" fmla="val 42763"/>
                <a:gd name="adj2" fmla="val 0"/>
              </a:avLst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b-NO"/>
            </a:p>
          </p:txBody>
        </p:sp>
        <p:sp>
          <p:nvSpPr>
            <p:cNvPr id="12" name="Ellipse 11">
              <a:extLst>
                <a:ext uri="{FF2B5EF4-FFF2-40B4-BE49-F238E27FC236}">
                  <a16:creationId xmlns:a16="http://schemas.microsoft.com/office/drawing/2014/main" id="{6BE81C71-E0E4-A147-85FD-31D6C99EF569}"/>
                </a:ext>
              </a:extLst>
            </p:cNvPr>
            <p:cNvSpPr/>
            <p:nvPr/>
          </p:nvSpPr>
          <p:spPr>
            <a:xfrm>
              <a:off x="1124041" y="1224590"/>
              <a:ext cx="74261" cy="74261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b-NO"/>
            </a:p>
          </p:txBody>
        </p:sp>
        <p:sp>
          <p:nvSpPr>
            <p:cNvPr id="13" name="Ellipse 12">
              <a:extLst>
                <a:ext uri="{FF2B5EF4-FFF2-40B4-BE49-F238E27FC236}">
                  <a16:creationId xmlns:a16="http://schemas.microsoft.com/office/drawing/2014/main" id="{02BE7FAB-AD95-7C46-A260-0B022910BCBE}"/>
                </a:ext>
              </a:extLst>
            </p:cNvPr>
            <p:cNvSpPr/>
            <p:nvPr/>
          </p:nvSpPr>
          <p:spPr>
            <a:xfrm>
              <a:off x="1235431" y="1224590"/>
              <a:ext cx="74261" cy="74261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b-NO"/>
            </a:p>
          </p:txBody>
        </p:sp>
        <p:sp>
          <p:nvSpPr>
            <p:cNvPr id="14" name="TekstSylinder 13">
              <a:extLst>
                <a:ext uri="{FF2B5EF4-FFF2-40B4-BE49-F238E27FC236}">
                  <a16:creationId xmlns:a16="http://schemas.microsoft.com/office/drawing/2014/main" id="{8F222A81-DC8E-0644-B382-1F6E1A56EE15}"/>
                </a:ext>
              </a:extLst>
            </p:cNvPr>
            <p:cNvSpPr txBox="1"/>
            <p:nvPr/>
          </p:nvSpPr>
          <p:spPr>
            <a:xfrm>
              <a:off x="3080095" y="1204554"/>
              <a:ext cx="335028" cy="107722"/>
            </a:xfrm>
            <a:prstGeom prst="rect">
              <a:avLst/>
            </a:prstGeom>
            <a:noFill/>
          </p:spPr>
          <p:txBody>
            <a:bodyPr wrap="none" lIns="0" tIns="0" rIns="0" bIns="0" rtlCol="0" anchor="t" anchorCtr="0">
              <a:spAutoFit/>
            </a:bodyPr>
            <a:lstStyle/>
            <a:p>
              <a:pPr algn="ctr"/>
              <a:r>
                <a:rPr lang="nb-NO" sz="700" noProof="1">
                  <a:solidFill>
                    <a:schemeClr val="bg1"/>
                  </a:solidFill>
                </a:rPr>
                <a:t>r-bup.no</a:t>
              </a:r>
            </a:p>
          </p:txBody>
        </p:sp>
      </p:grpSp>
      <p:pic>
        <p:nvPicPr>
          <p:cNvPr id="16" name="!!web">
            <a:extLst>
              <a:ext uri="{FF2B5EF4-FFF2-40B4-BE49-F238E27FC236}">
                <a16:creationId xmlns:a16="http://schemas.microsoft.com/office/drawing/2014/main" id="{48461BE9-2B0C-E04E-BD44-12425BB6A4C0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26" r="7426" b="67607"/>
          <a:stretch/>
        </p:blipFill>
        <p:spPr>
          <a:xfrm>
            <a:off x="1068343" y="1335207"/>
            <a:ext cx="4358532" cy="4918717"/>
          </a:xfrm>
          <a:prstGeom prst="rect">
            <a:avLst/>
          </a:prstGeom>
        </p:spPr>
      </p:pic>
      <p:sp>
        <p:nvSpPr>
          <p:cNvPr id="17" name="Rektangel 16">
            <a:extLst>
              <a:ext uri="{FF2B5EF4-FFF2-40B4-BE49-F238E27FC236}">
                <a16:creationId xmlns:a16="http://schemas.microsoft.com/office/drawing/2014/main" id="{C3EEF44B-5267-564E-91AD-958B91876868}"/>
              </a:ext>
            </a:extLst>
          </p:cNvPr>
          <p:cNvSpPr/>
          <p:nvPr userDrawn="1"/>
        </p:nvSpPr>
        <p:spPr>
          <a:xfrm>
            <a:off x="0" y="5145695"/>
            <a:ext cx="7049729" cy="1712305"/>
          </a:xfrm>
          <a:prstGeom prst="rect">
            <a:avLst/>
          </a:prstGeom>
          <a:solidFill>
            <a:srgbClr val="E6DCD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" name="TekstSylinder 1">
            <a:extLst>
              <a:ext uri="{FF2B5EF4-FFF2-40B4-BE49-F238E27FC236}">
                <a16:creationId xmlns:a16="http://schemas.microsoft.com/office/drawing/2014/main" id="{B38269AD-3A7E-5A49-82E2-300A731E0371}"/>
              </a:ext>
            </a:extLst>
          </p:cNvPr>
          <p:cNvSpPr txBox="1"/>
          <p:nvPr userDrawn="1"/>
        </p:nvSpPr>
        <p:spPr>
          <a:xfrm>
            <a:off x="6096000" y="1188232"/>
            <a:ext cx="4676503" cy="1615827"/>
          </a:xfrm>
          <a:prstGeom prst="rect">
            <a:avLst/>
          </a:prstGeom>
          <a:noFill/>
        </p:spPr>
        <p:txBody>
          <a:bodyPr wrap="square" lIns="0" tIns="0" rIns="0" bIns="0" rtlCol="0" anchor="t" anchorCtr="0">
            <a:spAutoFit/>
          </a:bodyPr>
          <a:lstStyle/>
          <a:p>
            <a:pPr marL="0" marR="0" indent="0" algn="l" defTabSz="2286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nb-NO" sz="3500" b="0" i="0" u="none" strike="noStrike" kern="1200" cap="none" spc="0" normalizeH="0" baseline="0" noProof="0" dirty="0">
                <a:ln>
                  <a:noFill/>
                </a:ln>
                <a:solidFill>
                  <a:srgbClr val="311D53"/>
                </a:solidFill>
                <a:effectLst/>
                <a:uLnTx/>
                <a:uFillTx/>
                <a:latin typeface="+mn-lt"/>
                <a:ea typeface="+mj-ea"/>
                <a:cs typeface="+mj-cs"/>
              </a:rPr>
              <a:t>Besøk vår nettside for kontaktskjema og mer informasjon:</a:t>
            </a:r>
            <a:endParaRPr lang="nb-NO" sz="2300" dirty="0" err="1"/>
          </a:p>
        </p:txBody>
      </p:sp>
    </p:spTree>
    <p:extLst>
      <p:ext uri="{BB962C8B-B14F-4D97-AF65-F5344CB8AC3E}">
        <p14:creationId xmlns:p14="http://schemas.microsoft.com/office/powerpoint/2010/main" val="9919746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RBUP nettside 2">
    <p:bg>
      <p:bgPr>
        <a:solidFill>
          <a:srgbClr val="FAF5F3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ssholder for lysbildenummer 4">
            <a:extLst>
              <a:ext uri="{FF2B5EF4-FFF2-40B4-BE49-F238E27FC236}">
                <a16:creationId xmlns:a16="http://schemas.microsoft.com/office/drawing/2014/main" id="{CAD27731-15F3-A146-B14B-44BF964ED7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7274F-C966-8C46-AFC4-F3A14ECF3B01}" type="slidenum">
              <a:rPr lang="nb-NO" smtClean="0"/>
              <a:t>‹#›</a:t>
            </a:fld>
            <a:endParaRPr lang="nb-NO"/>
          </a:p>
        </p:txBody>
      </p:sp>
      <p:sp>
        <p:nvSpPr>
          <p:cNvPr id="9" name="Rektangel 8">
            <a:extLst>
              <a:ext uri="{FF2B5EF4-FFF2-40B4-BE49-F238E27FC236}">
                <a16:creationId xmlns:a16="http://schemas.microsoft.com/office/drawing/2014/main" id="{24788075-A7CC-E14E-A27C-6CD23CA91042}"/>
              </a:ext>
            </a:extLst>
          </p:cNvPr>
          <p:cNvSpPr/>
          <p:nvPr userDrawn="1"/>
        </p:nvSpPr>
        <p:spPr>
          <a:xfrm>
            <a:off x="1068342" y="1328597"/>
            <a:ext cx="4358531" cy="3817098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27000" algn="ctr" rotWithShape="0">
              <a:prstClr val="black">
                <a:alpha val="2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pic>
        <p:nvPicPr>
          <p:cNvPr id="25" name="!!web">
            <a:extLst>
              <a:ext uri="{FF2B5EF4-FFF2-40B4-BE49-F238E27FC236}">
                <a16:creationId xmlns:a16="http://schemas.microsoft.com/office/drawing/2014/main" id="{A0F5BD08-F0A6-8849-A0DB-2E1D13A060E8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26" t="-1" r="7426" b="4652"/>
          <a:stretch/>
        </p:blipFill>
        <p:spPr>
          <a:xfrm>
            <a:off x="1068343" y="1335207"/>
            <a:ext cx="4358532" cy="14478255"/>
          </a:xfrm>
          <a:prstGeom prst="rect">
            <a:avLst/>
          </a:prstGeom>
        </p:spPr>
      </p:pic>
      <p:sp>
        <p:nvSpPr>
          <p:cNvPr id="19" name="Rektangel 18">
            <a:extLst>
              <a:ext uri="{FF2B5EF4-FFF2-40B4-BE49-F238E27FC236}">
                <a16:creationId xmlns:a16="http://schemas.microsoft.com/office/drawing/2014/main" id="{9107A367-446D-0349-B590-458F994EF57F}"/>
              </a:ext>
            </a:extLst>
          </p:cNvPr>
          <p:cNvSpPr/>
          <p:nvPr userDrawn="1"/>
        </p:nvSpPr>
        <p:spPr>
          <a:xfrm>
            <a:off x="0" y="5145695"/>
            <a:ext cx="7049729" cy="1712305"/>
          </a:xfrm>
          <a:prstGeom prst="rect">
            <a:avLst/>
          </a:prstGeom>
          <a:solidFill>
            <a:srgbClr val="F9F5F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" name="Plassholder for dato 2">
            <a:extLst>
              <a:ext uri="{FF2B5EF4-FFF2-40B4-BE49-F238E27FC236}">
                <a16:creationId xmlns:a16="http://schemas.microsoft.com/office/drawing/2014/main" id="{DE608CB4-7FB8-4F4A-8B58-A10D4C7093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79DD6-9036-5E4E-A769-804A89AA79F3}" type="datetimeFigureOut">
              <a:rPr lang="nb-NO" smtClean="0"/>
              <a:t>25.01.2024</a:t>
            </a:fld>
            <a:endParaRPr lang="nb-NO"/>
          </a:p>
        </p:txBody>
      </p:sp>
      <p:sp>
        <p:nvSpPr>
          <p:cNvPr id="4" name="Plassholder for bunntekst 3">
            <a:extLst>
              <a:ext uri="{FF2B5EF4-FFF2-40B4-BE49-F238E27FC236}">
                <a16:creationId xmlns:a16="http://schemas.microsoft.com/office/drawing/2014/main" id="{6A1CF599-976F-D34F-B0CC-3B079ECD9B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20" name="Tittel 1">
            <a:extLst>
              <a:ext uri="{FF2B5EF4-FFF2-40B4-BE49-F238E27FC236}">
                <a16:creationId xmlns:a16="http://schemas.microsoft.com/office/drawing/2014/main" id="{61E4D92A-B67C-6F48-8949-E085B20B5F3A}"/>
              </a:ext>
            </a:extLst>
          </p:cNvPr>
          <p:cNvSpPr txBox="1">
            <a:spLocks/>
          </p:cNvSpPr>
          <p:nvPr userDrawn="1"/>
        </p:nvSpPr>
        <p:spPr>
          <a:xfrm>
            <a:off x="6095999" y="1188232"/>
            <a:ext cx="5733011" cy="2951506"/>
          </a:xfrm>
          <a:prstGeom prst="rect">
            <a:avLst/>
          </a:prstGeom>
        </p:spPr>
        <p:txBody>
          <a:bodyPr vert="horz" lIns="0" tIns="0" rIns="0" bIns="0" rtlCol="0" anchor="t" anchorCtr="0">
            <a:noAutofit/>
          </a:bodyPr>
          <a:lstStyle>
            <a:lvl1pPr algn="l" defTabSz="914446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100000"/>
              </a:lnSpc>
            </a:pPr>
            <a:r>
              <a:rPr lang="nb-NO" sz="3500">
                <a:solidFill>
                  <a:schemeClr val="accent5"/>
                </a:solidFill>
              </a:rPr>
              <a:t>Få nyheter og informasjon fra oss rett i din innboks!</a:t>
            </a:r>
            <a:br>
              <a:rPr lang="nb-NO" sz="3500">
                <a:solidFill>
                  <a:schemeClr val="accent5"/>
                </a:solidFill>
              </a:rPr>
            </a:br>
            <a:br>
              <a:rPr lang="nb-NO" sz="3500">
                <a:solidFill>
                  <a:schemeClr val="accent5"/>
                </a:solidFill>
              </a:rPr>
            </a:br>
            <a:r>
              <a:rPr lang="nb-NO" sz="3500">
                <a:solidFill>
                  <a:schemeClr val="accent5"/>
                </a:solidFill>
              </a:rPr>
              <a:t>Meld deg på vårt nyhetsbrev:</a:t>
            </a:r>
            <a:endParaRPr lang="nb-NO" sz="3500" dirty="0"/>
          </a:p>
        </p:txBody>
      </p:sp>
      <p:sp>
        <p:nvSpPr>
          <p:cNvPr id="21" name="TekstSylinder 20">
            <a:extLst>
              <a:ext uri="{FF2B5EF4-FFF2-40B4-BE49-F238E27FC236}">
                <a16:creationId xmlns:a16="http://schemas.microsoft.com/office/drawing/2014/main" id="{2B6557CA-BD98-F147-9A96-E2887F135FB9}"/>
              </a:ext>
            </a:extLst>
          </p:cNvPr>
          <p:cNvSpPr txBox="1"/>
          <p:nvPr userDrawn="1"/>
        </p:nvSpPr>
        <p:spPr>
          <a:xfrm>
            <a:off x="6095999" y="4184763"/>
            <a:ext cx="2874185" cy="1015663"/>
          </a:xfrm>
          <a:prstGeom prst="rect">
            <a:avLst/>
          </a:prstGeom>
          <a:noFill/>
        </p:spPr>
        <p:txBody>
          <a:bodyPr wrap="none" lIns="0" tIns="0" rIns="0" bIns="0" rtlCol="0" anchor="t" anchorCtr="0">
            <a:spAutoFit/>
          </a:bodyPr>
          <a:lstStyle/>
          <a:p>
            <a:r>
              <a:rPr lang="nb-NO" sz="6600" u="sng" noProof="1">
                <a:solidFill>
                  <a:schemeClr val="accent5"/>
                </a:solidFill>
                <a:uFill>
                  <a:solidFill>
                    <a:srgbClr val="355EDB"/>
                  </a:solidFill>
                </a:uFill>
                <a:ea typeface="+mj-ea"/>
                <a:cs typeface="+mj-cs"/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rbup.no</a:t>
            </a:r>
            <a:endParaRPr lang="nb-NO" sz="2300" noProof="1">
              <a:solidFill>
                <a:schemeClr val="accent5"/>
              </a:solidFill>
            </a:endParaRPr>
          </a:p>
        </p:txBody>
      </p:sp>
      <p:sp>
        <p:nvSpPr>
          <p:cNvPr id="18" name="Rektangel 17">
            <a:extLst>
              <a:ext uri="{FF2B5EF4-FFF2-40B4-BE49-F238E27FC236}">
                <a16:creationId xmlns:a16="http://schemas.microsoft.com/office/drawing/2014/main" id="{26E7B584-323D-754C-BD23-9049A55553DF}"/>
              </a:ext>
            </a:extLst>
          </p:cNvPr>
          <p:cNvSpPr/>
          <p:nvPr userDrawn="1"/>
        </p:nvSpPr>
        <p:spPr>
          <a:xfrm>
            <a:off x="844062" y="-1"/>
            <a:ext cx="4582813" cy="1335208"/>
          </a:xfrm>
          <a:prstGeom prst="rect">
            <a:avLst/>
          </a:prstGeom>
          <a:solidFill>
            <a:srgbClr val="F9F5F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2" name="ditt navn">
            <a:extLst>
              <a:ext uri="{FF2B5EF4-FFF2-40B4-BE49-F238E27FC236}">
                <a16:creationId xmlns:a16="http://schemas.microsoft.com/office/drawing/2014/main" id="{9AD8EC90-0261-5747-8E1F-F53067F35E15}"/>
              </a:ext>
            </a:extLst>
          </p:cNvPr>
          <p:cNvSpPr/>
          <p:nvPr userDrawn="1"/>
        </p:nvSpPr>
        <p:spPr>
          <a:xfrm>
            <a:off x="2108198" y="3360910"/>
            <a:ext cx="1333501" cy="174280"/>
          </a:xfrm>
          <a:prstGeom prst="roundRect">
            <a:avLst>
              <a:gd name="adj" fmla="val 50000"/>
            </a:avLst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0000" tIns="0" rIns="90000" bIns="7200" rtlCol="0" anchor="ctr"/>
          <a:lstStyle/>
          <a:p>
            <a:pPr algn="ctr"/>
            <a:r>
              <a:rPr lang="nb-NO" dirty="0" err="1">
                <a:solidFill>
                  <a:schemeClr val="tx1"/>
                </a:solidFill>
              </a:rPr>
              <a:t>dittnavn@mail.no</a:t>
            </a:r>
            <a:endParaRPr lang="nb-NO" dirty="0">
              <a:solidFill>
                <a:schemeClr val="tx1"/>
              </a:solidFill>
            </a:endParaRPr>
          </a:p>
        </p:txBody>
      </p:sp>
      <p:sp>
        <p:nvSpPr>
          <p:cNvPr id="23" name="outline">
            <a:extLst>
              <a:ext uri="{FF2B5EF4-FFF2-40B4-BE49-F238E27FC236}">
                <a16:creationId xmlns:a16="http://schemas.microsoft.com/office/drawing/2014/main" id="{0FA7FF93-ECE8-C54D-9501-D1FDBEB72525}"/>
              </a:ext>
            </a:extLst>
          </p:cNvPr>
          <p:cNvSpPr/>
          <p:nvPr userDrawn="1"/>
        </p:nvSpPr>
        <p:spPr>
          <a:xfrm>
            <a:off x="2080657" y="3332252"/>
            <a:ext cx="1388584" cy="226923"/>
          </a:xfrm>
          <a:prstGeom prst="roundRect">
            <a:avLst>
              <a:gd name="adj" fmla="val 50000"/>
            </a:avLst>
          </a:prstGeom>
          <a:noFill/>
          <a:ln w="2222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0000" tIns="0" rIns="90000" bIns="7200" rtlCol="0" anchor="ctr"/>
          <a:lstStyle/>
          <a:p>
            <a:pPr algn="ctr"/>
            <a:endParaRPr lang="nb-NO" dirty="0">
              <a:solidFill>
                <a:schemeClr val="tx1"/>
              </a:solidFill>
            </a:endParaRPr>
          </a:p>
        </p:txBody>
      </p:sp>
      <p:grpSp>
        <p:nvGrpSpPr>
          <p:cNvPr id="10" name="Gruppe 9">
            <a:extLst>
              <a:ext uri="{FF2B5EF4-FFF2-40B4-BE49-F238E27FC236}">
                <a16:creationId xmlns:a16="http://schemas.microsoft.com/office/drawing/2014/main" id="{7D5BD470-2A5F-A642-B093-F27D1ECAFF59}"/>
              </a:ext>
            </a:extLst>
          </p:cNvPr>
          <p:cNvGrpSpPr/>
          <p:nvPr userDrawn="1"/>
        </p:nvGrpSpPr>
        <p:grpSpPr>
          <a:xfrm>
            <a:off x="1068343" y="1188233"/>
            <a:ext cx="4358532" cy="146974"/>
            <a:chOff x="1068343" y="1188233"/>
            <a:chExt cx="4358532" cy="146974"/>
          </a:xfrm>
          <a:effectLst>
            <a:outerShdw blurRad="127000" algn="ctr" rotWithShape="0">
              <a:prstClr val="black">
                <a:alpha val="20000"/>
              </a:prstClr>
            </a:outerShdw>
          </a:effectLst>
        </p:grpSpPr>
        <p:sp>
          <p:nvSpPr>
            <p:cNvPr id="11" name="Rektangel med avrundede hjørner på samme side 10">
              <a:extLst>
                <a:ext uri="{FF2B5EF4-FFF2-40B4-BE49-F238E27FC236}">
                  <a16:creationId xmlns:a16="http://schemas.microsoft.com/office/drawing/2014/main" id="{BAC3A6E9-E154-304A-BCE3-27B4F30475F4}"/>
                </a:ext>
              </a:extLst>
            </p:cNvPr>
            <p:cNvSpPr/>
            <p:nvPr/>
          </p:nvSpPr>
          <p:spPr>
            <a:xfrm>
              <a:off x="1068343" y="1188233"/>
              <a:ext cx="4358532" cy="146974"/>
            </a:xfrm>
            <a:prstGeom prst="round2SameRect">
              <a:avLst>
                <a:gd name="adj1" fmla="val 42763"/>
                <a:gd name="adj2" fmla="val 0"/>
              </a:avLst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b-NO"/>
            </a:p>
          </p:txBody>
        </p:sp>
        <p:sp>
          <p:nvSpPr>
            <p:cNvPr id="12" name="Ellipse 11">
              <a:extLst>
                <a:ext uri="{FF2B5EF4-FFF2-40B4-BE49-F238E27FC236}">
                  <a16:creationId xmlns:a16="http://schemas.microsoft.com/office/drawing/2014/main" id="{6BE81C71-E0E4-A147-85FD-31D6C99EF569}"/>
                </a:ext>
              </a:extLst>
            </p:cNvPr>
            <p:cNvSpPr/>
            <p:nvPr/>
          </p:nvSpPr>
          <p:spPr>
            <a:xfrm>
              <a:off x="1124041" y="1224590"/>
              <a:ext cx="74261" cy="74261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b-NO"/>
            </a:p>
          </p:txBody>
        </p:sp>
        <p:sp>
          <p:nvSpPr>
            <p:cNvPr id="13" name="Ellipse 12">
              <a:extLst>
                <a:ext uri="{FF2B5EF4-FFF2-40B4-BE49-F238E27FC236}">
                  <a16:creationId xmlns:a16="http://schemas.microsoft.com/office/drawing/2014/main" id="{02BE7FAB-AD95-7C46-A260-0B022910BCBE}"/>
                </a:ext>
              </a:extLst>
            </p:cNvPr>
            <p:cNvSpPr/>
            <p:nvPr/>
          </p:nvSpPr>
          <p:spPr>
            <a:xfrm>
              <a:off x="1235431" y="1224590"/>
              <a:ext cx="74261" cy="74261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b-NO"/>
            </a:p>
          </p:txBody>
        </p:sp>
        <p:sp>
          <p:nvSpPr>
            <p:cNvPr id="14" name="TekstSylinder 13">
              <a:extLst>
                <a:ext uri="{FF2B5EF4-FFF2-40B4-BE49-F238E27FC236}">
                  <a16:creationId xmlns:a16="http://schemas.microsoft.com/office/drawing/2014/main" id="{8F222A81-DC8E-0644-B382-1F6E1A56EE15}"/>
                </a:ext>
              </a:extLst>
            </p:cNvPr>
            <p:cNvSpPr txBox="1"/>
            <p:nvPr/>
          </p:nvSpPr>
          <p:spPr>
            <a:xfrm>
              <a:off x="3080095" y="1204554"/>
              <a:ext cx="335028" cy="107722"/>
            </a:xfrm>
            <a:prstGeom prst="rect">
              <a:avLst/>
            </a:prstGeom>
            <a:noFill/>
          </p:spPr>
          <p:txBody>
            <a:bodyPr wrap="none" lIns="0" tIns="0" rIns="0" bIns="0" rtlCol="0" anchor="t" anchorCtr="0">
              <a:spAutoFit/>
            </a:bodyPr>
            <a:lstStyle/>
            <a:p>
              <a:pPr algn="ctr"/>
              <a:r>
                <a:rPr lang="nb-NO" sz="700" noProof="1">
                  <a:solidFill>
                    <a:schemeClr val="bg1"/>
                  </a:solidFill>
                </a:rPr>
                <a:t>r-bup.no</a:t>
              </a:r>
            </a:p>
          </p:txBody>
        </p:sp>
      </p:grpSp>
      <p:pic>
        <p:nvPicPr>
          <p:cNvPr id="24" name="Graphic 9">
            <a:extLst>
              <a:ext uri="{FF2B5EF4-FFF2-40B4-BE49-F238E27FC236}">
                <a16:creationId xmlns:a16="http://schemas.microsoft.com/office/drawing/2014/main" id="{180A4D3A-DC8D-914D-AC21-B9706F4C6E0B}"/>
              </a:ext>
            </a:extLst>
          </p:cNvPr>
          <p:cNvPicPr>
            <a:picLocks noChangeAspect="1"/>
          </p:cNvPicPr>
          <p:nvPr userDrawn="1"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396023" y="393704"/>
            <a:ext cx="832862" cy="1766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111391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64" presetClass="path" presetSubtype="0" accel="50000" decel="5000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3.75E-6 -1.48148E-6 L 3.75E-6 -1.55833 " pathEditMode="relative" rAng="0" ptsTypes="AA">
                                      <p:cBhvr>
                                        <p:cTn id="6" dur="2000" fill="hold"/>
                                        <p:tgtEl>
                                          <p:spTgt spid="25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77917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2000"/>
                            </p:stCondLst>
                            <p:childTnLst>
                              <p:par>
                                <p:cTn id="8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" dur="500"/>
                                        <p:tgtEl>
                                          <p:spTgt spid="2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1" fill="hold">
                            <p:stCondLst>
                              <p:cond delay="2500"/>
                            </p:stCondLst>
                            <p:childTnLst>
                              <p:par>
                                <p:cTn id="12" presetID="21" presetClass="entr" presetSubtype="1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heel(1)">
                                      <p:cBhvr>
                                        <p:cTn id="14" dur="2000"/>
                                        <p:tgtEl>
                                          <p:spTgt spid="2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2" grpId="0" animBg="1"/>
      <p:bldP spid="23" grpId="0" animBg="1"/>
    </p:bld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Forside lilla">
    <p:bg>
      <p:bgPr>
        <a:solidFill>
          <a:schemeClr val="accent5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55CAB40B-704E-4695-9742-891A1684D576}"/>
              </a:ext>
            </a:extLst>
          </p:cNvPr>
          <p:cNvSpPr/>
          <p:nvPr userDrawn="1"/>
        </p:nvSpPr>
        <p:spPr>
          <a:xfrm>
            <a:off x="6299200" y="6718905"/>
            <a:ext cx="5892800" cy="139096"/>
          </a:xfrm>
          <a:prstGeom prst="rect">
            <a:avLst/>
          </a:prstGeom>
          <a:solidFill>
            <a:srgbClr val="E3DCD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2" name="Picture 21" descr="A picture containing venn diagram  Description automatically generated">
            <a:extLst>
              <a:ext uri="{FF2B5EF4-FFF2-40B4-BE49-F238E27FC236}">
                <a16:creationId xmlns:a16="http://schemas.microsoft.com/office/drawing/2014/main" id="{2967F070-C292-44DA-9559-0DAD792F17AE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9892" y="994102"/>
            <a:ext cx="8732108" cy="5863898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20016" y="1153266"/>
            <a:ext cx="4443283" cy="2387600"/>
          </a:xfrm>
        </p:spPr>
        <p:txBody>
          <a:bodyPr lIns="0" tIns="0" rIns="0" bIns="0" anchor="b">
            <a:normAutofit/>
          </a:bodyPr>
          <a:lstStyle>
            <a:lvl1pPr algn="l">
              <a:lnSpc>
                <a:spcPct val="110000"/>
              </a:lnSpc>
              <a:defRPr sz="3501" b="1">
                <a:solidFill>
                  <a:schemeClr val="bg1"/>
                </a:solidFill>
              </a:defRPr>
            </a:lvl1pPr>
          </a:lstStyle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0016" y="3735403"/>
            <a:ext cx="4443283" cy="1764696"/>
          </a:xfrm>
        </p:spPr>
        <p:txBody>
          <a:bodyPr lIns="0" tIns="0" rIns="0" bIns="0">
            <a:normAutofit/>
          </a:bodyPr>
          <a:lstStyle>
            <a:lvl1pPr marL="0" indent="0" algn="l">
              <a:buNone/>
              <a:defRPr sz="1500" b="1">
                <a:solidFill>
                  <a:schemeClr val="bg1"/>
                </a:solidFill>
              </a:defRPr>
            </a:lvl1pPr>
            <a:lvl2pPr marL="457223" indent="0" algn="ctr">
              <a:buNone/>
              <a:defRPr sz="2000"/>
            </a:lvl2pPr>
            <a:lvl3pPr marL="914446" indent="0" algn="ctr">
              <a:buNone/>
              <a:defRPr sz="1800"/>
            </a:lvl3pPr>
            <a:lvl4pPr marL="1371669" indent="0" algn="ctr">
              <a:buNone/>
              <a:defRPr sz="1600"/>
            </a:lvl4pPr>
            <a:lvl5pPr marL="1828891" indent="0" algn="ctr">
              <a:buNone/>
              <a:defRPr sz="1600"/>
            </a:lvl5pPr>
            <a:lvl6pPr marL="2286114" indent="0" algn="ctr">
              <a:buNone/>
              <a:defRPr sz="1600"/>
            </a:lvl6pPr>
            <a:lvl7pPr marL="2743337" indent="0" algn="ctr">
              <a:buNone/>
              <a:defRPr sz="1600"/>
            </a:lvl7pPr>
            <a:lvl8pPr marL="3200560" indent="0" algn="ctr">
              <a:buNone/>
              <a:defRPr sz="1600"/>
            </a:lvl8pPr>
            <a:lvl9pPr marL="3657783" indent="0" algn="ctr">
              <a:buNone/>
              <a:defRPr sz="1600"/>
            </a:lvl9pPr>
          </a:lstStyle>
          <a:p>
            <a:r>
              <a:rPr lang="nb-NO"/>
              <a:t>Klikk for å redigere undertittelstil i malen</a:t>
            </a:r>
            <a:endParaRPr lang="en-US" dirty="0"/>
          </a:p>
        </p:txBody>
      </p:sp>
      <p:pic>
        <p:nvPicPr>
          <p:cNvPr id="10" name="Graphic 9">
            <a:extLst>
              <a:ext uri="{FF2B5EF4-FFF2-40B4-BE49-F238E27FC236}">
                <a16:creationId xmlns:a16="http://schemas.microsoft.com/office/drawing/2014/main" id="{D6B5AA2E-9626-49A2-9CF4-6B0AF6ECA62D}"/>
              </a:ext>
            </a:extLst>
          </p:cNvPr>
          <p:cNvPicPr>
            <a:picLocks noChangeAspect="1"/>
          </p:cNvPicPr>
          <p:nvPr userDrawn="1"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2535291" y="534913"/>
            <a:ext cx="1452509" cy="391834"/>
          </a:xfrm>
          <a:prstGeom prst="rect">
            <a:avLst/>
          </a:prstGeom>
        </p:spPr>
      </p:pic>
      <p:pic>
        <p:nvPicPr>
          <p:cNvPr id="5" name="Graphic 4">
            <a:extLst>
              <a:ext uri="{FF2B5EF4-FFF2-40B4-BE49-F238E27FC236}">
                <a16:creationId xmlns:a16="http://schemas.microsoft.com/office/drawing/2014/main" id="{9DD12F87-B997-488E-81CD-3D5A71EB679C}"/>
              </a:ext>
            </a:extLst>
          </p:cNvPr>
          <p:cNvPicPr>
            <a:picLocks noChangeAspect="1"/>
          </p:cNvPicPr>
          <p:nvPr userDrawn="1"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44617" y="534914"/>
            <a:ext cx="1737263" cy="3727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993589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Forside grønn">
    <p:bg>
      <p:bgPr>
        <a:solidFill>
          <a:schemeClr val="accent3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Rectangle 22">
            <a:extLst>
              <a:ext uri="{FF2B5EF4-FFF2-40B4-BE49-F238E27FC236}">
                <a16:creationId xmlns:a16="http://schemas.microsoft.com/office/drawing/2014/main" id="{3E9888DA-929F-44E3-AAF3-DD459A712EBA}"/>
              </a:ext>
            </a:extLst>
          </p:cNvPr>
          <p:cNvSpPr/>
          <p:nvPr userDrawn="1"/>
        </p:nvSpPr>
        <p:spPr>
          <a:xfrm>
            <a:off x="6299200" y="6718905"/>
            <a:ext cx="5892800" cy="139096"/>
          </a:xfrm>
          <a:prstGeom prst="rect">
            <a:avLst/>
          </a:prstGeom>
          <a:solidFill>
            <a:srgbClr val="E3DCD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5" name="Picture 24" descr="Venn diagram  Description automatically generated with medium confidence">
            <a:extLst>
              <a:ext uri="{FF2B5EF4-FFF2-40B4-BE49-F238E27FC236}">
                <a16:creationId xmlns:a16="http://schemas.microsoft.com/office/drawing/2014/main" id="{FCC92A3D-A4E2-43FD-A1A5-116B632E0A9D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9892" y="994102"/>
            <a:ext cx="8732108" cy="5863898"/>
          </a:xfrm>
          <a:prstGeom prst="rect">
            <a:avLst/>
          </a:prstGeom>
        </p:spPr>
      </p:pic>
      <p:pic>
        <p:nvPicPr>
          <p:cNvPr id="15" name="Picture 14" descr="Diagram  Description automatically generated with medium confidence" hidden="1">
            <a:extLst>
              <a:ext uri="{FF2B5EF4-FFF2-40B4-BE49-F238E27FC236}">
                <a16:creationId xmlns:a16="http://schemas.microsoft.com/office/drawing/2014/main" id="{A63A23D3-5D49-4BAB-8BAD-7844B12979EB}"/>
              </a:ext>
            </a:extLst>
          </p:cNvPr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20016" y="1153266"/>
            <a:ext cx="4443283" cy="2387600"/>
          </a:xfrm>
        </p:spPr>
        <p:txBody>
          <a:bodyPr lIns="0" tIns="0" rIns="0" bIns="0" anchor="b">
            <a:normAutofit/>
          </a:bodyPr>
          <a:lstStyle>
            <a:lvl1pPr algn="l">
              <a:lnSpc>
                <a:spcPct val="110000"/>
              </a:lnSpc>
              <a:defRPr sz="3501" b="1">
                <a:solidFill>
                  <a:schemeClr val="bg1"/>
                </a:solidFill>
              </a:defRPr>
            </a:lvl1pPr>
          </a:lstStyle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0016" y="3735403"/>
            <a:ext cx="4443283" cy="1764696"/>
          </a:xfrm>
        </p:spPr>
        <p:txBody>
          <a:bodyPr lIns="0" tIns="0" rIns="0" bIns="0">
            <a:normAutofit/>
          </a:bodyPr>
          <a:lstStyle>
            <a:lvl1pPr marL="0" indent="0" algn="l">
              <a:buNone/>
              <a:defRPr sz="1500" b="1">
                <a:solidFill>
                  <a:schemeClr val="bg1"/>
                </a:solidFill>
              </a:defRPr>
            </a:lvl1pPr>
            <a:lvl2pPr marL="457223" indent="0" algn="ctr">
              <a:buNone/>
              <a:defRPr sz="2000"/>
            </a:lvl2pPr>
            <a:lvl3pPr marL="914446" indent="0" algn="ctr">
              <a:buNone/>
              <a:defRPr sz="1800"/>
            </a:lvl3pPr>
            <a:lvl4pPr marL="1371669" indent="0" algn="ctr">
              <a:buNone/>
              <a:defRPr sz="1600"/>
            </a:lvl4pPr>
            <a:lvl5pPr marL="1828891" indent="0" algn="ctr">
              <a:buNone/>
              <a:defRPr sz="1600"/>
            </a:lvl5pPr>
            <a:lvl6pPr marL="2286114" indent="0" algn="ctr">
              <a:buNone/>
              <a:defRPr sz="1600"/>
            </a:lvl6pPr>
            <a:lvl7pPr marL="2743337" indent="0" algn="ctr">
              <a:buNone/>
              <a:defRPr sz="1600"/>
            </a:lvl7pPr>
            <a:lvl8pPr marL="3200560" indent="0" algn="ctr">
              <a:buNone/>
              <a:defRPr sz="1600"/>
            </a:lvl8pPr>
            <a:lvl9pPr marL="3657783" indent="0" algn="ctr">
              <a:buNone/>
              <a:defRPr sz="1600"/>
            </a:lvl9pPr>
          </a:lstStyle>
          <a:p>
            <a:r>
              <a:rPr lang="nb-NO"/>
              <a:t>Klikk for å redigere undertittelstil i malen</a:t>
            </a:r>
            <a:endParaRPr lang="en-US" dirty="0"/>
          </a:p>
        </p:txBody>
      </p:sp>
      <p:pic>
        <p:nvPicPr>
          <p:cNvPr id="10" name="Graphic 9">
            <a:extLst>
              <a:ext uri="{FF2B5EF4-FFF2-40B4-BE49-F238E27FC236}">
                <a16:creationId xmlns:a16="http://schemas.microsoft.com/office/drawing/2014/main" id="{D6B5AA2E-9626-49A2-9CF4-6B0AF6ECA62D}"/>
              </a:ext>
            </a:extLst>
          </p:cNvPr>
          <p:cNvPicPr>
            <a:picLocks noChangeAspect="1"/>
          </p:cNvPicPr>
          <p:nvPr userDrawn="1"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2535291" y="534913"/>
            <a:ext cx="1452509" cy="391834"/>
          </a:xfrm>
          <a:prstGeom prst="rect">
            <a:avLst/>
          </a:prstGeom>
        </p:spPr>
      </p:pic>
      <p:pic>
        <p:nvPicPr>
          <p:cNvPr id="9" name="Graphic 8">
            <a:extLst>
              <a:ext uri="{FF2B5EF4-FFF2-40B4-BE49-F238E27FC236}">
                <a16:creationId xmlns:a16="http://schemas.microsoft.com/office/drawing/2014/main" id="{240EA434-AC5D-4DA3-9FF1-47432ACC8090}"/>
              </a:ext>
            </a:extLst>
          </p:cNvPr>
          <p:cNvPicPr>
            <a:picLocks noChangeAspect="1"/>
          </p:cNvPicPr>
          <p:nvPr userDrawn="1"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544617" y="534914"/>
            <a:ext cx="1737263" cy="3727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424225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26" Type="http://schemas.openxmlformats.org/officeDocument/2006/relationships/slideLayout" Target="../slideLayouts/slideLayout26.xml"/><Relationship Id="rId39" Type="http://schemas.openxmlformats.org/officeDocument/2006/relationships/theme" Target="../theme/theme1.xml"/><Relationship Id="rId21" Type="http://schemas.openxmlformats.org/officeDocument/2006/relationships/slideLayout" Target="../slideLayouts/slideLayout21.xml"/><Relationship Id="rId34" Type="http://schemas.openxmlformats.org/officeDocument/2006/relationships/slideLayout" Target="../slideLayouts/slideLayout34.xml"/><Relationship Id="rId42" Type="http://schemas.openxmlformats.org/officeDocument/2006/relationships/image" Target="../media/image3.png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9" Type="http://schemas.openxmlformats.org/officeDocument/2006/relationships/slideLayout" Target="../slideLayouts/slideLayout29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24" Type="http://schemas.openxmlformats.org/officeDocument/2006/relationships/slideLayout" Target="../slideLayouts/slideLayout24.xml"/><Relationship Id="rId32" Type="http://schemas.openxmlformats.org/officeDocument/2006/relationships/slideLayout" Target="../slideLayouts/slideLayout32.xml"/><Relationship Id="rId37" Type="http://schemas.openxmlformats.org/officeDocument/2006/relationships/slideLayout" Target="../slideLayouts/slideLayout37.xml"/><Relationship Id="rId40" Type="http://schemas.openxmlformats.org/officeDocument/2006/relationships/image" Target="../media/image1.png"/><Relationship Id="rId45" Type="http://schemas.openxmlformats.org/officeDocument/2006/relationships/image" Target="../media/image6.svg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23" Type="http://schemas.openxmlformats.org/officeDocument/2006/relationships/slideLayout" Target="../slideLayouts/slideLayout23.xml"/><Relationship Id="rId28" Type="http://schemas.openxmlformats.org/officeDocument/2006/relationships/slideLayout" Target="../slideLayouts/slideLayout28.xml"/><Relationship Id="rId36" Type="http://schemas.openxmlformats.org/officeDocument/2006/relationships/slideLayout" Target="../slideLayouts/slideLayout36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31" Type="http://schemas.openxmlformats.org/officeDocument/2006/relationships/slideLayout" Target="../slideLayouts/slideLayout31.xml"/><Relationship Id="rId44" Type="http://schemas.openxmlformats.org/officeDocument/2006/relationships/image" Target="../media/image5.png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Relationship Id="rId22" Type="http://schemas.openxmlformats.org/officeDocument/2006/relationships/slideLayout" Target="../slideLayouts/slideLayout22.xml"/><Relationship Id="rId27" Type="http://schemas.openxmlformats.org/officeDocument/2006/relationships/slideLayout" Target="../slideLayouts/slideLayout27.xml"/><Relationship Id="rId30" Type="http://schemas.openxmlformats.org/officeDocument/2006/relationships/slideLayout" Target="../slideLayouts/slideLayout30.xml"/><Relationship Id="rId35" Type="http://schemas.openxmlformats.org/officeDocument/2006/relationships/slideLayout" Target="../slideLayouts/slideLayout35.xml"/><Relationship Id="rId43" Type="http://schemas.openxmlformats.org/officeDocument/2006/relationships/image" Target="../media/image4.svg"/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5" Type="http://schemas.openxmlformats.org/officeDocument/2006/relationships/slideLayout" Target="../slideLayouts/slideLayout25.xml"/><Relationship Id="rId33" Type="http://schemas.openxmlformats.org/officeDocument/2006/relationships/slideLayout" Target="../slideLayouts/slideLayout33.xml"/><Relationship Id="rId38" Type="http://schemas.openxmlformats.org/officeDocument/2006/relationships/slideLayout" Target="../slideLayouts/slideLayout38.xml"/><Relationship Id="rId20" Type="http://schemas.openxmlformats.org/officeDocument/2006/relationships/slideLayout" Target="../slideLayouts/slideLayout20.xml"/><Relationship Id="rId41" Type="http://schemas.openxmlformats.org/officeDocument/2006/relationships/image" Target="../media/image2.sv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583908" y="6137907"/>
            <a:ext cx="608092" cy="608083"/>
          </a:xfrm>
          <a:prstGeom prst="rect">
            <a:avLst/>
          </a:prstGeom>
          <a:blipFill dpi="0" rotWithShape="1">
            <a:blip r:embed="rId40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1"/>
                </a:ext>
              </a:extLst>
            </a:blip>
            <a:srcRect/>
            <a:stretch>
              <a:fillRect/>
            </a:stretch>
          </a:blipFill>
        </p:spPr>
        <p:txBody>
          <a:bodyPr vert="horz" lIns="0" tIns="0" rIns="144000" bIns="0" rtlCol="0" anchor="ctr"/>
          <a:lstStyle>
            <a:lvl1pPr algn="r">
              <a:defRPr sz="1200" b="1">
                <a:solidFill>
                  <a:schemeClr val="tx1"/>
                </a:solidFill>
              </a:defRPr>
            </a:lvl1pPr>
          </a:lstStyle>
          <a:p>
            <a:fld id="{1E4BC5DA-09B7-4CD9-B21E-157BBBE69313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51200" y="856800"/>
            <a:ext cx="10533600" cy="705600"/>
          </a:xfrm>
          <a:prstGeom prst="rect">
            <a:avLst/>
          </a:prstGeom>
        </p:spPr>
        <p:txBody>
          <a:bodyPr vert="horz" lIns="0" tIns="0" rIns="0" bIns="0" rtlCol="0" anchor="t" anchorCtr="0">
            <a:noAutofit/>
          </a:bodyPr>
          <a:lstStyle/>
          <a:p>
            <a:r>
              <a:rPr lang="nb-NO" dirty="0"/>
              <a:t>Klikk for å redigere tittel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51200" y="1648800"/>
            <a:ext cx="10532708" cy="4320000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/>
          <a:p>
            <a:pPr lvl="0"/>
            <a:r>
              <a:rPr lang="en-US" dirty="0" err="1"/>
              <a:t>Kulepunkt</a:t>
            </a:r>
            <a:r>
              <a:rPr lang="en-US" dirty="0"/>
              <a:t> </a:t>
            </a:r>
            <a:r>
              <a:rPr lang="en-US" dirty="0" err="1"/>
              <a:t>nivå</a:t>
            </a:r>
            <a:r>
              <a:rPr lang="en-US" dirty="0"/>
              <a:t> 1</a:t>
            </a:r>
          </a:p>
          <a:p>
            <a:pPr lvl="1"/>
            <a:r>
              <a:rPr lang="en-US" dirty="0" err="1"/>
              <a:t>Kulepunkt</a:t>
            </a:r>
            <a:r>
              <a:rPr lang="en-US" dirty="0"/>
              <a:t> </a:t>
            </a:r>
            <a:r>
              <a:rPr lang="en-US" dirty="0" err="1"/>
              <a:t>nivå</a:t>
            </a:r>
            <a:r>
              <a:rPr lang="en-US" dirty="0"/>
              <a:t> 2</a:t>
            </a:r>
          </a:p>
          <a:p>
            <a:pPr lvl="2"/>
            <a:r>
              <a:rPr lang="en-US" dirty="0" err="1"/>
              <a:t>Kulepunkt</a:t>
            </a:r>
            <a:r>
              <a:rPr lang="en-US" dirty="0"/>
              <a:t> </a:t>
            </a:r>
            <a:r>
              <a:rPr lang="en-US" dirty="0" err="1"/>
              <a:t>nivå</a:t>
            </a:r>
            <a:r>
              <a:rPr lang="en-US" dirty="0"/>
              <a:t> 3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24400" y="6253924"/>
            <a:ext cx="2743200" cy="365125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ctr">
              <a:defRPr lang="en-US" sz="800" b="1"/>
            </a:lvl1pPr>
          </a:lstStyle>
          <a:p>
            <a:fld id="{9D03F6E6-5CDA-F241-BB38-1AEA2D1479E3}" type="datetime1">
              <a:rPr lang="nb-NO" smtClean="0"/>
              <a:t>25.01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6655" y="6253924"/>
            <a:ext cx="4114800" cy="365125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1">
                <a:solidFill>
                  <a:schemeClr val="tx1"/>
                </a:solidFill>
              </a:defRPr>
            </a:lvl1pPr>
          </a:lstStyle>
          <a:p>
            <a:endParaRPr lang="en-US" dirty="0"/>
          </a:p>
        </p:txBody>
      </p:sp>
      <p:pic>
        <p:nvPicPr>
          <p:cNvPr id="10" name="Graphic 9">
            <a:extLst>
              <a:ext uri="{FF2B5EF4-FFF2-40B4-BE49-F238E27FC236}">
                <a16:creationId xmlns:a16="http://schemas.microsoft.com/office/drawing/2014/main" id="{AEA6C9E0-A181-4901-8C5E-110A385E2644}"/>
              </a:ext>
            </a:extLst>
          </p:cNvPr>
          <p:cNvPicPr>
            <a:picLocks noChangeAspect="1"/>
          </p:cNvPicPr>
          <p:nvPr userDrawn="1"/>
        </p:nvPicPr>
        <p:blipFill>
          <a:blip r:embed="rId42">
            <a:extLst>
              <a:ext uri="{96DAC541-7B7A-43D3-8B79-37D633B846F1}">
                <asvg:svgBlip xmlns:asvg="http://schemas.microsoft.com/office/drawing/2016/SVG/main" r:embed="rId43"/>
              </a:ext>
            </a:extLst>
          </a:blip>
          <a:stretch>
            <a:fillRect/>
          </a:stretch>
        </p:blipFill>
        <p:spPr>
          <a:xfrm>
            <a:off x="396023" y="393704"/>
            <a:ext cx="832862" cy="176665"/>
          </a:xfrm>
          <a:prstGeom prst="rect">
            <a:avLst/>
          </a:prstGeom>
        </p:spPr>
      </p:pic>
      <p:sp>
        <p:nvSpPr>
          <p:cNvPr id="8" name="Rektangel 7">
            <a:extLst>
              <a:ext uri="{FF2B5EF4-FFF2-40B4-BE49-F238E27FC236}">
                <a16:creationId xmlns:a16="http://schemas.microsoft.com/office/drawing/2014/main" id="{4C7FCF7D-D59E-8540-9B84-A44615D74449}"/>
              </a:ext>
            </a:extLst>
          </p:cNvPr>
          <p:cNvSpPr/>
          <p:nvPr userDrawn="1"/>
        </p:nvSpPr>
        <p:spPr>
          <a:xfrm>
            <a:off x="7286920" y="-631595"/>
            <a:ext cx="4905080" cy="46191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grpSp>
        <p:nvGrpSpPr>
          <p:cNvPr id="9" name="Gruppe 8">
            <a:extLst>
              <a:ext uri="{FF2B5EF4-FFF2-40B4-BE49-F238E27FC236}">
                <a16:creationId xmlns:a16="http://schemas.microsoft.com/office/drawing/2014/main" id="{A3B8890A-99EC-0B4D-83F3-8B6F03661ECC}"/>
              </a:ext>
            </a:extLst>
          </p:cNvPr>
          <p:cNvGrpSpPr/>
          <p:nvPr userDrawn="1"/>
        </p:nvGrpSpPr>
        <p:grpSpPr>
          <a:xfrm>
            <a:off x="7535961" y="-517688"/>
            <a:ext cx="4406998" cy="234099"/>
            <a:chOff x="7467600" y="-499620"/>
            <a:chExt cx="4406998" cy="234099"/>
          </a:xfrm>
        </p:grpSpPr>
        <p:grpSp>
          <p:nvGrpSpPr>
            <p:cNvPr id="11" name="Gruppe 10">
              <a:extLst>
                <a:ext uri="{FF2B5EF4-FFF2-40B4-BE49-F238E27FC236}">
                  <a16:creationId xmlns:a16="http://schemas.microsoft.com/office/drawing/2014/main" id="{74624EE9-70D3-8742-AF84-BF683787CCB4}"/>
                </a:ext>
              </a:extLst>
            </p:cNvPr>
            <p:cNvGrpSpPr/>
            <p:nvPr userDrawn="1"/>
          </p:nvGrpSpPr>
          <p:grpSpPr>
            <a:xfrm>
              <a:off x="7467600" y="-499620"/>
              <a:ext cx="507476" cy="234099"/>
              <a:chOff x="7467600" y="-499620"/>
              <a:chExt cx="507476" cy="234099"/>
            </a:xfrm>
          </p:grpSpPr>
          <p:sp>
            <p:nvSpPr>
              <p:cNvPr id="28" name="Ellipse 27">
                <a:extLst>
                  <a:ext uri="{FF2B5EF4-FFF2-40B4-BE49-F238E27FC236}">
                    <a16:creationId xmlns:a16="http://schemas.microsoft.com/office/drawing/2014/main" id="{001A6E35-BFE4-F04E-B418-CB2BDFF48C6A}"/>
                  </a:ext>
                </a:extLst>
              </p:cNvPr>
              <p:cNvSpPr/>
              <p:nvPr userDrawn="1"/>
            </p:nvSpPr>
            <p:spPr>
              <a:xfrm>
                <a:off x="7467600" y="-499620"/>
                <a:ext cx="234099" cy="234099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b-NO"/>
              </a:p>
            </p:txBody>
          </p:sp>
          <p:sp>
            <p:nvSpPr>
              <p:cNvPr id="29" name="Ellipse 28">
                <a:extLst>
                  <a:ext uri="{FF2B5EF4-FFF2-40B4-BE49-F238E27FC236}">
                    <a16:creationId xmlns:a16="http://schemas.microsoft.com/office/drawing/2014/main" id="{7DDEA700-038D-064A-8906-2DB1344BC6B6}"/>
                  </a:ext>
                </a:extLst>
              </p:cNvPr>
              <p:cNvSpPr/>
              <p:nvPr userDrawn="1"/>
            </p:nvSpPr>
            <p:spPr>
              <a:xfrm>
                <a:off x="7740977" y="-499620"/>
                <a:ext cx="234099" cy="234099"/>
              </a:xfrm>
              <a:prstGeom prst="ellipse">
                <a:avLst/>
              </a:prstGeom>
              <a:solidFill>
                <a:schemeClr val="accent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b-NO"/>
              </a:p>
            </p:txBody>
          </p:sp>
        </p:grpSp>
        <p:grpSp>
          <p:nvGrpSpPr>
            <p:cNvPr id="12" name="Gruppe 11">
              <a:extLst>
                <a:ext uri="{FF2B5EF4-FFF2-40B4-BE49-F238E27FC236}">
                  <a16:creationId xmlns:a16="http://schemas.microsoft.com/office/drawing/2014/main" id="{590715C5-732D-0146-9AA6-B4CBF30A41CC}"/>
                </a:ext>
              </a:extLst>
            </p:cNvPr>
            <p:cNvGrpSpPr/>
            <p:nvPr userDrawn="1"/>
          </p:nvGrpSpPr>
          <p:grpSpPr>
            <a:xfrm>
              <a:off x="8198485" y="-499620"/>
              <a:ext cx="752574" cy="234099"/>
              <a:chOff x="8193464" y="-499620"/>
              <a:chExt cx="752574" cy="234099"/>
            </a:xfrm>
          </p:grpSpPr>
          <p:sp>
            <p:nvSpPr>
              <p:cNvPr id="25" name="Ellipse 24">
                <a:extLst>
                  <a:ext uri="{FF2B5EF4-FFF2-40B4-BE49-F238E27FC236}">
                    <a16:creationId xmlns:a16="http://schemas.microsoft.com/office/drawing/2014/main" id="{16E24F51-C072-1046-8480-B2DB95F63789}"/>
                  </a:ext>
                </a:extLst>
              </p:cNvPr>
              <p:cNvSpPr/>
              <p:nvPr userDrawn="1"/>
            </p:nvSpPr>
            <p:spPr>
              <a:xfrm>
                <a:off x="8193464" y="-499620"/>
                <a:ext cx="234099" cy="234099"/>
              </a:xfrm>
              <a:prstGeom prst="ellipse">
                <a:avLst/>
              </a:prstGeom>
              <a:solidFill>
                <a:srgbClr val="FF786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b-NO"/>
              </a:p>
            </p:txBody>
          </p:sp>
          <p:sp>
            <p:nvSpPr>
              <p:cNvPr id="26" name="Ellipse 25">
                <a:extLst>
                  <a:ext uri="{FF2B5EF4-FFF2-40B4-BE49-F238E27FC236}">
                    <a16:creationId xmlns:a16="http://schemas.microsoft.com/office/drawing/2014/main" id="{EAE9CF50-F168-334A-85E5-0BA60035697D}"/>
                  </a:ext>
                </a:extLst>
              </p:cNvPr>
              <p:cNvSpPr/>
              <p:nvPr userDrawn="1"/>
            </p:nvSpPr>
            <p:spPr>
              <a:xfrm>
                <a:off x="8447988" y="-499620"/>
                <a:ext cx="234099" cy="234099"/>
              </a:xfrm>
              <a:prstGeom prst="ellipse">
                <a:avLst/>
              </a:prstGeom>
              <a:solidFill>
                <a:srgbClr val="E5DCD8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b-NO"/>
              </a:p>
            </p:txBody>
          </p:sp>
          <p:sp>
            <p:nvSpPr>
              <p:cNvPr id="27" name="Ellipse 26">
                <a:extLst>
                  <a:ext uri="{FF2B5EF4-FFF2-40B4-BE49-F238E27FC236}">
                    <a16:creationId xmlns:a16="http://schemas.microsoft.com/office/drawing/2014/main" id="{8E7C63C0-F00D-9043-A193-F2096D3C03D5}"/>
                  </a:ext>
                </a:extLst>
              </p:cNvPr>
              <p:cNvSpPr/>
              <p:nvPr userDrawn="1"/>
            </p:nvSpPr>
            <p:spPr>
              <a:xfrm>
                <a:off x="8711939" y="-499620"/>
                <a:ext cx="234099" cy="234099"/>
              </a:xfrm>
              <a:prstGeom prst="ellipse">
                <a:avLst/>
              </a:prstGeom>
              <a:solidFill>
                <a:srgbClr val="F8F5F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b-NO"/>
              </a:p>
            </p:txBody>
          </p:sp>
        </p:grpSp>
        <p:grpSp>
          <p:nvGrpSpPr>
            <p:cNvPr id="13" name="Gruppe 12">
              <a:extLst>
                <a:ext uri="{FF2B5EF4-FFF2-40B4-BE49-F238E27FC236}">
                  <a16:creationId xmlns:a16="http://schemas.microsoft.com/office/drawing/2014/main" id="{80605AE4-34FB-5344-8F4C-CE7D12552F04}"/>
                </a:ext>
              </a:extLst>
            </p:cNvPr>
            <p:cNvGrpSpPr/>
            <p:nvPr userDrawn="1"/>
          </p:nvGrpSpPr>
          <p:grpSpPr>
            <a:xfrm>
              <a:off x="9174468" y="-499620"/>
              <a:ext cx="507476" cy="234099"/>
              <a:chOff x="9089010" y="-499620"/>
              <a:chExt cx="507476" cy="234099"/>
            </a:xfrm>
          </p:grpSpPr>
          <p:sp>
            <p:nvSpPr>
              <p:cNvPr id="23" name="Ellipse 22">
                <a:extLst>
                  <a:ext uri="{FF2B5EF4-FFF2-40B4-BE49-F238E27FC236}">
                    <a16:creationId xmlns:a16="http://schemas.microsoft.com/office/drawing/2014/main" id="{CB294ABA-2A38-C644-A66D-3013F1AC18E1}"/>
                  </a:ext>
                </a:extLst>
              </p:cNvPr>
              <p:cNvSpPr/>
              <p:nvPr userDrawn="1"/>
            </p:nvSpPr>
            <p:spPr>
              <a:xfrm>
                <a:off x="9089010" y="-499620"/>
                <a:ext cx="234099" cy="234099"/>
              </a:xfrm>
              <a:prstGeom prst="ellipse">
                <a:avLst/>
              </a:prstGeom>
              <a:solidFill>
                <a:schemeClr val="accent4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b-NO"/>
              </a:p>
            </p:txBody>
          </p:sp>
          <p:sp>
            <p:nvSpPr>
              <p:cNvPr id="24" name="Ellipse 23">
                <a:extLst>
                  <a:ext uri="{FF2B5EF4-FFF2-40B4-BE49-F238E27FC236}">
                    <a16:creationId xmlns:a16="http://schemas.microsoft.com/office/drawing/2014/main" id="{3E370BD5-9ECF-EB4D-B133-30927AE48CA5}"/>
                  </a:ext>
                </a:extLst>
              </p:cNvPr>
              <p:cNvSpPr/>
              <p:nvPr userDrawn="1"/>
            </p:nvSpPr>
            <p:spPr>
              <a:xfrm>
                <a:off x="9362387" y="-499620"/>
                <a:ext cx="234099" cy="234099"/>
              </a:xfrm>
              <a:prstGeom prst="ellipse">
                <a:avLst/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b-NO"/>
              </a:p>
            </p:txBody>
          </p:sp>
        </p:grpSp>
        <p:grpSp>
          <p:nvGrpSpPr>
            <p:cNvPr id="14" name="Gruppe 13">
              <a:extLst>
                <a:ext uri="{FF2B5EF4-FFF2-40B4-BE49-F238E27FC236}">
                  <a16:creationId xmlns:a16="http://schemas.microsoft.com/office/drawing/2014/main" id="{6022DFAD-DA42-CC49-A6F5-08B9AC583B3D}"/>
                </a:ext>
              </a:extLst>
            </p:cNvPr>
            <p:cNvGrpSpPr/>
            <p:nvPr userDrawn="1"/>
          </p:nvGrpSpPr>
          <p:grpSpPr>
            <a:xfrm>
              <a:off x="9905353" y="-499620"/>
              <a:ext cx="507476" cy="234099"/>
              <a:chOff x="9701753" y="-499620"/>
              <a:chExt cx="507476" cy="234099"/>
            </a:xfrm>
          </p:grpSpPr>
          <p:sp>
            <p:nvSpPr>
              <p:cNvPr id="21" name="Ellipse 20">
                <a:extLst>
                  <a:ext uri="{FF2B5EF4-FFF2-40B4-BE49-F238E27FC236}">
                    <a16:creationId xmlns:a16="http://schemas.microsoft.com/office/drawing/2014/main" id="{88798C12-A1D6-8349-B6CF-58AB4701B8DE}"/>
                  </a:ext>
                </a:extLst>
              </p:cNvPr>
              <p:cNvSpPr/>
              <p:nvPr userDrawn="1"/>
            </p:nvSpPr>
            <p:spPr>
              <a:xfrm>
                <a:off x="9701753" y="-499620"/>
                <a:ext cx="234099" cy="234099"/>
              </a:xfrm>
              <a:prstGeom prst="ellipse">
                <a:avLst/>
              </a:prstGeom>
              <a:solidFill>
                <a:schemeClr val="accent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b-NO"/>
              </a:p>
            </p:txBody>
          </p:sp>
          <p:sp>
            <p:nvSpPr>
              <p:cNvPr id="22" name="Ellipse 21">
                <a:extLst>
                  <a:ext uri="{FF2B5EF4-FFF2-40B4-BE49-F238E27FC236}">
                    <a16:creationId xmlns:a16="http://schemas.microsoft.com/office/drawing/2014/main" id="{A65A46A0-61E5-2343-9770-3A5399934BB4}"/>
                  </a:ext>
                </a:extLst>
              </p:cNvPr>
              <p:cNvSpPr/>
              <p:nvPr userDrawn="1"/>
            </p:nvSpPr>
            <p:spPr>
              <a:xfrm>
                <a:off x="9975130" y="-499620"/>
                <a:ext cx="234099" cy="234099"/>
              </a:xfrm>
              <a:prstGeom prst="ellipse">
                <a:avLst/>
              </a:prstGeom>
              <a:solidFill>
                <a:srgbClr val="D8E3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b-NO"/>
              </a:p>
            </p:txBody>
          </p:sp>
        </p:grpSp>
        <p:grpSp>
          <p:nvGrpSpPr>
            <p:cNvPr id="15" name="Gruppe 14">
              <a:extLst>
                <a:ext uri="{FF2B5EF4-FFF2-40B4-BE49-F238E27FC236}">
                  <a16:creationId xmlns:a16="http://schemas.microsoft.com/office/drawing/2014/main" id="{2DA71203-B6FA-5B45-80A5-0C45A6EFE446}"/>
                </a:ext>
              </a:extLst>
            </p:cNvPr>
            <p:cNvGrpSpPr/>
            <p:nvPr userDrawn="1"/>
          </p:nvGrpSpPr>
          <p:grpSpPr>
            <a:xfrm>
              <a:off x="10636238" y="-499620"/>
              <a:ext cx="507476" cy="234099"/>
              <a:chOff x="10314495" y="-499620"/>
              <a:chExt cx="507476" cy="234099"/>
            </a:xfrm>
          </p:grpSpPr>
          <p:sp>
            <p:nvSpPr>
              <p:cNvPr id="19" name="Ellipse 18">
                <a:extLst>
                  <a:ext uri="{FF2B5EF4-FFF2-40B4-BE49-F238E27FC236}">
                    <a16:creationId xmlns:a16="http://schemas.microsoft.com/office/drawing/2014/main" id="{12A09BF1-4A64-ED4E-8010-59E372AFF133}"/>
                  </a:ext>
                </a:extLst>
              </p:cNvPr>
              <p:cNvSpPr/>
              <p:nvPr userDrawn="1"/>
            </p:nvSpPr>
            <p:spPr>
              <a:xfrm>
                <a:off x="10314495" y="-499620"/>
                <a:ext cx="234099" cy="234099"/>
              </a:xfrm>
              <a:prstGeom prst="ellipse">
                <a:avLst/>
              </a:prstGeom>
              <a:solidFill>
                <a:schemeClr val="accent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b-NO"/>
              </a:p>
            </p:txBody>
          </p:sp>
          <p:sp>
            <p:nvSpPr>
              <p:cNvPr id="20" name="Ellipse 19">
                <a:extLst>
                  <a:ext uri="{FF2B5EF4-FFF2-40B4-BE49-F238E27FC236}">
                    <a16:creationId xmlns:a16="http://schemas.microsoft.com/office/drawing/2014/main" id="{CB7B7E58-6336-7343-B9BF-680329253C56}"/>
                  </a:ext>
                </a:extLst>
              </p:cNvPr>
              <p:cNvSpPr/>
              <p:nvPr userDrawn="1"/>
            </p:nvSpPr>
            <p:spPr>
              <a:xfrm>
                <a:off x="10587872" y="-499620"/>
                <a:ext cx="234099" cy="234099"/>
              </a:xfrm>
              <a:prstGeom prst="ellipse">
                <a:avLst/>
              </a:prstGeom>
              <a:solidFill>
                <a:schemeClr val="accent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b-NO"/>
              </a:p>
            </p:txBody>
          </p:sp>
        </p:grpSp>
        <p:grpSp>
          <p:nvGrpSpPr>
            <p:cNvPr id="16" name="Gruppe 15">
              <a:extLst>
                <a:ext uri="{FF2B5EF4-FFF2-40B4-BE49-F238E27FC236}">
                  <a16:creationId xmlns:a16="http://schemas.microsoft.com/office/drawing/2014/main" id="{D5A465B4-7927-A249-B233-AE1BD18DC1ED}"/>
                </a:ext>
              </a:extLst>
            </p:cNvPr>
            <p:cNvGrpSpPr/>
            <p:nvPr userDrawn="1"/>
          </p:nvGrpSpPr>
          <p:grpSpPr>
            <a:xfrm>
              <a:off x="11367122" y="-499620"/>
              <a:ext cx="507476" cy="234099"/>
              <a:chOff x="10974371" y="-499620"/>
              <a:chExt cx="507476" cy="234099"/>
            </a:xfrm>
          </p:grpSpPr>
          <p:sp>
            <p:nvSpPr>
              <p:cNvPr id="17" name="Ellipse 16">
                <a:extLst>
                  <a:ext uri="{FF2B5EF4-FFF2-40B4-BE49-F238E27FC236}">
                    <a16:creationId xmlns:a16="http://schemas.microsoft.com/office/drawing/2014/main" id="{CF34C304-AE0D-0C4A-A24A-333FC975DD97}"/>
                  </a:ext>
                </a:extLst>
              </p:cNvPr>
              <p:cNvSpPr/>
              <p:nvPr userDrawn="1"/>
            </p:nvSpPr>
            <p:spPr>
              <a:xfrm>
                <a:off x="10974371" y="-499620"/>
                <a:ext cx="234099" cy="234099"/>
              </a:xfrm>
              <a:prstGeom prst="ellipse">
                <a:avLst/>
              </a:prstGeom>
              <a:solidFill>
                <a:schemeClr val="accent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b-NO"/>
              </a:p>
            </p:txBody>
          </p:sp>
          <p:sp>
            <p:nvSpPr>
              <p:cNvPr id="18" name="Ellipse 17">
                <a:extLst>
                  <a:ext uri="{FF2B5EF4-FFF2-40B4-BE49-F238E27FC236}">
                    <a16:creationId xmlns:a16="http://schemas.microsoft.com/office/drawing/2014/main" id="{7FFA5E30-73C8-6E4E-AE01-9D4445101027}"/>
                  </a:ext>
                </a:extLst>
              </p:cNvPr>
              <p:cNvSpPr/>
              <p:nvPr userDrawn="1"/>
            </p:nvSpPr>
            <p:spPr>
              <a:xfrm>
                <a:off x="11247748" y="-499620"/>
                <a:ext cx="234099" cy="234099"/>
              </a:xfrm>
              <a:prstGeom prst="ellipse">
                <a:avLst/>
              </a:prstGeom>
              <a:solidFill>
                <a:srgbClr val="66479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b-NO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3381271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0" r:id="rId1"/>
    <p:sldLayoutId id="2147483702" r:id="rId2"/>
    <p:sldLayoutId id="2147483703" r:id="rId3"/>
    <p:sldLayoutId id="2147483704" r:id="rId4"/>
    <p:sldLayoutId id="2147483705" r:id="rId5"/>
    <p:sldLayoutId id="2147483706" r:id="rId6"/>
    <p:sldLayoutId id="2147483707" r:id="rId7"/>
    <p:sldLayoutId id="2147483691" r:id="rId8"/>
    <p:sldLayoutId id="2147483690" r:id="rId9"/>
    <p:sldLayoutId id="2147483661" r:id="rId10"/>
    <p:sldLayoutId id="2147483672" r:id="rId11"/>
    <p:sldLayoutId id="2147483673" r:id="rId12"/>
    <p:sldLayoutId id="2147483674" r:id="rId13"/>
    <p:sldLayoutId id="2147483675" r:id="rId14"/>
    <p:sldLayoutId id="2147483676" r:id="rId15"/>
    <p:sldLayoutId id="2147483677" r:id="rId16"/>
    <p:sldLayoutId id="2147483678" r:id="rId17"/>
    <p:sldLayoutId id="2147483692" r:id="rId18"/>
    <p:sldLayoutId id="2147483679" r:id="rId19"/>
    <p:sldLayoutId id="2147483680" r:id="rId20"/>
    <p:sldLayoutId id="2147483681" r:id="rId21"/>
    <p:sldLayoutId id="2147483682" r:id="rId22"/>
    <p:sldLayoutId id="2147483694" r:id="rId23"/>
    <p:sldLayoutId id="2147483693" r:id="rId24"/>
    <p:sldLayoutId id="2147483698" r:id="rId25"/>
    <p:sldLayoutId id="2147483697" r:id="rId26"/>
    <p:sldLayoutId id="2147483683" r:id="rId27"/>
    <p:sldLayoutId id="2147483699" r:id="rId28"/>
    <p:sldLayoutId id="2147483684" r:id="rId29"/>
    <p:sldLayoutId id="2147483685" r:id="rId30"/>
    <p:sldLayoutId id="2147483695" r:id="rId31"/>
    <p:sldLayoutId id="2147483696" r:id="rId32"/>
    <p:sldLayoutId id="2147483701" r:id="rId33"/>
    <p:sldLayoutId id="2147483663" r:id="rId34"/>
    <p:sldLayoutId id="2147483686" r:id="rId35"/>
    <p:sldLayoutId id="2147483687" r:id="rId36"/>
    <p:sldLayoutId id="2147483688" r:id="rId37"/>
    <p:sldLayoutId id="2147483689" r:id="rId38"/>
  </p:sldLayoutIdLst>
  <p:hf hdr="0" ftr="0" dt="0"/>
  <p:txStyles>
    <p:titleStyle>
      <a:lvl1pPr algn="l" defTabSz="914446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6481" indent="-406481" algn="l" defTabSz="914446" rtl="0" eaLnBrk="1" latinLnBrk="0" hangingPunct="1">
        <a:lnSpc>
          <a:spcPct val="110000"/>
        </a:lnSpc>
        <a:spcBef>
          <a:spcPts val="1200"/>
        </a:spcBef>
        <a:buSzPct val="100000"/>
        <a:buFontTx/>
        <a:buBlip>
          <a:blip r:embed="rId44">
            <a:extLst>
              <a:ext uri="{96DAC541-7B7A-43D3-8B79-37D633B846F1}">
                <asvg:svgBlip xmlns:asvg="http://schemas.microsoft.com/office/drawing/2016/SVG/main" r:embed="rId45"/>
              </a:ext>
            </a:extLst>
          </a:blip>
        </a:buBlip>
        <a:defRPr sz="2300" kern="1200">
          <a:solidFill>
            <a:schemeClr val="tx1"/>
          </a:solidFill>
          <a:latin typeface="+mn-lt"/>
          <a:ea typeface="+mn-ea"/>
          <a:cs typeface="+mn-cs"/>
        </a:defRPr>
      </a:lvl1pPr>
      <a:lvl2pPr marL="809787" indent="-407275" algn="l" defTabSz="914446" rtl="0" eaLnBrk="1" latinLnBrk="0" hangingPunct="1">
        <a:lnSpc>
          <a:spcPct val="110000"/>
        </a:lnSpc>
        <a:spcBef>
          <a:spcPts val="600"/>
        </a:spcBef>
        <a:buClr>
          <a:srgbClr val="94ABF7"/>
        </a:buClr>
        <a:buFont typeface="Arial" panose="020B0604020202020204" pitchFamily="34" charset="0"/>
        <a:buChar char="●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1257300" indent="-447675" algn="l" defTabSz="914446" rtl="0" eaLnBrk="1" latinLnBrk="0" hangingPunct="1">
        <a:lnSpc>
          <a:spcPct val="110000"/>
        </a:lnSpc>
        <a:spcBef>
          <a:spcPts val="600"/>
        </a:spcBef>
        <a:buClr>
          <a:srgbClr val="94ABF7"/>
        </a:buClr>
        <a:buFont typeface="Arial" panose="020B0604020202020204" pitchFamily="34" charset="0"/>
        <a:buChar char="■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793875" indent="-422275" algn="l" defTabSz="914446" rtl="0" eaLnBrk="1" latinLnBrk="0" hangingPunct="1">
        <a:lnSpc>
          <a:spcPct val="110000"/>
        </a:lnSpc>
        <a:spcBef>
          <a:spcPts val="600"/>
        </a:spcBef>
        <a:buClr>
          <a:srgbClr val="94ABF7"/>
        </a:buClr>
        <a:buFont typeface="Arial" panose="020B0604020202020204" pitchFamily="34" charset="0"/>
        <a:buChar char="■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241550" indent="-412750" algn="l" defTabSz="914446" rtl="0" eaLnBrk="1" latinLnBrk="0" hangingPunct="1">
        <a:lnSpc>
          <a:spcPct val="110000"/>
        </a:lnSpc>
        <a:spcBef>
          <a:spcPts val="600"/>
        </a:spcBef>
        <a:buClr>
          <a:srgbClr val="94ABF7"/>
        </a:buClr>
        <a:buFont typeface="Arial" panose="020B0604020202020204" pitchFamily="34" charset="0"/>
        <a:buChar char="■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726" indent="-228611" algn="l" defTabSz="91444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948" indent="-228611" algn="l" defTabSz="91444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171" indent="-228611" algn="l" defTabSz="91444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394" indent="-228611" algn="l" defTabSz="91444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4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23" algn="l" defTabSz="91444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46" algn="l" defTabSz="91444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69" algn="l" defTabSz="91444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91" algn="l" defTabSz="91444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114" algn="l" defTabSz="91444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337" algn="l" defTabSz="91444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560" algn="l" defTabSz="91444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783" algn="l" defTabSz="91444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filip.drozd@r-bup.no" TargetMode="External"/><Relationship Id="rId1" Type="http://schemas.openxmlformats.org/officeDocument/2006/relationships/slideLayout" Target="../slideLayouts/slideLayout1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9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3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3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19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6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1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6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20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26.xml"/><Relationship Id="rId4" Type="http://schemas.openxmlformats.org/officeDocument/2006/relationships/image" Target="../media/image6.sv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19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23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3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9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6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0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6.xml"/><Relationship Id="rId4" Type="http://schemas.openxmlformats.org/officeDocument/2006/relationships/image" Target="../media/image6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tel 4">
            <a:extLst>
              <a:ext uri="{FF2B5EF4-FFF2-40B4-BE49-F238E27FC236}">
                <a16:creationId xmlns:a16="http://schemas.microsoft.com/office/drawing/2014/main" id="{687D1BBC-5E4F-4C03-800E-44401ED8151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020015" y="1153266"/>
            <a:ext cx="10097164" cy="2387600"/>
          </a:xfrm>
        </p:spPr>
        <p:txBody>
          <a:bodyPr>
            <a:noAutofit/>
          </a:bodyPr>
          <a:lstStyle/>
          <a:p>
            <a:r>
              <a:rPr lang="en-US" sz="2800" dirty="0"/>
              <a:t>Identifying and developing strategies for implementation of a guided internet- and mobile-based infant sleep intervention in well-baby and community mental health clinics using group concept mapping</a:t>
            </a:r>
            <a:endParaRPr lang="nb-NO" sz="2800" dirty="0"/>
          </a:p>
        </p:txBody>
      </p:sp>
      <p:sp>
        <p:nvSpPr>
          <p:cNvPr id="7" name="Undertittel 6">
            <a:extLst>
              <a:ext uri="{FF2B5EF4-FFF2-40B4-BE49-F238E27FC236}">
                <a16:creationId xmlns:a16="http://schemas.microsoft.com/office/drawing/2014/main" id="{3369664B-A6B5-4903-968C-C1CF53E40930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nb-NO" dirty="0" err="1"/>
              <a:t>Participant</a:t>
            </a:r>
            <a:r>
              <a:rPr lang="nb-NO" dirty="0"/>
              <a:t> </a:t>
            </a:r>
            <a:r>
              <a:rPr lang="nb-NO" dirty="0" err="1"/>
              <a:t>instructions</a:t>
            </a:r>
            <a:r>
              <a:rPr lang="nb-NO" dirty="0"/>
              <a:t> for </a:t>
            </a:r>
            <a:r>
              <a:rPr lang="nb-NO" dirty="0" err="1"/>
              <a:t>sorting</a:t>
            </a:r>
            <a:r>
              <a:rPr lang="nb-NO" dirty="0"/>
              <a:t>, </a:t>
            </a:r>
            <a:r>
              <a:rPr lang="nb-NO" dirty="0" err="1"/>
              <a:t>rating</a:t>
            </a:r>
            <a:r>
              <a:rPr lang="nb-NO" dirty="0"/>
              <a:t>, and brainstorming </a:t>
            </a:r>
            <a:r>
              <a:rPr lang="nb-NO" dirty="0" err="1"/>
              <a:t>implementation</a:t>
            </a:r>
            <a:r>
              <a:rPr lang="nb-NO" dirty="0"/>
              <a:t> </a:t>
            </a:r>
            <a:r>
              <a:rPr lang="nb-NO" dirty="0" err="1"/>
              <a:t>strategies</a:t>
            </a:r>
            <a:endParaRPr lang="nb-NO" dirty="0"/>
          </a:p>
          <a:p>
            <a:r>
              <a:rPr lang="nb-NO" b="0" dirty="0"/>
              <a:t>Filip Drozd</a:t>
            </a:r>
          </a:p>
          <a:p>
            <a:r>
              <a:rPr lang="nb-NO" b="0" dirty="0"/>
              <a:t>E-mail: </a:t>
            </a:r>
            <a:r>
              <a:rPr lang="nb-NO" b="0" dirty="0">
                <a:hlinkClick r:id="rId2"/>
              </a:rPr>
              <a:t>filip.drozd@r-bup.no</a:t>
            </a:r>
            <a:r>
              <a:rPr lang="nb-NO" b="0" dirty="0"/>
              <a:t> </a:t>
            </a:r>
          </a:p>
          <a:p>
            <a:endParaRPr lang="nb-NO" dirty="0"/>
          </a:p>
        </p:txBody>
      </p:sp>
      <p:sp>
        <p:nvSpPr>
          <p:cNvPr id="2" name="Plassholder for lysbildenummer 1">
            <a:extLst>
              <a:ext uri="{FF2B5EF4-FFF2-40B4-BE49-F238E27FC236}">
                <a16:creationId xmlns:a16="http://schemas.microsoft.com/office/drawing/2014/main" id="{B155BA17-B068-4895-94F5-6F15B9B61DD8}"/>
              </a:ext>
            </a:extLst>
          </p:cNvPr>
          <p:cNvSpPr>
            <a:spLocks noGrp="1"/>
          </p:cNvSpPr>
          <p:nvPr>
            <p:ph type="sldNum" sz="quarter" idx="4294967295"/>
          </p:nvPr>
        </p:nvSpPr>
        <p:spPr>
          <a:xfrm>
            <a:off x="11583988" y="6137275"/>
            <a:ext cx="608012" cy="608013"/>
          </a:xfrm>
        </p:spPr>
        <p:txBody>
          <a:bodyPr/>
          <a:lstStyle/>
          <a:p>
            <a:fld id="{EB47274F-C966-8C46-AFC4-F3A14ECF3B01}" type="slidenum">
              <a:rPr lang="nb-NO" smtClean="0"/>
              <a:t>1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70646430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5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Undertittel 1">
            <a:extLst>
              <a:ext uri="{FF2B5EF4-FFF2-40B4-BE49-F238E27FC236}">
                <a16:creationId xmlns:a16="http://schemas.microsoft.com/office/drawing/2014/main" id="{C9E8D2D5-ED41-424C-8996-468AC4AA8EB7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nb-NO" dirty="0" err="1"/>
              <a:t>Interpreting</a:t>
            </a:r>
            <a:r>
              <a:rPr lang="nb-NO" dirty="0"/>
              <a:t> </a:t>
            </a:r>
            <a:r>
              <a:rPr lang="nb-NO" dirty="0" err="1"/>
              <a:t>the</a:t>
            </a:r>
            <a:r>
              <a:rPr lang="nb-NO" dirty="0"/>
              <a:t> </a:t>
            </a:r>
            <a:r>
              <a:rPr lang="nb-NO" dirty="0" err="1"/>
              <a:t>Findings</a:t>
            </a:r>
            <a:endParaRPr lang="nb-NO" dirty="0"/>
          </a:p>
        </p:txBody>
      </p:sp>
      <p:sp>
        <p:nvSpPr>
          <p:cNvPr id="5" name="Tittel 4">
            <a:extLst>
              <a:ext uri="{FF2B5EF4-FFF2-40B4-BE49-F238E27FC236}">
                <a16:creationId xmlns:a16="http://schemas.microsoft.com/office/drawing/2014/main" id="{AE2D6C44-0600-4569-B047-9F6660F28FB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nb-NO" dirty="0"/>
              <a:t>Group </a:t>
            </a:r>
            <a:r>
              <a:rPr lang="nb-NO" dirty="0" err="1"/>
              <a:t>Discussion</a:t>
            </a:r>
            <a:endParaRPr lang="nb-NO" dirty="0"/>
          </a:p>
        </p:txBody>
      </p:sp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03AF29A7-5751-2041-B29B-827CA14C98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7274F-C966-8C46-AFC4-F3A14ECF3B01}" type="slidenum">
              <a:rPr lang="nb-NO" smtClean="0"/>
              <a:t>10</a:t>
            </a:fld>
            <a:endParaRPr lang="nb-NO"/>
          </a:p>
        </p:txBody>
      </p:sp>
      <p:grpSp>
        <p:nvGrpSpPr>
          <p:cNvPr id="6" name="Gruppe 5">
            <a:extLst>
              <a:ext uri="{FF2B5EF4-FFF2-40B4-BE49-F238E27FC236}">
                <a16:creationId xmlns:a16="http://schemas.microsoft.com/office/drawing/2014/main" id="{F3F58BED-396B-56E1-9103-D68DF98AC94A}"/>
              </a:ext>
            </a:extLst>
          </p:cNvPr>
          <p:cNvGrpSpPr/>
          <p:nvPr/>
        </p:nvGrpSpPr>
        <p:grpSpPr>
          <a:xfrm>
            <a:off x="396023" y="393704"/>
            <a:ext cx="833492" cy="177295"/>
            <a:chOff x="396023" y="393704"/>
            <a:chExt cx="833492" cy="177295"/>
          </a:xfrm>
        </p:grpSpPr>
        <p:sp>
          <p:nvSpPr>
            <p:cNvPr id="7" name="Friform 6">
              <a:extLst>
                <a:ext uri="{FF2B5EF4-FFF2-40B4-BE49-F238E27FC236}">
                  <a16:creationId xmlns:a16="http://schemas.microsoft.com/office/drawing/2014/main" id="{E7DE86B2-F985-39C0-EA1D-FDC143F48A9B}"/>
                </a:ext>
              </a:extLst>
            </p:cNvPr>
            <p:cNvSpPr/>
            <p:nvPr/>
          </p:nvSpPr>
          <p:spPr>
            <a:xfrm>
              <a:off x="936121" y="394334"/>
              <a:ext cx="135024" cy="176665"/>
            </a:xfrm>
            <a:custGeom>
              <a:avLst/>
              <a:gdLst>
                <a:gd name="connsiteX0" fmla="*/ 108524 w 135024"/>
                <a:gd name="connsiteY0" fmla="*/ 0 h 176665"/>
                <a:gd name="connsiteX1" fmla="*/ 108524 w 135024"/>
                <a:gd name="connsiteY1" fmla="*/ 109154 h 176665"/>
                <a:gd name="connsiteX2" fmla="*/ 96536 w 135024"/>
                <a:gd name="connsiteY2" fmla="*/ 138808 h 176665"/>
                <a:gd name="connsiteX3" fmla="*/ 66881 w 135024"/>
                <a:gd name="connsiteY3" fmla="*/ 150796 h 176665"/>
                <a:gd name="connsiteX4" fmla="*/ 37226 w 135024"/>
                <a:gd name="connsiteY4" fmla="*/ 138808 h 176665"/>
                <a:gd name="connsiteX5" fmla="*/ 25238 w 135024"/>
                <a:gd name="connsiteY5" fmla="*/ 109154 h 176665"/>
                <a:gd name="connsiteX6" fmla="*/ 25238 w 135024"/>
                <a:gd name="connsiteY6" fmla="*/ 0 h 176665"/>
                <a:gd name="connsiteX7" fmla="*/ 0 w 135024"/>
                <a:gd name="connsiteY7" fmla="*/ 0 h 176665"/>
                <a:gd name="connsiteX8" fmla="*/ 0 w 135024"/>
                <a:gd name="connsiteY8" fmla="*/ 109154 h 176665"/>
                <a:gd name="connsiteX9" fmla="*/ 5048 w 135024"/>
                <a:gd name="connsiteY9" fmla="*/ 135023 h 176665"/>
                <a:gd name="connsiteX10" fmla="*/ 19560 w 135024"/>
                <a:gd name="connsiteY10" fmla="*/ 157106 h 176665"/>
                <a:gd name="connsiteX11" fmla="*/ 41643 w 135024"/>
                <a:gd name="connsiteY11" fmla="*/ 171617 h 176665"/>
                <a:gd name="connsiteX12" fmla="*/ 67512 w 135024"/>
                <a:gd name="connsiteY12" fmla="*/ 176665 h 176665"/>
                <a:gd name="connsiteX13" fmla="*/ 93382 w 135024"/>
                <a:gd name="connsiteY13" fmla="*/ 171617 h 176665"/>
                <a:gd name="connsiteX14" fmla="*/ 115465 w 135024"/>
                <a:gd name="connsiteY14" fmla="*/ 157106 h 176665"/>
                <a:gd name="connsiteX15" fmla="*/ 129977 w 135024"/>
                <a:gd name="connsiteY15" fmla="*/ 135023 h 176665"/>
                <a:gd name="connsiteX16" fmla="*/ 135025 w 135024"/>
                <a:gd name="connsiteY16" fmla="*/ 109154 h 176665"/>
                <a:gd name="connsiteX17" fmla="*/ 135025 w 135024"/>
                <a:gd name="connsiteY17" fmla="*/ 0 h 176665"/>
                <a:gd name="connsiteX18" fmla="*/ 108524 w 135024"/>
                <a:gd name="connsiteY18" fmla="*/ 0 h 1766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</a:cxnLst>
              <a:rect l="l" t="t" r="r" b="b"/>
              <a:pathLst>
                <a:path w="135024" h="176665">
                  <a:moveTo>
                    <a:pt x="108524" y="0"/>
                  </a:moveTo>
                  <a:lnTo>
                    <a:pt x="108524" y="109154"/>
                  </a:lnTo>
                  <a:cubicBezTo>
                    <a:pt x="108524" y="120511"/>
                    <a:pt x="104108" y="131237"/>
                    <a:pt x="96536" y="138808"/>
                  </a:cubicBezTo>
                  <a:cubicBezTo>
                    <a:pt x="88965" y="146380"/>
                    <a:pt x="78239" y="150796"/>
                    <a:pt x="66881" y="150796"/>
                  </a:cubicBezTo>
                  <a:cubicBezTo>
                    <a:pt x="55524" y="150796"/>
                    <a:pt x="44798" y="146380"/>
                    <a:pt x="37226" y="138808"/>
                  </a:cubicBezTo>
                  <a:cubicBezTo>
                    <a:pt x="29655" y="131237"/>
                    <a:pt x="25238" y="120511"/>
                    <a:pt x="25238" y="109154"/>
                  </a:cubicBezTo>
                  <a:lnTo>
                    <a:pt x="25238" y="0"/>
                  </a:lnTo>
                  <a:lnTo>
                    <a:pt x="0" y="0"/>
                  </a:lnTo>
                  <a:lnTo>
                    <a:pt x="0" y="109154"/>
                  </a:lnTo>
                  <a:cubicBezTo>
                    <a:pt x="0" y="117987"/>
                    <a:pt x="1893" y="126820"/>
                    <a:pt x="5048" y="135023"/>
                  </a:cubicBezTo>
                  <a:cubicBezTo>
                    <a:pt x="8202" y="143225"/>
                    <a:pt x="13250" y="150796"/>
                    <a:pt x="19560" y="157106"/>
                  </a:cubicBezTo>
                  <a:cubicBezTo>
                    <a:pt x="25869" y="163415"/>
                    <a:pt x="33441" y="168463"/>
                    <a:pt x="41643" y="171617"/>
                  </a:cubicBezTo>
                  <a:cubicBezTo>
                    <a:pt x="49846" y="174772"/>
                    <a:pt x="58679" y="176665"/>
                    <a:pt x="67512" y="176665"/>
                  </a:cubicBezTo>
                  <a:cubicBezTo>
                    <a:pt x="76346" y="176665"/>
                    <a:pt x="85179" y="174772"/>
                    <a:pt x="93382" y="171617"/>
                  </a:cubicBezTo>
                  <a:cubicBezTo>
                    <a:pt x="101584" y="168463"/>
                    <a:pt x="109155" y="163415"/>
                    <a:pt x="115465" y="157106"/>
                  </a:cubicBezTo>
                  <a:cubicBezTo>
                    <a:pt x="121775" y="150796"/>
                    <a:pt x="126822" y="143225"/>
                    <a:pt x="129977" y="135023"/>
                  </a:cubicBezTo>
                  <a:cubicBezTo>
                    <a:pt x="133132" y="126820"/>
                    <a:pt x="135025" y="117987"/>
                    <a:pt x="135025" y="109154"/>
                  </a:cubicBezTo>
                  <a:lnTo>
                    <a:pt x="135025" y="0"/>
                  </a:lnTo>
                  <a:lnTo>
                    <a:pt x="108524" y="0"/>
                  </a:lnTo>
                  <a:close/>
                </a:path>
              </a:pathLst>
            </a:custGeom>
            <a:solidFill>
              <a:schemeClr val="bg1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8" name="Friform 7">
              <a:extLst>
                <a:ext uri="{FF2B5EF4-FFF2-40B4-BE49-F238E27FC236}">
                  <a16:creationId xmlns:a16="http://schemas.microsoft.com/office/drawing/2014/main" id="{DD108473-0437-FEAE-0537-7E4BFAEE0A0B}"/>
                </a:ext>
              </a:extLst>
            </p:cNvPr>
            <p:cNvSpPr/>
            <p:nvPr/>
          </p:nvSpPr>
          <p:spPr>
            <a:xfrm>
              <a:off x="630107" y="393704"/>
              <a:ext cx="119881" cy="175403"/>
            </a:xfrm>
            <a:custGeom>
              <a:avLst/>
              <a:gdLst>
                <a:gd name="connsiteX0" fmla="*/ 66881 w 119881"/>
                <a:gd name="connsiteY0" fmla="*/ 76345 h 175403"/>
                <a:gd name="connsiteX1" fmla="*/ 24607 w 119881"/>
                <a:gd name="connsiteY1" fmla="*/ 76345 h 175403"/>
                <a:gd name="connsiteX2" fmla="*/ 24607 w 119881"/>
                <a:gd name="connsiteY2" fmla="*/ 22714 h 175403"/>
                <a:gd name="connsiteX3" fmla="*/ 66881 w 119881"/>
                <a:gd name="connsiteY3" fmla="*/ 22714 h 175403"/>
                <a:gd name="connsiteX4" fmla="*/ 85179 w 119881"/>
                <a:gd name="connsiteY4" fmla="*/ 30285 h 175403"/>
                <a:gd name="connsiteX5" fmla="*/ 92751 w 119881"/>
                <a:gd name="connsiteY5" fmla="*/ 48583 h 175403"/>
                <a:gd name="connsiteX6" fmla="*/ 92751 w 119881"/>
                <a:gd name="connsiteY6" fmla="*/ 50476 h 175403"/>
                <a:gd name="connsiteX7" fmla="*/ 85179 w 119881"/>
                <a:gd name="connsiteY7" fmla="*/ 68773 h 175403"/>
                <a:gd name="connsiteX8" fmla="*/ 66881 w 119881"/>
                <a:gd name="connsiteY8" fmla="*/ 76345 h 175403"/>
                <a:gd name="connsiteX9" fmla="*/ 119882 w 119881"/>
                <a:gd name="connsiteY9" fmla="*/ 49845 h 175403"/>
                <a:gd name="connsiteX10" fmla="*/ 119882 w 119881"/>
                <a:gd name="connsiteY10" fmla="*/ 49845 h 175403"/>
                <a:gd name="connsiteX11" fmla="*/ 105370 w 119881"/>
                <a:gd name="connsiteY11" fmla="*/ 14512 h 175403"/>
                <a:gd name="connsiteX12" fmla="*/ 70667 w 119881"/>
                <a:gd name="connsiteY12" fmla="*/ 0 h 175403"/>
                <a:gd name="connsiteX13" fmla="*/ 0 w 119881"/>
                <a:gd name="connsiteY13" fmla="*/ 0 h 175403"/>
                <a:gd name="connsiteX14" fmla="*/ 0 w 119881"/>
                <a:gd name="connsiteY14" fmla="*/ 174772 h 175403"/>
                <a:gd name="connsiteX15" fmla="*/ 25238 w 119881"/>
                <a:gd name="connsiteY15" fmla="*/ 174772 h 175403"/>
                <a:gd name="connsiteX16" fmla="*/ 25238 w 119881"/>
                <a:gd name="connsiteY16" fmla="*/ 98428 h 175403"/>
                <a:gd name="connsiteX17" fmla="*/ 37226 w 119881"/>
                <a:gd name="connsiteY17" fmla="*/ 98428 h 175403"/>
                <a:gd name="connsiteX18" fmla="*/ 86441 w 119881"/>
                <a:gd name="connsiteY18" fmla="*/ 175403 h 175403"/>
                <a:gd name="connsiteX19" fmla="*/ 117989 w 119881"/>
                <a:gd name="connsiteY19" fmla="*/ 175403 h 175403"/>
                <a:gd name="connsiteX20" fmla="*/ 67512 w 119881"/>
                <a:gd name="connsiteY20" fmla="*/ 98428 h 175403"/>
                <a:gd name="connsiteX21" fmla="*/ 71298 w 119881"/>
                <a:gd name="connsiteY21" fmla="*/ 98428 h 175403"/>
                <a:gd name="connsiteX22" fmla="*/ 90227 w 119881"/>
                <a:gd name="connsiteY22" fmla="*/ 94642 h 175403"/>
                <a:gd name="connsiteX23" fmla="*/ 106001 w 119881"/>
                <a:gd name="connsiteY23" fmla="*/ 83916 h 175403"/>
                <a:gd name="connsiteX24" fmla="*/ 116727 w 119881"/>
                <a:gd name="connsiteY24" fmla="*/ 68142 h 175403"/>
                <a:gd name="connsiteX25" fmla="*/ 119882 w 119881"/>
                <a:gd name="connsiteY25" fmla="*/ 49845 h 1754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</a:cxnLst>
              <a:rect l="l" t="t" r="r" b="b"/>
              <a:pathLst>
                <a:path w="119881" h="175403">
                  <a:moveTo>
                    <a:pt x="66881" y="76345"/>
                  </a:moveTo>
                  <a:lnTo>
                    <a:pt x="24607" y="76345"/>
                  </a:lnTo>
                  <a:lnTo>
                    <a:pt x="24607" y="22714"/>
                  </a:lnTo>
                  <a:lnTo>
                    <a:pt x="66881" y="22714"/>
                  </a:lnTo>
                  <a:cubicBezTo>
                    <a:pt x="73822" y="22714"/>
                    <a:pt x="80762" y="25238"/>
                    <a:pt x="85179" y="30285"/>
                  </a:cubicBezTo>
                  <a:cubicBezTo>
                    <a:pt x="90227" y="35333"/>
                    <a:pt x="92751" y="41642"/>
                    <a:pt x="92751" y="48583"/>
                  </a:cubicBezTo>
                  <a:lnTo>
                    <a:pt x="92751" y="50476"/>
                  </a:lnTo>
                  <a:cubicBezTo>
                    <a:pt x="92751" y="57416"/>
                    <a:pt x="90227" y="64357"/>
                    <a:pt x="85179" y="68773"/>
                  </a:cubicBezTo>
                  <a:cubicBezTo>
                    <a:pt x="80131" y="73190"/>
                    <a:pt x="73822" y="76345"/>
                    <a:pt x="66881" y="76345"/>
                  </a:cubicBezTo>
                  <a:close/>
                  <a:moveTo>
                    <a:pt x="119882" y="49845"/>
                  </a:moveTo>
                  <a:lnTo>
                    <a:pt x="119882" y="49845"/>
                  </a:lnTo>
                  <a:cubicBezTo>
                    <a:pt x="119882" y="36595"/>
                    <a:pt x="114834" y="23976"/>
                    <a:pt x="105370" y="14512"/>
                  </a:cubicBezTo>
                  <a:cubicBezTo>
                    <a:pt x="95905" y="5048"/>
                    <a:pt x="83917" y="0"/>
                    <a:pt x="70667" y="0"/>
                  </a:cubicBezTo>
                  <a:lnTo>
                    <a:pt x="0" y="0"/>
                  </a:lnTo>
                  <a:lnTo>
                    <a:pt x="0" y="174772"/>
                  </a:lnTo>
                  <a:lnTo>
                    <a:pt x="25238" y="174772"/>
                  </a:lnTo>
                  <a:lnTo>
                    <a:pt x="25238" y="98428"/>
                  </a:lnTo>
                  <a:lnTo>
                    <a:pt x="37226" y="98428"/>
                  </a:lnTo>
                  <a:lnTo>
                    <a:pt x="86441" y="175403"/>
                  </a:lnTo>
                  <a:lnTo>
                    <a:pt x="117989" y="175403"/>
                  </a:lnTo>
                  <a:lnTo>
                    <a:pt x="67512" y="98428"/>
                  </a:lnTo>
                  <a:lnTo>
                    <a:pt x="71298" y="98428"/>
                  </a:lnTo>
                  <a:cubicBezTo>
                    <a:pt x="77608" y="98428"/>
                    <a:pt x="83917" y="97166"/>
                    <a:pt x="90227" y="94642"/>
                  </a:cubicBezTo>
                  <a:cubicBezTo>
                    <a:pt x="95905" y="92118"/>
                    <a:pt x="101584" y="88333"/>
                    <a:pt x="106001" y="83916"/>
                  </a:cubicBezTo>
                  <a:cubicBezTo>
                    <a:pt x="110417" y="79499"/>
                    <a:pt x="114203" y="73821"/>
                    <a:pt x="116727" y="68142"/>
                  </a:cubicBezTo>
                  <a:cubicBezTo>
                    <a:pt x="118620" y="62464"/>
                    <a:pt x="119882" y="56154"/>
                    <a:pt x="119882" y="49845"/>
                  </a:cubicBezTo>
                  <a:close/>
                </a:path>
              </a:pathLst>
            </a:custGeom>
            <a:solidFill>
              <a:schemeClr val="bg1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9" name="Friform 8">
              <a:extLst>
                <a:ext uri="{FF2B5EF4-FFF2-40B4-BE49-F238E27FC236}">
                  <a16:creationId xmlns:a16="http://schemas.microsoft.com/office/drawing/2014/main" id="{13D660FD-EFBD-19BB-32F1-F599E1E2F943}"/>
                </a:ext>
              </a:extLst>
            </p:cNvPr>
            <p:cNvSpPr/>
            <p:nvPr/>
          </p:nvSpPr>
          <p:spPr>
            <a:xfrm>
              <a:off x="1109003" y="394334"/>
              <a:ext cx="120512" cy="174772"/>
            </a:xfrm>
            <a:custGeom>
              <a:avLst/>
              <a:gdLst>
                <a:gd name="connsiteX0" fmla="*/ 92751 w 120512"/>
                <a:gd name="connsiteY0" fmla="*/ 49845 h 174772"/>
                <a:gd name="connsiteX1" fmla="*/ 85179 w 120512"/>
                <a:gd name="connsiteY1" fmla="*/ 68142 h 174772"/>
                <a:gd name="connsiteX2" fmla="*/ 66881 w 120512"/>
                <a:gd name="connsiteY2" fmla="*/ 75714 h 174772"/>
                <a:gd name="connsiteX3" fmla="*/ 24607 w 120512"/>
                <a:gd name="connsiteY3" fmla="*/ 75714 h 174772"/>
                <a:gd name="connsiteX4" fmla="*/ 24607 w 120512"/>
                <a:gd name="connsiteY4" fmla="*/ 22083 h 174772"/>
                <a:gd name="connsiteX5" fmla="*/ 66881 w 120512"/>
                <a:gd name="connsiteY5" fmla="*/ 22083 h 174772"/>
                <a:gd name="connsiteX6" fmla="*/ 85179 w 120512"/>
                <a:gd name="connsiteY6" fmla="*/ 29654 h 174772"/>
                <a:gd name="connsiteX7" fmla="*/ 92751 w 120512"/>
                <a:gd name="connsiteY7" fmla="*/ 47952 h 174772"/>
                <a:gd name="connsiteX8" fmla="*/ 92751 w 120512"/>
                <a:gd name="connsiteY8" fmla="*/ 49845 h 174772"/>
                <a:gd name="connsiteX9" fmla="*/ 71298 w 120512"/>
                <a:gd name="connsiteY9" fmla="*/ 0 h 174772"/>
                <a:gd name="connsiteX10" fmla="*/ 0 w 120512"/>
                <a:gd name="connsiteY10" fmla="*/ 0 h 174772"/>
                <a:gd name="connsiteX11" fmla="*/ 0 w 120512"/>
                <a:gd name="connsiteY11" fmla="*/ 174772 h 174772"/>
                <a:gd name="connsiteX12" fmla="*/ 25238 w 120512"/>
                <a:gd name="connsiteY12" fmla="*/ 174772 h 174772"/>
                <a:gd name="connsiteX13" fmla="*/ 25238 w 120512"/>
                <a:gd name="connsiteY13" fmla="*/ 97797 h 174772"/>
                <a:gd name="connsiteX14" fmla="*/ 71298 w 120512"/>
                <a:gd name="connsiteY14" fmla="*/ 97797 h 174772"/>
                <a:gd name="connsiteX15" fmla="*/ 90227 w 120512"/>
                <a:gd name="connsiteY15" fmla="*/ 94011 h 174772"/>
                <a:gd name="connsiteX16" fmla="*/ 106001 w 120512"/>
                <a:gd name="connsiteY16" fmla="*/ 83285 h 174772"/>
                <a:gd name="connsiteX17" fmla="*/ 116727 w 120512"/>
                <a:gd name="connsiteY17" fmla="*/ 67511 h 174772"/>
                <a:gd name="connsiteX18" fmla="*/ 120513 w 120512"/>
                <a:gd name="connsiteY18" fmla="*/ 48583 h 174772"/>
                <a:gd name="connsiteX19" fmla="*/ 120513 w 120512"/>
                <a:gd name="connsiteY19" fmla="*/ 48583 h 174772"/>
                <a:gd name="connsiteX20" fmla="*/ 106001 w 120512"/>
                <a:gd name="connsiteY20" fmla="*/ 13881 h 174772"/>
                <a:gd name="connsiteX21" fmla="*/ 71298 w 120512"/>
                <a:gd name="connsiteY21" fmla="*/ 0 h 1747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</a:cxnLst>
              <a:rect l="l" t="t" r="r" b="b"/>
              <a:pathLst>
                <a:path w="120512" h="174772">
                  <a:moveTo>
                    <a:pt x="92751" y="49845"/>
                  </a:moveTo>
                  <a:cubicBezTo>
                    <a:pt x="92751" y="56785"/>
                    <a:pt x="90227" y="63726"/>
                    <a:pt x="85179" y="68142"/>
                  </a:cubicBezTo>
                  <a:cubicBezTo>
                    <a:pt x="80131" y="72559"/>
                    <a:pt x="73822" y="75714"/>
                    <a:pt x="66881" y="75714"/>
                  </a:cubicBezTo>
                  <a:lnTo>
                    <a:pt x="24607" y="75714"/>
                  </a:lnTo>
                  <a:lnTo>
                    <a:pt x="24607" y="22083"/>
                  </a:lnTo>
                  <a:lnTo>
                    <a:pt x="66881" y="22083"/>
                  </a:lnTo>
                  <a:cubicBezTo>
                    <a:pt x="73822" y="22083"/>
                    <a:pt x="80762" y="24607"/>
                    <a:pt x="85179" y="29654"/>
                  </a:cubicBezTo>
                  <a:cubicBezTo>
                    <a:pt x="89596" y="34702"/>
                    <a:pt x="92751" y="41012"/>
                    <a:pt x="92751" y="47952"/>
                  </a:cubicBezTo>
                  <a:lnTo>
                    <a:pt x="92751" y="49845"/>
                  </a:lnTo>
                  <a:close/>
                  <a:moveTo>
                    <a:pt x="71298" y="0"/>
                  </a:moveTo>
                  <a:lnTo>
                    <a:pt x="0" y="0"/>
                  </a:lnTo>
                  <a:lnTo>
                    <a:pt x="0" y="174772"/>
                  </a:lnTo>
                  <a:lnTo>
                    <a:pt x="25238" y="174772"/>
                  </a:lnTo>
                  <a:lnTo>
                    <a:pt x="25238" y="97797"/>
                  </a:lnTo>
                  <a:lnTo>
                    <a:pt x="71298" y="97797"/>
                  </a:lnTo>
                  <a:cubicBezTo>
                    <a:pt x="77608" y="97797"/>
                    <a:pt x="83917" y="96535"/>
                    <a:pt x="90227" y="94011"/>
                  </a:cubicBezTo>
                  <a:cubicBezTo>
                    <a:pt x="96536" y="91487"/>
                    <a:pt x="101584" y="87702"/>
                    <a:pt x="106001" y="83285"/>
                  </a:cubicBezTo>
                  <a:cubicBezTo>
                    <a:pt x="110417" y="78868"/>
                    <a:pt x="114203" y="73190"/>
                    <a:pt x="116727" y="67511"/>
                  </a:cubicBezTo>
                  <a:cubicBezTo>
                    <a:pt x="119251" y="61833"/>
                    <a:pt x="120513" y="55523"/>
                    <a:pt x="120513" y="48583"/>
                  </a:cubicBezTo>
                  <a:lnTo>
                    <a:pt x="120513" y="48583"/>
                  </a:lnTo>
                  <a:cubicBezTo>
                    <a:pt x="120513" y="35333"/>
                    <a:pt x="115465" y="23345"/>
                    <a:pt x="106001" y="13881"/>
                  </a:cubicBezTo>
                  <a:cubicBezTo>
                    <a:pt x="96536" y="5048"/>
                    <a:pt x="83917" y="0"/>
                    <a:pt x="71298" y="0"/>
                  </a:cubicBezTo>
                  <a:close/>
                </a:path>
              </a:pathLst>
            </a:custGeom>
            <a:solidFill>
              <a:schemeClr val="bg1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0" name="Friform 9">
              <a:extLst>
                <a:ext uri="{FF2B5EF4-FFF2-40B4-BE49-F238E27FC236}">
                  <a16:creationId xmlns:a16="http://schemas.microsoft.com/office/drawing/2014/main" id="{AE80D1ED-9C2F-4639-6F01-6EC3BB88EBFB}"/>
                </a:ext>
              </a:extLst>
            </p:cNvPr>
            <p:cNvSpPr/>
            <p:nvPr/>
          </p:nvSpPr>
          <p:spPr>
            <a:xfrm>
              <a:off x="782168" y="394334"/>
              <a:ext cx="120354" cy="174772"/>
            </a:xfrm>
            <a:custGeom>
              <a:avLst/>
              <a:gdLst>
                <a:gd name="connsiteX0" fmla="*/ 93381 w 120354"/>
                <a:gd name="connsiteY0" fmla="*/ 49845 h 174772"/>
                <a:gd name="connsiteX1" fmla="*/ 91489 w 120354"/>
                <a:gd name="connsiteY1" fmla="*/ 59940 h 174772"/>
                <a:gd name="connsiteX2" fmla="*/ 85810 w 120354"/>
                <a:gd name="connsiteY2" fmla="*/ 68142 h 174772"/>
                <a:gd name="connsiteX3" fmla="*/ 77608 w 120354"/>
                <a:gd name="connsiteY3" fmla="*/ 73821 h 174772"/>
                <a:gd name="connsiteX4" fmla="*/ 67512 w 120354"/>
                <a:gd name="connsiteY4" fmla="*/ 75714 h 174772"/>
                <a:gd name="connsiteX5" fmla="*/ 25238 w 120354"/>
                <a:gd name="connsiteY5" fmla="*/ 75714 h 174772"/>
                <a:gd name="connsiteX6" fmla="*/ 25238 w 120354"/>
                <a:gd name="connsiteY6" fmla="*/ 22083 h 174772"/>
                <a:gd name="connsiteX7" fmla="*/ 67512 w 120354"/>
                <a:gd name="connsiteY7" fmla="*/ 22083 h 174772"/>
                <a:gd name="connsiteX8" fmla="*/ 85810 w 120354"/>
                <a:gd name="connsiteY8" fmla="*/ 29654 h 174772"/>
                <a:gd name="connsiteX9" fmla="*/ 93381 w 120354"/>
                <a:gd name="connsiteY9" fmla="*/ 47952 h 174772"/>
                <a:gd name="connsiteX10" fmla="*/ 93381 w 120354"/>
                <a:gd name="connsiteY10" fmla="*/ 49845 h 174772"/>
                <a:gd name="connsiteX11" fmla="*/ 93381 w 120354"/>
                <a:gd name="connsiteY11" fmla="*/ 126189 h 174772"/>
                <a:gd name="connsiteX12" fmla="*/ 85810 w 120354"/>
                <a:gd name="connsiteY12" fmla="*/ 144487 h 174772"/>
                <a:gd name="connsiteX13" fmla="*/ 67512 w 120354"/>
                <a:gd name="connsiteY13" fmla="*/ 152058 h 174772"/>
                <a:gd name="connsiteX14" fmla="*/ 25238 w 120354"/>
                <a:gd name="connsiteY14" fmla="*/ 152058 h 174772"/>
                <a:gd name="connsiteX15" fmla="*/ 25238 w 120354"/>
                <a:gd name="connsiteY15" fmla="*/ 98428 h 174772"/>
                <a:gd name="connsiteX16" fmla="*/ 67512 w 120354"/>
                <a:gd name="connsiteY16" fmla="*/ 98428 h 174772"/>
                <a:gd name="connsiteX17" fmla="*/ 85810 w 120354"/>
                <a:gd name="connsiteY17" fmla="*/ 105999 h 174772"/>
                <a:gd name="connsiteX18" fmla="*/ 93381 w 120354"/>
                <a:gd name="connsiteY18" fmla="*/ 124296 h 174772"/>
                <a:gd name="connsiteX19" fmla="*/ 93381 w 120354"/>
                <a:gd name="connsiteY19" fmla="*/ 126189 h 174772"/>
                <a:gd name="connsiteX20" fmla="*/ 119882 w 120354"/>
                <a:gd name="connsiteY20" fmla="*/ 48583 h 174772"/>
                <a:gd name="connsiteX21" fmla="*/ 105370 w 120354"/>
                <a:gd name="connsiteY21" fmla="*/ 14512 h 174772"/>
                <a:gd name="connsiteX22" fmla="*/ 71298 w 120354"/>
                <a:gd name="connsiteY22" fmla="*/ 0 h 174772"/>
                <a:gd name="connsiteX23" fmla="*/ 0 w 120354"/>
                <a:gd name="connsiteY23" fmla="*/ 0 h 174772"/>
                <a:gd name="connsiteX24" fmla="*/ 0 w 120354"/>
                <a:gd name="connsiteY24" fmla="*/ 174772 h 174772"/>
                <a:gd name="connsiteX25" fmla="*/ 71929 w 120354"/>
                <a:gd name="connsiteY25" fmla="*/ 174772 h 174772"/>
                <a:gd name="connsiteX26" fmla="*/ 100322 w 120354"/>
                <a:gd name="connsiteY26" fmla="*/ 165308 h 174772"/>
                <a:gd name="connsiteX27" fmla="*/ 117989 w 120354"/>
                <a:gd name="connsiteY27" fmla="*/ 141332 h 174772"/>
                <a:gd name="connsiteX28" fmla="*/ 117989 w 120354"/>
                <a:gd name="connsiteY28" fmla="*/ 111678 h 174772"/>
                <a:gd name="connsiteX29" fmla="*/ 100322 w 120354"/>
                <a:gd name="connsiteY29" fmla="*/ 87702 h 174772"/>
                <a:gd name="connsiteX30" fmla="*/ 114834 w 120354"/>
                <a:gd name="connsiteY30" fmla="*/ 70666 h 174772"/>
                <a:gd name="connsiteX31" fmla="*/ 119882 w 120354"/>
                <a:gd name="connsiteY31" fmla="*/ 48583 h 1747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</a:cxnLst>
              <a:rect l="l" t="t" r="r" b="b"/>
              <a:pathLst>
                <a:path w="120354" h="174772">
                  <a:moveTo>
                    <a:pt x="93381" y="49845"/>
                  </a:moveTo>
                  <a:cubicBezTo>
                    <a:pt x="93381" y="53000"/>
                    <a:pt x="92751" y="56785"/>
                    <a:pt x="91489" y="59940"/>
                  </a:cubicBezTo>
                  <a:cubicBezTo>
                    <a:pt x="90227" y="63095"/>
                    <a:pt x="88334" y="66249"/>
                    <a:pt x="85810" y="68142"/>
                  </a:cubicBezTo>
                  <a:cubicBezTo>
                    <a:pt x="83286" y="70666"/>
                    <a:pt x="80762" y="72559"/>
                    <a:pt x="77608" y="73821"/>
                  </a:cubicBezTo>
                  <a:cubicBezTo>
                    <a:pt x="74453" y="75083"/>
                    <a:pt x="71298" y="75714"/>
                    <a:pt x="67512" y="75714"/>
                  </a:cubicBezTo>
                  <a:lnTo>
                    <a:pt x="25238" y="75714"/>
                  </a:lnTo>
                  <a:lnTo>
                    <a:pt x="25238" y="22083"/>
                  </a:lnTo>
                  <a:lnTo>
                    <a:pt x="67512" y="22083"/>
                  </a:lnTo>
                  <a:cubicBezTo>
                    <a:pt x="74453" y="22083"/>
                    <a:pt x="81393" y="24607"/>
                    <a:pt x="85810" y="29654"/>
                  </a:cubicBezTo>
                  <a:cubicBezTo>
                    <a:pt x="90227" y="34702"/>
                    <a:pt x="93381" y="41012"/>
                    <a:pt x="93381" y="47952"/>
                  </a:cubicBezTo>
                  <a:lnTo>
                    <a:pt x="93381" y="49845"/>
                  </a:lnTo>
                  <a:close/>
                  <a:moveTo>
                    <a:pt x="93381" y="126189"/>
                  </a:moveTo>
                  <a:cubicBezTo>
                    <a:pt x="93381" y="133130"/>
                    <a:pt x="90858" y="140070"/>
                    <a:pt x="85810" y="144487"/>
                  </a:cubicBezTo>
                  <a:cubicBezTo>
                    <a:pt x="80762" y="149534"/>
                    <a:pt x="74453" y="152058"/>
                    <a:pt x="67512" y="152058"/>
                  </a:cubicBezTo>
                  <a:lnTo>
                    <a:pt x="25238" y="152058"/>
                  </a:lnTo>
                  <a:lnTo>
                    <a:pt x="25238" y="98428"/>
                  </a:lnTo>
                  <a:lnTo>
                    <a:pt x="67512" y="98428"/>
                  </a:lnTo>
                  <a:cubicBezTo>
                    <a:pt x="74453" y="98428"/>
                    <a:pt x="81393" y="100951"/>
                    <a:pt x="85810" y="105999"/>
                  </a:cubicBezTo>
                  <a:cubicBezTo>
                    <a:pt x="90858" y="111047"/>
                    <a:pt x="93381" y="117356"/>
                    <a:pt x="93381" y="124296"/>
                  </a:cubicBezTo>
                  <a:lnTo>
                    <a:pt x="93381" y="126189"/>
                  </a:lnTo>
                  <a:close/>
                  <a:moveTo>
                    <a:pt x="119882" y="48583"/>
                  </a:moveTo>
                  <a:cubicBezTo>
                    <a:pt x="119882" y="35964"/>
                    <a:pt x="114834" y="23345"/>
                    <a:pt x="105370" y="14512"/>
                  </a:cubicBezTo>
                  <a:cubicBezTo>
                    <a:pt x="96536" y="5679"/>
                    <a:pt x="83917" y="0"/>
                    <a:pt x="71298" y="0"/>
                  </a:cubicBezTo>
                  <a:lnTo>
                    <a:pt x="0" y="0"/>
                  </a:lnTo>
                  <a:lnTo>
                    <a:pt x="0" y="174772"/>
                  </a:lnTo>
                  <a:lnTo>
                    <a:pt x="71929" y="174772"/>
                  </a:lnTo>
                  <a:cubicBezTo>
                    <a:pt x="82024" y="174772"/>
                    <a:pt x="92120" y="171617"/>
                    <a:pt x="100322" y="165308"/>
                  </a:cubicBezTo>
                  <a:cubicBezTo>
                    <a:pt x="108524" y="159629"/>
                    <a:pt x="114834" y="150796"/>
                    <a:pt x="117989" y="141332"/>
                  </a:cubicBezTo>
                  <a:cubicBezTo>
                    <a:pt x="121144" y="131868"/>
                    <a:pt x="121144" y="121142"/>
                    <a:pt x="117989" y="111678"/>
                  </a:cubicBezTo>
                  <a:cubicBezTo>
                    <a:pt x="114834" y="102213"/>
                    <a:pt x="108524" y="93380"/>
                    <a:pt x="100322" y="87702"/>
                  </a:cubicBezTo>
                  <a:cubicBezTo>
                    <a:pt x="106632" y="83285"/>
                    <a:pt x="111679" y="77606"/>
                    <a:pt x="114834" y="70666"/>
                  </a:cubicBezTo>
                  <a:cubicBezTo>
                    <a:pt x="117989" y="63726"/>
                    <a:pt x="119882" y="56154"/>
                    <a:pt x="119882" y="48583"/>
                  </a:cubicBezTo>
                  <a:close/>
                </a:path>
              </a:pathLst>
            </a:custGeom>
            <a:solidFill>
              <a:schemeClr val="bg1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1" name="Friform 10">
              <a:extLst>
                <a:ext uri="{FF2B5EF4-FFF2-40B4-BE49-F238E27FC236}">
                  <a16:creationId xmlns:a16="http://schemas.microsoft.com/office/drawing/2014/main" id="{8DFD9E24-A84E-FD5E-3C22-1D7A1E9EA571}"/>
                </a:ext>
              </a:extLst>
            </p:cNvPr>
            <p:cNvSpPr/>
            <p:nvPr/>
          </p:nvSpPr>
          <p:spPr>
            <a:xfrm>
              <a:off x="454701" y="393704"/>
              <a:ext cx="116095" cy="116725"/>
            </a:xfrm>
            <a:custGeom>
              <a:avLst/>
              <a:gdLst>
                <a:gd name="connsiteX0" fmla="*/ 58048 w 116095"/>
                <a:gd name="connsiteY0" fmla="*/ 0 h 116725"/>
                <a:gd name="connsiteX1" fmla="*/ 99060 w 116095"/>
                <a:gd name="connsiteY1" fmla="*/ 17036 h 116725"/>
                <a:gd name="connsiteX2" fmla="*/ 116096 w 116095"/>
                <a:gd name="connsiteY2" fmla="*/ 58047 h 116725"/>
                <a:gd name="connsiteX3" fmla="*/ 116096 w 116095"/>
                <a:gd name="connsiteY3" fmla="*/ 116725 h 116725"/>
                <a:gd name="connsiteX4" fmla="*/ 0 w 116095"/>
                <a:gd name="connsiteY4" fmla="*/ 116725 h 116725"/>
                <a:gd name="connsiteX5" fmla="*/ 0 w 116095"/>
                <a:gd name="connsiteY5" fmla="*/ 58678 h 116725"/>
                <a:gd name="connsiteX6" fmla="*/ 17036 w 116095"/>
                <a:gd name="connsiteY6" fmla="*/ 17667 h 116725"/>
                <a:gd name="connsiteX7" fmla="*/ 58048 w 116095"/>
                <a:gd name="connsiteY7" fmla="*/ 0 h 1167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116095" h="116725">
                  <a:moveTo>
                    <a:pt x="58048" y="0"/>
                  </a:moveTo>
                  <a:cubicBezTo>
                    <a:pt x="73822" y="0"/>
                    <a:pt x="88334" y="6309"/>
                    <a:pt x="99060" y="17036"/>
                  </a:cubicBezTo>
                  <a:cubicBezTo>
                    <a:pt x="109786" y="27762"/>
                    <a:pt x="116096" y="42904"/>
                    <a:pt x="116096" y="58047"/>
                  </a:cubicBezTo>
                  <a:lnTo>
                    <a:pt x="116096" y="116725"/>
                  </a:lnTo>
                  <a:lnTo>
                    <a:pt x="0" y="116725"/>
                  </a:lnTo>
                  <a:lnTo>
                    <a:pt x="0" y="58678"/>
                  </a:lnTo>
                  <a:cubicBezTo>
                    <a:pt x="0" y="42904"/>
                    <a:pt x="6310" y="28393"/>
                    <a:pt x="17036" y="17667"/>
                  </a:cubicBezTo>
                  <a:cubicBezTo>
                    <a:pt x="27762" y="6940"/>
                    <a:pt x="42905" y="0"/>
                    <a:pt x="58048" y="0"/>
                  </a:cubicBezTo>
                  <a:close/>
                </a:path>
              </a:pathLst>
            </a:custGeom>
            <a:solidFill>
              <a:srgbClr val="E31836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2" name="Friform 11">
              <a:extLst>
                <a:ext uri="{FF2B5EF4-FFF2-40B4-BE49-F238E27FC236}">
                  <a16:creationId xmlns:a16="http://schemas.microsoft.com/office/drawing/2014/main" id="{1CF8E28E-A836-6EC6-D886-AD078D07F10F}"/>
                </a:ext>
              </a:extLst>
            </p:cNvPr>
            <p:cNvSpPr/>
            <p:nvPr/>
          </p:nvSpPr>
          <p:spPr>
            <a:xfrm>
              <a:off x="396023" y="452382"/>
              <a:ext cx="58678" cy="116094"/>
            </a:xfrm>
            <a:custGeom>
              <a:avLst/>
              <a:gdLst>
                <a:gd name="connsiteX0" fmla="*/ 58679 w 58678"/>
                <a:gd name="connsiteY0" fmla="*/ 0 h 116094"/>
                <a:gd name="connsiteX1" fmla="*/ 17667 w 58678"/>
                <a:gd name="connsiteY1" fmla="*/ 17036 h 116094"/>
                <a:gd name="connsiteX2" fmla="*/ 0 w 58678"/>
                <a:gd name="connsiteY2" fmla="*/ 58047 h 116094"/>
                <a:gd name="connsiteX3" fmla="*/ 17036 w 58678"/>
                <a:gd name="connsiteY3" fmla="*/ 99059 h 116094"/>
                <a:gd name="connsiteX4" fmla="*/ 58048 w 58678"/>
                <a:gd name="connsiteY4" fmla="*/ 116094 h 116094"/>
                <a:gd name="connsiteX5" fmla="*/ 58048 w 58678"/>
                <a:gd name="connsiteY5" fmla="*/ 116094 h 116094"/>
                <a:gd name="connsiteX6" fmla="*/ 58048 w 58678"/>
                <a:gd name="connsiteY6" fmla="*/ 116094 h 116094"/>
                <a:gd name="connsiteX7" fmla="*/ 58048 w 58678"/>
                <a:gd name="connsiteY7" fmla="*/ 0 h 1160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58678" h="116094">
                  <a:moveTo>
                    <a:pt x="58679" y="0"/>
                  </a:moveTo>
                  <a:cubicBezTo>
                    <a:pt x="42905" y="0"/>
                    <a:pt x="28393" y="6309"/>
                    <a:pt x="17667" y="17036"/>
                  </a:cubicBezTo>
                  <a:cubicBezTo>
                    <a:pt x="6310" y="27762"/>
                    <a:pt x="0" y="42904"/>
                    <a:pt x="0" y="58047"/>
                  </a:cubicBezTo>
                  <a:cubicBezTo>
                    <a:pt x="0" y="73821"/>
                    <a:pt x="6310" y="88332"/>
                    <a:pt x="17036" y="99059"/>
                  </a:cubicBezTo>
                  <a:cubicBezTo>
                    <a:pt x="27762" y="109785"/>
                    <a:pt x="42905" y="116094"/>
                    <a:pt x="58048" y="116094"/>
                  </a:cubicBezTo>
                  <a:cubicBezTo>
                    <a:pt x="58048" y="116094"/>
                    <a:pt x="58048" y="116094"/>
                    <a:pt x="58048" y="116094"/>
                  </a:cubicBezTo>
                  <a:lnTo>
                    <a:pt x="58048" y="116094"/>
                  </a:lnTo>
                  <a:lnTo>
                    <a:pt x="58048" y="0"/>
                  </a:lnTo>
                  <a:close/>
                </a:path>
              </a:pathLst>
            </a:custGeom>
            <a:solidFill>
              <a:srgbClr val="728EE6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3" name="Friform 12">
              <a:extLst>
                <a:ext uri="{FF2B5EF4-FFF2-40B4-BE49-F238E27FC236}">
                  <a16:creationId xmlns:a16="http://schemas.microsoft.com/office/drawing/2014/main" id="{AD7DA5FB-7A04-D730-4524-68224255B8B1}"/>
                </a:ext>
              </a:extLst>
            </p:cNvPr>
            <p:cNvSpPr/>
            <p:nvPr/>
          </p:nvSpPr>
          <p:spPr>
            <a:xfrm>
              <a:off x="454701" y="510429"/>
              <a:ext cx="116726" cy="58047"/>
            </a:xfrm>
            <a:custGeom>
              <a:avLst/>
              <a:gdLst>
                <a:gd name="connsiteX0" fmla="*/ 116727 w 116726"/>
                <a:gd name="connsiteY0" fmla="*/ 0 h 58047"/>
                <a:gd name="connsiteX1" fmla="*/ 58048 w 116726"/>
                <a:gd name="connsiteY1" fmla="*/ 0 h 58047"/>
                <a:gd name="connsiteX2" fmla="*/ 41012 w 116726"/>
                <a:gd name="connsiteY2" fmla="*/ 41012 h 58047"/>
                <a:gd name="connsiteX3" fmla="*/ 0 w 116726"/>
                <a:gd name="connsiteY3" fmla="*/ 58047 h 58047"/>
                <a:gd name="connsiteX4" fmla="*/ 116727 w 116726"/>
                <a:gd name="connsiteY4" fmla="*/ 58047 h 58047"/>
                <a:gd name="connsiteX5" fmla="*/ 116727 w 116726"/>
                <a:gd name="connsiteY5" fmla="*/ 0 h 580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116726" h="58047">
                  <a:moveTo>
                    <a:pt x="116727" y="0"/>
                  </a:moveTo>
                  <a:lnTo>
                    <a:pt x="58048" y="0"/>
                  </a:lnTo>
                  <a:cubicBezTo>
                    <a:pt x="58048" y="15774"/>
                    <a:pt x="51738" y="30285"/>
                    <a:pt x="41012" y="41012"/>
                  </a:cubicBezTo>
                  <a:cubicBezTo>
                    <a:pt x="30286" y="51738"/>
                    <a:pt x="15143" y="58047"/>
                    <a:pt x="0" y="58047"/>
                  </a:cubicBezTo>
                  <a:lnTo>
                    <a:pt x="116727" y="58047"/>
                  </a:lnTo>
                  <a:lnTo>
                    <a:pt x="116727" y="0"/>
                  </a:lnTo>
                  <a:close/>
                </a:path>
              </a:pathLst>
            </a:custGeom>
            <a:solidFill>
              <a:srgbClr val="C2CFF4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4" name="Friform 13">
              <a:extLst>
                <a:ext uri="{FF2B5EF4-FFF2-40B4-BE49-F238E27FC236}">
                  <a16:creationId xmlns:a16="http://schemas.microsoft.com/office/drawing/2014/main" id="{24D5CA76-9DE6-594C-1D9C-DA58B22904CC}"/>
                </a:ext>
              </a:extLst>
            </p:cNvPr>
            <p:cNvSpPr/>
            <p:nvPr/>
          </p:nvSpPr>
          <p:spPr>
            <a:xfrm>
              <a:off x="454701" y="510429"/>
              <a:ext cx="58047" cy="58678"/>
            </a:xfrm>
            <a:custGeom>
              <a:avLst/>
              <a:gdLst>
                <a:gd name="connsiteX0" fmla="*/ 58048 w 58047"/>
                <a:gd name="connsiteY0" fmla="*/ 0 h 58678"/>
                <a:gd name="connsiteX1" fmla="*/ 0 w 58047"/>
                <a:gd name="connsiteY1" fmla="*/ 0 h 58678"/>
                <a:gd name="connsiteX2" fmla="*/ 0 w 58047"/>
                <a:gd name="connsiteY2" fmla="*/ 58678 h 58678"/>
                <a:gd name="connsiteX3" fmla="*/ 0 w 58047"/>
                <a:gd name="connsiteY3" fmla="*/ 58678 h 58678"/>
                <a:gd name="connsiteX4" fmla="*/ 41012 w 58047"/>
                <a:gd name="connsiteY4" fmla="*/ 41642 h 58678"/>
                <a:gd name="connsiteX5" fmla="*/ 58048 w 58047"/>
                <a:gd name="connsiteY5" fmla="*/ 0 h 5867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8047" h="58678">
                  <a:moveTo>
                    <a:pt x="58048" y="0"/>
                  </a:moveTo>
                  <a:lnTo>
                    <a:pt x="0" y="0"/>
                  </a:lnTo>
                  <a:lnTo>
                    <a:pt x="0" y="58678"/>
                  </a:lnTo>
                  <a:lnTo>
                    <a:pt x="0" y="58678"/>
                  </a:lnTo>
                  <a:cubicBezTo>
                    <a:pt x="15774" y="58678"/>
                    <a:pt x="30286" y="52369"/>
                    <a:pt x="41012" y="41642"/>
                  </a:cubicBezTo>
                  <a:cubicBezTo>
                    <a:pt x="52369" y="30285"/>
                    <a:pt x="58048" y="15774"/>
                    <a:pt x="58048" y="0"/>
                  </a:cubicBezTo>
                  <a:close/>
                </a:path>
              </a:pathLst>
            </a:custGeom>
            <a:solidFill>
              <a:srgbClr val="355EDB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5" name="Friform 14">
              <a:extLst>
                <a:ext uri="{FF2B5EF4-FFF2-40B4-BE49-F238E27FC236}">
                  <a16:creationId xmlns:a16="http://schemas.microsoft.com/office/drawing/2014/main" id="{C18510F3-49A9-FACD-B6A6-1A46F89C69FC}"/>
                </a:ext>
              </a:extLst>
            </p:cNvPr>
            <p:cNvSpPr/>
            <p:nvPr/>
          </p:nvSpPr>
          <p:spPr>
            <a:xfrm>
              <a:off x="454701" y="452382"/>
              <a:ext cx="116726" cy="58678"/>
            </a:xfrm>
            <a:custGeom>
              <a:avLst/>
              <a:gdLst>
                <a:gd name="connsiteX0" fmla="*/ 0 w 116726"/>
                <a:gd name="connsiteY0" fmla="*/ 0 h 58678"/>
                <a:gd name="connsiteX1" fmla="*/ 116727 w 116726"/>
                <a:gd name="connsiteY1" fmla="*/ 0 h 58678"/>
                <a:gd name="connsiteX2" fmla="*/ 116727 w 116726"/>
                <a:gd name="connsiteY2" fmla="*/ 58678 h 58678"/>
                <a:gd name="connsiteX3" fmla="*/ 0 w 116726"/>
                <a:gd name="connsiteY3" fmla="*/ 58678 h 5867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16726" h="58678">
                  <a:moveTo>
                    <a:pt x="0" y="0"/>
                  </a:moveTo>
                  <a:lnTo>
                    <a:pt x="116727" y="0"/>
                  </a:lnTo>
                  <a:lnTo>
                    <a:pt x="116727" y="58678"/>
                  </a:lnTo>
                  <a:lnTo>
                    <a:pt x="0" y="58678"/>
                  </a:lnTo>
                  <a:close/>
                </a:path>
              </a:pathLst>
            </a:custGeom>
            <a:solidFill>
              <a:srgbClr val="C21536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</p:grpSp>
    </p:spTree>
    <p:extLst>
      <p:ext uri="{BB962C8B-B14F-4D97-AF65-F5344CB8AC3E}">
        <p14:creationId xmlns:p14="http://schemas.microsoft.com/office/powerpoint/2010/main" val="357324868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5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tel 2">
            <a:extLst>
              <a:ext uri="{FF2B5EF4-FFF2-40B4-BE49-F238E27FC236}">
                <a16:creationId xmlns:a16="http://schemas.microsoft.com/office/drawing/2014/main" id="{6BAA7D64-5519-8859-B9F2-21FE8FCAEF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dirty="0">
                <a:solidFill>
                  <a:schemeClr val="bg1"/>
                </a:solidFill>
              </a:rPr>
              <a:t>Questions for </a:t>
            </a:r>
            <a:r>
              <a:rPr lang="nb-NO" dirty="0" err="1">
                <a:solidFill>
                  <a:schemeClr val="bg1"/>
                </a:solidFill>
              </a:rPr>
              <a:t>discussion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E361ADA8-375E-9B1A-96CF-E8E8EDFBE9C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nb-NO" dirty="0">
                <a:solidFill>
                  <a:schemeClr val="bg1"/>
                </a:solidFill>
              </a:rPr>
              <a:t>Are </a:t>
            </a:r>
            <a:r>
              <a:rPr lang="nb-NO" dirty="0" err="1">
                <a:solidFill>
                  <a:schemeClr val="bg1"/>
                </a:solidFill>
              </a:rPr>
              <a:t>the</a:t>
            </a:r>
            <a:r>
              <a:rPr lang="nb-NO" dirty="0">
                <a:solidFill>
                  <a:schemeClr val="bg1"/>
                </a:solidFill>
              </a:rPr>
              <a:t> </a:t>
            </a:r>
            <a:r>
              <a:rPr lang="nb-NO" dirty="0" err="1">
                <a:solidFill>
                  <a:schemeClr val="bg1"/>
                </a:solidFill>
              </a:rPr>
              <a:t>results</a:t>
            </a:r>
            <a:r>
              <a:rPr lang="nb-NO" dirty="0">
                <a:solidFill>
                  <a:schemeClr val="bg1"/>
                </a:solidFill>
              </a:rPr>
              <a:t> surprising to </a:t>
            </a:r>
            <a:r>
              <a:rPr lang="nb-NO" dirty="0" err="1">
                <a:solidFill>
                  <a:schemeClr val="bg1"/>
                </a:solidFill>
              </a:rPr>
              <a:t>you</a:t>
            </a:r>
            <a:r>
              <a:rPr lang="nb-NO" dirty="0">
                <a:solidFill>
                  <a:schemeClr val="bg1"/>
                </a:solidFill>
              </a:rPr>
              <a:t>? If so, </a:t>
            </a:r>
            <a:r>
              <a:rPr lang="nb-NO" dirty="0" err="1">
                <a:solidFill>
                  <a:schemeClr val="bg1"/>
                </a:solidFill>
              </a:rPr>
              <a:t>how</a:t>
            </a:r>
            <a:r>
              <a:rPr lang="nb-NO" dirty="0">
                <a:solidFill>
                  <a:schemeClr val="bg1"/>
                </a:solidFill>
              </a:rPr>
              <a:t>?</a:t>
            </a:r>
          </a:p>
          <a:p>
            <a:r>
              <a:rPr lang="en-US" dirty="0">
                <a:solidFill>
                  <a:schemeClr val="bg1"/>
                </a:solidFill>
              </a:rPr>
              <a:t>Do the results really reflect your opinion? If no, why not?</a:t>
            </a:r>
          </a:p>
          <a:p>
            <a:r>
              <a:rPr lang="en-US" dirty="0">
                <a:solidFill>
                  <a:schemeClr val="bg1"/>
                </a:solidFill>
              </a:rPr>
              <a:t>How can we understand […]?</a:t>
            </a:r>
          </a:p>
          <a:p>
            <a:r>
              <a:rPr lang="en-US" dirty="0">
                <a:solidFill>
                  <a:schemeClr val="bg1"/>
                </a:solidFill>
              </a:rPr>
              <a:t>How would you recommendation us to solve [</a:t>
            </a:r>
            <a:r>
              <a:rPr lang="en-US" i="1" dirty="0">
                <a:solidFill>
                  <a:schemeClr val="bg1"/>
                </a:solidFill>
              </a:rPr>
              <a:t>strategy X</a:t>
            </a:r>
            <a:r>
              <a:rPr lang="en-US" dirty="0">
                <a:solidFill>
                  <a:schemeClr val="bg1"/>
                </a:solidFill>
              </a:rPr>
              <a:t>]?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2" name="Plassholder for lysbildenummer 1">
            <a:extLst>
              <a:ext uri="{FF2B5EF4-FFF2-40B4-BE49-F238E27FC236}">
                <a16:creationId xmlns:a16="http://schemas.microsoft.com/office/drawing/2014/main" id="{26E48693-AFF4-E9CB-FE0D-CCAFF28E8A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7274F-C966-8C46-AFC4-F3A14ECF3B01}" type="slidenum">
              <a:rPr lang="nb-NO" smtClean="0"/>
              <a:t>11</a:t>
            </a:fld>
            <a:endParaRPr lang="nb-NO"/>
          </a:p>
        </p:txBody>
      </p:sp>
      <p:grpSp>
        <p:nvGrpSpPr>
          <p:cNvPr id="5" name="Gruppe 4">
            <a:extLst>
              <a:ext uri="{FF2B5EF4-FFF2-40B4-BE49-F238E27FC236}">
                <a16:creationId xmlns:a16="http://schemas.microsoft.com/office/drawing/2014/main" id="{59FFC450-961B-C223-B439-EADE524AB746}"/>
              </a:ext>
            </a:extLst>
          </p:cNvPr>
          <p:cNvGrpSpPr/>
          <p:nvPr/>
        </p:nvGrpSpPr>
        <p:grpSpPr>
          <a:xfrm>
            <a:off x="396023" y="393704"/>
            <a:ext cx="833492" cy="177295"/>
            <a:chOff x="396023" y="393704"/>
            <a:chExt cx="833492" cy="177295"/>
          </a:xfrm>
        </p:grpSpPr>
        <p:sp>
          <p:nvSpPr>
            <p:cNvPr id="6" name="Friform 6">
              <a:extLst>
                <a:ext uri="{FF2B5EF4-FFF2-40B4-BE49-F238E27FC236}">
                  <a16:creationId xmlns:a16="http://schemas.microsoft.com/office/drawing/2014/main" id="{CEE91B08-B51D-349C-DEA7-269E4B667D5B}"/>
                </a:ext>
              </a:extLst>
            </p:cNvPr>
            <p:cNvSpPr/>
            <p:nvPr/>
          </p:nvSpPr>
          <p:spPr>
            <a:xfrm>
              <a:off x="936121" y="394334"/>
              <a:ext cx="135024" cy="176665"/>
            </a:xfrm>
            <a:custGeom>
              <a:avLst/>
              <a:gdLst>
                <a:gd name="connsiteX0" fmla="*/ 108524 w 135024"/>
                <a:gd name="connsiteY0" fmla="*/ 0 h 176665"/>
                <a:gd name="connsiteX1" fmla="*/ 108524 w 135024"/>
                <a:gd name="connsiteY1" fmla="*/ 109154 h 176665"/>
                <a:gd name="connsiteX2" fmla="*/ 96536 w 135024"/>
                <a:gd name="connsiteY2" fmla="*/ 138808 h 176665"/>
                <a:gd name="connsiteX3" fmla="*/ 66881 w 135024"/>
                <a:gd name="connsiteY3" fmla="*/ 150796 h 176665"/>
                <a:gd name="connsiteX4" fmla="*/ 37226 w 135024"/>
                <a:gd name="connsiteY4" fmla="*/ 138808 h 176665"/>
                <a:gd name="connsiteX5" fmla="*/ 25238 w 135024"/>
                <a:gd name="connsiteY5" fmla="*/ 109154 h 176665"/>
                <a:gd name="connsiteX6" fmla="*/ 25238 w 135024"/>
                <a:gd name="connsiteY6" fmla="*/ 0 h 176665"/>
                <a:gd name="connsiteX7" fmla="*/ 0 w 135024"/>
                <a:gd name="connsiteY7" fmla="*/ 0 h 176665"/>
                <a:gd name="connsiteX8" fmla="*/ 0 w 135024"/>
                <a:gd name="connsiteY8" fmla="*/ 109154 h 176665"/>
                <a:gd name="connsiteX9" fmla="*/ 5048 w 135024"/>
                <a:gd name="connsiteY9" fmla="*/ 135023 h 176665"/>
                <a:gd name="connsiteX10" fmla="*/ 19560 w 135024"/>
                <a:gd name="connsiteY10" fmla="*/ 157106 h 176665"/>
                <a:gd name="connsiteX11" fmla="*/ 41643 w 135024"/>
                <a:gd name="connsiteY11" fmla="*/ 171617 h 176665"/>
                <a:gd name="connsiteX12" fmla="*/ 67512 w 135024"/>
                <a:gd name="connsiteY12" fmla="*/ 176665 h 176665"/>
                <a:gd name="connsiteX13" fmla="*/ 93382 w 135024"/>
                <a:gd name="connsiteY13" fmla="*/ 171617 h 176665"/>
                <a:gd name="connsiteX14" fmla="*/ 115465 w 135024"/>
                <a:gd name="connsiteY14" fmla="*/ 157106 h 176665"/>
                <a:gd name="connsiteX15" fmla="*/ 129977 w 135024"/>
                <a:gd name="connsiteY15" fmla="*/ 135023 h 176665"/>
                <a:gd name="connsiteX16" fmla="*/ 135025 w 135024"/>
                <a:gd name="connsiteY16" fmla="*/ 109154 h 176665"/>
                <a:gd name="connsiteX17" fmla="*/ 135025 w 135024"/>
                <a:gd name="connsiteY17" fmla="*/ 0 h 176665"/>
                <a:gd name="connsiteX18" fmla="*/ 108524 w 135024"/>
                <a:gd name="connsiteY18" fmla="*/ 0 h 1766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</a:cxnLst>
              <a:rect l="l" t="t" r="r" b="b"/>
              <a:pathLst>
                <a:path w="135024" h="176665">
                  <a:moveTo>
                    <a:pt x="108524" y="0"/>
                  </a:moveTo>
                  <a:lnTo>
                    <a:pt x="108524" y="109154"/>
                  </a:lnTo>
                  <a:cubicBezTo>
                    <a:pt x="108524" y="120511"/>
                    <a:pt x="104108" y="131237"/>
                    <a:pt x="96536" y="138808"/>
                  </a:cubicBezTo>
                  <a:cubicBezTo>
                    <a:pt x="88965" y="146380"/>
                    <a:pt x="78239" y="150796"/>
                    <a:pt x="66881" y="150796"/>
                  </a:cubicBezTo>
                  <a:cubicBezTo>
                    <a:pt x="55524" y="150796"/>
                    <a:pt x="44798" y="146380"/>
                    <a:pt x="37226" y="138808"/>
                  </a:cubicBezTo>
                  <a:cubicBezTo>
                    <a:pt x="29655" y="131237"/>
                    <a:pt x="25238" y="120511"/>
                    <a:pt x="25238" y="109154"/>
                  </a:cubicBezTo>
                  <a:lnTo>
                    <a:pt x="25238" y="0"/>
                  </a:lnTo>
                  <a:lnTo>
                    <a:pt x="0" y="0"/>
                  </a:lnTo>
                  <a:lnTo>
                    <a:pt x="0" y="109154"/>
                  </a:lnTo>
                  <a:cubicBezTo>
                    <a:pt x="0" y="117987"/>
                    <a:pt x="1893" y="126820"/>
                    <a:pt x="5048" y="135023"/>
                  </a:cubicBezTo>
                  <a:cubicBezTo>
                    <a:pt x="8202" y="143225"/>
                    <a:pt x="13250" y="150796"/>
                    <a:pt x="19560" y="157106"/>
                  </a:cubicBezTo>
                  <a:cubicBezTo>
                    <a:pt x="25869" y="163415"/>
                    <a:pt x="33441" y="168463"/>
                    <a:pt x="41643" y="171617"/>
                  </a:cubicBezTo>
                  <a:cubicBezTo>
                    <a:pt x="49846" y="174772"/>
                    <a:pt x="58679" y="176665"/>
                    <a:pt x="67512" y="176665"/>
                  </a:cubicBezTo>
                  <a:cubicBezTo>
                    <a:pt x="76346" y="176665"/>
                    <a:pt x="85179" y="174772"/>
                    <a:pt x="93382" y="171617"/>
                  </a:cubicBezTo>
                  <a:cubicBezTo>
                    <a:pt x="101584" y="168463"/>
                    <a:pt x="109155" y="163415"/>
                    <a:pt x="115465" y="157106"/>
                  </a:cubicBezTo>
                  <a:cubicBezTo>
                    <a:pt x="121775" y="150796"/>
                    <a:pt x="126822" y="143225"/>
                    <a:pt x="129977" y="135023"/>
                  </a:cubicBezTo>
                  <a:cubicBezTo>
                    <a:pt x="133132" y="126820"/>
                    <a:pt x="135025" y="117987"/>
                    <a:pt x="135025" y="109154"/>
                  </a:cubicBezTo>
                  <a:lnTo>
                    <a:pt x="135025" y="0"/>
                  </a:lnTo>
                  <a:lnTo>
                    <a:pt x="108524" y="0"/>
                  </a:lnTo>
                  <a:close/>
                </a:path>
              </a:pathLst>
            </a:custGeom>
            <a:solidFill>
              <a:schemeClr val="bg1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7" name="Friform 7">
              <a:extLst>
                <a:ext uri="{FF2B5EF4-FFF2-40B4-BE49-F238E27FC236}">
                  <a16:creationId xmlns:a16="http://schemas.microsoft.com/office/drawing/2014/main" id="{3A255EF6-000E-9DAC-27F7-87BA4E617DE8}"/>
                </a:ext>
              </a:extLst>
            </p:cNvPr>
            <p:cNvSpPr/>
            <p:nvPr/>
          </p:nvSpPr>
          <p:spPr>
            <a:xfrm>
              <a:off x="630107" y="393704"/>
              <a:ext cx="119881" cy="175403"/>
            </a:xfrm>
            <a:custGeom>
              <a:avLst/>
              <a:gdLst>
                <a:gd name="connsiteX0" fmla="*/ 66881 w 119881"/>
                <a:gd name="connsiteY0" fmla="*/ 76345 h 175403"/>
                <a:gd name="connsiteX1" fmla="*/ 24607 w 119881"/>
                <a:gd name="connsiteY1" fmla="*/ 76345 h 175403"/>
                <a:gd name="connsiteX2" fmla="*/ 24607 w 119881"/>
                <a:gd name="connsiteY2" fmla="*/ 22714 h 175403"/>
                <a:gd name="connsiteX3" fmla="*/ 66881 w 119881"/>
                <a:gd name="connsiteY3" fmla="*/ 22714 h 175403"/>
                <a:gd name="connsiteX4" fmla="*/ 85179 w 119881"/>
                <a:gd name="connsiteY4" fmla="*/ 30285 h 175403"/>
                <a:gd name="connsiteX5" fmla="*/ 92751 w 119881"/>
                <a:gd name="connsiteY5" fmla="*/ 48583 h 175403"/>
                <a:gd name="connsiteX6" fmla="*/ 92751 w 119881"/>
                <a:gd name="connsiteY6" fmla="*/ 50476 h 175403"/>
                <a:gd name="connsiteX7" fmla="*/ 85179 w 119881"/>
                <a:gd name="connsiteY7" fmla="*/ 68773 h 175403"/>
                <a:gd name="connsiteX8" fmla="*/ 66881 w 119881"/>
                <a:gd name="connsiteY8" fmla="*/ 76345 h 175403"/>
                <a:gd name="connsiteX9" fmla="*/ 119882 w 119881"/>
                <a:gd name="connsiteY9" fmla="*/ 49845 h 175403"/>
                <a:gd name="connsiteX10" fmla="*/ 119882 w 119881"/>
                <a:gd name="connsiteY10" fmla="*/ 49845 h 175403"/>
                <a:gd name="connsiteX11" fmla="*/ 105370 w 119881"/>
                <a:gd name="connsiteY11" fmla="*/ 14512 h 175403"/>
                <a:gd name="connsiteX12" fmla="*/ 70667 w 119881"/>
                <a:gd name="connsiteY12" fmla="*/ 0 h 175403"/>
                <a:gd name="connsiteX13" fmla="*/ 0 w 119881"/>
                <a:gd name="connsiteY13" fmla="*/ 0 h 175403"/>
                <a:gd name="connsiteX14" fmla="*/ 0 w 119881"/>
                <a:gd name="connsiteY14" fmla="*/ 174772 h 175403"/>
                <a:gd name="connsiteX15" fmla="*/ 25238 w 119881"/>
                <a:gd name="connsiteY15" fmla="*/ 174772 h 175403"/>
                <a:gd name="connsiteX16" fmla="*/ 25238 w 119881"/>
                <a:gd name="connsiteY16" fmla="*/ 98428 h 175403"/>
                <a:gd name="connsiteX17" fmla="*/ 37226 w 119881"/>
                <a:gd name="connsiteY17" fmla="*/ 98428 h 175403"/>
                <a:gd name="connsiteX18" fmla="*/ 86441 w 119881"/>
                <a:gd name="connsiteY18" fmla="*/ 175403 h 175403"/>
                <a:gd name="connsiteX19" fmla="*/ 117989 w 119881"/>
                <a:gd name="connsiteY19" fmla="*/ 175403 h 175403"/>
                <a:gd name="connsiteX20" fmla="*/ 67512 w 119881"/>
                <a:gd name="connsiteY20" fmla="*/ 98428 h 175403"/>
                <a:gd name="connsiteX21" fmla="*/ 71298 w 119881"/>
                <a:gd name="connsiteY21" fmla="*/ 98428 h 175403"/>
                <a:gd name="connsiteX22" fmla="*/ 90227 w 119881"/>
                <a:gd name="connsiteY22" fmla="*/ 94642 h 175403"/>
                <a:gd name="connsiteX23" fmla="*/ 106001 w 119881"/>
                <a:gd name="connsiteY23" fmla="*/ 83916 h 175403"/>
                <a:gd name="connsiteX24" fmla="*/ 116727 w 119881"/>
                <a:gd name="connsiteY24" fmla="*/ 68142 h 175403"/>
                <a:gd name="connsiteX25" fmla="*/ 119882 w 119881"/>
                <a:gd name="connsiteY25" fmla="*/ 49845 h 1754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</a:cxnLst>
              <a:rect l="l" t="t" r="r" b="b"/>
              <a:pathLst>
                <a:path w="119881" h="175403">
                  <a:moveTo>
                    <a:pt x="66881" y="76345"/>
                  </a:moveTo>
                  <a:lnTo>
                    <a:pt x="24607" y="76345"/>
                  </a:lnTo>
                  <a:lnTo>
                    <a:pt x="24607" y="22714"/>
                  </a:lnTo>
                  <a:lnTo>
                    <a:pt x="66881" y="22714"/>
                  </a:lnTo>
                  <a:cubicBezTo>
                    <a:pt x="73822" y="22714"/>
                    <a:pt x="80762" y="25238"/>
                    <a:pt x="85179" y="30285"/>
                  </a:cubicBezTo>
                  <a:cubicBezTo>
                    <a:pt x="90227" y="35333"/>
                    <a:pt x="92751" y="41642"/>
                    <a:pt x="92751" y="48583"/>
                  </a:cubicBezTo>
                  <a:lnTo>
                    <a:pt x="92751" y="50476"/>
                  </a:lnTo>
                  <a:cubicBezTo>
                    <a:pt x="92751" y="57416"/>
                    <a:pt x="90227" y="64357"/>
                    <a:pt x="85179" y="68773"/>
                  </a:cubicBezTo>
                  <a:cubicBezTo>
                    <a:pt x="80131" y="73190"/>
                    <a:pt x="73822" y="76345"/>
                    <a:pt x="66881" y="76345"/>
                  </a:cubicBezTo>
                  <a:close/>
                  <a:moveTo>
                    <a:pt x="119882" y="49845"/>
                  </a:moveTo>
                  <a:lnTo>
                    <a:pt x="119882" y="49845"/>
                  </a:lnTo>
                  <a:cubicBezTo>
                    <a:pt x="119882" y="36595"/>
                    <a:pt x="114834" y="23976"/>
                    <a:pt x="105370" y="14512"/>
                  </a:cubicBezTo>
                  <a:cubicBezTo>
                    <a:pt x="95905" y="5048"/>
                    <a:pt x="83917" y="0"/>
                    <a:pt x="70667" y="0"/>
                  </a:cubicBezTo>
                  <a:lnTo>
                    <a:pt x="0" y="0"/>
                  </a:lnTo>
                  <a:lnTo>
                    <a:pt x="0" y="174772"/>
                  </a:lnTo>
                  <a:lnTo>
                    <a:pt x="25238" y="174772"/>
                  </a:lnTo>
                  <a:lnTo>
                    <a:pt x="25238" y="98428"/>
                  </a:lnTo>
                  <a:lnTo>
                    <a:pt x="37226" y="98428"/>
                  </a:lnTo>
                  <a:lnTo>
                    <a:pt x="86441" y="175403"/>
                  </a:lnTo>
                  <a:lnTo>
                    <a:pt x="117989" y="175403"/>
                  </a:lnTo>
                  <a:lnTo>
                    <a:pt x="67512" y="98428"/>
                  </a:lnTo>
                  <a:lnTo>
                    <a:pt x="71298" y="98428"/>
                  </a:lnTo>
                  <a:cubicBezTo>
                    <a:pt x="77608" y="98428"/>
                    <a:pt x="83917" y="97166"/>
                    <a:pt x="90227" y="94642"/>
                  </a:cubicBezTo>
                  <a:cubicBezTo>
                    <a:pt x="95905" y="92118"/>
                    <a:pt x="101584" y="88333"/>
                    <a:pt x="106001" y="83916"/>
                  </a:cubicBezTo>
                  <a:cubicBezTo>
                    <a:pt x="110417" y="79499"/>
                    <a:pt x="114203" y="73821"/>
                    <a:pt x="116727" y="68142"/>
                  </a:cubicBezTo>
                  <a:cubicBezTo>
                    <a:pt x="118620" y="62464"/>
                    <a:pt x="119882" y="56154"/>
                    <a:pt x="119882" y="49845"/>
                  </a:cubicBezTo>
                  <a:close/>
                </a:path>
              </a:pathLst>
            </a:custGeom>
            <a:solidFill>
              <a:schemeClr val="bg1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8" name="Friform 8">
              <a:extLst>
                <a:ext uri="{FF2B5EF4-FFF2-40B4-BE49-F238E27FC236}">
                  <a16:creationId xmlns:a16="http://schemas.microsoft.com/office/drawing/2014/main" id="{DD435A19-7BBE-D3CD-71ED-D6F7DAC4075B}"/>
                </a:ext>
              </a:extLst>
            </p:cNvPr>
            <p:cNvSpPr/>
            <p:nvPr/>
          </p:nvSpPr>
          <p:spPr>
            <a:xfrm>
              <a:off x="1109003" y="394334"/>
              <a:ext cx="120512" cy="174772"/>
            </a:xfrm>
            <a:custGeom>
              <a:avLst/>
              <a:gdLst>
                <a:gd name="connsiteX0" fmla="*/ 92751 w 120512"/>
                <a:gd name="connsiteY0" fmla="*/ 49845 h 174772"/>
                <a:gd name="connsiteX1" fmla="*/ 85179 w 120512"/>
                <a:gd name="connsiteY1" fmla="*/ 68142 h 174772"/>
                <a:gd name="connsiteX2" fmla="*/ 66881 w 120512"/>
                <a:gd name="connsiteY2" fmla="*/ 75714 h 174772"/>
                <a:gd name="connsiteX3" fmla="*/ 24607 w 120512"/>
                <a:gd name="connsiteY3" fmla="*/ 75714 h 174772"/>
                <a:gd name="connsiteX4" fmla="*/ 24607 w 120512"/>
                <a:gd name="connsiteY4" fmla="*/ 22083 h 174772"/>
                <a:gd name="connsiteX5" fmla="*/ 66881 w 120512"/>
                <a:gd name="connsiteY5" fmla="*/ 22083 h 174772"/>
                <a:gd name="connsiteX6" fmla="*/ 85179 w 120512"/>
                <a:gd name="connsiteY6" fmla="*/ 29654 h 174772"/>
                <a:gd name="connsiteX7" fmla="*/ 92751 w 120512"/>
                <a:gd name="connsiteY7" fmla="*/ 47952 h 174772"/>
                <a:gd name="connsiteX8" fmla="*/ 92751 w 120512"/>
                <a:gd name="connsiteY8" fmla="*/ 49845 h 174772"/>
                <a:gd name="connsiteX9" fmla="*/ 71298 w 120512"/>
                <a:gd name="connsiteY9" fmla="*/ 0 h 174772"/>
                <a:gd name="connsiteX10" fmla="*/ 0 w 120512"/>
                <a:gd name="connsiteY10" fmla="*/ 0 h 174772"/>
                <a:gd name="connsiteX11" fmla="*/ 0 w 120512"/>
                <a:gd name="connsiteY11" fmla="*/ 174772 h 174772"/>
                <a:gd name="connsiteX12" fmla="*/ 25238 w 120512"/>
                <a:gd name="connsiteY12" fmla="*/ 174772 h 174772"/>
                <a:gd name="connsiteX13" fmla="*/ 25238 w 120512"/>
                <a:gd name="connsiteY13" fmla="*/ 97797 h 174772"/>
                <a:gd name="connsiteX14" fmla="*/ 71298 w 120512"/>
                <a:gd name="connsiteY14" fmla="*/ 97797 h 174772"/>
                <a:gd name="connsiteX15" fmla="*/ 90227 w 120512"/>
                <a:gd name="connsiteY15" fmla="*/ 94011 h 174772"/>
                <a:gd name="connsiteX16" fmla="*/ 106001 w 120512"/>
                <a:gd name="connsiteY16" fmla="*/ 83285 h 174772"/>
                <a:gd name="connsiteX17" fmla="*/ 116727 w 120512"/>
                <a:gd name="connsiteY17" fmla="*/ 67511 h 174772"/>
                <a:gd name="connsiteX18" fmla="*/ 120513 w 120512"/>
                <a:gd name="connsiteY18" fmla="*/ 48583 h 174772"/>
                <a:gd name="connsiteX19" fmla="*/ 120513 w 120512"/>
                <a:gd name="connsiteY19" fmla="*/ 48583 h 174772"/>
                <a:gd name="connsiteX20" fmla="*/ 106001 w 120512"/>
                <a:gd name="connsiteY20" fmla="*/ 13881 h 174772"/>
                <a:gd name="connsiteX21" fmla="*/ 71298 w 120512"/>
                <a:gd name="connsiteY21" fmla="*/ 0 h 1747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</a:cxnLst>
              <a:rect l="l" t="t" r="r" b="b"/>
              <a:pathLst>
                <a:path w="120512" h="174772">
                  <a:moveTo>
                    <a:pt x="92751" y="49845"/>
                  </a:moveTo>
                  <a:cubicBezTo>
                    <a:pt x="92751" y="56785"/>
                    <a:pt x="90227" y="63726"/>
                    <a:pt x="85179" y="68142"/>
                  </a:cubicBezTo>
                  <a:cubicBezTo>
                    <a:pt x="80131" y="72559"/>
                    <a:pt x="73822" y="75714"/>
                    <a:pt x="66881" y="75714"/>
                  </a:cubicBezTo>
                  <a:lnTo>
                    <a:pt x="24607" y="75714"/>
                  </a:lnTo>
                  <a:lnTo>
                    <a:pt x="24607" y="22083"/>
                  </a:lnTo>
                  <a:lnTo>
                    <a:pt x="66881" y="22083"/>
                  </a:lnTo>
                  <a:cubicBezTo>
                    <a:pt x="73822" y="22083"/>
                    <a:pt x="80762" y="24607"/>
                    <a:pt x="85179" y="29654"/>
                  </a:cubicBezTo>
                  <a:cubicBezTo>
                    <a:pt x="89596" y="34702"/>
                    <a:pt x="92751" y="41012"/>
                    <a:pt x="92751" y="47952"/>
                  </a:cubicBezTo>
                  <a:lnTo>
                    <a:pt x="92751" y="49845"/>
                  </a:lnTo>
                  <a:close/>
                  <a:moveTo>
                    <a:pt x="71298" y="0"/>
                  </a:moveTo>
                  <a:lnTo>
                    <a:pt x="0" y="0"/>
                  </a:lnTo>
                  <a:lnTo>
                    <a:pt x="0" y="174772"/>
                  </a:lnTo>
                  <a:lnTo>
                    <a:pt x="25238" y="174772"/>
                  </a:lnTo>
                  <a:lnTo>
                    <a:pt x="25238" y="97797"/>
                  </a:lnTo>
                  <a:lnTo>
                    <a:pt x="71298" y="97797"/>
                  </a:lnTo>
                  <a:cubicBezTo>
                    <a:pt x="77608" y="97797"/>
                    <a:pt x="83917" y="96535"/>
                    <a:pt x="90227" y="94011"/>
                  </a:cubicBezTo>
                  <a:cubicBezTo>
                    <a:pt x="96536" y="91487"/>
                    <a:pt x="101584" y="87702"/>
                    <a:pt x="106001" y="83285"/>
                  </a:cubicBezTo>
                  <a:cubicBezTo>
                    <a:pt x="110417" y="78868"/>
                    <a:pt x="114203" y="73190"/>
                    <a:pt x="116727" y="67511"/>
                  </a:cubicBezTo>
                  <a:cubicBezTo>
                    <a:pt x="119251" y="61833"/>
                    <a:pt x="120513" y="55523"/>
                    <a:pt x="120513" y="48583"/>
                  </a:cubicBezTo>
                  <a:lnTo>
                    <a:pt x="120513" y="48583"/>
                  </a:lnTo>
                  <a:cubicBezTo>
                    <a:pt x="120513" y="35333"/>
                    <a:pt x="115465" y="23345"/>
                    <a:pt x="106001" y="13881"/>
                  </a:cubicBezTo>
                  <a:cubicBezTo>
                    <a:pt x="96536" y="5048"/>
                    <a:pt x="83917" y="0"/>
                    <a:pt x="71298" y="0"/>
                  </a:cubicBezTo>
                  <a:close/>
                </a:path>
              </a:pathLst>
            </a:custGeom>
            <a:solidFill>
              <a:schemeClr val="bg1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9" name="Friform 9">
              <a:extLst>
                <a:ext uri="{FF2B5EF4-FFF2-40B4-BE49-F238E27FC236}">
                  <a16:creationId xmlns:a16="http://schemas.microsoft.com/office/drawing/2014/main" id="{9F491119-47C9-AEE4-A14B-2B209FF41241}"/>
                </a:ext>
              </a:extLst>
            </p:cNvPr>
            <p:cNvSpPr/>
            <p:nvPr/>
          </p:nvSpPr>
          <p:spPr>
            <a:xfrm>
              <a:off x="782168" y="394334"/>
              <a:ext cx="120354" cy="174772"/>
            </a:xfrm>
            <a:custGeom>
              <a:avLst/>
              <a:gdLst>
                <a:gd name="connsiteX0" fmla="*/ 93381 w 120354"/>
                <a:gd name="connsiteY0" fmla="*/ 49845 h 174772"/>
                <a:gd name="connsiteX1" fmla="*/ 91489 w 120354"/>
                <a:gd name="connsiteY1" fmla="*/ 59940 h 174772"/>
                <a:gd name="connsiteX2" fmla="*/ 85810 w 120354"/>
                <a:gd name="connsiteY2" fmla="*/ 68142 h 174772"/>
                <a:gd name="connsiteX3" fmla="*/ 77608 w 120354"/>
                <a:gd name="connsiteY3" fmla="*/ 73821 h 174772"/>
                <a:gd name="connsiteX4" fmla="*/ 67512 w 120354"/>
                <a:gd name="connsiteY4" fmla="*/ 75714 h 174772"/>
                <a:gd name="connsiteX5" fmla="*/ 25238 w 120354"/>
                <a:gd name="connsiteY5" fmla="*/ 75714 h 174772"/>
                <a:gd name="connsiteX6" fmla="*/ 25238 w 120354"/>
                <a:gd name="connsiteY6" fmla="*/ 22083 h 174772"/>
                <a:gd name="connsiteX7" fmla="*/ 67512 w 120354"/>
                <a:gd name="connsiteY7" fmla="*/ 22083 h 174772"/>
                <a:gd name="connsiteX8" fmla="*/ 85810 w 120354"/>
                <a:gd name="connsiteY8" fmla="*/ 29654 h 174772"/>
                <a:gd name="connsiteX9" fmla="*/ 93381 w 120354"/>
                <a:gd name="connsiteY9" fmla="*/ 47952 h 174772"/>
                <a:gd name="connsiteX10" fmla="*/ 93381 w 120354"/>
                <a:gd name="connsiteY10" fmla="*/ 49845 h 174772"/>
                <a:gd name="connsiteX11" fmla="*/ 93381 w 120354"/>
                <a:gd name="connsiteY11" fmla="*/ 126189 h 174772"/>
                <a:gd name="connsiteX12" fmla="*/ 85810 w 120354"/>
                <a:gd name="connsiteY12" fmla="*/ 144487 h 174772"/>
                <a:gd name="connsiteX13" fmla="*/ 67512 w 120354"/>
                <a:gd name="connsiteY13" fmla="*/ 152058 h 174772"/>
                <a:gd name="connsiteX14" fmla="*/ 25238 w 120354"/>
                <a:gd name="connsiteY14" fmla="*/ 152058 h 174772"/>
                <a:gd name="connsiteX15" fmla="*/ 25238 w 120354"/>
                <a:gd name="connsiteY15" fmla="*/ 98428 h 174772"/>
                <a:gd name="connsiteX16" fmla="*/ 67512 w 120354"/>
                <a:gd name="connsiteY16" fmla="*/ 98428 h 174772"/>
                <a:gd name="connsiteX17" fmla="*/ 85810 w 120354"/>
                <a:gd name="connsiteY17" fmla="*/ 105999 h 174772"/>
                <a:gd name="connsiteX18" fmla="*/ 93381 w 120354"/>
                <a:gd name="connsiteY18" fmla="*/ 124296 h 174772"/>
                <a:gd name="connsiteX19" fmla="*/ 93381 w 120354"/>
                <a:gd name="connsiteY19" fmla="*/ 126189 h 174772"/>
                <a:gd name="connsiteX20" fmla="*/ 119882 w 120354"/>
                <a:gd name="connsiteY20" fmla="*/ 48583 h 174772"/>
                <a:gd name="connsiteX21" fmla="*/ 105370 w 120354"/>
                <a:gd name="connsiteY21" fmla="*/ 14512 h 174772"/>
                <a:gd name="connsiteX22" fmla="*/ 71298 w 120354"/>
                <a:gd name="connsiteY22" fmla="*/ 0 h 174772"/>
                <a:gd name="connsiteX23" fmla="*/ 0 w 120354"/>
                <a:gd name="connsiteY23" fmla="*/ 0 h 174772"/>
                <a:gd name="connsiteX24" fmla="*/ 0 w 120354"/>
                <a:gd name="connsiteY24" fmla="*/ 174772 h 174772"/>
                <a:gd name="connsiteX25" fmla="*/ 71929 w 120354"/>
                <a:gd name="connsiteY25" fmla="*/ 174772 h 174772"/>
                <a:gd name="connsiteX26" fmla="*/ 100322 w 120354"/>
                <a:gd name="connsiteY26" fmla="*/ 165308 h 174772"/>
                <a:gd name="connsiteX27" fmla="*/ 117989 w 120354"/>
                <a:gd name="connsiteY27" fmla="*/ 141332 h 174772"/>
                <a:gd name="connsiteX28" fmla="*/ 117989 w 120354"/>
                <a:gd name="connsiteY28" fmla="*/ 111678 h 174772"/>
                <a:gd name="connsiteX29" fmla="*/ 100322 w 120354"/>
                <a:gd name="connsiteY29" fmla="*/ 87702 h 174772"/>
                <a:gd name="connsiteX30" fmla="*/ 114834 w 120354"/>
                <a:gd name="connsiteY30" fmla="*/ 70666 h 174772"/>
                <a:gd name="connsiteX31" fmla="*/ 119882 w 120354"/>
                <a:gd name="connsiteY31" fmla="*/ 48583 h 1747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</a:cxnLst>
              <a:rect l="l" t="t" r="r" b="b"/>
              <a:pathLst>
                <a:path w="120354" h="174772">
                  <a:moveTo>
                    <a:pt x="93381" y="49845"/>
                  </a:moveTo>
                  <a:cubicBezTo>
                    <a:pt x="93381" y="53000"/>
                    <a:pt x="92751" y="56785"/>
                    <a:pt x="91489" y="59940"/>
                  </a:cubicBezTo>
                  <a:cubicBezTo>
                    <a:pt x="90227" y="63095"/>
                    <a:pt x="88334" y="66249"/>
                    <a:pt x="85810" y="68142"/>
                  </a:cubicBezTo>
                  <a:cubicBezTo>
                    <a:pt x="83286" y="70666"/>
                    <a:pt x="80762" y="72559"/>
                    <a:pt x="77608" y="73821"/>
                  </a:cubicBezTo>
                  <a:cubicBezTo>
                    <a:pt x="74453" y="75083"/>
                    <a:pt x="71298" y="75714"/>
                    <a:pt x="67512" y="75714"/>
                  </a:cubicBezTo>
                  <a:lnTo>
                    <a:pt x="25238" y="75714"/>
                  </a:lnTo>
                  <a:lnTo>
                    <a:pt x="25238" y="22083"/>
                  </a:lnTo>
                  <a:lnTo>
                    <a:pt x="67512" y="22083"/>
                  </a:lnTo>
                  <a:cubicBezTo>
                    <a:pt x="74453" y="22083"/>
                    <a:pt x="81393" y="24607"/>
                    <a:pt x="85810" y="29654"/>
                  </a:cubicBezTo>
                  <a:cubicBezTo>
                    <a:pt x="90227" y="34702"/>
                    <a:pt x="93381" y="41012"/>
                    <a:pt x="93381" y="47952"/>
                  </a:cubicBezTo>
                  <a:lnTo>
                    <a:pt x="93381" y="49845"/>
                  </a:lnTo>
                  <a:close/>
                  <a:moveTo>
                    <a:pt x="93381" y="126189"/>
                  </a:moveTo>
                  <a:cubicBezTo>
                    <a:pt x="93381" y="133130"/>
                    <a:pt x="90858" y="140070"/>
                    <a:pt x="85810" y="144487"/>
                  </a:cubicBezTo>
                  <a:cubicBezTo>
                    <a:pt x="80762" y="149534"/>
                    <a:pt x="74453" y="152058"/>
                    <a:pt x="67512" y="152058"/>
                  </a:cubicBezTo>
                  <a:lnTo>
                    <a:pt x="25238" y="152058"/>
                  </a:lnTo>
                  <a:lnTo>
                    <a:pt x="25238" y="98428"/>
                  </a:lnTo>
                  <a:lnTo>
                    <a:pt x="67512" y="98428"/>
                  </a:lnTo>
                  <a:cubicBezTo>
                    <a:pt x="74453" y="98428"/>
                    <a:pt x="81393" y="100951"/>
                    <a:pt x="85810" y="105999"/>
                  </a:cubicBezTo>
                  <a:cubicBezTo>
                    <a:pt x="90858" y="111047"/>
                    <a:pt x="93381" y="117356"/>
                    <a:pt x="93381" y="124296"/>
                  </a:cubicBezTo>
                  <a:lnTo>
                    <a:pt x="93381" y="126189"/>
                  </a:lnTo>
                  <a:close/>
                  <a:moveTo>
                    <a:pt x="119882" y="48583"/>
                  </a:moveTo>
                  <a:cubicBezTo>
                    <a:pt x="119882" y="35964"/>
                    <a:pt x="114834" y="23345"/>
                    <a:pt x="105370" y="14512"/>
                  </a:cubicBezTo>
                  <a:cubicBezTo>
                    <a:pt x="96536" y="5679"/>
                    <a:pt x="83917" y="0"/>
                    <a:pt x="71298" y="0"/>
                  </a:cubicBezTo>
                  <a:lnTo>
                    <a:pt x="0" y="0"/>
                  </a:lnTo>
                  <a:lnTo>
                    <a:pt x="0" y="174772"/>
                  </a:lnTo>
                  <a:lnTo>
                    <a:pt x="71929" y="174772"/>
                  </a:lnTo>
                  <a:cubicBezTo>
                    <a:pt x="82024" y="174772"/>
                    <a:pt x="92120" y="171617"/>
                    <a:pt x="100322" y="165308"/>
                  </a:cubicBezTo>
                  <a:cubicBezTo>
                    <a:pt x="108524" y="159629"/>
                    <a:pt x="114834" y="150796"/>
                    <a:pt x="117989" y="141332"/>
                  </a:cubicBezTo>
                  <a:cubicBezTo>
                    <a:pt x="121144" y="131868"/>
                    <a:pt x="121144" y="121142"/>
                    <a:pt x="117989" y="111678"/>
                  </a:cubicBezTo>
                  <a:cubicBezTo>
                    <a:pt x="114834" y="102213"/>
                    <a:pt x="108524" y="93380"/>
                    <a:pt x="100322" y="87702"/>
                  </a:cubicBezTo>
                  <a:cubicBezTo>
                    <a:pt x="106632" y="83285"/>
                    <a:pt x="111679" y="77606"/>
                    <a:pt x="114834" y="70666"/>
                  </a:cubicBezTo>
                  <a:cubicBezTo>
                    <a:pt x="117989" y="63726"/>
                    <a:pt x="119882" y="56154"/>
                    <a:pt x="119882" y="48583"/>
                  </a:cubicBezTo>
                  <a:close/>
                </a:path>
              </a:pathLst>
            </a:custGeom>
            <a:solidFill>
              <a:schemeClr val="bg1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0" name="Friform 10">
              <a:extLst>
                <a:ext uri="{FF2B5EF4-FFF2-40B4-BE49-F238E27FC236}">
                  <a16:creationId xmlns:a16="http://schemas.microsoft.com/office/drawing/2014/main" id="{38BBA28F-588B-0E53-B7E9-09453BEFC2EB}"/>
                </a:ext>
              </a:extLst>
            </p:cNvPr>
            <p:cNvSpPr/>
            <p:nvPr/>
          </p:nvSpPr>
          <p:spPr>
            <a:xfrm>
              <a:off x="454701" y="393704"/>
              <a:ext cx="116095" cy="116725"/>
            </a:xfrm>
            <a:custGeom>
              <a:avLst/>
              <a:gdLst>
                <a:gd name="connsiteX0" fmla="*/ 58048 w 116095"/>
                <a:gd name="connsiteY0" fmla="*/ 0 h 116725"/>
                <a:gd name="connsiteX1" fmla="*/ 99060 w 116095"/>
                <a:gd name="connsiteY1" fmla="*/ 17036 h 116725"/>
                <a:gd name="connsiteX2" fmla="*/ 116096 w 116095"/>
                <a:gd name="connsiteY2" fmla="*/ 58047 h 116725"/>
                <a:gd name="connsiteX3" fmla="*/ 116096 w 116095"/>
                <a:gd name="connsiteY3" fmla="*/ 116725 h 116725"/>
                <a:gd name="connsiteX4" fmla="*/ 0 w 116095"/>
                <a:gd name="connsiteY4" fmla="*/ 116725 h 116725"/>
                <a:gd name="connsiteX5" fmla="*/ 0 w 116095"/>
                <a:gd name="connsiteY5" fmla="*/ 58678 h 116725"/>
                <a:gd name="connsiteX6" fmla="*/ 17036 w 116095"/>
                <a:gd name="connsiteY6" fmla="*/ 17667 h 116725"/>
                <a:gd name="connsiteX7" fmla="*/ 58048 w 116095"/>
                <a:gd name="connsiteY7" fmla="*/ 0 h 1167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116095" h="116725">
                  <a:moveTo>
                    <a:pt x="58048" y="0"/>
                  </a:moveTo>
                  <a:cubicBezTo>
                    <a:pt x="73822" y="0"/>
                    <a:pt x="88334" y="6309"/>
                    <a:pt x="99060" y="17036"/>
                  </a:cubicBezTo>
                  <a:cubicBezTo>
                    <a:pt x="109786" y="27762"/>
                    <a:pt x="116096" y="42904"/>
                    <a:pt x="116096" y="58047"/>
                  </a:cubicBezTo>
                  <a:lnTo>
                    <a:pt x="116096" y="116725"/>
                  </a:lnTo>
                  <a:lnTo>
                    <a:pt x="0" y="116725"/>
                  </a:lnTo>
                  <a:lnTo>
                    <a:pt x="0" y="58678"/>
                  </a:lnTo>
                  <a:cubicBezTo>
                    <a:pt x="0" y="42904"/>
                    <a:pt x="6310" y="28393"/>
                    <a:pt x="17036" y="17667"/>
                  </a:cubicBezTo>
                  <a:cubicBezTo>
                    <a:pt x="27762" y="6940"/>
                    <a:pt x="42905" y="0"/>
                    <a:pt x="58048" y="0"/>
                  </a:cubicBezTo>
                  <a:close/>
                </a:path>
              </a:pathLst>
            </a:custGeom>
            <a:solidFill>
              <a:srgbClr val="E31836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1" name="Friform 11">
              <a:extLst>
                <a:ext uri="{FF2B5EF4-FFF2-40B4-BE49-F238E27FC236}">
                  <a16:creationId xmlns:a16="http://schemas.microsoft.com/office/drawing/2014/main" id="{5D3AA832-F6AD-507E-CEF0-FB80F39C631B}"/>
                </a:ext>
              </a:extLst>
            </p:cNvPr>
            <p:cNvSpPr/>
            <p:nvPr/>
          </p:nvSpPr>
          <p:spPr>
            <a:xfrm>
              <a:off x="396023" y="452382"/>
              <a:ext cx="58678" cy="116094"/>
            </a:xfrm>
            <a:custGeom>
              <a:avLst/>
              <a:gdLst>
                <a:gd name="connsiteX0" fmla="*/ 58679 w 58678"/>
                <a:gd name="connsiteY0" fmla="*/ 0 h 116094"/>
                <a:gd name="connsiteX1" fmla="*/ 17667 w 58678"/>
                <a:gd name="connsiteY1" fmla="*/ 17036 h 116094"/>
                <a:gd name="connsiteX2" fmla="*/ 0 w 58678"/>
                <a:gd name="connsiteY2" fmla="*/ 58047 h 116094"/>
                <a:gd name="connsiteX3" fmla="*/ 17036 w 58678"/>
                <a:gd name="connsiteY3" fmla="*/ 99059 h 116094"/>
                <a:gd name="connsiteX4" fmla="*/ 58048 w 58678"/>
                <a:gd name="connsiteY4" fmla="*/ 116094 h 116094"/>
                <a:gd name="connsiteX5" fmla="*/ 58048 w 58678"/>
                <a:gd name="connsiteY5" fmla="*/ 116094 h 116094"/>
                <a:gd name="connsiteX6" fmla="*/ 58048 w 58678"/>
                <a:gd name="connsiteY6" fmla="*/ 116094 h 116094"/>
                <a:gd name="connsiteX7" fmla="*/ 58048 w 58678"/>
                <a:gd name="connsiteY7" fmla="*/ 0 h 1160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58678" h="116094">
                  <a:moveTo>
                    <a:pt x="58679" y="0"/>
                  </a:moveTo>
                  <a:cubicBezTo>
                    <a:pt x="42905" y="0"/>
                    <a:pt x="28393" y="6309"/>
                    <a:pt x="17667" y="17036"/>
                  </a:cubicBezTo>
                  <a:cubicBezTo>
                    <a:pt x="6310" y="27762"/>
                    <a:pt x="0" y="42904"/>
                    <a:pt x="0" y="58047"/>
                  </a:cubicBezTo>
                  <a:cubicBezTo>
                    <a:pt x="0" y="73821"/>
                    <a:pt x="6310" y="88332"/>
                    <a:pt x="17036" y="99059"/>
                  </a:cubicBezTo>
                  <a:cubicBezTo>
                    <a:pt x="27762" y="109785"/>
                    <a:pt x="42905" y="116094"/>
                    <a:pt x="58048" y="116094"/>
                  </a:cubicBezTo>
                  <a:cubicBezTo>
                    <a:pt x="58048" y="116094"/>
                    <a:pt x="58048" y="116094"/>
                    <a:pt x="58048" y="116094"/>
                  </a:cubicBezTo>
                  <a:lnTo>
                    <a:pt x="58048" y="116094"/>
                  </a:lnTo>
                  <a:lnTo>
                    <a:pt x="58048" y="0"/>
                  </a:lnTo>
                  <a:close/>
                </a:path>
              </a:pathLst>
            </a:custGeom>
            <a:solidFill>
              <a:srgbClr val="728EE6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2" name="Friform 12">
              <a:extLst>
                <a:ext uri="{FF2B5EF4-FFF2-40B4-BE49-F238E27FC236}">
                  <a16:creationId xmlns:a16="http://schemas.microsoft.com/office/drawing/2014/main" id="{4A5FE642-BE42-62BF-E1DF-EF981A89E8B6}"/>
                </a:ext>
              </a:extLst>
            </p:cNvPr>
            <p:cNvSpPr/>
            <p:nvPr/>
          </p:nvSpPr>
          <p:spPr>
            <a:xfrm>
              <a:off x="454701" y="510429"/>
              <a:ext cx="116726" cy="58047"/>
            </a:xfrm>
            <a:custGeom>
              <a:avLst/>
              <a:gdLst>
                <a:gd name="connsiteX0" fmla="*/ 116727 w 116726"/>
                <a:gd name="connsiteY0" fmla="*/ 0 h 58047"/>
                <a:gd name="connsiteX1" fmla="*/ 58048 w 116726"/>
                <a:gd name="connsiteY1" fmla="*/ 0 h 58047"/>
                <a:gd name="connsiteX2" fmla="*/ 41012 w 116726"/>
                <a:gd name="connsiteY2" fmla="*/ 41012 h 58047"/>
                <a:gd name="connsiteX3" fmla="*/ 0 w 116726"/>
                <a:gd name="connsiteY3" fmla="*/ 58047 h 58047"/>
                <a:gd name="connsiteX4" fmla="*/ 116727 w 116726"/>
                <a:gd name="connsiteY4" fmla="*/ 58047 h 58047"/>
                <a:gd name="connsiteX5" fmla="*/ 116727 w 116726"/>
                <a:gd name="connsiteY5" fmla="*/ 0 h 580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116726" h="58047">
                  <a:moveTo>
                    <a:pt x="116727" y="0"/>
                  </a:moveTo>
                  <a:lnTo>
                    <a:pt x="58048" y="0"/>
                  </a:lnTo>
                  <a:cubicBezTo>
                    <a:pt x="58048" y="15774"/>
                    <a:pt x="51738" y="30285"/>
                    <a:pt x="41012" y="41012"/>
                  </a:cubicBezTo>
                  <a:cubicBezTo>
                    <a:pt x="30286" y="51738"/>
                    <a:pt x="15143" y="58047"/>
                    <a:pt x="0" y="58047"/>
                  </a:cubicBezTo>
                  <a:lnTo>
                    <a:pt x="116727" y="58047"/>
                  </a:lnTo>
                  <a:lnTo>
                    <a:pt x="116727" y="0"/>
                  </a:lnTo>
                  <a:close/>
                </a:path>
              </a:pathLst>
            </a:custGeom>
            <a:solidFill>
              <a:srgbClr val="C2CFF4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3" name="Friform 13">
              <a:extLst>
                <a:ext uri="{FF2B5EF4-FFF2-40B4-BE49-F238E27FC236}">
                  <a16:creationId xmlns:a16="http://schemas.microsoft.com/office/drawing/2014/main" id="{96A9957A-DB35-F7A4-E7BC-373218AF117D}"/>
                </a:ext>
              </a:extLst>
            </p:cNvPr>
            <p:cNvSpPr/>
            <p:nvPr/>
          </p:nvSpPr>
          <p:spPr>
            <a:xfrm>
              <a:off x="454701" y="510429"/>
              <a:ext cx="58047" cy="58678"/>
            </a:xfrm>
            <a:custGeom>
              <a:avLst/>
              <a:gdLst>
                <a:gd name="connsiteX0" fmla="*/ 58048 w 58047"/>
                <a:gd name="connsiteY0" fmla="*/ 0 h 58678"/>
                <a:gd name="connsiteX1" fmla="*/ 0 w 58047"/>
                <a:gd name="connsiteY1" fmla="*/ 0 h 58678"/>
                <a:gd name="connsiteX2" fmla="*/ 0 w 58047"/>
                <a:gd name="connsiteY2" fmla="*/ 58678 h 58678"/>
                <a:gd name="connsiteX3" fmla="*/ 0 w 58047"/>
                <a:gd name="connsiteY3" fmla="*/ 58678 h 58678"/>
                <a:gd name="connsiteX4" fmla="*/ 41012 w 58047"/>
                <a:gd name="connsiteY4" fmla="*/ 41642 h 58678"/>
                <a:gd name="connsiteX5" fmla="*/ 58048 w 58047"/>
                <a:gd name="connsiteY5" fmla="*/ 0 h 5867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8047" h="58678">
                  <a:moveTo>
                    <a:pt x="58048" y="0"/>
                  </a:moveTo>
                  <a:lnTo>
                    <a:pt x="0" y="0"/>
                  </a:lnTo>
                  <a:lnTo>
                    <a:pt x="0" y="58678"/>
                  </a:lnTo>
                  <a:lnTo>
                    <a:pt x="0" y="58678"/>
                  </a:lnTo>
                  <a:cubicBezTo>
                    <a:pt x="15774" y="58678"/>
                    <a:pt x="30286" y="52369"/>
                    <a:pt x="41012" y="41642"/>
                  </a:cubicBezTo>
                  <a:cubicBezTo>
                    <a:pt x="52369" y="30285"/>
                    <a:pt x="58048" y="15774"/>
                    <a:pt x="58048" y="0"/>
                  </a:cubicBezTo>
                  <a:close/>
                </a:path>
              </a:pathLst>
            </a:custGeom>
            <a:solidFill>
              <a:srgbClr val="355EDB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4" name="Friform 14">
              <a:extLst>
                <a:ext uri="{FF2B5EF4-FFF2-40B4-BE49-F238E27FC236}">
                  <a16:creationId xmlns:a16="http://schemas.microsoft.com/office/drawing/2014/main" id="{11538F44-B2D6-9457-E2BB-58ADE0A06D6B}"/>
                </a:ext>
              </a:extLst>
            </p:cNvPr>
            <p:cNvSpPr/>
            <p:nvPr/>
          </p:nvSpPr>
          <p:spPr>
            <a:xfrm>
              <a:off x="454701" y="452382"/>
              <a:ext cx="116726" cy="58678"/>
            </a:xfrm>
            <a:custGeom>
              <a:avLst/>
              <a:gdLst>
                <a:gd name="connsiteX0" fmla="*/ 0 w 116726"/>
                <a:gd name="connsiteY0" fmla="*/ 0 h 58678"/>
                <a:gd name="connsiteX1" fmla="*/ 116727 w 116726"/>
                <a:gd name="connsiteY1" fmla="*/ 0 h 58678"/>
                <a:gd name="connsiteX2" fmla="*/ 116727 w 116726"/>
                <a:gd name="connsiteY2" fmla="*/ 58678 h 58678"/>
                <a:gd name="connsiteX3" fmla="*/ 0 w 116726"/>
                <a:gd name="connsiteY3" fmla="*/ 58678 h 5867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16726" h="58678">
                  <a:moveTo>
                    <a:pt x="0" y="0"/>
                  </a:moveTo>
                  <a:lnTo>
                    <a:pt x="116727" y="0"/>
                  </a:lnTo>
                  <a:lnTo>
                    <a:pt x="116727" y="58678"/>
                  </a:lnTo>
                  <a:lnTo>
                    <a:pt x="0" y="58678"/>
                  </a:lnTo>
                  <a:close/>
                </a:path>
              </a:pathLst>
            </a:custGeom>
            <a:solidFill>
              <a:srgbClr val="C21536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</p:grpSp>
    </p:spTree>
    <p:extLst>
      <p:ext uri="{BB962C8B-B14F-4D97-AF65-F5344CB8AC3E}">
        <p14:creationId xmlns:p14="http://schemas.microsoft.com/office/powerpoint/2010/main" val="220594022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Undertittel 2">
            <a:extLst>
              <a:ext uri="{FF2B5EF4-FFF2-40B4-BE49-F238E27FC236}">
                <a16:creationId xmlns:a16="http://schemas.microsoft.com/office/drawing/2014/main" id="{5512372B-80FE-4EAF-B063-7C4464D6C595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Tittel 4">
            <a:extLst>
              <a:ext uri="{FF2B5EF4-FFF2-40B4-BE49-F238E27FC236}">
                <a16:creationId xmlns:a16="http://schemas.microsoft.com/office/drawing/2014/main" id="{AE2D6C44-0600-4569-B047-9F6660F28FB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nb-NO" dirty="0"/>
              <a:t>Fokusutsagn</a:t>
            </a:r>
          </a:p>
        </p:txBody>
      </p:sp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03AF29A7-5751-2041-B29B-827CA14C98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7274F-C966-8C46-AFC4-F3A14ECF3B01}" type="slidenum">
              <a:rPr lang="nb-NO" smtClean="0"/>
              <a:t>12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12599093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1373CCB0-9E84-493B-9A6D-C4C3147E71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2286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B47274F-C966-8C46-AFC4-F3A14ECF3B01}" type="slidenum">
              <a:rPr kumimoji="0" lang="nb-NO" sz="1200" b="1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+mn-ea"/>
                <a:cs typeface="+mn-cs"/>
              </a:rPr>
              <a:pPr marL="0" marR="0" lvl="0" indent="0" algn="r" defTabSz="2286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3</a:t>
            </a:fld>
            <a:endParaRPr kumimoji="0" lang="nb-NO" sz="1200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+mn-ea"/>
              <a:cs typeface="+mn-cs"/>
            </a:endParaRPr>
          </a:p>
        </p:txBody>
      </p:sp>
      <p:sp>
        <p:nvSpPr>
          <p:cNvPr id="5" name="Rektangel 4">
            <a:extLst>
              <a:ext uri="{FF2B5EF4-FFF2-40B4-BE49-F238E27FC236}">
                <a16:creationId xmlns:a16="http://schemas.microsoft.com/office/drawing/2014/main" id="{902ACBC1-3963-4B21-8A2D-F989E6D78527}"/>
              </a:ext>
            </a:extLst>
          </p:cNvPr>
          <p:cNvSpPr/>
          <p:nvPr/>
        </p:nvSpPr>
        <p:spPr>
          <a:xfrm>
            <a:off x="1981201" y="2690337"/>
            <a:ext cx="8327985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ctr"/>
            <a:r>
              <a:rPr kumimoji="0" lang="nb-NO" sz="3200" b="1" i="0" u="none" strike="noStrike" kern="0" cap="none" spc="0" normalizeH="0" baseline="0" noProof="0" dirty="0">
                <a:ln>
                  <a:noFill/>
                </a:ln>
                <a:solidFill>
                  <a:schemeClr val="accent1"/>
                </a:solidFill>
                <a:effectLst/>
                <a:uLnTx/>
                <a:uFillTx/>
                <a:latin typeface="Century Gothic" panose="020B0502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‘’</a:t>
            </a:r>
            <a:r>
              <a:rPr lang="nb-NO" sz="3200" b="1" i="1" kern="0" noProof="0" dirty="0">
                <a:solidFill>
                  <a:schemeClr val="accent1"/>
                </a:solidFill>
                <a:latin typeface="Century Gothic" panose="020B0502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nb-NO" sz="3200" b="1" i="1" kern="0" dirty="0" err="1">
                <a:solidFill>
                  <a:schemeClr val="accent1"/>
                </a:solidFill>
                <a:latin typeface="Century Gothic" panose="020B0502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vilke</a:t>
            </a:r>
            <a:r>
              <a:rPr lang="nb-NO" sz="3200" b="1" i="1" kern="0" dirty="0">
                <a:solidFill>
                  <a:schemeClr val="accent1"/>
                </a:solidFill>
                <a:latin typeface="Century Gothic" panose="020B0502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etingelser må være til stede for en vellykket implementering ved din arbeidsplass</a:t>
            </a:r>
            <a:r>
              <a:rPr kumimoji="0" lang="nb-NO" sz="3200" b="1" i="0" u="none" strike="noStrike" kern="0" cap="none" spc="0" normalizeH="0" baseline="0" noProof="0" dirty="0">
                <a:ln>
                  <a:noFill/>
                </a:ln>
                <a:solidFill>
                  <a:schemeClr val="accent1"/>
                </a:solidFill>
                <a:effectLst/>
                <a:uLnTx/>
                <a:uFillTx/>
                <a:latin typeface="Century Gothic" panose="020B0502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‘’</a:t>
            </a:r>
            <a:endParaRPr kumimoji="0" lang="nb-NO" sz="3200" b="1" i="1" u="none" strike="noStrike" kern="0" cap="none" spc="0" normalizeH="0" baseline="0" noProof="0" dirty="0">
              <a:ln>
                <a:noFill/>
              </a:ln>
              <a:solidFill>
                <a:schemeClr val="accent1"/>
              </a:solidFill>
              <a:effectLst/>
              <a:uLnTx/>
              <a:uFillTx/>
              <a:latin typeface="Century Gothic" panose="020B0502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9454176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Undertittel 5">
            <a:extLst>
              <a:ext uri="{FF2B5EF4-FFF2-40B4-BE49-F238E27FC236}">
                <a16:creationId xmlns:a16="http://schemas.microsoft.com/office/drawing/2014/main" id="{ADABB02F-9972-4C7D-841E-0E8722653B92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Tittel 4">
            <a:extLst>
              <a:ext uri="{FF2B5EF4-FFF2-40B4-BE49-F238E27FC236}">
                <a16:creationId xmlns:a16="http://schemas.microsoft.com/office/drawing/2014/main" id="{AE2D6C44-0600-4569-B047-9F6660F28FB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nb-NO" dirty="0"/>
              <a:t>Sortering</a:t>
            </a:r>
          </a:p>
        </p:txBody>
      </p:sp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03AF29A7-5751-2041-B29B-827CA14C98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7274F-C966-8C46-AFC4-F3A14ECF3B01}" type="slidenum">
              <a:rPr lang="nb-NO" smtClean="0"/>
              <a:t>14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15600639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ssholder for innhold 5">
            <a:extLst>
              <a:ext uri="{FF2B5EF4-FFF2-40B4-BE49-F238E27FC236}">
                <a16:creationId xmlns:a16="http://schemas.microsoft.com/office/drawing/2014/main" id="{AD37E570-729C-4434-9AF1-C45B1D904C08}"/>
              </a:ext>
            </a:extLst>
          </p:cNvPr>
          <p:cNvSpPr>
            <a:spLocks noGrp="1"/>
          </p:cNvSpPr>
          <p:nvPr>
            <p:ph sz="half" idx="1"/>
          </p:nvPr>
        </p:nvSpPr>
        <p:spPr/>
        <p:txBody>
          <a:bodyPr/>
          <a:lstStyle/>
          <a:p>
            <a:pPr marL="457200" indent="-457200">
              <a:buFont typeface="+mj-lt"/>
              <a:buAutoNum type="arabicParenR"/>
            </a:pPr>
            <a:r>
              <a:rPr lang="nb-NO" sz="2000" dirty="0"/>
              <a:t>Les strategien på hvert av kortene</a:t>
            </a:r>
          </a:p>
          <a:p>
            <a:pPr marL="457200" indent="-457200">
              <a:buFont typeface="+mj-lt"/>
              <a:buAutoNum type="arabicParenR"/>
            </a:pPr>
            <a:r>
              <a:rPr lang="nb-NO" sz="2000" dirty="0"/>
              <a:t>Om du vil nyansere eller legge til noe, skriv en kommentar på baksiden </a:t>
            </a:r>
          </a:p>
          <a:p>
            <a:pPr marL="457200" indent="-457200">
              <a:buFont typeface="+mj-lt"/>
              <a:buAutoNum type="arabicParenR"/>
            </a:pPr>
            <a:r>
              <a:rPr lang="nb-NO" sz="2000" dirty="0"/>
              <a:t>Sorter kortene i bunker på en måte </a:t>
            </a:r>
            <a:r>
              <a:rPr lang="nb-NO" sz="2000" i="1" dirty="0"/>
              <a:t>som gir mening for deg</a:t>
            </a:r>
          </a:p>
          <a:p>
            <a:pPr marL="457200" indent="-457200">
              <a:buFont typeface="+mj-lt"/>
              <a:buAutoNum type="arabicParenR"/>
            </a:pPr>
            <a:r>
              <a:rPr lang="nb-NO" sz="2000" dirty="0"/>
              <a:t>Plasser lignende kort i samme bunke. Grupper kort etter likhet, </a:t>
            </a:r>
            <a:r>
              <a:rPr lang="nb-NO" sz="2000" i="1" u="sng" dirty="0"/>
              <a:t>ikke</a:t>
            </a:r>
            <a:r>
              <a:rPr lang="nb-NO" sz="2000" dirty="0"/>
              <a:t> prioritet</a:t>
            </a:r>
          </a:p>
        </p:txBody>
      </p:sp>
      <p:sp>
        <p:nvSpPr>
          <p:cNvPr id="8" name="Plassholder for innhold 7">
            <a:extLst>
              <a:ext uri="{FF2B5EF4-FFF2-40B4-BE49-F238E27FC236}">
                <a16:creationId xmlns:a16="http://schemas.microsoft.com/office/drawing/2014/main" id="{85039023-2EDA-41FB-8571-73D711319320}"/>
              </a:ext>
            </a:extLst>
          </p:cNvPr>
          <p:cNvSpPr>
            <a:spLocks noGrp="1"/>
          </p:cNvSpPr>
          <p:nvPr>
            <p:ph sz="half" idx="13"/>
          </p:nvPr>
        </p:nvSpPr>
        <p:spPr/>
        <p:txBody>
          <a:bodyPr/>
          <a:lstStyle/>
          <a:p>
            <a:pPr marL="457200" indent="-457200">
              <a:buFont typeface="+mj-lt"/>
              <a:buAutoNum type="arabicParenR" startAt="9"/>
            </a:pPr>
            <a:r>
              <a:rPr lang="nb-NO" sz="2000" dirty="0"/>
              <a:t>Skriv et navn på hver bunke på en </a:t>
            </a:r>
            <a:r>
              <a:rPr lang="nb-NO" sz="2000" dirty="0" err="1"/>
              <a:t>post-it</a:t>
            </a:r>
            <a:r>
              <a:rPr lang="nb-NO" sz="2000" dirty="0"/>
              <a:t> lapp</a:t>
            </a:r>
          </a:p>
          <a:p>
            <a:pPr marL="457200" indent="-457200">
              <a:buFont typeface="+mj-lt"/>
              <a:buAutoNum type="arabicParenR" startAt="9"/>
            </a:pPr>
            <a:r>
              <a:rPr lang="nb-NO" sz="2000" dirty="0"/>
              <a:t>Fest hver bunke med navnelappen sammen med en strikk</a:t>
            </a:r>
          </a:p>
        </p:txBody>
      </p:sp>
      <p:sp>
        <p:nvSpPr>
          <p:cNvPr id="7" name="Plassholder for innhold 6">
            <a:extLst>
              <a:ext uri="{FF2B5EF4-FFF2-40B4-BE49-F238E27FC236}">
                <a16:creationId xmlns:a16="http://schemas.microsoft.com/office/drawing/2014/main" id="{B63D18CD-5F46-4C31-AE1D-30A1E121463A}"/>
              </a:ext>
            </a:extLst>
          </p:cNvPr>
          <p:cNvSpPr>
            <a:spLocks noGrp="1"/>
          </p:cNvSpPr>
          <p:nvPr>
            <p:ph sz="half" idx="2"/>
          </p:nvPr>
        </p:nvSpPr>
        <p:spPr/>
        <p:txBody>
          <a:bodyPr/>
          <a:lstStyle/>
          <a:p>
            <a:pPr marL="457200" indent="-457200">
              <a:buFont typeface="+mj-lt"/>
              <a:buAutoNum type="arabicParenR" startAt="5"/>
            </a:pPr>
            <a:r>
              <a:rPr lang="nb-NO" sz="2000" dirty="0"/>
              <a:t>Det er ingen riktige eller gale grupperinger</a:t>
            </a:r>
          </a:p>
          <a:p>
            <a:pPr marL="457200" indent="-457200">
              <a:buFont typeface="+mj-lt"/>
              <a:buAutoNum type="arabicParenR" startAt="5"/>
            </a:pPr>
            <a:r>
              <a:rPr lang="nb-NO" sz="2000" dirty="0"/>
              <a:t>Lag så mange bunker du vil, men du kan ikke samle alle kortene i 1 bunke eller la hvert kort være sin egen bunke</a:t>
            </a:r>
          </a:p>
          <a:p>
            <a:pPr marL="457200" indent="-457200">
              <a:buFont typeface="+mj-lt"/>
              <a:buAutoNum type="arabicParenR" startAt="5"/>
            </a:pPr>
            <a:r>
              <a:rPr lang="nb-NO" sz="2000" dirty="0"/>
              <a:t>Alle kort skal plasseres inn i en av bunkene. Det er ikke lov å lage en «</a:t>
            </a:r>
            <a:r>
              <a:rPr lang="nb-NO" sz="2000" i="1" dirty="0"/>
              <a:t>diverse</a:t>
            </a:r>
            <a:r>
              <a:rPr lang="nb-NO" sz="2000" dirty="0"/>
              <a:t>»-bunke</a:t>
            </a:r>
          </a:p>
        </p:txBody>
      </p:sp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1E7E68CE-BFFB-4706-B661-36E4AE0D68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BC5DA-09B7-4CD9-B21E-157BBBE69313}" type="slidenum">
              <a:rPr lang="en-US" smtClean="0"/>
              <a:pPr/>
              <a:t>15</a:t>
            </a:fld>
            <a:endParaRPr lang="en-US" dirty="0"/>
          </a:p>
        </p:txBody>
      </p:sp>
      <p:sp>
        <p:nvSpPr>
          <p:cNvPr id="5" name="Tittel 4">
            <a:extLst>
              <a:ext uri="{FF2B5EF4-FFF2-40B4-BE49-F238E27FC236}">
                <a16:creationId xmlns:a16="http://schemas.microsoft.com/office/drawing/2014/main" id="{58F7FC86-8252-4795-81CA-4AF5F04D50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dirty="0"/>
              <a:t>Sorteringsoppgave – instruksjoner </a:t>
            </a:r>
          </a:p>
        </p:txBody>
      </p:sp>
    </p:spTree>
    <p:extLst>
      <p:ext uri="{BB962C8B-B14F-4D97-AF65-F5344CB8AC3E}">
        <p14:creationId xmlns:p14="http://schemas.microsoft.com/office/powerpoint/2010/main" val="370687073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Undertittel 1">
            <a:extLst>
              <a:ext uri="{FF2B5EF4-FFF2-40B4-BE49-F238E27FC236}">
                <a16:creationId xmlns:a16="http://schemas.microsoft.com/office/drawing/2014/main" id="{57028FFE-B7DF-45BD-9B6E-7BDCF48EE222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Tittel 4">
            <a:extLst>
              <a:ext uri="{FF2B5EF4-FFF2-40B4-BE49-F238E27FC236}">
                <a16:creationId xmlns:a16="http://schemas.microsoft.com/office/drawing/2014/main" id="{AE2D6C44-0600-4569-B047-9F6660F28FB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nb-NO" dirty="0"/>
              <a:t>Vurdering</a:t>
            </a:r>
          </a:p>
        </p:txBody>
      </p:sp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03AF29A7-5751-2041-B29B-827CA14C98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7274F-C966-8C46-AFC4-F3A14ECF3B01}" type="slidenum">
              <a:rPr lang="nb-NO" smtClean="0"/>
              <a:t>16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02269348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innhold 1">
            <a:extLst>
              <a:ext uri="{FF2B5EF4-FFF2-40B4-BE49-F238E27FC236}">
                <a16:creationId xmlns:a16="http://schemas.microsoft.com/office/drawing/2014/main" id="{5D2046FD-E210-44A5-B8B2-275A659FB3AF}"/>
              </a:ext>
            </a:extLst>
          </p:cNvPr>
          <p:cNvSpPr>
            <a:spLocks noGrp="1"/>
          </p:cNvSpPr>
          <p:nvPr>
            <p:ph sz="half" idx="1"/>
          </p:nvPr>
        </p:nvSpPr>
        <p:spPr/>
        <p:txBody>
          <a:bodyPr/>
          <a:lstStyle/>
          <a:p>
            <a:r>
              <a:rPr lang="nb-NO" dirty="0"/>
              <a:t>Finn frem 1-og-1 bunke av gangen</a:t>
            </a:r>
          </a:p>
          <a:p>
            <a:r>
              <a:rPr lang="nb-NO" dirty="0"/>
              <a:t>Ta av strikken, les strategien på hvert av kortene i bunken</a:t>
            </a:r>
          </a:p>
          <a:p>
            <a:r>
              <a:rPr lang="nb-NO" dirty="0"/>
              <a:t>Vurder hvert av strategiene </a:t>
            </a:r>
            <a:r>
              <a:rPr lang="nb-NO" dirty="0" err="1"/>
              <a:t>mtp</a:t>
            </a:r>
            <a:r>
              <a:rPr lang="nb-NO" dirty="0"/>
              <a:t>. dens betydning for implementering hos dere</a:t>
            </a:r>
            <a:endParaRPr lang="nb-NO" sz="1200" dirty="0"/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9BC388C2-48F9-4E4C-9ED5-378D431BF4CA}"/>
              </a:ext>
            </a:extLst>
          </p:cNvPr>
          <p:cNvSpPr>
            <a:spLocks noGrp="1"/>
          </p:cNvSpPr>
          <p:nvPr>
            <p:ph sz="half" idx="2"/>
          </p:nvPr>
        </p:nvSpPr>
        <p:spPr/>
        <p:txBody>
          <a:bodyPr/>
          <a:lstStyle/>
          <a:p>
            <a:r>
              <a:rPr lang="nb-NO" dirty="0"/>
              <a:t>Vurder hver strategi på en skala fra 1 til 5 hvor 1 = Relativt uviktig og 5 = Ekstremt viktig</a:t>
            </a:r>
          </a:p>
          <a:p>
            <a:r>
              <a:rPr lang="nb-NO" dirty="0"/>
              <a:t>Vurder hver strategi på en skala fra 1 til 5 hvor 1 = Ikke i det hele tatt og 5 = Særdeles (gjennomførbar)</a:t>
            </a:r>
          </a:p>
        </p:txBody>
      </p:sp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3323A835-EE8A-4FA2-9BD5-EBD7EC96CF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7274F-C966-8C46-AFC4-F3A14ECF3B01}" type="slidenum">
              <a:rPr lang="nb-NO" smtClean="0"/>
              <a:t>17</a:t>
            </a:fld>
            <a:endParaRPr lang="nb-NO"/>
          </a:p>
        </p:txBody>
      </p:sp>
      <p:sp>
        <p:nvSpPr>
          <p:cNvPr id="5" name="Tittel 4">
            <a:extLst>
              <a:ext uri="{FF2B5EF4-FFF2-40B4-BE49-F238E27FC236}">
                <a16:creationId xmlns:a16="http://schemas.microsoft.com/office/drawing/2014/main" id="{7AA29B48-AFBC-48A1-9CD3-A12E199B02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dirty="0"/>
              <a:t>Vurderingsoppgave – instruksjoner </a:t>
            </a:r>
          </a:p>
        </p:txBody>
      </p:sp>
      <p:sp>
        <p:nvSpPr>
          <p:cNvPr id="6" name="Plassholder for innhold 5">
            <a:extLst>
              <a:ext uri="{FF2B5EF4-FFF2-40B4-BE49-F238E27FC236}">
                <a16:creationId xmlns:a16="http://schemas.microsoft.com/office/drawing/2014/main" id="{5200C0C5-2C47-410F-9F91-8F9699BEAD01}"/>
              </a:ext>
            </a:extLst>
          </p:cNvPr>
          <p:cNvSpPr>
            <a:spLocks noGrp="1"/>
          </p:cNvSpPr>
          <p:nvPr>
            <p:ph sz="half" idx="13"/>
          </p:nvPr>
        </p:nvSpPr>
        <p:spPr/>
        <p:txBody>
          <a:bodyPr/>
          <a:lstStyle/>
          <a:p>
            <a:r>
              <a:rPr lang="nb-NO" dirty="0"/>
              <a:t>Spre vurderingene; bruk alle 5 verdiene minst én gang for hvert av spørsmålene</a:t>
            </a:r>
          </a:p>
          <a:p>
            <a:r>
              <a:rPr lang="nb-NO" dirty="0"/>
              <a:t>Når du er ferdig, slå strikk rundt bunken  og vurder neste</a:t>
            </a:r>
          </a:p>
          <a:p>
            <a:r>
              <a:rPr lang="nb-NO" dirty="0"/>
              <a:t>Legg hver bunke i egen </a:t>
            </a:r>
            <a:r>
              <a:rPr lang="nb-NO" dirty="0" err="1"/>
              <a:t>zippet</a:t>
            </a:r>
            <a:r>
              <a:rPr lang="nb-NO" dirty="0"/>
              <a:t> pose</a:t>
            </a:r>
          </a:p>
          <a:p>
            <a:r>
              <a:rPr lang="nb-NO" dirty="0"/>
              <a:t>Legg de </a:t>
            </a:r>
            <a:r>
              <a:rPr lang="nb-NO" dirty="0" err="1"/>
              <a:t>zippede</a:t>
            </a:r>
            <a:r>
              <a:rPr lang="nb-NO" dirty="0"/>
              <a:t> posene i den store posen</a:t>
            </a:r>
          </a:p>
          <a:p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262198510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Undertittel 1">
            <a:extLst>
              <a:ext uri="{FF2B5EF4-FFF2-40B4-BE49-F238E27FC236}">
                <a16:creationId xmlns:a16="http://schemas.microsoft.com/office/drawing/2014/main" id="{C9E8D2D5-ED41-424C-8996-468AC4AA8EB7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Tittel 4">
            <a:extLst>
              <a:ext uri="{FF2B5EF4-FFF2-40B4-BE49-F238E27FC236}">
                <a16:creationId xmlns:a16="http://schemas.microsoft.com/office/drawing/2014/main" id="{AE2D6C44-0600-4569-B047-9F6660F28FB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nb-NO" dirty="0"/>
              <a:t>Brainstorming</a:t>
            </a:r>
          </a:p>
        </p:txBody>
      </p:sp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03AF29A7-5751-2041-B29B-827CA14C98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7274F-C966-8C46-AFC4-F3A14ECF3B01}" type="slidenum">
              <a:rPr lang="nb-NO" smtClean="0"/>
              <a:t>18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288341701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FC2FDF97-C995-4369-AD52-1B07420DE6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2286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B47274F-C966-8C46-AFC4-F3A14ECF3B01}" type="slidenum">
              <a:rPr kumimoji="0" lang="nb-NO" sz="1200" b="1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+mn-ea"/>
                <a:cs typeface="+mn-cs"/>
              </a:rPr>
              <a:pPr marL="0" marR="0" lvl="0" indent="0" algn="r" defTabSz="2286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9</a:t>
            </a:fld>
            <a:endParaRPr kumimoji="0" lang="nb-NO" sz="1200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+mn-ea"/>
              <a:cs typeface="+mn-cs"/>
            </a:endParaRPr>
          </a:p>
        </p:txBody>
      </p:sp>
      <p:grpSp>
        <p:nvGrpSpPr>
          <p:cNvPr id="10" name="Gruppe 9">
            <a:extLst>
              <a:ext uri="{FF2B5EF4-FFF2-40B4-BE49-F238E27FC236}">
                <a16:creationId xmlns:a16="http://schemas.microsoft.com/office/drawing/2014/main" id="{7F6A9326-EB71-42AE-A844-315B036EF7DF}"/>
              </a:ext>
            </a:extLst>
          </p:cNvPr>
          <p:cNvGrpSpPr/>
          <p:nvPr/>
        </p:nvGrpSpPr>
        <p:grpSpPr>
          <a:xfrm>
            <a:off x="396023" y="393704"/>
            <a:ext cx="833492" cy="177295"/>
            <a:chOff x="396023" y="393704"/>
            <a:chExt cx="833492" cy="177295"/>
          </a:xfrm>
        </p:grpSpPr>
        <p:sp>
          <p:nvSpPr>
            <p:cNvPr id="11" name="Friform 6">
              <a:extLst>
                <a:ext uri="{FF2B5EF4-FFF2-40B4-BE49-F238E27FC236}">
                  <a16:creationId xmlns:a16="http://schemas.microsoft.com/office/drawing/2014/main" id="{D190F5B5-D06A-4992-9FDC-98B8B1A56B35}"/>
                </a:ext>
              </a:extLst>
            </p:cNvPr>
            <p:cNvSpPr/>
            <p:nvPr/>
          </p:nvSpPr>
          <p:spPr>
            <a:xfrm>
              <a:off x="936121" y="394334"/>
              <a:ext cx="135024" cy="176665"/>
            </a:xfrm>
            <a:custGeom>
              <a:avLst/>
              <a:gdLst>
                <a:gd name="connsiteX0" fmla="*/ 108524 w 135024"/>
                <a:gd name="connsiteY0" fmla="*/ 0 h 176665"/>
                <a:gd name="connsiteX1" fmla="*/ 108524 w 135024"/>
                <a:gd name="connsiteY1" fmla="*/ 109154 h 176665"/>
                <a:gd name="connsiteX2" fmla="*/ 96536 w 135024"/>
                <a:gd name="connsiteY2" fmla="*/ 138808 h 176665"/>
                <a:gd name="connsiteX3" fmla="*/ 66881 w 135024"/>
                <a:gd name="connsiteY3" fmla="*/ 150796 h 176665"/>
                <a:gd name="connsiteX4" fmla="*/ 37226 w 135024"/>
                <a:gd name="connsiteY4" fmla="*/ 138808 h 176665"/>
                <a:gd name="connsiteX5" fmla="*/ 25238 w 135024"/>
                <a:gd name="connsiteY5" fmla="*/ 109154 h 176665"/>
                <a:gd name="connsiteX6" fmla="*/ 25238 w 135024"/>
                <a:gd name="connsiteY6" fmla="*/ 0 h 176665"/>
                <a:gd name="connsiteX7" fmla="*/ 0 w 135024"/>
                <a:gd name="connsiteY7" fmla="*/ 0 h 176665"/>
                <a:gd name="connsiteX8" fmla="*/ 0 w 135024"/>
                <a:gd name="connsiteY8" fmla="*/ 109154 h 176665"/>
                <a:gd name="connsiteX9" fmla="*/ 5048 w 135024"/>
                <a:gd name="connsiteY9" fmla="*/ 135023 h 176665"/>
                <a:gd name="connsiteX10" fmla="*/ 19560 w 135024"/>
                <a:gd name="connsiteY10" fmla="*/ 157106 h 176665"/>
                <a:gd name="connsiteX11" fmla="*/ 41643 w 135024"/>
                <a:gd name="connsiteY11" fmla="*/ 171617 h 176665"/>
                <a:gd name="connsiteX12" fmla="*/ 67512 w 135024"/>
                <a:gd name="connsiteY12" fmla="*/ 176665 h 176665"/>
                <a:gd name="connsiteX13" fmla="*/ 93382 w 135024"/>
                <a:gd name="connsiteY13" fmla="*/ 171617 h 176665"/>
                <a:gd name="connsiteX14" fmla="*/ 115465 w 135024"/>
                <a:gd name="connsiteY14" fmla="*/ 157106 h 176665"/>
                <a:gd name="connsiteX15" fmla="*/ 129977 w 135024"/>
                <a:gd name="connsiteY15" fmla="*/ 135023 h 176665"/>
                <a:gd name="connsiteX16" fmla="*/ 135025 w 135024"/>
                <a:gd name="connsiteY16" fmla="*/ 109154 h 176665"/>
                <a:gd name="connsiteX17" fmla="*/ 135025 w 135024"/>
                <a:gd name="connsiteY17" fmla="*/ 0 h 176665"/>
                <a:gd name="connsiteX18" fmla="*/ 108524 w 135024"/>
                <a:gd name="connsiteY18" fmla="*/ 0 h 1766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</a:cxnLst>
              <a:rect l="l" t="t" r="r" b="b"/>
              <a:pathLst>
                <a:path w="135024" h="176665">
                  <a:moveTo>
                    <a:pt x="108524" y="0"/>
                  </a:moveTo>
                  <a:lnTo>
                    <a:pt x="108524" y="109154"/>
                  </a:lnTo>
                  <a:cubicBezTo>
                    <a:pt x="108524" y="120511"/>
                    <a:pt x="104108" y="131237"/>
                    <a:pt x="96536" y="138808"/>
                  </a:cubicBezTo>
                  <a:cubicBezTo>
                    <a:pt x="88965" y="146380"/>
                    <a:pt x="78239" y="150796"/>
                    <a:pt x="66881" y="150796"/>
                  </a:cubicBezTo>
                  <a:cubicBezTo>
                    <a:pt x="55524" y="150796"/>
                    <a:pt x="44798" y="146380"/>
                    <a:pt x="37226" y="138808"/>
                  </a:cubicBezTo>
                  <a:cubicBezTo>
                    <a:pt x="29655" y="131237"/>
                    <a:pt x="25238" y="120511"/>
                    <a:pt x="25238" y="109154"/>
                  </a:cubicBezTo>
                  <a:lnTo>
                    <a:pt x="25238" y="0"/>
                  </a:lnTo>
                  <a:lnTo>
                    <a:pt x="0" y="0"/>
                  </a:lnTo>
                  <a:lnTo>
                    <a:pt x="0" y="109154"/>
                  </a:lnTo>
                  <a:cubicBezTo>
                    <a:pt x="0" y="117987"/>
                    <a:pt x="1893" y="126820"/>
                    <a:pt x="5048" y="135023"/>
                  </a:cubicBezTo>
                  <a:cubicBezTo>
                    <a:pt x="8202" y="143225"/>
                    <a:pt x="13250" y="150796"/>
                    <a:pt x="19560" y="157106"/>
                  </a:cubicBezTo>
                  <a:cubicBezTo>
                    <a:pt x="25869" y="163415"/>
                    <a:pt x="33441" y="168463"/>
                    <a:pt x="41643" y="171617"/>
                  </a:cubicBezTo>
                  <a:cubicBezTo>
                    <a:pt x="49846" y="174772"/>
                    <a:pt x="58679" y="176665"/>
                    <a:pt x="67512" y="176665"/>
                  </a:cubicBezTo>
                  <a:cubicBezTo>
                    <a:pt x="76346" y="176665"/>
                    <a:pt x="85179" y="174772"/>
                    <a:pt x="93382" y="171617"/>
                  </a:cubicBezTo>
                  <a:cubicBezTo>
                    <a:pt x="101584" y="168463"/>
                    <a:pt x="109155" y="163415"/>
                    <a:pt x="115465" y="157106"/>
                  </a:cubicBezTo>
                  <a:cubicBezTo>
                    <a:pt x="121775" y="150796"/>
                    <a:pt x="126822" y="143225"/>
                    <a:pt x="129977" y="135023"/>
                  </a:cubicBezTo>
                  <a:cubicBezTo>
                    <a:pt x="133132" y="126820"/>
                    <a:pt x="135025" y="117987"/>
                    <a:pt x="135025" y="109154"/>
                  </a:cubicBezTo>
                  <a:lnTo>
                    <a:pt x="135025" y="0"/>
                  </a:lnTo>
                  <a:lnTo>
                    <a:pt x="108524" y="0"/>
                  </a:lnTo>
                  <a:close/>
                </a:path>
              </a:pathLst>
            </a:custGeom>
            <a:solidFill>
              <a:schemeClr val="bg1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pPr marL="0" marR="0" lvl="0" indent="0" algn="l" defTabSz="2286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nb-NO" sz="9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12" name="Friform 7">
              <a:extLst>
                <a:ext uri="{FF2B5EF4-FFF2-40B4-BE49-F238E27FC236}">
                  <a16:creationId xmlns:a16="http://schemas.microsoft.com/office/drawing/2014/main" id="{B882EE20-9FD9-4D3C-B0C6-52EAB88C4F75}"/>
                </a:ext>
              </a:extLst>
            </p:cNvPr>
            <p:cNvSpPr/>
            <p:nvPr/>
          </p:nvSpPr>
          <p:spPr>
            <a:xfrm>
              <a:off x="630107" y="393704"/>
              <a:ext cx="119881" cy="175403"/>
            </a:xfrm>
            <a:custGeom>
              <a:avLst/>
              <a:gdLst>
                <a:gd name="connsiteX0" fmla="*/ 66881 w 119881"/>
                <a:gd name="connsiteY0" fmla="*/ 76345 h 175403"/>
                <a:gd name="connsiteX1" fmla="*/ 24607 w 119881"/>
                <a:gd name="connsiteY1" fmla="*/ 76345 h 175403"/>
                <a:gd name="connsiteX2" fmla="*/ 24607 w 119881"/>
                <a:gd name="connsiteY2" fmla="*/ 22714 h 175403"/>
                <a:gd name="connsiteX3" fmla="*/ 66881 w 119881"/>
                <a:gd name="connsiteY3" fmla="*/ 22714 h 175403"/>
                <a:gd name="connsiteX4" fmla="*/ 85179 w 119881"/>
                <a:gd name="connsiteY4" fmla="*/ 30285 h 175403"/>
                <a:gd name="connsiteX5" fmla="*/ 92751 w 119881"/>
                <a:gd name="connsiteY5" fmla="*/ 48583 h 175403"/>
                <a:gd name="connsiteX6" fmla="*/ 92751 w 119881"/>
                <a:gd name="connsiteY6" fmla="*/ 50476 h 175403"/>
                <a:gd name="connsiteX7" fmla="*/ 85179 w 119881"/>
                <a:gd name="connsiteY7" fmla="*/ 68773 h 175403"/>
                <a:gd name="connsiteX8" fmla="*/ 66881 w 119881"/>
                <a:gd name="connsiteY8" fmla="*/ 76345 h 175403"/>
                <a:gd name="connsiteX9" fmla="*/ 119882 w 119881"/>
                <a:gd name="connsiteY9" fmla="*/ 49845 h 175403"/>
                <a:gd name="connsiteX10" fmla="*/ 119882 w 119881"/>
                <a:gd name="connsiteY10" fmla="*/ 49845 h 175403"/>
                <a:gd name="connsiteX11" fmla="*/ 105370 w 119881"/>
                <a:gd name="connsiteY11" fmla="*/ 14512 h 175403"/>
                <a:gd name="connsiteX12" fmla="*/ 70667 w 119881"/>
                <a:gd name="connsiteY12" fmla="*/ 0 h 175403"/>
                <a:gd name="connsiteX13" fmla="*/ 0 w 119881"/>
                <a:gd name="connsiteY13" fmla="*/ 0 h 175403"/>
                <a:gd name="connsiteX14" fmla="*/ 0 w 119881"/>
                <a:gd name="connsiteY14" fmla="*/ 174772 h 175403"/>
                <a:gd name="connsiteX15" fmla="*/ 25238 w 119881"/>
                <a:gd name="connsiteY15" fmla="*/ 174772 h 175403"/>
                <a:gd name="connsiteX16" fmla="*/ 25238 w 119881"/>
                <a:gd name="connsiteY16" fmla="*/ 98428 h 175403"/>
                <a:gd name="connsiteX17" fmla="*/ 37226 w 119881"/>
                <a:gd name="connsiteY17" fmla="*/ 98428 h 175403"/>
                <a:gd name="connsiteX18" fmla="*/ 86441 w 119881"/>
                <a:gd name="connsiteY18" fmla="*/ 175403 h 175403"/>
                <a:gd name="connsiteX19" fmla="*/ 117989 w 119881"/>
                <a:gd name="connsiteY19" fmla="*/ 175403 h 175403"/>
                <a:gd name="connsiteX20" fmla="*/ 67512 w 119881"/>
                <a:gd name="connsiteY20" fmla="*/ 98428 h 175403"/>
                <a:gd name="connsiteX21" fmla="*/ 71298 w 119881"/>
                <a:gd name="connsiteY21" fmla="*/ 98428 h 175403"/>
                <a:gd name="connsiteX22" fmla="*/ 90227 w 119881"/>
                <a:gd name="connsiteY22" fmla="*/ 94642 h 175403"/>
                <a:gd name="connsiteX23" fmla="*/ 106001 w 119881"/>
                <a:gd name="connsiteY23" fmla="*/ 83916 h 175403"/>
                <a:gd name="connsiteX24" fmla="*/ 116727 w 119881"/>
                <a:gd name="connsiteY24" fmla="*/ 68142 h 175403"/>
                <a:gd name="connsiteX25" fmla="*/ 119882 w 119881"/>
                <a:gd name="connsiteY25" fmla="*/ 49845 h 1754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</a:cxnLst>
              <a:rect l="l" t="t" r="r" b="b"/>
              <a:pathLst>
                <a:path w="119881" h="175403">
                  <a:moveTo>
                    <a:pt x="66881" y="76345"/>
                  </a:moveTo>
                  <a:lnTo>
                    <a:pt x="24607" y="76345"/>
                  </a:lnTo>
                  <a:lnTo>
                    <a:pt x="24607" y="22714"/>
                  </a:lnTo>
                  <a:lnTo>
                    <a:pt x="66881" y="22714"/>
                  </a:lnTo>
                  <a:cubicBezTo>
                    <a:pt x="73822" y="22714"/>
                    <a:pt x="80762" y="25238"/>
                    <a:pt x="85179" y="30285"/>
                  </a:cubicBezTo>
                  <a:cubicBezTo>
                    <a:pt x="90227" y="35333"/>
                    <a:pt x="92751" y="41642"/>
                    <a:pt x="92751" y="48583"/>
                  </a:cubicBezTo>
                  <a:lnTo>
                    <a:pt x="92751" y="50476"/>
                  </a:lnTo>
                  <a:cubicBezTo>
                    <a:pt x="92751" y="57416"/>
                    <a:pt x="90227" y="64357"/>
                    <a:pt x="85179" y="68773"/>
                  </a:cubicBezTo>
                  <a:cubicBezTo>
                    <a:pt x="80131" y="73190"/>
                    <a:pt x="73822" y="76345"/>
                    <a:pt x="66881" y="76345"/>
                  </a:cubicBezTo>
                  <a:close/>
                  <a:moveTo>
                    <a:pt x="119882" y="49845"/>
                  </a:moveTo>
                  <a:lnTo>
                    <a:pt x="119882" y="49845"/>
                  </a:lnTo>
                  <a:cubicBezTo>
                    <a:pt x="119882" y="36595"/>
                    <a:pt x="114834" y="23976"/>
                    <a:pt x="105370" y="14512"/>
                  </a:cubicBezTo>
                  <a:cubicBezTo>
                    <a:pt x="95905" y="5048"/>
                    <a:pt x="83917" y="0"/>
                    <a:pt x="70667" y="0"/>
                  </a:cubicBezTo>
                  <a:lnTo>
                    <a:pt x="0" y="0"/>
                  </a:lnTo>
                  <a:lnTo>
                    <a:pt x="0" y="174772"/>
                  </a:lnTo>
                  <a:lnTo>
                    <a:pt x="25238" y="174772"/>
                  </a:lnTo>
                  <a:lnTo>
                    <a:pt x="25238" y="98428"/>
                  </a:lnTo>
                  <a:lnTo>
                    <a:pt x="37226" y="98428"/>
                  </a:lnTo>
                  <a:lnTo>
                    <a:pt x="86441" y="175403"/>
                  </a:lnTo>
                  <a:lnTo>
                    <a:pt x="117989" y="175403"/>
                  </a:lnTo>
                  <a:lnTo>
                    <a:pt x="67512" y="98428"/>
                  </a:lnTo>
                  <a:lnTo>
                    <a:pt x="71298" y="98428"/>
                  </a:lnTo>
                  <a:cubicBezTo>
                    <a:pt x="77608" y="98428"/>
                    <a:pt x="83917" y="97166"/>
                    <a:pt x="90227" y="94642"/>
                  </a:cubicBezTo>
                  <a:cubicBezTo>
                    <a:pt x="95905" y="92118"/>
                    <a:pt x="101584" y="88333"/>
                    <a:pt x="106001" y="83916"/>
                  </a:cubicBezTo>
                  <a:cubicBezTo>
                    <a:pt x="110417" y="79499"/>
                    <a:pt x="114203" y="73821"/>
                    <a:pt x="116727" y="68142"/>
                  </a:cubicBezTo>
                  <a:cubicBezTo>
                    <a:pt x="118620" y="62464"/>
                    <a:pt x="119882" y="56154"/>
                    <a:pt x="119882" y="49845"/>
                  </a:cubicBezTo>
                  <a:close/>
                </a:path>
              </a:pathLst>
            </a:custGeom>
            <a:solidFill>
              <a:schemeClr val="bg1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pPr marL="0" marR="0" lvl="0" indent="0" algn="l" defTabSz="2286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nb-NO" sz="9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13" name="Friform 8">
              <a:extLst>
                <a:ext uri="{FF2B5EF4-FFF2-40B4-BE49-F238E27FC236}">
                  <a16:creationId xmlns:a16="http://schemas.microsoft.com/office/drawing/2014/main" id="{8AC0AB69-9321-4F81-8A70-EC176161BDFC}"/>
                </a:ext>
              </a:extLst>
            </p:cNvPr>
            <p:cNvSpPr/>
            <p:nvPr/>
          </p:nvSpPr>
          <p:spPr>
            <a:xfrm>
              <a:off x="1109003" y="394334"/>
              <a:ext cx="120512" cy="174772"/>
            </a:xfrm>
            <a:custGeom>
              <a:avLst/>
              <a:gdLst>
                <a:gd name="connsiteX0" fmla="*/ 92751 w 120512"/>
                <a:gd name="connsiteY0" fmla="*/ 49845 h 174772"/>
                <a:gd name="connsiteX1" fmla="*/ 85179 w 120512"/>
                <a:gd name="connsiteY1" fmla="*/ 68142 h 174772"/>
                <a:gd name="connsiteX2" fmla="*/ 66881 w 120512"/>
                <a:gd name="connsiteY2" fmla="*/ 75714 h 174772"/>
                <a:gd name="connsiteX3" fmla="*/ 24607 w 120512"/>
                <a:gd name="connsiteY3" fmla="*/ 75714 h 174772"/>
                <a:gd name="connsiteX4" fmla="*/ 24607 w 120512"/>
                <a:gd name="connsiteY4" fmla="*/ 22083 h 174772"/>
                <a:gd name="connsiteX5" fmla="*/ 66881 w 120512"/>
                <a:gd name="connsiteY5" fmla="*/ 22083 h 174772"/>
                <a:gd name="connsiteX6" fmla="*/ 85179 w 120512"/>
                <a:gd name="connsiteY6" fmla="*/ 29654 h 174772"/>
                <a:gd name="connsiteX7" fmla="*/ 92751 w 120512"/>
                <a:gd name="connsiteY7" fmla="*/ 47952 h 174772"/>
                <a:gd name="connsiteX8" fmla="*/ 92751 w 120512"/>
                <a:gd name="connsiteY8" fmla="*/ 49845 h 174772"/>
                <a:gd name="connsiteX9" fmla="*/ 71298 w 120512"/>
                <a:gd name="connsiteY9" fmla="*/ 0 h 174772"/>
                <a:gd name="connsiteX10" fmla="*/ 0 w 120512"/>
                <a:gd name="connsiteY10" fmla="*/ 0 h 174772"/>
                <a:gd name="connsiteX11" fmla="*/ 0 w 120512"/>
                <a:gd name="connsiteY11" fmla="*/ 174772 h 174772"/>
                <a:gd name="connsiteX12" fmla="*/ 25238 w 120512"/>
                <a:gd name="connsiteY12" fmla="*/ 174772 h 174772"/>
                <a:gd name="connsiteX13" fmla="*/ 25238 w 120512"/>
                <a:gd name="connsiteY13" fmla="*/ 97797 h 174772"/>
                <a:gd name="connsiteX14" fmla="*/ 71298 w 120512"/>
                <a:gd name="connsiteY14" fmla="*/ 97797 h 174772"/>
                <a:gd name="connsiteX15" fmla="*/ 90227 w 120512"/>
                <a:gd name="connsiteY15" fmla="*/ 94011 h 174772"/>
                <a:gd name="connsiteX16" fmla="*/ 106001 w 120512"/>
                <a:gd name="connsiteY16" fmla="*/ 83285 h 174772"/>
                <a:gd name="connsiteX17" fmla="*/ 116727 w 120512"/>
                <a:gd name="connsiteY17" fmla="*/ 67511 h 174772"/>
                <a:gd name="connsiteX18" fmla="*/ 120513 w 120512"/>
                <a:gd name="connsiteY18" fmla="*/ 48583 h 174772"/>
                <a:gd name="connsiteX19" fmla="*/ 120513 w 120512"/>
                <a:gd name="connsiteY19" fmla="*/ 48583 h 174772"/>
                <a:gd name="connsiteX20" fmla="*/ 106001 w 120512"/>
                <a:gd name="connsiteY20" fmla="*/ 13881 h 174772"/>
                <a:gd name="connsiteX21" fmla="*/ 71298 w 120512"/>
                <a:gd name="connsiteY21" fmla="*/ 0 h 1747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</a:cxnLst>
              <a:rect l="l" t="t" r="r" b="b"/>
              <a:pathLst>
                <a:path w="120512" h="174772">
                  <a:moveTo>
                    <a:pt x="92751" y="49845"/>
                  </a:moveTo>
                  <a:cubicBezTo>
                    <a:pt x="92751" y="56785"/>
                    <a:pt x="90227" y="63726"/>
                    <a:pt x="85179" y="68142"/>
                  </a:cubicBezTo>
                  <a:cubicBezTo>
                    <a:pt x="80131" y="72559"/>
                    <a:pt x="73822" y="75714"/>
                    <a:pt x="66881" y="75714"/>
                  </a:cubicBezTo>
                  <a:lnTo>
                    <a:pt x="24607" y="75714"/>
                  </a:lnTo>
                  <a:lnTo>
                    <a:pt x="24607" y="22083"/>
                  </a:lnTo>
                  <a:lnTo>
                    <a:pt x="66881" y="22083"/>
                  </a:lnTo>
                  <a:cubicBezTo>
                    <a:pt x="73822" y="22083"/>
                    <a:pt x="80762" y="24607"/>
                    <a:pt x="85179" y="29654"/>
                  </a:cubicBezTo>
                  <a:cubicBezTo>
                    <a:pt x="89596" y="34702"/>
                    <a:pt x="92751" y="41012"/>
                    <a:pt x="92751" y="47952"/>
                  </a:cubicBezTo>
                  <a:lnTo>
                    <a:pt x="92751" y="49845"/>
                  </a:lnTo>
                  <a:close/>
                  <a:moveTo>
                    <a:pt x="71298" y="0"/>
                  </a:moveTo>
                  <a:lnTo>
                    <a:pt x="0" y="0"/>
                  </a:lnTo>
                  <a:lnTo>
                    <a:pt x="0" y="174772"/>
                  </a:lnTo>
                  <a:lnTo>
                    <a:pt x="25238" y="174772"/>
                  </a:lnTo>
                  <a:lnTo>
                    <a:pt x="25238" y="97797"/>
                  </a:lnTo>
                  <a:lnTo>
                    <a:pt x="71298" y="97797"/>
                  </a:lnTo>
                  <a:cubicBezTo>
                    <a:pt x="77608" y="97797"/>
                    <a:pt x="83917" y="96535"/>
                    <a:pt x="90227" y="94011"/>
                  </a:cubicBezTo>
                  <a:cubicBezTo>
                    <a:pt x="96536" y="91487"/>
                    <a:pt x="101584" y="87702"/>
                    <a:pt x="106001" y="83285"/>
                  </a:cubicBezTo>
                  <a:cubicBezTo>
                    <a:pt x="110417" y="78868"/>
                    <a:pt x="114203" y="73190"/>
                    <a:pt x="116727" y="67511"/>
                  </a:cubicBezTo>
                  <a:cubicBezTo>
                    <a:pt x="119251" y="61833"/>
                    <a:pt x="120513" y="55523"/>
                    <a:pt x="120513" y="48583"/>
                  </a:cubicBezTo>
                  <a:lnTo>
                    <a:pt x="120513" y="48583"/>
                  </a:lnTo>
                  <a:cubicBezTo>
                    <a:pt x="120513" y="35333"/>
                    <a:pt x="115465" y="23345"/>
                    <a:pt x="106001" y="13881"/>
                  </a:cubicBezTo>
                  <a:cubicBezTo>
                    <a:pt x="96536" y="5048"/>
                    <a:pt x="83917" y="0"/>
                    <a:pt x="71298" y="0"/>
                  </a:cubicBezTo>
                  <a:close/>
                </a:path>
              </a:pathLst>
            </a:custGeom>
            <a:solidFill>
              <a:schemeClr val="bg1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pPr marL="0" marR="0" lvl="0" indent="0" algn="l" defTabSz="2286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nb-NO" sz="9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14" name="Friform 9">
              <a:extLst>
                <a:ext uri="{FF2B5EF4-FFF2-40B4-BE49-F238E27FC236}">
                  <a16:creationId xmlns:a16="http://schemas.microsoft.com/office/drawing/2014/main" id="{24D6FAFA-DC8E-4871-8526-4A1AD98C0CB7}"/>
                </a:ext>
              </a:extLst>
            </p:cNvPr>
            <p:cNvSpPr/>
            <p:nvPr/>
          </p:nvSpPr>
          <p:spPr>
            <a:xfrm>
              <a:off x="782168" y="394334"/>
              <a:ext cx="120354" cy="174772"/>
            </a:xfrm>
            <a:custGeom>
              <a:avLst/>
              <a:gdLst>
                <a:gd name="connsiteX0" fmla="*/ 93381 w 120354"/>
                <a:gd name="connsiteY0" fmla="*/ 49845 h 174772"/>
                <a:gd name="connsiteX1" fmla="*/ 91489 w 120354"/>
                <a:gd name="connsiteY1" fmla="*/ 59940 h 174772"/>
                <a:gd name="connsiteX2" fmla="*/ 85810 w 120354"/>
                <a:gd name="connsiteY2" fmla="*/ 68142 h 174772"/>
                <a:gd name="connsiteX3" fmla="*/ 77608 w 120354"/>
                <a:gd name="connsiteY3" fmla="*/ 73821 h 174772"/>
                <a:gd name="connsiteX4" fmla="*/ 67512 w 120354"/>
                <a:gd name="connsiteY4" fmla="*/ 75714 h 174772"/>
                <a:gd name="connsiteX5" fmla="*/ 25238 w 120354"/>
                <a:gd name="connsiteY5" fmla="*/ 75714 h 174772"/>
                <a:gd name="connsiteX6" fmla="*/ 25238 w 120354"/>
                <a:gd name="connsiteY6" fmla="*/ 22083 h 174772"/>
                <a:gd name="connsiteX7" fmla="*/ 67512 w 120354"/>
                <a:gd name="connsiteY7" fmla="*/ 22083 h 174772"/>
                <a:gd name="connsiteX8" fmla="*/ 85810 w 120354"/>
                <a:gd name="connsiteY8" fmla="*/ 29654 h 174772"/>
                <a:gd name="connsiteX9" fmla="*/ 93381 w 120354"/>
                <a:gd name="connsiteY9" fmla="*/ 47952 h 174772"/>
                <a:gd name="connsiteX10" fmla="*/ 93381 w 120354"/>
                <a:gd name="connsiteY10" fmla="*/ 49845 h 174772"/>
                <a:gd name="connsiteX11" fmla="*/ 93381 w 120354"/>
                <a:gd name="connsiteY11" fmla="*/ 126189 h 174772"/>
                <a:gd name="connsiteX12" fmla="*/ 85810 w 120354"/>
                <a:gd name="connsiteY12" fmla="*/ 144487 h 174772"/>
                <a:gd name="connsiteX13" fmla="*/ 67512 w 120354"/>
                <a:gd name="connsiteY13" fmla="*/ 152058 h 174772"/>
                <a:gd name="connsiteX14" fmla="*/ 25238 w 120354"/>
                <a:gd name="connsiteY14" fmla="*/ 152058 h 174772"/>
                <a:gd name="connsiteX15" fmla="*/ 25238 w 120354"/>
                <a:gd name="connsiteY15" fmla="*/ 98428 h 174772"/>
                <a:gd name="connsiteX16" fmla="*/ 67512 w 120354"/>
                <a:gd name="connsiteY16" fmla="*/ 98428 h 174772"/>
                <a:gd name="connsiteX17" fmla="*/ 85810 w 120354"/>
                <a:gd name="connsiteY17" fmla="*/ 105999 h 174772"/>
                <a:gd name="connsiteX18" fmla="*/ 93381 w 120354"/>
                <a:gd name="connsiteY18" fmla="*/ 124296 h 174772"/>
                <a:gd name="connsiteX19" fmla="*/ 93381 w 120354"/>
                <a:gd name="connsiteY19" fmla="*/ 126189 h 174772"/>
                <a:gd name="connsiteX20" fmla="*/ 119882 w 120354"/>
                <a:gd name="connsiteY20" fmla="*/ 48583 h 174772"/>
                <a:gd name="connsiteX21" fmla="*/ 105370 w 120354"/>
                <a:gd name="connsiteY21" fmla="*/ 14512 h 174772"/>
                <a:gd name="connsiteX22" fmla="*/ 71298 w 120354"/>
                <a:gd name="connsiteY22" fmla="*/ 0 h 174772"/>
                <a:gd name="connsiteX23" fmla="*/ 0 w 120354"/>
                <a:gd name="connsiteY23" fmla="*/ 0 h 174772"/>
                <a:gd name="connsiteX24" fmla="*/ 0 w 120354"/>
                <a:gd name="connsiteY24" fmla="*/ 174772 h 174772"/>
                <a:gd name="connsiteX25" fmla="*/ 71929 w 120354"/>
                <a:gd name="connsiteY25" fmla="*/ 174772 h 174772"/>
                <a:gd name="connsiteX26" fmla="*/ 100322 w 120354"/>
                <a:gd name="connsiteY26" fmla="*/ 165308 h 174772"/>
                <a:gd name="connsiteX27" fmla="*/ 117989 w 120354"/>
                <a:gd name="connsiteY27" fmla="*/ 141332 h 174772"/>
                <a:gd name="connsiteX28" fmla="*/ 117989 w 120354"/>
                <a:gd name="connsiteY28" fmla="*/ 111678 h 174772"/>
                <a:gd name="connsiteX29" fmla="*/ 100322 w 120354"/>
                <a:gd name="connsiteY29" fmla="*/ 87702 h 174772"/>
                <a:gd name="connsiteX30" fmla="*/ 114834 w 120354"/>
                <a:gd name="connsiteY30" fmla="*/ 70666 h 174772"/>
                <a:gd name="connsiteX31" fmla="*/ 119882 w 120354"/>
                <a:gd name="connsiteY31" fmla="*/ 48583 h 1747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</a:cxnLst>
              <a:rect l="l" t="t" r="r" b="b"/>
              <a:pathLst>
                <a:path w="120354" h="174772">
                  <a:moveTo>
                    <a:pt x="93381" y="49845"/>
                  </a:moveTo>
                  <a:cubicBezTo>
                    <a:pt x="93381" y="53000"/>
                    <a:pt x="92751" y="56785"/>
                    <a:pt x="91489" y="59940"/>
                  </a:cubicBezTo>
                  <a:cubicBezTo>
                    <a:pt x="90227" y="63095"/>
                    <a:pt x="88334" y="66249"/>
                    <a:pt x="85810" y="68142"/>
                  </a:cubicBezTo>
                  <a:cubicBezTo>
                    <a:pt x="83286" y="70666"/>
                    <a:pt x="80762" y="72559"/>
                    <a:pt x="77608" y="73821"/>
                  </a:cubicBezTo>
                  <a:cubicBezTo>
                    <a:pt x="74453" y="75083"/>
                    <a:pt x="71298" y="75714"/>
                    <a:pt x="67512" y="75714"/>
                  </a:cubicBezTo>
                  <a:lnTo>
                    <a:pt x="25238" y="75714"/>
                  </a:lnTo>
                  <a:lnTo>
                    <a:pt x="25238" y="22083"/>
                  </a:lnTo>
                  <a:lnTo>
                    <a:pt x="67512" y="22083"/>
                  </a:lnTo>
                  <a:cubicBezTo>
                    <a:pt x="74453" y="22083"/>
                    <a:pt x="81393" y="24607"/>
                    <a:pt x="85810" y="29654"/>
                  </a:cubicBezTo>
                  <a:cubicBezTo>
                    <a:pt x="90227" y="34702"/>
                    <a:pt x="93381" y="41012"/>
                    <a:pt x="93381" y="47952"/>
                  </a:cubicBezTo>
                  <a:lnTo>
                    <a:pt x="93381" y="49845"/>
                  </a:lnTo>
                  <a:close/>
                  <a:moveTo>
                    <a:pt x="93381" y="126189"/>
                  </a:moveTo>
                  <a:cubicBezTo>
                    <a:pt x="93381" y="133130"/>
                    <a:pt x="90858" y="140070"/>
                    <a:pt x="85810" y="144487"/>
                  </a:cubicBezTo>
                  <a:cubicBezTo>
                    <a:pt x="80762" y="149534"/>
                    <a:pt x="74453" y="152058"/>
                    <a:pt x="67512" y="152058"/>
                  </a:cubicBezTo>
                  <a:lnTo>
                    <a:pt x="25238" y="152058"/>
                  </a:lnTo>
                  <a:lnTo>
                    <a:pt x="25238" y="98428"/>
                  </a:lnTo>
                  <a:lnTo>
                    <a:pt x="67512" y="98428"/>
                  </a:lnTo>
                  <a:cubicBezTo>
                    <a:pt x="74453" y="98428"/>
                    <a:pt x="81393" y="100951"/>
                    <a:pt x="85810" y="105999"/>
                  </a:cubicBezTo>
                  <a:cubicBezTo>
                    <a:pt x="90858" y="111047"/>
                    <a:pt x="93381" y="117356"/>
                    <a:pt x="93381" y="124296"/>
                  </a:cubicBezTo>
                  <a:lnTo>
                    <a:pt x="93381" y="126189"/>
                  </a:lnTo>
                  <a:close/>
                  <a:moveTo>
                    <a:pt x="119882" y="48583"/>
                  </a:moveTo>
                  <a:cubicBezTo>
                    <a:pt x="119882" y="35964"/>
                    <a:pt x="114834" y="23345"/>
                    <a:pt x="105370" y="14512"/>
                  </a:cubicBezTo>
                  <a:cubicBezTo>
                    <a:pt x="96536" y="5679"/>
                    <a:pt x="83917" y="0"/>
                    <a:pt x="71298" y="0"/>
                  </a:cubicBezTo>
                  <a:lnTo>
                    <a:pt x="0" y="0"/>
                  </a:lnTo>
                  <a:lnTo>
                    <a:pt x="0" y="174772"/>
                  </a:lnTo>
                  <a:lnTo>
                    <a:pt x="71929" y="174772"/>
                  </a:lnTo>
                  <a:cubicBezTo>
                    <a:pt x="82024" y="174772"/>
                    <a:pt x="92120" y="171617"/>
                    <a:pt x="100322" y="165308"/>
                  </a:cubicBezTo>
                  <a:cubicBezTo>
                    <a:pt x="108524" y="159629"/>
                    <a:pt x="114834" y="150796"/>
                    <a:pt x="117989" y="141332"/>
                  </a:cubicBezTo>
                  <a:cubicBezTo>
                    <a:pt x="121144" y="131868"/>
                    <a:pt x="121144" y="121142"/>
                    <a:pt x="117989" y="111678"/>
                  </a:cubicBezTo>
                  <a:cubicBezTo>
                    <a:pt x="114834" y="102213"/>
                    <a:pt x="108524" y="93380"/>
                    <a:pt x="100322" y="87702"/>
                  </a:cubicBezTo>
                  <a:cubicBezTo>
                    <a:pt x="106632" y="83285"/>
                    <a:pt x="111679" y="77606"/>
                    <a:pt x="114834" y="70666"/>
                  </a:cubicBezTo>
                  <a:cubicBezTo>
                    <a:pt x="117989" y="63726"/>
                    <a:pt x="119882" y="56154"/>
                    <a:pt x="119882" y="48583"/>
                  </a:cubicBezTo>
                  <a:close/>
                </a:path>
              </a:pathLst>
            </a:custGeom>
            <a:solidFill>
              <a:schemeClr val="bg1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pPr marL="0" marR="0" lvl="0" indent="0" algn="l" defTabSz="2286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nb-NO" sz="9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15" name="Friform 10">
              <a:extLst>
                <a:ext uri="{FF2B5EF4-FFF2-40B4-BE49-F238E27FC236}">
                  <a16:creationId xmlns:a16="http://schemas.microsoft.com/office/drawing/2014/main" id="{7998BF4A-7B72-4DCC-9F67-7C92137E3389}"/>
                </a:ext>
              </a:extLst>
            </p:cNvPr>
            <p:cNvSpPr/>
            <p:nvPr/>
          </p:nvSpPr>
          <p:spPr>
            <a:xfrm>
              <a:off x="454701" y="393704"/>
              <a:ext cx="116095" cy="116725"/>
            </a:xfrm>
            <a:custGeom>
              <a:avLst/>
              <a:gdLst>
                <a:gd name="connsiteX0" fmla="*/ 58048 w 116095"/>
                <a:gd name="connsiteY0" fmla="*/ 0 h 116725"/>
                <a:gd name="connsiteX1" fmla="*/ 99060 w 116095"/>
                <a:gd name="connsiteY1" fmla="*/ 17036 h 116725"/>
                <a:gd name="connsiteX2" fmla="*/ 116096 w 116095"/>
                <a:gd name="connsiteY2" fmla="*/ 58047 h 116725"/>
                <a:gd name="connsiteX3" fmla="*/ 116096 w 116095"/>
                <a:gd name="connsiteY3" fmla="*/ 116725 h 116725"/>
                <a:gd name="connsiteX4" fmla="*/ 0 w 116095"/>
                <a:gd name="connsiteY4" fmla="*/ 116725 h 116725"/>
                <a:gd name="connsiteX5" fmla="*/ 0 w 116095"/>
                <a:gd name="connsiteY5" fmla="*/ 58678 h 116725"/>
                <a:gd name="connsiteX6" fmla="*/ 17036 w 116095"/>
                <a:gd name="connsiteY6" fmla="*/ 17667 h 116725"/>
                <a:gd name="connsiteX7" fmla="*/ 58048 w 116095"/>
                <a:gd name="connsiteY7" fmla="*/ 0 h 1167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116095" h="116725">
                  <a:moveTo>
                    <a:pt x="58048" y="0"/>
                  </a:moveTo>
                  <a:cubicBezTo>
                    <a:pt x="73822" y="0"/>
                    <a:pt x="88334" y="6309"/>
                    <a:pt x="99060" y="17036"/>
                  </a:cubicBezTo>
                  <a:cubicBezTo>
                    <a:pt x="109786" y="27762"/>
                    <a:pt x="116096" y="42904"/>
                    <a:pt x="116096" y="58047"/>
                  </a:cubicBezTo>
                  <a:lnTo>
                    <a:pt x="116096" y="116725"/>
                  </a:lnTo>
                  <a:lnTo>
                    <a:pt x="0" y="116725"/>
                  </a:lnTo>
                  <a:lnTo>
                    <a:pt x="0" y="58678"/>
                  </a:lnTo>
                  <a:cubicBezTo>
                    <a:pt x="0" y="42904"/>
                    <a:pt x="6310" y="28393"/>
                    <a:pt x="17036" y="17667"/>
                  </a:cubicBezTo>
                  <a:cubicBezTo>
                    <a:pt x="27762" y="6940"/>
                    <a:pt x="42905" y="0"/>
                    <a:pt x="58048" y="0"/>
                  </a:cubicBezTo>
                  <a:close/>
                </a:path>
              </a:pathLst>
            </a:custGeom>
            <a:solidFill>
              <a:srgbClr val="E31836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pPr marL="0" marR="0" lvl="0" indent="0" algn="l" defTabSz="2286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nb-NO" sz="9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16" name="Friform 11">
              <a:extLst>
                <a:ext uri="{FF2B5EF4-FFF2-40B4-BE49-F238E27FC236}">
                  <a16:creationId xmlns:a16="http://schemas.microsoft.com/office/drawing/2014/main" id="{37A3AE22-B5EE-402B-8924-FC0CB1AB1674}"/>
                </a:ext>
              </a:extLst>
            </p:cNvPr>
            <p:cNvSpPr/>
            <p:nvPr/>
          </p:nvSpPr>
          <p:spPr>
            <a:xfrm>
              <a:off x="396023" y="452382"/>
              <a:ext cx="58678" cy="116094"/>
            </a:xfrm>
            <a:custGeom>
              <a:avLst/>
              <a:gdLst>
                <a:gd name="connsiteX0" fmla="*/ 58679 w 58678"/>
                <a:gd name="connsiteY0" fmla="*/ 0 h 116094"/>
                <a:gd name="connsiteX1" fmla="*/ 17667 w 58678"/>
                <a:gd name="connsiteY1" fmla="*/ 17036 h 116094"/>
                <a:gd name="connsiteX2" fmla="*/ 0 w 58678"/>
                <a:gd name="connsiteY2" fmla="*/ 58047 h 116094"/>
                <a:gd name="connsiteX3" fmla="*/ 17036 w 58678"/>
                <a:gd name="connsiteY3" fmla="*/ 99059 h 116094"/>
                <a:gd name="connsiteX4" fmla="*/ 58048 w 58678"/>
                <a:gd name="connsiteY4" fmla="*/ 116094 h 116094"/>
                <a:gd name="connsiteX5" fmla="*/ 58048 w 58678"/>
                <a:gd name="connsiteY5" fmla="*/ 116094 h 116094"/>
                <a:gd name="connsiteX6" fmla="*/ 58048 w 58678"/>
                <a:gd name="connsiteY6" fmla="*/ 116094 h 116094"/>
                <a:gd name="connsiteX7" fmla="*/ 58048 w 58678"/>
                <a:gd name="connsiteY7" fmla="*/ 0 h 1160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58678" h="116094">
                  <a:moveTo>
                    <a:pt x="58679" y="0"/>
                  </a:moveTo>
                  <a:cubicBezTo>
                    <a:pt x="42905" y="0"/>
                    <a:pt x="28393" y="6309"/>
                    <a:pt x="17667" y="17036"/>
                  </a:cubicBezTo>
                  <a:cubicBezTo>
                    <a:pt x="6310" y="27762"/>
                    <a:pt x="0" y="42904"/>
                    <a:pt x="0" y="58047"/>
                  </a:cubicBezTo>
                  <a:cubicBezTo>
                    <a:pt x="0" y="73821"/>
                    <a:pt x="6310" y="88332"/>
                    <a:pt x="17036" y="99059"/>
                  </a:cubicBezTo>
                  <a:cubicBezTo>
                    <a:pt x="27762" y="109785"/>
                    <a:pt x="42905" y="116094"/>
                    <a:pt x="58048" y="116094"/>
                  </a:cubicBezTo>
                  <a:cubicBezTo>
                    <a:pt x="58048" y="116094"/>
                    <a:pt x="58048" y="116094"/>
                    <a:pt x="58048" y="116094"/>
                  </a:cubicBezTo>
                  <a:lnTo>
                    <a:pt x="58048" y="116094"/>
                  </a:lnTo>
                  <a:lnTo>
                    <a:pt x="58048" y="0"/>
                  </a:lnTo>
                  <a:close/>
                </a:path>
              </a:pathLst>
            </a:custGeom>
            <a:solidFill>
              <a:srgbClr val="728EE6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pPr marL="0" marR="0" lvl="0" indent="0" algn="l" defTabSz="2286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nb-NO" sz="9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17" name="Friform 12">
              <a:extLst>
                <a:ext uri="{FF2B5EF4-FFF2-40B4-BE49-F238E27FC236}">
                  <a16:creationId xmlns:a16="http://schemas.microsoft.com/office/drawing/2014/main" id="{446F9CFF-1FC9-43E2-82F4-47F2B3BFF833}"/>
                </a:ext>
              </a:extLst>
            </p:cNvPr>
            <p:cNvSpPr/>
            <p:nvPr/>
          </p:nvSpPr>
          <p:spPr>
            <a:xfrm>
              <a:off x="454701" y="510429"/>
              <a:ext cx="116726" cy="58047"/>
            </a:xfrm>
            <a:custGeom>
              <a:avLst/>
              <a:gdLst>
                <a:gd name="connsiteX0" fmla="*/ 116727 w 116726"/>
                <a:gd name="connsiteY0" fmla="*/ 0 h 58047"/>
                <a:gd name="connsiteX1" fmla="*/ 58048 w 116726"/>
                <a:gd name="connsiteY1" fmla="*/ 0 h 58047"/>
                <a:gd name="connsiteX2" fmla="*/ 41012 w 116726"/>
                <a:gd name="connsiteY2" fmla="*/ 41012 h 58047"/>
                <a:gd name="connsiteX3" fmla="*/ 0 w 116726"/>
                <a:gd name="connsiteY3" fmla="*/ 58047 h 58047"/>
                <a:gd name="connsiteX4" fmla="*/ 116727 w 116726"/>
                <a:gd name="connsiteY4" fmla="*/ 58047 h 58047"/>
                <a:gd name="connsiteX5" fmla="*/ 116727 w 116726"/>
                <a:gd name="connsiteY5" fmla="*/ 0 h 580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116726" h="58047">
                  <a:moveTo>
                    <a:pt x="116727" y="0"/>
                  </a:moveTo>
                  <a:lnTo>
                    <a:pt x="58048" y="0"/>
                  </a:lnTo>
                  <a:cubicBezTo>
                    <a:pt x="58048" y="15774"/>
                    <a:pt x="51738" y="30285"/>
                    <a:pt x="41012" y="41012"/>
                  </a:cubicBezTo>
                  <a:cubicBezTo>
                    <a:pt x="30286" y="51738"/>
                    <a:pt x="15143" y="58047"/>
                    <a:pt x="0" y="58047"/>
                  </a:cubicBezTo>
                  <a:lnTo>
                    <a:pt x="116727" y="58047"/>
                  </a:lnTo>
                  <a:lnTo>
                    <a:pt x="116727" y="0"/>
                  </a:lnTo>
                  <a:close/>
                </a:path>
              </a:pathLst>
            </a:custGeom>
            <a:solidFill>
              <a:srgbClr val="C2CFF4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pPr marL="0" marR="0" lvl="0" indent="0" algn="l" defTabSz="2286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nb-NO" sz="9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18" name="Friform 13">
              <a:extLst>
                <a:ext uri="{FF2B5EF4-FFF2-40B4-BE49-F238E27FC236}">
                  <a16:creationId xmlns:a16="http://schemas.microsoft.com/office/drawing/2014/main" id="{B829ED2D-65D2-412D-BF0E-8E353B04BC58}"/>
                </a:ext>
              </a:extLst>
            </p:cNvPr>
            <p:cNvSpPr/>
            <p:nvPr/>
          </p:nvSpPr>
          <p:spPr>
            <a:xfrm>
              <a:off x="454701" y="510429"/>
              <a:ext cx="58047" cy="58678"/>
            </a:xfrm>
            <a:custGeom>
              <a:avLst/>
              <a:gdLst>
                <a:gd name="connsiteX0" fmla="*/ 58048 w 58047"/>
                <a:gd name="connsiteY0" fmla="*/ 0 h 58678"/>
                <a:gd name="connsiteX1" fmla="*/ 0 w 58047"/>
                <a:gd name="connsiteY1" fmla="*/ 0 h 58678"/>
                <a:gd name="connsiteX2" fmla="*/ 0 w 58047"/>
                <a:gd name="connsiteY2" fmla="*/ 58678 h 58678"/>
                <a:gd name="connsiteX3" fmla="*/ 0 w 58047"/>
                <a:gd name="connsiteY3" fmla="*/ 58678 h 58678"/>
                <a:gd name="connsiteX4" fmla="*/ 41012 w 58047"/>
                <a:gd name="connsiteY4" fmla="*/ 41642 h 58678"/>
                <a:gd name="connsiteX5" fmla="*/ 58048 w 58047"/>
                <a:gd name="connsiteY5" fmla="*/ 0 h 5867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8047" h="58678">
                  <a:moveTo>
                    <a:pt x="58048" y="0"/>
                  </a:moveTo>
                  <a:lnTo>
                    <a:pt x="0" y="0"/>
                  </a:lnTo>
                  <a:lnTo>
                    <a:pt x="0" y="58678"/>
                  </a:lnTo>
                  <a:lnTo>
                    <a:pt x="0" y="58678"/>
                  </a:lnTo>
                  <a:cubicBezTo>
                    <a:pt x="15774" y="58678"/>
                    <a:pt x="30286" y="52369"/>
                    <a:pt x="41012" y="41642"/>
                  </a:cubicBezTo>
                  <a:cubicBezTo>
                    <a:pt x="52369" y="30285"/>
                    <a:pt x="58048" y="15774"/>
                    <a:pt x="58048" y="0"/>
                  </a:cubicBezTo>
                  <a:close/>
                </a:path>
              </a:pathLst>
            </a:custGeom>
            <a:solidFill>
              <a:srgbClr val="355EDB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pPr marL="0" marR="0" lvl="0" indent="0" algn="l" defTabSz="2286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nb-NO" sz="9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19" name="Friform 14">
              <a:extLst>
                <a:ext uri="{FF2B5EF4-FFF2-40B4-BE49-F238E27FC236}">
                  <a16:creationId xmlns:a16="http://schemas.microsoft.com/office/drawing/2014/main" id="{7222D3DC-E8A8-4057-87C4-B636576B7EE0}"/>
                </a:ext>
              </a:extLst>
            </p:cNvPr>
            <p:cNvSpPr/>
            <p:nvPr/>
          </p:nvSpPr>
          <p:spPr>
            <a:xfrm>
              <a:off x="454701" y="452382"/>
              <a:ext cx="116726" cy="58678"/>
            </a:xfrm>
            <a:custGeom>
              <a:avLst/>
              <a:gdLst>
                <a:gd name="connsiteX0" fmla="*/ 0 w 116726"/>
                <a:gd name="connsiteY0" fmla="*/ 0 h 58678"/>
                <a:gd name="connsiteX1" fmla="*/ 116727 w 116726"/>
                <a:gd name="connsiteY1" fmla="*/ 0 h 58678"/>
                <a:gd name="connsiteX2" fmla="*/ 116727 w 116726"/>
                <a:gd name="connsiteY2" fmla="*/ 58678 h 58678"/>
                <a:gd name="connsiteX3" fmla="*/ 0 w 116726"/>
                <a:gd name="connsiteY3" fmla="*/ 58678 h 5867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16726" h="58678">
                  <a:moveTo>
                    <a:pt x="0" y="0"/>
                  </a:moveTo>
                  <a:lnTo>
                    <a:pt x="116727" y="0"/>
                  </a:lnTo>
                  <a:lnTo>
                    <a:pt x="116727" y="58678"/>
                  </a:lnTo>
                  <a:lnTo>
                    <a:pt x="0" y="58678"/>
                  </a:lnTo>
                  <a:close/>
                </a:path>
              </a:pathLst>
            </a:custGeom>
            <a:solidFill>
              <a:srgbClr val="C21536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pPr marL="0" marR="0" lvl="0" indent="0" algn="l" defTabSz="2286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nb-NO" sz="9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</p:grpSp>
      <p:sp>
        <p:nvSpPr>
          <p:cNvPr id="20" name="Plassholder for innhold 5">
            <a:extLst>
              <a:ext uri="{FF2B5EF4-FFF2-40B4-BE49-F238E27FC236}">
                <a16:creationId xmlns:a16="http://schemas.microsoft.com/office/drawing/2014/main" id="{E9C10196-8B1E-4FC7-8DC3-538F9A18D5D7}"/>
              </a:ext>
            </a:extLst>
          </p:cNvPr>
          <p:cNvSpPr txBox="1">
            <a:spLocks/>
          </p:cNvSpPr>
          <p:nvPr/>
        </p:nvSpPr>
        <p:spPr>
          <a:xfrm>
            <a:off x="7086600" y="1648800"/>
            <a:ext cx="4498200" cy="4351338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>
            <a:lvl1pPr marL="406481" indent="-406481" algn="l" defTabSz="914446" rtl="0" eaLnBrk="1" latinLnBrk="0" hangingPunct="1">
              <a:lnSpc>
                <a:spcPct val="110000"/>
              </a:lnSpc>
              <a:spcBef>
                <a:spcPts val="1200"/>
              </a:spcBef>
              <a:buSzPct val="100000"/>
              <a:buFontTx/>
              <a:buBlip>
                <a:blip r:embed="rId3">
                  <a:extLst>
                    <a:ext uri="{96DAC541-7B7A-43D3-8B79-37D633B846F1}">
                      <asvg:svgBlip xmlns:asvg="http://schemas.microsoft.com/office/drawing/2016/SVG/main" r:embed="rId4"/>
                    </a:ext>
                  </a:extLst>
                </a:blip>
              </a:buBlip>
              <a:defRPr sz="2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809787" indent="-407275" algn="l" defTabSz="914446" rtl="0" eaLnBrk="1" latinLnBrk="0" hangingPunct="1">
              <a:lnSpc>
                <a:spcPct val="110000"/>
              </a:lnSpc>
              <a:spcBef>
                <a:spcPts val="600"/>
              </a:spcBef>
              <a:buClr>
                <a:srgbClr val="94ABF7"/>
              </a:buClr>
              <a:buFont typeface="Arial" panose="020B0604020202020204" pitchFamily="34" charset="0"/>
              <a:buChar char="●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257300" indent="-447675" algn="l" defTabSz="914446" rtl="0" eaLnBrk="1" latinLnBrk="0" hangingPunct="1">
              <a:lnSpc>
                <a:spcPct val="110000"/>
              </a:lnSpc>
              <a:spcBef>
                <a:spcPts val="600"/>
              </a:spcBef>
              <a:buClr>
                <a:srgbClr val="94ABF7"/>
              </a:buClr>
              <a:buFont typeface="Arial" panose="020B0604020202020204" pitchFamily="34" charset="0"/>
              <a:buChar char="■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793875" indent="-422275" algn="l" defTabSz="914446" rtl="0" eaLnBrk="1" latinLnBrk="0" hangingPunct="1">
              <a:lnSpc>
                <a:spcPct val="110000"/>
              </a:lnSpc>
              <a:spcBef>
                <a:spcPts val="600"/>
              </a:spcBef>
              <a:buClr>
                <a:srgbClr val="94ABF7"/>
              </a:buClr>
              <a:buFont typeface="Arial" panose="020B0604020202020204" pitchFamily="34" charset="0"/>
              <a:buChar char="■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241550" indent="-412750" algn="l" defTabSz="914446" rtl="0" eaLnBrk="1" latinLnBrk="0" hangingPunct="1">
              <a:lnSpc>
                <a:spcPct val="110000"/>
              </a:lnSpc>
              <a:spcBef>
                <a:spcPts val="600"/>
              </a:spcBef>
              <a:buClr>
                <a:srgbClr val="94ABF7"/>
              </a:buClr>
              <a:buFont typeface="Arial" panose="020B0604020202020204" pitchFamily="34" charset="0"/>
              <a:buChar char="■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726" indent="-228611" algn="l" defTabSz="914446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948" indent="-228611" algn="l" defTabSz="914446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171" indent="-228611" algn="l" defTabSz="914446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394" indent="-228611" algn="l" defTabSz="914446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406481" marR="0" lvl="0" indent="-406481" algn="l" defTabSz="914446" rtl="0" eaLnBrk="1" fontAlgn="auto" latinLnBrk="0" hangingPunct="1">
              <a:lnSpc>
                <a:spcPct val="110000"/>
              </a:lnSpc>
              <a:spcBef>
                <a:spcPts val="1200"/>
              </a:spcBef>
              <a:spcAft>
                <a:spcPts val="0"/>
              </a:spcAft>
              <a:buClrTx/>
              <a:buSzPct val="100000"/>
              <a:buFontTx/>
              <a:buBlip>
                <a:blip r:embed="rId3">
                  <a:extLst>
                    <a:ext uri="{96DAC541-7B7A-43D3-8B79-37D633B846F1}">
                      <asvg:svgBlip xmlns:asvg="http://schemas.microsoft.com/office/drawing/2016/SVG/main" r:embed="rId4"/>
                    </a:ext>
                  </a:extLst>
                </a:blip>
              </a:buBlip>
              <a:tabLst/>
              <a:defRPr/>
            </a:pPr>
            <a:r>
              <a:rPr kumimoji="0" lang="nb-NO" sz="23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/>
                <a:ea typeface="+mn-ea"/>
                <a:cs typeface="+mn-cs"/>
              </a:rPr>
              <a:t>Skriv navnet på strategien og dens definisjon på en </a:t>
            </a:r>
            <a:r>
              <a:rPr kumimoji="0" lang="nb-NO" sz="2300" b="0" i="0" u="none" strike="noStrike" kern="1200" cap="none" spc="0" normalizeH="0" baseline="0" noProof="0" dirty="0" err="1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/>
                <a:ea typeface="+mn-ea"/>
                <a:cs typeface="+mn-cs"/>
              </a:rPr>
              <a:t>post-it</a:t>
            </a:r>
            <a:r>
              <a:rPr kumimoji="0" lang="nb-NO" sz="23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/>
                <a:ea typeface="+mn-ea"/>
                <a:cs typeface="+mn-cs"/>
              </a:rPr>
              <a:t> lapp</a:t>
            </a:r>
          </a:p>
          <a:p>
            <a:pPr marL="406481" marR="0" lvl="0" indent="-406481" algn="l" defTabSz="914446" rtl="0" eaLnBrk="1" fontAlgn="auto" latinLnBrk="0" hangingPunct="1">
              <a:lnSpc>
                <a:spcPct val="110000"/>
              </a:lnSpc>
              <a:spcBef>
                <a:spcPts val="1200"/>
              </a:spcBef>
              <a:spcAft>
                <a:spcPts val="0"/>
              </a:spcAft>
              <a:buClrTx/>
              <a:buSzPct val="100000"/>
              <a:buFontTx/>
              <a:buBlip>
                <a:blip r:embed="rId3">
                  <a:extLst>
                    <a:ext uri="{96DAC541-7B7A-43D3-8B79-37D633B846F1}">
                      <asvg:svgBlip xmlns:asvg="http://schemas.microsoft.com/office/drawing/2016/SVG/main" r:embed="rId4"/>
                    </a:ext>
                  </a:extLst>
                </a:blip>
              </a:buBlip>
              <a:tabLst/>
              <a:defRPr/>
            </a:pPr>
            <a:r>
              <a:rPr kumimoji="0" lang="nb-NO" sz="23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/>
                <a:ea typeface="+mn-ea"/>
                <a:cs typeface="+mn-cs"/>
              </a:rPr>
              <a:t>Usikker? Skriv det ned.</a:t>
            </a:r>
          </a:p>
          <a:p>
            <a:pPr marL="406481" marR="0" lvl="0" indent="-406481" algn="l" defTabSz="914446" rtl="0" eaLnBrk="1" fontAlgn="auto" latinLnBrk="0" hangingPunct="1">
              <a:lnSpc>
                <a:spcPct val="110000"/>
              </a:lnSpc>
              <a:spcBef>
                <a:spcPts val="1200"/>
              </a:spcBef>
              <a:spcAft>
                <a:spcPts val="0"/>
              </a:spcAft>
              <a:buClrTx/>
              <a:buSzPct val="100000"/>
              <a:buFontTx/>
              <a:buBlip>
                <a:blip r:embed="rId3">
                  <a:extLst>
                    <a:ext uri="{96DAC541-7B7A-43D3-8B79-37D633B846F1}">
                      <asvg:svgBlip xmlns:asvg="http://schemas.microsoft.com/office/drawing/2016/SVG/main" r:embed="rId4"/>
                    </a:ext>
                  </a:extLst>
                </a:blip>
              </a:buBlip>
              <a:tabLst/>
              <a:defRPr/>
            </a:pPr>
            <a:r>
              <a:rPr kumimoji="0" lang="nb-NO" sz="23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/>
                <a:ea typeface="+mn-ea"/>
                <a:cs typeface="+mn-cs"/>
              </a:rPr>
              <a:t>Når du er ferdig, legg lappene utover bordet for felles gjennomgang</a:t>
            </a:r>
          </a:p>
          <a:p>
            <a:pPr marL="406481" marR="0" lvl="0" indent="-406481" algn="l" defTabSz="914446" rtl="0" eaLnBrk="1" fontAlgn="auto" latinLnBrk="0" hangingPunct="1">
              <a:lnSpc>
                <a:spcPct val="110000"/>
              </a:lnSpc>
              <a:spcBef>
                <a:spcPts val="1200"/>
              </a:spcBef>
              <a:spcAft>
                <a:spcPts val="0"/>
              </a:spcAft>
              <a:buClrTx/>
              <a:buSzPct val="100000"/>
              <a:buFontTx/>
              <a:buBlip>
                <a:blip r:embed="rId3">
                  <a:extLst>
                    <a:ext uri="{96DAC541-7B7A-43D3-8B79-37D633B846F1}">
                      <asvg:svgBlip xmlns:asvg="http://schemas.microsoft.com/office/drawing/2016/SVG/main" r:embed="rId4"/>
                    </a:ext>
                  </a:extLst>
                </a:blip>
              </a:buBlip>
              <a:tabLst/>
              <a:defRPr/>
            </a:pPr>
            <a:r>
              <a:rPr kumimoji="0" lang="nb-NO" sz="23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/>
                <a:ea typeface="+mn-ea"/>
                <a:cs typeface="+mn-cs"/>
              </a:rPr>
              <a:t>Legg </a:t>
            </a:r>
            <a:r>
              <a:rPr kumimoji="0" lang="nb-NO" sz="2300" b="0" i="0" u="none" strike="noStrike" kern="1200" cap="none" spc="0" normalizeH="0" baseline="0" noProof="0" dirty="0" err="1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/>
                <a:ea typeface="+mn-ea"/>
                <a:cs typeface="+mn-cs"/>
              </a:rPr>
              <a:t>post-it</a:t>
            </a:r>
            <a:r>
              <a:rPr kumimoji="0" lang="nb-NO" sz="23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/>
                <a:ea typeface="+mn-ea"/>
                <a:cs typeface="+mn-cs"/>
              </a:rPr>
              <a:t> lappene i egen </a:t>
            </a:r>
            <a:r>
              <a:rPr kumimoji="0" lang="nb-NO" sz="2300" b="0" i="0" u="none" strike="noStrike" kern="1200" cap="none" spc="0" normalizeH="0" baseline="0" noProof="0" dirty="0" err="1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/>
                <a:ea typeface="+mn-ea"/>
                <a:cs typeface="+mn-cs"/>
              </a:rPr>
              <a:t>zippet</a:t>
            </a:r>
            <a:r>
              <a:rPr kumimoji="0" lang="nb-NO" sz="23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/>
                <a:ea typeface="+mn-ea"/>
                <a:cs typeface="+mn-cs"/>
              </a:rPr>
              <a:t> pose</a:t>
            </a:r>
          </a:p>
          <a:p>
            <a:pPr marL="406481" marR="0" lvl="0" indent="-406481" algn="l" defTabSz="914446" rtl="0" eaLnBrk="1" fontAlgn="auto" latinLnBrk="0" hangingPunct="1">
              <a:lnSpc>
                <a:spcPct val="110000"/>
              </a:lnSpc>
              <a:spcBef>
                <a:spcPts val="1200"/>
              </a:spcBef>
              <a:spcAft>
                <a:spcPts val="0"/>
              </a:spcAft>
              <a:buClrTx/>
              <a:buSzPct val="100000"/>
              <a:buFontTx/>
              <a:buBlip>
                <a:blip r:embed="rId3">
                  <a:extLst>
                    <a:ext uri="{96DAC541-7B7A-43D3-8B79-37D633B846F1}">
                      <asvg:svgBlip xmlns:asvg="http://schemas.microsoft.com/office/drawing/2016/SVG/main" r:embed="rId4"/>
                    </a:ext>
                  </a:extLst>
                </a:blip>
              </a:buBlip>
              <a:tabLst/>
              <a:defRPr/>
            </a:pPr>
            <a:r>
              <a:rPr kumimoji="0" lang="nb-NO" sz="23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/>
                <a:ea typeface="+mn-ea"/>
                <a:cs typeface="+mn-cs"/>
              </a:rPr>
              <a:t>Legg den </a:t>
            </a:r>
            <a:r>
              <a:rPr kumimoji="0" lang="nb-NO" sz="2300" b="0" i="0" u="none" strike="noStrike" kern="1200" cap="none" spc="0" normalizeH="0" baseline="0" noProof="0" dirty="0" err="1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/>
                <a:ea typeface="+mn-ea"/>
                <a:cs typeface="+mn-cs"/>
              </a:rPr>
              <a:t>zippede</a:t>
            </a:r>
            <a:r>
              <a:rPr kumimoji="0" lang="nb-NO" sz="23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/>
                <a:ea typeface="+mn-ea"/>
                <a:cs typeface="+mn-cs"/>
              </a:rPr>
              <a:t> posene med </a:t>
            </a:r>
            <a:r>
              <a:rPr kumimoji="0" lang="nb-NO" sz="2300" b="0" i="0" u="none" strike="noStrike" kern="1200" cap="none" spc="0" normalizeH="0" baseline="0" noProof="0" dirty="0" err="1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/>
                <a:ea typeface="+mn-ea"/>
                <a:cs typeface="+mn-cs"/>
              </a:rPr>
              <a:t>post-it</a:t>
            </a:r>
            <a:r>
              <a:rPr kumimoji="0" lang="nb-NO" sz="23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/>
                <a:ea typeface="+mn-ea"/>
                <a:cs typeface="+mn-cs"/>
              </a:rPr>
              <a:t> lapper i den store posen</a:t>
            </a:r>
          </a:p>
          <a:p>
            <a:pPr marL="406481" marR="0" lvl="0" indent="-406481" algn="l" defTabSz="914446" rtl="0" eaLnBrk="1" fontAlgn="auto" latinLnBrk="0" hangingPunct="1">
              <a:lnSpc>
                <a:spcPct val="110000"/>
              </a:lnSpc>
              <a:spcBef>
                <a:spcPts val="1200"/>
              </a:spcBef>
              <a:spcAft>
                <a:spcPts val="0"/>
              </a:spcAft>
              <a:buClrTx/>
              <a:buSzPct val="100000"/>
              <a:buFontTx/>
              <a:buBlip>
                <a:blip r:embed="rId3">
                  <a:extLst>
                    <a:ext uri="{96DAC541-7B7A-43D3-8B79-37D633B846F1}">
                      <asvg:svgBlip xmlns:asvg="http://schemas.microsoft.com/office/drawing/2016/SVG/main" r:embed="rId4"/>
                    </a:ext>
                  </a:extLst>
                </a:blip>
              </a:buBlip>
              <a:tabLst/>
              <a:defRPr/>
            </a:pPr>
            <a:endParaRPr kumimoji="0" lang="nb-NO" sz="23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/>
              <a:ea typeface="+mn-ea"/>
              <a:cs typeface="+mn-cs"/>
            </a:endParaRPr>
          </a:p>
        </p:txBody>
      </p:sp>
      <p:grpSp>
        <p:nvGrpSpPr>
          <p:cNvPr id="23" name="Gruppe 22">
            <a:extLst>
              <a:ext uri="{FF2B5EF4-FFF2-40B4-BE49-F238E27FC236}">
                <a16:creationId xmlns:a16="http://schemas.microsoft.com/office/drawing/2014/main" id="{90510782-8884-449A-B1DC-ADDE4E11C2EA}"/>
              </a:ext>
            </a:extLst>
          </p:cNvPr>
          <p:cNvGrpSpPr/>
          <p:nvPr/>
        </p:nvGrpSpPr>
        <p:grpSpPr>
          <a:xfrm>
            <a:off x="607200" y="2168148"/>
            <a:ext cx="6354719" cy="2453901"/>
            <a:chOff x="607200" y="1759929"/>
            <a:chExt cx="6354719" cy="2453901"/>
          </a:xfrm>
        </p:grpSpPr>
        <p:sp>
          <p:nvSpPr>
            <p:cNvPr id="9" name="Rektangel 8">
              <a:extLst>
                <a:ext uri="{FF2B5EF4-FFF2-40B4-BE49-F238E27FC236}">
                  <a16:creationId xmlns:a16="http://schemas.microsoft.com/office/drawing/2014/main" id="{85EA07A7-708D-4897-AD83-B1FE6E2F302C}"/>
                </a:ext>
              </a:extLst>
            </p:cNvPr>
            <p:cNvSpPr/>
            <p:nvPr/>
          </p:nvSpPr>
          <p:spPr>
            <a:xfrm>
              <a:off x="607200" y="2644170"/>
              <a:ext cx="6332443" cy="156966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2286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nb-NO" sz="3200" b="1" i="0" u="none" strike="noStrike" kern="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entury Gothic" panose="020B0502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‘’</a:t>
              </a:r>
              <a:r>
                <a:rPr kumimoji="0" lang="nb-NO" sz="3200" b="1" i="1" u="none" strike="noStrike" kern="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entury Gothic" panose="020B0502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Er det noe vi ikke har tenkt på, betingelser eller strategier som ikke tilstrekkelig dekket?</a:t>
              </a:r>
              <a:r>
                <a:rPr kumimoji="0" lang="nb-NO" sz="3200" b="1" i="0" u="none" strike="noStrike" kern="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entury Gothic" panose="020B0502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‘’</a:t>
              </a:r>
              <a:endParaRPr kumimoji="0" lang="nb-NO" sz="3200" b="1" i="1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entury Gothic" panose="020B0502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ittel 4">
              <a:extLst>
                <a:ext uri="{FF2B5EF4-FFF2-40B4-BE49-F238E27FC236}">
                  <a16:creationId xmlns:a16="http://schemas.microsoft.com/office/drawing/2014/main" id="{ECD615C2-4D22-4956-B656-D1C172C8B52F}"/>
                </a:ext>
              </a:extLst>
            </p:cNvPr>
            <p:cNvSpPr txBox="1">
              <a:spLocks/>
            </p:cNvSpPr>
            <p:nvPr/>
          </p:nvSpPr>
          <p:spPr>
            <a:xfrm>
              <a:off x="749988" y="1759929"/>
              <a:ext cx="6211931" cy="1764696"/>
            </a:xfrm>
            <a:prstGeom prst="rect">
              <a:avLst/>
            </a:prstGeom>
          </p:spPr>
          <p:txBody>
            <a:bodyPr vert="horz" lIns="0" tIns="0" rIns="0" bIns="0" rtlCol="0" anchor="t" anchorCtr="0">
              <a:noAutofit/>
            </a:bodyPr>
            <a:lstStyle>
              <a:lvl1pPr algn="l" defTabSz="914446" rtl="0" eaLnBrk="1" latinLnBrk="0" hangingPunct="1">
                <a:lnSpc>
                  <a:spcPct val="90000"/>
                </a:lnSpc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marL="0" marR="0" lvl="0" indent="0" algn="l" defTabSz="914446" rtl="0" eaLnBrk="1" fontAlgn="auto" latinLnBrk="0" hangingPunct="1">
                <a:lnSpc>
                  <a:spcPct val="9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nb-NO" sz="4400" b="1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/>
                  <a:ea typeface="+mj-ea"/>
                  <a:cs typeface="+mj-cs"/>
                </a:rPr>
                <a:t>Fokusutsagn:</a:t>
              </a:r>
            </a:p>
          </p:txBody>
        </p:sp>
      </p:grpSp>
      <p:sp>
        <p:nvSpPr>
          <p:cNvPr id="22" name="Tittel 4">
            <a:extLst>
              <a:ext uri="{FF2B5EF4-FFF2-40B4-BE49-F238E27FC236}">
                <a16:creationId xmlns:a16="http://schemas.microsoft.com/office/drawing/2014/main" id="{7ACD5F7F-4285-48E4-8A5F-B4D129A252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51200" y="856800"/>
            <a:ext cx="10533600" cy="705600"/>
          </a:xfrm>
        </p:spPr>
        <p:txBody>
          <a:bodyPr/>
          <a:lstStyle/>
          <a:p>
            <a:r>
              <a:rPr lang="nb-NO" dirty="0">
                <a:solidFill>
                  <a:schemeClr val="bg1"/>
                </a:solidFill>
              </a:rPr>
              <a:t>Brainstorming – instruksjoner </a:t>
            </a:r>
          </a:p>
        </p:txBody>
      </p:sp>
    </p:spTree>
    <p:extLst>
      <p:ext uri="{BB962C8B-B14F-4D97-AF65-F5344CB8AC3E}">
        <p14:creationId xmlns:p14="http://schemas.microsoft.com/office/powerpoint/2010/main" val="39788937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Undertittel 2">
            <a:extLst>
              <a:ext uri="{FF2B5EF4-FFF2-40B4-BE49-F238E27FC236}">
                <a16:creationId xmlns:a16="http://schemas.microsoft.com/office/drawing/2014/main" id="{5512372B-80FE-4EAF-B063-7C4464D6C595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Tittel 4">
            <a:extLst>
              <a:ext uri="{FF2B5EF4-FFF2-40B4-BE49-F238E27FC236}">
                <a16:creationId xmlns:a16="http://schemas.microsoft.com/office/drawing/2014/main" id="{AE2D6C44-0600-4569-B047-9F6660F28FB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nb-NO" dirty="0"/>
              <a:t>Focus prompt</a:t>
            </a:r>
          </a:p>
        </p:txBody>
      </p:sp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03AF29A7-5751-2041-B29B-827CA14C98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7274F-C966-8C46-AFC4-F3A14ECF3B01}" type="slidenum">
              <a:rPr lang="nb-NO" smtClean="0"/>
              <a:t>2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81669069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5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Undertittel 1">
            <a:extLst>
              <a:ext uri="{FF2B5EF4-FFF2-40B4-BE49-F238E27FC236}">
                <a16:creationId xmlns:a16="http://schemas.microsoft.com/office/drawing/2014/main" id="{C9E8D2D5-ED41-424C-8996-468AC4AA8EB7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nb-NO" dirty="0"/>
              <a:t>Fortolkning av funn</a:t>
            </a:r>
          </a:p>
        </p:txBody>
      </p:sp>
      <p:sp>
        <p:nvSpPr>
          <p:cNvPr id="5" name="Tittel 4">
            <a:extLst>
              <a:ext uri="{FF2B5EF4-FFF2-40B4-BE49-F238E27FC236}">
                <a16:creationId xmlns:a16="http://schemas.microsoft.com/office/drawing/2014/main" id="{AE2D6C44-0600-4569-B047-9F6660F28FB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nb-NO" dirty="0"/>
              <a:t>Gruppediskusjon</a:t>
            </a:r>
          </a:p>
        </p:txBody>
      </p:sp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03AF29A7-5751-2041-B29B-827CA14C98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7274F-C966-8C46-AFC4-F3A14ECF3B01}" type="slidenum">
              <a:rPr lang="nb-NO" smtClean="0"/>
              <a:t>20</a:t>
            </a:fld>
            <a:endParaRPr lang="nb-NO"/>
          </a:p>
        </p:txBody>
      </p:sp>
      <p:grpSp>
        <p:nvGrpSpPr>
          <p:cNvPr id="6" name="Gruppe 5">
            <a:extLst>
              <a:ext uri="{FF2B5EF4-FFF2-40B4-BE49-F238E27FC236}">
                <a16:creationId xmlns:a16="http://schemas.microsoft.com/office/drawing/2014/main" id="{F3F58BED-396B-56E1-9103-D68DF98AC94A}"/>
              </a:ext>
            </a:extLst>
          </p:cNvPr>
          <p:cNvGrpSpPr/>
          <p:nvPr/>
        </p:nvGrpSpPr>
        <p:grpSpPr>
          <a:xfrm>
            <a:off x="396023" y="393704"/>
            <a:ext cx="833492" cy="177295"/>
            <a:chOff x="396023" y="393704"/>
            <a:chExt cx="833492" cy="177295"/>
          </a:xfrm>
        </p:grpSpPr>
        <p:sp>
          <p:nvSpPr>
            <p:cNvPr id="7" name="Friform 6">
              <a:extLst>
                <a:ext uri="{FF2B5EF4-FFF2-40B4-BE49-F238E27FC236}">
                  <a16:creationId xmlns:a16="http://schemas.microsoft.com/office/drawing/2014/main" id="{E7DE86B2-F985-39C0-EA1D-FDC143F48A9B}"/>
                </a:ext>
              </a:extLst>
            </p:cNvPr>
            <p:cNvSpPr/>
            <p:nvPr/>
          </p:nvSpPr>
          <p:spPr>
            <a:xfrm>
              <a:off x="936121" y="394334"/>
              <a:ext cx="135024" cy="176665"/>
            </a:xfrm>
            <a:custGeom>
              <a:avLst/>
              <a:gdLst>
                <a:gd name="connsiteX0" fmla="*/ 108524 w 135024"/>
                <a:gd name="connsiteY0" fmla="*/ 0 h 176665"/>
                <a:gd name="connsiteX1" fmla="*/ 108524 w 135024"/>
                <a:gd name="connsiteY1" fmla="*/ 109154 h 176665"/>
                <a:gd name="connsiteX2" fmla="*/ 96536 w 135024"/>
                <a:gd name="connsiteY2" fmla="*/ 138808 h 176665"/>
                <a:gd name="connsiteX3" fmla="*/ 66881 w 135024"/>
                <a:gd name="connsiteY3" fmla="*/ 150796 h 176665"/>
                <a:gd name="connsiteX4" fmla="*/ 37226 w 135024"/>
                <a:gd name="connsiteY4" fmla="*/ 138808 h 176665"/>
                <a:gd name="connsiteX5" fmla="*/ 25238 w 135024"/>
                <a:gd name="connsiteY5" fmla="*/ 109154 h 176665"/>
                <a:gd name="connsiteX6" fmla="*/ 25238 w 135024"/>
                <a:gd name="connsiteY6" fmla="*/ 0 h 176665"/>
                <a:gd name="connsiteX7" fmla="*/ 0 w 135024"/>
                <a:gd name="connsiteY7" fmla="*/ 0 h 176665"/>
                <a:gd name="connsiteX8" fmla="*/ 0 w 135024"/>
                <a:gd name="connsiteY8" fmla="*/ 109154 h 176665"/>
                <a:gd name="connsiteX9" fmla="*/ 5048 w 135024"/>
                <a:gd name="connsiteY9" fmla="*/ 135023 h 176665"/>
                <a:gd name="connsiteX10" fmla="*/ 19560 w 135024"/>
                <a:gd name="connsiteY10" fmla="*/ 157106 h 176665"/>
                <a:gd name="connsiteX11" fmla="*/ 41643 w 135024"/>
                <a:gd name="connsiteY11" fmla="*/ 171617 h 176665"/>
                <a:gd name="connsiteX12" fmla="*/ 67512 w 135024"/>
                <a:gd name="connsiteY12" fmla="*/ 176665 h 176665"/>
                <a:gd name="connsiteX13" fmla="*/ 93382 w 135024"/>
                <a:gd name="connsiteY13" fmla="*/ 171617 h 176665"/>
                <a:gd name="connsiteX14" fmla="*/ 115465 w 135024"/>
                <a:gd name="connsiteY14" fmla="*/ 157106 h 176665"/>
                <a:gd name="connsiteX15" fmla="*/ 129977 w 135024"/>
                <a:gd name="connsiteY15" fmla="*/ 135023 h 176665"/>
                <a:gd name="connsiteX16" fmla="*/ 135025 w 135024"/>
                <a:gd name="connsiteY16" fmla="*/ 109154 h 176665"/>
                <a:gd name="connsiteX17" fmla="*/ 135025 w 135024"/>
                <a:gd name="connsiteY17" fmla="*/ 0 h 176665"/>
                <a:gd name="connsiteX18" fmla="*/ 108524 w 135024"/>
                <a:gd name="connsiteY18" fmla="*/ 0 h 1766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</a:cxnLst>
              <a:rect l="l" t="t" r="r" b="b"/>
              <a:pathLst>
                <a:path w="135024" h="176665">
                  <a:moveTo>
                    <a:pt x="108524" y="0"/>
                  </a:moveTo>
                  <a:lnTo>
                    <a:pt x="108524" y="109154"/>
                  </a:lnTo>
                  <a:cubicBezTo>
                    <a:pt x="108524" y="120511"/>
                    <a:pt x="104108" y="131237"/>
                    <a:pt x="96536" y="138808"/>
                  </a:cubicBezTo>
                  <a:cubicBezTo>
                    <a:pt x="88965" y="146380"/>
                    <a:pt x="78239" y="150796"/>
                    <a:pt x="66881" y="150796"/>
                  </a:cubicBezTo>
                  <a:cubicBezTo>
                    <a:pt x="55524" y="150796"/>
                    <a:pt x="44798" y="146380"/>
                    <a:pt x="37226" y="138808"/>
                  </a:cubicBezTo>
                  <a:cubicBezTo>
                    <a:pt x="29655" y="131237"/>
                    <a:pt x="25238" y="120511"/>
                    <a:pt x="25238" y="109154"/>
                  </a:cubicBezTo>
                  <a:lnTo>
                    <a:pt x="25238" y="0"/>
                  </a:lnTo>
                  <a:lnTo>
                    <a:pt x="0" y="0"/>
                  </a:lnTo>
                  <a:lnTo>
                    <a:pt x="0" y="109154"/>
                  </a:lnTo>
                  <a:cubicBezTo>
                    <a:pt x="0" y="117987"/>
                    <a:pt x="1893" y="126820"/>
                    <a:pt x="5048" y="135023"/>
                  </a:cubicBezTo>
                  <a:cubicBezTo>
                    <a:pt x="8202" y="143225"/>
                    <a:pt x="13250" y="150796"/>
                    <a:pt x="19560" y="157106"/>
                  </a:cubicBezTo>
                  <a:cubicBezTo>
                    <a:pt x="25869" y="163415"/>
                    <a:pt x="33441" y="168463"/>
                    <a:pt x="41643" y="171617"/>
                  </a:cubicBezTo>
                  <a:cubicBezTo>
                    <a:pt x="49846" y="174772"/>
                    <a:pt x="58679" y="176665"/>
                    <a:pt x="67512" y="176665"/>
                  </a:cubicBezTo>
                  <a:cubicBezTo>
                    <a:pt x="76346" y="176665"/>
                    <a:pt x="85179" y="174772"/>
                    <a:pt x="93382" y="171617"/>
                  </a:cubicBezTo>
                  <a:cubicBezTo>
                    <a:pt x="101584" y="168463"/>
                    <a:pt x="109155" y="163415"/>
                    <a:pt x="115465" y="157106"/>
                  </a:cubicBezTo>
                  <a:cubicBezTo>
                    <a:pt x="121775" y="150796"/>
                    <a:pt x="126822" y="143225"/>
                    <a:pt x="129977" y="135023"/>
                  </a:cubicBezTo>
                  <a:cubicBezTo>
                    <a:pt x="133132" y="126820"/>
                    <a:pt x="135025" y="117987"/>
                    <a:pt x="135025" y="109154"/>
                  </a:cubicBezTo>
                  <a:lnTo>
                    <a:pt x="135025" y="0"/>
                  </a:lnTo>
                  <a:lnTo>
                    <a:pt x="108524" y="0"/>
                  </a:lnTo>
                  <a:close/>
                </a:path>
              </a:pathLst>
            </a:custGeom>
            <a:solidFill>
              <a:schemeClr val="bg1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8" name="Friform 7">
              <a:extLst>
                <a:ext uri="{FF2B5EF4-FFF2-40B4-BE49-F238E27FC236}">
                  <a16:creationId xmlns:a16="http://schemas.microsoft.com/office/drawing/2014/main" id="{DD108473-0437-FEAE-0537-7E4BFAEE0A0B}"/>
                </a:ext>
              </a:extLst>
            </p:cNvPr>
            <p:cNvSpPr/>
            <p:nvPr/>
          </p:nvSpPr>
          <p:spPr>
            <a:xfrm>
              <a:off x="630107" y="393704"/>
              <a:ext cx="119881" cy="175403"/>
            </a:xfrm>
            <a:custGeom>
              <a:avLst/>
              <a:gdLst>
                <a:gd name="connsiteX0" fmla="*/ 66881 w 119881"/>
                <a:gd name="connsiteY0" fmla="*/ 76345 h 175403"/>
                <a:gd name="connsiteX1" fmla="*/ 24607 w 119881"/>
                <a:gd name="connsiteY1" fmla="*/ 76345 h 175403"/>
                <a:gd name="connsiteX2" fmla="*/ 24607 w 119881"/>
                <a:gd name="connsiteY2" fmla="*/ 22714 h 175403"/>
                <a:gd name="connsiteX3" fmla="*/ 66881 w 119881"/>
                <a:gd name="connsiteY3" fmla="*/ 22714 h 175403"/>
                <a:gd name="connsiteX4" fmla="*/ 85179 w 119881"/>
                <a:gd name="connsiteY4" fmla="*/ 30285 h 175403"/>
                <a:gd name="connsiteX5" fmla="*/ 92751 w 119881"/>
                <a:gd name="connsiteY5" fmla="*/ 48583 h 175403"/>
                <a:gd name="connsiteX6" fmla="*/ 92751 w 119881"/>
                <a:gd name="connsiteY6" fmla="*/ 50476 h 175403"/>
                <a:gd name="connsiteX7" fmla="*/ 85179 w 119881"/>
                <a:gd name="connsiteY7" fmla="*/ 68773 h 175403"/>
                <a:gd name="connsiteX8" fmla="*/ 66881 w 119881"/>
                <a:gd name="connsiteY8" fmla="*/ 76345 h 175403"/>
                <a:gd name="connsiteX9" fmla="*/ 119882 w 119881"/>
                <a:gd name="connsiteY9" fmla="*/ 49845 h 175403"/>
                <a:gd name="connsiteX10" fmla="*/ 119882 w 119881"/>
                <a:gd name="connsiteY10" fmla="*/ 49845 h 175403"/>
                <a:gd name="connsiteX11" fmla="*/ 105370 w 119881"/>
                <a:gd name="connsiteY11" fmla="*/ 14512 h 175403"/>
                <a:gd name="connsiteX12" fmla="*/ 70667 w 119881"/>
                <a:gd name="connsiteY12" fmla="*/ 0 h 175403"/>
                <a:gd name="connsiteX13" fmla="*/ 0 w 119881"/>
                <a:gd name="connsiteY13" fmla="*/ 0 h 175403"/>
                <a:gd name="connsiteX14" fmla="*/ 0 w 119881"/>
                <a:gd name="connsiteY14" fmla="*/ 174772 h 175403"/>
                <a:gd name="connsiteX15" fmla="*/ 25238 w 119881"/>
                <a:gd name="connsiteY15" fmla="*/ 174772 h 175403"/>
                <a:gd name="connsiteX16" fmla="*/ 25238 w 119881"/>
                <a:gd name="connsiteY16" fmla="*/ 98428 h 175403"/>
                <a:gd name="connsiteX17" fmla="*/ 37226 w 119881"/>
                <a:gd name="connsiteY17" fmla="*/ 98428 h 175403"/>
                <a:gd name="connsiteX18" fmla="*/ 86441 w 119881"/>
                <a:gd name="connsiteY18" fmla="*/ 175403 h 175403"/>
                <a:gd name="connsiteX19" fmla="*/ 117989 w 119881"/>
                <a:gd name="connsiteY19" fmla="*/ 175403 h 175403"/>
                <a:gd name="connsiteX20" fmla="*/ 67512 w 119881"/>
                <a:gd name="connsiteY20" fmla="*/ 98428 h 175403"/>
                <a:gd name="connsiteX21" fmla="*/ 71298 w 119881"/>
                <a:gd name="connsiteY21" fmla="*/ 98428 h 175403"/>
                <a:gd name="connsiteX22" fmla="*/ 90227 w 119881"/>
                <a:gd name="connsiteY22" fmla="*/ 94642 h 175403"/>
                <a:gd name="connsiteX23" fmla="*/ 106001 w 119881"/>
                <a:gd name="connsiteY23" fmla="*/ 83916 h 175403"/>
                <a:gd name="connsiteX24" fmla="*/ 116727 w 119881"/>
                <a:gd name="connsiteY24" fmla="*/ 68142 h 175403"/>
                <a:gd name="connsiteX25" fmla="*/ 119882 w 119881"/>
                <a:gd name="connsiteY25" fmla="*/ 49845 h 1754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</a:cxnLst>
              <a:rect l="l" t="t" r="r" b="b"/>
              <a:pathLst>
                <a:path w="119881" h="175403">
                  <a:moveTo>
                    <a:pt x="66881" y="76345"/>
                  </a:moveTo>
                  <a:lnTo>
                    <a:pt x="24607" y="76345"/>
                  </a:lnTo>
                  <a:lnTo>
                    <a:pt x="24607" y="22714"/>
                  </a:lnTo>
                  <a:lnTo>
                    <a:pt x="66881" y="22714"/>
                  </a:lnTo>
                  <a:cubicBezTo>
                    <a:pt x="73822" y="22714"/>
                    <a:pt x="80762" y="25238"/>
                    <a:pt x="85179" y="30285"/>
                  </a:cubicBezTo>
                  <a:cubicBezTo>
                    <a:pt x="90227" y="35333"/>
                    <a:pt x="92751" y="41642"/>
                    <a:pt x="92751" y="48583"/>
                  </a:cubicBezTo>
                  <a:lnTo>
                    <a:pt x="92751" y="50476"/>
                  </a:lnTo>
                  <a:cubicBezTo>
                    <a:pt x="92751" y="57416"/>
                    <a:pt x="90227" y="64357"/>
                    <a:pt x="85179" y="68773"/>
                  </a:cubicBezTo>
                  <a:cubicBezTo>
                    <a:pt x="80131" y="73190"/>
                    <a:pt x="73822" y="76345"/>
                    <a:pt x="66881" y="76345"/>
                  </a:cubicBezTo>
                  <a:close/>
                  <a:moveTo>
                    <a:pt x="119882" y="49845"/>
                  </a:moveTo>
                  <a:lnTo>
                    <a:pt x="119882" y="49845"/>
                  </a:lnTo>
                  <a:cubicBezTo>
                    <a:pt x="119882" y="36595"/>
                    <a:pt x="114834" y="23976"/>
                    <a:pt x="105370" y="14512"/>
                  </a:cubicBezTo>
                  <a:cubicBezTo>
                    <a:pt x="95905" y="5048"/>
                    <a:pt x="83917" y="0"/>
                    <a:pt x="70667" y="0"/>
                  </a:cubicBezTo>
                  <a:lnTo>
                    <a:pt x="0" y="0"/>
                  </a:lnTo>
                  <a:lnTo>
                    <a:pt x="0" y="174772"/>
                  </a:lnTo>
                  <a:lnTo>
                    <a:pt x="25238" y="174772"/>
                  </a:lnTo>
                  <a:lnTo>
                    <a:pt x="25238" y="98428"/>
                  </a:lnTo>
                  <a:lnTo>
                    <a:pt x="37226" y="98428"/>
                  </a:lnTo>
                  <a:lnTo>
                    <a:pt x="86441" y="175403"/>
                  </a:lnTo>
                  <a:lnTo>
                    <a:pt x="117989" y="175403"/>
                  </a:lnTo>
                  <a:lnTo>
                    <a:pt x="67512" y="98428"/>
                  </a:lnTo>
                  <a:lnTo>
                    <a:pt x="71298" y="98428"/>
                  </a:lnTo>
                  <a:cubicBezTo>
                    <a:pt x="77608" y="98428"/>
                    <a:pt x="83917" y="97166"/>
                    <a:pt x="90227" y="94642"/>
                  </a:cubicBezTo>
                  <a:cubicBezTo>
                    <a:pt x="95905" y="92118"/>
                    <a:pt x="101584" y="88333"/>
                    <a:pt x="106001" y="83916"/>
                  </a:cubicBezTo>
                  <a:cubicBezTo>
                    <a:pt x="110417" y="79499"/>
                    <a:pt x="114203" y="73821"/>
                    <a:pt x="116727" y="68142"/>
                  </a:cubicBezTo>
                  <a:cubicBezTo>
                    <a:pt x="118620" y="62464"/>
                    <a:pt x="119882" y="56154"/>
                    <a:pt x="119882" y="49845"/>
                  </a:cubicBezTo>
                  <a:close/>
                </a:path>
              </a:pathLst>
            </a:custGeom>
            <a:solidFill>
              <a:schemeClr val="bg1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9" name="Friform 8">
              <a:extLst>
                <a:ext uri="{FF2B5EF4-FFF2-40B4-BE49-F238E27FC236}">
                  <a16:creationId xmlns:a16="http://schemas.microsoft.com/office/drawing/2014/main" id="{13D660FD-EFBD-19BB-32F1-F599E1E2F943}"/>
                </a:ext>
              </a:extLst>
            </p:cNvPr>
            <p:cNvSpPr/>
            <p:nvPr/>
          </p:nvSpPr>
          <p:spPr>
            <a:xfrm>
              <a:off x="1109003" y="394334"/>
              <a:ext cx="120512" cy="174772"/>
            </a:xfrm>
            <a:custGeom>
              <a:avLst/>
              <a:gdLst>
                <a:gd name="connsiteX0" fmla="*/ 92751 w 120512"/>
                <a:gd name="connsiteY0" fmla="*/ 49845 h 174772"/>
                <a:gd name="connsiteX1" fmla="*/ 85179 w 120512"/>
                <a:gd name="connsiteY1" fmla="*/ 68142 h 174772"/>
                <a:gd name="connsiteX2" fmla="*/ 66881 w 120512"/>
                <a:gd name="connsiteY2" fmla="*/ 75714 h 174772"/>
                <a:gd name="connsiteX3" fmla="*/ 24607 w 120512"/>
                <a:gd name="connsiteY3" fmla="*/ 75714 h 174772"/>
                <a:gd name="connsiteX4" fmla="*/ 24607 w 120512"/>
                <a:gd name="connsiteY4" fmla="*/ 22083 h 174772"/>
                <a:gd name="connsiteX5" fmla="*/ 66881 w 120512"/>
                <a:gd name="connsiteY5" fmla="*/ 22083 h 174772"/>
                <a:gd name="connsiteX6" fmla="*/ 85179 w 120512"/>
                <a:gd name="connsiteY6" fmla="*/ 29654 h 174772"/>
                <a:gd name="connsiteX7" fmla="*/ 92751 w 120512"/>
                <a:gd name="connsiteY7" fmla="*/ 47952 h 174772"/>
                <a:gd name="connsiteX8" fmla="*/ 92751 w 120512"/>
                <a:gd name="connsiteY8" fmla="*/ 49845 h 174772"/>
                <a:gd name="connsiteX9" fmla="*/ 71298 w 120512"/>
                <a:gd name="connsiteY9" fmla="*/ 0 h 174772"/>
                <a:gd name="connsiteX10" fmla="*/ 0 w 120512"/>
                <a:gd name="connsiteY10" fmla="*/ 0 h 174772"/>
                <a:gd name="connsiteX11" fmla="*/ 0 w 120512"/>
                <a:gd name="connsiteY11" fmla="*/ 174772 h 174772"/>
                <a:gd name="connsiteX12" fmla="*/ 25238 w 120512"/>
                <a:gd name="connsiteY12" fmla="*/ 174772 h 174772"/>
                <a:gd name="connsiteX13" fmla="*/ 25238 w 120512"/>
                <a:gd name="connsiteY13" fmla="*/ 97797 h 174772"/>
                <a:gd name="connsiteX14" fmla="*/ 71298 w 120512"/>
                <a:gd name="connsiteY14" fmla="*/ 97797 h 174772"/>
                <a:gd name="connsiteX15" fmla="*/ 90227 w 120512"/>
                <a:gd name="connsiteY15" fmla="*/ 94011 h 174772"/>
                <a:gd name="connsiteX16" fmla="*/ 106001 w 120512"/>
                <a:gd name="connsiteY16" fmla="*/ 83285 h 174772"/>
                <a:gd name="connsiteX17" fmla="*/ 116727 w 120512"/>
                <a:gd name="connsiteY17" fmla="*/ 67511 h 174772"/>
                <a:gd name="connsiteX18" fmla="*/ 120513 w 120512"/>
                <a:gd name="connsiteY18" fmla="*/ 48583 h 174772"/>
                <a:gd name="connsiteX19" fmla="*/ 120513 w 120512"/>
                <a:gd name="connsiteY19" fmla="*/ 48583 h 174772"/>
                <a:gd name="connsiteX20" fmla="*/ 106001 w 120512"/>
                <a:gd name="connsiteY20" fmla="*/ 13881 h 174772"/>
                <a:gd name="connsiteX21" fmla="*/ 71298 w 120512"/>
                <a:gd name="connsiteY21" fmla="*/ 0 h 1747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</a:cxnLst>
              <a:rect l="l" t="t" r="r" b="b"/>
              <a:pathLst>
                <a:path w="120512" h="174772">
                  <a:moveTo>
                    <a:pt x="92751" y="49845"/>
                  </a:moveTo>
                  <a:cubicBezTo>
                    <a:pt x="92751" y="56785"/>
                    <a:pt x="90227" y="63726"/>
                    <a:pt x="85179" y="68142"/>
                  </a:cubicBezTo>
                  <a:cubicBezTo>
                    <a:pt x="80131" y="72559"/>
                    <a:pt x="73822" y="75714"/>
                    <a:pt x="66881" y="75714"/>
                  </a:cubicBezTo>
                  <a:lnTo>
                    <a:pt x="24607" y="75714"/>
                  </a:lnTo>
                  <a:lnTo>
                    <a:pt x="24607" y="22083"/>
                  </a:lnTo>
                  <a:lnTo>
                    <a:pt x="66881" y="22083"/>
                  </a:lnTo>
                  <a:cubicBezTo>
                    <a:pt x="73822" y="22083"/>
                    <a:pt x="80762" y="24607"/>
                    <a:pt x="85179" y="29654"/>
                  </a:cubicBezTo>
                  <a:cubicBezTo>
                    <a:pt x="89596" y="34702"/>
                    <a:pt x="92751" y="41012"/>
                    <a:pt x="92751" y="47952"/>
                  </a:cubicBezTo>
                  <a:lnTo>
                    <a:pt x="92751" y="49845"/>
                  </a:lnTo>
                  <a:close/>
                  <a:moveTo>
                    <a:pt x="71298" y="0"/>
                  </a:moveTo>
                  <a:lnTo>
                    <a:pt x="0" y="0"/>
                  </a:lnTo>
                  <a:lnTo>
                    <a:pt x="0" y="174772"/>
                  </a:lnTo>
                  <a:lnTo>
                    <a:pt x="25238" y="174772"/>
                  </a:lnTo>
                  <a:lnTo>
                    <a:pt x="25238" y="97797"/>
                  </a:lnTo>
                  <a:lnTo>
                    <a:pt x="71298" y="97797"/>
                  </a:lnTo>
                  <a:cubicBezTo>
                    <a:pt x="77608" y="97797"/>
                    <a:pt x="83917" y="96535"/>
                    <a:pt x="90227" y="94011"/>
                  </a:cubicBezTo>
                  <a:cubicBezTo>
                    <a:pt x="96536" y="91487"/>
                    <a:pt x="101584" y="87702"/>
                    <a:pt x="106001" y="83285"/>
                  </a:cubicBezTo>
                  <a:cubicBezTo>
                    <a:pt x="110417" y="78868"/>
                    <a:pt x="114203" y="73190"/>
                    <a:pt x="116727" y="67511"/>
                  </a:cubicBezTo>
                  <a:cubicBezTo>
                    <a:pt x="119251" y="61833"/>
                    <a:pt x="120513" y="55523"/>
                    <a:pt x="120513" y="48583"/>
                  </a:cubicBezTo>
                  <a:lnTo>
                    <a:pt x="120513" y="48583"/>
                  </a:lnTo>
                  <a:cubicBezTo>
                    <a:pt x="120513" y="35333"/>
                    <a:pt x="115465" y="23345"/>
                    <a:pt x="106001" y="13881"/>
                  </a:cubicBezTo>
                  <a:cubicBezTo>
                    <a:pt x="96536" y="5048"/>
                    <a:pt x="83917" y="0"/>
                    <a:pt x="71298" y="0"/>
                  </a:cubicBezTo>
                  <a:close/>
                </a:path>
              </a:pathLst>
            </a:custGeom>
            <a:solidFill>
              <a:schemeClr val="bg1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0" name="Friform 9">
              <a:extLst>
                <a:ext uri="{FF2B5EF4-FFF2-40B4-BE49-F238E27FC236}">
                  <a16:creationId xmlns:a16="http://schemas.microsoft.com/office/drawing/2014/main" id="{AE80D1ED-9C2F-4639-6F01-6EC3BB88EBFB}"/>
                </a:ext>
              </a:extLst>
            </p:cNvPr>
            <p:cNvSpPr/>
            <p:nvPr/>
          </p:nvSpPr>
          <p:spPr>
            <a:xfrm>
              <a:off x="782168" y="394334"/>
              <a:ext cx="120354" cy="174772"/>
            </a:xfrm>
            <a:custGeom>
              <a:avLst/>
              <a:gdLst>
                <a:gd name="connsiteX0" fmla="*/ 93381 w 120354"/>
                <a:gd name="connsiteY0" fmla="*/ 49845 h 174772"/>
                <a:gd name="connsiteX1" fmla="*/ 91489 w 120354"/>
                <a:gd name="connsiteY1" fmla="*/ 59940 h 174772"/>
                <a:gd name="connsiteX2" fmla="*/ 85810 w 120354"/>
                <a:gd name="connsiteY2" fmla="*/ 68142 h 174772"/>
                <a:gd name="connsiteX3" fmla="*/ 77608 w 120354"/>
                <a:gd name="connsiteY3" fmla="*/ 73821 h 174772"/>
                <a:gd name="connsiteX4" fmla="*/ 67512 w 120354"/>
                <a:gd name="connsiteY4" fmla="*/ 75714 h 174772"/>
                <a:gd name="connsiteX5" fmla="*/ 25238 w 120354"/>
                <a:gd name="connsiteY5" fmla="*/ 75714 h 174772"/>
                <a:gd name="connsiteX6" fmla="*/ 25238 w 120354"/>
                <a:gd name="connsiteY6" fmla="*/ 22083 h 174772"/>
                <a:gd name="connsiteX7" fmla="*/ 67512 w 120354"/>
                <a:gd name="connsiteY7" fmla="*/ 22083 h 174772"/>
                <a:gd name="connsiteX8" fmla="*/ 85810 w 120354"/>
                <a:gd name="connsiteY8" fmla="*/ 29654 h 174772"/>
                <a:gd name="connsiteX9" fmla="*/ 93381 w 120354"/>
                <a:gd name="connsiteY9" fmla="*/ 47952 h 174772"/>
                <a:gd name="connsiteX10" fmla="*/ 93381 w 120354"/>
                <a:gd name="connsiteY10" fmla="*/ 49845 h 174772"/>
                <a:gd name="connsiteX11" fmla="*/ 93381 w 120354"/>
                <a:gd name="connsiteY11" fmla="*/ 126189 h 174772"/>
                <a:gd name="connsiteX12" fmla="*/ 85810 w 120354"/>
                <a:gd name="connsiteY12" fmla="*/ 144487 h 174772"/>
                <a:gd name="connsiteX13" fmla="*/ 67512 w 120354"/>
                <a:gd name="connsiteY13" fmla="*/ 152058 h 174772"/>
                <a:gd name="connsiteX14" fmla="*/ 25238 w 120354"/>
                <a:gd name="connsiteY14" fmla="*/ 152058 h 174772"/>
                <a:gd name="connsiteX15" fmla="*/ 25238 w 120354"/>
                <a:gd name="connsiteY15" fmla="*/ 98428 h 174772"/>
                <a:gd name="connsiteX16" fmla="*/ 67512 w 120354"/>
                <a:gd name="connsiteY16" fmla="*/ 98428 h 174772"/>
                <a:gd name="connsiteX17" fmla="*/ 85810 w 120354"/>
                <a:gd name="connsiteY17" fmla="*/ 105999 h 174772"/>
                <a:gd name="connsiteX18" fmla="*/ 93381 w 120354"/>
                <a:gd name="connsiteY18" fmla="*/ 124296 h 174772"/>
                <a:gd name="connsiteX19" fmla="*/ 93381 w 120354"/>
                <a:gd name="connsiteY19" fmla="*/ 126189 h 174772"/>
                <a:gd name="connsiteX20" fmla="*/ 119882 w 120354"/>
                <a:gd name="connsiteY20" fmla="*/ 48583 h 174772"/>
                <a:gd name="connsiteX21" fmla="*/ 105370 w 120354"/>
                <a:gd name="connsiteY21" fmla="*/ 14512 h 174772"/>
                <a:gd name="connsiteX22" fmla="*/ 71298 w 120354"/>
                <a:gd name="connsiteY22" fmla="*/ 0 h 174772"/>
                <a:gd name="connsiteX23" fmla="*/ 0 w 120354"/>
                <a:gd name="connsiteY23" fmla="*/ 0 h 174772"/>
                <a:gd name="connsiteX24" fmla="*/ 0 w 120354"/>
                <a:gd name="connsiteY24" fmla="*/ 174772 h 174772"/>
                <a:gd name="connsiteX25" fmla="*/ 71929 w 120354"/>
                <a:gd name="connsiteY25" fmla="*/ 174772 h 174772"/>
                <a:gd name="connsiteX26" fmla="*/ 100322 w 120354"/>
                <a:gd name="connsiteY26" fmla="*/ 165308 h 174772"/>
                <a:gd name="connsiteX27" fmla="*/ 117989 w 120354"/>
                <a:gd name="connsiteY27" fmla="*/ 141332 h 174772"/>
                <a:gd name="connsiteX28" fmla="*/ 117989 w 120354"/>
                <a:gd name="connsiteY28" fmla="*/ 111678 h 174772"/>
                <a:gd name="connsiteX29" fmla="*/ 100322 w 120354"/>
                <a:gd name="connsiteY29" fmla="*/ 87702 h 174772"/>
                <a:gd name="connsiteX30" fmla="*/ 114834 w 120354"/>
                <a:gd name="connsiteY30" fmla="*/ 70666 h 174772"/>
                <a:gd name="connsiteX31" fmla="*/ 119882 w 120354"/>
                <a:gd name="connsiteY31" fmla="*/ 48583 h 1747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</a:cxnLst>
              <a:rect l="l" t="t" r="r" b="b"/>
              <a:pathLst>
                <a:path w="120354" h="174772">
                  <a:moveTo>
                    <a:pt x="93381" y="49845"/>
                  </a:moveTo>
                  <a:cubicBezTo>
                    <a:pt x="93381" y="53000"/>
                    <a:pt x="92751" y="56785"/>
                    <a:pt x="91489" y="59940"/>
                  </a:cubicBezTo>
                  <a:cubicBezTo>
                    <a:pt x="90227" y="63095"/>
                    <a:pt x="88334" y="66249"/>
                    <a:pt x="85810" y="68142"/>
                  </a:cubicBezTo>
                  <a:cubicBezTo>
                    <a:pt x="83286" y="70666"/>
                    <a:pt x="80762" y="72559"/>
                    <a:pt x="77608" y="73821"/>
                  </a:cubicBezTo>
                  <a:cubicBezTo>
                    <a:pt x="74453" y="75083"/>
                    <a:pt x="71298" y="75714"/>
                    <a:pt x="67512" y="75714"/>
                  </a:cubicBezTo>
                  <a:lnTo>
                    <a:pt x="25238" y="75714"/>
                  </a:lnTo>
                  <a:lnTo>
                    <a:pt x="25238" y="22083"/>
                  </a:lnTo>
                  <a:lnTo>
                    <a:pt x="67512" y="22083"/>
                  </a:lnTo>
                  <a:cubicBezTo>
                    <a:pt x="74453" y="22083"/>
                    <a:pt x="81393" y="24607"/>
                    <a:pt x="85810" y="29654"/>
                  </a:cubicBezTo>
                  <a:cubicBezTo>
                    <a:pt x="90227" y="34702"/>
                    <a:pt x="93381" y="41012"/>
                    <a:pt x="93381" y="47952"/>
                  </a:cubicBezTo>
                  <a:lnTo>
                    <a:pt x="93381" y="49845"/>
                  </a:lnTo>
                  <a:close/>
                  <a:moveTo>
                    <a:pt x="93381" y="126189"/>
                  </a:moveTo>
                  <a:cubicBezTo>
                    <a:pt x="93381" y="133130"/>
                    <a:pt x="90858" y="140070"/>
                    <a:pt x="85810" y="144487"/>
                  </a:cubicBezTo>
                  <a:cubicBezTo>
                    <a:pt x="80762" y="149534"/>
                    <a:pt x="74453" y="152058"/>
                    <a:pt x="67512" y="152058"/>
                  </a:cubicBezTo>
                  <a:lnTo>
                    <a:pt x="25238" y="152058"/>
                  </a:lnTo>
                  <a:lnTo>
                    <a:pt x="25238" y="98428"/>
                  </a:lnTo>
                  <a:lnTo>
                    <a:pt x="67512" y="98428"/>
                  </a:lnTo>
                  <a:cubicBezTo>
                    <a:pt x="74453" y="98428"/>
                    <a:pt x="81393" y="100951"/>
                    <a:pt x="85810" y="105999"/>
                  </a:cubicBezTo>
                  <a:cubicBezTo>
                    <a:pt x="90858" y="111047"/>
                    <a:pt x="93381" y="117356"/>
                    <a:pt x="93381" y="124296"/>
                  </a:cubicBezTo>
                  <a:lnTo>
                    <a:pt x="93381" y="126189"/>
                  </a:lnTo>
                  <a:close/>
                  <a:moveTo>
                    <a:pt x="119882" y="48583"/>
                  </a:moveTo>
                  <a:cubicBezTo>
                    <a:pt x="119882" y="35964"/>
                    <a:pt x="114834" y="23345"/>
                    <a:pt x="105370" y="14512"/>
                  </a:cubicBezTo>
                  <a:cubicBezTo>
                    <a:pt x="96536" y="5679"/>
                    <a:pt x="83917" y="0"/>
                    <a:pt x="71298" y="0"/>
                  </a:cubicBezTo>
                  <a:lnTo>
                    <a:pt x="0" y="0"/>
                  </a:lnTo>
                  <a:lnTo>
                    <a:pt x="0" y="174772"/>
                  </a:lnTo>
                  <a:lnTo>
                    <a:pt x="71929" y="174772"/>
                  </a:lnTo>
                  <a:cubicBezTo>
                    <a:pt x="82024" y="174772"/>
                    <a:pt x="92120" y="171617"/>
                    <a:pt x="100322" y="165308"/>
                  </a:cubicBezTo>
                  <a:cubicBezTo>
                    <a:pt x="108524" y="159629"/>
                    <a:pt x="114834" y="150796"/>
                    <a:pt x="117989" y="141332"/>
                  </a:cubicBezTo>
                  <a:cubicBezTo>
                    <a:pt x="121144" y="131868"/>
                    <a:pt x="121144" y="121142"/>
                    <a:pt x="117989" y="111678"/>
                  </a:cubicBezTo>
                  <a:cubicBezTo>
                    <a:pt x="114834" y="102213"/>
                    <a:pt x="108524" y="93380"/>
                    <a:pt x="100322" y="87702"/>
                  </a:cubicBezTo>
                  <a:cubicBezTo>
                    <a:pt x="106632" y="83285"/>
                    <a:pt x="111679" y="77606"/>
                    <a:pt x="114834" y="70666"/>
                  </a:cubicBezTo>
                  <a:cubicBezTo>
                    <a:pt x="117989" y="63726"/>
                    <a:pt x="119882" y="56154"/>
                    <a:pt x="119882" y="48583"/>
                  </a:cubicBezTo>
                  <a:close/>
                </a:path>
              </a:pathLst>
            </a:custGeom>
            <a:solidFill>
              <a:schemeClr val="bg1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1" name="Friform 10">
              <a:extLst>
                <a:ext uri="{FF2B5EF4-FFF2-40B4-BE49-F238E27FC236}">
                  <a16:creationId xmlns:a16="http://schemas.microsoft.com/office/drawing/2014/main" id="{8DFD9E24-A84E-FD5E-3C22-1D7A1E9EA571}"/>
                </a:ext>
              </a:extLst>
            </p:cNvPr>
            <p:cNvSpPr/>
            <p:nvPr/>
          </p:nvSpPr>
          <p:spPr>
            <a:xfrm>
              <a:off x="454701" y="393704"/>
              <a:ext cx="116095" cy="116725"/>
            </a:xfrm>
            <a:custGeom>
              <a:avLst/>
              <a:gdLst>
                <a:gd name="connsiteX0" fmla="*/ 58048 w 116095"/>
                <a:gd name="connsiteY0" fmla="*/ 0 h 116725"/>
                <a:gd name="connsiteX1" fmla="*/ 99060 w 116095"/>
                <a:gd name="connsiteY1" fmla="*/ 17036 h 116725"/>
                <a:gd name="connsiteX2" fmla="*/ 116096 w 116095"/>
                <a:gd name="connsiteY2" fmla="*/ 58047 h 116725"/>
                <a:gd name="connsiteX3" fmla="*/ 116096 w 116095"/>
                <a:gd name="connsiteY3" fmla="*/ 116725 h 116725"/>
                <a:gd name="connsiteX4" fmla="*/ 0 w 116095"/>
                <a:gd name="connsiteY4" fmla="*/ 116725 h 116725"/>
                <a:gd name="connsiteX5" fmla="*/ 0 w 116095"/>
                <a:gd name="connsiteY5" fmla="*/ 58678 h 116725"/>
                <a:gd name="connsiteX6" fmla="*/ 17036 w 116095"/>
                <a:gd name="connsiteY6" fmla="*/ 17667 h 116725"/>
                <a:gd name="connsiteX7" fmla="*/ 58048 w 116095"/>
                <a:gd name="connsiteY7" fmla="*/ 0 h 1167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116095" h="116725">
                  <a:moveTo>
                    <a:pt x="58048" y="0"/>
                  </a:moveTo>
                  <a:cubicBezTo>
                    <a:pt x="73822" y="0"/>
                    <a:pt x="88334" y="6309"/>
                    <a:pt x="99060" y="17036"/>
                  </a:cubicBezTo>
                  <a:cubicBezTo>
                    <a:pt x="109786" y="27762"/>
                    <a:pt x="116096" y="42904"/>
                    <a:pt x="116096" y="58047"/>
                  </a:cubicBezTo>
                  <a:lnTo>
                    <a:pt x="116096" y="116725"/>
                  </a:lnTo>
                  <a:lnTo>
                    <a:pt x="0" y="116725"/>
                  </a:lnTo>
                  <a:lnTo>
                    <a:pt x="0" y="58678"/>
                  </a:lnTo>
                  <a:cubicBezTo>
                    <a:pt x="0" y="42904"/>
                    <a:pt x="6310" y="28393"/>
                    <a:pt x="17036" y="17667"/>
                  </a:cubicBezTo>
                  <a:cubicBezTo>
                    <a:pt x="27762" y="6940"/>
                    <a:pt x="42905" y="0"/>
                    <a:pt x="58048" y="0"/>
                  </a:cubicBezTo>
                  <a:close/>
                </a:path>
              </a:pathLst>
            </a:custGeom>
            <a:solidFill>
              <a:srgbClr val="E31836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2" name="Friform 11">
              <a:extLst>
                <a:ext uri="{FF2B5EF4-FFF2-40B4-BE49-F238E27FC236}">
                  <a16:creationId xmlns:a16="http://schemas.microsoft.com/office/drawing/2014/main" id="{1CF8E28E-A836-6EC6-D886-AD078D07F10F}"/>
                </a:ext>
              </a:extLst>
            </p:cNvPr>
            <p:cNvSpPr/>
            <p:nvPr/>
          </p:nvSpPr>
          <p:spPr>
            <a:xfrm>
              <a:off x="396023" y="452382"/>
              <a:ext cx="58678" cy="116094"/>
            </a:xfrm>
            <a:custGeom>
              <a:avLst/>
              <a:gdLst>
                <a:gd name="connsiteX0" fmla="*/ 58679 w 58678"/>
                <a:gd name="connsiteY0" fmla="*/ 0 h 116094"/>
                <a:gd name="connsiteX1" fmla="*/ 17667 w 58678"/>
                <a:gd name="connsiteY1" fmla="*/ 17036 h 116094"/>
                <a:gd name="connsiteX2" fmla="*/ 0 w 58678"/>
                <a:gd name="connsiteY2" fmla="*/ 58047 h 116094"/>
                <a:gd name="connsiteX3" fmla="*/ 17036 w 58678"/>
                <a:gd name="connsiteY3" fmla="*/ 99059 h 116094"/>
                <a:gd name="connsiteX4" fmla="*/ 58048 w 58678"/>
                <a:gd name="connsiteY4" fmla="*/ 116094 h 116094"/>
                <a:gd name="connsiteX5" fmla="*/ 58048 w 58678"/>
                <a:gd name="connsiteY5" fmla="*/ 116094 h 116094"/>
                <a:gd name="connsiteX6" fmla="*/ 58048 w 58678"/>
                <a:gd name="connsiteY6" fmla="*/ 116094 h 116094"/>
                <a:gd name="connsiteX7" fmla="*/ 58048 w 58678"/>
                <a:gd name="connsiteY7" fmla="*/ 0 h 1160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58678" h="116094">
                  <a:moveTo>
                    <a:pt x="58679" y="0"/>
                  </a:moveTo>
                  <a:cubicBezTo>
                    <a:pt x="42905" y="0"/>
                    <a:pt x="28393" y="6309"/>
                    <a:pt x="17667" y="17036"/>
                  </a:cubicBezTo>
                  <a:cubicBezTo>
                    <a:pt x="6310" y="27762"/>
                    <a:pt x="0" y="42904"/>
                    <a:pt x="0" y="58047"/>
                  </a:cubicBezTo>
                  <a:cubicBezTo>
                    <a:pt x="0" y="73821"/>
                    <a:pt x="6310" y="88332"/>
                    <a:pt x="17036" y="99059"/>
                  </a:cubicBezTo>
                  <a:cubicBezTo>
                    <a:pt x="27762" y="109785"/>
                    <a:pt x="42905" y="116094"/>
                    <a:pt x="58048" y="116094"/>
                  </a:cubicBezTo>
                  <a:cubicBezTo>
                    <a:pt x="58048" y="116094"/>
                    <a:pt x="58048" y="116094"/>
                    <a:pt x="58048" y="116094"/>
                  </a:cubicBezTo>
                  <a:lnTo>
                    <a:pt x="58048" y="116094"/>
                  </a:lnTo>
                  <a:lnTo>
                    <a:pt x="58048" y="0"/>
                  </a:lnTo>
                  <a:close/>
                </a:path>
              </a:pathLst>
            </a:custGeom>
            <a:solidFill>
              <a:srgbClr val="728EE6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3" name="Friform 12">
              <a:extLst>
                <a:ext uri="{FF2B5EF4-FFF2-40B4-BE49-F238E27FC236}">
                  <a16:creationId xmlns:a16="http://schemas.microsoft.com/office/drawing/2014/main" id="{AD7DA5FB-7A04-D730-4524-68224255B8B1}"/>
                </a:ext>
              </a:extLst>
            </p:cNvPr>
            <p:cNvSpPr/>
            <p:nvPr/>
          </p:nvSpPr>
          <p:spPr>
            <a:xfrm>
              <a:off x="454701" y="510429"/>
              <a:ext cx="116726" cy="58047"/>
            </a:xfrm>
            <a:custGeom>
              <a:avLst/>
              <a:gdLst>
                <a:gd name="connsiteX0" fmla="*/ 116727 w 116726"/>
                <a:gd name="connsiteY0" fmla="*/ 0 h 58047"/>
                <a:gd name="connsiteX1" fmla="*/ 58048 w 116726"/>
                <a:gd name="connsiteY1" fmla="*/ 0 h 58047"/>
                <a:gd name="connsiteX2" fmla="*/ 41012 w 116726"/>
                <a:gd name="connsiteY2" fmla="*/ 41012 h 58047"/>
                <a:gd name="connsiteX3" fmla="*/ 0 w 116726"/>
                <a:gd name="connsiteY3" fmla="*/ 58047 h 58047"/>
                <a:gd name="connsiteX4" fmla="*/ 116727 w 116726"/>
                <a:gd name="connsiteY4" fmla="*/ 58047 h 58047"/>
                <a:gd name="connsiteX5" fmla="*/ 116727 w 116726"/>
                <a:gd name="connsiteY5" fmla="*/ 0 h 580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116726" h="58047">
                  <a:moveTo>
                    <a:pt x="116727" y="0"/>
                  </a:moveTo>
                  <a:lnTo>
                    <a:pt x="58048" y="0"/>
                  </a:lnTo>
                  <a:cubicBezTo>
                    <a:pt x="58048" y="15774"/>
                    <a:pt x="51738" y="30285"/>
                    <a:pt x="41012" y="41012"/>
                  </a:cubicBezTo>
                  <a:cubicBezTo>
                    <a:pt x="30286" y="51738"/>
                    <a:pt x="15143" y="58047"/>
                    <a:pt x="0" y="58047"/>
                  </a:cubicBezTo>
                  <a:lnTo>
                    <a:pt x="116727" y="58047"/>
                  </a:lnTo>
                  <a:lnTo>
                    <a:pt x="116727" y="0"/>
                  </a:lnTo>
                  <a:close/>
                </a:path>
              </a:pathLst>
            </a:custGeom>
            <a:solidFill>
              <a:srgbClr val="C2CFF4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4" name="Friform 13">
              <a:extLst>
                <a:ext uri="{FF2B5EF4-FFF2-40B4-BE49-F238E27FC236}">
                  <a16:creationId xmlns:a16="http://schemas.microsoft.com/office/drawing/2014/main" id="{24D5CA76-9DE6-594C-1D9C-DA58B22904CC}"/>
                </a:ext>
              </a:extLst>
            </p:cNvPr>
            <p:cNvSpPr/>
            <p:nvPr/>
          </p:nvSpPr>
          <p:spPr>
            <a:xfrm>
              <a:off x="454701" y="510429"/>
              <a:ext cx="58047" cy="58678"/>
            </a:xfrm>
            <a:custGeom>
              <a:avLst/>
              <a:gdLst>
                <a:gd name="connsiteX0" fmla="*/ 58048 w 58047"/>
                <a:gd name="connsiteY0" fmla="*/ 0 h 58678"/>
                <a:gd name="connsiteX1" fmla="*/ 0 w 58047"/>
                <a:gd name="connsiteY1" fmla="*/ 0 h 58678"/>
                <a:gd name="connsiteX2" fmla="*/ 0 w 58047"/>
                <a:gd name="connsiteY2" fmla="*/ 58678 h 58678"/>
                <a:gd name="connsiteX3" fmla="*/ 0 w 58047"/>
                <a:gd name="connsiteY3" fmla="*/ 58678 h 58678"/>
                <a:gd name="connsiteX4" fmla="*/ 41012 w 58047"/>
                <a:gd name="connsiteY4" fmla="*/ 41642 h 58678"/>
                <a:gd name="connsiteX5" fmla="*/ 58048 w 58047"/>
                <a:gd name="connsiteY5" fmla="*/ 0 h 5867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8047" h="58678">
                  <a:moveTo>
                    <a:pt x="58048" y="0"/>
                  </a:moveTo>
                  <a:lnTo>
                    <a:pt x="0" y="0"/>
                  </a:lnTo>
                  <a:lnTo>
                    <a:pt x="0" y="58678"/>
                  </a:lnTo>
                  <a:lnTo>
                    <a:pt x="0" y="58678"/>
                  </a:lnTo>
                  <a:cubicBezTo>
                    <a:pt x="15774" y="58678"/>
                    <a:pt x="30286" y="52369"/>
                    <a:pt x="41012" y="41642"/>
                  </a:cubicBezTo>
                  <a:cubicBezTo>
                    <a:pt x="52369" y="30285"/>
                    <a:pt x="58048" y="15774"/>
                    <a:pt x="58048" y="0"/>
                  </a:cubicBezTo>
                  <a:close/>
                </a:path>
              </a:pathLst>
            </a:custGeom>
            <a:solidFill>
              <a:srgbClr val="355EDB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5" name="Friform 14">
              <a:extLst>
                <a:ext uri="{FF2B5EF4-FFF2-40B4-BE49-F238E27FC236}">
                  <a16:creationId xmlns:a16="http://schemas.microsoft.com/office/drawing/2014/main" id="{C18510F3-49A9-FACD-B6A6-1A46F89C69FC}"/>
                </a:ext>
              </a:extLst>
            </p:cNvPr>
            <p:cNvSpPr/>
            <p:nvPr/>
          </p:nvSpPr>
          <p:spPr>
            <a:xfrm>
              <a:off x="454701" y="452382"/>
              <a:ext cx="116726" cy="58678"/>
            </a:xfrm>
            <a:custGeom>
              <a:avLst/>
              <a:gdLst>
                <a:gd name="connsiteX0" fmla="*/ 0 w 116726"/>
                <a:gd name="connsiteY0" fmla="*/ 0 h 58678"/>
                <a:gd name="connsiteX1" fmla="*/ 116727 w 116726"/>
                <a:gd name="connsiteY1" fmla="*/ 0 h 58678"/>
                <a:gd name="connsiteX2" fmla="*/ 116727 w 116726"/>
                <a:gd name="connsiteY2" fmla="*/ 58678 h 58678"/>
                <a:gd name="connsiteX3" fmla="*/ 0 w 116726"/>
                <a:gd name="connsiteY3" fmla="*/ 58678 h 5867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16726" h="58678">
                  <a:moveTo>
                    <a:pt x="0" y="0"/>
                  </a:moveTo>
                  <a:lnTo>
                    <a:pt x="116727" y="0"/>
                  </a:lnTo>
                  <a:lnTo>
                    <a:pt x="116727" y="58678"/>
                  </a:lnTo>
                  <a:lnTo>
                    <a:pt x="0" y="58678"/>
                  </a:lnTo>
                  <a:close/>
                </a:path>
              </a:pathLst>
            </a:custGeom>
            <a:solidFill>
              <a:srgbClr val="C21536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</p:grpSp>
    </p:spTree>
    <p:extLst>
      <p:ext uri="{BB962C8B-B14F-4D97-AF65-F5344CB8AC3E}">
        <p14:creationId xmlns:p14="http://schemas.microsoft.com/office/powerpoint/2010/main" val="3147558904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5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tel 2">
            <a:extLst>
              <a:ext uri="{FF2B5EF4-FFF2-40B4-BE49-F238E27FC236}">
                <a16:creationId xmlns:a16="http://schemas.microsoft.com/office/drawing/2014/main" id="{6BAA7D64-5519-8859-B9F2-21FE8FCAEF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dirty="0">
                <a:solidFill>
                  <a:schemeClr val="bg1"/>
                </a:solidFill>
              </a:rPr>
              <a:t>Spørsmål for diskusjon</a:t>
            </a:r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E361ADA8-375E-9B1A-96CF-E8E8EDFBE9C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nb-NO" dirty="0">
                <a:solidFill>
                  <a:schemeClr val="bg1"/>
                </a:solidFill>
              </a:rPr>
              <a:t>Er resultatene overraskende for deg? I så fall, på hvilken måte?</a:t>
            </a:r>
          </a:p>
          <a:p>
            <a:r>
              <a:rPr lang="en-US" dirty="0" err="1">
                <a:solidFill>
                  <a:schemeClr val="bg1"/>
                </a:solidFill>
              </a:rPr>
              <a:t>Reflekterer</a:t>
            </a:r>
            <a:r>
              <a:rPr lang="en-US" dirty="0">
                <a:solidFill>
                  <a:schemeClr val="bg1"/>
                </a:solidFill>
              </a:rPr>
              <a:t> </a:t>
            </a:r>
            <a:r>
              <a:rPr lang="en-US" dirty="0" err="1">
                <a:solidFill>
                  <a:schemeClr val="bg1"/>
                </a:solidFill>
              </a:rPr>
              <a:t>resultatene</a:t>
            </a:r>
            <a:r>
              <a:rPr lang="en-US" dirty="0">
                <a:solidFill>
                  <a:schemeClr val="bg1"/>
                </a:solidFill>
              </a:rPr>
              <a:t> </a:t>
            </a:r>
            <a:r>
              <a:rPr lang="en-US" dirty="0" err="1">
                <a:solidFill>
                  <a:schemeClr val="bg1"/>
                </a:solidFill>
              </a:rPr>
              <a:t>virkelig</a:t>
            </a:r>
            <a:r>
              <a:rPr lang="en-US" dirty="0">
                <a:solidFill>
                  <a:schemeClr val="bg1"/>
                </a:solidFill>
              </a:rPr>
              <a:t> din </a:t>
            </a:r>
            <a:r>
              <a:rPr lang="en-US" dirty="0" err="1">
                <a:solidFill>
                  <a:schemeClr val="bg1"/>
                </a:solidFill>
              </a:rPr>
              <a:t>mening</a:t>
            </a:r>
            <a:r>
              <a:rPr lang="en-US" dirty="0">
                <a:solidFill>
                  <a:schemeClr val="bg1"/>
                </a:solidFill>
              </a:rPr>
              <a:t>? </a:t>
            </a:r>
            <a:r>
              <a:rPr lang="en-US" dirty="0" err="1">
                <a:solidFill>
                  <a:schemeClr val="bg1"/>
                </a:solidFill>
              </a:rPr>
              <a:t>Hvis</a:t>
            </a:r>
            <a:r>
              <a:rPr lang="en-US" dirty="0">
                <a:solidFill>
                  <a:schemeClr val="bg1"/>
                </a:solidFill>
              </a:rPr>
              <a:t> </a:t>
            </a:r>
            <a:r>
              <a:rPr lang="en-US" dirty="0" err="1">
                <a:solidFill>
                  <a:schemeClr val="bg1"/>
                </a:solidFill>
              </a:rPr>
              <a:t>ikke</a:t>
            </a:r>
            <a:r>
              <a:rPr lang="en-US" dirty="0">
                <a:solidFill>
                  <a:schemeClr val="bg1"/>
                </a:solidFill>
              </a:rPr>
              <a:t>, </a:t>
            </a:r>
            <a:r>
              <a:rPr lang="en-US" dirty="0" err="1">
                <a:solidFill>
                  <a:schemeClr val="bg1"/>
                </a:solidFill>
              </a:rPr>
              <a:t>hvorfor</a:t>
            </a:r>
            <a:r>
              <a:rPr lang="en-US" dirty="0">
                <a:solidFill>
                  <a:schemeClr val="bg1"/>
                </a:solidFill>
              </a:rPr>
              <a:t> </a:t>
            </a:r>
            <a:r>
              <a:rPr lang="en-US" dirty="0" err="1">
                <a:solidFill>
                  <a:schemeClr val="bg1"/>
                </a:solidFill>
              </a:rPr>
              <a:t>ikke</a:t>
            </a:r>
            <a:r>
              <a:rPr lang="en-US" dirty="0">
                <a:solidFill>
                  <a:schemeClr val="bg1"/>
                </a:solidFill>
              </a:rPr>
              <a:t>?</a:t>
            </a:r>
          </a:p>
          <a:p>
            <a:r>
              <a:rPr lang="en-US" dirty="0" err="1">
                <a:solidFill>
                  <a:schemeClr val="bg1"/>
                </a:solidFill>
              </a:rPr>
              <a:t>Hvordan</a:t>
            </a:r>
            <a:r>
              <a:rPr lang="en-US" dirty="0">
                <a:solidFill>
                  <a:schemeClr val="bg1"/>
                </a:solidFill>
              </a:rPr>
              <a:t> </a:t>
            </a:r>
            <a:r>
              <a:rPr lang="en-US" dirty="0" err="1">
                <a:solidFill>
                  <a:schemeClr val="bg1"/>
                </a:solidFill>
              </a:rPr>
              <a:t>kan</a:t>
            </a:r>
            <a:r>
              <a:rPr lang="en-US" dirty="0">
                <a:solidFill>
                  <a:schemeClr val="bg1"/>
                </a:solidFill>
              </a:rPr>
              <a:t> vi </a:t>
            </a:r>
            <a:r>
              <a:rPr lang="en-US" dirty="0" err="1">
                <a:solidFill>
                  <a:schemeClr val="bg1"/>
                </a:solidFill>
              </a:rPr>
              <a:t>forstå</a:t>
            </a:r>
            <a:r>
              <a:rPr lang="en-US" dirty="0">
                <a:solidFill>
                  <a:schemeClr val="bg1"/>
                </a:solidFill>
              </a:rPr>
              <a:t> […]?</a:t>
            </a:r>
          </a:p>
          <a:p>
            <a:r>
              <a:rPr lang="en-US" dirty="0" err="1">
                <a:solidFill>
                  <a:schemeClr val="bg1"/>
                </a:solidFill>
              </a:rPr>
              <a:t>Hvilke</a:t>
            </a:r>
            <a:r>
              <a:rPr lang="en-US" dirty="0">
                <a:solidFill>
                  <a:schemeClr val="bg1"/>
                </a:solidFill>
              </a:rPr>
              <a:t> </a:t>
            </a:r>
            <a:r>
              <a:rPr lang="en-US" dirty="0" err="1">
                <a:solidFill>
                  <a:schemeClr val="bg1"/>
                </a:solidFill>
              </a:rPr>
              <a:t>anbefalinger</a:t>
            </a:r>
            <a:r>
              <a:rPr lang="en-US" dirty="0">
                <a:solidFill>
                  <a:schemeClr val="bg1"/>
                </a:solidFill>
              </a:rPr>
              <a:t> </a:t>
            </a:r>
            <a:r>
              <a:rPr lang="en-US" dirty="0" err="1">
                <a:solidFill>
                  <a:schemeClr val="bg1"/>
                </a:solidFill>
              </a:rPr>
              <a:t>vil</a:t>
            </a:r>
            <a:r>
              <a:rPr lang="en-US" dirty="0">
                <a:solidFill>
                  <a:schemeClr val="bg1"/>
                </a:solidFill>
              </a:rPr>
              <a:t> </a:t>
            </a:r>
            <a:r>
              <a:rPr lang="en-US" dirty="0" err="1">
                <a:solidFill>
                  <a:schemeClr val="bg1"/>
                </a:solidFill>
              </a:rPr>
              <a:t>dere</a:t>
            </a:r>
            <a:r>
              <a:rPr lang="en-US" dirty="0">
                <a:solidFill>
                  <a:schemeClr val="bg1"/>
                </a:solidFill>
              </a:rPr>
              <a:t> </a:t>
            </a:r>
            <a:r>
              <a:rPr lang="en-US" dirty="0" err="1">
                <a:solidFill>
                  <a:schemeClr val="bg1"/>
                </a:solidFill>
              </a:rPr>
              <a:t>gi</a:t>
            </a:r>
            <a:r>
              <a:rPr lang="en-US" dirty="0">
                <a:solidFill>
                  <a:schemeClr val="bg1"/>
                </a:solidFill>
              </a:rPr>
              <a:t> </a:t>
            </a:r>
            <a:r>
              <a:rPr lang="en-US" dirty="0" err="1">
                <a:solidFill>
                  <a:schemeClr val="bg1"/>
                </a:solidFill>
              </a:rPr>
              <a:t>oss</a:t>
            </a:r>
            <a:r>
              <a:rPr lang="en-US" dirty="0">
                <a:solidFill>
                  <a:schemeClr val="bg1"/>
                </a:solidFill>
              </a:rPr>
              <a:t> for å </a:t>
            </a:r>
            <a:r>
              <a:rPr lang="en-US" dirty="0" err="1">
                <a:solidFill>
                  <a:schemeClr val="bg1"/>
                </a:solidFill>
              </a:rPr>
              <a:t>løse</a:t>
            </a:r>
            <a:r>
              <a:rPr lang="en-US" dirty="0">
                <a:solidFill>
                  <a:schemeClr val="bg1"/>
                </a:solidFill>
              </a:rPr>
              <a:t> [</a:t>
            </a:r>
            <a:r>
              <a:rPr lang="en-US" i="1" dirty="0">
                <a:solidFill>
                  <a:schemeClr val="bg1"/>
                </a:solidFill>
              </a:rPr>
              <a:t>strategi x</a:t>
            </a:r>
            <a:r>
              <a:rPr lang="en-US" dirty="0">
                <a:solidFill>
                  <a:schemeClr val="bg1"/>
                </a:solidFill>
              </a:rPr>
              <a:t>]?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2" name="Plassholder for lysbildenummer 1">
            <a:extLst>
              <a:ext uri="{FF2B5EF4-FFF2-40B4-BE49-F238E27FC236}">
                <a16:creationId xmlns:a16="http://schemas.microsoft.com/office/drawing/2014/main" id="{26E48693-AFF4-E9CB-FE0D-CCAFF28E8A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7274F-C966-8C46-AFC4-F3A14ECF3B01}" type="slidenum">
              <a:rPr lang="nb-NO" smtClean="0"/>
              <a:t>21</a:t>
            </a:fld>
            <a:endParaRPr lang="nb-NO"/>
          </a:p>
        </p:txBody>
      </p:sp>
      <p:grpSp>
        <p:nvGrpSpPr>
          <p:cNvPr id="5" name="Gruppe 4">
            <a:extLst>
              <a:ext uri="{FF2B5EF4-FFF2-40B4-BE49-F238E27FC236}">
                <a16:creationId xmlns:a16="http://schemas.microsoft.com/office/drawing/2014/main" id="{59FFC450-961B-C223-B439-EADE524AB746}"/>
              </a:ext>
            </a:extLst>
          </p:cNvPr>
          <p:cNvGrpSpPr/>
          <p:nvPr/>
        </p:nvGrpSpPr>
        <p:grpSpPr>
          <a:xfrm>
            <a:off x="396023" y="393704"/>
            <a:ext cx="833492" cy="177295"/>
            <a:chOff x="396023" y="393704"/>
            <a:chExt cx="833492" cy="177295"/>
          </a:xfrm>
        </p:grpSpPr>
        <p:sp>
          <p:nvSpPr>
            <p:cNvPr id="6" name="Friform 6">
              <a:extLst>
                <a:ext uri="{FF2B5EF4-FFF2-40B4-BE49-F238E27FC236}">
                  <a16:creationId xmlns:a16="http://schemas.microsoft.com/office/drawing/2014/main" id="{CEE91B08-B51D-349C-DEA7-269E4B667D5B}"/>
                </a:ext>
              </a:extLst>
            </p:cNvPr>
            <p:cNvSpPr/>
            <p:nvPr/>
          </p:nvSpPr>
          <p:spPr>
            <a:xfrm>
              <a:off x="936121" y="394334"/>
              <a:ext cx="135024" cy="176665"/>
            </a:xfrm>
            <a:custGeom>
              <a:avLst/>
              <a:gdLst>
                <a:gd name="connsiteX0" fmla="*/ 108524 w 135024"/>
                <a:gd name="connsiteY0" fmla="*/ 0 h 176665"/>
                <a:gd name="connsiteX1" fmla="*/ 108524 w 135024"/>
                <a:gd name="connsiteY1" fmla="*/ 109154 h 176665"/>
                <a:gd name="connsiteX2" fmla="*/ 96536 w 135024"/>
                <a:gd name="connsiteY2" fmla="*/ 138808 h 176665"/>
                <a:gd name="connsiteX3" fmla="*/ 66881 w 135024"/>
                <a:gd name="connsiteY3" fmla="*/ 150796 h 176665"/>
                <a:gd name="connsiteX4" fmla="*/ 37226 w 135024"/>
                <a:gd name="connsiteY4" fmla="*/ 138808 h 176665"/>
                <a:gd name="connsiteX5" fmla="*/ 25238 w 135024"/>
                <a:gd name="connsiteY5" fmla="*/ 109154 h 176665"/>
                <a:gd name="connsiteX6" fmla="*/ 25238 w 135024"/>
                <a:gd name="connsiteY6" fmla="*/ 0 h 176665"/>
                <a:gd name="connsiteX7" fmla="*/ 0 w 135024"/>
                <a:gd name="connsiteY7" fmla="*/ 0 h 176665"/>
                <a:gd name="connsiteX8" fmla="*/ 0 w 135024"/>
                <a:gd name="connsiteY8" fmla="*/ 109154 h 176665"/>
                <a:gd name="connsiteX9" fmla="*/ 5048 w 135024"/>
                <a:gd name="connsiteY9" fmla="*/ 135023 h 176665"/>
                <a:gd name="connsiteX10" fmla="*/ 19560 w 135024"/>
                <a:gd name="connsiteY10" fmla="*/ 157106 h 176665"/>
                <a:gd name="connsiteX11" fmla="*/ 41643 w 135024"/>
                <a:gd name="connsiteY11" fmla="*/ 171617 h 176665"/>
                <a:gd name="connsiteX12" fmla="*/ 67512 w 135024"/>
                <a:gd name="connsiteY12" fmla="*/ 176665 h 176665"/>
                <a:gd name="connsiteX13" fmla="*/ 93382 w 135024"/>
                <a:gd name="connsiteY13" fmla="*/ 171617 h 176665"/>
                <a:gd name="connsiteX14" fmla="*/ 115465 w 135024"/>
                <a:gd name="connsiteY14" fmla="*/ 157106 h 176665"/>
                <a:gd name="connsiteX15" fmla="*/ 129977 w 135024"/>
                <a:gd name="connsiteY15" fmla="*/ 135023 h 176665"/>
                <a:gd name="connsiteX16" fmla="*/ 135025 w 135024"/>
                <a:gd name="connsiteY16" fmla="*/ 109154 h 176665"/>
                <a:gd name="connsiteX17" fmla="*/ 135025 w 135024"/>
                <a:gd name="connsiteY17" fmla="*/ 0 h 176665"/>
                <a:gd name="connsiteX18" fmla="*/ 108524 w 135024"/>
                <a:gd name="connsiteY18" fmla="*/ 0 h 1766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</a:cxnLst>
              <a:rect l="l" t="t" r="r" b="b"/>
              <a:pathLst>
                <a:path w="135024" h="176665">
                  <a:moveTo>
                    <a:pt x="108524" y="0"/>
                  </a:moveTo>
                  <a:lnTo>
                    <a:pt x="108524" y="109154"/>
                  </a:lnTo>
                  <a:cubicBezTo>
                    <a:pt x="108524" y="120511"/>
                    <a:pt x="104108" y="131237"/>
                    <a:pt x="96536" y="138808"/>
                  </a:cubicBezTo>
                  <a:cubicBezTo>
                    <a:pt x="88965" y="146380"/>
                    <a:pt x="78239" y="150796"/>
                    <a:pt x="66881" y="150796"/>
                  </a:cubicBezTo>
                  <a:cubicBezTo>
                    <a:pt x="55524" y="150796"/>
                    <a:pt x="44798" y="146380"/>
                    <a:pt x="37226" y="138808"/>
                  </a:cubicBezTo>
                  <a:cubicBezTo>
                    <a:pt x="29655" y="131237"/>
                    <a:pt x="25238" y="120511"/>
                    <a:pt x="25238" y="109154"/>
                  </a:cubicBezTo>
                  <a:lnTo>
                    <a:pt x="25238" y="0"/>
                  </a:lnTo>
                  <a:lnTo>
                    <a:pt x="0" y="0"/>
                  </a:lnTo>
                  <a:lnTo>
                    <a:pt x="0" y="109154"/>
                  </a:lnTo>
                  <a:cubicBezTo>
                    <a:pt x="0" y="117987"/>
                    <a:pt x="1893" y="126820"/>
                    <a:pt x="5048" y="135023"/>
                  </a:cubicBezTo>
                  <a:cubicBezTo>
                    <a:pt x="8202" y="143225"/>
                    <a:pt x="13250" y="150796"/>
                    <a:pt x="19560" y="157106"/>
                  </a:cubicBezTo>
                  <a:cubicBezTo>
                    <a:pt x="25869" y="163415"/>
                    <a:pt x="33441" y="168463"/>
                    <a:pt x="41643" y="171617"/>
                  </a:cubicBezTo>
                  <a:cubicBezTo>
                    <a:pt x="49846" y="174772"/>
                    <a:pt x="58679" y="176665"/>
                    <a:pt x="67512" y="176665"/>
                  </a:cubicBezTo>
                  <a:cubicBezTo>
                    <a:pt x="76346" y="176665"/>
                    <a:pt x="85179" y="174772"/>
                    <a:pt x="93382" y="171617"/>
                  </a:cubicBezTo>
                  <a:cubicBezTo>
                    <a:pt x="101584" y="168463"/>
                    <a:pt x="109155" y="163415"/>
                    <a:pt x="115465" y="157106"/>
                  </a:cubicBezTo>
                  <a:cubicBezTo>
                    <a:pt x="121775" y="150796"/>
                    <a:pt x="126822" y="143225"/>
                    <a:pt x="129977" y="135023"/>
                  </a:cubicBezTo>
                  <a:cubicBezTo>
                    <a:pt x="133132" y="126820"/>
                    <a:pt x="135025" y="117987"/>
                    <a:pt x="135025" y="109154"/>
                  </a:cubicBezTo>
                  <a:lnTo>
                    <a:pt x="135025" y="0"/>
                  </a:lnTo>
                  <a:lnTo>
                    <a:pt x="108524" y="0"/>
                  </a:lnTo>
                  <a:close/>
                </a:path>
              </a:pathLst>
            </a:custGeom>
            <a:solidFill>
              <a:schemeClr val="bg1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7" name="Friform 7">
              <a:extLst>
                <a:ext uri="{FF2B5EF4-FFF2-40B4-BE49-F238E27FC236}">
                  <a16:creationId xmlns:a16="http://schemas.microsoft.com/office/drawing/2014/main" id="{3A255EF6-000E-9DAC-27F7-87BA4E617DE8}"/>
                </a:ext>
              </a:extLst>
            </p:cNvPr>
            <p:cNvSpPr/>
            <p:nvPr/>
          </p:nvSpPr>
          <p:spPr>
            <a:xfrm>
              <a:off x="630107" y="393704"/>
              <a:ext cx="119881" cy="175403"/>
            </a:xfrm>
            <a:custGeom>
              <a:avLst/>
              <a:gdLst>
                <a:gd name="connsiteX0" fmla="*/ 66881 w 119881"/>
                <a:gd name="connsiteY0" fmla="*/ 76345 h 175403"/>
                <a:gd name="connsiteX1" fmla="*/ 24607 w 119881"/>
                <a:gd name="connsiteY1" fmla="*/ 76345 h 175403"/>
                <a:gd name="connsiteX2" fmla="*/ 24607 w 119881"/>
                <a:gd name="connsiteY2" fmla="*/ 22714 h 175403"/>
                <a:gd name="connsiteX3" fmla="*/ 66881 w 119881"/>
                <a:gd name="connsiteY3" fmla="*/ 22714 h 175403"/>
                <a:gd name="connsiteX4" fmla="*/ 85179 w 119881"/>
                <a:gd name="connsiteY4" fmla="*/ 30285 h 175403"/>
                <a:gd name="connsiteX5" fmla="*/ 92751 w 119881"/>
                <a:gd name="connsiteY5" fmla="*/ 48583 h 175403"/>
                <a:gd name="connsiteX6" fmla="*/ 92751 w 119881"/>
                <a:gd name="connsiteY6" fmla="*/ 50476 h 175403"/>
                <a:gd name="connsiteX7" fmla="*/ 85179 w 119881"/>
                <a:gd name="connsiteY7" fmla="*/ 68773 h 175403"/>
                <a:gd name="connsiteX8" fmla="*/ 66881 w 119881"/>
                <a:gd name="connsiteY8" fmla="*/ 76345 h 175403"/>
                <a:gd name="connsiteX9" fmla="*/ 119882 w 119881"/>
                <a:gd name="connsiteY9" fmla="*/ 49845 h 175403"/>
                <a:gd name="connsiteX10" fmla="*/ 119882 w 119881"/>
                <a:gd name="connsiteY10" fmla="*/ 49845 h 175403"/>
                <a:gd name="connsiteX11" fmla="*/ 105370 w 119881"/>
                <a:gd name="connsiteY11" fmla="*/ 14512 h 175403"/>
                <a:gd name="connsiteX12" fmla="*/ 70667 w 119881"/>
                <a:gd name="connsiteY12" fmla="*/ 0 h 175403"/>
                <a:gd name="connsiteX13" fmla="*/ 0 w 119881"/>
                <a:gd name="connsiteY13" fmla="*/ 0 h 175403"/>
                <a:gd name="connsiteX14" fmla="*/ 0 w 119881"/>
                <a:gd name="connsiteY14" fmla="*/ 174772 h 175403"/>
                <a:gd name="connsiteX15" fmla="*/ 25238 w 119881"/>
                <a:gd name="connsiteY15" fmla="*/ 174772 h 175403"/>
                <a:gd name="connsiteX16" fmla="*/ 25238 w 119881"/>
                <a:gd name="connsiteY16" fmla="*/ 98428 h 175403"/>
                <a:gd name="connsiteX17" fmla="*/ 37226 w 119881"/>
                <a:gd name="connsiteY17" fmla="*/ 98428 h 175403"/>
                <a:gd name="connsiteX18" fmla="*/ 86441 w 119881"/>
                <a:gd name="connsiteY18" fmla="*/ 175403 h 175403"/>
                <a:gd name="connsiteX19" fmla="*/ 117989 w 119881"/>
                <a:gd name="connsiteY19" fmla="*/ 175403 h 175403"/>
                <a:gd name="connsiteX20" fmla="*/ 67512 w 119881"/>
                <a:gd name="connsiteY20" fmla="*/ 98428 h 175403"/>
                <a:gd name="connsiteX21" fmla="*/ 71298 w 119881"/>
                <a:gd name="connsiteY21" fmla="*/ 98428 h 175403"/>
                <a:gd name="connsiteX22" fmla="*/ 90227 w 119881"/>
                <a:gd name="connsiteY22" fmla="*/ 94642 h 175403"/>
                <a:gd name="connsiteX23" fmla="*/ 106001 w 119881"/>
                <a:gd name="connsiteY23" fmla="*/ 83916 h 175403"/>
                <a:gd name="connsiteX24" fmla="*/ 116727 w 119881"/>
                <a:gd name="connsiteY24" fmla="*/ 68142 h 175403"/>
                <a:gd name="connsiteX25" fmla="*/ 119882 w 119881"/>
                <a:gd name="connsiteY25" fmla="*/ 49845 h 1754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</a:cxnLst>
              <a:rect l="l" t="t" r="r" b="b"/>
              <a:pathLst>
                <a:path w="119881" h="175403">
                  <a:moveTo>
                    <a:pt x="66881" y="76345"/>
                  </a:moveTo>
                  <a:lnTo>
                    <a:pt x="24607" y="76345"/>
                  </a:lnTo>
                  <a:lnTo>
                    <a:pt x="24607" y="22714"/>
                  </a:lnTo>
                  <a:lnTo>
                    <a:pt x="66881" y="22714"/>
                  </a:lnTo>
                  <a:cubicBezTo>
                    <a:pt x="73822" y="22714"/>
                    <a:pt x="80762" y="25238"/>
                    <a:pt x="85179" y="30285"/>
                  </a:cubicBezTo>
                  <a:cubicBezTo>
                    <a:pt x="90227" y="35333"/>
                    <a:pt x="92751" y="41642"/>
                    <a:pt x="92751" y="48583"/>
                  </a:cubicBezTo>
                  <a:lnTo>
                    <a:pt x="92751" y="50476"/>
                  </a:lnTo>
                  <a:cubicBezTo>
                    <a:pt x="92751" y="57416"/>
                    <a:pt x="90227" y="64357"/>
                    <a:pt x="85179" y="68773"/>
                  </a:cubicBezTo>
                  <a:cubicBezTo>
                    <a:pt x="80131" y="73190"/>
                    <a:pt x="73822" y="76345"/>
                    <a:pt x="66881" y="76345"/>
                  </a:cubicBezTo>
                  <a:close/>
                  <a:moveTo>
                    <a:pt x="119882" y="49845"/>
                  </a:moveTo>
                  <a:lnTo>
                    <a:pt x="119882" y="49845"/>
                  </a:lnTo>
                  <a:cubicBezTo>
                    <a:pt x="119882" y="36595"/>
                    <a:pt x="114834" y="23976"/>
                    <a:pt x="105370" y="14512"/>
                  </a:cubicBezTo>
                  <a:cubicBezTo>
                    <a:pt x="95905" y="5048"/>
                    <a:pt x="83917" y="0"/>
                    <a:pt x="70667" y="0"/>
                  </a:cubicBezTo>
                  <a:lnTo>
                    <a:pt x="0" y="0"/>
                  </a:lnTo>
                  <a:lnTo>
                    <a:pt x="0" y="174772"/>
                  </a:lnTo>
                  <a:lnTo>
                    <a:pt x="25238" y="174772"/>
                  </a:lnTo>
                  <a:lnTo>
                    <a:pt x="25238" y="98428"/>
                  </a:lnTo>
                  <a:lnTo>
                    <a:pt x="37226" y="98428"/>
                  </a:lnTo>
                  <a:lnTo>
                    <a:pt x="86441" y="175403"/>
                  </a:lnTo>
                  <a:lnTo>
                    <a:pt x="117989" y="175403"/>
                  </a:lnTo>
                  <a:lnTo>
                    <a:pt x="67512" y="98428"/>
                  </a:lnTo>
                  <a:lnTo>
                    <a:pt x="71298" y="98428"/>
                  </a:lnTo>
                  <a:cubicBezTo>
                    <a:pt x="77608" y="98428"/>
                    <a:pt x="83917" y="97166"/>
                    <a:pt x="90227" y="94642"/>
                  </a:cubicBezTo>
                  <a:cubicBezTo>
                    <a:pt x="95905" y="92118"/>
                    <a:pt x="101584" y="88333"/>
                    <a:pt x="106001" y="83916"/>
                  </a:cubicBezTo>
                  <a:cubicBezTo>
                    <a:pt x="110417" y="79499"/>
                    <a:pt x="114203" y="73821"/>
                    <a:pt x="116727" y="68142"/>
                  </a:cubicBezTo>
                  <a:cubicBezTo>
                    <a:pt x="118620" y="62464"/>
                    <a:pt x="119882" y="56154"/>
                    <a:pt x="119882" y="49845"/>
                  </a:cubicBezTo>
                  <a:close/>
                </a:path>
              </a:pathLst>
            </a:custGeom>
            <a:solidFill>
              <a:schemeClr val="bg1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8" name="Friform 8">
              <a:extLst>
                <a:ext uri="{FF2B5EF4-FFF2-40B4-BE49-F238E27FC236}">
                  <a16:creationId xmlns:a16="http://schemas.microsoft.com/office/drawing/2014/main" id="{DD435A19-7BBE-D3CD-71ED-D6F7DAC4075B}"/>
                </a:ext>
              </a:extLst>
            </p:cNvPr>
            <p:cNvSpPr/>
            <p:nvPr/>
          </p:nvSpPr>
          <p:spPr>
            <a:xfrm>
              <a:off x="1109003" y="394334"/>
              <a:ext cx="120512" cy="174772"/>
            </a:xfrm>
            <a:custGeom>
              <a:avLst/>
              <a:gdLst>
                <a:gd name="connsiteX0" fmla="*/ 92751 w 120512"/>
                <a:gd name="connsiteY0" fmla="*/ 49845 h 174772"/>
                <a:gd name="connsiteX1" fmla="*/ 85179 w 120512"/>
                <a:gd name="connsiteY1" fmla="*/ 68142 h 174772"/>
                <a:gd name="connsiteX2" fmla="*/ 66881 w 120512"/>
                <a:gd name="connsiteY2" fmla="*/ 75714 h 174772"/>
                <a:gd name="connsiteX3" fmla="*/ 24607 w 120512"/>
                <a:gd name="connsiteY3" fmla="*/ 75714 h 174772"/>
                <a:gd name="connsiteX4" fmla="*/ 24607 w 120512"/>
                <a:gd name="connsiteY4" fmla="*/ 22083 h 174772"/>
                <a:gd name="connsiteX5" fmla="*/ 66881 w 120512"/>
                <a:gd name="connsiteY5" fmla="*/ 22083 h 174772"/>
                <a:gd name="connsiteX6" fmla="*/ 85179 w 120512"/>
                <a:gd name="connsiteY6" fmla="*/ 29654 h 174772"/>
                <a:gd name="connsiteX7" fmla="*/ 92751 w 120512"/>
                <a:gd name="connsiteY7" fmla="*/ 47952 h 174772"/>
                <a:gd name="connsiteX8" fmla="*/ 92751 w 120512"/>
                <a:gd name="connsiteY8" fmla="*/ 49845 h 174772"/>
                <a:gd name="connsiteX9" fmla="*/ 71298 w 120512"/>
                <a:gd name="connsiteY9" fmla="*/ 0 h 174772"/>
                <a:gd name="connsiteX10" fmla="*/ 0 w 120512"/>
                <a:gd name="connsiteY10" fmla="*/ 0 h 174772"/>
                <a:gd name="connsiteX11" fmla="*/ 0 w 120512"/>
                <a:gd name="connsiteY11" fmla="*/ 174772 h 174772"/>
                <a:gd name="connsiteX12" fmla="*/ 25238 w 120512"/>
                <a:gd name="connsiteY12" fmla="*/ 174772 h 174772"/>
                <a:gd name="connsiteX13" fmla="*/ 25238 w 120512"/>
                <a:gd name="connsiteY13" fmla="*/ 97797 h 174772"/>
                <a:gd name="connsiteX14" fmla="*/ 71298 w 120512"/>
                <a:gd name="connsiteY14" fmla="*/ 97797 h 174772"/>
                <a:gd name="connsiteX15" fmla="*/ 90227 w 120512"/>
                <a:gd name="connsiteY15" fmla="*/ 94011 h 174772"/>
                <a:gd name="connsiteX16" fmla="*/ 106001 w 120512"/>
                <a:gd name="connsiteY16" fmla="*/ 83285 h 174772"/>
                <a:gd name="connsiteX17" fmla="*/ 116727 w 120512"/>
                <a:gd name="connsiteY17" fmla="*/ 67511 h 174772"/>
                <a:gd name="connsiteX18" fmla="*/ 120513 w 120512"/>
                <a:gd name="connsiteY18" fmla="*/ 48583 h 174772"/>
                <a:gd name="connsiteX19" fmla="*/ 120513 w 120512"/>
                <a:gd name="connsiteY19" fmla="*/ 48583 h 174772"/>
                <a:gd name="connsiteX20" fmla="*/ 106001 w 120512"/>
                <a:gd name="connsiteY20" fmla="*/ 13881 h 174772"/>
                <a:gd name="connsiteX21" fmla="*/ 71298 w 120512"/>
                <a:gd name="connsiteY21" fmla="*/ 0 h 1747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</a:cxnLst>
              <a:rect l="l" t="t" r="r" b="b"/>
              <a:pathLst>
                <a:path w="120512" h="174772">
                  <a:moveTo>
                    <a:pt x="92751" y="49845"/>
                  </a:moveTo>
                  <a:cubicBezTo>
                    <a:pt x="92751" y="56785"/>
                    <a:pt x="90227" y="63726"/>
                    <a:pt x="85179" y="68142"/>
                  </a:cubicBezTo>
                  <a:cubicBezTo>
                    <a:pt x="80131" y="72559"/>
                    <a:pt x="73822" y="75714"/>
                    <a:pt x="66881" y="75714"/>
                  </a:cubicBezTo>
                  <a:lnTo>
                    <a:pt x="24607" y="75714"/>
                  </a:lnTo>
                  <a:lnTo>
                    <a:pt x="24607" y="22083"/>
                  </a:lnTo>
                  <a:lnTo>
                    <a:pt x="66881" y="22083"/>
                  </a:lnTo>
                  <a:cubicBezTo>
                    <a:pt x="73822" y="22083"/>
                    <a:pt x="80762" y="24607"/>
                    <a:pt x="85179" y="29654"/>
                  </a:cubicBezTo>
                  <a:cubicBezTo>
                    <a:pt x="89596" y="34702"/>
                    <a:pt x="92751" y="41012"/>
                    <a:pt x="92751" y="47952"/>
                  </a:cubicBezTo>
                  <a:lnTo>
                    <a:pt x="92751" y="49845"/>
                  </a:lnTo>
                  <a:close/>
                  <a:moveTo>
                    <a:pt x="71298" y="0"/>
                  </a:moveTo>
                  <a:lnTo>
                    <a:pt x="0" y="0"/>
                  </a:lnTo>
                  <a:lnTo>
                    <a:pt x="0" y="174772"/>
                  </a:lnTo>
                  <a:lnTo>
                    <a:pt x="25238" y="174772"/>
                  </a:lnTo>
                  <a:lnTo>
                    <a:pt x="25238" y="97797"/>
                  </a:lnTo>
                  <a:lnTo>
                    <a:pt x="71298" y="97797"/>
                  </a:lnTo>
                  <a:cubicBezTo>
                    <a:pt x="77608" y="97797"/>
                    <a:pt x="83917" y="96535"/>
                    <a:pt x="90227" y="94011"/>
                  </a:cubicBezTo>
                  <a:cubicBezTo>
                    <a:pt x="96536" y="91487"/>
                    <a:pt x="101584" y="87702"/>
                    <a:pt x="106001" y="83285"/>
                  </a:cubicBezTo>
                  <a:cubicBezTo>
                    <a:pt x="110417" y="78868"/>
                    <a:pt x="114203" y="73190"/>
                    <a:pt x="116727" y="67511"/>
                  </a:cubicBezTo>
                  <a:cubicBezTo>
                    <a:pt x="119251" y="61833"/>
                    <a:pt x="120513" y="55523"/>
                    <a:pt x="120513" y="48583"/>
                  </a:cubicBezTo>
                  <a:lnTo>
                    <a:pt x="120513" y="48583"/>
                  </a:lnTo>
                  <a:cubicBezTo>
                    <a:pt x="120513" y="35333"/>
                    <a:pt x="115465" y="23345"/>
                    <a:pt x="106001" y="13881"/>
                  </a:cubicBezTo>
                  <a:cubicBezTo>
                    <a:pt x="96536" y="5048"/>
                    <a:pt x="83917" y="0"/>
                    <a:pt x="71298" y="0"/>
                  </a:cubicBezTo>
                  <a:close/>
                </a:path>
              </a:pathLst>
            </a:custGeom>
            <a:solidFill>
              <a:schemeClr val="bg1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9" name="Friform 9">
              <a:extLst>
                <a:ext uri="{FF2B5EF4-FFF2-40B4-BE49-F238E27FC236}">
                  <a16:creationId xmlns:a16="http://schemas.microsoft.com/office/drawing/2014/main" id="{9F491119-47C9-AEE4-A14B-2B209FF41241}"/>
                </a:ext>
              </a:extLst>
            </p:cNvPr>
            <p:cNvSpPr/>
            <p:nvPr/>
          </p:nvSpPr>
          <p:spPr>
            <a:xfrm>
              <a:off x="782168" y="394334"/>
              <a:ext cx="120354" cy="174772"/>
            </a:xfrm>
            <a:custGeom>
              <a:avLst/>
              <a:gdLst>
                <a:gd name="connsiteX0" fmla="*/ 93381 w 120354"/>
                <a:gd name="connsiteY0" fmla="*/ 49845 h 174772"/>
                <a:gd name="connsiteX1" fmla="*/ 91489 w 120354"/>
                <a:gd name="connsiteY1" fmla="*/ 59940 h 174772"/>
                <a:gd name="connsiteX2" fmla="*/ 85810 w 120354"/>
                <a:gd name="connsiteY2" fmla="*/ 68142 h 174772"/>
                <a:gd name="connsiteX3" fmla="*/ 77608 w 120354"/>
                <a:gd name="connsiteY3" fmla="*/ 73821 h 174772"/>
                <a:gd name="connsiteX4" fmla="*/ 67512 w 120354"/>
                <a:gd name="connsiteY4" fmla="*/ 75714 h 174772"/>
                <a:gd name="connsiteX5" fmla="*/ 25238 w 120354"/>
                <a:gd name="connsiteY5" fmla="*/ 75714 h 174772"/>
                <a:gd name="connsiteX6" fmla="*/ 25238 w 120354"/>
                <a:gd name="connsiteY6" fmla="*/ 22083 h 174772"/>
                <a:gd name="connsiteX7" fmla="*/ 67512 w 120354"/>
                <a:gd name="connsiteY7" fmla="*/ 22083 h 174772"/>
                <a:gd name="connsiteX8" fmla="*/ 85810 w 120354"/>
                <a:gd name="connsiteY8" fmla="*/ 29654 h 174772"/>
                <a:gd name="connsiteX9" fmla="*/ 93381 w 120354"/>
                <a:gd name="connsiteY9" fmla="*/ 47952 h 174772"/>
                <a:gd name="connsiteX10" fmla="*/ 93381 w 120354"/>
                <a:gd name="connsiteY10" fmla="*/ 49845 h 174772"/>
                <a:gd name="connsiteX11" fmla="*/ 93381 w 120354"/>
                <a:gd name="connsiteY11" fmla="*/ 126189 h 174772"/>
                <a:gd name="connsiteX12" fmla="*/ 85810 w 120354"/>
                <a:gd name="connsiteY12" fmla="*/ 144487 h 174772"/>
                <a:gd name="connsiteX13" fmla="*/ 67512 w 120354"/>
                <a:gd name="connsiteY13" fmla="*/ 152058 h 174772"/>
                <a:gd name="connsiteX14" fmla="*/ 25238 w 120354"/>
                <a:gd name="connsiteY14" fmla="*/ 152058 h 174772"/>
                <a:gd name="connsiteX15" fmla="*/ 25238 w 120354"/>
                <a:gd name="connsiteY15" fmla="*/ 98428 h 174772"/>
                <a:gd name="connsiteX16" fmla="*/ 67512 w 120354"/>
                <a:gd name="connsiteY16" fmla="*/ 98428 h 174772"/>
                <a:gd name="connsiteX17" fmla="*/ 85810 w 120354"/>
                <a:gd name="connsiteY17" fmla="*/ 105999 h 174772"/>
                <a:gd name="connsiteX18" fmla="*/ 93381 w 120354"/>
                <a:gd name="connsiteY18" fmla="*/ 124296 h 174772"/>
                <a:gd name="connsiteX19" fmla="*/ 93381 w 120354"/>
                <a:gd name="connsiteY19" fmla="*/ 126189 h 174772"/>
                <a:gd name="connsiteX20" fmla="*/ 119882 w 120354"/>
                <a:gd name="connsiteY20" fmla="*/ 48583 h 174772"/>
                <a:gd name="connsiteX21" fmla="*/ 105370 w 120354"/>
                <a:gd name="connsiteY21" fmla="*/ 14512 h 174772"/>
                <a:gd name="connsiteX22" fmla="*/ 71298 w 120354"/>
                <a:gd name="connsiteY22" fmla="*/ 0 h 174772"/>
                <a:gd name="connsiteX23" fmla="*/ 0 w 120354"/>
                <a:gd name="connsiteY23" fmla="*/ 0 h 174772"/>
                <a:gd name="connsiteX24" fmla="*/ 0 w 120354"/>
                <a:gd name="connsiteY24" fmla="*/ 174772 h 174772"/>
                <a:gd name="connsiteX25" fmla="*/ 71929 w 120354"/>
                <a:gd name="connsiteY25" fmla="*/ 174772 h 174772"/>
                <a:gd name="connsiteX26" fmla="*/ 100322 w 120354"/>
                <a:gd name="connsiteY26" fmla="*/ 165308 h 174772"/>
                <a:gd name="connsiteX27" fmla="*/ 117989 w 120354"/>
                <a:gd name="connsiteY27" fmla="*/ 141332 h 174772"/>
                <a:gd name="connsiteX28" fmla="*/ 117989 w 120354"/>
                <a:gd name="connsiteY28" fmla="*/ 111678 h 174772"/>
                <a:gd name="connsiteX29" fmla="*/ 100322 w 120354"/>
                <a:gd name="connsiteY29" fmla="*/ 87702 h 174772"/>
                <a:gd name="connsiteX30" fmla="*/ 114834 w 120354"/>
                <a:gd name="connsiteY30" fmla="*/ 70666 h 174772"/>
                <a:gd name="connsiteX31" fmla="*/ 119882 w 120354"/>
                <a:gd name="connsiteY31" fmla="*/ 48583 h 1747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</a:cxnLst>
              <a:rect l="l" t="t" r="r" b="b"/>
              <a:pathLst>
                <a:path w="120354" h="174772">
                  <a:moveTo>
                    <a:pt x="93381" y="49845"/>
                  </a:moveTo>
                  <a:cubicBezTo>
                    <a:pt x="93381" y="53000"/>
                    <a:pt x="92751" y="56785"/>
                    <a:pt x="91489" y="59940"/>
                  </a:cubicBezTo>
                  <a:cubicBezTo>
                    <a:pt x="90227" y="63095"/>
                    <a:pt x="88334" y="66249"/>
                    <a:pt x="85810" y="68142"/>
                  </a:cubicBezTo>
                  <a:cubicBezTo>
                    <a:pt x="83286" y="70666"/>
                    <a:pt x="80762" y="72559"/>
                    <a:pt x="77608" y="73821"/>
                  </a:cubicBezTo>
                  <a:cubicBezTo>
                    <a:pt x="74453" y="75083"/>
                    <a:pt x="71298" y="75714"/>
                    <a:pt x="67512" y="75714"/>
                  </a:cubicBezTo>
                  <a:lnTo>
                    <a:pt x="25238" y="75714"/>
                  </a:lnTo>
                  <a:lnTo>
                    <a:pt x="25238" y="22083"/>
                  </a:lnTo>
                  <a:lnTo>
                    <a:pt x="67512" y="22083"/>
                  </a:lnTo>
                  <a:cubicBezTo>
                    <a:pt x="74453" y="22083"/>
                    <a:pt x="81393" y="24607"/>
                    <a:pt x="85810" y="29654"/>
                  </a:cubicBezTo>
                  <a:cubicBezTo>
                    <a:pt x="90227" y="34702"/>
                    <a:pt x="93381" y="41012"/>
                    <a:pt x="93381" y="47952"/>
                  </a:cubicBezTo>
                  <a:lnTo>
                    <a:pt x="93381" y="49845"/>
                  </a:lnTo>
                  <a:close/>
                  <a:moveTo>
                    <a:pt x="93381" y="126189"/>
                  </a:moveTo>
                  <a:cubicBezTo>
                    <a:pt x="93381" y="133130"/>
                    <a:pt x="90858" y="140070"/>
                    <a:pt x="85810" y="144487"/>
                  </a:cubicBezTo>
                  <a:cubicBezTo>
                    <a:pt x="80762" y="149534"/>
                    <a:pt x="74453" y="152058"/>
                    <a:pt x="67512" y="152058"/>
                  </a:cubicBezTo>
                  <a:lnTo>
                    <a:pt x="25238" y="152058"/>
                  </a:lnTo>
                  <a:lnTo>
                    <a:pt x="25238" y="98428"/>
                  </a:lnTo>
                  <a:lnTo>
                    <a:pt x="67512" y="98428"/>
                  </a:lnTo>
                  <a:cubicBezTo>
                    <a:pt x="74453" y="98428"/>
                    <a:pt x="81393" y="100951"/>
                    <a:pt x="85810" y="105999"/>
                  </a:cubicBezTo>
                  <a:cubicBezTo>
                    <a:pt x="90858" y="111047"/>
                    <a:pt x="93381" y="117356"/>
                    <a:pt x="93381" y="124296"/>
                  </a:cubicBezTo>
                  <a:lnTo>
                    <a:pt x="93381" y="126189"/>
                  </a:lnTo>
                  <a:close/>
                  <a:moveTo>
                    <a:pt x="119882" y="48583"/>
                  </a:moveTo>
                  <a:cubicBezTo>
                    <a:pt x="119882" y="35964"/>
                    <a:pt x="114834" y="23345"/>
                    <a:pt x="105370" y="14512"/>
                  </a:cubicBezTo>
                  <a:cubicBezTo>
                    <a:pt x="96536" y="5679"/>
                    <a:pt x="83917" y="0"/>
                    <a:pt x="71298" y="0"/>
                  </a:cubicBezTo>
                  <a:lnTo>
                    <a:pt x="0" y="0"/>
                  </a:lnTo>
                  <a:lnTo>
                    <a:pt x="0" y="174772"/>
                  </a:lnTo>
                  <a:lnTo>
                    <a:pt x="71929" y="174772"/>
                  </a:lnTo>
                  <a:cubicBezTo>
                    <a:pt x="82024" y="174772"/>
                    <a:pt x="92120" y="171617"/>
                    <a:pt x="100322" y="165308"/>
                  </a:cubicBezTo>
                  <a:cubicBezTo>
                    <a:pt x="108524" y="159629"/>
                    <a:pt x="114834" y="150796"/>
                    <a:pt x="117989" y="141332"/>
                  </a:cubicBezTo>
                  <a:cubicBezTo>
                    <a:pt x="121144" y="131868"/>
                    <a:pt x="121144" y="121142"/>
                    <a:pt x="117989" y="111678"/>
                  </a:cubicBezTo>
                  <a:cubicBezTo>
                    <a:pt x="114834" y="102213"/>
                    <a:pt x="108524" y="93380"/>
                    <a:pt x="100322" y="87702"/>
                  </a:cubicBezTo>
                  <a:cubicBezTo>
                    <a:pt x="106632" y="83285"/>
                    <a:pt x="111679" y="77606"/>
                    <a:pt x="114834" y="70666"/>
                  </a:cubicBezTo>
                  <a:cubicBezTo>
                    <a:pt x="117989" y="63726"/>
                    <a:pt x="119882" y="56154"/>
                    <a:pt x="119882" y="48583"/>
                  </a:cubicBezTo>
                  <a:close/>
                </a:path>
              </a:pathLst>
            </a:custGeom>
            <a:solidFill>
              <a:schemeClr val="bg1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0" name="Friform 10">
              <a:extLst>
                <a:ext uri="{FF2B5EF4-FFF2-40B4-BE49-F238E27FC236}">
                  <a16:creationId xmlns:a16="http://schemas.microsoft.com/office/drawing/2014/main" id="{38BBA28F-588B-0E53-B7E9-09453BEFC2EB}"/>
                </a:ext>
              </a:extLst>
            </p:cNvPr>
            <p:cNvSpPr/>
            <p:nvPr/>
          </p:nvSpPr>
          <p:spPr>
            <a:xfrm>
              <a:off x="454701" y="393704"/>
              <a:ext cx="116095" cy="116725"/>
            </a:xfrm>
            <a:custGeom>
              <a:avLst/>
              <a:gdLst>
                <a:gd name="connsiteX0" fmla="*/ 58048 w 116095"/>
                <a:gd name="connsiteY0" fmla="*/ 0 h 116725"/>
                <a:gd name="connsiteX1" fmla="*/ 99060 w 116095"/>
                <a:gd name="connsiteY1" fmla="*/ 17036 h 116725"/>
                <a:gd name="connsiteX2" fmla="*/ 116096 w 116095"/>
                <a:gd name="connsiteY2" fmla="*/ 58047 h 116725"/>
                <a:gd name="connsiteX3" fmla="*/ 116096 w 116095"/>
                <a:gd name="connsiteY3" fmla="*/ 116725 h 116725"/>
                <a:gd name="connsiteX4" fmla="*/ 0 w 116095"/>
                <a:gd name="connsiteY4" fmla="*/ 116725 h 116725"/>
                <a:gd name="connsiteX5" fmla="*/ 0 w 116095"/>
                <a:gd name="connsiteY5" fmla="*/ 58678 h 116725"/>
                <a:gd name="connsiteX6" fmla="*/ 17036 w 116095"/>
                <a:gd name="connsiteY6" fmla="*/ 17667 h 116725"/>
                <a:gd name="connsiteX7" fmla="*/ 58048 w 116095"/>
                <a:gd name="connsiteY7" fmla="*/ 0 h 1167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116095" h="116725">
                  <a:moveTo>
                    <a:pt x="58048" y="0"/>
                  </a:moveTo>
                  <a:cubicBezTo>
                    <a:pt x="73822" y="0"/>
                    <a:pt x="88334" y="6309"/>
                    <a:pt x="99060" y="17036"/>
                  </a:cubicBezTo>
                  <a:cubicBezTo>
                    <a:pt x="109786" y="27762"/>
                    <a:pt x="116096" y="42904"/>
                    <a:pt x="116096" y="58047"/>
                  </a:cubicBezTo>
                  <a:lnTo>
                    <a:pt x="116096" y="116725"/>
                  </a:lnTo>
                  <a:lnTo>
                    <a:pt x="0" y="116725"/>
                  </a:lnTo>
                  <a:lnTo>
                    <a:pt x="0" y="58678"/>
                  </a:lnTo>
                  <a:cubicBezTo>
                    <a:pt x="0" y="42904"/>
                    <a:pt x="6310" y="28393"/>
                    <a:pt x="17036" y="17667"/>
                  </a:cubicBezTo>
                  <a:cubicBezTo>
                    <a:pt x="27762" y="6940"/>
                    <a:pt x="42905" y="0"/>
                    <a:pt x="58048" y="0"/>
                  </a:cubicBezTo>
                  <a:close/>
                </a:path>
              </a:pathLst>
            </a:custGeom>
            <a:solidFill>
              <a:srgbClr val="E31836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1" name="Friform 11">
              <a:extLst>
                <a:ext uri="{FF2B5EF4-FFF2-40B4-BE49-F238E27FC236}">
                  <a16:creationId xmlns:a16="http://schemas.microsoft.com/office/drawing/2014/main" id="{5D3AA832-F6AD-507E-CEF0-FB80F39C631B}"/>
                </a:ext>
              </a:extLst>
            </p:cNvPr>
            <p:cNvSpPr/>
            <p:nvPr/>
          </p:nvSpPr>
          <p:spPr>
            <a:xfrm>
              <a:off x="396023" y="452382"/>
              <a:ext cx="58678" cy="116094"/>
            </a:xfrm>
            <a:custGeom>
              <a:avLst/>
              <a:gdLst>
                <a:gd name="connsiteX0" fmla="*/ 58679 w 58678"/>
                <a:gd name="connsiteY0" fmla="*/ 0 h 116094"/>
                <a:gd name="connsiteX1" fmla="*/ 17667 w 58678"/>
                <a:gd name="connsiteY1" fmla="*/ 17036 h 116094"/>
                <a:gd name="connsiteX2" fmla="*/ 0 w 58678"/>
                <a:gd name="connsiteY2" fmla="*/ 58047 h 116094"/>
                <a:gd name="connsiteX3" fmla="*/ 17036 w 58678"/>
                <a:gd name="connsiteY3" fmla="*/ 99059 h 116094"/>
                <a:gd name="connsiteX4" fmla="*/ 58048 w 58678"/>
                <a:gd name="connsiteY4" fmla="*/ 116094 h 116094"/>
                <a:gd name="connsiteX5" fmla="*/ 58048 w 58678"/>
                <a:gd name="connsiteY5" fmla="*/ 116094 h 116094"/>
                <a:gd name="connsiteX6" fmla="*/ 58048 w 58678"/>
                <a:gd name="connsiteY6" fmla="*/ 116094 h 116094"/>
                <a:gd name="connsiteX7" fmla="*/ 58048 w 58678"/>
                <a:gd name="connsiteY7" fmla="*/ 0 h 1160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58678" h="116094">
                  <a:moveTo>
                    <a:pt x="58679" y="0"/>
                  </a:moveTo>
                  <a:cubicBezTo>
                    <a:pt x="42905" y="0"/>
                    <a:pt x="28393" y="6309"/>
                    <a:pt x="17667" y="17036"/>
                  </a:cubicBezTo>
                  <a:cubicBezTo>
                    <a:pt x="6310" y="27762"/>
                    <a:pt x="0" y="42904"/>
                    <a:pt x="0" y="58047"/>
                  </a:cubicBezTo>
                  <a:cubicBezTo>
                    <a:pt x="0" y="73821"/>
                    <a:pt x="6310" y="88332"/>
                    <a:pt x="17036" y="99059"/>
                  </a:cubicBezTo>
                  <a:cubicBezTo>
                    <a:pt x="27762" y="109785"/>
                    <a:pt x="42905" y="116094"/>
                    <a:pt x="58048" y="116094"/>
                  </a:cubicBezTo>
                  <a:cubicBezTo>
                    <a:pt x="58048" y="116094"/>
                    <a:pt x="58048" y="116094"/>
                    <a:pt x="58048" y="116094"/>
                  </a:cubicBezTo>
                  <a:lnTo>
                    <a:pt x="58048" y="116094"/>
                  </a:lnTo>
                  <a:lnTo>
                    <a:pt x="58048" y="0"/>
                  </a:lnTo>
                  <a:close/>
                </a:path>
              </a:pathLst>
            </a:custGeom>
            <a:solidFill>
              <a:srgbClr val="728EE6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2" name="Friform 12">
              <a:extLst>
                <a:ext uri="{FF2B5EF4-FFF2-40B4-BE49-F238E27FC236}">
                  <a16:creationId xmlns:a16="http://schemas.microsoft.com/office/drawing/2014/main" id="{4A5FE642-BE42-62BF-E1DF-EF981A89E8B6}"/>
                </a:ext>
              </a:extLst>
            </p:cNvPr>
            <p:cNvSpPr/>
            <p:nvPr/>
          </p:nvSpPr>
          <p:spPr>
            <a:xfrm>
              <a:off x="454701" y="510429"/>
              <a:ext cx="116726" cy="58047"/>
            </a:xfrm>
            <a:custGeom>
              <a:avLst/>
              <a:gdLst>
                <a:gd name="connsiteX0" fmla="*/ 116727 w 116726"/>
                <a:gd name="connsiteY0" fmla="*/ 0 h 58047"/>
                <a:gd name="connsiteX1" fmla="*/ 58048 w 116726"/>
                <a:gd name="connsiteY1" fmla="*/ 0 h 58047"/>
                <a:gd name="connsiteX2" fmla="*/ 41012 w 116726"/>
                <a:gd name="connsiteY2" fmla="*/ 41012 h 58047"/>
                <a:gd name="connsiteX3" fmla="*/ 0 w 116726"/>
                <a:gd name="connsiteY3" fmla="*/ 58047 h 58047"/>
                <a:gd name="connsiteX4" fmla="*/ 116727 w 116726"/>
                <a:gd name="connsiteY4" fmla="*/ 58047 h 58047"/>
                <a:gd name="connsiteX5" fmla="*/ 116727 w 116726"/>
                <a:gd name="connsiteY5" fmla="*/ 0 h 580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116726" h="58047">
                  <a:moveTo>
                    <a:pt x="116727" y="0"/>
                  </a:moveTo>
                  <a:lnTo>
                    <a:pt x="58048" y="0"/>
                  </a:lnTo>
                  <a:cubicBezTo>
                    <a:pt x="58048" y="15774"/>
                    <a:pt x="51738" y="30285"/>
                    <a:pt x="41012" y="41012"/>
                  </a:cubicBezTo>
                  <a:cubicBezTo>
                    <a:pt x="30286" y="51738"/>
                    <a:pt x="15143" y="58047"/>
                    <a:pt x="0" y="58047"/>
                  </a:cubicBezTo>
                  <a:lnTo>
                    <a:pt x="116727" y="58047"/>
                  </a:lnTo>
                  <a:lnTo>
                    <a:pt x="116727" y="0"/>
                  </a:lnTo>
                  <a:close/>
                </a:path>
              </a:pathLst>
            </a:custGeom>
            <a:solidFill>
              <a:srgbClr val="C2CFF4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3" name="Friform 13">
              <a:extLst>
                <a:ext uri="{FF2B5EF4-FFF2-40B4-BE49-F238E27FC236}">
                  <a16:creationId xmlns:a16="http://schemas.microsoft.com/office/drawing/2014/main" id="{96A9957A-DB35-F7A4-E7BC-373218AF117D}"/>
                </a:ext>
              </a:extLst>
            </p:cNvPr>
            <p:cNvSpPr/>
            <p:nvPr/>
          </p:nvSpPr>
          <p:spPr>
            <a:xfrm>
              <a:off x="454701" y="510429"/>
              <a:ext cx="58047" cy="58678"/>
            </a:xfrm>
            <a:custGeom>
              <a:avLst/>
              <a:gdLst>
                <a:gd name="connsiteX0" fmla="*/ 58048 w 58047"/>
                <a:gd name="connsiteY0" fmla="*/ 0 h 58678"/>
                <a:gd name="connsiteX1" fmla="*/ 0 w 58047"/>
                <a:gd name="connsiteY1" fmla="*/ 0 h 58678"/>
                <a:gd name="connsiteX2" fmla="*/ 0 w 58047"/>
                <a:gd name="connsiteY2" fmla="*/ 58678 h 58678"/>
                <a:gd name="connsiteX3" fmla="*/ 0 w 58047"/>
                <a:gd name="connsiteY3" fmla="*/ 58678 h 58678"/>
                <a:gd name="connsiteX4" fmla="*/ 41012 w 58047"/>
                <a:gd name="connsiteY4" fmla="*/ 41642 h 58678"/>
                <a:gd name="connsiteX5" fmla="*/ 58048 w 58047"/>
                <a:gd name="connsiteY5" fmla="*/ 0 h 5867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8047" h="58678">
                  <a:moveTo>
                    <a:pt x="58048" y="0"/>
                  </a:moveTo>
                  <a:lnTo>
                    <a:pt x="0" y="0"/>
                  </a:lnTo>
                  <a:lnTo>
                    <a:pt x="0" y="58678"/>
                  </a:lnTo>
                  <a:lnTo>
                    <a:pt x="0" y="58678"/>
                  </a:lnTo>
                  <a:cubicBezTo>
                    <a:pt x="15774" y="58678"/>
                    <a:pt x="30286" y="52369"/>
                    <a:pt x="41012" y="41642"/>
                  </a:cubicBezTo>
                  <a:cubicBezTo>
                    <a:pt x="52369" y="30285"/>
                    <a:pt x="58048" y="15774"/>
                    <a:pt x="58048" y="0"/>
                  </a:cubicBezTo>
                  <a:close/>
                </a:path>
              </a:pathLst>
            </a:custGeom>
            <a:solidFill>
              <a:srgbClr val="355EDB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4" name="Friform 14">
              <a:extLst>
                <a:ext uri="{FF2B5EF4-FFF2-40B4-BE49-F238E27FC236}">
                  <a16:creationId xmlns:a16="http://schemas.microsoft.com/office/drawing/2014/main" id="{11538F44-B2D6-9457-E2BB-58ADE0A06D6B}"/>
                </a:ext>
              </a:extLst>
            </p:cNvPr>
            <p:cNvSpPr/>
            <p:nvPr/>
          </p:nvSpPr>
          <p:spPr>
            <a:xfrm>
              <a:off x="454701" y="452382"/>
              <a:ext cx="116726" cy="58678"/>
            </a:xfrm>
            <a:custGeom>
              <a:avLst/>
              <a:gdLst>
                <a:gd name="connsiteX0" fmla="*/ 0 w 116726"/>
                <a:gd name="connsiteY0" fmla="*/ 0 h 58678"/>
                <a:gd name="connsiteX1" fmla="*/ 116727 w 116726"/>
                <a:gd name="connsiteY1" fmla="*/ 0 h 58678"/>
                <a:gd name="connsiteX2" fmla="*/ 116727 w 116726"/>
                <a:gd name="connsiteY2" fmla="*/ 58678 h 58678"/>
                <a:gd name="connsiteX3" fmla="*/ 0 w 116726"/>
                <a:gd name="connsiteY3" fmla="*/ 58678 h 5867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16726" h="58678">
                  <a:moveTo>
                    <a:pt x="0" y="0"/>
                  </a:moveTo>
                  <a:lnTo>
                    <a:pt x="116727" y="0"/>
                  </a:lnTo>
                  <a:lnTo>
                    <a:pt x="116727" y="58678"/>
                  </a:lnTo>
                  <a:lnTo>
                    <a:pt x="0" y="58678"/>
                  </a:lnTo>
                  <a:close/>
                </a:path>
              </a:pathLst>
            </a:custGeom>
            <a:solidFill>
              <a:srgbClr val="C21536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</p:grpSp>
    </p:spTree>
    <p:extLst>
      <p:ext uri="{BB962C8B-B14F-4D97-AF65-F5344CB8AC3E}">
        <p14:creationId xmlns:p14="http://schemas.microsoft.com/office/powerpoint/2010/main" val="1546467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1373CCB0-9E84-493B-9A6D-C4C3147E71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2286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B47274F-C966-8C46-AFC4-F3A14ECF3B01}" type="slidenum">
              <a:rPr kumimoji="0" lang="nb-NO" sz="1200" b="1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+mn-ea"/>
                <a:cs typeface="+mn-cs"/>
              </a:rPr>
              <a:pPr marL="0" marR="0" lvl="0" indent="0" algn="r" defTabSz="2286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</a:t>
            </a:fld>
            <a:endParaRPr kumimoji="0" lang="nb-NO" sz="1200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+mn-ea"/>
              <a:cs typeface="+mn-cs"/>
            </a:endParaRPr>
          </a:p>
        </p:txBody>
      </p:sp>
      <p:sp>
        <p:nvSpPr>
          <p:cNvPr id="5" name="Rektangel 4">
            <a:extLst>
              <a:ext uri="{FF2B5EF4-FFF2-40B4-BE49-F238E27FC236}">
                <a16:creationId xmlns:a16="http://schemas.microsoft.com/office/drawing/2014/main" id="{902ACBC1-3963-4B21-8A2D-F989E6D78527}"/>
              </a:ext>
            </a:extLst>
          </p:cNvPr>
          <p:cNvSpPr/>
          <p:nvPr/>
        </p:nvSpPr>
        <p:spPr>
          <a:xfrm>
            <a:off x="1981201" y="2690337"/>
            <a:ext cx="8327985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ctr"/>
            <a:r>
              <a:rPr kumimoji="0" lang="nb-NO" sz="3200" b="1" i="0" u="none" strike="noStrike" kern="0" cap="none" spc="0" normalizeH="0" baseline="0" noProof="0" dirty="0">
                <a:ln>
                  <a:noFill/>
                </a:ln>
                <a:solidFill>
                  <a:schemeClr val="accent1"/>
                </a:solidFill>
                <a:effectLst/>
                <a:uLnTx/>
                <a:uFillTx/>
                <a:latin typeface="Century Gothic" panose="020B0502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‘’</a:t>
            </a:r>
            <a:r>
              <a:rPr lang="nb-NO" sz="3200" b="1" i="1" kern="0" noProof="0" dirty="0" err="1">
                <a:solidFill>
                  <a:schemeClr val="accent1"/>
                </a:solidFill>
                <a:latin typeface="Century Gothic" panose="020B0502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What</a:t>
            </a:r>
            <a:r>
              <a:rPr lang="nb-NO" sz="3200" b="1" i="1" kern="0" noProof="0" dirty="0">
                <a:solidFill>
                  <a:schemeClr val="accent1"/>
                </a:solidFill>
                <a:latin typeface="Century Gothic" panose="020B0502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b-NO" sz="3200" b="1" i="1" kern="0" noProof="0" dirty="0" err="1">
                <a:solidFill>
                  <a:schemeClr val="accent1"/>
                </a:solidFill>
                <a:latin typeface="Century Gothic" panose="020B0502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nditions</a:t>
            </a:r>
            <a:r>
              <a:rPr lang="nb-NO" sz="3200" b="1" i="1" kern="0" noProof="0" dirty="0">
                <a:solidFill>
                  <a:schemeClr val="accent1"/>
                </a:solidFill>
                <a:latin typeface="Century Gothic" panose="020B0502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ust be present for </a:t>
            </a:r>
            <a:r>
              <a:rPr lang="nb-NO" sz="3200" b="1" i="1" kern="0" noProof="0" dirty="0" err="1">
                <a:solidFill>
                  <a:schemeClr val="accent1"/>
                </a:solidFill>
                <a:latin typeface="Century Gothic" panose="020B0502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ccessful</a:t>
            </a:r>
            <a:r>
              <a:rPr lang="nb-NO" sz="3200" b="1" i="1" kern="0" noProof="0" dirty="0">
                <a:solidFill>
                  <a:schemeClr val="accent1"/>
                </a:solidFill>
                <a:latin typeface="Century Gothic" panose="020B0502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b-NO" sz="3200" b="1" i="1" kern="0" noProof="0" dirty="0" err="1">
                <a:solidFill>
                  <a:schemeClr val="accent1"/>
                </a:solidFill>
                <a:latin typeface="Century Gothic" panose="020B0502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plementation</a:t>
            </a:r>
            <a:r>
              <a:rPr lang="nb-NO" sz="3200" b="1" i="1" kern="0" noProof="0" dirty="0">
                <a:solidFill>
                  <a:schemeClr val="accent1"/>
                </a:solidFill>
                <a:latin typeface="Century Gothic" panose="020B0502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t </a:t>
            </a:r>
            <a:r>
              <a:rPr lang="nb-NO" sz="3200" b="1" i="1" kern="0" noProof="0" dirty="0" err="1">
                <a:solidFill>
                  <a:schemeClr val="accent1"/>
                </a:solidFill>
                <a:latin typeface="Century Gothic" panose="020B0502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your</a:t>
            </a:r>
            <a:r>
              <a:rPr lang="nb-NO" sz="3200" b="1" i="1" kern="0" noProof="0" dirty="0">
                <a:solidFill>
                  <a:schemeClr val="accent1"/>
                </a:solidFill>
                <a:latin typeface="Century Gothic" panose="020B0502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b-NO" sz="3200" b="1" i="1" kern="0" noProof="0" dirty="0" err="1">
                <a:solidFill>
                  <a:schemeClr val="accent1"/>
                </a:solidFill>
                <a:latin typeface="Century Gothic" panose="020B0502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workplace</a:t>
            </a:r>
            <a:r>
              <a:rPr lang="nb-NO" sz="3200" b="1" i="1" kern="0" noProof="0" dirty="0">
                <a:solidFill>
                  <a:schemeClr val="accent1"/>
                </a:solidFill>
                <a:latin typeface="Century Gothic" panose="020B0502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?</a:t>
            </a:r>
            <a:r>
              <a:rPr kumimoji="0" lang="nb-NO" sz="3200" b="1" i="0" u="none" strike="noStrike" kern="0" cap="none" spc="0" normalizeH="0" baseline="0" noProof="0" dirty="0">
                <a:ln>
                  <a:noFill/>
                </a:ln>
                <a:solidFill>
                  <a:schemeClr val="accent1"/>
                </a:solidFill>
                <a:effectLst/>
                <a:uLnTx/>
                <a:uFillTx/>
                <a:latin typeface="Century Gothic" panose="020B0502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‘’</a:t>
            </a:r>
            <a:endParaRPr kumimoji="0" lang="nb-NO" sz="3200" b="1" i="1" u="none" strike="noStrike" kern="0" cap="none" spc="0" normalizeH="0" baseline="0" noProof="0" dirty="0">
              <a:ln>
                <a:noFill/>
              </a:ln>
              <a:solidFill>
                <a:schemeClr val="accent1"/>
              </a:solidFill>
              <a:effectLst/>
              <a:uLnTx/>
              <a:uFillTx/>
              <a:latin typeface="Century Gothic" panose="020B0502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533878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Undertittel 5">
            <a:extLst>
              <a:ext uri="{FF2B5EF4-FFF2-40B4-BE49-F238E27FC236}">
                <a16:creationId xmlns:a16="http://schemas.microsoft.com/office/drawing/2014/main" id="{ADABB02F-9972-4C7D-841E-0E8722653B92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Tittel 4">
            <a:extLst>
              <a:ext uri="{FF2B5EF4-FFF2-40B4-BE49-F238E27FC236}">
                <a16:creationId xmlns:a16="http://schemas.microsoft.com/office/drawing/2014/main" id="{AE2D6C44-0600-4569-B047-9F6660F28FB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nb-NO" dirty="0"/>
              <a:t>Card </a:t>
            </a:r>
            <a:r>
              <a:rPr lang="nb-NO" dirty="0" err="1"/>
              <a:t>Sorting</a:t>
            </a:r>
            <a:r>
              <a:rPr lang="nb-NO" dirty="0"/>
              <a:t> </a:t>
            </a:r>
            <a:r>
              <a:rPr lang="nb-NO" dirty="0" err="1"/>
              <a:t>Task</a:t>
            </a:r>
            <a:endParaRPr lang="nb-NO" dirty="0"/>
          </a:p>
        </p:txBody>
      </p:sp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03AF29A7-5751-2041-B29B-827CA14C98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7274F-C966-8C46-AFC4-F3A14ECF3B01}" type="slidenum">
              <a:rPr lang="nb-NO" smtClean="0"/>
              <a:t>4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3168359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ssholder for innhold 5">
            <a:extLst>
              <a:ext uri="{FF2B5EF4-FFF2-40B4-BE49-F238E27FC236}">
                <a16:creationId xmlns:a16="http://schemas.microsoft.com/office/drawing/2014/main" id="{AD37E570-729C-4434-9AF1-C45B1D904C08}"/>
              </a:ext>
            </a:extLst>
          </p:cNvPr>
          <p:cNvSpPr>
            <a:spLocks noGrp="1"/>
          </p:cNvSpPr>
          <p:nvPr>
            <p:ph sz="half" idx="1"/>
          </p:nvPr>
        </p:nvSpPr>
        <p:spPr/>
        <p:txBody>
          <a:bodyPr/>
          <a:lstStyle/>
          <a:p>
            <a:pPr marL="457200" indent="-457200">
              <a:buFont typeface="+mj-lt"/>
              <a:buAutoNum type="arabicParenR"/>
            </a:pPr>
            <a:r>
              <a:rPr lang="nb-NO" sz="2000" dirty="0"/>
              <a:t>Read </a:t>
            </a:r>
            <a:r>
              <a:rPr lang="nb-NO" sz="2000" dirty="0" err="1"/>
              <a:t>the</a:t>
            </a:r>
            <a:r>
              <a:rPr lang="nb-NO" sz="2000" dirty="0"/>
              <a:t> </a:t>
            </a:r>
            <a:r>
              <a:rPr lang="nb-NO" sz="2000" dirty="0" err="1"/>
              <a:t>strategy</a:t>
            </a:r>
            <a:r>
              <a:rPr lang="nb-NO" sz="2000" dirty="0"/>
              <a:t> </a:t>
            </a:r>
            <a:r>
              <a:rPr lang="nb-NO" sz="2000" dirty="0" err="1"/>
              <a:t>on</a:t>
            </a:r>
            <a:r>
              <a:rPr lang="nb-NO" sz="2000" dirty="0"/>
              <a:t> </a:t>
            </a:r>
            <a:r>
              <a:rPr lang="nb-NO" sz="2000" dirty="0" err="1"/>
              <a:t>each</a:t>
            </a:r>
            <a:r>
              <a:rPr lang="nb-NO" sz="2000" dirty="0"/>
              <a:t> </a:t>
            </a:r>
            <a:r>
              <a:rPr lang="nb-NO" sz="2000" dirty="0" err="1"/>
              <a:t>of</a:t>
            </a:r>
            <a:r>
              <a:rPr lang="nb-NO" sz="2000" dirty="0"/>
              <a:t> </a:t>
            </a:r>
            <a:r>
              <a:rPr lang="nb-NO" sz="2000" dirty="0" err="1"/>
              <a:t>the</a:t>
            </a:r>
            <a:r>
              <a:rPr lang="nb-NO" sz="2000" dirty="0"/>
              <a:t> </a:t>
            </a:r>
            <a:r>
              <a:rPr lang="nb-NO" sz="2000" dirty="0" err="1"/>
              <a:t>cards</a:t>
            </a:r>
            <a:endParaRPr lang="nb-NO" sz="2000" dirty="0"/>
          </a:p>
          <a:p>
            <a:pPr marL="457200" indent="-457200">
              <a:buFont typeface="+mj-lt"/>
              <a:buAutoNum type="arabicParenR"/>
            </a:pPr>
            <a:r>
              <a:rPr lang="nb-NO" sz="2000" dirty="0"/>
              <a:t>If </a:t>
            </a:r>
            <a:r>
              <a:rPr lang="nb-NO" sz="2000" dirty="0" err="1"/>
              <a:t>you</a:t>
            </a:r>
            <a:r>
              <a:rPr lang="nb-NO" sz="2000" dirty="0"/>
              <a:t> </a:t>
            </a:r>
            <a:r>
              <a:rPr lang="nb-NO" sz="2000" dirty="0" err="1"/>
              <a:t>want</a:t>
            </a:r>
            <a:r>
              <a:rPr lang="nb-NO" sz="2000" dirty="0"/>
              <a:t> to </a:t>
            </a:r>
            <a:r>
              <a:rPr lang="nb-NO" sz="2000" dirty="0" err="1"/>
              <a:t>add</a:t>
            </a:r>
            <a:r>
              <a:rPr lang="nb-NO" sz="2000" dirty="0"/>
              <a:t> </a:t>
            </a:r>
            <a:r>
              <a:rPr lang="nb-NO" sz="2000" dirty="0" err="1"/>
              <a:t>anything</a:t>
            </a:r>
            <a:r>
              <a:rPr lang="nb-NO" sz="2000" dirty="0"/>
              <a:t>, </a:t>
            </a:r>
            <a:r>
              <a:rPr lang="nb-NO" sz="2000" dirty="0" err="1"/>
              <a:t>write</a:t>
            </a:r>
            <a:r>
              <a:rPr lang="nb-NO" sz="2000" dirty="0"/>
              <a:t> a </a:t>
            </a:r>
            <a:r>
              <a:rPr lang="nb-NO" sz="2000" dirty="0" err="1"/>
              <a:t>comment</a:t>
            </a:r>
            <a:r>
              <a:rPr lang="nb-NO" sz="2000" dirty="0"/>
              <a:t> </a:t>
            </a:r>
            <a:r>
              <a:rPr lang="nb-NO" sz="2000" dirty="0" err="1"/>
              <a:t>on</a:t>
            </a:r>
            <a:r>
              <a:rPr lang="nb-NO" sz="2000" dirty="0"/>
              <a:t> </a:t>
            </a:r>
            <a:r>
              <a:rPr lang="nb-NO" sz="2000" dirty="0" err="1"/>
              <a:t>the</a:t>
            </a:r>
            <a:r>
              <a:rPr lang="nb-NO" sz="2000" dirty="0"/>
              <a:t> back </a:t>
            </a:r>
            <a:r>
              <a:rPr lang="nb-NO" sz="2000" dirty="0" err="1"/>
              <a:t>of</a:t>
            </a:r>
            <a:r>
              <a:rPr lang="nb-NO" sz="2000" dirty="0"/>
              <a:t> </a:t>
            </a:r>
            <a:r>
              <a:rPr lang="nb-NO" sz="2000" dirty="0" err="1"/>
              <a:t>the</a:t>
            </a:r>
            <a:r>
              <a:rPr lang="nb-NO" sz="2000" dirty="0"/>
              <a:t> </a:t>
            </a:r>
            <a:r>
              <a:rPr lang="nb-NO" sz="2000" dirty="0" err="1"/>
              <a:t>card</a:t>
            </a:r>
            <a:endParaRPr lang="nb-NO" sz="2000" dirty="0"/>
          </a:p>
          <a:p>
            <a:pPr marL="457200" indent="-457200">
              <a:buFont typeface="+mj-lt"/>
              <a:buAutoNum type="arabicParenR"/>
            </a:pPr>
            <a:r>
              <a:rPr lang="nb-NO" sz="2000" dirty="0"/>
              <a:t>Sort </a:t>
            </a:r>
            <a:r>
              <a:rPr lang="nb-NO" sz="2000" dirty="0" err="1"/>
              <a:t>the</a:t>
            </a:r>
            <a:r>
              <a:rPr lang="nb-NO" sz="2000" dirty="0"/>
              <a:t> </a:t>
            </a:r>
            <a:r>
              <a:rPr lang="nb-NO" sz="2000" dirty="0" err="1"/>
              <a:t>cards</a:t>
            </a:r>
            <a:r>
              <a:rPr lang="nb-NO" sz="2000" dirty="0"/>
              <a:t> </a:t>
            </a:r>
            <a:r>
              <a:rPr lang="nb-NO" sz="2000" dirty="0" err="1"/>
              <a:t>into</a:t>
            </a:r>
            <a:r>
              <a:rPr lang="nb-NO" sz="2000" dirty="0"/>
              <a:t> piles in a </a:t>
            </a:r>
            <a:r>
              <a:rPr lang="nb-NO" sz="2000" dirty="0" err="1"/>
              <a:t>way</a:t>
            </a:r>
            <a:r>
              <a:rPr lang="nb-NO" sz="2000" dirty="0"/>
              <a:t> </a:t>
            </a:r>
            <a:r>
              <a:rPr lang="nb-NO" sz="2000" dirty="0" err="1"/>
              <a:t>that</a:t>
            </a:r>
            <a:r>
              <a:rPr lang="nb-NO" sz="2000" dirty="0"/>
              <a:t> is </a:t>
            </a:r>
            <a:r>
              <a:rPr lang="nb-NO" sz="2000" i="1" dirty="0" err="1"/>
              <a:t>meaningful</a:t>
            </a:r>
            <a:r>
              <a:rPr lang="nb-NO" sz="2000" i="1" dirty="0"/>
              <a:t> to </a:t>
            </a:r>
            <a:r>
              <a:rPr lang="nb-NO" sz="2000" i="1" dirty="0" err="1"/>
              <a:t>you</a:t>
            </a:r>
            <a:endParaRPr lang="nb-NO" sz="2000" i="1" dirty="0"/>
          </a:p>
          <a:p>
            <a:pPr marL="457200" indent="-457200">
              <a:buFont typeface="+mj-lt"/>
              <a:buAutoNum type="arabicParenR"/>
            </a:pPr>
            <a:r>
              <a:rPr lang="nb-NO" sz="2000" dirty="0"/>
              <a:t>Place </a:t>
            </a:r>
            <a:r>
              <a:rPr lang="nb-NO" sz="2000" dirty="0" err="1"/>
              <a:t>similar</a:t>
            </a:r>
            <a:r>
              <a:rPr lang="nb-NO" sz="2000" dirty="0"/>
              <a:t> </a:t>
            </a:r>
            <a:r>
              <a:rPr lang="nb-NO" sz="2000" dirty="0" err="1"/>
              <a:t>cards</a:t>
            </a:r>
            <a:r>
              <a:rPr lang="nb-NO" sz="2000" dirty="0"/>
              <a:t> in </a:t>
            </a:r>
            <a:r>
              <a:rPr lang="nb-NO" sz="2000" dirty="0" err="1"/>
              <a:t>the</a:t>
            </a:r>
            <a:r>
              <a:rPr lang="nb-NO" sz="2000" dirty="0"/>
              <a:t> same pile. Group </a:t>
            </a:r>
            <a:r>
              <a:rPr lang="nb-NO" sz="2000" dirty="0" err="1"/>
              <a:t>cards</a:t>
            </a:r>
            <a:r>
              <a:rPr lang="nb-NO" sz="2000" dirty="0"/>
              <a:t> by </a:t>
            </a:r>
            <a:r>
              <a:rPr lang="nb-NO" sz="2000" dirty="0" err="1"/>
              <a:t>similarity</a:t>
            </a:r>
            <a:r>
              <a:rPr lang="nb-NO" sz="2000" dirty="0"/>
              <a:t>, and </a:t>
            </a:r>
            <a:r>
              <a:rPr lang="nb-NO" sz="2000" i="1" u="sng" dirty="0"/>
              <a:t>not </a:t>
            </a:r>
            <a:r>
              <a:rPr lang="nb-NO" sz="2000" dirty="0" err="1"/>
              <a:t>priority</a:t>
            </a:r>
            <a:endParaRPr lang="nb-NO" sz="2000" dirty="0"/>
          </a:p>
        </p:txBody>
      </p:sp>
      <p:sp>
        <p:nvSpPr>
          <p:cNvPr id="8" name="Plassholder for innhold 7">
            <a:extLst>
              <a:ext uri="{FF2B5EF4-FFF2-40B4-BE49-F238E27FC236}">
                <a16:creationId xmlns:a16="http://schemas.microsoft.com/office/drawing/2014/main" id="{85039023-2EDA-41FB-8571-73D711319320}"/>
              </a:ext>
            </a:extLst>
          </p:cNvPr>
          <p:cNvSpPr>
            <a:spLocks noGrp="1"/>
          </p:cNvSpPr>
          <p:nvPr>
            <p:ph sz="half" idx="13"/>
          </p:nvPr>
        </p:nvSpPr>
        <p:spPr/>
        <p:txBody>
          <a:bodyPr/>
          <a:lstStyle/>
          <a:p>
            <a:pPr marL="457200" indent="-457200">
              <a:buFont typeface="+mj-lt"/>
              <a:buAutoNum type="arabicParenR" startAt="9"/>
            </a:pPr>
            <a:r>
              <a:rPr lang="nb-NO" sz="2000" dirty="0"/>
              <a:t>Write a </a:t>
            </a:r>
            <a:r>
              <a:rPr lang="nb-NO" sz="2000" dirty="0" err="1"/>
              <a:t>name</a:t>
            </a:r>
            <a:r>
              <a:rPr lang="nb-NO" sz="2000" dirty="0"/>
              <a:t>/</a:t>
            </a:r>
            <a:r>
              <a:rPr lang="nb-NO" sz="2000" dirty="0" err="1"/>
              <a:t>label</a:t>
            </a:r>
            <a:r>
              <a:rPr lang="nb-NO" sz="2000" dirty="0"/>
              <a:t> for </a:t>
            </a:r>
            <a:r>
              <a:rPr lang="nb-NO" sz="2000" dirty="0" err="1"/>
              <a:t>each</a:t>
            </a:r>
            <a:r>
              <a:rPr lang="nb-NO" sz="2000" dirty="0"/>
              <a:t> pile </a:t>
            </a:r>
            <a:r>
              <a:rPr lang="nb-NO" sz="2000" dirty="0" err="1"/>
              <a:t>on</a:t>
            </a:r>
            <a:r>
              <a:rPr lang="nb-NO" sz="2000" dirty="0"/>
              <a:t> a </a:t>
            </a:r>
            <a:r>
              <a:rPr lang="nb-NO" sz="2000" dirty="0" err="1"/>
              <a:t>post-it</a:t>
            </a:r>
            <a:r>
              <a:rPr lang="nb-NO" sz="2000" dirty="0"/>
              <a:t> note</a:t>
            </a:r>
          </a:p>
          <a:p>
            <a:pPr marL="457200" indent="-457200">
              <a:buFont typeface="+mj-lt"/>
              <a:buAutoNum type="arabicParenR" startAt="9"/>
            </a:pPr>
            <a:r>
              <a:rPr lang="nb-NO" sz="2000" dirty="0" err="1"/>
              <a:t>Wrap</a:t>
            </a:r>
            <a:r>
              <a:rPr lang="nb-NO" sz="2000" dirty="0"/>
              <a:t> a rubber band </a:t>
            </a:r>
            <a:r>
              <a:rPr lang="nb-NO" sz="2000" dirty="0" err="1"/>
              <a:t>around</a:t>
            </a:r>
            <a:r>
              <a:rPr lang="nb-NO" sz="2000" dirty="0"/>
              <a:t> </a:t>
            </a:r>
            <a:r>
              <a:rPr lang="nb-NO" sz="2000" dirty="0" err="1"/>
              <a:t>each</a:t>
            </a:r>
            <a:r>
              <a:rPr lang="nb-NO" sz="2000" dirty="0"/>
              <a:t> pile </a:t>
            </a:r>
            <a:r>
              <a:rPr lang="nb-NO" sz="2000" dirty="0" err="1"/>
              <a:t>together</a:t>
            </a:r>
            <a:r>
              <a:rPr lang="nb-NO" sz="2000" dirty="0"/>
              <a:t> </a:t>
            </a:r>
            <a:r>
              <a:rPr lang="nb-NO" sz="2000" dirty="0" err="1"/>
              <a:t>with</a:t>
            </a:r>
            <a:r>
              <a:rPr lang="nb-NO" sz="2000" dirty="0"/>
              <a:t> </a:t>
            </a:r>
            <a:r>
              <a:rPr lang="nb-NO" sz="2000" dirty="0" err="1"/>
              <a:t>the</a:t>
            </a:r>
            <a:r>
              <a:rPr lang="nb-NO" sz="2000" dirty="0"/>
              <a:t> </a:t>
            </a:r>
            <a:r>
              <a:rPr lang="nb-NO" sz="2000" dirty="0" err="1"/>
              <a:t>post-it</a:t>
            </a:r>
            <a:r>
              <a:rPr lang="nb-NO" sz="2000" dirty="0"/>
              <a:t> </a:t>
            </a:r>
            <a:r>
              <a:rPr lang="nb-NO" sz="2000" dirty="0" err="1"/>
              <a:t>with</a:t>
            </a:r>
            <a:r>
              <a:rPr lang="nb-NO" sz="2000" dirty="0"/>
              <a:t> </a:t>
            </a:r>
            <a:r>
              <a:rPr lang="nb-NO" sz="2000" dirty="0" err="1"/>
              <a:t>its</a:t>
            </a:r>
            <a:r>
              <a:rPr lang="nb-NO" sz="2000" dirty="0"/>
              <a:t> </a:t>
            </a:r>
            <a:r>
              <a:rPr lang="nb-NO" sz="2000" dirty="0" err="1"/>
              <a:t>name</a:t>
            </a:r>
            <a:endParaRPr lang="nb-NO" sz="2000" dirty="0"/>
          </a:p>
        </p:txBody>
      </p:sp>
      <p:sp>
        <p:nvSpPr>
          <p:cNvPr id="7" name="Plassholder for innhold 6">
            <a:extLst>
              <a:ext uri="{FF2B5EF4-FFF2-40B4-BE49-F238E27FC236}">
                <a16:creationId xmlns:a16="http://schemas.microsoft.com/office/drawing/2014/main" id="{B63D18CD-5F46-4C31-AE1D-30A1E121463A}"/>
              </a:ext>
            </a:extLst>
          </p:cNvPr>
          <p:cNvSpPr>
            <a:spLocks noGrp="1"/>
          </p:cNvSpPr>
          <p:nvPr>
            <p:ph sz="half" idx="2"/>
          </p:nvPr>
        </p:nvSpPr>
        <p:spPr/>
        <p:txBody>
          <a:bodyPr/>
          <a:lstStyle/>
          <a:p>
            <a:pPr marL="457200" indent="-457200">
              <a:buFont typeface="+mj-lt"/>
              <a:buAutoNum type="arabicParenR" startAt="5"/>
            </a:pPr>
            <a:r>
              <a:rPr lang="nb-NO" sz="2000" dirty="0" err="1"/>
              <a:t>There</a:t>
            </a:r>
            <a:r>
              <a:rPr lang="nb-NO" sz="2000" dirty="0"/>
              <a:t> </a:t>
            </a:r>
            <a:r>
              <a:rPr lang="nb-NO" sz="2000" dirty="0" err="1"/>
              <a:t>are</a:t>
            </a:r>
            <a:r>
              <a:rPr lang="nb-NO" sz="2000" dirty="0"/>
              <a:t> </a:t>
            </a:r>
            <a:r>
              <a:rPr lang="nb-NO" sz="2000" dirty="0" err="1"/>
              <a:t>no</a:t>
            </a:r>
            <a:r>
              <a:rPr lang="nb-NO" sz="2000" dirty="0"/>
              <a:t> right or </a:t>
            </a:r>
            <a:r>
              <a:rPr lang="nb-NO" sz="2000" dirty="0" err="1"/>
              <a:t>wrong</a:t>
            </a:r>
            <a:r>
              <a:rPr lang="nb-NO" sz="2000" dirty="0"/>
              <a:t> </a:t>
            </a:r>
            <a:r>
              <a:rPr lang="nb-NO" sz="2000" dirty="0" err="1"/>
              <a:t>sortings</a:t>
            </a:r>
            <a:endParaRPr lang="nb-NO" sz="2000" dirty="0"/>
          </a:p>
          <a:p>
            <a:pPr marL="457200" indent="-457200">
              <a:buFont typeface="+mj-lt"/>
              <a:buAutoNum type="arabicParenR" startAt="5"/>
            </a:pPr>
            <a:r>
              <a:rPr lang="nb-NO" sz="2000" dirty="0"/>
              <a:t>Make as </a:t>
            </a:r>
            <a:r>
              <a:rPr lang="nb-NO" sz="2000" dirty="0" err="1"/>
              <a:t>many</a:t>
            </a:r>
            <a:r>
              <a:rPr lang="nb-NO" sz="2000" dirty="0"/>
              <a:t> piles as </a:t>
            </a:r>
            <a:r>
              <a:rPr lang="nb-NO" sz="2000" dirty="0" err="1"/>
              <a:t>you</a:t>
            </a:r>
            <a:r>
              <a:rPr lang="nb-NO" sz="2000" dirty="0"/>
              <a:t> </a:t>
            </a:r>
            <a:r>
              <a:rPr lang="nb-NO" sz="2000" dirty="0" err="1"/>
              <a:t>want</a:t>
            </a:r>
            <a:r>
              <a:rPr lang="nb-NO" sz="2000" dirty="0"/>
              <a:t>, </a:t>
            </a:r>
            <a:r>
              <a:rPr lang="nb-NO" sz="2000" dirty="0" err="1"/>
              <a:t>but</a:t>
            </a:r>
            <a:r>
              <a:rPr lang="nb-NO" sz="2000" dirty="0"/>
              <a:t> </a:t>
            </a:r>
            <a:r>
              <a:rPr lang="nb-NO" sz="2000" dirty="0" err="1"/>
              <a:t>you</a:t>
            </a:r>
            <a:r>
              <a:rPr lang="nb-NO" sz="2000" dirty="0"/>
              <a:t> </a:t>
            </a:r>
            <a:r>
              <a:rPr lang="nb-NO" sz="2000" dirty="0" err="1"/>
              <a:t>cannot</a:t>
            </a:r>
            <a:r>
              <a:rPr lang="nb-NO" sz="2000" dirty="0"/>
              <a:t> </a:t>
            </a:r>
            <a:r>
              <a:rPr lang="nb-NO" sz="2000" dirty="0" err="1"/>
              <a:t>place</a:t>
            </a:r>
            <a:r>
              <a:rPr lang="nb-NO" sz="2000" dirty="0"/>
              <a:t> all </a:t>
            </a:r>
            <a:r>
              <a:rPr lang="nb-NO" sz="2000" dirty="0" err="1"/>
              <a:t>cards</a:t>
            </a:r>
            <a:r>
              <a:rPr lang="nb-NO" sz="2000" dirty="0"/>
              <a:t> </a:t>
            </a:r>
            <a:r>
              <a:rPr lang="nb-NO" sz="2000" dirty="0" err="1"/>
              <a:t>into</a:t>
            </a:r>
            <a:r>
              <a:rPr lang="nb-NO" sz="2000" dirty="0"/>
              <a:t> </a:t>
            </a:r>
            <a:r>
              <a:rPr lang="nb-NO" sz="2000" dirty="0" err="1"/>
              <a:t>one</a:t>
            </a:r>
            <a:r>
              <a:rPr lang="nb-NO" sz="2000" dirty="0"/>
              <a:t> pile or let </a:t>
            </a:r>
            <a:r>
              <a:rPr lang="nb-NO" sz="2000" dirty="0" err="1"/>
              <a:t>each</a:t>
            </a:r>
            <a:r>
              <a:rPr lang="nb-NO" sz="2000" dirty="0"/>
              <a:t> </a:t>
            </a:r>
            <a:r>
              <a:rPr lang="nb-NO" sz="2000" dirty="0" err="1"/>
              <a:t>card</a:t>
            </a:r>
            <a:r>
              <a:rPr lang="nb-NO" sz="2000" dirty="0"/>
              <a:t> be </a:t>
            </a:r>
            <a:r>
              <a:rPr lang="nb-NO" sz="2000" dirty="0" err="1"/>
              <a:t>its</a:t>
            </a:r>
            <a:r>
              <a:rPr lang="nb-NO" sz="2000" dirty="0"/>
              <a:t> </a:t>
            </a:r>
            <a:r>
              <a:rPr lang="nb-NO" sz="2000" dirty="0" err="1"/>
              <a:t>own</a:t>
            </a:r>
            <a:r>
              <a:rPr lang="nb-NO" sz="2000" dirty="0"/>
              <a:t> pile</a:t>
            </a:r>
          </a:p>
          <a:p>
            <a:pPr marL="457200" indent="-457200">
              <a:buFont typeface="+mj-lt"/>
              <a:buAutoNum type="arabicParenR" startAt="5"/>
            </a:pPr>
            <a:r>
              <a:rPr lang="nb-NO" sz="2000" dirty="0"/>
              <a:t>All </a:t>
            </a:r>
            <a:r>
              <a:rPr lang="nb-NO" sz="2000" dirty="0" err="1"/>
              <a:t>cards</a:t>
            </a:r>
            <a:r>
              <a:rPr lang="nb-NO" sz="2000" dirty="0"/>
              <a:t> must be </a:t>
            </a:r>
            <a:r>
              <a:rPr lang="nb-NO" sz="2000" dirty="0" err="1"/>
              <a:t>placed</a:t>
            </a:r>
            <a:r>
              <a:rPr lang="nb-NO" sz="2000" dirty="0"/>
              <a:t> </a:t>
            </a:r>
            <a:r>
              <a:rPr lang="nb-NO" sz="2000" dirty="0" err="1"/>
              <a:t>into</a:t>
            </a:r>
            <a:r>
              <a:rPr lang="nb-NO" sz="2000" dirty="0"/>
              <a:t> </a:t>
            </a:r>
            <a:r>
              <a:rPr lang="nb-NO" sz="2000" dirty="0" err="1"/>
              <a:t>one</a:t>
            </a:r>
            <a:r>
              <a:rPr lang="nb-NO" sz="2000" dirty="0"/>
              <a:t> </a:t>
            </a:r>
            <a:r>
              <a:rPr lang="nb-NO" sz="2000" dirty="0" err="1"/>
              <a:t>of</a:t>
            </a:r>
            <a:r>
              <a:rPr lang="nb-NO" sz="2000" dirty="0"/>
              <a:t> </a:t>
            </a:r>
            <a:r>
              <a:rPr lang="nb-NO" sz="2000" dirty="0" err="1"/>
              <a:t>the</a:t>
            </a:r>
            <a:r>
              <a:rPr lang="nb-NO" sz="2000" dirty="0"/>
              <a:t> piles. It is not </a:t>
            </a:r>
            <a:r>
              <a:rPr lang="nb-NO" sz="2000" dirty="0" err="1"/>
              <a:t>allowed</a:t>
            </a:r>
            <a:r>
              <a:rPr lang="nb-NO" sz="2000" dirty="0"/>
              <a:t> to </a:t>
            </a:r>
            <a:r>
              <a:rPr lang="nb-NO" sz="2000" dirty="0" err="1"/>
              <a:t>create</a:t>
            </a:r>
            <a:r>
              <a:rPr lang="nb-NO" sz="2000" dirty="0"/>
              <a:t> a «</a:t>
            </a:r>
            <a:r>
              <a:rPr lang="nb-NO" sz="2000" dirty="0" err="1"/>
              <a:t>miscellaneous</a:t>
            </a:r>
            <a:r>
              <a:rPr lang="nb-NO" sz="2000" dirty="0"/>
              <a:t>» pile</a:t>
            </a:r>
          </a:p>
        </p:txBody>
      </p:sp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1E7E68CE-BFFB-4706-B661-36E4AE0D68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BC5DA-09B7-4CD9-B21E-157BBBE69313}" type="slidenum">
              <a:rPr lang="en-US" smtClean="0"/>
              <a:pPr/>
              <a:t>5</a:t>
            </a:fld>
            <a:endParaRPr lang="en-US" dirty="0"/>
          </a:p>
        </p:txBody>
      </p:sp>
      <p:sp>
        <p:nvSpPr>
          <p:cNvPr id="5" name="Tittel 4">
            <a:extLst>
              <a:ext uri="{FF2B5EF4-FFF2-40B4-BE49-F238E27FC236}">
                <a16:creationId xmlns:a16="http://schemas.microsoft.com/office/drawing/2014/main" id="{58F7FC86-8252-4795-81CA-4AF5F04D50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dirty="0" err="1"/>
              <a:t>Instructions</a:t>
            </a:r>
            <a:r>
              <a:rPr lang="nb-NO" dirty="0"/>
              <a:t> for </a:t>
            </a:r>
            <a:r>
              <a:rPr lang="nb-NO" dirty="0" err="1"/>
              <a:t>card</a:t>
            </a:r>
            <a:r>
              <a:rPr lang="nb-NO" dirty="0"/>
              <a:t> </a:t>
            </a:r>
            <a:r>
              <a:rPr lang="nb-NO" dirty="0" err="1"/>
              <a:t>sorting</a:t>
            </a:r>
            <a:r>
              <a:rPr lang="nb-NO" dirty="0"/>
              <a:t> </a:t>
            </a:r>
            <a:r>
              <a:rPr lang="nb-NO" dirty="0" err="1"/>
              <a:t>task</a:t>
            </a:r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3714243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Undertittel 1">
            <a:extLst>
              <a:ext uri="{FF2B5EF4-FFF2-40B4-BE49-F238E27FC236}">
                <a16:creationId xmlns:a16="http://schemas.microsoft.com/office/drawing/2014/main" id="{57028FFE-B7DF-45BD-9B6E-7BDCF48EE222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Tittel 4">
            <a:extLst>
              <a:ext uri="{FF2B5EF4-FFF2-40B4-BE49-F238E27FC236}">
                <a16:creationId xmlns:a16="http://schemas.microsoft.com/office/drawing/2014/main" id="{AE2D6C44-0600-4569-B047-9F6660F28FB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nb-NO" dirty="0" err="1"/>
              <a:t>Rating</a:t>
            </a:r>
            <a:endParaRPr lang="nb-NO" dirty="0"/>
          </a:p>
        </p:txBody>
      </p:sp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03AF29A7-5751-2041-B29B-827CA14C98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7274F-C966-8C46-AFC4-F3A14ECF3B01}" type="slidenum">
              <a:rPr lang="nb-NO" smtClean="0"/>
              <a:t>6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94048142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6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innhold 1">
            <a:extLst>
              <a:ext uri="{FF2B5EF4-FFF2-40B4-BE49-F238E27FC236}">
                <a16:creationId xmlns:a16="http://schemas.microsoft.com/office/drawing/2014/main" id="{5D2046FD-E210-44A5-B8B2-275A659FB3A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42125" y="1648800"/>
            <a:ext cx="3648181" cy="4352400"/>
          </a:xfrm>
        </p:spPr>
        <p:txBody>
          <a:bodyPr/>
          <a:lstStyle/>
          <a:p>
            <a:r>
              <a:rPr lang="nb-NO" dirty="0" err="1"/>
              <a:t>Take</a:t>
            </a:r>
            <a:r>
              <a:rPr lang="nb-NO" dirty="0"/>
              <a:t> </a:t>
            </a:r>
            <a:r>
              <a:rPr lang="nb-NO" dirty="0" err="1"/>
              <a:t>out</a:t>
            </a:r>
            <a:r>
              <a:rPr lang="nb-NO" dirty="0"/>
              <a:t> </a:t>
            </a:r>
            <a:r>
              <a:rPr lang="nb-NO" dirty="0" err="1"/>
              <a:t>one</a:t>
            </a:r>
            <a:r>
              <a:rPr lang="nb-NO" dirty="0"/>
              <a:t> pile at a time</a:t>
            </a:r>
          </a:p>
          <a:p>
            <a:r>
              <a:rPr lang="nb-NO" dirty="0" err="1"/>
              <a:t>Take</a:t>
            </a:r>
            <a:r>
              <a:rPr lang="nb-NO" dirty="0"/>
              <a:t> </a:t>
            </a:r>
            <a:r>
              <a:rPr lang="nb-NO" dirty="0" err="1"/>
              <a:t>off</a:t>
            </a:r>
            <a:r>
              <a:rPr lang="nb-NO" dirty="0"/>
              <a:t> </a:t>
            </a:r>
            <a:r>
              <a:rPr lang="nb-NO" dirty="0" err="1"/>
              <a:t>the</a:t>
            </a:r>
            <a:r>
              <a:rPr lang="nb-NO" dirty="0"/>
              <a:t> rubber band and </a:t>
            </a:r>
            <a:r>
              <a:rPr lang="nb-NO" dirty="0" err="1"/>
              <a:t>read</a:t>
            </a:r>
            <a:r>
              <a:rPr lang="nb-NO" dirty="0"/>
              <a:t> </a:t>
            </a:r>
            <a:r>
              <a:rPr lang="nb-NO" dirty="0" err="1"/>
              <a:t>each</a:t>
            </a:r>
            <a:r>
              <a:rPr lang="nb-NO" dirty="0"/>
              <a:t> </a:t>
            </a:r>
            <a:r>
              <a:rPr lang="nb-NO" dirty="0" err="1"/>
              <a:t>card</a:t>
            </a:r>
            <a:r>
              <a:rPr lang="nb-NO" dirty="0"/>
              <a:t> in </a:t>
            </a:r>
            <a:r>
              <a:rPr lang="nb-NO" dirty="0" err="1"/>
              <a:t>the</a:t>
            </a:r>
            <a:r>
              <a:rPr lang="nb-NO" dirty="0"/>
              <a:t> pile</a:t>
            </a:r>
          </a:p>
          <a:p>
            <a:r>
              <a:rPr lang="nb-NO" dirty="0" err="1"/>
              <a:t>Evaluate</a:t>
            </a:r>
            <a:r>
              <a:rPr lang="nb-NO" dirty="0"/>
              <a:t> </a:t>
            </a:r>
            <a:r>
              <a:rPr lang="nb-NO" dirty="0" err="1"/>
              <a:t>each</a:t>
            </a:r>
            <a:r>
              <a:rPr lang="nb-NO" dirty="0"/>
              <a:t> </a:t>
            </a:r>
            <a:r>
              <a:rPr lang="nb-NO" dirty="0" err="1"/>
              <a:t>of</a:t>
            </a:r>
            <a:r>
              <a:rPr lang="nb-NO" dirty="0"/>
              <a:t> </a:t>
            </a:r>
            <a:r>
              <a:rPr lang="nb-NO" dirty="0" err="1"/>
              <a:t>the</a:t>
            </a:r>
            <a:r>
              <a:rPr lang="nb-NO" dirty="0"/>
              <a:t> </a:t>
            </a:r>
            <a:r>
              <a:rPr lang="nb-NO" dirty="0" err="1"/>
              <a:t>strategies</a:t>
            </a:r>
            <a:r>
              <a:rPr lang="nb-NO" dirty="0"/>
              <a:t> in terms </a:t>
            </a:r>
            <a:r>
              <a:rPr lang="nb-NO" dirty="0" err="1"/>
              <a:t>of</a:t>
            </a:r>
            <a:r>
              <a:rPr lang="nb-NO" dirty="0"/>
              <a:t> </a:t>
            </a:r>
            <a:r>
              <a:rPr lang="nb-NO" dirty="0" err="1"/>
              <a:t>their</a:t>
            </a:r>
            <a:r>
              <a:rPr lang="nb-NO" dirty="0"/>
              <a:t> </a:t>
            </a:r>
            <a:r>
              <a:rPr lang="nb-NO" dirty="0" err="1"/>
              <a:t>importance</a:t>
            </a:r>
            <a:r>
              <a:rPr lang="nb-NO" dirty="0"/>
              <a:t> and </a:t>
            </a:r>
            <a:r>
              <a:rPr lang="nb-NO" dirty="0" err="1"/>
              <a:t>feasibility</a:t>
            </a:r>
            <a:r>
              <a:rPr lang="nb-NO" dirty="0"/>
              <a:t> for </a:t>
            </a:r>
            <a:r>
              <a:rPr lang="nb-NO" dirty="0" err="1"/>
              <a:t>implementation</a:t>
            </a:r>
            <a:r>
              <a:rPr lang="nb-NO" dirty="0"/>
              <a:t> at </a:t>
            </a:r>
            <a:r>
              <a:rPr lang="nb-NO" dirty="0" err="1"/>
              <a:t>your</a:t>
            </a:r>
            <a:r>
              <a:rPr lang="nb-NO" dirty="0"/>
              <a:t> </a:t>
            </a:r>
            <a:r>
              <a:rPr lang="nb-NO" dirty="0" err="1"/>
              <a:t>workplace</a:t>
            </a:r>
            <a:endParaRPr lang="nb-NO" sz="1200" dirty="0"/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9BC388C2-48F9-4E4C-9ED5-378D431BF4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288926" y="1648800"/>
            <a:ext cx="3648181" cy="4351338"/>
          </a:xfrm>
        </p:spPr>
        <p:txBody>
          <a:bodyPr/>
          <a:lstStyle/>
          <a:p>
            <a:r>
              <a:rPr lang="nb-NO" dirty="0"/>
              <a:t>Rate </a:t>
            </a:r>
            <a:r>
              <a:rPr lang="nb-NO" dirty="0" err="1"/>
              <a:t>each</a:t>
            </a:r>
            <a:r>
              <a:rPr lang="nb-NO" dirty="0"/>
              <a:t> </a:t>
            </a:r>
            <a:r>
              <a:rPr lang="nb-NO" dirty="0" err="1"/>
              <a:t>strategy</a:t>
            </a:r>
            <a:r>
              <a:rPr lang="nb-NO" dirty="0"/>
              <a:t> </a:t>
            </a:r>
            <a:r>
              <a:rPr lang="nb-NO" dirty="0" err="1"/>
              <a:t>on</a:t>
            </a:r>
            <a:r>
              <a:rPr lang="nb-NO" dirty="0"/>
              <a:t> a </a:t>
            </a:r>
            <a:r>
              <a:rPr lang="nb-NO" dirty="0" err="1"/>
              <a:t>scale</a:t>
            </a:r>
            <a:r>
              <a:rPr lang="nb-NO" dirty="0"/>
              <a:t> from 1 to 5 </a:t>
            </a:r>
            <a:r>
              <a:rPr lang="nb-NO" dirty="0" err="1"/>
              <a:t>where</a:t>
            </a:r>
            <a:r>
              <a:rPr lang="nb-NO" dirty="0"/>
              <a:t> 1 = </a:t>
            </a:r>
            <a:r>
              <a:rPr lang="nb-NO" dirty="0" err="1"/>
              <a:t>Relatively</a:t>
            </a:r>
            <a:r>
              <a:rPr lang="nb-NO" dirty="0"/>
              <a:t> </a:t>
            </a:r>
            <a:r>
              <a:rPr lang="nb-NO" dirty="0" err="1"/>
              <a:t>unimportant</a:t>
            </a:r>
            <a:r>
              <a:rPr lang="nb-NO" dirty="0"/>
              <a:t> and 5 = </a:t>
            </a:r>
            <a:r>
              <a:rPr lang="nb-NO" dirty="0" err="1"/>
              <a:t>Extremely</a:t>
            </a:r>
            <a:r>
              <a:rPr lang="nb-NO" dirty="0"/>
              <a:t> </a:t>
            </a:r>
            <a:r>
              <a:rPr lang="nb-NO" dirty="0" err="1"/>
              <a:t>important</a:t>
            </a:r>
            <a:endParaRPr lang="nb-NO" dirty="0"/>
          </a:p>
          <a:p>
            <a:r>
              <a:rPr lang="nb-NO" dirty="0"/>
              <a:t>Rate </a:t>
            </a:r>
            <a:r>
              <a:rPr lang="nb-NO" dirty="0" err="1"/>
              <a:t>each</a:t>
            </a:r>
            <a:r>
              <a:rPr lang="nb-NO" dirty="0"/>
              <a:t> </a:t>
            </a:r>
            <a:r>
              <a:rPr lang="nb-NO" dirty="0" err="1"/>
              <a:t>strategy</a:t>
            </a:r>
            <a:r>
              <a:rPr lang="nb-NO" dirty="0"/>
              <a:t> </a:t>
            </a:r>
            <a:r>
              <a:rPr lang="nb-NO" dirty="0" err="1"/>
              <a:t>on</a:t>
            </a:r>
            <a:r>
              <a:rPr lang="nb-NO" dirty="0"/>
              <a:t> a </a:t>
            </a:r>
            <a:r>
              <a:rPr lang="nb-NO" dirty="0" err="1"/>
              <a:t>scale</a:t>
            </a:r>
            <a:r>
              <a:rPr lang="nb-NO" dirty="0"/>
              <a:t> from 1 to 5 </a:t>
            </a:r>
            <a:r>
              <a:rPr lang="nb-NO" dirty="0" err="1"/>
              <a:t>where</a:t>
            </a:r>
            <a:r>
              <a:rPr lang="nb-NO" dirty="0"/>
              <a:t> 1 = Not at all </a:t>
            </a:r>
            <a:r>
              <a:rPr lang="nb-NO" dirty="0" err="1"/>
              <a:t>feasible</a:t>
            </a:r>
            <a:r>
              <a:rPr lang="nb-NO" dirty="0"/>
              <a:t> to 5 = </a:t>
            </a:r>
            <a:r>
              <a:rPr lang="nb-NO" dirty="0" err="1"/>
              <a:t>Extremely</a:t>
            </a:r>
            <a:r>
              <a:rPr lang="nb-NO" dirty="0"/>
              <a:t> </a:t>
            </a:r>
            <a:r>
              <a:rPr lang="nb-NO" dirty="0" err="1"/>
              <a:t>feasible</a:t>
            </a:r>
            <a:endParaRPr lang="nb-NO" dirty="0"/>
          </a:p>
        </p:txBody>
      </p:sp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3323A835-EE8A-4FA2-9BD5-EBD7EC96CF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7274F-C966-8C46-AFC4-F3A14ECF3B01}" type="slidenum">
              <a:rPr lang="nb-NO" smtClean="0"/>
              <a:t>7</a:t>
            </a:fld>
            <a:endParaRPr lang="nb-NO"/>
          </a:p>
        </p:txBody>
      </p:sp>
      <p:sp>
        <p:nvSpPr>
          <p:cNvPr id="5" name="Tittel 4">
            <a:extLst>
              <a:ext uri="{FF2B5EF4-FFF2-40B4-BE49-F238E27FC236}">
                <a16:creationId xmlns:a16="http://schemas.microsoft.com/office/drawing/2014/main" id="{7AA29B48-AFBC-48A1-9CD3-A12E199B02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dirty="0" err="1"/>
              <a:t>Instructions</a:t>
            </a:r>
            <a:r>
              <a:rPr lang="nb-NO" dirty="0"/>
              <a:t> for </a:t>
            </a:r>
            <a:r>
              <a:rPr lang="nb-NO" dirty="0" err="1"/>
              <a:t>rating</a:t>
            </a:r>
            <a:r>
              <a:rPr lang="nb-NO" dirty="0"/>
              <a:t> statements</a:t>
            </a:r>
          </a:p>
        </p:txBody>
      </p:sp>
      <p:sp>
        <p:nvSpPr>
          <p:cNvPr id="6" name="Plassholder for innhold 5">
            <a:extLst>
              <a:ext uri="{FF2B5EF4-FFF2-40B4-BE49-F238E27FC236}">
                <a16:creationId xmlns:a16="http://schemas.microsoft.com/office/drawing/2014/main" id="{5200C0C5-2C47-410F-9F91-8F9699BEAD01}"/>
              </a:ext>
            </a:extLst>
          </p:cNvPr>
          <p:cNvSpPr>
            <a:spLocks noGrp="1"/>
          </p:cNvSpPr>
          <p:nvPr>
            <p:ph sz="half" idx="13"/>
          </p:nvPr>
        </p:nvSpPr>
        <p:spPr>
          <a:xfrm>
            <a:off x="7935726" y="1648800"/>
            <a:ext cx="3648181" cy="4351338"/>
          </a:xfrm>
        </p:spPr>
        <p:txBody>
          <a:bodyPr/>
          <a:lstStyle/>
          <a:p>
            <a:r>
              <a:rPr lang="nb-NO" dirty="0" err="1"/>
              <a:t>Spread</a:t>
            </a:r>
            <a:r>
              <a:rPr lang="nb-NO" dirty="0"/>
              <a:t> </a:t>
            </a:r>
            <a:r>
              <a:rPr lang="nb-NO" dirty="0" err="1"/>
              <a:t>your</a:t>
            </a:r>
            <a:r>
              <a:rPr lang="nb-NO" dirty="0"/>
              <a:t> </a:t>
            </a:r>
            <a:r>
              <a:rPr lang="nb-NO" dirty="0" err="1"/>
              <a:t>ratings</a:t>
            </a:r>
            <a:r>
              <a:rPr lang="nb-NO" dirty="0"/>
              <a:t>; </a:t>
            </a:r>
            <a:r>
              <a:rPr lang="nb-NO" dirty="0" err="1"/>
              <a:t>use</a:t>
            </a:r>
            <a:r>
              <a:rPr lang="nb-NO" dirty="0"/>
              <a:t> all </a:t>
            </a:r>
            <a:r>
              <a:rPr lang="nb-NO" dirty="0" err="1"/>
              <a:t>of</a:t>
            </a:r>
            <a:r>
              <a:rPr lang="nb-NO" dirty="0"/>
              <a:t> </a:t>
            </a:r>
            <a:r>
              <a:rPr lang="nb-NO" dirty="0" err="1"/>
              <a:t>the</a:t>
            </a:r>
            <a:r>
              <a:rPr lang="nb-NO" dirty="0"/>
              <a:t> </a:t>
            </a:r>
            <a:r>
              <a:rPr lang="nb-NO" dirty="0" err="1"/>
              <a:t>values</a:t>
            </a:r>
            <a:r>
              <a:rPr lang="nb-NO" dirty="0"/>
              <a:t> at </a:t>
            </a:r>
            <a:r>
              <a:rPr lang="nb-NO" dirty="0" err="1"/>
              <a:t>least</a:t>
            </a:r>
            <a:r>
              <a:rPr lang="nb-NO" dirty="0"/>
              <a:t> </a:t>
            </a:r>
            <a:r>
              <a:rPr lang="nb-NO" dirty="0" err="1"/>
              <a:t>once</a:t>
            </a:r>
            <a:r>
              <a:rPr lang="nb-NO" dirty="0"/>
              <a:t> for </a:t>
            </a:r>
            <a:r>
              <a:rPr lang="nb-NO" dirty="0" err="1"/>
              <a:t>each</a:t>
            </a:r>
            <a:r>
              <a:rPr lang="nb-NO" dirty="0"/>
              <a:t> </a:t>
            </a:r>
            <a:r>
              <a:rPr lang="nb-NO" dirty="0" err="1"/>
              <a:t>of</a:t>
            </a:r>
            <a:r>
              <a:rPr lang="nb-NO" dirty="0"/>
              <a:t> </a:t>
            </a:r>
            <a:r>
              <a:rPr lang="nb-NO" dirty="0" err="1"/>
              <a:t>the</a:t>
            </a:r>
            <a:r>
              <a:rPr lang="nb-NO" dirty="0"/>
              <a:t> </a:t>
            </a:r>
            <a:r>
              <a:rPr lang="nb-NO" dirty="0" err="1"/>
              <a:t>rating</a:t>
            </a:r>
            <a:r>
              <a:rPr lang="nb-NO" dirty="0"/>
              <a:t> </a:t>
            </a:r>
            <a:r>
              <a:rPr lang="nb-NO" dirty="0" err="1"/>
              <a:t>scales</a:t>
            </a:r>
            <a:endParaRPr lang="nb-NO" dirty="0"/>
          </a:p>
          <a:p>
            <a:r>
              <a:rPr lang="nb-NO" dirty="0" err="1"/>
              <a:t>When</a:t>
            </a:r>
            <a:r>
              <a:rPr lang="nb-NO" dirty="0"/>
              <a:t> </a:t>
            </a:r>
            <a:r>
              <a:rPr lang="nb-NO" dirty="0" err="1"/>
              <a:t>you’re</a:t>
            </a:r>
            <a:r>
              <a:rPr lang="nb-NO" dirty="0"/>
              <a:t> done, </a:t>
            </a:r>
            <a:r>
              <a:rPr lang="nb-NO" dirty="0" err="1"/>
              <a:t>wrap</a:t>
            </a:r>
            <a:r>
              <a:rPr lang="nb-NO" dirty="0"/>
              <a:t> a rubber band </a:t>
            </a:r>
            <a:r>
              <a:rPr lang="nb-NO" dirty="0" err="1"/>
              <a:t>around</a:t>
            </a:r>
            <a:r>
              <a:rPr lang="nb-NO" dirty="0"/>
              <a:t> </a:t>
            </a:r>
            <a:r>
              <a:rPr lang="nb-NO" dirty="0" err="1"/>
              <a:t>the</a:t>
            </a:r>
            <a:r>
              <a:rPr lang="nb-NO" dirty="0"/>
              <a:t> pile and rate </a:t>
            </a:r>
            <a:r>
              <a:rPr lang="nb-NO" dirty="0" err="1"/>
              <a:t>the</a:t>
            </a:r>
            <a:r>
              <a:rPr lang="nb-NO" dirty="0"/>
              <a:t> </a:t>
            </a:r>
            <a:r>
              <a:rPr lang="nb-NO" dirty="0" err="1"/>
              <a:t>next</a:t>
            </a:r>
            <a:endParaRPr lang="nb-NO" dirty="0"/>
          </a:p>
          <a:p>
            <a:r>
              <a:rPr lang="nb-NO" dirty="0"/>
              <a:t>Place </a:t>
            </a:r>
            <a:r>
              <a:rPr lang="nb-NO" dirty="0" err="1"/>
              <a:t>each</a:t>
            </a:r>
            <a:r>
              <a:rPr lang="nb-NO" dirty="0"/>
              <a:t> pile in a separate </a:t>
            </a:r>
            <a:r>
              <a:rPr lang="nb-NO" dirty="0" err="1"/>
              <a:t>zipped</a:t>
            </a:r>
            <a:r>
              <a:rPr lang="nb-NO" dirty="0"/>
              <a:t> bag</a:t>
            </a:r>
          </a:p>
          <a:p>
            <a:r>
              <a:rPr lang="nb-NO" dirty="0" err="1"/>
              <a:t>Put</a:t>
            </a:r>
            <a:r>
              <a:rPr lang="nb-NO" dirty="0"/>
              <a:t> </a:t>
            </a:r>
            <a:r>
              <a:rPr lang="nb-NO" dirty="0" err="1"/>
              <a:t>the</a:t>
            </a:r>
            <a:r>
              <a:rPr lang="nb-NO" dirty="0"/>
              <a:t> </a:t>
            </a:r>
            <a:r>
              <a:rPr lang="nb-NO" dirty="0" err="1"/>
              <a:t>zipped</a:t>
            </a:r>
            <a:r>
              <a:rPr lang="nb-NO" dirty="0"/>
              <a:t> bags in </a:t>
            </a:r>
            <a:r>
              <a:rPr lang="nb-NO" dirty="0" err="1"/>
              <a:t>the</a:t>
            </a:r>
            <a:r>
              <a:rPr lang="nb-NO" dirty="0"/>
              <a:t> </a:t>
            </a:r>
            <a:r>
              <a:rPr lang="nb-NO" dirty="0" err="1"/>
              <a:t>large</a:t>
            </a:r>
            <a:r>
              <a:rPr lang="nb-NO" dirty="0"/>
              <a:t> </a:t>
            </a:r>
            <a:r>
              <a:rPr lang="nb-NO" dirty="0" err="1"/>
              <a:t>zipped</a:t>
            </a:r>
            <a:r>
              <a:rPr lang="nb-NO" dirty="0"/>
              <a:t> bag («bags-in-bag»)</a:t>
            </a:r>
          </a:p>
          <a:p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202542154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Undertittel 1">
            <a:extLst>
              <a:ext uri="{FF2B5EF4-FFF2-40B4-BE49-F238E27FC236}">
                <a16:creationId xmlns:a16="http://schemas.microsoft.com/office/drawing/2014/main" id="{C9E8D2D5-ED41-424C-8996-468AC4AA8EB7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Tittel 4">
            <a:extLst>
              <a:ext uri="{FF2B5EF4-FFF2-40B4-BE49-F238E27FC236}">
                <a16:creationId xmlns:a16="http://schemas.microsoft.com/office/drawing/2014/main" id="{AE2D6C44-0600-4569-B047-9F6660F28FB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nb-NO" dirty="0"/>
              <a:t>Brainstorming</a:t>
            </a:r>
          </a:p>
        </p:txBody>
      </p:sp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03AF29A7-5751-2041-B29B-827CA14C98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7274F-C966-8C46-AFC4-F3A14ECF3B01}" type="slidenum">
              <a:rPr lang="nb-NO" smtClean="0"/>
              <a:t>8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08701430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FC2FDF97-C995-4369-AD52-1B07420DE6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7274F-C966-8C46-AFC4-F3A14ECF3B01}" type="slidenum">
              <a:rPr lang="nb-NO" smtClean="0"/>
              <a:t>9</a:t>
            </a:fld>
            <a:endParaRPr lang="nb-NO"/>
          </a:p>
        </p:txBody>
      </p:sp>
      <p:grpSp>
        <p:nvGrpSpPr>
          <p:cNvPr id="10" name="Gruppe 9">
            <a:extLst>
              <a:ext uri="{FF2B5EF4-FFF2-40B4-BE49-F238E27FC236}">
                <a16:creationId xmlns:a16="http://schemas.microsoft.com/office/drawing/2014/main" id="{7F6A9326-EB71-42AE-A844-315B036EF7DF}"/>
              </a:ext>
            </a:extLst>
          </p:cNvPr>
          <p:cNvGrpSpPr/>
          <p:nvPr/>
        </p:nvGrpSpPr>
        <p:grpSpPr>
          <a:xfrm>
            <a:off x="396023" y="393704"/>
            <a:ext cx="833492" cy="177295"/>
            <a:chOff x="396023" y="393704"/>
            <a:chExt cx="833492" cy="177295"/>
          </a:xfrm>
        </p:grpSpPr>
        <p:sp>
          <p:nvSpPr>
            <p:cNvPr id="11" name="Friform 6">
              <a:extLst>
                <a:ext uri="{FF2B5EF4-FFF2-40B4-BE49-F238E27FC236}">
                  <a16:creationId xmlns:a16="http://schemas.microsoft.com/office/drawing/2014/main" id="{D190F5B5-D06A-4992-9FDC-98B8B1A56B35}"/>
                </a:ext>
              </a:extLst>
            </p:cNvPr>
            <p:cNvSpPr/>
            <p:nvPr/>
          </p:nvSpPr>
          <p:spPr>
            <a:xfrm>
              <a:off x="936121" y="394334"/>
              <a:ext cx="135024" cy="176665"/>
            </a:xfrm>
            <a:custGeom>
              <a:avLst/>
              <a:gdLst>
                <a:gd name="connsiteX0" fmla="*/ 108524 w 135024"/>
                <a:gd name="connsiteY0" fmla="*/ 0 h 176665"/>
                <a:gd name="connsiteX1" fmla="*/ 108524 w 135024"/>
                <a:gd name="connsiteY1" fmla="*/ 109154 h 176665"/>
                <a:gd name="connsiteX2" fmla="*/ 96536 w 135024"/>
                <a:gd name="connsiteY2" fmla="*/ 138808 h 176665"/>
                <a:gd name="connsiteX3" fmla="*/ 66881 w 135024"/>
                <a:gd name="connsiteY3" fmla="*/ 150796 h 176665"/>
                <a:gd name="connsiteX4" fmla="*/ 37226 w 135024"/>
                <a:gd name="connsiteY4" fmla="*/ 138808 h 176665"/>
                <a:gd name="connsiteX5" fmla="*/ 25238 w 135024"/>
                <a:gd name="connsiteY5" fmla="*/ 109154 h 176665"/>
                <a:gd name="connsiteX6" fmla="*/ 25238 w 135024"/>
                <a:gd name="connsiteY6" fmla="*/ 0 h 176665"/>
                <a:gd name="connsiteX7" fmla="*/ 0 w 135024"/>
                <a:gd name="connsiteY7" fmla="*/ 0 h 176665"/>
                <a:gd name="connsiteX8" fmla="*/ 0 w 135024"/>
                <a:gd name="connsiteY8" fmla="*/ 109154 h 176665"/>
                <a:gd name="connsiteX9" fmla="*/ 5048 w 135024"/>
                <a:gd name="connsiteY9" fmla="*/ 135023 h 176665"/>
                <a:gd name="connsiteX10" fmla="*/ 19560 w 135024"/>
                <a:gd name="connsiteY10" fmla="*/ 157106 h 176665"/>
                <a:gd name="connsiteX11" fmla="*/ 41643 w 135024"/>
                <a:gd name="connsiteY11" fmla="*/ 171617 h 176665"/>
                <a:gd name="connsiteX12" fmla="*/ 67512 w 135024"/>
                <a:gd name="connsiteY12" fmla="*/ 176665 h 176665"/>
                <a:gd name="connsiteX13" fmla="*/ 93382 w 135024"/>
                <a:gd name="connsiteY13" fmla="*/ 171617 h 176665"/>
                <a:gd name="connsiteX14" fmla="*/ 115465 w 135024"/>
                <a:gd name="connsiteY14" fmla="*/ 157106 h 176665"/>
                <a:gd name="connsiteX15" fmla="*/ 129977 w 135024"/>
                <a:gd name="connsiteY15" fmla="*/ 135023 h 176665"/>
                <a:gd name="connsiteX16" fmla="*/ 135025 w 135024"/>
                <a:gd name="connsiteY16" fmla="*/ 109154 h 176665"/>
                <a:gd name="connsiteX17" fmla="*/ 135025 w 135024"/>
                <a:gd name="connsiteY17" fmla="*/ 0 h 176665"/>
                <a:gd name="connsiteX18" fmla="*/ 108524 w 135024"/>
                <a:gd name="connsiteY18" fmla="*/ 0 h 1766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</a:cxnLst>
              <a:rect l="l" t="t" r="r" b="b"/>
              <a:pathLst>
                <a:path w="135024" h="176665">
                  <a:moveTo>
                    <a:pt x="108524" y="0"/>
                  </a:moveTo>
                  <a:lnTo>
                    <a:pt x="108524" y="109154"/>
                  </a:lnTo>
                  <a:cubicBezTo>
                    <a:pt x="108524" y="120511"/>
                    <a:pt x="104108" y="131237"/>
                    <a:pt x="96536" y="138808"/>
                  </a:cubicBezTo>
                  <a:cubicBezTo>
                    <a:pt x="88965" y="146380"/>
                    <a:pt x="78239" y="150796"/>
                    <a:pt x="66881" y="150796"/>
                  </a:cubicBezTo>
                  <a:cubicBezTo>
                    <a:pt x="55524" y="150796"/>
                    <a:pt x="44798" y="146380"/>
                    <a:pt x="37226" y="138808"/>
                  </a:cubicBezTo>
                  <a:cubicBezTo>
                    <a:pt x="29655" y="131237"/>
                    <a:pt x="25238" y="120511"/>
                    <a:pt x="25238" y="109154"/>
                  </a:cubicBezTo>
                  <a:lnTo>
                    <a:pt x="25238" y="0"/>
                  </a:lnTo>
                  <a:lnTo>
                    <a:pt x="0" y="0"/>
                  </a:lnTo>
                  <a:lnTo>
                    <a:pt x="0" y="109154"/>
                  </a:lnTo>
                  <a:cubicBezTo>
                    <a:pt x="0" y="117987"/>
                    <a:pt x="1893" y="126820"/>
                    <a:pt x="5048" y="135023"/>
                  </a:cubicBezTo>
                  <a:cubicBezTo>
                    <a:pt x="8202" y="143225"/>
                    <a:pt x="13250" y="150796"/>
                    <a:pt x="19560" y="157106"/>
                  </a:cubicBezTo>
                  <a:cubicBezTo>
                    <a:pt x="25869" y="163415"/>
                    <a:pt x="33441" y="168463"/>
                    <a:pt x="41643" y="171617"/>
                  </a:cubicBezTo>
                  <a:cubicBezTo>
                    <a:pt x="49846" y="174772"/>
                    <a:pt x="58679" y="176665"/>
                    <a:pt x="67512" y="176665"/>
                  </a:cubicBezTo>
                  <a:cubicBezTo>
                    <a:pt x="76346" y="176665"/>
                    <a:pt x="85179" y="174772"/>
                    <a:pt x="93382" y="171617"/>
                  </a:cubicBezTo>
                  <a:cubicBezTo>
                    <a:pt x="101584" y="168463"/>
                    <a:pt x="109155" y="163415"/>
                    <a:pt x="115465" y="157106"/>
                  </a:cubicBezTo>
                  <a:cubicBezTo>
                    <a:pt x="121775" y="150796"/>
                    <a:pt x="126822" y="143225"/>
                    <a:pt x="129977" y="135023"/>
                  </a:cubicBezTo>
                  <a:cubicBezTo>
                    <a:pt x="133132" y="126820"/>
                    <a:pt x="135025" y="117987"/>
                    <a:pt x="135025" y="109154"/>
                  </a:cubicBezTo>
                  <a:lnTo>
                    <a:pt x="135025" y="0"/>
                  </a:lnTo>
                  <a:lnTo>
                    <a:pt x="108524" y="0"/>
                  </a:lnTo>
                  <a:close/>
                </a:path>
              </a:pathLst>
            </a:custGeom>
            <a:solidFill>
              <a:schemeClr val="bg1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2" name="Friform 7">
              <a:extLst>
                <a:ext uri="{FF2B5EF4-FFF2-40B4-BE49-F238E27FC236}">
                  <a16:creationId xmlns:a16="http://schemas.microsoft.com/office/drawing/2014/main" id="{B882EE20-9FD9-4D3C-B0C6-52EAB88C4F75}"/>
                </a:ext>
              </a:extLst>
            </p:cNvPr>
            <p:cNvSpPr/>
            <p:nvPr/>
          </p:nvSpPr>
          <p:spPr>
            <a:xfrm>
              <a:off x="630107" y="393704"/>
              <a:ext cx="119881" cy="175403"/>
            </a:xfrm>
            <a:custGeom>
              <a:avLst/>
              <a:gdLst>
                <a:gd name="connsiteX0" fmla="*/ 66881 w 119881"/>
                <a:gd name="connsiteY0" fmla="*/ 76345 h 175403"/>
                <a:gd name="connsiteX1" fmla="*/ 24607 w 119881"/>
                <a:gd name="connsiteY1" fmla="*/ 76345 h 175403"/>
                <a:gd name="connsiteX2" fmla="*/ 24607 w 119881"/>
                <a:gd name="connsiteY2" fmla="*/ 22714 h 175403"/>
                <a:gd name="connsiteX3" fmla="*/ 66881 w 119881"/>
                <a:gd name="connsiteY3" fmla="*/ 22714 h 175403"/>
                <a:gd name="connsiteX4" fmla="*/ 85179 w 119881"/>
                <a:gd name="connsiteY4" fmla="*/ 30285 h 175403"/>
                <a:gd name="connsiteX5" fmla="*/ 92751 w 119881"/>
                <a:gd name="connsiteY5" fmla="*/ 48583 h 175403"/>
                <a:gd name="connsiteX6" fmla="*/ 92751 w 119881"/>
                <a:gd name="connsiteY6" fmla="*/ 50476 h 175403"/>
                <a:gd name="connsiteX7" fmla="*/ 85179 w 119881"/>
                <a:gd name="connsiteY7" fmla="*/ 68773 h 175403"/>
                <a:gd name="connsiteX8" fmla="*/ 66881 w 119881"/>
                <a:gd name="connsiteY8" fmla="*/ 76345 h 175403"/>
                <a:gd name="connsiteX9" fmla="*/ 119882 w 119881"/>
                <a:gd name="connsiteY9" fmla="*/ 49845 h 175403"/>
                <a:gd name="connsiteX10" fmla="*/ 119882 w 119881"/>
                <a:gd name="connsiteY10" fmla="*/ 49845 h 175403"/>
                <a:gd name="connsiteX11" fmla="*/ 105370 w 119881"/>
                <a:gd name="connsiteY11" fmla="*/ 14512 h 175403"/>
                <a:gd name="connsiteX12" fmla="*/ 70667 w 119881"/>
                <a:gd name="connsiteY12" fmla="*/ 0 h 175403"/>
                <a:gd name="connsiteX13" fmla="*/ 0 w 119881"/>
                <a:gd name="connsiteY13" fmla="*/ 0 h 175403"/>
                <a:gd name="connsiteX14" fmla="*/ 0 w 119881"/>
                <a:gd name="connsiteY14" fmla="*/ 174772 h 175403"/>
                <a:gd name="connsiteX15" fmla="*/ 25238 w 119881"/>
                <a:gd name="connsiteY15" fmla="*/ 174772 h 175403"/>
                <a:gd name="connsiteX16" fmla="*/ 25238 w 119881"/>
                <a:gd name="connsiteY16" fmla="*/ 98428 h 175403"/>
                <a:gd name="connsiteX17" fmla="*/ 37226 w 119881"/>
                <a:gd name="connsiteY17" fmla="*/ 98428 h 175403"/>
                <a:gd name="connsiteX18" fmla="*/ 86441 w 119881"/>
                <a:gd name="connsiteY18" fmla="*/ 175403 h 175403"/>
                <a:gd name="connsiteX19" fmla="*/ 117989 w 119881"/>
                <a:gd name="connsiteY19" fmla="*/ 175403 h 175403"/>
                <a:gd name="connsiteX20" fmla="*/ 67512 w 119881"/>
                <a:gd name="connsiteY20" fmla="*/ 98428 h 175403"/>
                <a:gd name="connsiteX21" fmla="*/ 71298 w 119881"/>
                <a:gd name="connsiteY21" fmla="*/ 98428 h 175403"/>
                <a:gd name="connsiteX22" fmla="*/ 90227 w 119881"/>
                <a:gd name="connsiteY22" fmla="*/ 94642 h 175403"/>
                <a:gd name="connsiteX23" fmla="*/ 106001 w 119881"/>
                <a:gd name="connsiteY23" fmla="*/ 83916 h 175403"/>
                <a:gd name="connsiteX24" fmla="*/ 116727 w 119881"/>
                <a:gd name="connsiteY24" fmla="*/ 68142 h 175403"/>
                <a:gd name="connsiteX25" fmla="*/ 119882 w 119881"/>
                <a:gd name="connsiteY25" fmla="*/ 49845 h 1754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</a:cxnLst>
              <a:rect l="l" t="t" r="r" b="b"/>
              <a:pathLst>
                <a:path w="119881" h="175403">
                  <a:moveTo>
                    <a:pt x="66881" y="76345"/>
                  </a:moveTo>
                  <a:lnTo>
                    <a:pt x="24607" y="76345"/>
                  </a:lnTo>
                  <a:lnTo>
                    <a:pt x="24607" y="22714"/>
                  </a:lnTo>
                  <a:lnTo>
                    <a:pt x="66881" y="22714"/>
                  </a:lnTo>
                  <a:cubicBezTo>
                    <a:pt x="73822" y="22714"/>
                    <a:pt x="80762" y="25238"/>
                    <a:pt x="85179" y="30285"/>
                  </a:cubicBezTo>
                  <a:cubicBezTo>
                    <a:pt x="90227" y="35333"/>
                    <a:pt x="92751" y="41642"/>
                    <a:pt x="92751" y="48583"/>
                  </a:cubicBezTo>
                  <a:lnTo>
                    <a:pt x="92751" y="50476"/>
                  </a:lnTo>
                  <a:cubicBezTo>
                    <a:pt x="92751" y="57416"/>
                    <a:pt x="90227" y="64357"/>
                    <a:pt x="85179" y="68773"/>
                  </a:cubicBezTo>
                  <a:cubicBezTo>
                    <a:pt x="80131" y="73190"/>
                    <a:pt x="73822" y="76345"/>
                    <a:pt x="66881" y="76345"/>
                  </a:cubicBezTo>
                  <a:close/>
                  <a:moveTo>
                    <a:pt x="119882" y="49845"/>
                  </a:moveTo>
                  <a:lnTo>
                    <a:pt x="119882" y="49845"/>
                  </a:lnTo>
                  <a:cubicBezTo>
                    <a:pt x="119882" y="36595"/>
                    <a:pt x="114834" y="23976"/>
                    <a:pt x="105370" y="14512"/>
                  </a:cubicBezTo>
                  <a:cubicBezTo>
                    <a:pt x="95905" y="5048"/>
                    <a:pt x="83917" y="0"/>
                    <a:pt x="70667" y="0"/>
                  </a:cubicBezTo>
                  <a:lnTo>
                    <a:pt x="0" y="0"/>
                  </a:lnTo>
                  <a:lnTo>
                    <a:pt x="0" y="174772"/>
                  </a:lnTo>
                  <a:lnTo>
                    <a:pt x="25238" y="174772"/>
                  </a:lnTo>
                  <a:lnTo>
                    <a:pt x="25238" y="98428"/>
                  </a:lnTo>
                  <a:lnTo>
                    <a:pt x="37226" y="98428"/>
                  </a:lnTo>
                  <a:lnTo>
                    <a:pt x="86441" y="175403"/>
                  </a:lnTo>
                  <a:lnTo>
                    <a:pt x="117989" y="175403"/>
                  </a:lnTo>
                  <a:lnTo>
                    <a:pt x="67512" y="98428"/>
                  </a:lnTo>
                  <a:lnTo>
                    <a:pt x="71298" y="98428"/>
                  </a:lnTo>
                  <a:cubicBezTo>
                    <a:pt x="77608" y="98428"/>
                    <a:pt x="83917" y="97166"/>
                    <a:pt x="90227" y="94642"/>
                  </a:cubicBezTo>
                  <a:cubicBezTo>
                    <a:pt x="95905" y="92118"/>
                    <a:pt x="101584" y="88333"/>
                    <a:pt x="106001" y="83916"/>
                  </a:cubicBezTo>
                  <a:cubicBezTo>
                    <a:pt x="110417" y="79499"/>
                    <a:pt x="114203" y="73821"/>
                    <a:pt x="116727" y="68142"/>
                  </a:cubicBezTo>
                  <a:cubicBezTo>
                    <a:pt x="118620" y="62464"/>
                    <a:pt x="119882" y="56154"/>
                    <a:pt x="119882" y="49845"/>
                  </a:cubicBezTo>
                  <a:close/>
                </a:path>
              </a:pathLst>
            </a:custGeom>
            <a:solidFill>
              <a:schemeClr val="bg1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3" name="Friform 8">
              <a:extLst>
                <a:ext uri="{FF2B5EF4-FFF2-40B4-BE49-F238E27FC236}">
                  <a16:creationId xmlns:a16="http://schemas.microsoft.com/office/drawing/2014/main" id="{8AC0AB69-9321-4F81-8A70-EC176161BDFC}"/>
                </a:ext>
              </a:extLst>
            </p:cNvPr>
            <p:cNvSpPr/>
            <p:nvPr/>
          </p:nvSpPr>
          <p:spPr>
            <a:xfrm>
              <a:off x="1109003" y="394334"/>
              <a:ext cx="120512" cy="174772"/>
            </a:xfrm>
            <a:custGeom>
              <a:avLst/>
              <a:gdLst>
                <a:gd name="connsiteX0" fmla="*/ 92751 w 120512"/>
                <a:gd name="connsiteY0" fmla="*/ 49845 h 174772"/>
                <a:gd name="connsiteX1" fmla="*/ 85179 w 120512"/>
                <a:gd name="connsiteY1" fmla="*/ 68142 h 174772"/>
                <a:gd name="connsiteX2" fmla="*/ 66881 w 120512"/>
                <a:gd name="connsiteY2" fmla="*/ 75714 h 174772"/>
                <a:gd name="connsiteX3" fmla="*/ 24607 w 120512"/>
                <a:gd name="connsiteY3" fmla="*/ 75714 h 174772"/>
                <a:gd name="connsiteX4" fmla="*/ 24607 w 120512"/>
                <a:gd name="connsiteY4" fmla="*/ 22083 h 174772"/>
                <a:gd name="connsiteX5" fmla="*/ 66881 w 120512"/>
                <a:gd name="connsiteY5" fmla="*/ 22083 h 174772"/>
                <a:gd name="connsiteX6" fmla="*/ 85179 w 120512"/>
                <a:gd name="connsiteY6" fmla="*/ 29654 h 174772"/>
                <a:gd name="connsiteX7" fmla="*/ 92751 w 120512"/>
                <a:gd name="connsiteY7" fmla="*/ 47952 h 174772"/>
                <a:gd name="connsiteX8" fmla="*/ 92751 w 120512"/>
                <a:gd name="connsiteY8" fmla="*/ 49845 h 174772"/>
                <a:gd name="connsiteX9" fmla="*/ 71298 w 120512"/>
                <a:gd name="connsiteY9" fmla="*/ 0 h 174772"/>
                <a:gd name="connsiteX10" fmla="*/ 0 w 120512"/>
                <a:gd name="connsiteY10" fmla="*/ 0 h 174772"/>
                <a:gd name="connsiteX11" fmla="*/ 0 w 120512"/>
                <a:gd name="connsiteY11" fmla="*/ 174772 h 174772"/>
                <a:gd name="connsiteX12" fmla="*/ 25238 w 120512"/>
                <a:gd name="connsiteY12" fmla="*/ 174772 h 174772"/>
                <a:gd name="connsiteX13" fmla="*/ 25238 w 120512"/>
                <a:gd name="connsiteY13" fmla="*/ 97797 h 174772"/>
                <a:gd name="connsiteX14" fmla="*/ 71298 w 120512"/>
                <a:gd name="connsiteY14" fmla="*/ 97797 h 174772"/>
                <a:gd name="connsiteX15" fmla="*/ 90227 w 120512"/>
                <a:gd name="connsiteY15" fmla="*/ 94011 h 174772"/>
                <a:gd name="connsiteX16" fmla="*/ 106001 w 120512"/>
                <a:gd name="connsiteY16" fmla="*/ 83285 h 174772"/>
                <a:gd name="connsiteX17" fmla="*/ 116727 w 120512"/>
                <a:gd name="connsiteY17" fmla="*/ 67511 h 174772"/>
                <a:gd name="connsiteX18" fmla="*/ 120513 w 120512"/>
                <a:gd name="connsiteY18" fmla="*/ 48583 h 174772"/>
                <a:gd name="connsiteX19" fmla="*/ 120513 w 120512"/>
                <a:gd name="connsiteY19" fmla="*/ 48583 h 174772"/>
                <a:gd name="connsiteX20" fmla="*/ 106001 w 120512"/>
                <a:gd name="connsiteY20" fmla="*/ 13881 h 174772"/>
                <a:gd name="connsiteX21" fmla="*/ 71298 w 120512"/>
                <a:gd name="connsiteY21" fmla="*/ 0 h 1747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</a:cxnLst>
              <a:rect l="l" t="t" r="r" b="b"/>
              <a:pathLst>
                <a:path w="120512" h="174772">
                  <a:moveTo>
                    <a:pt x="92751" y="49845"/>
                  </a:moveTo>
                  <a:cubicBezTo>
                    <a:pt x="92751" y="56785"/>
                    <a:pt x="90227" y="63726"/>
                    <a:pt x="85179" y="68142"/>
                  </a:cubicBezTo>
                  <a:cubicBezTo>
                    <a:pt x="80131" y="72559"/>
                    <a:pt x="73822" y="75714"/>
                    <a:pt x="66881" y="75714"/>
                  </a:cubicBezTo>
                  <a:lnTo>
                    <a:pt x="24607" y="75714"/>
                  </a:lnTo>
                  <a:lnTo>
                    <a:pt x="24607" y="22083"/>
                  </a:lnTo>
                  <a:lnTo>
                    <a:pt x="66881" y="22083"/>
                  </a:lnTo>
                  <a:cubicBezTo>
                    <a:pt x="73822" y="22083"/>
                    <a:pt x="80762" y="24607"/>
                    <a:pt x="85179" y="29654"/>
                  </a:cubicBezTo>
                  <a:cubicBezTo>
                    <a:pt x="89596" y="34702"/>
                    <a:pt x="92751" y="41012"/>
                    <a:pt x="92751" y="47952"/>
                  </a:cubicBezTo>
                  <a:lnTo>
                    <a:pt x="92751" y="49845"/>
                  </a:lnTo>
                  <a:close/>
                  <a:moveTo>
                    <a:pt x="71298" y="0"/>
                  </a:moveTo>
                  <a:lnTo>
                    <a:pt x="0" y="0"/>
                  </a:lnTo>
                  <a:lnTo>
                    <a:pt x="0" y="174772"/>
                  </a:lnTo>
                  <a:lnTo>
                    <a:pt x="25238" y="174772"/>
                  </a:lnTo>
                  <a:lnTo>
                    <a:pt x="25238" y="97797"/>
                  </a:lnTo>
                  <a:lnTo>
                    <a:pt x="71298" y="97797"/>
                  </a:lnTo>
                  <a:cubicBezTo>
                    <a:pt x="77608" y="97797"/>
                    <a:pt x="83917" y="96535"/>
                    <a:pt x="90227" y="94011"/>
                  </a:cubicBezTo>
                  <a:cubicBezTo>
                    <a:pt x="96536" y="91487"/>
                    <a:pt x="101584" y="87702"/>
                    <a:pt x="106001" y="83285"/>
                  </a:cubicBezTo>
                  <a:cubicBezTo>
                    <a:pt x="110417" y="78868"/>
                    <a:pt x="114203" y="73190"/>
                    <a:pt x="116727" y="67511"/>
                  </a:cubicBezTo>
                  <a:cubicBezTo>
                    <a:pt x="119251" y="61833"/>
                    <a:pt x="120513" y="55523"/>
                    <a:pt x="120513" y="48583"/>
                  </a:cubicBezTo>
                  <a:lnTo>
                    <a:pt x="120513" y="48583"/>
                  </a:lnTo>
                  <a:cubicBezTo>
                    <a:pt x="120513" y="35333"/>
                    <a:pt x="115465" y="23345"/>
                    <a:pt x="106001" y="13881"/>
                  </a:cubicBezTo>
                  <a:cubicBezTo>
                    <a:pt x="96536" y="5048"/>
                    <a:pt x="83917" y="0"/>
                    <a:pt x="71298" y="0"/>
                  </a:cubicBezTo>
                  <a:close/>
                </a:path>
              </a:pathLst>
            </a:custGeom>
            <a:solidFill>
              <a:schemeClr val="bg1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4" name="Friform 9">
              <a:extLst>
                <a:ext uri="{FF2B5EF4-FFF2-40B4-BE49-F238E27FC236}">
                  <a16:creationId xmlns:a16="http://schemas.microsoft.com/office/drawing/2014/main" id="{24D6FAFA-DC8E-4871-8526-4A1AD98C0CB7}"/>
                </a:ext>
              </a:extLst>
            </p:cNvPr>
            <p:cNvSpPr/>
            <p:nvPr/>
          </p:nvSpPr>
          <p:spPr>
            <a:xfrm>
              <a:off x="782168" y="394334"/>
              <a:ext cx="120354" cy="174772"/>
            </a:xfrm>
            <a:custGeom>
              <a:avLst/>
              <a:gdLst>
                <a:gd name="connsiteX0" fmla="*/ 93381 w 120354"/>
                <a:gd name="connsiteY0" fmla="*/ 49845 h 174772"/>
                <a:gd name="connsiteX1" fmla="*/ 91489 w 120354"/>
                <a:gd name="connsiteY1" fmla="*/ 59940 h 174772"/>
                <a:gd name="connsiteX2" fmla="*/ 85810 w 120354"/>
                <a:gd name="connsiteY2" fmla="*/ 68142 h 174772"/>
                <a:gd name="connsiteX3" fmla="*/ 77608 w 120354"/>
                <a:gd name="connsiteY3" fmla="*/ 73821 h 174772"/>
                <a:gd name="connsiteX4" fmla="*/ 67512 w 120354"/>
                <a:gd name="connsiteY4" fmla="*/ 75714 h 174772"/>
                <a:gd name="connsiteX5" fmla="*/ 25238 w 120354"/>
                <a:gd name="connsiteY5" fmla="*/ 75714 h 174772"/>
                <a:gd name="connsiteX6" fmla="*/ 25238 w 120354"/>
                <a:gd name="connsiteY6" fmla="*/ 22083 h 174772"/>
                <a:gd name="connsiteX7" fmla="*/ 67512 w 120354"/>
                <a:gd name="connsiteY7" fmla="*/ 22083 h 174772"/>
                <a:gd name="connsiteX8" fmla="*/ 85810 w 120354"/>
                <a:gd name="connsiteY8" fmla="*/ 29654 h 174772"/>
                <a:gd name="connsiteX9" fmla="*/ 93381 w 120354"/>
                <a:gd name="connsiteY9" fmla="*/ 47952 h 174772"/>
                <a:gd name="connsiteX10" fmla="*/ 93381 w 120354"/>
                <a:gd name="connsiteY10" fmla="*/ 49845 h 174772"/>
                <a:gd name="connsiteX11" fmla="*/ 93381 w 120354"/>
                <a:gd name="connsiteY11" fmla="*/ 126189 h 174772"/>
                <a:gd name="connsiteX12" fmla="*/ 85810 w 120354"/>
                <a:gd name="connsiteY12" fmla="*/ 144487 h 174772"/>
                <a:gd name="connsiteX13" fmla="*/ 67512 w 120354"/>
                <a:gd name="connsiteY13" fmla="*/ 152058 h 174772"/>
                <a:gd name="connsiteX14" fmla="*/ 25238 w 120354"/>
                <a:gd name="connsiteY14" fmla="*/ 152058 h 174772"/>
                <a:gd name="connsiteX15" fmla="*/ 25238 w 120354"/>
                <a:gd name="connsiteY15" fmla="*/ 98428 h 174772"/>
                <a:gd name="connsiteX16" fmla="*/ 67512 w 120354"/>
                <a:gd name="connsiteY16" fmla="*/ 98428 h 174772"/>
                <a:gd name="connsiteX17" fmla="*/ 85810 w 120354"/>
                <a:gd name="connsiteY17" fmla="*/ 105999 h 174772"/>
                <a:gd name="connsiteX18" fmla="*/ 93381 w 120354"/>
                <a:gd name="connsiteY18" fmla="*/ 124296 h 174772"/>
                <a:gd name="connsiteX19" fmla="*/ 93381 w 120354"/>
                <a:gd name="connsiteY19" fmla="*/ 126189 h 174772"/>
                <a:gd name="connsiteX20" fmla="*/ 119882 w 120354"/>
                <a:gd name="connsiteY20" fmla="*/ 48583 h 174772"/>
                <a:gd name="connsiteX21" fmla="*/ 105370 w 120354"/>
                <a:gd name="connsiteY21" fmla="*/ 14512 h 174772"/>
                <a:gd name="connsiteX22" fmla="*/ 71298 w 120354"/>
                <a:gd name="connsiteY22" fmla="*/ 0 h 174772"/>
                <a:gd name="connsiteX23" fmla="*/ 0 w 120354"/>
                <a:gd name="connsiteY23" fmla="*/ 0 h 174772"/>
                <a:gd name="connsiteX24" fmla="*/ 0 w 120354"/>
                <a:gd name="connsiteY24" fmla="*/ 174772 h 174772"/>
                <a:gd name="connsiteX25" fmla="*/ 71929 w 120354"/>
                <a:gd name="connsiteY25" fmla="*/ 174772 h 174772"/>
                <a:gd name="connsiteX26" fmla="*/ 100322 w 120354"/>
                <a:gd name="connsiteY26" fmla="*/ 165308 h 174772"/>
                <a:gd name="connsiteX27" fmla="*/ 117989 w 120354"/>
                <a:gd name="connsiteY27" fmla="*/ 141332 h 174772"/>
                <a:gd name="connsiteX28" fmla="*/ 117989 w 120354"/>
                <a:gd name="connsiteY28" fmla="*/ 111678 h 174772"/>
                <a:gd name="connsiteX29" fmla="*/ 100322 w 120354"/>
                <a:gd name="connsiteY29" fmla="*/ 87702 h 174772"/>
                <a:gd name="connsiteX30" fmla="*/ 114834 w 120354"/>
                <a:gd name="connsiteY30" fmla="*/ 70666 h 174772"/>
                <a:gd name="connsiteX31" fmla="*/ 119882 w 120354"/>
                <a:gd name="connsiteY31" fmla="*/ 48583 h 1747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</a:cxnLst>
              <a:rect l="l" t="t" r="r" b="b"/>
              <a:pathLst>
                <a:path w="120354" h="174772">
                  <a:moveTo>
                    <a:pt x="93381" y="49845"/>
                  </a:moveTo>
                  <a:cubicBezTo>
                    <a:pt x="93381" y="53000"/>
                    <a:pt x="92751" y="56785"/>
                    <a:pt x="91489" y="59940"/>
                  </a:cubicBezTo>
                  <a:cubicBezTo>
                    <a:pt x="90227" y="63095"/>
                    <a:pt x="88334" y="66249"/>
                    <a:pt x="85810" y="68142"/>
                  </a:cubicBezTo>
                  <a:cubicBezTo>
                    <a:pt x="83286" y="70666"/>
                    <a:pt x="80762" y="72559"/>
                    <a:pt x="77608" y="73821"/>
                  </a:cubicBezTo>
                  <a:cubicBezTo>
                    <a:pt x="74453" y="75083"/>
                    <a:pt x="71298" y="75714"/>
                    <a:pt x="67512" y="75714"/>
                  </a:cubicBezTo>
                  <a:lnTo>
                    <a:pt x="25238" y="75714"/>
                  </a:lnTo>
                  <a:lnTo>
                    <a:pt x="25238" y="22083"/>
                  </a:lnTo>
                  <a:lnTo>
                    <a:pt x="67512" y="22083"/>
                  </a:lnTo>
                  <a:cubicBezTo>
                    <a:pt x="74453" y="22083"/>
                    <a:pt x="81393" y="24607"/>
                    <a:pt x="85810" y="29654"/>
                  </a:cubicBezTo>
                  <a:cubicBezTo>
                    <a:pt x="90227" y="34702"/>
                    <a:pt x="93381" y="41012"/>
                    <a:pt x="93381" y="47952"/>
                  </a:cubicBezTo>
                  <a:lnTo>
                    <a:pt x="93381" y="49845"/>
                  </a:lnTo>
                  <a:close/>
                  <a:moveTo>
                    <a:pt x="93381" y="126189"/>
                  </a:moveTo>
                  <a:cubicBezTo>
                    <a:pt x="93381" y="133130"/>
                    <a:pt x="90858" y="140070"/>
                    <a:pt x="85810" y="144487"/>
                  </a:cubicBezTo>
                  <a:cubicBezTo>
                    <a:pt x="80762" y="149534"/>
                    <a:pt x="74453" y="152058"/>
                    <a:pt x="67512" y="152058"/>
                  </a:cubicBezTo>
                  <a:lnTo>
                    <a:pt x="25238" y="152058"/>
                  </a:lnTo>
                  <a:lnTo>
                    <a:pt x="25238" y="98428"/>
                  </a:lnTo>
                  <a:lnTo>
                    <a:pt x="67512" y="98428"/>
                  </a:lnTo>
                  <a:cubicBezTo>
                    <a:pt x="74453" y="98428"/>
                    <a:pt x="81393" y="100951"/>
                    <a:pt x="85810" y="105999"/>
                  </a:cubicBezTo>
                  <a:cubicBezTo>
                    <a:pt x="90858" y="111047"/>
                    <a:pt x="93381" y="117356"/>
                    <a:pt x="93381" y="124296"/>
                  </a:cubicBezTo>
                  <a:lnTo>
                    <a:pt x="93381" y="126189"/>
                  </a:lnTo>
                  <a:close/>
                  <a:moveTo>
                    <a:pt x="119882" y="48583"/>
                  </a:moveTo>
                  <a:cubicBezTo>
                    <a:pt x="119882" y="35964"/>
                    <a:pt x="114834" y="23345"/>
                    <a:pt x="105370" y="14512"/>
                  </a:cubicBezTo>
                  <a:cubicBezTo>
                    <a:pt x="96536" y="5679"/>
                    <a:pt x="83917" y="0"/>
                    <a:pt x="71298" y="0"/>
                  </a:cubicBezTo>
                  <a:lnTo>
                    <a:pt x="0" y="0"/>
                  </a:lnTo>
                  <a:lnTo>
                    <a:pt x="0" y="174772"/>
                  </a:lnTo>
                  <a:lnTo>
                    <a:pt x="71929" y="174772"/>
                  </a:lnTo>
                  <a:cubicBezTo>
                    <a:pt x="82024" y="174772"/>
                    <a:pt x="92120" y="171617"/>
                    <a:pt x="100322" y="165308"/>
                  </a:cubicBezTo>
                  <a:cubicBezTo>
                    <a:pt x="108524" y="159629"/>
                    <a:pt x="114834" y="150796"/>
                    <a:pt x="117989" y="141332"/>
                  </a:cubicBezTo>
                  <a:cubicBezTo>
                    <a:pt x="121144" y="131868"/>
                    <a:pt x="121144" y="121142"/>
                    <a:pt x="117989" y="111678"/>
                  </a:cubicBezTo>
                  <a:cubicBezTo>
                    <a:pt x="114834" y="102213"/>
                    <a:pt x="108524" y="93380"/>
                    <a:pt x="100322" y="87702"/>
                  </a:cubicBezTo>
                  <a:cubicBezTo>
                    <a:pt x="106632" y="83285"/>
                    <a:pt x="111679" y="77606"/>
                    <a:pt x="114834" y="70666"/>
                  </a:cubicBezTo>
                  <a:cubicBezTo>
                    <a:pt x="117989" y="63726"/>
                    <a:pt x="119882" y="56154"/>
                    <a:pt x="119882" y="48583"/>
                  </a:cubicBezTo>
                  <a:close/>
                </a:path>
              </a:pathLst>
            </a:custGeom>
            <a:solidFill>
              <a:schemeClr val="bg1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5" name="Friform 10">
              <a:extLst>
                <a:ext uri="{FF2B5EF4-FFF2-40B4-BE49-F238E27FC236}">
                  <a16:creationId xmlns:a16="http://schemas.microsoft.com/office/drawing/2014/main" id="{7998BF4A-7B72-4DCC-9F67-7C92137E3389}"/>
                </a:ext>
              </a:extLst>
            </p:cNvPr>
            <p:cNvSpPr/>
            <p:nvPr/>
          </p:nvSpPr>
          <p:spPr>
            <a:xfrm>
              <a:off x="454701" y="393704"/>
              <a:ext cx="116095" cy="116725"/>
            </a:xfrm>
            <a:custGeom>
              <a:avLst/>
              <a:gdLst>
                <a:gd name="connsiteX0" fmla="*/ 58048 w 116095"/>
                <a:gd name="connsiteY0" fmla="*/ 0 h 116725"/>
                <a:gd name="connsiteX1" fmla="*/ 99060 w 116095"/>
                <a:gd name="connsiteY1" fmla="*/ 17036 h 116725"/>
                <a:gd name="connsiteX2" fmla="*/ 116096 w 116095"/>
                <a:gd name="connsiteY2" fmla="*/ 58047 h 116725"/>
                <a:gd name="connsiteX3" fmla="*/ 116096 w 116095"/>
                <a:gd name="connsiteY3" fmla="*/ 116725 h 116725"/>
                <a:gd name="connsiteX4" fmla="*/ 0 w 116095"/>
                <a:gd name="connsiteY4" fmla="*/ 116725 h 116725"/>
                <a:gd name="connsiteX5" fmla="*/ 0 w 116095"/>
                <a:gd name="connsiteY5" fmla="*/ 58678 h 116725"/>
                <a:gd name="connsiteX6" fmla="*/ 17036 w 116095"/>
                <a:gd name="connsiteY6" fmla="*/ 17667 h 116725"/>
                <a:gd name="connsiteX7" fmla="*/ 58048 w 116095"/>
                <a:gd name="connsiteY7" fmla="*/ 0 h 1167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116095" h="116725">
                  <a:moveTo>
                    <a:pt x="58048" y="0"/>
                  </a:moveTo>
                  <a:cubicBezTo>
                    <a:pt x="73822" y="0"/>
                    <a:pt x="88334" y="6309"/>
                    <a:pt x="99060" y="17036"/>
                  </a:cubicBezTo>
                  <a:cubicBezTo>
                    <a:pt x="109786" y="27762"/>
                    <a:pt x="116096" y="42904"/>
                    <a:pt x="116096" y="58047"/>
                  </a:cubicBezTo>
                  <a:lnTo>
                    <a:pt x="116096" y="116725"/>
                  </a:lnTo>
                  <a:lnTo>
                    <a:pt x="0" y="116725"/>
                  </a:lnTo>
                  <a:lnTo>
                    <a:pt x="0" y="58678"/>
                  </a:lnTo>
                  <a:cubicBezTo>
                    <a:pt x="0" y="42904"/>
                    <a:pt x="6310" y="28393"/>
                    <a:pt x="17036" y="17667"/>
                  </a:cubicBezTo>
                  <a:cubicBezTo>
                    <a:pt x="27762" y="6940"/>
                    <a:pt x="42905" y="0"/>
                    <a:pt x="58048" y="0"/>
                  </a:cubicBezTo>
                  <a:close/>
                </a:path>
              </a:pathLst>
            </a:custGeom>
            <a:solidFill>
              <a:srgbClr val="E31836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6" name="Friform 11">
              <a:extLst>
                <a:ext uri="{FF2B5EF4-FFF2-40B4-BE49-F238E27FC236}">
                  <a16:creationId xmlns:a16="http://schemas.microsoft.com/office/drawing/2014/main" id="{37A3AE22-B5EE-402B-8924-FC0CB1AB1674}"/>
                </a:ext>
              </a:extLst>
            </p:cNvPr>
            <p:cNvSpPr/>
            <p:nvPr/>
          </p:nvSpPr>
          <p:spPr>
            <a:xfrm>
              <a:off x="396023" y="452382"/>
              <a:ext cx="58678" cy="116094"/>
            </a:xfrm>
            <a:custGeom>
              <a:avLst/>
              <a:gdLst>
                <a:gd name="connsiteX0" fmla="*/ 58679 w 58678"/>
                <a:gd name="connsiteY0" fmla="*/ 0 h 116094"/>
                <a:gd name="connsiteX1" fmla="*/ 17667 w 58678"/>
                <a:gd name="connsiteY1" fmla="*/ 17036 h 116094"/>
                <a:gd name="connsiteX2" fmla="*/ 0 w 58678"/>
                <a:gd name="connsiteY2" fmla="*/ 58047 h 116094"/>
                <a:gd name="connsiteX3" fmla="*/ 17036 w 58678"/>
                <a:gd name="connsiteY3" fmla="*/ 99059 h 116094"/>
                <a:gd name="connsiteX4" fmla="*/ 58048 w 58678"/>
                <a:gd name="connsiteY4" fmla="*/ 116094 h 116094"/>
                <a:gd name="connsiteX5" fmla="*/ 58048 w 58678"/>
                <a:gd name="connsiteY5" fmla="*/ 116094 h 116094"/>
                <a:gd name="connsiteX6" fmla="*/ 58048 w 58678"/>
                <a:gd name="connsiteY6" fmla="*/ 116094 h 116094"/>
                <a:gd name="connsiteX7" fmla="*/ 58048 w 58678"/>
                <a:gd name="connsiteY7" fmla="*/ 0 h 1160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58678" h="116094">
                  <a:moveTo>
                    <a:pt x="58679" y="0"/>
                  </a:moveTo>
                  <a:cubicBezTo>
                    <a:pt x="42905" y="0"/>
                    <a:pt x="28393" y="6309"/>
                    <a:pt x="17667" y="17036"/>
                  </a:cubicBezTo>
                  <a:cubicBezTo>
                    <a:pt x="6310" y="27762"/>
                    <a:pt x="0" y="42904"/>
                    <a:pt x="0" y="58047"/>
                  </a:cubicBezTo>
                  <a:cubicBezTo>
                    <a:pt x="0" y="73821"/>
                    <a:pt x="6310" y="88332"/>
                    <a:pt x="17036" y="99059"/>
                  </a:cubicBezTo>
                  <a:cubicBezTo>
                    <a:pt x="27762" y="109785"/>
                    <a:pt x="42905" y="116094"/>
                    <a:pt x="58048" y="116094"/>
                  </a:cubicBezTo>
                  <a:cubicBezTo>
                    <a:pt x="58048" y="116094"/>
                    <a:pt x="58048" y="116094"/>
                    <a:pt x="58048" y="116094"/>
                  </a:cubicBezTo>
                  <a:lnTo>
                    <a:pt x="58048" y="116094"/>
                  </a:lnTo>
                  <a:lnTo>
                    <a:pt x="58048" y="0"/>
                  </a:lnTo>
                  <a:close/>
                </a:path>
              </a:pathLst>
            </a:custGeom>
            <a:solidFill>
              <a:srgbClr val="728EE6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7" name="Friform 12">
              <a:extLst>
                <a:ext uri="{FF2B5EF4-FFF2-40B4-BE49-F238E27FC236}">
                  <a16:creationId xmlns:a16="http://schemas.microsoft.com/office/drawing/2014/main" id="{446F9CFF-1FC9-43E2-82F4-47F2B3BFF833}"/>
                </a:ext>
              </a:extLst>
            </p:cNvPr>
            <p:cNvSpPr/>
            <p:nvPr/>
          </p:nvSpPr>
          <p:spPr>
            <a:xfrm>
              <a:off x="454701" y="510429"/>
              <a:ext cx="116726" cy="58047"/>
            </a:xfrm>
            <a:custGeom>
              <a:avLst/>
              <a:gdLst>
                <a:gd name="connsiteX0" fmla="*/ 116727 w 116726"/>
                <a:gd name="connsiteY0" fmla="*/ 0 h 58047"/>
                <a:gd name="connsiteX1" fmla="*/ 58048 w 116726"/>
                <a:gd name="connsiteY1" fmla="*/ 0 h 58047"/>
                <a:gd name="connsiteX2" fmla="*/ 41012 w 116726"/>
                <a:gd name="connsiteY2" fmla="*/ 41012 h 58047"/>
                <a:gd name="connsiteX3" fmla="*/ 0 w 116726"/>
                <a:gd name="connsiteY3" fmla="*/ 58047 h 58047"/>
                <a:gd name="connsiteX4" fmla="*/ 116727 w 116726"/>
                <a:gd name="connsiteY4" fmla="*/ 58047 h 58047"/>
                <a:gd name="connsiteX5" fmla="*/ 116727 w 116726"/>
                <a:gd name="connsiteY5" fmla="*/ 0 h 580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116726" h="58047">
                  <a:moveTo>
                    <a:pt x="116727" y="0"/>
                  </a:moveTo>
                  <a:lnTo>
                    <a:pt x="58048" y="0"/>
                  </a:lnTo>
                  <a:cubicBezTo>
                    <a:pt x="58048" y="15774"/>
                    <a:pt x="51738" y="30285"/>
                    <a:pt x="41012" y="41012"/>
                  </a:cubicBezTo>
                  <a:cubicBezTo>
                    <a:pt x="30286" y="51738"/>
                    <a:pt x="15143" y="58047"/>
                    <a:pt x="0" y="58047"/>
                  </a:cubicBezTo>
                  <a:lnTo>
                    <a:pt x="116727" y="58047"/>
                  </a:lnTo>
                  <a:lnTo>
                    <a:pt x="116727" y="0"/>
                  </a:lnTo>
                  <a:close/>
                </a:path>
              </a:pathLst>
            </a:custGeom>
            <a:solidFill>
              <a:srgbClr val="C2CFF4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8" name="Friform 13">
              <a:extLst>
                <a:ext uri="{FF2B5EF4-FFF2-40B4-BE49-F238E27FC236}">
                  <a16:creationId xmlns:a16="http://schemas.microsoft.com/office/drawing/2014/main" id="{B829ED2D-65D2-412D-BF0E-8E353B04BC58}"/>
                </a:ext>
              </a:extLst>
            </p:cNvPr>
            <p:cNvSpPr/>
            <p:nvPr/>
          </p:nvSpPr>
          <p:spPr>
            <a:xfrm>
              <a:off x="454701" y="510429"/>
              <a:ext cx="58047" cy="58678"/>
            </a:xfrm>
            <a:custGeom>
              <a:avLst/>
              <a:gdLst>
                <a:gd name="connsiteX0" fmla="*/ 58048 w 58047"/>
                <a:gd name="connsiteY0" fmla="*/ 0 h 58678"/>
                <a:gd name="connsiteX1" fmla="*/ 0 w 58047"/>
                <a:gd name="connsiteY1" fmla="*/ 0 h 58678"/>
                <a:gd name="connsiteX2" fmla="*/ 0 w 58047"/>
                <a:gd name="connsiteY2" fmla="*/ 58678 h 58678"/>
                <a:gd name="connsiteX3" fmla="*/ 0 w 58047"/>
                <a:gd name="connsiteY3" fmla="*/ 58678 h 58678"/>
                <a:gd name="connsiteX4" fmla="*/ 41012 w 58047"/>
                <a:gd name="connsiteY4" fmla="*/ 41642 h 58678"/>
                <a:gd name="connsiteX5" fmla="*/ 58048 w 58047"/>
                <a:gd name="connsiteY5" fmla="*/ 0 h 5867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8047" h="58678">
                  <a:moveTo>
                    <a:pt x="58048" y="0"/>
                  </a:moveTo>
                  <a:lnTo>
                    <a:pt x="0" y="0"/>
                  </a:lnTo>
                  <a:lnTo>
                    <a:pt x="0" y="58678"/>
                  </a:lnTo>
                  <a:lnTo>
                    <a:pt x="0" y="58678"/>
                  </a:lnTo>
                  <a:cubicBezTo>
                    <a:pt x="15774" y="58678"/>
                    <a:pt x="30286" y="52369"/>
                    <a:pt x="41012" y="41642"/>
                  </a:cubicBezTo>
                  <a:cubicBezTo>
                    <a:pt x="52369" y="30285"/>
                    <a:pt x="58048" y="15774"/>
                    <a:pt x="58048" y="0"/>
                  </a:cubicBezTo>
                  <a:close/>
                </a:path>
              </a:pathLst>
            </a:custGeom>
            <a:solidFill>
              <a:srgbClr val="355EDB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  <p:sp>
          <p:nvSpPr>
            <p:cNvPr id="19" name="Friform 14">
              <a:extLst>
                <a:ext uri="{FF2B5EF4-FFF2-40B4-BE49-F238E27FC236}">
                  <a16:creationId xmlns:a16="http://schemas.microsoft.com/office/drawing/2014/main" id="{7222D3DC-E8A8-4057-87C4-B636576B7EE0}"/>
                </a:ext>
              </a:extLst>
            </p:cNvPr>
            <p:cNvSpPr/>
            <p:nvPr/>
          </p:nvSpPr>
          <p:spPr>
            <a:xfrm>
              <a:off x="454701" y="452382"/>
              <a:ext cx="116726" cy="58678"/>
            </a:xfrm>
            <a:custGeom>
              <a:avLst/>
              <a:gdLst>
                <a:gd name="connsiteX0" fmla="*/ 0 w 116726"/>
                <a:gd name="connsiteY0" fmla="*/ 0 h 58678"/>
                <a:gd name="connsiteX1" fmla="*/ 116727 w 116726"/>
                <a:gd name="connsiteY1" fmla="*/ 0 h 58678"/>
                <a:gd name="connsiteX2" fmla="*/ 116727 w 116726"/>
                <a:gd name="connsiteY2" fmla="*/ 58678 h 58678"/>
                <a:gd name="connsiteX3" fmla="*/ 0 w 116726"/>
                <a:gd name="connsiteY3" fmla="*/ 58678 h 5867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16726" h="58678">
                  <a:moveTo>
                    <a:pt x="0" y="0"/>
                  </a:moveTo>
                  <a:lnTo>
                    <a:pt x="116727" y="0"/>
                  </a:lnTo>
                  <a:lnTo>
                    <a:pt x="116727" y="58678"/>
                  </a:lnTo>
                  <a:lnTo>
                    <a:pt x="0" y="58678"/>
                  </a:lnTo>
                  <a:close/>
                </a:path>
              </a:pathLst>
            </a:custGeom>
            <a:solidFill>
              <a:srgbClr val="C21536"/>
            </a:solidFill>
            <a:ln w="6278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nb-NO"/>
            </a:p>
          </p:txBody>
        </p:sp>
      </p:grpSp>
      <p:sp>
        <p:nvSpPr>
          <p:cNvPr id="20" name="Plassholder for innhold 5">
            <a:extLst>
              <a:ext uri="{FF2B5EF4-FFF2-40B4-BE49-F238E27FC236}">
                <a16:creationId xmlns:a16="http://schemas.microsoft.com/office/drawing/2014/main" id="{E9C10196-8B1E-4FC7-8DC3-538F9A18D5D7}"/>
              </a:ext>
            </a:extLst>
          </p:cNvPr>
          <p:cNvSpPr txBox="1">
            <a:spLocks/>
          </p:cNvSpPr>
          <p:nvPr/>
        </p:nvSpPr>
        <p:spPr>
          <a:xfrm>
            <a:off x="7086600" y="1648800"/>
            <a:ext cx="4498200" cy="4351338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>
            <a:lvl1pPr marL="406481" indent="-406481" algn="l" defTabSz="914446" rtl="0" eaLnBrk="1" latinLnBrk="0" hangingPunct="1">
              <a:lnSpc>
                <a:spcPct val="110000"/>
              </a:lnSpc>
              <a:spcBef>
                <a:spcPts val="1200"/>
              </a:spcBef>
              <a:buSzPct val="100000"/>
              <a:buFontTx/>
              <a:buBlip>
                <a:blip r:embed="rId3">
                  <a:extLst>
                    <a:ext uri="{96DAC541-7B7A-43D3-8B79-37D633B846F1}">
                      <asvg:svgBlip xmlns:asvg="http://schemas.microsoft.com/office/drawing/2016/SVG/main" r:embed="rId4"/>
                    </a:ext>
                  </a:extLst>
                </a:blip>
              </a:buBlip>
              <a:defRPr sz="2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809787" indent="-407275" algn="l" defTabSz="914446" rtl="0" eaLnBrk="1" latinLnBrk="0" hangingPunct="1">
              <a:lnSpc>
                <a:spcPct val="110000"/>
              </a:lnSpc>
              <a:spcBef>
                <a:spcPts val="600"/>
              </a:spcBef>
              <a:buClr>
                <a:srgbClr val="94ABF7"/>
              </a:buClr>
              <a:buFont typeface="Arial" panose="020B0604020202020204" pitchFamily="34" charset="0"/>
              <a:buChar char="●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257300" indent="-447675" algn="l" defTabSz="914446" rtl="0" eaLnBrk="1" latinLnBrk="0" hangingPunct="1">
              <a:lnSpc>
                <a:spcPct val="110000"/>
              </a:lnSpc>
              <a:spcBef>
                <a:spcPts val="600"/>
              </a:spcBef>
              <a:buClr>
                <a:srgbClr val="94ABF7"/>
              </a:buClr>
              <a:buFont typeface="Arial" panose="020B0604020202020204" pitchFamily="34" charset="0"/>
              <a:buChar char="■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793875" indent="-422275" algn="l" defTabSz="914446" rtl="0" eaLnBrk="1" latinLnBrk="0" hangingPunct="1">
              <a:lnSpc>
                <a:spcPct val="110000"/>
              </a:lnSpc>
              <a:spcBef>
                <a:spcPts val="600"/>
              </a:spcBef>
              <a:buClr>
                <a:srgbClr val="94ABF7"/>
              </a:buClr>
              <a:buFont typeface="Arial" panose="020B0604020202020204" pitchFamily="34" charset="0"/>
              <a:buChar char="■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241550" indent="-412750" algn="l" defTabSz="914446" rtl="0" eaLnBrk="1" latinLnBrk="0" hangingPunct="1">
              <a:lnSpc>
                <a:spcPct val="110000"/>
              </a:lnSpc>
              <a:spcBef>
                <a:spcPts val="600"/>
              </a:spcBef>
              <a:buClr>
                <a:srgbClr val="94ABF7"/>
              </a:buClr>
              <a:buFont typeface="Arial" panose="020B0604020202020204" pitchFamily="34" charset="0"/>
              <a:buChar char="■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726" indent="-228611" algn="l" defTabSz="914446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948" indent="-228611" algn="l" defTabSz="914446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171" indent="-228611" algn="l" defTabSz="914446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394" indent="-228611" algn="l" defTabSz="914446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b-NO" dirty="0">
                <a:solidFill>
                  <a:schemeClr val="bg1"/>
                </a:solidFill>
              </a:rPr>
              <a:t>Write </a:t>
            </a:r>
            <a:r>
              <a:rPr lang="nb-NO" dirty="0" err="1">
                <a:solidFill>
                  <a:schemeClr val="bg1"/>
                </a:solidFill>
              </a:rPr>
              <a:t>the</a:t>
            </a:r>
            <a:r>
              <a:rPr lang="nb-NO" dirty="0">
                <a:solidFill>
                  <a:schemeClr val="bg1"/>
                </a:solidFill>
              </a:rPr>
              <a:t> </a:t>
            </a:r>
            <a:r>
              <a:rPr lang="nb-NO" dirty="0" err="1">
                <a:solidFill>
                  <a:schemeClr val="bg1"/>
                </a:solidFill>
              </a:rPr>
              <a:t>name</a:t>
            </a:r>
            <a:r>
              <a:rPr lang="nb-NO" dirty="0">
                <a:solidFill>
                  <a:schemeClr val="bg1"/>
                </a:solidFill>
              </a:rPr>
              <a:t> </a:t>
            </a:r>
            <a:r>
              <a:rPr lang="nb-NO" dirty="0" err="1">
                <a:solidFill>
                  <a:schemeClr val="bg1"/>
                </a:solidFill>
              </a:rPr>
              <a:t>of</a:t>
            </a:r>
            <a:r>
              <a:rPr lang="nb-NO" dirty="0">
                <a:solidFill>
                  <a:schemeClr val="bg1"/>
                </a:solidFill>
              </a:rPr>
              <a:t> </a:t>
            </a:r>
            <a:r>
              <a:rPr lang="nb-NO" dirty="0" err="1">
                <a:solidFill>
                  <a:schemeClr val="bg1"/>
                </a:solidFill>
              </a:rPr>
              <a:t>the</a:t>
            </a:r>
            <a:r>
              <a:rPr lang="nb-NO" dirty="0">
                <a:solidFill>
                  <a:schemeClr val="bg1"/>
                </a:solidFill>
              </a:rPr>
              <a:t> </a:t>
            </a:r>
            <a:r>
              <a:rPr lang="nb-NO" dirty="0" err="1">
                <a:solidFill>
                  <a:schemeClr val="bg1"/>
                </a:solidFill>
              </a:rPr>
              <a:t>strategy</a:t>
            </a:r>
            <a:r>
              <a:rPr lang="nb-NO" dirty="0">
                <a:solidFill>
                  <a:schemeClr val="bg1"/>
                </a:solidFill>
              </a:rPr>
              <a:t> and </a:t>
            </a:r>
            <a:r>
              <a:rPr lang="nb-NO" dirty="0" err="1">
                <a:solidFill>
                  <a:schemeClr val="bg1"/>
                </a:solidFill>
              </a:rPr>
              <a:t>its</a:t>
            </a:r>
            <a:r>
              <a:rPr lang="nb-NO" dirty="0">
                <a:solidFill>
                  <a:schemeClr val="bg1"/>
                </a:solidFill>
              </a:rPr>
              <a:t>’ </a:t>
            </a:r>
            <a:r>
              <a:rPr lang="nb-NO" dirty="0" err="1">
                <a:solidFill>
                  <a:schemeClr val="bg1"/>
                </a:solidFill>
              </a:rPr>
              <a:t>definition</a:t>
            </a:r>
            <a:r>
              <a:rPr lang="nb-NO" dirty="0">
                <a:solidFill>
                  <a:schemeClr val="bg1"/>
                </a:solidFill>
              </a:rPr>
              <a:t> </a:t>
            </a:r>
            <a:r>
              <a:rPr lang="nb-NO" dirty="0" err="1">
                <a:solidFill>
                  <a:schemeClr val="bg1"/>
                </a:solidFill>
              </a:rPr>
              <a:t>on</a:t>
            </a:r>
            <a:r>
              <a:rPr lang="nb-NO" dirty="0">
                <a:solidFill>
                  <a:schemeClr val="bg1"/>
                </a:solidFill>
              </a:rPr>
              <a:t> a </a:t>
            </a:r>
            <a:r>
              <a:rPr lang="nb-NO" dirty="0" err="1">
                <a:solidFill>
                  <a:schemeClr val="bg1"/>
                </a:solidFill>
              </a:rPr>
              <a:t>post-it</a:t>
            </a:r>
            <a:endParaRPr lang="nb-NO" dirty="0">
              <a:solidFill>
                <a:schemeClr val="bg1"/>
              </a:solidFill>
            </a:endParaRPr>
          </a:p>
          <a:p>
            <a:r>
              <a:rPr lang="nb-NO" dirty="0" err="1">
                <a:solidFill>
                  <a:schemeClr val="bg1"/>
                </a:solidFill>
              </a:rPr>
              <a:t>Unsure</a:t>
            </a:r>
            <a:r>
              <a:rPr lang="nb-NO" dirty="0">
                <a:solidFill>
                  <a:schemeClr val="bg1"/>
                </a:solidFill>
              </a:rPr>
              <a:t>? Write it </a:t>
            </a:r>
            <a:r>
              <a:rPr lang="nb-NO" dirty="0" err="1">
                <a:solidFill>
                  <a:schemeClr val="bg1"/>
                </a:solidFill>
              </a:rPr>
              <a:t>down</a:t>
            </a:r>
            <a:r>
              <a:rPr lang="nb-NO" dirty="0">
                <a:solidFill>
                  <a:schemeClr val="bg1"/>
                </a:solidFill>
              </a:rPr>
              <a:t>.</a:t>
            </a:r>
          </a:p>
          <a:p>
            <a:r>
              <a:rPr lang="nb-NO" dirty="0" err="1">
                <a:solidFill>
                  <a:schemeClr val="bg1"/>
                </a:solidFill>
              </a:rPr>
              <a:t>When</a:t>
            </a:r>
            <a:r>
              <a:rPr lang="nb-NO" dirty="0">
                <a:solidFill>
                  <a:schemeClr val="bg1"/>
                </a:solidFill>
              </a:rPr>
              <a:t> </a:t>
            </a:r>
            <a:r>
              <a:rPr lang="nb-NO" dirty="0" err="1">
                <a:solidFill>
                  <a:schemeClr val="bg1"/>
                </a:solidFill>
              </a:rPr>
              <a:t>you’re</a:t>
            </a:r>
            <a:r>
              <a:rPr lang="nb-NO" dirty="0">
                <a:solidFill>
                  <a:schemeClr val="bg1"/>
                </a:solidFill>
              </a:rPr>
              <a:t> done, </a:t>
            </a:r>
            <a:r>
              <a:rPr lang="nb-NO" dirty="0" err="1">
                <a:solidFill>
                  <a:schemeClr val="bg1"/>
                </a:solidFill>
              </a:rPr>
              <a:t>lay</a:t>
            </a:r>
            <a:r>
              <a:rPr lang="nb-NO" dirty="0">
                <a:solidFill>
                  <a:schemeClr val="bg1"/>
                </a:solidFill>
              </a:rPr>
              <a:t> </a:t>
            </a:r>
            <a:r>
              <a:rPr lang="nb-NO" dirty="0" err="1">
                <a:solidFill>
                  <a:schemeClr val="bg1"/>
                </a:solidFill>
              </a:rPr>
              <a:t>the</a:t>
            </a:r>
            <a:r>
              <a:rPr lang="nb-NO" dirty="0">
                <a:solidFill>
                  <a:schemeClr val="bg1"/>
                </a:solidFill>
              </a:rPr>
              <a:t> </a:t>
            </a:r>
            <a:r>
              <a:rPr lang="nb-NO" dirty="0" err="1">
                <a:solidFill>
                  <a:schemeClr val="bg1"/>
                </a:solidFill>
              </a:rPr>
              <a:t>post-its</a:t>
            </a:r>
            <a:r>
              <a:rPr lang="nb-NO" dirty="0">
                <a:solidFill>
                  <a:schemeClr val="bg1"/>
                </a:solidFill>
              </a:rPr>
              <a:t> </a:t>
            </a:r>
            <a:r>
              <a:rPr lang="nb-NO" dirty="0" err="1">
                <a:solidFill>
                  <a:schemeClr val="bg1"/>
                </a:solidFill>
              </a:rPr>
              <a:t>out</a:t>
            </a:r>
            <a:r>
              <a:rPr lang="nb-NO" dirty="0">
                <a:solidFill>
                  <a:schemeClr val="bg1"/>
                </a:solidFill>
              </a:rPr>
              <a:t> </a:t>
            </a:r>
            <a:r>
              <a:rPr lang="nb-NO" dirty="0" err="1">
                <a:solidFill>
                  <a:schemeClr val="bg1"/>
                </a:solidFill>
              </a:rPr>
              <a:t>on</a:t>
            </a:r>
            <a:r>
              <a:rPr lang="nb-NO" dirty="0">
                <a:solidFill>
                  <a:schemeClr val="bg1"/>
                </a:solidFill>
              </a:rPr>
              <a:t> </a:t>
            </a:r>
            <a:r>
              <a:rPr lang="nb-NO" dirty="0" err="1">
                <a:solidFill>
                  <a:schemeClr val="bg1"/>
                </a:solidFill>
              </a:rPr>
              <a:t>the</a:t>
            </a:r>
            <a:r>
              <a:rPr lang="nb-NO" dirty="0">
                <a:solidFill>
                  <a:schemeClr val="bg1"/>
                </a:solidFill>
              </a:rPr>
              <a:t> </a:t>
            </a:r>
            <a:r>
              <a:rPr lang="nb-NO" dirty="0" err="1">
                <a:solidFill>
                  <a:schemeClr val="bg1"/>
                </a:solidFill>
              </a:rPr>
              <a:t>table</a:t>
            </a:r>
            <a:r>
              <a:rPr lang="nb-NO" dirty="0">
                <a:solidFill>
                  <a:schemeClr val="bg1"/>
                </a:solidFill>
              </a:rPr>
              <a:t> for a </a:t>
            </a:r>
            <a:r>
              <a:rPr lang="nb-NO" dirty="0" err="1">
                <a:solidFill>
                  <a:schemeClr val="bg1"/>
                </a:solidFill>
              </a:rPr>
              <a:t>review</a:t>
            </a:r>
            <a:r>
              <a:rPr lang="nb-NO" dirty="0">
                <a:solidFill>
                  <a:schemeClr val="bg1"/>
                </a:solidFill>
              </a:rPr>
              <a:t> in </a:t>
            </a:r>
            <a:r>
              <a:rPr lang="nb-NO" dirty="0" err="1">
                <a:solidFill>
                  <a:schemeClr val="bg1"/>
                </a:solidFill>
              </a:rPr>
              <a:t>plenary</a:t>
            </a:r>
            <a:endParaRPr lang="nb-NO" dirty="0">
              <a:solidFill>
                <a:schemeClr val="bg1"/>
              </a:solidFill>
            </a:endParaRPr>
          </a:p>
          <a:p>
            <a:r>
              <a:rPr lang="nb-NO" dirty="0" err="1">
                <a:solidFill>
                  <a:schemeClr val="bg1"/>
                </a:solidFill>
              </a:rPr>
              <a:t>Put</a:t>
            </a:r>
            <a:r>
              <a:rPr lang="nb-NO" dirty="0">
                <a:solidFill>
                  <a:schemeClr val="bg1"/>
                </a:solidFill>
              </a:rPr>
              <a:t> </a:t>
            </a:r>
            <a:r>
              <a:rPr lang="nb-NO" dirty="0" err="1">
                <a:solidFill>
                  <a:schemeClr val="bg1"/>
                </a:solidFill>
              </a:rPr>
              <a:t>the</a:t>
            </a:r>
            <a:r>
              <a:rPr lang="nb-NO" dirty="0">
                <a:solidFill>
                  <a:schemeClr val="bg1"/>
                </a:solidFill>
              </a:rPr>
              <a:t> </a:t>
            </a:r>
            <a:r>
              <a:rPr lang="nb-NO" dirty="0" err="1">
                <a:solidFill>
                  <a:schemeClr val="bg1"/>
                </a:solidFill>
              </a:rPr>
              <a:t>post-its</a:t>
            </a:r>
            <a:r>
              <a:rPr lang="nb-NO" dirty="0">
                <a:solidFill>
                  <a:schemeClr val="bg1"/>
                </a:solidFill>
              </a:rPr>
              <a:t> in a separate </a:t>
            </a:r>
            <a:r>
              <a:rPr lang="nb-NO" dirty="0" err="1">
                <a:solidFill>
                  <a:schemeClr val="bg1"/>
                </a:solidFill>
              </a:rPr>
              <a:t>zipped</a:t>
            </a:r>
            <a:r>
              <a:rPr lang="nb-NO" dirty="0">
                <a:solidFill>
                  <a:schemeClr val="bg1"/>
                </a:solidFill>
              </a:rPr>
              <a:t> bag</a:t>
            </a:r>
          </a:p>
          <a:p>
            <a:r>
              <a:rPr lang="nb-NO" dirty="0" err="1">
                <a:solidFill>
                  <a:schemeClr val="bg1"/>
                </a:solidFill>
              </a:rPr>
              <a:t>Put</a:t>
            </a:r>
            <a:r>
              <a:rPr lang="nb-NO" dirty="0">
                <a:solidFill>
                  <a:schemeClr val="bg1"/>
                </a:solidFill>
              </a:rPr>
              <a:t> </a:t>
            </a:r>
            <a:r>
              <a:rPr lang="nb-NO" dirty="0" err="1">
                <a:solidFill>
                  <a:schemeClr val="bg1"/>
                </a:solidFill>
              </a:rPr>
              <a:t>the</a:t>
            </a:r>
            <a:r>
              <a:rPr lang="nb-NO" dirty="0">
                <a:solidFill>
                  <a:schemeClr val="bg1"/>
                </a:solidFill>
              </a:rPr>
              <a:t> </a:t>
            </a:r>
            <a:r>
              <a:rPr lang="nb-NO" dirty="0" err="1">
                <a:solidFill>
                  <a:schemeClr val="bg1"/>
                </a:solidFill>
              </a:rPr>
              <a:t>zipped</a:t>
            </a:r>
            <a:r>
              <a:rPr lang="nb-NO" dirty="0">
                <a:solidFill>
                  <a:schemeClr val="bg1"/>
                </a:solidFill>
              </a:rPr>
              <a:t> bag </a:t>
            </a:r>
            <a:r>
              <a:rPr lang="nb-NO" dirty="0" err="1">
                <a:solidFill>
                  <a:schemeClr val="bg1"/>
                </a:solidFill>
              </a:rPr>
              <a:t>with</a:t>
            </a:r>
            <a:r>
              <a:rPr lang="nb-NO" dirty="0">
                <a:solidFill>
                  <a:schemeClr val="bg1"/>
                </a:solidFill>
              </a:rPr>
              <a:t> </a:t>
            </a:r>
            <a:r>
              <a:rPr lang="nb-NO" dirty="0" err="1">
                <a:solidFill>
                  <a:schemeClr val="bg1"/>
                </a:solidFill>
              </a:rPr>
              <a:t>the</a:t>
            </a:r>
            <a:r>
              <a:rPr lang="nb-NO" dirty="0">
                <a:solidFill>
                  <a:schemeClr val="bg1"/>
                </a:solidFill>
              </a:rPr>
              <a:t> </a:t>
            </a:r>
            <a:r>
              <a:rPr lang="nb-NO" dirty="0" err="1">
                <a:solidFill>
                  <a:schemeClr val="bg1"/>
                </a:solidFill>
              </a:rPr>
              <a:t>post-its</a:t>
            </a:r>
            <a:r>
              <a:rPr lang="nb-NO" dirty="0">
                <a:solidFill>
                  <a:schemeClr val="bg1"/>
                </a:solidFill>
              </a:rPr>
              <a:t> in </a:t>
            </a:r>
            <a:r>
              <a:rPr lang="nb-NO" dirty="0" err="1">
                <a:solidFill>
                  <a:schemeClr val="bg1"/>
                </a:solidFill>
              </a:rPr>
              <a:t>the</a:t>
            </a:r>
            <a:r>
              <a:rPr lang="nb-NO" dirty="0">
                <a:solidFill>
                  <a:schemeClr val="bg1"/>
                </a:solidFill>
              </a:rPr>
              <a:t> </a:t>
            </a:r>
            <a:r>
              <a:rPr lang="nb-NO" dirty="0" err="1">
                <a:solidFill>
                  <a:schemeClr val="bg1"/>
                </a:solidFill>
              </a:rPr>
              <a:t>larger</a:t>
            </a:r>
            <a:r>
              <a:rPr lang="nb-NO" dirty="0">
                <a:solidFill>
                  <a:schemeClr val="bg1"/>
                </a:solidFill>
              </a:rPr>
              <a:t> </a:t>
            </a:r>
            <a:r>
              <a:rPr lang="nb-NO" dirty="0" err="1">
                <a:solidFill>
                  <a:schemeClr val="bg1"/>
                </a:solidFill>
              </a:rPr>
              <a:t>zipped</a:t>
            </a:r>
            <a:r>
              <a:rPr lang="nb-NO" dirty="0">
                <a:solidFill>
                  <a:schemeClr val="bg1"/>
                </a:solidFill>
              </a:rPr>
              <a:t> bag («bags-in-bag»)</a:t>
            </a:r>
          </a:p>
        </p:txBody>
      </p:sp>
      <p:grpSp>
        <p:nvGrpSpPr>
          <p:cNvPr id="23" name="Gruppe 22">
            <a:extLst>
              <a:ext uri="{FF2B5EF4-FFF2-40B4-BE49-F238E27FC236}">
                <a16:creationId xmlns:a16="http://schemas.microsoft.com/office/drawing/2014/main" id="{90510782-8884-449A-B1DC-ADDE4E11C2EA}"/>
              </a:ext>
            </a:extLst>
          </p:cNvPr>
          <p:cNvGrpSpPr/>
          <p:nvPr/>
        </p:nvGrpSpPr>
        <p:grpSpPr>
          <a:xfrm>
            <a:off x="607200" y="2168148"/>
            <a:ext cx="6354719" cy="2946344"/>
            <a:chOff x="607200" y="1759929"/>
            <a:chExt cx="6354719" cy="2946344"/>
          </a:xfrm>
        </p:grpSpPr>
        <p:sp>
          <p:nvSpPr>
            <p:cNvPr id="9" name="Rektangel 8">
              <a:extLst>
                <a:ext uri="{FF2B5EF4-FFF2-40B4-BE49-F238E27FC236}">
                  <a16:creationId xmlns:a16="http://schemas.microsoft.com/office/drawing/2014/main" id="{85EA07A7-708D-4897-AD83-B1FE6E2F302C}"/>
                </a:ext>
              </a:extLst>
            </p:cNvPr>
            <p:cNvSpPr/>
            <p:nvPr/>
          </p:nvSpPr>
          <p:spPr>
            <a:xfrm>
              <a:off x="607200" y="2644170"/>
              <a:ext cx="6332443" cy="206210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kumimoji="0" lang="nb-NO" sz="3200" b="1" i="0" u="none" strike="noStrike" kern="0" cap="none" spc="0" normalizeH="0" baseline="0" noProof="0" dirty="0">
                  <a:ln>
                    <a:noFill/>
                  </a:ln>
                  <a:solidFill>
                    <a:schemeClr val="bg1"/>
                  </a:solidFill>
                  <a:effectLst/>
                  <a:uLnTx/>
                  <a:uFillTx/>
                  <a:latin typeface="Century Gothic" panose="020B0502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‘’</a:t>
              </a:r>
              <a:r>
                <a:rPr lang="nb-NO" sz="3200" b="1" i="1" kern="0" noProof="0" dirty="0">
                  <a:solidFill>
                    <a:schemeClr val="bg1"/>
                  </a:solidFill>
                  <a:latin typeface="Century Gothic" panose="020B0502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Is </a:t>
              </a:r>
              <a:r>
                <a:rPr lang="nb-NO" sz="3200" b="1" i="1" kern="0" noProof="0" dirty="0" err="1">
                  <a:solidFill>
                    <a:schemeClr val="bg1"/>
                  </a:solidFill>
                  <a:latin typeface="Century Gothic" panose="020B0502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there</a:t>
              </a:r>
              <a:r>
                <a:rPr lang="nb-NO" sz="3200" b="1" i="1" kern="0" noProof="0" dirty="0">
                  <a:solidFill>
                    <a:schemeClr val="bg1"/>
                  </a:solidFill>
                  <a:latin typeface="Century Gothic" panose="020B0502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nb-NO" sz="3200" b="1" i="1" kern="0" noProof="0" dirty="0" err="1">
                  <a:solidFill>
                    <a:schemeClr val="bg1"/>
                  </a:solidFill>
                  <a:latin typeface="Century Gothic" panose="020B0502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anything</a:t>
              </a:r>
              <a:r>
                <a:rPr lang="nb-NO" sz="3200" b="1" i="1" kern="0" noProof="0" dirty="0">
                  <a:solidFill>
                    <a:schemeClr val="bg1"/>
                  </a:solidFill>
                  <a:latin typeface="Century Gothic" panose="020B0502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nb-NO" sz="3200" b="1" i="1" kern="0" noProof="0" dirty="0" err="1">
                  <a:solidFill>
                    <a:schemeClr val="bg1"/>
                  </a:solidFill>
                  <a:latin typeface="Century Gothic" panose="020B0502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we</a:t>
              </a:r>
              <a:r>
                <a:rPr lang="nb-NO" sz="3200" b="1" i="1" kern="0" noProof="0" dirty="0">
                  <a:solidFill>
                    <a:schemeClr val="bg1"/>
                  </a:solidFill>
                  <a:latin typeface="Century Gothic" panose="020B0502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have not </a:t>
              </a:r>
              <a:r>
                <a:rPr lang="nb-NO" sz="3200" b="1" i="1" kern="0" noProof="0" dirty="0" err="1">
                  <a:solidFill>
                    <a:schemeClr val="bg1"/>
                  </a:solidFill>
                  <a:latin typeface="Century Gothic" panose="020B0502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thought</a:t>
              </a:r>
              <a:r>
                <a:rPr lang="nb-NO" sz="3200" b="1" i="1" kern="0" noProof="0" dirty="0">
                  <a:solidFill>
                    <a:schemeClr val="bg1"/>
                  </a:solidFill>
                  <a:latin typeface="Century Gothic" panose="020B0502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nb-NO" sz="3200" b="1" i="1" kern="0" noProof="0" dirty="0" err="1">
                  <a:solidFill>
                    <a:schemeClr val="bg1"/>
                  </a:solidFill>
                  <a:latin typeface="Century Gothic" panose="020B0502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about</a:t>
              </a:r>
              <a:r>
                <a:rPr lang="nb-NO" sz="3200" b="1" i="1" kern="0" noProof="0" dirty="0">
                  <a:solidFill>
                    <a:schemeClr val="bg1"/>
                  </a:solidFill>
                  <a:latin typeface="Century Gothic" panose="020B0502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  <a:r>
                <a:rPr lang="nb-NO" sz="3200" b="1" i="1" kern="0" noProof="0" dirty="0" err="1">
                  <a:solidFill>
                    <a:schemeClr val="bg1"/>
                  </a:solidFill>
                  <a:latin typeface="Century Gothic" panose="020B0502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any</a:t>
              </a:r>
              <a:r>
                <a:rPr lang="nb-NO" sz="3200" b="1" i="1" kern="0" noProof="0" dirty="0">
                  <a:solidFill>
                    <a:schemeClr val="bg1"/>
                  </a:solidFill>
                  <a:latin typeface="Century Gothic" panose="020B0502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nb-NO" sz="3200" b="1" i="1" kern="0" noProof="0" dirty="0" err="1">
                  <a:solidFill>
                    <a:schemeClr val="bg1"/>
                  </a:solidFill>
                  <a:latin typeface="Century Gothic" panose="020B0502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onditions</a:t>
              </a:r>
              <a:r>
                <a:rPr lang="nb-NO" sz="3200" b="1" i="1" kern="0" noProof="0" dirty="0">
                  <a:solidFill>
                    <a:schemeClr val="bg1"/>
                  </a:solidFill>
                  <a:latin typeface="Century Gothic" panose="020B0502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or </a:t>
              </a:r>
              <a:r>
                <a:rPr lang="nb-NO" sz="3200" b="1" i="1" kern="0" noProof="0" dirty="0" err="1">
                  <a:solidFill>
                    <a:schemeClr val="bg1"/>
                  </a:solidFill>
                  <a:latin typeface="Century Gothic" panose="020B0502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strategies</a:t>
              </a:r>
              <a:r>
                <a:rPr lang="nb-NO" sz="3200" b="1" i="1" kern="0" noProof="0" dirty="0">
                  <a:solidFill>
                    <a:schemeClr val="bg1"/>
                  </a:solidFill>
                  <a:latin typeface="Century Gothic" panose="020B0502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nb-NO" sz="3200" b="1" i="1" kern="0" noProof="0" dirty="0" err="1">
                  <a:solidFill>
                    <a:schemeClr val="bg1"/>
                  </a:solidFill>
                  <a:latin typeface="Century Gothic" panose="020B0502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that</a:t>
              </a:r>
              <a:r>
                <a:rPr lang="nb-NO" sz="3200" b="1" i="1" kern="0" noProof="0" dirty="0">
                  <a:solidFill>
                    <a:schemeClr val="bg1"/>
                  </a:solidFill>
                  <a:latin typeface="Century Gothic" panose="020B0502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have not </a:t>
              </a:r>
              <a:r>
                <a:rPr lang="nb-NO" sz="3200" b="1" i="1" kern="0" noProof="0" dirty="0" err="1">
                  <a:solidFill>
                    <a:schemeClr val="bg1"/>
                  </a:solidFill>
                  <a:latin typeface="Century Gothic" panose="020B0502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been</a:t>
              </a:r>
              <a:r>
                <a:rPr lang="nb-NO" sz="3200" b="1" i="1" kern="0" noProof="0" dirty="0">
                  <a:solidFill>
                    <a:schemeClr val="bg1"/>
                  </a:solidFill>
                  <a:latin typeface="Century Gothic" panose="020B0502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nb-NO" sz="3200" b="1" i="1" kern="0" noProof="0" dirty="0" err="1">
                  <a:solidFill>
                    <a:schemeClr val="bg1"/>
                  </a:solidFill>
                  <a:latin typeface="Century Gothic" panose="020B0502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sufficiently</a:t>
              </a:r>
              <a:r>
                <a:rPr lang="nb-NO" sz="3200" b="1" i="1" kern="0" noProof="0" dirty="0">
                  <a:solidFill>
                    <a:schemeClr val="bg1"/>
                  </a:solidFill>
                  <a:latin typeface="Century Gothic" panose="020B0502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nb-NO" sz="3200" b="1" i="1" kern="0" noProof="0" dirty="0" err="1">
                  <a:solidFill>
                    <a:schemeClr val="bg1"/>
                  </a:solidFill>
                  <a:latin typeface="Century Gothic" panose="020B0502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overed</a:t>
              </a:r>
              <a:r>
                <a:rPr lang="nb-NO" sz="3200" b="1" i="1" kern="0" noProof="0" dirty="0">
                  <a:solidFill>
                    <a:schemeClr val="bg1"/>
                  </a:solidFill>
                  <a:latin typeface="Century Gothic" panose="020B0502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?</a:t>
              </a:r>
              <a:r>
                <a:rPr kumimoji="0" lang="nb-NO" sz="3200" b="1" i="0" u="none" strike="noStrike" kern="0" cap="none" spc="0" normalizeH="0" baseline="0" noProof="0" dirty="0">
                  <a:ln>
                    <a:noFill/>
                  </a:ln>
                  <a:solidFill>
                    <a:schemeClr val="bg1"/>
                  </a:solidFill>
                  <a:effectLst/>
                  <a:uLnTx/>
                  <a:uFillTx/>
                  <a:latin typeface="Century Gothic" panose="020B0502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‘’</a:t>
              </a:r>
              <a:endParaRPr kumimoji="0" lang="nb-NO" sz="3200" b="1" i="1" u="none" strike="noStrike" kern="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Century Gothic" panose="020B0502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ittel 4">
              <a:extLst>
                <a:ext uri="{FF2B5EF4-FFF2-40B4-BE49-F238E27FC236}">
                  <a16:creationId xmlns:a16="http://schemas.microsoft.com/office/drawing/2014/main" id="{ECD615C2-4D22-4956-B656-D1C172C8B52F}"/>
                </a:ext>
              </a:extLst>
            </p:cNvPr>
            <p:cNvSpPr txBox="1">
              <a:spLocks/>
            </p:cNvSpPr>
            <p:nvPr/>
          </p:nvSpPr>
          <p:spPr>
            <a:xfrm>
              <a:off x="749988" y="1759929"/>
              <a:ext cx="6211931" cy="1764696"/>
            </a:xfrm>
            <a:prstGeom prst="rect">
              <a:avLst/>
            </a:prstGeom>
          </p:spPr>
          <p:txBody>
            <a:bodyPr vert="horz" lIns="0" tIns="0" rIns="0" bIns="0" rtlCol="0" anchor="t" anchorCtr="0">
              <a:noAutofit/>
            </a:bodyPr>
            <a:lstStyle>
              <a:lvl1pPr algn="l" defTabSz="914446" rtl="0" eaLnBrk="1" latinLnBrk="0" hangingPunct="1">
                <a:lnSpc>
                  <a:spcPct val="90000"/>
                </a:lnSpc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nb-NO" b="1" dirty="0">
                  <a:solidFill>
                    <a:schemeClr val="bg1"/>
                  </a:solidFill>
                </a:rPr>
                <a:t>Focus prompt:</a:t>
              </a:r>
            </a:p>
          </p:txBody>
        </p:sp>
      </p:grpSp>
      <p:sp>
        <p:nvSpPr>
          <p:cNvPr id="22" name="Tittel 4">
            <a:extLst>
              <a:ext uri="{FF2B5EF4-FFF2-40B4-BE49-F238E27FC236}">
                <a16:creationId xmlns:a16="http://schemas.microsoft.com/office/drawing/2014/main" id="{7ACD5F7F-4285-48E4-8A5F-B4D129A252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51200" y="856800"/>
            <a:ext cx="10533600" cy="705600"/>
          </a:xfrm>
        </p:spPr>
        <p:txBody>
          <a:bodyPr/>
          <a:lstStyle/>
          <a:p>
            <a:r>
              <a:rPr lang="nb-NO" dirty="0" err="1">
                <a:solidFill>
                  <a:schemeClr val="bg1"/>
                </a:solidFill>
              </a:rPr>
              <a:t>Instructions</a:t>
            </a:r>
            <a:r>
              <a:rPr lang="nb-NO" dirty="0">
                <a:solidFill>
                  <a:schemeClr val="bg1"/>
                </a:solidFill>
              </a:rPr>
              <a:t> for brainstorming</a:t>
            </a:r>
          </a:p>
        </p:txBody>
      </p:sp>
    </p:spTree>
    <p:extLst>
      <p:ext uri="{BB962C8B-B14F-4D97-AF65-F5344CB8AC3E}">
        <p14:creationId xmlns:p14="http://schemas.microsoft.com/office/powerpoint/2010/main" val="551581596"/>
      </p:ext>
    </p:extLst>
  </p:cSld>
  <p:clrMapOvr>
    <a:masterClrMapping/>
  </p:clrMapOvr>
</p:sld>
</file>

<file path=ppt/theme/theme1.xml><?xml version="1.0" encoding="utf-8"?>
<a:theme xmlns:a="http://schemas.openxmlformats.org/drawingml/2006/main" name="RBUP">
  <a:themeElements>
    <a:clrScheme name="Custom 82">
      <a:dk1>
        <a:sysClr val="windowText" lastClr="000000"/>
      </a:dk1>
      <a:lt1>
        <a:sysClr val="window" lastClr="FFFFFF"/>
      </a:lt1>
      <a:dk2>
        <a:srgbClr val="44546A"/>
      </a:dk2>
      <a:lt2>
        <a:srgbClr val="FFE09F"/>
      </a:lt2>
      <a:accent1>
        <a:srgbClr val="355EDB"/>
      </a:accent1>
      <a:accent2>
        <a:srgbClr val="E31836"/>
      </a:accent2>
      <a:accent3>
        <a:srgbClr val="093640"/>
      </a:accent3>
      <a:accent4>
        <a:srgbClr val="FDB200"/>
      </a:accent4>
      <a:accent5>
        <a:srgbClr val="311D53"/>
      </a:accent5>
      <a:accent6>
        <a:srgbClr val="7CE9CC"/>
      </a:accent6>
      <a:hlink>
        <a:srgbClr val="000000"/>
      </a:hlink>
      <a:folHlink>
        <a:srgbClr val="954F72"/>
      </a:folHlink>
    </a:clrScheme>
    <a:fontScheme name="Custom 98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ln>
          <a:noFill/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txDef>
      <a:spPr>
        <a:noFill/>
      </a:spPr>
      <a:bodyPr wrap="square" lIns="0" tIns="0" rIns="0" bIns="0" rtlCol="0" anchor="t" anchorCtr="0">
        <a:spAutoFit/>
      </a:bodyPr>
      <a:lstStyle>
        <a:defPPr algn="l">
          <a:defRPr sz="2300" dirty="0" err="1"/>
        </a:defPPr>
      </a:lstStyle>
    </a:txDef>
  </a:objectDefaults>
  <a:extraClrSchemeLst/>
  <a:extLst>
    <a:ext uri="{05A4C25C-085E-4340-85A3-A5531E510DB2}">
      <thm15:themeFamily xmlns:thm15="http://schemas.microsoft.com/office/thememl/2012/main" name="RBUP.cleaned.potx  -  Skrivebeskyttet" id="{0AC83856-5976-4A61-9524-1424634EB8B0}" vid="{FF711EC6-629D-4C1A-9F33-6B8927B9F01E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698527ACF481A44DAFB5AABA49D6A18E" ma:contentTypeVersion="5" ma:contentTypeDescription="Opprett et nytt dokument." ma:contentTypeScope="" ma:versionID="0e4374e9545189517311fd4e8da637b4">
  <xsd:schema xmlns:xsd="http://www.w3.org/2001/XMLSchema" xmlns:xs="http://www.w3.org/2001/XMLSchema" xmlns:p="http://schemas.microsoft.com/office/2006/metadata/properties" xmlns:ns2="ed560210-fdc7-4e70-af25-c51466d91ade" targetNamespace="http://schemas.microsoft.com/office/2006/metadata/properties" ma:root="true" ma:fieldsID="ad0ec9997f43bafdcd698bcb02f00ca6" ns2:_="">
    <xsd:import namespace="ed560210-fdc7-4e70-af25-c51466d91ade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DateTaken" minOccurs="0"/>
                <xsd:element ref="ns2:MediaLengthInSeconds" minOccurs="0"/>
                <xsd:element ref="ns2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d560210-fdc7-4e70-af25-c51466d91ad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11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1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nholdstype"/>
        <xsd:element ref="dc:title" minOccurs="0" maxOccurs="1" ma:index="4" ma:displayName="Tit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487E7A74-0B8E-4A5C-803F-70642090A198}">
  <ds:schemaRefs>
    <ds:schemaRef ds:uri="http://purl.org/dc/elements/1.1/"/>
    <ds:schemaRef ds:uri="http://purl.org/dc/terms/"/>
    <ds:schemaRef ds:uri="http://www.w3.org/XML/1998/namespace"/>
    <ds:schemaRef ds:uri="http://schemas.microsoft.com/office/2006/documentManagement/types"/>
    <ds:schemaRef ds:uri="d07fb212-b39b-4c3a-8c0b-1ca17916a849"/>
    <ds:schemaRef ds:uri="http://purl.org/dc/dcmitype/"/>
    <ds:schemaRef ds:uri="http://schemas.microsoft.com/office/infopath/2007/PartnerControls"/>
    <ds:schemaRef ds:uri="http://schemas.openxmlformats.org/package/2006/metadata/core-properties"/>
    <ds:schemaRef ds:uri="ac7b205f-0556-44ac-9cd4-1a3015777919"/>
    <ds:schemaRef ds:uri="http://schemas.microsoft.com/office/2006/metadata/properties"/>
  </ds:schemaRefs>
</ds:datastoreItem>
</file>

<file path=customXml/itemProps2.xml><?xml version="1.0" encoding="utf-8"?>
<ds:datastoreItem xmlns:ds="http://schemas.openxmlformats.org/officeDocument/2006/customXml" ds:itemID="{1C55CE39-2F77-49FF-992B-57928D6C9BA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ed560210-fdc7-4e70-af25-c51466d91ad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9F57E23F-E0AC-4D47-AC72-1B2399438054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27</TotalTime>
  <Words>897</Words>
  <Application>Microsoft Office PowerPoint</Application>
  <PresentationFormat>Widescreen</PresentationFormat>
  <Paragraphs>125</Paragraphs>
  <Slides>21</Slides>
  <Notes>20</Notes>
  <HiddenSlides>0</HiddenSlides>
  <MMClips>0</MMClips>
  <ScaleCrop>false</ScaleCrop>
  <HeadingPairs>
    <vt:vector size="6" baseType="variant">
      <vt:variant>
        <vt:lpstr>Brukte skrifter</vt:lpstr>
      </vt:variant>
      <vt:variant>
        <vt:i4>2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21</vt:i4>
      </vt:variant>
    </vt:vector>
  </HeadingPairs>
  <TitlesOfParts>
    <vt:vector size="24" baseType="lpstr">
      <vt:lpstr>Arial</vt:lpstr>
      <vt:lpstr>Century Gothic</vt:lpstr>
      <vt:lpstr>RBUP</vt:lpstr>
      <vt:lpstr>Identifying and developing strategies for implementation of a guided internet- and mobile-based infant sleep intervention in well-baby and community mental health clinics using group concept mapping</vt:lpstr>
      <vt:lpstr>Focus prompt</vt:lpstr>
      <vt:lpstr>PowerPoint-presentasjon</vt:lpstr>
      <vt:lpstr>Card Sorting Task</vt:lpstr>
      <vt:lpstr>Instructions for card sorting task</vt:lpstr>
      <vt:lpstr>Rating</vt:lpstr>
      <vt:lpstr>Instructions for rating statements</vt:lpstr>
      <vt:lpstr>Brainstorming</vt:lpstr>
      <vt:lpstr>Instructions for brainstorming</vt:lpstr>
      <vt:lpstr>Group Discussion</vt:lpstr>
      <vt:lpstr>Questions for discussion</vt:lpstr>
      <vt:lpstr>Fokusutsagn</vt:lpstr>
      <vt:lpstr>PowerPoint-presentasjon</vt:lpstr>
      <vt:lpstr>Sortering</vt:lpstr>
      <vt:lpstr>Sorteringsoppgave – instruksjoner </vt:lpstr>
      <vt:lpstr>Vurdering</vt:lpstr>
      <vt:lpstr>Vurderingsoppgave – instruksjoner </vt:lpstr>
      <vt:lpstr>Brainstorming</vt:lpstr>
      <vt:lpstr>Brainstorming – instruksjoner </vt:lpstr>
      <vt:lpstr>Gruppediskusjon</vt:lpstr>
      <vt:lpstr>Spørsmål for diskusj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Filip Drozd</dc:creator>
  <cp:lastModifiedBy>Filip Drozd</cp:lastModifiedBy>
  <cp:revision>17</cp:revision>
  <dcterms:created xsi:type="dcterms:W3CDTF">2021-12-28T06:39:29Z</dcterms:created>
  <dcterms:modified xsi:type="dcterms:W3CDTF">2024-01-25T08:01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88181f18-e8b3-49ee-90c4-cfe0624ec4f0_Enabled">
    <vt:lpwstr>true</vt:lpwstr>
  </property>
  <property fmtid="{D5CDD505-2E9C-101B-9397-08002B2CF9AE}" pid="3" name="MSIP_Label_88181f18-e8b3-49ee-90c4-cfe0624ec4f0_SetDate">
    <vt:lpwstr>2021-11-17T10:46:32Z</vt:lpwstr>
  </property>
  <property fmtid="{D5CDD505-2E9C-101B-9397-08002B2CF9AE}" pid="4" name="MSIP_Label_88181f18-e8b3-49ee-90c4-cfe0624ec4f0_Method">
    <vt:lpwstr>Standard</vt:lpwstr>
  </property>
  <property fmtid="{D5CDD505-2E9C-101B-9397-08002B2CF9AE}" pid="5" name="MSIP_Label_88181f18-e8b3-49ee-90c4-cfe0624ec4f0_Name">
    <vt:lpwstr>Åpen</vt:lpwstr>
  </property>
  <property fmtid="{D5CDD505-2E9C-101B-9397-08002B2CF9AE}" pid="6" name="MSIP_Label_88181f18-e8b3-49ee-90c4-cfe0624ec4f0_SiteId">
    <vt:lpwstr>a34f6ee5-2cae-4a46-a779-6480cace54ec</vt:lpwstr>
  </property>
  <property fmtid="{D5CDD505-2E9C-101B-9397-08002B2CF9AE}" pid="7" name="MSIP_Label_88181f18-e8b3-49ee-90c4-cfe0624ec4f0_ActionId">
    <vt:lpwstr>528869b4-84b3-40b6-850f-8c8abf6d7019</vt:lpwstr>
  </property>
  <property fmtid="{D5CDD505-2E9C-101B-9397-08002B2CF9AE}" pid="8" name="MSIP_Label_88181f18-e8b3-49ee-90c4-cfe0624ec4f0_ContentBits">
    <vt:lpwstr>0</vt:lpwstr>
  </property>
  <property fmtid="{D5CDD505-2E9C-101B-9397-08002B2CF9AE}" pid="9" name="ContentTypeId">
    <vt:lpwstr>0x010100698527ACF481A44DAFB5AABA49D6A18E</vt:lpwstr>
  </property>
</Properties>
</file>